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79" r:id="rId2"/>
    <p:sldId id="278" r:id="rId3"/>
    <p:sldId id="281" r:id="rId4"/>
    <p:sldId id="284" r:id="rId5"/>
    <p:sldId id="280" r:id="rId6"/>
    <p:sldId id="285" r:id="rId7"/>
  </p:sldIdLst>
  <p:sldSz cx="6858000" cy="9144000" type="screen4x3"/>
  <p:notesSz cx="6792913" cy="9925050"/>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27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46C0A"/>
    <a:srgbClr val="F2F2F2"/>
    <a:srgbClr val="FDEADA"/>
    <a:srgbClr val="FAC090"/>
    <a:srgbClr val="DBEEF4"/>
    <a:srgbClr val="F2DCDB"/>
    <a:srgbClr val="FFDF87"/>
    <a:srgbClr val="FCFDC8"/>
    <a:srgbClr val="F78C06"/>
    <a:srgbClr val="F7FDD2"/>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202B0CA-FC54-4496-8BCA-5EF66A818D29}" styleName="スタイル (濃色)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038" autoAdjust="0"/>
    <p:restoredTop sz="91429" autoAdjust="0"/>
  </p:normalViewPr>
  <p:slideViewPr>
    <p:cSldViewPr snapToGrid="0" snapToObjects="1">
      <p:cViewPr varScale="1">
        <p:scale>
          <a:sx n="92" d="100"/>
          <a:sy n="92" d="100"/>
        </p:scale>
        <p:origin x="3365" y="86"/>
      </p:cViewPr>
      <p:guideLst>
        <p:guide orient="horz" pos="2880"/>
        <p:guide pos="2273"/>
      </p:guideLst>
    </p:cSldViewPr>
  </p:slideViewPr>
  <p:outlineViewPr>
    <p:cViewPr>
      <p:scale>
        <a:sx n="33" d="100"/>
        <a:sy n="33" d="100"/>
      </p:scale>
      <p:origin x="0" y="0"/>
    </p:cViewPr>
  </p:outlineViewPr>
  <p:notesTextViewPr>
    <p:cViewPr>
      <p:scale>
        <a:sx n="105" d="100"/>
        <a:sy n="105"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G:\&#20849;&#26377;&#12489;&#12521;&#12452;&#12502;\&#26757;&#28580;&#30740;&#31350;&#23460;\&#35542;&#25991;&#21407;&#31295;\srk2dei_abi1-1\&#12381;&#12398;&#20182;&#12464;&#12521;&#12501;.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95000"/>
              </a:schemeClr>
            </a:solidFill>
            <a:ln w="6350">
              <a:solidFill>
                <a:schemeClr val="tx1"/>
              </a:solidFill>
            </a:ln>
            <a:effectLst/>
          </c:spPr>
          <c:invertIfNegative val="0"/>
          <c:dPt>
            <c:idx val="1"/>
            <c:invertIfNegative val="0"/>
            <c:bubble3D val="0"/>
            <c:spPr>
              <a:solidFill>
                <a:schemeClr val="accent6">
                  <a:lumMod val="40000"/>
                  <a:lumOff val="60000"/>
                </a:schemeClr>
              </a:solidFill>
              <a:ln w="6350">
                <a:solidFill>
                  <a:schemeClr val="tx1"/>
                </a:solidFill>
              </a:ln>
              <a:effectLst/>
            </c:spPr>
            <c:extLst>
              <c:ext xmlns:c16="http://schemas.microsoft.com/office/drawing/2014/chart" uri="{C3380CC4-5D6E-409C-BE32-E72D297353CC}">
                <c16:uniqueId val="{00000005-0989-473E-9FB0-CCB3B17DAA4D}"/>
              </c:ext>
            </c:extLst>
          </c:dPt>
          <c:dPt>
            <c:idx val="2"/>
            <c:invertIfNegative val="0"/>
            <c:bubble3D val="0"/>
            <c:spPr>
              <a:solidFill>
                <a:schemeClr val="accent6"/>
              </a:solidFill>
              <a:ln w="6350">
                <a:solidFill>
                  <a:schemeClr val="tx1"/>
                </a:solidFill>
              </a:ln>
              <a:effectLst/>
            </c:spPr>
            <c:extLst>
              <c:ext xmlns:c16="http://schemas.microsoft.com/office/drawing/2014/chart" uri="{C3380CC4-5D6E-409C-BE32-E72D297353CC}">
                <c16:uniqueId val="{00000008-0989-473E-9FB0-CCB3B17DAA4D}"/>
              </c:ext>
            </c:extLst>
          </c:dPt>
          <c:dPt>
            <c:idx val="3"/>
            <c:invertIfNegative val="0"/>
            <c:bubble3D val="0"/>
            <c:spPr>
              <a:solidFill>
                <a:schemeClr val="accent6">
                  <a:lumMod val="75000"/>
                </a:schemeClr>
              </a:solidFill>
              <a:ln w="6350">
                <a:solidFill>
                  <a:schemeClr val="tx1"/>
                </a:solidFill>
              </a:ln>
              <a:effectLst/>
            </c:spPr>
            <c:extLst>
              <c:ext xmlns:c16="http://schemas.microsoft.com/office/drawing/2014/chart" uri="{C3380CC4-5D6E-409C-BE32-E72D297353CC}">
                <c16:uniqueId val="{0000000B-0989-473E-9FB0-CCB3B17DAA4D}"/>
              </c:ext>
            </c:extLst>
          </c:dPt>
          <c:dPt>
            <c:idx val="5"/>
            <c:invertIfNegative val="0"/>
            <c:bubble3D val="0"/>
            <c:spPr>
              <a:solidFill>
                <a:schemeClr val="accent6">
                  <a:lumMod val="40000"/>
                  <a:lumOff val="60000"/>
                </a:schemeClr>
              </a:solidFill>
              <a:ln w="6350">
                <a:solidFill>
                  <a:schemeClr val="tx1"/>
                </a:solidFill>
              </a:ln>
              <a:effectLst/>
            </c:spPr>
            <c:extLst>
              <c:ext xmlns:c16="http://schemas.microsoft.com/office/drawing/2014/chart" uri="{C3380CC4-5D6E-409C-BE32-E72D297353CC}">
                <c16:uniqueId val="{00000006-0989-473E-9FB0-CCB3B17DAA4D}"/>
              </c:ext>
            </c:extLst>
          </c:dPt>
          <c:dPt>
            <c:idx val="6"/>
            <c:invertIfNegative val="0"/>
            <c:bubble3D val="0"/>
            <c:spPr>
              <a:solidFill>
                <a:schemeClr val="accent6"/>
              </a:solidFill>
              <a:ln w="6350">
                <a:solidFill>
                  <a:schemeClr val="tx1"/>
                </a:solidFill>
              </a:ln>
              <a:effectLst/>
            </c:spPr>
            <c:extLst>
              <c:ext xmlns:c16="http://schemas.microsoft.com/office/drawing/2014/chart" uri="{C3380CC4-5D6E-409C-BE32-E72D297353CC}">
                <c16:uniqueId val="{00000009-0989-473E-9FB0-CCB3B17DAA4D}"/>
              </c:ext>
            </c:extLst>
          </c:dPt>
          <c:dPt>
            <c:idx val="7"/>
            <c:invertIfNegative val="0"/>
            <c:bubble3D val="0"/>
            <c:spPr>
              <a:solidFill>
                <a:schemeClr val="accent6">
                  <a:lumMod val="75000"/>
                </a:schemeClr>
              </a:solidFill>
              <a:ln w="6350">
                <a:solidFill>
                  <a:schemeClr val="tx1"/>
                </a:solidFill>
              </a:ln>
              <a:effectLst/>
            </c:spPr>
            <c:extLst>
              <c:ext xmlns:c16="http://schemas.microsoft.com/office/drawing/2014/chart" uri="{C3380CC4-5D6E-409C-BE32-E72D297353CC}">
                <c16:uniqueId val="{0000000C-0989-473E-9FB0-CCB3B17DAA4D}"/>
              </c:ext>
            </c:extLst>
          </c:dPt>
          <c:dPt>
            <c:idx val="9"/>
            <c:invertIfNegative val="0"/>
            <c:bubble3D val="0"/>
            <c:spPr>
              <a:solidFill>
                <a:schemeClr val="accent6">
                  <a:lumMod val="40000"/>
                  <a:lumOff val="60000"/>
                </a:schemeClr>
              </a:solidFill>
              <a:ln w="6350">
                <a:solidFill>
                  <a:schemeClr val="tx1"/>
                </a:solidFill>
              </a:ln>
              <a:effectLst/>
            </c:spPr>
            <c:extLst>
              <c:ext xmlns:c16="http://schemas.microsoft.com/office/drawing/2014/chart" uri="{C3380CC4-5D6E-409C-BE32-E72D297353CC}">
                <c16:uniqueId val="{00000007-0989-473E-9FB0-CCB3B17DAA4D}"/>
              </c:ext>
            </c:extLst>
          </c:dPt>
          <c:dPt>
            <c:idx val="10"/>
            <c:invertIfNegative val="0"/>
            <c:bubble3D val="0"/>
            <c:spPr>
              <a:solidFill>
                <a:schemeClr val="accent6"/>
              </a:solidFill>
              <a:ln w="6350">
                <a:solidFill>
                  <a:schemeClr val="tx1"/>
                </a:solidFill>
              </a:ln>
              <a:effectLst/>
            </c:spPr>
            <c:extLst>
              <c:ext xmlns:c16="http://schemas.microsoft.com/office/drawing/2014/chart" uri="{C3380CC4-5D6E-409C-BE32-E72D297353CC}">
                <c16:uniqueId val="{0000000A-0989-473E-9FB0-CCB3B17DAA4D}"/>
              </c:ext>
            </c:extLst>
          </c:dPt>
          <c:dPt>
            <c:idx val="11"/>
            <c:invertIfNegative val="0"/>
            <c:bubble3D val="0"/>
            <c:spPr>
              <a:solidFill>
                <a:schemeClr val="accent6">
                  <a:lumMod val="75000"/>
                </a:schemeClr>
              </a:solidFill>
              <a:ln w="6350">
                <a:solidFill>
                  <a:schemeClr val="tx1"/>
                </a:solidFill>
              </a:ln>
              <a:effectLst/>
            </c:spPr>
            <c:extLst>
              <c:ext xmlns:c16="http://schemas.microsoft.com/office/drawing/2014/chart" uri="{C3380CC4-5D6E-409C-BE32-E72D297353CC}">
                <c16:uniqueId val="{0000000D-0989-473E-9FB0-CCB3B17DAA4D}"/>
              </c:ext>
            </c:extLst>
          </c:dPt>
          <c:errBars>
            <c:errBarType val="both"/>
            <c:errValType val="cust"/>
            <c:noEndCap val="0"/>
            <c:plus>
              <c:numRef>
                <c:f>Fig.S1!$AR$17:$BC$17</c:f>
                <c:numCache>
                  <c:formatCode>General</c:formatCode>
                  <c:ptCount val="12"/>
                  <c:pt idx="0">
                    <c:v>636.24694252703489</c:v>
                  </c:pt>
                  <c:pt idx="1">
                    <c:v>558.18041438230341</c:v>
                  </c:pt>
                  <c:pt idx="2">
                    <c:v>299.79625894096813</c:v>
                  </c:pt>
                  <c:pt idx="3">
                    <c:v>609.61504246532502</c:v>
                  </c:pt>
                  <c:pt idx="4">
                    <c:v>426.02998353989125</c:v>
                  </c:pt>
                  <c:pt idx="5">
                    <c:v>484.33446604593399</c:v>
                  </c:pt>
                  <c:pt idx="6">
                    <c:v>403.83387286729675</c:v>
                  </c:pt>
                  <c:pt idx="7">
                    <c:v>780.05163090336532</c:v>
                  </c:pt>
                  <c:pt idx="8">
                    <c:v>478.64293842069787</c:v>
                  </c:pt>
                  <c:pt idx="9">
                    <c:v>648.23997292669321</c:v>
                  </c:pt>
                  <c:pt idx="10">
                    <c:v>655.48325445811349</c:v>
                  </c:pt>
                  <c:pt idx="11">
                    <c:v>175.50249285978819</c:v>
                  </c:pt>
                </c:numCache>
              </c:numRef>
            </c:plus>
            <c:minus>
              <c:numRef>
                <c:f>Fig.S1!$AR$17:$BC$17</c:f>
                <c:numCache>
                  <c:formatCode>General</c:formatCode>
                  <c:ptCount val="12"/>
                  <c:pt idx="0">
                    <c:v>636.24694252703489</c:v>
                  </c:pt>
                  <c:pt idx="1">
                    <c:v>558.18041438230341</c:v>
                  </c:pt>
                  <c:pt idx="2">
                    <c:v>299.79625894096813</c:v>
                  </c:pt>
                  <c:pt idx="3">
                    <c:v>609.61504246532502</c:v>
                  </c:pt>
                  <c:pt idx="4">
                    <c:v>426.02998353989125</c:v>
                  </c:pt>
                  <c:pt idx="5">
                    <c:v>484.33446604593399</c:v>
                  </c:pt>
                  <c:pt idx="6">
                    <c:v>403.83387286729675</c:v>
                  </c:pt>
                  <c:pt idx="7">
                    <c:v>780.05163090336532</c:v>
                  </c:pt>
                  <c:pt idx="8">
                    <c:v>478.64293842069787</c:v>
                  </c:pt>
                  <c:pt idx="9">
                    <c:v>648.23997292669321</c:v>
                  </c:pt>
                  <c:pt idx="10">
                    <c:v>655.48325445811349</c:v>
                  </c:pt>
                  <c:pt idx="11">
                    <c:v>175.50249285978819</c:v>
                  </c:pt>
                </c:numCache>
              </c:numRef>
            </c:minus>
            <c:spPr>
              <a:noFill/>
              <a:ln w="6350" cap="flat" cmpd="sng" algn="ctr">
                <a:solidFill>
                  <a:schemeClr val="tx1"/>
                </a:solidFill>
                <a:round/>
              </a:ln>
              <a:effectLst/>
            </c:spPr>
          </c:errBars>
          <c:val>
            <c:numRef>
              <c:f>Fig.S1!$AR$16:$BC$16</c:f>
              <c:numCache>
                <c:formatCode>General</c:formatCode>
                <c:ptCount val="12"/>
                <c:pt idx="0">
                  <c:v>23477.25</c:v>
                </c:pt>
                <c:pt idx="1">
                  <c:v>21969</c:v>
                </c:pt>
                <c:pt idx="2">
                  <c:v>22171.75</c:v>
                </c:pt>
                <c:pt idx="3">
                  <c:v>22269</c:v>
                </c:pt>
                <c:pt idx="4">
                  <c:v>22019.25</c:v>
                </c:pt>
                <c:pt idx="5">
                  <c:v>20379</c:v>
                </c:pt>
                <c:pt idx="6">
                  <c:v>20073.25</c:v>
                </c:pt>
                <c:pt idx="7">
                  <c:v>20777.25</c:v>
                </c:pt>
                <c:pt idx="8">
                  <c:v>23727.5</c:v>
                </c:pt>
                <c:pt idx="9">
                  <c:v>24114.5</c:v>
                </c:pt>
                <c:pt idx="10">
                  <c:v>22858.75</c:v>
                </c:pt>
                <c:pt idx="11">
                  <c:v>22915</c:v>
                </c:pt>
              </c:numCache>
            </c:numRef>
          </c:val>
          <c:extLst>
            <c:ext xmlns:c16="http://schemas.microsoft.com/office/drawing/2014/chart" uri="{C3380CC4-5D6E-409C-BE32-E72D297353CC}">
              <c16:uniqueId val="{00000000-0989-473E-9FB0-CCB3B17DAA4D}"/>
            </c:ext>
          </c:extLst>
        </c:ser>
        <c:dLbls>
          <c:showLegendKey val="0"/>
          <c:showVal val="0"/>
          <c:showCatName val="0"/>
          <c:showSerName val="0"/>
          <c:showPercent val="0"/>
          <c:showBubbleSize val="0"/>
        </c:dLbls>
        <c:gapWidth val="100"/>
        <c:axId val="1118798928"/>
        <c:axId val="1118804688"/>
      </c:barChart>
      <c:scatterChart>
        <c:scatterStyle val="lineMarker"/>
        <c:varyColors val="0"/>
        <c:ser>
          <c:idx val="1"/>
          <c:order val="1"/>
          <c:spPr>
            <a:ln w="25400" cap="rnd">
              <a:noFill/>
              <a:round/>
            </a:ln>
            <a:effectLst/>
          </c:spPr>
          <c:marker>
            <c:symbol val="circle"/>
            <c:size val="3"/>
            <c:spPr>
              <a:noFill/>
              <a:ln w="3175">
                <a:solidFill>
                  <a:schemeClr val="tx1"/>
                </a:solidFill>
              </a:ln>
              <a:effectLst/>
            </c:spPr>
          </c:marker>
          <c:yVal>
            <c:numRef>
              <c:f>Fig.S1!$AR$12:$BC$12</c:f>
              <c:numCache>
                <c:formatCode>General</c:formatCode>
                <c:ptCount val="12"/>
                <c:pt idx="0">
                  <c:v>22052</c:v>
                </c:pt>
                <c:pt idx="1">
                  <c:v>21938</c:v>
                </c:pt>
                <c:pt idx="2">
                  <c:v>21145</c:v>
                </c:pt>
                <c:pt idx="3">
                  <c:v>20359</c:v>
                </c:pt>
                <c:pt idx="4">
                  <c:v>21497</c:v>
                </c:pt>
                <c:pt idx="5">
                  <c:v>20594</c:v>
                </c:pt>
                <c:pt idx="6">
                  <c:v>20025</c:v>
                </c:pt>
                <c:pt idx="7">
                  <c:v>22058</c:v>
                </c:pt>
                <c:pt idx="8">
                  <c:v>22183</c:v>
                </c:pt>
                <c:pt idx="9">
                  <c:v>22089</c:v>
                </c:pt>
                <c:pt idx="10">
                  <c:v>20941</c:v>
                </c:pt>
                <c:pt idx="11">
                  <c:v>23047</c:v>
                </c:pt>
              </c:numCache>
            </c:numRef>
          </c:yVal>
          <c:smooth val="0"/>
          <c:extLst>
            <c:ext xmlns:c16="http://schemas.microsoft.com/office/drawing/2014/chart" uri="{C3380CC4-5D6E-409C-BE32-E72D297353CC}">
              <c16:uniqueId val="{00000001-0989-473E-9FB0-CCB3B17DAA4D}"/>
            </c:ext>
          </c:extLst>
        </c:ser>
        <c:ser>
          <c:idx val="2"/>
          <c:order val="2"/>
          <c:spPr>
            <a:ln w="25400" cap="rnd">
              <a:noFill/>
              <a:round/>
            </a:ln>
            <a:effectLst/>
          </c:spPr>
          <c:marker>
            <c:symbol val="circle"/>
            <c:size val="3"/>
            <c:spPr>
              <a:noFill/>
              <a:ln w="3175">
                <a:solidFill>
                  <a:schemeClr val="tx1"/>
                </a:solidFill>
              </a:ln>
              <a:effectLst/>
            </c:spPr>
          </c:marker>
          <c:yVal>
            <c:numRef>
              <c:f>Fig.S1!$AR$13:$BC$13</c:f>
              <c:numCache>
                <c:formatCode>General</c:formatCode>
                <c:ptCount val="12"/>
                <c:pt idx="0">
                  <c:v>22390</c:v>
                </c:pt>
                <c:pt idx="1">
                  <c:v>22578</c:v>
                </c:pt>
                <c:pt idx="2">
                  <c:v>22572</c:v>
                </c:pt>
                <c:pt idx="3">
                  <c:v>22571</c:v>
                </c:pt>
                <c:pt idx="4">
                  <c:v>22233</c:v>
                </c:pt>
                <c:pt idx="5">
                  <c:v>19869</c:v>
                </c:pt>
                <c:pt idx="6">
                  <c:v>19799</c:v>
                </c:pt>
                <c:pt idx="7">
                  <c:v>20255</c:v>
                </c:pt>
                <c:pt idx="8">
                  <c:v>24746</c:v>
                </c:pt>
                <c:pt idx="9">
                  <c:v>24536</c:v>
                </c:pt>
                <c:pt idx="10">
                  <c:v>22359</c:v>
                </c:pt>
                <c:pt idx="11">
                  <c:v>22742</c:v>
                </c:pt>
              </c:numCache>
            </c:numRef>
          </c:yVal>
          <c:smooth val="0"/>
          <c:extLst>
            <c:ext xmlns:c16="http://schemas.microsoft.com/office/drawing/2014/chart" uri="{C3380CC4-5D6E-409C-BE32-E72D297353CC}">
              <c16:uniqueId val="{00000002-0989-473E-9FB0-CCB3B17DAA4D}"/>
            </c:ext>
          </c:extLst>
        </c:ser>
        <c:ser>
          <c:idx val="3"/>
          <c:order val="3"/>
          <c:spPr>
            <a:ln w="25400" cap="rnd">
              <a:noFill/>
              <a:round/>
            </a:ln>
            <a:effectLst/>
          </c:spPr>
          <c:marker>
            <c:symbol val="circle"/>
            <c:size val="3"/>
            <c:spPr>
              <a:noFill/>
              <a:ln w="3175">
                <a:solidFill>
                  <a:schemeClr val="tx1"/>
                </a:solidFill>
              </a:ln>
              <a:effectLst/>
            </c:spPr>
          </c:marker>
          <c:yVal>
            <c:numRef>
              <c:f>Fig.S1!$AR$14:$BC$14</c:f>
              <c:numCache>
                <c:formatCode>General</c:formatCode>
                <c:ptCount val="12"/>
                <c:pt idx="0">
                  <c:v>24502</c:v>
                </c:pt>
                <c:pt idx="1">
                  <c:v>20189</c:v>
                </c:pt>
                <c:pt idx="2">
                  <c:v>22602</c:v>
                </c:pt>
                <c:pt idx="3">
                  <c:v>23749</c:v>
                </c:pt>
                <c:pt idx="4">
                  <c:v>21047</c:v>
                </c:pt>
                <c:pt idx="5">
                  <c:v>19222</c:v>
                </c:pt>
                <c:pt idx="6">
                  <c:v>19121</c:v>
                </c:pt>
                <c:pt idx="7">
                  <c:v>18457</c:v>
                </c:pt>
                <c:pt idx="8">
                  <c:v>24219</c:v>
                </c:pt>
                <c:pt idx="9">
                  <c:v>25677</c:v>
                </c:pt>
                <c:pt idx="10">
                  <c:v>23956</c:v>
                </c:pt>
                <c:pt idx="11">
                  <c:v>22464</c:v>
                </c:pt>
              </c:numCache>
            </c:numRef>
          </c:yVal>
          <c:smooth val="0"/>
          <c:extLst>
            <c:ext xmlns:c16="http://schemas.microsoft.com/office/drawing/2014/chart" uri="{C3380CC4-5D6E-409C-BE32-E72D297353CC}">
              <c16:uniqueId val="{00000003-0989-473E-9FB0-CCB3B17DAA4D}"/>
            </c:ext>
          </c:extLst>
        </c:ser>
        <c:ser>
          <c:idx val="4"/>
          <c:order val="4"/>
          <c:spPr>
            <a:ln w="25400" cap="rnd">
              <a:noFill/>
              <a:round/>
            </a:ln>
            <a:effectLst/>
          </c:spPr>
          <c:marker>
            <c:symbol val="circle"/>
            <c:size val="3"/>
            <c:spPr>
              <a:noFill/>
              <a:ln w="3175">
                <a:solidFill>
                  <a:schemeClr val="tx1"/>
                </a:solidFill>
              </a:ln>
              <a:effectLst/>
            </c:spPr>
          </c:marker>
          <c:yVal>
            <c:numRef>
              <c:f>Fig.S1!$AR$15:$BC$15</c:f>
              <c:numCache>
                <c:formatCode>General</c:formatCode>
                <c:ptCount val="12"/>
                <c:pt idx="0">
                  <c:v>24965</c:v>
                </c:pt>
                <c:pt idx="1">
                  <c:v>23171</c:v>
                </c:pt>
                <c:pt idx="2">
                  <c:v>22368</c:v>
                </c:pt>
                <c:pt idx="3">
                  <c:v>22397</c:v>
                </c:pt>
                <c:pt idx="4">
                  <c:v>23300</c:v>
                </c:pt>
                <c:pt idx="5">
                  <c:v>21831</c:v>
                </c:pt>
                <c:pt idx="6">
                  <c:v>21348</c:v>
                </c:pt>
                <c:pt idx="7">
                  <c:v>22339</c:v>
                </c:pt>
                <c:pt idx="8">
                  <c:v>23762</c:v>
                </c:pt>
                <c:pt idx="9">
                  <c:v>24156</c:v>
                </c:pt>
                <c:pt idx="10">
                  <c:v>24179</c:v>
                </c:pt>
                <c:pt idx="11">
                  <c:v>23407</c:v>
                </c:pt>
              </c:numCache>
            </c:numRef>
          </c:yVal>
          <c:smooth val="0"/>
          <c:extLst>
            <c:ext xmlns:c16="http://schemas.microsoft.com/office/drawing/2014/chart" uri="{C3380CC4-5D6E-409C-BE32-E72D297353CC}">
              <c16:uniqueId val="{00000004-0989-473E-9FB0-CCB3B17DAA4D}"/>
            </c:ext>
          </c:extLst>
        </c:ser>
        <c:dLbls>
          <c:showLegendKey val="0"/>
          <c:showVal val="0"/>
          <c:showCatName val="0"/>
          <c:showSerName val="0"/>
          <c:showPercent val="0"/>
          <c:showBubbleSize val="0"/>
        </c:dLbls>
        <c:axId val="1118798928"/>
        <c:axId val="1118804688"/>
      </c:scatterChart>
      <c:catAx>
        <c:axId val="1118798928"/>
        <c:scaling>
          <c:orientation val="minMax"/>
        </c:scaling>
        <c:delete val="1"/>
        <c:axPos val="b"/>
        <c:numFmt formatCode="General" sourceLinked="1"/>
        <c:majorTickMark val="none"/>
        <c:minorTickMark val="none"/>
        <c:tickLblPos val="nextTo"/>
        <c:crossAx val="1118804688"/>
        <c:crosses val="autoZero"/>
        <c:auto val="1"/>
        <c:lblAlgn val="ctr"/>
        <c:lblOffset val="100"/>
        <c:noMultiLvlLbl val="0"/>
      </c:catAx>
      <c:valAx>
        <c:axId val="1118804688"/>
        <c:scaling>
          <c:orientation val="minMax"/>
        </c:scaling>
        <c:delete val="1"/>
        <c:axPos val="l"/>
        <c:numFmt formatCode="General" sourceLinked="1"/>
        <c:majorTickMark val="none"/>
        <c:minorTickMark val="none"/>
        <c:tickLblPos val="nextTo"/>
        <c:crossAx val="111879892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4336" cy="496809"/>
          </a:xfrm>
          <a:prstGeom prst="rect">
            <a:avLst/>
          </a:prstGeom>
        </p:spPr>
        <p:txBody>
          <a:bodyPr vert="horz" lIns="91403" tIns="45702" rIns="91403" bIns="45702" rtlCol="0"/>
          <a:lstStyle>
            <a:lvl1pPr algn="l">
              <a:defRPr sz="1200"/>
            </a:lvl1pPr>
          </a:lstStyle>
          <a:p>
            <a:endParaRPr kumimoji="1" lang="ja-JP" altLang="en-US"/>
          </a:p>
        </p:txBody>
      </p:sp>
      <p:sp>
        <p:nvSpPr>
          <p:cNvPr id="3" name="日付プレースホルダー 2"/>
          <p:cNvSpPr>
            <a:spLocks noGrp="1"/>
          </p:cNvSpPr>
          <p:nvPr>
            <p:ph type="dt" idx="1"/>
          </p:nvPr>
        </p:nvSpPr>
        <p:spPr>
          <a:xfrm>
            <a:off x="3846991" y="0"/>
            <a:ext cx="2944336" cy="496809"/>
          </a:xfrm>
          <a:prstGeom prst="rect">
            <a:avLst/>
          </a:prstGeom>
        </p:spPr>
        <p:txBody>
          <a:bodyPr vert="horz" lIns="91403" tIns="45702" rIns="91403" bIns="45702" rtlCol="0"/>
          <a:lstStyle>
            <a:lvl1pPr algn="r">
              <a:defRPr sz="1200"/>
            </a:lvl1pPr>
          </a:lstStyle>
          <a:p>
            <a:fld id="{671B49E1-9DA7-CF41-8F38-ADD4CF890694}" type="datetimeFigureOut">
              <a:rPr kumimoji="1" lang="ja-JP" altLang="en-US" smtClean="0"/>
              <a:t>2026/4/15</a:t>
            </a:fld>
            <a:endParaRPr kumimoji="1" lang="ja-JP" altLang="en-US"/>
          </a:p>
        </p:txBody>
      </p:sp>
      <p:sp>
        <p:nvSpPr>
          <p:cNvPr id="4" name="スライド イメージ プレースホルダー 3"/>
          <p:cNvSpPr>
            <a:spLocks noGrp="1" noRot="1" noChangeAspect="1"/>
          </p:cNvSpPr>
          <p:nvPr>
            <p:ph type="sldImg" idx="2"/>
          </p:nvPr>
        </p:nvSpPr>
        <p:spPr>
          <a:xfrm>
            <a:off x="2141538" y="1241425"/>
            <a:ext cx="2509837" cy="3349625"/>
          </a:xfrm>
          <a:prstGeom prst="rect">
            <a:avLst/>
          </a:prstGeom>
          <a:noFill/>
          <a:ln w="12700">
            <a:solidFill>
              <a:prstClr val="black"/>
            </a:solidFill>
          </a:ln>
        </p:spPr>
        <p:txBody>
          <a:bodyPr vert="horz" lIns="91403" tIns="45702" rIns="91403" bIns="45702" rtlCol="0" anchor="ctr"/>
          <a:lstStyle/>
          <a:p>
            <a:endParaRPr lang="ja-JP" altLang="en-US"/>
          </a:p>
        </p:txBody>
      </p:sp>
      <p:sp>
        <p:nvSpPr>
          <p:cNvPr id="5" name="ノート プレースホルダー 4"/>
          <p:cNvSpPr>
            <a:spLocks noGrp="1"/>
          </p:cNvSpPr>
          <p:nvPr>
            <p:ph type="body" sz="quarter" idx="3"/>
          </p:nvPr>
        </p:nvSpPr>
        <p:spPr>
          <a:xfrm>
            <a:off x="678974" y="4776024"/>
            <a:ext cx="5434965" cy="3907800"/>
          </a:xfrm>
          <a:prstGeom prst="rect">
            <a:avLst/>
          </a:prstGeom>
        </p:spPr>
        <p:txBody>
          <a:bodyPr vert="horz" lIns="91403" tIns="45702" rIns="91403" bIns="45702"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8241"/>
            <a:ext cx="2944336" cy="496809"/>
          </a:xfrm>
          <a:prstGeom prst="rect">
            <a:avLst/>
          </a:prstGeom>
        </p:spPr>
        <p:txBody>
          <a:bodyPr vert="horz" lIns="91403" tIns="45702" rIns="91403" bIns="45702"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46991" y="9428241"/>
            <a:ext cx="2944336" cy="496809"/>
          </a:xfrm>
          <a:prstGeom prst="rect">
            <a:avLst/>
          </a:prstGeom>
        </p:spPr>
        <p:txBody>
          <a:bodyPr vert="horz" lIns="91403" tIns="45702" rIns="91403" bIns="45702" rtlCol="0" anchor="b"/>
          <a:lstStyle>
            <a:lvl1pPr algn="r">
              <a:defRPr sz="1200"/>
            </a:lvl1pPr>
          </a:lstStyle>
          <a:p>
            <a:fld id="{7F37041C-9C9F-0542-9320-4ABB0B3E1A57}" type="slidenum">
              <a:rPr kumimoji="1" lang="ja-JP" altLang="en-US" smtClean="0"/>
              <a:t>‹#›</a:t>
            </a:fld>
            <a:endParaRPr kumimoji="1" lang="ja-JP" altLang="en-US"/>
          </a:p>
        </p:txBody>
      </p:sp>
    </p:spTree>
    <p:extLst>
      <p:ext uri="{BB962C8B-B14F-4D97-AF65-F5344CB8AC3E}">
        <p14:creationId xmlns:p14="http://schemas.microsoft.com/office/powerpoint/2010/main" val="182624124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CB96062-40E4-2D74-ADE3-8C4A209305D9}"/>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EDC162A0-D189-3AF6-8FF2-7F2CB0D5F23E}"/>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B4F5A47F-1D11-87A5-499C-AECAC9468056}"/>
              </a:ext>
            </a:extLst>
          </p:cNvPr>
          <p:cNvSpPr>
            <a:spLocks noGrp="1"/>
          </p:cNvSpPr>
          <p:nvPr>
            <p:ph type="body" idx="1"/>
          </p:nvPr>
        </p:nvSpPr>
        <p:spPr/>
        <p:txBody>
          <a:bodyPr/>
          <a:lstStyle/>
          <a:p>
            <a:r>
              <a:rPr kumimoji="1" lang="en-US" altLang="ja-JP" sz="1200" dirty="0">
                <a:latin typeface="Arial" panose="020B0604020202020204" pitchFamily="34" charset="0"/>
                <a:cs typeface="Arial" panose="020B0604020202020204" pitchFamily="34" charset="0"/>
              </a:rPr>
              <a:t>(A)</a:t>
            </a:r>
            <a:r>
              <a:rPr kumimoji="1" lang="ja-JP" altLang="en-US" sz="1200" dirty="0">
                <a:latin typeface="Arial" panose="020B0604020202020204" pitchFamily="34" charset="0"/>
                <a:cs typeface="Arial" panose="020B0604020202020204" pitchFamily="34" charset="0"/>
              </a:rPr>
              <a:t>シロイヌナズナ・イネ・ダイズのリン酸化プロテオームの結果、</a:t>
            </a:r>
            <a:r>
              <a:rPr kumimoji="1" lang="en-US" altLang="ja-JP" sz="1200" dirty="0">
                <a:latin typeface="Arial" panose="020B0604020202020204" pitchFamily="34" charset="0"/>
                <a:cs typeface="Arial" panose="020B0604020202020204" pitchFamily="34" charset="0"/>
              </a:rPr>
              <a:t>12721, 10215, 13963</a:t>
            </a:r>
            <a:r>
              <a:rPr kumimoji="1" lang="ja-JP" altLang="en-US" sz="1200" dirty="0">
                <a:latin typeface="Arial" panose="020B0604020202020204" pitchFamily="34" charset="0"/>
                <a:cs typeface="Arial" panose="020B0604020202020204" pitchFamily="34" charset="0"/>
              </a:rPr>
              <a:t>種類のタンパク質由来の</a:t>
            </a:r>
            <a:r>
              <a:rPr kumimoji="1" lang="en-US" altLang="ja-JP" sz="1200" dirty="0">
                <a:latin typeface="Arial" panose="020B0604020202020204" pitchFamily="34" charset="0"/>
                <a:cs typeface="Arial" panose="020B0604020202020204" pitchFamily="34" charset="0"/>
              </a:rPr>
              <a:t>34767, 31831, 39918</a:t>
            </a:r>
            <a:r>
              <a:rPr kumimoji="1" lang="ja-JP" altLang="en-US" sz="1200" dirty="0">
                <a:latin typeface="Arial" panose="020B0604020202020204" pitchFamily="34" charset="0"/>
                <a:cs typeface="Arial" panose="020B0604020202020204" pitchFamily="34" charset="0"/>
              </a:rPr>
              <a:t>種類のペプチドを同定した。</a:t>
            </a:r>
            <a:r>
              <a:rPr kumimoji="1" lang="en-US" altLang="ja-JP" sz="1200" dirty="0">
                <a:latin typeface="Arial" panose="020B0604020202020204" pitchFamily="34" charset="0"/>
                <a:cs typeface="Arial" panose="020B0604020202020204" pitchFamily="34" charset="0"/>
              </a:rPr>
              <a:t>24604, 18865, 24930</a:t>
            </a:r>
            <a:r>
              <a:rPr kumimoji="1" lang="ja-JP" altLang="en-US" sz="1200" dirty="0">
                <a:latin typeface="Arial" panose="020B0604020202020204" pitchFamily="34" charset="0"/>
                <a:cs typeface="Arial" panose="020B0604020202020204" pitchFamily="34" charset="0"/>
              </a:rPr>
              <a:t>種類のリン酸化ペプチドを同定した。同定したペプチドのうち、</a:t>
            </a:r>
            <a:r>
              <a:rPr kumimoji="1" lang="en-US" altLang="ja-JP" sz="1200" dirty="0">
                <a:latin typeface="Arial" panose="020B0604020202020204" pitchFamily="34" charset="0"/>
                <a:cs typeface="Arial" panose="020B0604020202020204" pitchFamily="34" charset="0"/>
              </a:rPr>
              <a:t>71%, 59%, 62%</a:t>
            </a:r>
            <a:r>
              <a:rPr kumimoji="1" lang="ja-JP" altLang="en-US" sz="1200" dirty="0">
                <a:latin typeface="Arial" panose="020B0604020202020204" pitchFamily="34" charset="0"/>
                <a:cs typeface="Arial" panose="020B0604020202020204" pitchFamily="34" charset="0"/>
              </a:rPr>
              <a:t>がリン酸化ペプチドだった。</a:t>
            </a:r>
            <a:endParaRPr kumimoji="1" lang="en-US" altLang="ja-JP" sz="1200" dirty="0">
              <a:latin typeface="Arial" panose="020B0604020202020204" pitchFamily="34" charset="0"/>
              <a:cs typeface="Arial" panose="020B0604020202020204" pitchFamily="34" charset="0"/>
            </a:endParaRPr>
          </a:p>
          <a:p>
            <a:r>
              <a:rPr kumimoji="1" lang="en-US" altLang="ja-JP" sz="1200" dirty="0">
                <a:latin typeface="Arial" panose="020B0604020202020204" pitchFamily="34" charset="0"/>
                <a:cs typeface="Arial" panose="020B0604020202020204" pitchFamily="34" charset="0"/>
              </a:rPr>
              <a:t>(B)</a:t>
            </a:r>
            <a:r>
              <a:rPr kumimoji="1" lang="ja-JP" altLang="en-US" sz="1200" dirty="0">
                <a:latin typeface="Arial" panose="020B0604020202020204" pitchFamily="34" charset="0"/>
                <a:cs typeface="Arial" panose="020B0604020202020204" pitchFamily="34" charset="0"/>
              </a:rPr>
              <a:t>シロイヌナズナ・イネ・ダイズのリン酸化セリン、スレオニン、チロシン残基の比率はそれぞれ</a:t>
            </a:r>
            <a:r>
              <a:rPr kumimoji="1" lang="en-US" altLang="ja-JP" sz="1200" dirty="0">
                <a:latin typeface="Arial" panose="020B0604020202020204" pitchFamily="34" charset="0"/>
                <a:cs typeface="Arial" panose="020B0604020202020204" pitchFamily="34" charset="0"/>
              </a:rPr>
              <a:t>88.0:11.7:0.3</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7.5:12.0:0.5</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8.7:11.0:0.3</a:t>
            </a:r>
            <a:r>
              <a:rPr kumimoji="1" lang="ja-JP" altLang="en-US" sz="1200" dirty="0">
                <a:latin typeface="Arial" panose="020B0604020202020204" pitchFamily="34" charset="0"/>
                <a:cs typeface="Arial" panose="020B0604020202020204" pitchFamily="34" charset="0"/>
              </a:rPr>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r>
              <a:rPr kumimoji="1" lang="en-US" altLang="ja-JP" dirty="0"/>
              <a:t>(C)</a:t>
            </a:r>
            <a:r>
              <a:rPr kumimoji="1" lang="ja-JP" altLang="en-US" sz="1200" dirty="0">
                <a:latin typeface="Arial" panose="020B0604020202020204" pitchFamily="34" charset="0"/>
                <a:cs typeface="Arial" panose="020B0604020202020204" pitchFamily="34" charset="0"/>
              </a:rPr>
              <a:t>シロイヌナズナ・イネ・ダイズの</a:t>
            </a:r>
            <a:r>
              <a:rPr kumimoji="1" lang="ja-JP" altLang="en-US" dirty="0"/>
              <a:t>ペプチドあたりのリン酸化部位数</a:t>
            </a:r>
            <a:r>
              <a:rPr kumimoji="1" lang="en-US" altLang="ja-JP" dirty="0"/>
              <a:t>1:2:3</a:t>
            </a:r>
            <a:r>
              <a:rPr kumimoji="1" lang="ja-JP" altLang="en-US" dirty="0"/>
              <a:t>の比率はそれぞれ</a:t>
            </a:r>
            <a:r>
              <a:rPr kumimoji="1" lang="en-US" altLang="ja-JP" dirty="0"/>
              <a:t>78.7:17.3:4.0</a:t>
            </a:r>
            <a:r>
              <a:rPr kumimoji="1" lang="ja-JP" altLang="en-US" dirty="0"/>
              <a:t>、</a:t>
            </a:r>
            <a:r>
              <a:rPr kumimoji="1" lang="en-US" altLang="ja-JP" dirty="0"/>
              <a:t>76.4:18.4:5.2</a:t>
            </a:r>
            <a:r>
              <a:rPr kumimoji="1" lang="ja-JP" altLang="en-US" dirty="0"/>
              <a:t>、</a:t>
            </a:r>
            <a:r>
              <a:rPr kumimoji="1" lang="en-US" altLang="ja-JP" dirty="0"/>
              <a:t>79.0:17.0:4.0</a:t>
            </a:r>
            <a:r>
              <a:rPr kumimoji="1" lang="ja-JP" altLang="en-US" dirty="0"/>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endParaRPr kumimoji="1" lang="en-US" altLang="ja-JP" sz="1200" dirty="0">
              <a:latin typeface="Arial" panose="020B0604020202020204" pitchFamily="34" charset="0"/>
              <a:cs typeface="Arial" panose="020B0604020202020204" pitchFamily="34" charset="0"/>
            </a:endParaRPr>
          </a:p>
          <a:p>
            <a:r>
              <a:rPr kumimoji="1" lang="ja-JP" altLang="en-US" sz="1200" dirty="0">
                <a:latin typeface="Arial" panose="020B0604020202020204" pitchFamily="34" charset="0"/>
                <a:cs typeface="Arial" panose="020B0604020202020204" pitchFamily="34" charset="0"/>
              </a:rPr>
              <a:t>考察：</a:t>
            </a:r>
            <a:endParaRPr kumimoji="1" lang="en-US" altLang="ja-JP" sz="1200" dirty="0">
              <a:latin typeface="Arial" panose="020B0604020202020204" pitchFamily="34" charset="0"/>
              <a:cs typeface="Arial" panose="020B0604020202020204" pitchFamily="34" charset="0"/>
            </a:endParaRPr>
          </a:p>
          <a:p>
            <a:r>
              <a:rPr kumimoji="1" lang="ja-JP" altLang="en-US"/>
              <a:t>シロイヌナズナ実生を用いた最近のリン酸化プロテオーム研究の例として、</a:t>
            </a:r>
            <a:r>
              <a:rPr kumimoji="1" lang="en-US" altLang="ja-JP" dirty="0"/>
              <a:t>2023</a:t>
            </a:r>
            <a:r>
              <a:rPr kumimoji="1" lang="ja-JP" altLang="en-US"/>
              <a:t>年に、初期の</a:t>
            </a:r>
            <a:r>
              <a:rPr kumimoji="1" lang="en" altLang="ja-JP" dirty="0"/>
              <a:t>ABA</a:t>
            </a:r>
            <a:r>
              <a:rPr kumimoji="1" lang="ja-JP" altLang="en-US"/>
              <a:t>シグナル伝達が</a:t>
            </a:r>
            <a:r>
              <a:rPr kumimoji="1" lang="en" altLang="ja-JP" dirty="0"/>
              <a:t>CASEIN KINASE 1-LIKE PROTEIN 2</a:t>
            </a:r>
            <a:r>
              <a:rPr kumimoji="1" lang="ja-JP" altLang="en"/>
              <a:t>（</a:t>
            </a:r>
            <a:r>
              <a:rPr kumimoji="1" lang="en" altLang="ja-JP" dirty="0"/>
              <a:t>CKL2</a:t>
            </a:r>
            <a:r>
              <a:rPr kumimoji="1" lang="ja-JP" altLang="en"/>
              <a:t>）</a:t>
            </a:r>
            <a:r>
              <a:rPr kumimoji="1" lang="ja-JP" altLang="en-US"/>
              <a:t>を介してブラジノステロイド（</a:t>
            </a:r>
            <a:r>
              <a:rPr kumimoji="1" lang="en" altLang="ja-JP" dirty="0"/>
              <a:t>BR</a:t>
            </a:r>
            <a:r>
              <a:rPr kumimoji="1" lang="ja-JP" altLang="en"/>
              <a:t>）</a:t>
            </a:r>
            <a:r>
              <a:rPr kumimoji="1" lang="ja-JP" altLang="en-US"/>
              <a:t>シグナル伝達の上流成分を活性化することが報告されている。この研究で行われたリン酸化プロテオーム解析では、</a:t>
            </a:r>
            <a:r>
              <a:rPr kumimoji="1" lang="en-US" altLang="ja-JP" dirty="0"/>
              <a:t>13,295</a:t>
            </a:r>
            <a:r>
              <a:rPr kumimoji="1" lang="ja-JP" altLang="en-US"/>
              <a:t>種類のペプチドが同定され、そのうち</a:t>
            </a:r>
            <a:r>
              <a:rPr kumimoji="1" lang="en-US" altLang="ja-JP" dirty="0"/>
              <a:t>10,768</a:t>
            </a:r>
            <a:r>
              <a:rPr kumimoji="1" lang="ja-JP" altLang="en-US"/>
              <a:t>がリン酸化ペプチドだった</a:t>
            </a:r>
            <a:r>
              <a:rPr kumimoji="1" lang="en-US" altLang="ja-JP" dirty="0"/>
              <a:t>(https://</a:t>
            </a:r>
            <a:r>
              <a:rPr kumimoji="1" lang="en-US" altLang="ja-JP" dirty="0" err="1"/>
              <a:t>onlinelibrary.wiley.com</a:t>
            </a:r>
            <a:r>
              <a:rPr kumimoji="1" lang="en-US" altLang="ja-JP" dirty="0"/>
              <a:t>/</a:t>
            </a:r>
            <a:r>
              <a:rPr kumimoji="1" lang="en-US" altLang="ja-JP" dirty="0" err="1"/>
              <a:t>doi</a:t>
            </a:r>
            <a:r>
              <a:rPr kumimoji="1" lang="en-US" altLang="ja-JP" dirty="0"/>
              <a:t>/10.1111/jipb.13397)</a:t>
            </a:r>
            <a:r>
              <a:rPr kumimoji="1" lang="ja-JP" altLang="en-US"/>
              <a:t>。その研究と比較すると、約</a:t>
            </a:r>
            <a:r>
              <a:rPr kumimoji="1" lang="en-US" altLang="ja-JP" dirty="0"/>
              <a:t>2.6</a:t>
            </a:r>
            <a:r>
              <a:rPr kumimoji="1" lang="ja-JP" altLang="en-US"/>
              <a:t>倍のペプチド種数と約</a:t>
            </a:r>
            <a:r>
              <a:rPr kumimoji="1" lang="en-US" altLang="ja-JP" dirty="0"/>
              <a:t>2.3</a:t>
            </a:r>
            <a:r>
              <a:rPr kumimoji="1" lang="ja-JP" altLang="en-US"/>
              <a:t>倍のリン酸化ペプチド種数を同定することができた。</a:t>
            </a:r>
            <a:endParaRPr kumimoji="1" lang="en-US" altLang="ja-JP" dirty="0"/>
          </a:p>
          <a:p>
            <a:r>
              <a:rPr kumimoji="1" lang="ja-JP" altLang="en-US"/>
              <a:t>一方でイネでは、</a:t>
            </a:r>
            <a:r>
              <a:rPr kumimoji="1" lang="en-US" altLang="ja-JP" dirty="0"/>
              <a:t>2017</a:t>
            </a:r>
            <a:r>
              <a:rPr kumimoji="1" lang="ja-JP" altLang="en-US"/>
              <a:t>年に</a:t>
            </a:r>
            <a:r>
              <a:rPr kumimoji="1" lang="en" altLang="ja-JP" dirty="0"/>
              <a:t>ABA</a:t>
            </a:r>
            <a:r>
              <a:rPr kumimoji="1" lang="ja-JP" altLang="en-US"/>
              <a:t>応答をリン酸化プロテオミクスで調べられているが、当時は</a:t>
            </a:r>
            <a:r>
              <a:rPr kumimoji="1" lang="en-US" altLang="ja-JP" dirty="0"/>
              <a:t>2162</a:t>
            </a:r>
            <a:r>
              <a:rPr kumimoji="1" lang="ja-JP" altLang="en-US"/>
              <a:t>種類のリン酸化ペプチドが同定されていた。今回我々は</a:t>
            </a:r>
            <a:r>
              <a:rPr kumimoji="1" lang="en-US" altLang="ja-JP" dirty="0"/>
              <a:t>18865</a:t>
            </a:r>
            <a:r>
              <a:rPr kumimoji="1" lang="ja-JP" altLang="en-US"/>
              <a:t>種類（約</a:t>
            </a:r>
            <a:r>
              <a:rPr kumimoji="1" lang="en-US" altLang="ja-JP" dirty="0"/>
              <a:t>8.7</a:t>
            </a:r>
            <a:r>
              <a:rPr kumimoji="1" lang="ja-JP" altLang="en-US"/>
              <a:t>倍）のリン酸化ペプチドを同定することができた。</a:t>
            </a:r>
            <a:endParaRPr kumimoji="1" lang="en-US" altLang="ja-JP" dirty="0"/>
          </a:p>
          <a:p>
            <a:r>
              <a:rPr kumimoji="1" lang="ja-JP" altLang="en-US"/>
              <a:t>ダイズのリン酸化プロテオーム研究では、</a:t>
            </a:r>
            <a:endParaRPr kumimoji="1" lang="ja-JP" altLang="en"/>
          </a:p>
        </p:txBody>
      </p:sp>
      <p:sp>
        <p:nvSpPr>
          <p:cNvPr id="4" name="スライド番号プレースホルダー 3">
            <a:extLst>
              <a:ext uri="{FF2B5EF4-FFF2-40B4-BE49-F238E27FC236}">
                <a16:creationId xmlns:a16="http://schemas.microsoft.com/office/drawing/2014/main" id="{D4F39F53-57A0-ADA1-D589-F1193BE5A894}"/>
              </a:ext>
            </a:extLst>
          </p:cNvPr>
          <p:cNvSpPr>
            <a:spLocks noGrp="1"/>
          </p:cNvSpPr>
          <p:nvPr>
            <p:ph type="sldNum" sz="quarter" idx="5"/>
          </p:nvPr>
        </p:nvSpPr>
        <p:spPr/>
        <p:txBody>
          <a:bodyPr/>
          <a:lstStyle/>
          <a:p>
            <a:fld id="{7F37041C-9C9F-0542-9320-4ABB0B3E1A57}" type="slidenum">
              <a:rPr kumimoji="1" lang="ja-JP" altLang="en-US" smtClean="0"/>
              <a:t>2</a:t>
            </a:fld>
            <a:endParaRPr kumimoji="1" lang="ja-JP" altLang="en-US"/>
          </a:p>
        </p:txBody>
      </p:sp>
    </p:spTree>
    <p:extLst>
      <p:ext uri="{BB962C8B-B14F-4D97-AF65-F5344CB8AC3E}">
        <p14:creationId xmlns:p14="http://schemas.microsoft.com/office/powerpoint/2010/main" val="34725816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1C4AE72-CF1E-9386-7D1A-722BF73F4396}"/>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B326D8C7-0371-1908-965D-2163F25DBDFD}"/>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AE12F3DC-1660-D8F7-5715-615A4458445D}"/>
              </a:ext>
            </a:extLst>
          </p:cNvPr>
          <p:cNvSpPr>
            <a:spLocks noGrp="1"/>
          </p:cNvSpPr>
          <p:nvPr>
            <p:ph type="body" idx="1"/>
          </p:nvPr>
        </p:nvSpPr>
        <p:spPr/>
        <p:txBody>
          <a:bodyPr/>
          <a:lstStyle/>
          <a:p>
            <a:r>
              <a:rPr kumimoji="1" lang="en-US" altLang="ja-JP" sz="1200" dirty="0">
                <a:latin typeface="Arial" panose="020B0604020202020204" pitchFamily="34" charset="0"/>
                <a:cs typeface="Arial" panose="020B0604020202020204" pitchFamily="34" charset="0"/>
              </a:rPr>
              <a:t>(A)</a:t>
            </a:r>
            <a:r>
              <a:rPr kumimoji="1" lang="ja-JP" altLang="en-US" sz="1200" dirty="0">
                <a:latin typeface="Arial" panose="020B0604020202020204" pitchFamily="34" charset="0"/>
                <a:cs typeface="Arial" panose="020B0604020202020204" pitchFamily="34" charset="0"/>
              </a:rPr>
              <a:t>シロイヌナズナ・イネ・ダイズのリン酸化プロテオームの結果、</a:t>
            </a:r>
            <a:r>
              <a:rPr kumimoji="1" lang="en-US" altLang="ja-JP" sz="1200" dirty="0">
                <a:latin typeface="Arial" panose="020B0604020202020204" pitchFamily="34" charset="0"/>
                <a:cs typeface="Arial" panose="020B0604020202020204" pitchFamily="34" charset="0"/>
              </a:rPr>
              <a:t>12721, 10215, 13963</a:t>
            </a:r>
            <a:r>
              <a:rPr kumimoji="1" lang="ja-JP" altLang="en-US" sz="1200" dirty="0">
                <a:latin typeface="Arial" panose="020B0604020202020204" pitchFamily="34" charset="0"/>
                <a:cs typeface="Arial" panose="020B0604020202020204" pitchFamily="34" charset="0"/>
              </a:rPr>
              <a:t>種類のタンパク質由来の</a:t>
            </a:r>
            <a:r>
              <a:rPr kumimoji="1" lang="en-US" altLang="ja-JP" sz="1200" dirty="0">
                <a:latin typeface="Arial" panose="020B0604020202020204" pitchFamily="34" charset="0"/>
                <a:cs typeface="Arial" panose="020B0604020202020204" pitchFamily="34" charset="0"/>
              </a:rPr>
              <a:t>34767, 31831, 39918</a:t>
            </a:r>
            <a:r>
              <a:rPr kumimoji="1" lang="ja-JP" altLang="en-US" sz="1200" dirty="0">
                <a:latin typeface="Arial" panose="020B0604020202020204" pitchFamily="34" charset="0"/>
                <a:cs typeface="Arial" panose="020B0604020202020204" pitchFamily="34" charset="0"/>
              </a:rPr>
              <a:t>種類のペプチドを同定した。</a:t>
            </a:r>
            <a:r>
              <a:rPr kumimoji="1" lang="en-US" altLang="ja-JP" sz="1200" dirty="0">
                <a:latin typeface="Arial" panose="020B0604020202020204" pitchFamily="34" charset="0"/>
                <a:cs typeface="Arial" panose="020B0604020202020204" pitchFamily="34" charset="0"/>
              </a:rPr>
              <a:t>24604, 18865, 24930</a:t>
            </a:r>
            <a:r>
              <a:rPr kumimoji="1" lang="ja-JP" altLang="en-US" sz="1200" dirty="0">
                <a:latin typeface="Arial" panose="020B0604020202020204" pitchFamily="34" charset="0"/>
                <a:cs typeface="Arial" panose="020B0604020202020204" pitchFamily="34" charset="0"/>
              </a:rPr>
              <a:t>種類のリン酸化ペプチドを同定した。同定したペプチドのうち、</a:t>
            </a:r>
            <a:r>
              <a:rPr kumimoji="1" lang="en-US" altLang="ja-JP" sz="1200" dirty="0">
                <a:latin typeface="Arial" panose="020B0604020202020204" pitchFamily="34" charset="0"/>
                <a:cs typeface="Arial" panose="020B0604020202020204" pitchFamily="34" charset="0"/>
              </a:rPr>
              <a:t>71%, 59%, 62%</a:t>
            </a:r>
            <a:r>
              <a:rPr kumimoji="1" lang="ja-JP" altLang="en-US" sz="1200" dirty="0">
                <a:latin typeface="Arial" panose="020B0604020202020204" pitchFamily="34" charset="0"/>
                <a:cs typeface="Arial" panose="020B0604020202020204" pitchFamily="34" charset="0"/>
              </a:rPr>
              <a:t>がリン酸化ペプチドだった。</a:t>
            </a:r>
            <a:endParaRPr kumimoji="1" lang="en-US" altLang="ja-JP" sz="1200" dirty="0">
              <a:latin typeface="Arial" panose="020B0604020202020204" pitchFamily="34" charset="0"/>
              <a:cs typeface="Arial" panose="020B0604020202020204" pitchFamily="34" charset="0"/>
            </a:endParaRPr>
          </a:p>
          <a:p>
            <a:r>
              <a:rPr kumimoji="1" lang="en-US" altLang="ja-JP" sz="1200" dirty="0">
                <a:latin typeface="Arial" panose="020B0604020202020204" pitchFamily="34" charset="0"/>
                <a:cs typeface="Arial" panose="020B0604020202020204" pitchFamily="34" charset="0"/>
              </a:rPr>
              <a:t>(B)</a:t>
            </a:r>
            <a:r>
              <a:rPr kumimoji="1" lang="ja-JP" altLang="en-US" sz="1200" dirty="0">
                <a:latin typeface="Arial" panose="020B0604020202020204" pitchFamily="34" charset="0"/>
                <a:cs typeface="Arial" panose="020B0604020202020204" pitchFamily="34" charset="0"/>
              </a:rPr>
              <a:t>シロイヌナズナ・イネ・ダイズのリン酸化セリン、スレオニン、チロシン残基の比率はそれぞれ</a:t>
            </a:r>
            <a:r>
              <a:rPr kumimoji="1" lang="en-US" altLang="ja-JP" sz="1200" dirty="0">
                <a:latin typeface="Arial" panose="020B0604020202020204" pitchFamily="34" charset="0"/>
                <a:cs typeface="Arial" panose="020B0604020202020204" pitchFamily="34" charset="0"/>
              </a:rPr>
              <a:t>88.0:11.7:0.3</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7.5:12.0:0.5</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8.7:11.0:0.3</a:t>
            </a:r>
            <a:r>
              <a:rPr kumimoji="1" lang="ja-JP" altLang="en-US" sz="1200" dirty="0">
                <a:latin typeface="Arial" panose="020B0604020202020204" pitchFamily="34" charset="0"/>
                <a:cs typeface="Arial" panose="020B0604020202020204" pitchFamily="34" charset="0"/>
              </a:rPr>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r>
              <a:rPr kumimoji="1" lang="en-US" altLang="ja-JP" dirty="0"/>
              <a:t>(C)</a:t>
            </a:r>
            <a:r>
              <a:rPr kumimoji="1" lang="ja-JP" altLang="en-US" sz="1200" dirty="0">
                <a:latin typeface="Arial" panose="020B0604020202020204" pitchFamily="34" charset="0"/>
                <a:cs typeface="Arial" panose="020B0604020202020204" pitchFamily="34" charset="0"/>
              </a:rPr>
              <a:t>シロイヌナズナ・イネ・ダイズの</a:t>
            </a:r>
            <a:r>
              <a:rPr kumimoji="1" lang="ja-JP" altLang="en-US" dirty="0"/>
              <a:t>ペプチドあたりのリン酸化部位数</a:t>
            </a:r>
            <a:r>
              <a:rPr kumimoji="1" lang="en-US" altLang="ja-JP" dirty="0"/>
              <a:t>1:2:3</a:t>
            </a:r>
            <a:r>
              <a:rPr kumimoji="1" lang="ja-JP" altLang="en-US" dirty="0"/>
              <a:t>の比率はそれぞれ</a:t>
            </a:r>
            <a:r>
              <a:rPr kumimoji="1" lang="en-US" altLang="ja-JP" dirty="0"/>
              <a:t>78.7:17.3:4.0</a:t>
            </a:r>
            <a:r>
              <a:rPr kumimoji="1" lang="ja-JP" altLang="en-US" dirty="0"/>
              <a:t>、</a:t>
            </a:r>
            <a:r>
              <a:rPr kumimoji="1" lang="en-US" altLang="ja-JP" dirty="0"/>
              <a:t>76.4:18.4:5.2</a:t>
            </a:r>
            <a:r>
              <a:rPr kumimoji="1" lang="ja-JP" altLang="en-US" dirty="0"/>
              <a:t>、</a:t>
            </a:r>
            <a:r>
              <a:rPr kumimoji="1" lang="en-US" altLang="ja-JP" dirty="0"/>
              <a:t>79.0:17.0:4.0</a:t>
            </a:r>
            <a:r>
              <a:rPr kumimoji="1" lang="ja-JP" altLang="en-US" dirty="0"/>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endParaRPr kumimoji="1" lang="en-US" altLang="ja-JP" sz="1200" dirty="0">
              <a:latin typeface="Arial" panose="020B0604020202020204" pitchFamily="34" charset="0"/>
              <a:cs typeface="Arial" panose="020B0604020202020204" pitchFamily="34" charset="0"/>
            </a:endParaRPr>
          </a:p>
          <a:p>
            <a:r>
              <a:rPr kumimoji="1" lang="ja-JP" altLang="en-US" sz="1200" dirty="0">
                <a:latin typeface="Arial" panose="020B0604020202020204" pitchFamily="34" charset="0"/>
                <a:cs typeface="Arial" panose="020B0604020202020204" pitchFamily="34" charset="0"/>
              </a:rPr>
              <a:t>考察：</a:t>
            </a:r>
            <a:endParaRPr kumimoji="1" lang="en-US" altLang="ja-JP" sz="1200" dirty="0">
              <a:latin typeface="Arial" panose="020B0604020202020204" pitchFamily="34" charset="0"/>
              <a:cs typeface="Arial" panose="020B0604020202020204" pitchFamily="34" charset="0"/>
            </a:endParaRPr>
          </a:p>
          <a:p>
            <a:r>
              <a:rPr kumimoji="1" lang="ja-JP" altLang="en-US"/>
              <a:t>シロイヌナズナ実生を用いた最近のリン酸化プロテオーム研究の例として、</a:t>
            </a:r>
            <a:r>
              <a:rPr kumimoji="1" lang="en-US" altLang="ja-JP" dirty="0"/>
              <a:t>2023</a:t>
            </a:r>
            <a:r>
              <a:rPr kumimoji="1" lang="ja-JP" altLang="en-US"/>
              <a:t>年に、初期の</a:t>
            </a:r>
            <a:r>
              <a:rPr kumimoji="1" lang="en" altLang="ja-JP" dirty="0"/>
              <a:t>ABA</a:t>
            </a:r>
            <a:r>
              <a:rPr kumimoji="1" lang="ja-JP" altLang="en-US"/>
              <a:t>シグナル伝達が</a:t>
            </a:r>
            <a:r>
              <a:rPr kumimoji="1" lang="en" altLang="ja-JP" dirty="0"/>
              <a:t>CASEIN KINASE 1-LIKE PROTEIN 2</a:t>
            </a:r>
            <a:r>
              <a:rPr kumimoji="1" lang="ja-JP" altLang="en"/>
              <a:t>（</a:t>
            </a:r>
            <a:r>
              <a:rPr kumimoji="1" lang="en" altLang="ja-JP" dirty="0"/>
              <a:t>CKL2</a:t>
            </a:r>
            <a:r>
              <a:rPr kumimoji="1" lang="ja-JP" altLang="en"/>
              <a:t>）</a:t>
            </a:r>
            <a:r>
              <a:rPr kumimoji="1" lang="ja-JP" altLang="en-US"/>
              <a:t>を介してブラジノステロイド（</a:t>
            </a:r>
            <a:r>
              <a:rPr kumimoji="1" lang="en" altLang="ja-JP" dirty="0"/>
              <a:t>BR</a:t>
            </a:r>
            <a:r>
              <a:rPr kumimoji="1" lang="ja-JP" altLang="en"/>
              <a:t>）</a:t>
            </a:r>
            <a:r>
              <a:rPr kumimoji="1" lang="ja-JP" altLang="en-US"/>
              <a:t>シグナル伝達の上流成分を活性化することが報告されている。この研究で行われたリン酸化プロテオーム解析では、</a:t>
            </a:r>
            <a:r>
              <a:rPr kumimoji="1" lang="en-US" altLang="ja-JP" dirty="0"/>
              <a:t>13,295</a:t>
            </a:r>
            <a:r>
              <a:rPr kumimoji="1" lang="ja-JP" altLang="en-US"/>
              <a:t>種類のペプチドが同定され、そのうち</a:t>
            </a:r>
            <a:r>
              <a:rPr kumimoji="1" lang="en-US" altLang="ja-JP" dirty="0"/>
              <a:t>10,768</a:t>
            </a:r>
            <a:r>
              <a:rPr kumimoji="1" lang="ja-JP" altLang="en-US"/>
              <a:t>がリン酸化ペプチドだった</a:t>
            </a:r>
            <a:r>
              <a:rPr kumimoji="1" lang="en-US" altLang="ja-JP" dirty="0"/>
              <a:t>(https://</a:t>
            </a:r>
            <a:r>
              <a:rPr kumimoji="1" lang="en-US" altLang="ja-JP" dirty="0" err="1"/>
              <a:t>onlinelibrary.wiley.com</a:t>
            </a:r>
            <a:r>
              <a:rPr kumimoji="1" lang="en-US" altLang="ja-JP" dirty="0"/>
              <a:t>/</a:t>
            </a:r>
            <a:r>
              <a:rPr kumimoji="1" lang="en-US" altLang="ja-JP" dirty="0" err="1"/>
              <a:t>doi</a:t>
            </a:r>
            <a:r>
              <a:rPr kumimoji="1" lang="en-US" altLang="ja-JP" dirty="0"/>
              <a:t>/10.1111/jipb.13397)</a:t>
            </a:r>
            <a:r>
              <a:rPr kumimoji="1" lang="ja-JP" altLang="en-US"/>
              <a:t>。その研究と比較すると、約</a:t>
            </a:r>
            <a:r>
              <a:rPr kumimoji="1" lang="en-US" altLang="ja-JP" dirty="0"/>
              <a:t>2.6</a:t>
            </a:r>
            <a:r>
              <a:rPr kumimoji="1" lang="ja-JP" altLang="en-US"/>
              <a:t>倍のペプチド種数と約</a:t>
            </a:r>
            <a:r>
              <a:rPr kumimoji="1" lang="en-US" altLang="ja-JP" dirty="0"/>
              <a:t>2.3</a:t>
            </a:r>
            <a:r>
              <a:rPr kumimoji="1" lang="ja-JP" altLang="en-US"/>
              <a:t>倍のリン酸化ペプチド種数を同定することができた。</a:t>
            </a:r>
            <a:endParaRPr kumimoji="1" lang="en-US" altLang="ja-JP" dirty="0"/>
          </a:p>
          <a:p>
            <a:r>
              <a:rPr kumimoji="1" lang="ja-JP" altLang="en-US"/>
              <a:t>一方でイネでは、</a:t>
            </a:r>
            <a:r>
              <a:rPr kumimoji="1" lang="en-US" altLang="ja-JP" dirty="0"/>
              <a:t>2017</a:t>
            </a:r>
            <a:r>
              <a:rPr kumimoji="1" lang="ja-JP" altLang="en-US"/>
              <a:t>年に</a:t>
            </a:r>
            <a:r>
              <a:rPr kumimoji="1" lang="en" altLang="ja-JP" dirty="0"/>
              <a:t>ABA</a:t>
            </a:r>
            <a:r>
              <a:rPr kumimoji="1" lang="ja-JP" altLang="en-US"/>
              <a:t>応答をリン酸化プロテオミクスで調べられているが、当時は</a:t>
            </a:r>
            <a:r>
              <a:rPr kumimoji="1" lang="en-US" altLang="ja-JP" dirty="0"/>
              <a:t>2162</a:t>
            </a:r>
            <a:r>
              <a:rPr kumimoji="1" lang="ja-JP" altLang="en-US"/>
              <a:t>種類のリン酸化ペプチドが同定されていた。今回我々は</a:t>
            </a:r>
            <a:r>
              <a:rPr kumimoji="1" lang="en-US" altLang="ja-JP" dirty="0"/>
              <a:t>18865</a:t>
            </a:r>
            <a:r>
              <a:rPr kumimoji="1" lang="ja-JP" altLang="en-US"/>
              <a:t>種類（約</a:t>
            </a:r>
            <a:r>
              <a:rPr kumimoji="1" lang="en-US" altLang="ja-JP" dirty="0"/>
              <a:t>8.7</a:t>
            </a:r>
            <a:r>
              <a:rPr kumimoji="1" lang="ja-JP" altLang="en-US"/>
              <a:t>倍）のリン酸化ペプチドを同定することができた。</a:t>
            </a:r>
            <a:endParaRPr kumimoji="1" lang="en-US" altLang="ja-JP" dirty="0"/>
          </a:p>
          <a:p>
            <a:r>
              <a:rPr kumimoji="1" lang="ja-JP" altLang="en-US"/>
              <a:t>ダイズのリン酸化プロテオーム研究では、</a:t>
            </a:r>
            <a:endParaRPr kumimoji="1" lang="ja-JP" altLang="en"/>
          </a:p>
        </p:txBody>
      </p:sp>
      <p:sp>
        <p:nvSpPr>
          <p:cNvPr id="4" name="スライド番号プレースホルダー 3">
            <a:extLst>
              <a:ext uri="{FF2B5EF4-FFF2-40B4-BE49-F238E27FC236}">
                <a16:creationId xmlns:a16="http://schemas.microsoft.com/office/drawing/2014/main" id="{060EF349-2998-111D-FEE2-DB166F37BA1F}"/>
              </a:ext>
            </a:extLst>
          </p:cNvPr>
          <p:cNvSpPr>
            <a:spLocks noGrp="1"/>
          </p:cNvSpPr>
          <p:nvPr>
            <p:ph type="sldNum" sz="quarter" idx="5"/>
          </p:nvPr>
        </p:nvSpPr>
        <p:spPr/>
        <p:txBody>
          <a:bodyPr/>
          <a:lstStyle/>
          <a:p>
            <a:fld id="{7F37041C-9C9F-0542-9320-4ABB0B3E1A57}" type="slidenum">
              <a:rPr kumimoji="1" lang="ja-JP" altLang="en-US" smtClean="0"/>
              <a:t>4</a:t>
            </a:fld>
            <a:endParaRPr kumimoji="1" lang="ja-JP" altLang="en-US"/>
          </a:p>
        </p:txBody>
      </p:sp>
    </p:spTree>
    <p:extLst>
      <p:ext uri="{BB962C8B-B14F-4D97-AF65-F5344CB8AC3E}">
        <p14:creationId xmlns:p14="http://schemas.microsoft.com/office/powerpoint/2010/main" val="37779293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79D0304-AAD0-544F-D8BB-DA5D68D7B4F3}"/>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96B89B19-FAA4-740B-6867-816A924EA7CE}"/>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FF3B7935-7EBF-AADE-7167-4AA27C077D7A}"/>
              </a:ext>
            </a:extLst>
          </p:cNvPr>
          <p:cNvSpPr>
            <a:spLocks noGrp="1"/>
          </p:cNvSpPr>
          <p:nvPr>
            <p:ph type="body" idx="1"/>
          </p:nvPr>
        </p:nvSpPr>
        <p:spPr/>
        <p:txBody>
          <a:bodyPr/>
          <a:lstStyle/>
          <a:p>
            <a:r>
              <a:rPr kumimoji="1" lang="en-US" altLang="ja-JP" sz="1200" dirty="0">
                <a:latin typeface="Arial" panose="020B0604020202020204" pitchFamily="34" charset="0"/>
                <a:cs typeface="Arial" panose="020B0604020202020204" pitchFamily="34" charset="0"/>
              </a:rPr>
              <a:t>(A)</a:t>
            </a:r>
            <a:r>
              <a:rPr kumimoji="1" lang="ja-JP" altLang="en-US" sz="1200" dirty="0">
                <a:latin typeface="Arial" panose="020B0604020202020204" pitchFamily="34" charset="0"/>
                <a:cs typeface="Arial" panose="020B0604020202020204" pitchFamily="34" charset="0"/>
              </a:rPr>
              <a:t>シロイヌナズナ・イネ・ダイズのリン酸化プロテオームの結果、</a:t>
            </a:r>
            <a:r>
              <a:rPr kumimoji="1" lang="en-US" altLang="ja-JP" sz="1200" dirty="0">
                <a:latin typeface="Arial" panose="020B0604020202020204" pitchFamily="34" charset="0"/>
                <a:cs typeface="Arial" panose="020B0604020202020204" pitchFamily="34" charset="0"/>
              </a:rPr>
              <a:t>12721, 10215, 13963</a:t>
            </a:r>
            <a:r>
              <a:rPr kumimoji="1" lang="ja-JP" altLang="en-US" sz="1200" dirty="0">
                <a:latin typeface="Arial" panose="020B0604020202020204" pitchFamily="34" charset="0"/>
                <a:cs typeface="Arial" panose="020B0604020202020204" pitchFamily="34" charset="0"/>
              </a:rPr>
              <a:t>種類のタンパク質由来の</a:t>
            </a:r>
            <a:r>
              <a:rPr kumimoji="1" lang="en-US" altLang="ja-JP" sz="1200" dirty="0">
                <a:latin typeface="Arial" panose="020B0604020202020204" pitchFamily="34" charset="0"/>
                <a:cs typeface="Arial" panose="020B0604020202020204" pitchFamily="34" charset="0"/>
              </a:rPr>
              <a:t>34767, 31831, 39918</a:t>
            </a:r>
            <a:r>
              <a:rPr kumimoji="1" lang="ja-JP" altLang="en-US" sz="1200" dirty="0">
                <a:latin typeface="Arial" panose="020B0604020202020204" pitchFamily="34" charset="0"/>
                <a:cs typeface="Arial" panose="020B0604020202020204" pitchFamily="34" charset="0"/>
              </a:rPr>
              <a:t>種類のペプチドを同定した。</a:t>
            </a:r>
            <a:r>
              <a:rPr kumimoji="1" lang="en-US" altLang="ja-JP" sz="1200" dirty="0">
                <a:latin typeface="Arial" panose="020B0604020202020204" pitchFamily="34" charset="0"/>
                <a:cs typeface="Arial" panose="020B0604020202020204" pitchFamily="34" charset="0"/>
              </a:rPr>
              <a:t>24604, 18865, 24930</a:t>
            </a:r>
            <a:r>
              <a:rPr kumimoji="1" lang="ja-JP" altLang="en-US" sz="1200" dirty="0">
                <a:latin typeface="Arial" panose="020B0604020202020204" pitchFamily="34" charset="0"/>
                <a:cs typeface="Arial" panose="020B0604020202020204" pitchFamily="34" charset="0"/>
              </a:rPr>
              <a:t>種類のリン酸化ペプチドを同定した。同定したペプチドのうち、</a:t>
            </a:r>
            <a:r>
              <a:rPr kumimoji="1" lang="en-US" altLang="ja-JP" sz="1200" dirty="0">
                <a:latin typeface="Arial" panose="020B0604020202020204" pitchFamily="34" charset="0"/>
                <a:cs typeface="Arial" panose="020B0604020202020204" pitchFamily="34" charset="0"/>
              </a:rPr>
              <a:t>71%, 59%, 62%</a:t>
            </a:r>
            <a:r>
              <a:rPr kumimoji="1" lang="ja-JP" altLang="en-US" sz="1200" dirty="0">
                <a:latin typeface="Arial" panose="020B0604020202020204" pitchFamily="34" charset="0"/>
                <a:cs typeface="Arial" panose="020B0604020202020204" pitchFamily="34" charset="0"/>
              </a:rPr>
              <a:t>がリン酸化ペプチドだった。</a:t>
            </a:r>
            <a:endParaRPr kumimoji="1" lang="en-US" altLang="ja-JP" sz="1200" dirty="0">
              <a:latin typeface="Arial" panose="020B0604020202020204" pitchFamily="34" charset="0"/>
              <a:cs typeface="Arial" panose="020B0604020202020204" pitchFamily="34" charset="0"/>
            </a:endParaRPr>
          </a:p>
          <a:p>
            <a:r>
              <a:rPr kumimoji="1" lang="en-US" altLang="ja-JP" sz="1200" dirty="0">
                <a:latin typeface="Arial" panose="020B0604020202020204" pitchFamily="34" charset="0"/>
                <a:cs typeface="Arial" panose="020B0604020202020204" pitchFamily="34" charset="0"/>
              </a:rPr>
              <a:t>(B)</a:t>
            </a:r>
            <a:r>
              <a:rPr kumimoji="1" lang="ja-JP" altLang="en-US" sz="1200" dirty="0">
                <a:latin typeface="Arial" panose="020B0604020202020204" pitchFamily="34" charset="0"/>
                <a:cs typeface="Arial" panose="020B0604020202020204" pitchFamily="34" charset="0"/>
              </a:rPr>
              <a:t>シロイヌナズナ・イネ・ダイズのリン酸化セリン、スレオニン、チロシン残基の比率はそれぞれ</a:t>
            </a:r>
            <a:r>
              <a:rPr kumimoji="1" lang="en-US" altLang="ja-JP" sz="1200" dirty="0">
                <a:latin typeface="Arial" panose="020B0604020202020204" pitchFamily="34" charset="0"/>
                <a:cs typeface="Arial" panose="020B0604020202020204" pitchFamily="34" charset="0"/>
              </a:rPr>
              <a:t>88.0:11.7:0.3</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7.5:12.0:0.5</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8.7:11.0:0.3</a:t>
            </a:r>
            <a:r>
              <a:rPr kumimoji="1" lang="ja-JP" altLang="en-US" sz="1200" dirty="0">
                <a:latin typeface="Arial" panose="020B0604020202020204" pitchFamily="34" charset="0"/>
                <a:cs typeface="Arial" panose="020B0604020202020204" pitchFamily="34" charset="0"/>
              </a:rPr>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r>
              <a:rPr kumimoji="1" lang="en-US" altLang="ja-JP" dirty="0"/>
              <a:t>(C)</a:t>
            </a:r>
            <a:r>
              <a:rPr kumimoji="1" lang="ja-JP" altLang="en-US" sz="1200" dirty="0">
                <a:latin typeface="Arial" panose="020B0604020202020204" pitchFamily="34" charset="0"/>
                <a:cs typeface="Arial" panose="020B0604020202020204" pitchFamily="34" charset="0"/>
              </a:rPr>
              <a:t>シロイヌナズナ・イネ・ダイズの</a:t>
            </a:r>
            <a:r>
              <a:rPr kumimoji="1" lang="ja-JP" altLang="en-US" dirty="0"/>
              <a:t>ペプチドあたりのリン酸化部位数</a:t>
            </a:r>
            <a:r>
              <a:rPr kumimoji="1" lang="en-US" altLang="ja-JP" dirty="0"/>
              <a:t>1:2:3</a:t>
            </a:r>
            <a:r>
              <a:rPr kumimoji="1" lang="ja-JP" altLang="en-US" dirty="0"/>
              <a:t>の比率はそれぞれ</a:t>
            </a:r>
            <a:r>
              <a:rPr kumimoji="1" lang="en-US" altLang="ja-JP" dirty="0"/>
              <a:t>78.7:17.3:4.0</a:t>
            </a:r>
            <a:r>
              <a:rPr kumimoji="1" lang="ja-JP" altLang="en-US" dirty="0"/>
              <a:t>、</a:t>
            </a:r>
            <a:r>
              <a:rPr kumimoji="1" lang="en-US" altLang="ja-JP" dirty="0"/>
              <a:t>76.4:18.4:5.2</a:t>
            </a:r>
            <a:r>
              <a:rPr kumimoji="1" lang="ja-JP" altLang="en-US" dirty="0"/>
              <a:t>、</a:t>
            </a:r>
            <a:r>
              <a:rPr kumimoji="1" lang="en-US" altLang="ja-JP" dirty="0"/>
              <a:t>79.0:17.0:4.0</a:t>
            </a:r>
            <a:r>
              <a:rPr kumimoji="1" lang="ja-JP" altLang="en-US" dirty="0"/>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endParaRPr kumimoji="1" lang="en-US" altLang="ja-JP" sz="1200" dirty="0">
              <a:latin typeface="Arial" panose="020B0604020202020204" pitchFamily="34" charset="0"/>
              <a:cs typeface="Arial" panose="020B0604020202020204" pitchFamily="34" charset="0"/>
            </a:endParaRPr>
          </a:p>
          <a:p>
            <a:r>
              <a:rPr kumimoji="1" lang="ja-JP" altLang="en-US" sz="1200" dirty="0">
                <a:latin typeface="Arial" panose="020B0604020202020204" pitchFamily="34" charset="0"/>
                <a:cs typeface="Arial" panose="020B0604020202020204" pitchFamily="34" charset="0"/>
              </a:rPr>
              <a:t>考察：</a:t>
            </a:r>
            <a:endParaRPr kumimoji="1" lang="en-US" altLang="ja-JP" sz="1200" dirty="0">
              <a:latin typeface="Arial" panose="020B0604020202020204" pitchFamily="34" charset="0"/>
              <a:cs typeface="Arial" panose="020B0604020202020204" pitchFamily="34" charset="0"/>
            </a:endParaRPr>
          </a:p>
          <a:p>
            <a:r>
              <a:rPr kumimoji="1" lang="ja-JP" altLang="en-US"/>
              <a:t>シロイヌナズナ実生を用いた最近のリン酸化プロテオーム研究の例として、</a:t>
            </a:r>
            <a:r>
              <a:rPr kumimoji="1" lang="en-US" altLang="ja-JP" dirty="0"/>
              <a:t>2023</a:t>
            </a:r>
            <a:r>
              <a:rPr kumimoji="1" lang="ja-JP" altLang="en-US"/>
              <a:t>年に、初期の</a:t>
            </a:r>
            <a:r>
              <a:rPr kumimoji="1" lang="en" altLang="ja-JP" dirty="0"/>
              <a:t>ABA</a:t>
            </a:r>
            <a:r>
              <a:rPr kumimoji="1" lang="ja-JP" altLang="en-US"/>
              <a:t>シグナル伝達が</a:t>
            </a:r>
            <a:r>
              <a:rPr kumimoji="1" lang="en" altLang="ja-JP" dirty="0"/>
              <a:t>CASEIN KINASE 1-LIKE PROTEIN 2</a:t>
            </a:r>
            <a:r>
              <a:rPr kumimoji="1" lang="ja-JP" altLang="en"/>
              <a:t>（</a:t>
            </a:r>
            <a:r>
              <a:rPr kumimoji="1" lang="en" altLang="ja-JP" dirty="0"/>
              <a:t>CKL2</a:t>
            </a:r>
            <a:r>
              <a:rPr kumimoji="1" lang="ja-JP" altLang="en"/>
              <a:t>）</a:t>
            </a:r>
            <a:r>
              <a:rPr kumimoji="1" lang="ja-JP" altLang="en-US"/>
              <a:t>を介してブラジノステロイド（</a:t>
            </a:r>
            <a:r>
              <a:rPr kumimoji="1" lang="en" altLang="ja-JP" dirty="0"/>
              <a:t>BR</a:t>
            </a:r>
            <a:r>
              <a:rPr kumimoji="1" lang="ja-JP" altLang="en"/>
              <a:t>）</a:t>
            </a:r>
            <a:r>
              <a:rPr kumimoji="1" lang="ja-JP" altLang="en-US"/>
              <a:t>シグナル伝達の上流成分を活性化することが報告されている。この研究で行われたリン酸化プロテオーム解析では、</a:t>
            </a:r>
            <a:r>
              <a:rPr kumimoji="1" lang="en-US" altLang="ja-JP" dirty="0"/>
              <a:t>13,295</a:t>
            </a:r>
            <a:r>
              <a:rPr kumimoji="1" lang="ja-JP" altLang="en-US"/>
              <a:t>種類のペプチドが同定され、そのうち</a:t>
            </a:r>
            <a:r>
              <a:rPr kumimoji="1" lang="en-US" altLang="ja-JP" dirty="0"/>
              <a:t>10,768</a:t>
            </a:r>
            <a:r>
              <a:rPr kumimoji="1" lang="ja-JP" altLang="en-US"/>
              <a:t>がリン酸化ペプチドだった</a:t>
            </a:r>
            <a:r>
              <a:rPr kumimoji="1" lang="en-US" altLang="ja-JP" dirty="0"/>
              <a:t>(https://</a:t>
            </a:r>
            <a:r>
              <a:rPr kumimoji="1" lang="en-US" altLang="ja-JP" dirty="0" err="1"/>
              <a:t>onlinelibrary.wiley.com</a:t>
            </a:r>
            <a:r>
              <a:rPr kumimoji="1" lang="en-US" altLang="ja-JP" dirty="0"/>
              <a:t>/</a:t>
            </a:r>
            <a:r>
              <a:rPr kumimoji="1" lang="en-US" altLang="ja-JP" dirty="0" err="1"/>
              <a:t>doi</a:t>
            </a:r>
            <a:r>
              <a:rPr kumimoji="1" lang="en-US" altLang="ja-JP" dirty="0"/>
              <a:t>/10.1111/jipb.13397)</a:t>
            </a:r>
            <a:r>
              <a:rPr kumimoji="1" lang="ja-JP" altLang="en-US"/>
              <a:t>。その研究と比較すると、約</a:t>
            </a:r>
            <a:r>
              <a:rPr kumimoji="1" lang="en-US" altLang="ja-JP" dirty="0"/>
              <a:t>2.6</a:t>
            </a:r>
            <a:r>
              <a:rPr kumimoji="1" lang="ja-JP" altLang="en-US"/>
              <a:t>倍のペプチド種数と約</a:t>
            </a:r>
            <a:r>
              <a:rPr kumimoji="1" lang="en-US" altLang="ja-JP" dirty="0"/>
              <a:t>2.3</a:t>
            </a:r>
            <a:r>
              <a:rPr kumimoji="1" lang="ja-JP" altLang="en-US"/>
              <a:t>倍のリン酸化ペプチド種数を同定することができた。</a:t>
            </a:r>
            <a:endParaRPr kumimoji="1" lang="en-US" altLang="ja-JP" dirty="0"/>
          </a:p>
          <a:p>
            <a:r>
              <a:rPr kumimoji="1" lang="ja-JP" altLang="en-US"/>
              <a:t>一方でイネでは、</a:t>
            </a:r>
            <a:r>
              <a:rPr kumimoji="1" lang="en-US" altLang="ja-JP" dirty="0"/>
              <a:t>2017</a:t>
            </a:r>
            <a:r>
              <a:rPr kumimoji="1" lang="ja-JP" altLang="en-US"/>
              <a:t>年に</a:t>
            </a:r>
            <a:r>
              <a:rPr kumimoji="1" lang="en" altLang="ja-JP" dirty="0"/>
              <a:t>ABA</a:t>
            </a:r>
            <a:r>
              <a:rPr kumimoji="1" lang="ja-JP" altLang="en-US"/>
              <a:t>応答をリン酸化プロテオミクスで調べられているが、当時は</a:t>
            </a:r>
            <a:r>
              <a:rPr kumimoji="1" lang="en-US" altLang="ja-JP" dirty="0"/>
              <a:t>2162</a:t>
            </a:r>
            <a:r>
              <a:rPr kumimoji="1" lang="ja-JP" altLang="en-US"/>
              <a:t>種類のリン酸化ペプチドが同定されていた。今回我々は</a:t>
            </a:r>
            <a:r>
              <a:rPr kumimoji="1" lang="en-US" altLang="ja-JP" dirty="0"/>
              <a:t>18865</a:t>
            </a:r>
            <a:r>
              <a:rPr kumimoji="1" lang="ja-JP" altLang="en-US"/>
              <a:t>種類（約</a:t>
            </a:r>
            <a:r>
              <a:rPr kumimoji="1" lang="en-US" altLang="ja-JP" dirty="0"/>
              <a:t>8.7</a:t>
            </a:r>
            <a:r>
              <a:rPr kumimoji="1" lang="ja-JP" altLang="en-US"/>
              <a:t>倍）のリン酸化ペプチドを同定することができた。</a:t>
            </a:r>
            <a:endParaRPr kumimoji="1" lang="en-US" altLang="ja-JP" dirty="0"/>
          </a:p>
          <a:p>
            <a:r>
              <a:rPr kumimoji="1" lang="ja-JP" altLang="en-US"/>
              <a:t>ダイズのリン酸化プロテオーム研究では、</a:t>
            </a:r>
            <a:endParaRPr kumimoji="1" lang="ja-JP" altLang="en"/>
          </a:p>
        </p:txBody>
      </p:sp>
      <p:sp>
        <p:nvSpPr>
          <p:cNvPr id="4" name="スライド番号プレースホルダー 3">
            <a:extLst>
              <a:ext uri="{FF2B5EF4-FFF2-40B4-BE49-F238E27FC236}">
                <a16:creationId xmlns:a16="http://schemas.microsoft.com/office/drawing/2014/main" id="{06BC1AE8-2A8C-B3E7-A476-96E19A8EF048}"/>
              </a:ext>
            </a:extLst>
          </p:cNvPr>
          <p:cNvSpPr>
            <a:spLocks noGrp="1"/>
          </p:cNvSpPr>
          <p:nvPr>
            <p:ph type="sldNum" sz="quarter" idx="5"/>
          </p:nvPr>
        </p:nvSpPr>
        <p:spPr/>
        <p:txBody>
          <a:bodyPr/>
          <a:lstStyle/>
          <a:p>
            <a:fld id="{7F37041C-9C9F-0542-9320-4ABB0B3E1A57}" type="slidenum">
              <a:rPr kumimoji="1" lang="ja-JP" altLang="en-US" smtClean="0"/>
              <a:t>5</a:t>
            </a:fld>
            <a:endParaRPr kumimoji="1" lang="ja-JP" altLang="en-US"/>
          </a:p>
        </p:txBody>
      </p:sp>
    </p:spTree>
    <p:extLst>
      <p:ext uri="{BB962C8B-B14F-4D97-AF65-F5344CB8AC3E}">
        <p14:creationId xmlns:p14="http://schemas.microsoft.com/office/powerpoint/2010/main" val="17188098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9E2F9D1-8A66-9856-A9C6-6EFDDBAC046A}"/>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78CE1664-3B30-A3F9-CB29-691678079180}"/>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97FE5B90-F291-A9AA-DC43-F4D57891E53F}"/>
              </a:ext>
            </a:extLst>
          </p:cNvPr>
          <p:cNvSpPr>
            <a:spLocks noGrp="1"/>
          </p:cNvSpPr>
          <p:nvPr>
            <p:ph type="body" idx="1"/>
          </p:nvPr>
        </p:nvSpPr>
        <p:spPr/>
        <p:txBody>
          <a:bodyPr/>
          <a:lstStyle/>
          <a:p>
            <a:r>
              <a:rPr kumimoji="1" lang="en-US" altLang="ja-JP" sz="1200" dirty="0">
                <a:latin typeface="Arial" panose="020B0604020202020204" pitchFamily="34" charset="0"/>
                <a:cs typeface="Arial" panose="020B0604020202020204" pitchFamily="34" charset="0"/>
              </a:rPr>
              <a:t>(A)</a:t>
            </a:r>
            <a:r>
              <a:rPr kumimoji="1" lang="ja-JP" altLang="en-US" sz="1200" dirty="0">
                <a:latin typeface="Arial" panose="020B0604020202020204" pitchFamily="34" charset="0"/>
                <a:cs typeface="Arial" panose="020B0604020202020204" pitchFamily="34" charset="0"/>
              </a:rPr>
              <a:t>シロイヌナズナ・イネ・ダイズのリン酸化プロテオームの結果、</a:t>
            </a:r>
            <a:r>
              <a:rPr kumimoji="1" lang="en-US" altLang="ja-JP" sz="1200" dirty="0">
                <a:latin typeface="Arial" panose="020B0604020202020204" pitchFamily="34" charset="0"/>
                <a:cs typeface="Arial" panose="020B0604020202020204" pitchFamily="34" charset="0"/>
              </a:rPr>
              <a:t>12721, 10215, 13963</a:t>
            </a:r>
            <a:r>
              <a:rPr kumimoji="1" lang="ja-JP" altLang="en-US" sz="1200" dirty="0">
                <a:latin typeface="Arial" panose="020B0604020202020204" pitchFamily="34" charset="0"/>
                <a:cs typeface="Arial" panose="020B0604020202020204" pitchFamily="34" charset="0"/>
              </a:rPr>
              <a:t>種類のタンパク質由来の</a:t>
            </a:r>
            <a:r>
              <a:rPr kumimoji="1" lang="en-US" altLang="ja-JP" sz="1200" dirty="0">
                <a:latin typeface="Arial" panose="020B0604020202020204" pitchFamily="34" charset="0"/>
                <a:cs typeface="Arial" panose="020B0604020202020204" pitchFamily="34" charset="0"/>
              </a:rPr>
              <a:t>34767, 31831, 39918</a:t>
            </a:r>
            <a:r>
              <a:rPr kumimoji="1" lang="ja-JP" altLang="en-US" sz="1200" dirty="0">
                <a:latin typeface="Arial" panose="020B0604020202020204" pitchFamily="34" charset="0"/>
                <a:cs typeface="Arial" panose="020B0604020202020204" pitchFamily="34" charset="0"/>
              </a:rPr>
              <a:t>種類のペプチドを同定した。</a:t>
            </a:r>
            <a:r>
              <a:rPr kumimoji="1" lang="en-US" altLang="ja-JP" sz="1200" dirty="0">
                <a:latin typeface="Arial" panose="020B0604020202020204" pitchFamily="34" charset="0"/>
                <a:cs typeface="Arial" panose="020B0604020202020204" pitchFamily="34" charset="0"/>
              </a:rPr>
              <a:t>24604, 18865, 24930</a:t>
            </a:r>
            <a:r>
              <a:rPr kumimoji="1" lang="ja-JP" altLang="en-US" sz="1200" dirty="0">
                <a:latin typeface="Arial" panose="020B0604020202020204" pitchFamily="34" charset="0"/>
                <a:cs typeface="Arial" panose="020B0604020202020204" pitchFamily="34" charset="0"/>
              </a:rPr>
              <a:t>種類のリン酸化ペプチドを同定した。同定したペプチドのうち、</a:t>
            </a:r>
            <a:r>
              <a:rPr kumimoji="1" lang="en-US" altLang="ja-JP" sz="1200" dirty="0">
                <a:latin typeface="Arial" panose="020B0604020202020204" pitchFamily="34" charset="0"/>
                <a:cs typeface="Arial" panose="020B0604020202020204" pitchFamily="34" charset="0"/>
              </a:rPr>
              <a:t>71%, 59%, 62%</a:t>
            </a:r>
            <a:r>
              <a:rPr kumimoji="1" lang="ja-JP" altLang="en-US" sz="1200" dirty="0">
                <a:latin typeface="Arial" panose="020B0604020202020204" pitchFamily="34" charset="0"/>
                <a:cs typeface="Arial" panose="020B0604020202020204" pitchFamily="34" charset="0"/>
              </a:rPr>
              <a:t>がリン酸化ペプチドだった。</a:t>
            </a:r>
            <a:endParaRPr kumimoji="1" lang="en-US" altLang="ja-JP" sz="1200" dirty="0">
              <a:latin typeface="Arial" panose="020B0604020202020204" pitchFamily="34" charset="0"/>
              <a:cs typeface="Arial" panose="020B0604020202020204" pitchFamily="34" charset="0"/>
            </a:endParaRPr>
          </a:p>
          <a:p>
            <a:r>
              <a:rPr kumimoji="1" lang="en-US" altLang="ja-JP" sz="1200" dirty="0">
                <a:latin typeface="Arial" panose="020B0604020202020204" pitchFamily="34" charset="0"/>
                <a:cs typeface="Arial" panose="020B0604020202020204" pitchFamily="34" charset="0"/>
              </a:rPr>
              <a:t>(B)</a:t>
            </a:r>
            <a:r>
              <a:rPr kumimoji="1" lang="ja-JP" altLang="en-US" sz="1200" dirty="0">
                <a:latin typeface="Arial" panose="020B0604020202020204" pitchFamily="34" charset="0"/>
                <a:cs typeface="Arial" panose="020B0604020202020204" pitchFamily="34" charset="0"/>
              </a:rPr>
              <a:t>シロイヌナズナ・イネ・ダイズのリン酸化セリン、スレオニン、チロシン残基の比率はそれぞれ</a:t>
            </a:r>
            <a:r>
              <a:rPr kumimoji="1" lang="en-US" altLang="ja-JP" sz="1200" dirty="0">
                <a:latin typeface="Arial" panose="020B0604020202020204" pitchFamily="34" charset="0"/>
                <a:cs typeface="Arial" panose="020B0604020202020204" pitchFamily="34" charset="0"/>
              </a:rPr>
              <a:t>88.0:11.7:0.3</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7.5:12.0:0.5</a:t>
            </a:r>
            <a:r>
              <a:rPr kumimoji="1" lang="ja-JP" altLang="en-US" sz="1200" dirty="0">
                <a:latin typeface="Arial" panose="020B0604020202020204" pitchFamily="34" charset="0"/>
                <a:cs typeface="Arial" panose="020B0604020202020204" pitchFamily="34" charset="0"/>
              </a:rPr>
              <a:t>、</a:t>
            </a:r>
            <a:r>
              <a:rPr kumimoji="1" lang="en-US" altLang="ja-JP" sz="1200" dirty="0">
                <a:latin typeface="Arial" panose="020B0604020202020204" pitchFamily="34" charset="0"/>
                <a:cs typeface="Arial" panose="020B0604020202020204" pitchFamily="34" charset="0"/>
              </a:rPr>
              <a:t>88.7:11.0:0.3</a:t>
            </a:r>
            <a:r>
              <a:rPr kumimoji="1" lang="ja-JP" altLang="en-US" sz="1200" dirty="0">
                <a:latin typeface="Arial" panose="020B0604020202020204" pitchFamily="34" charset="0"/>
                <a:cs typeface="Arial" panose="020B0604020202020204" pitchFamily="34" charset="0"/>
              </a:rPr>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r>
              <a:rPr kumimoji="1" lang="en-US" altLang="ja-JP" dirty="0"/>
              <a:t>(C)</a:t>
            </a:r>
            <a:r>
              <a:rPr kumimoji="1" lang="ja-JP" altLang="en-US" sz="1200" dirty="0">
                <a:latin typeface="Arial" panose="020B0604020202020204" pitchFamily="34" charset="0"/>
                <a:cs typeface="Arial" panose="020B0604020202020204" pitchFamily="34" charset="0"/>
              </a:rPr>
              <a:t>シロイヌナズナ・イネ・ダイズの</a:t>
            </a:r>
            <a:r>
              <a:rPr kumimoji="1" lang="ja-JP" altLang="en-US" dirty="0"/>
              <a:t>ペプチドあたりのリン酸化部位数</a:t>
            </a:r>
            <a:r>
              <a:rPr kumimoji="1" lang="en-US" altLang="ja-JP" dirty="0"/>
              <a:t>1:2:3</a:t>
            </a:r>
            <a:r>
              <a:rPr kumimoji="1" lang="ja-JP" altLang="en-US" dirty="0"/>
              <a:t>の比率はそれぞれ</a:t>
            </a:r>
            <a:r>
              <a:rPr kumimoji="1" lang="en-US" altLang="ja-JP" dirty="0"/>
              <a:t>78.7:17.3:4.0</a:t>
            </a:r>
            <a:r>
              <a:rPr kumimoji="1" lang="ja-JP" altLang="en-US" dirty="0"/>
              <a:t>、</a:t>
            </a:r>
            <a:r>
              <a:rPr kumimoji="1" lang="en-US" altLang="ja-JP" dirty="0"/>
              <a:t>76.4:18.4:5.2</a:t>
            </a:r>
            <a:r>
              <a:rPr kumimoji="1" lang="ja-JP" altLang="en-US" dirty="0"/>
              <a:t>、</a:t>
            </a:r>
            <a:r>
              <a:rPr kumimoji="1" lang="en-US" altLang="ja-JP" dirty="0"/>
              <a:t>79.0:17.0:4.0</a:t>
            </a:r>
            <a:r>
              <a:rPr kumimoji="1" lang="ja-JP" altLang="en-US" dirty="0"/>
              <a:t>で、</a:t>
            </a:r>
            <a:r>
              <a:rPr kumimoji="1" lang="en-US" altLang="ja-JP" sz="1200" dirty="0">
                <a:latin typeface="Arial" panose="020B0604020202020204" pitchFamily="34" charset="0"/>
                <a:cs typeface="Arial" panose="020B0604020202020204" pitchFamily="34" charset="0"/>
              </a:rPr>
              <a:t>3</a:t>
            </a:r>
            <a:r>
              <a:rPr kumimoji="1" lang="ja-JP" altLang="en-US" sz="1200" dirty="0">
                <a:latin typeface="Arial" panose="020B0604020202020204" pitchFamily="34" charset="0"/>
                <a:cs typeface="Arial" panose="020B0604020202020204" pitchFamily="34" charset="0"/>
              </a:rPr>
              <a:t>種で類似していた。</a:t>
            </a:r>
            <a:endParaRPr kumimoji="1" lang="en-US" altLang="ja-JP" sz="1200" dirty="0">
              <a:latin typeface="Arial" panose="020B0604020202020204" pitchFamily="34" charset="0"/>
              <a:cs typeface="Arial" panose="020B0604020202020204" pitchFamily="34" charset="0"/>
            </a:endParaRPr>
          </a:p>
          <a:p>
            <a:endParaRPr kumimoji="1" lang="en-US" altLang="ja-JP" sz="1200" dirty="0">
              <a:latin typeface="Arial" panose="020B0604020202020204" pitchFamily="34" charset="0"/>
              <a:cs typeface="Arial" panose="020B0604020202020204" pitchFamily="34" charset="0"/>
            </a:endParaRPr>
          </a:p>
          <a:p>
            <a:r>
              <a:rPr kumimoji="1" lang="ja-JP" altLang="en-US" sz="1200" dirty="0">
                <a:latin typeface="Arial" panose="020B0604020202020204" pitchFamily="34" charset="0"/>
                <a:cs typeface="Arial" panose="020B0604020202020204" pitchFamily="34" charset="0"/>
              </a:rPr>
              <a:t>考察：</a:t>
            </a:r>
            <a:endParaRPr kumimoji="1" lang="en-US" altLang="ja-JP" sz="1200" dirty="0">
              <a:latin typeface="Arial" panose="020B0604020202020204" pitchFamily="34" charset="0"/>
              <a:cs typeface="Arial" panose="020B0604020202020204" pitchFamily="34" charset="0"/>
            </a:endParaRPr>
          </a:p>
          <a:p>
            <a:r>
              <a:rPr kumimoji="1" lang="ja-JP" altLang="en-US"/>
              <a:t>シロイヌナズナ実生を用いた最近のリン酸化プロテオーム研究の例として、</a:t>
            </a:r>
            <a:r>
              <a:rPr kumimoji="1" lang="en-US" altLang="ja-JP" dirty="0"/>
              <a:t>2023</a:t>
            </a:r>
            <a:r>
              <a:rPr kumimoji="1" lang="ja-JP" altLang="en-US"/>
              <a:t>年に、初期の</a:t>
            </a:r>
            <a:r>
              <a:rPr kumimoji="1" lang="en" altLang="ja-JP" dirty="0"/>
              <a:t>ABA</a:t>
            </a:r>
            <a:r>
              <a:rPr kumimoji="1" lang="ja-JP" altLang="en-US"/>
              <a:t>シグナル伝達が</a:t>
            </a:r>
            <a:r>
              <a:rPr kumimoji="1" lang="en" altLang="ja-JP" dirty="0"/>
              <a:t>CASEIN KINASE 1-LIKE PROTEIN 2</a:t>
            </a:r>
            <a:r>
              <a:rPr kumimoji="1" lang="ja-JP" altLang="en"/>
              <a:t>（</a:t>
            </a:r>
            <a:r>
              <a:rPr kumimoji="1" lang="en" altLang="ja-JP" dirty="0"/>
              <a:t>CKL2</a:t>
            </a:r>
            <a:r>
              <a:rPr kumimoji="1" lang="ja-JP" altLang="en"/>
              <a:t>）</a:t>
            </a:r>
            <a:r>
              <a:rPr kumimoji="1" lang="ja-JP" altLang="en-US"/>
              <a:t>を介してブラジノステロイド（</a:t>
            </a:r>
            <a:r>
              <a:rPr kumimoji="1" lang="en" altLang="ja-JP" dirty="0"/>
              <a:t>BR</a:t>
            </a:r>
            <a:r>
              <a:rPr kumimoji="1" lang="ja-JP" altLang="en"/>
              <a:t>）</a:t>
            </a:r>
            <a:r>
              <a:rPr kumimoji="1" lang="ja-JP" altLang="en-US"/>
              <a:t>シグナル伝達の上流成分を活性化することが報告されている。この研究で行われたリン酸化プロテオーム解析では、</a:t>
            </a:r>
            <a:r>
              <a:rPr kumimoji="1" lang="en-US" altLang="ja-JP" dirty="0"/>
              <a:t>13,295</a:t>
            </a:r>
            <a:r>
              <a:rPr kumimoji="1" lang="ja-JP" altLang="en-US"/>
              <a:t>種類のペプチドが同定され、そのうち</a:t>
            </a:r>
            <a:r>
              <a:rPr kumimoji="1" lang="en-US" altLang="ja-JP" dirty="0"/>
              <a:t>10,768</a:t>
            </a:r>
            <a:r>
              <a:rPr kumimoji="1" lang="ja-JP" altLang="en-US"/>
              <a:t>がリン酸化ペプチドだった</a:t>
            </a:r>
            <a:r>
              <a:rPr kumimoji="1" lang="en-US" altLang="ja-JP" dirty="0"/>
              <a:t>(https://</a:t>
            </a:r>
            <a:r>
              <a:rPr kumimoji="1" lang="en-US" altLang="ja-JP" dirty="0" err="1"/>
              <a:t>onlinelibrary.wiley.com</a:t>
            </a:r>
            <a:r>
              <a:rPr kumimoji="1" lang="en-US" altLang="ja-JP" dirty="0"/>
              <a:t>/</a:t>
            </a:r>
            <a:r>
              <a:rPr kumimoji="1" lang="en-US" altLang="ja-JP" dirty="0" err="1"/>
              <a:t>doi</a:t>
            </a:r>
            <a:r>
              <a:rPr kumimoji="1" lang="en-US" altLang="ja-JP" dirty="0"/>
              <a:t>/10.1111/jipb.13397)</a:t>
            </a:r>
            <a:r>
              <a:rPr kumimoji="1" lang="ja-JP" altLang="en-US"/>
              <a:t>。その研究と比較すると、約</a:t>
            </a:r>
            <a:r>
              <a:rPr kumimoji="1" lang="en-US" altLang="ja-JP" dirty="0"/>
              <a:t>2.6</a:t>
            </a:r>
            <a:r>
              <a:rPr kumimoji="1" lang="ja-JP" altLang="en-US"/>
              <a:t>倍のペプチド種数と約</a:t>
            </a:r>
            <a:r>
              <a:rPr kumimoji="1" lang="en-US" altLang="ja-JP" dirty="0"/>
              <a:t>2.3</a:t>
            </a:r>
            <a:r>
              <a:rPr kumimoji="1" lang="ja-JP" altLang="en-US"/>
              <a:t>倍のリン酸化ペプチド種数を同定することができた。</a:t>
            </a:r>
            <a:endParaRPr kumimoji="1" lang="en-US" altLang="ja-JP" dirty="0"/>
          </a:p>
          <a:p>
            <a:r>
              <a:rPr kumimoji="1" lang="ja-JP" altLang="en-US"/>
              <a:t>一方でイネでは、</a:t>
            </a:r>
            <a:r>
              <a:rPr kumimoji="1" lang="en-US" altLang="ja-JP" dirty="0"/>
              <a:t>2017</a:t>
            </a:r>
            <a:r>
              <a:rPr kumimoji="1" lang="ja-JP" altLang="en-US"/>
              <a:t>年に</a:t>
            </a:r>
            <a:r>
              <a:rPr kumimoji="1" lang="en" altLang="ja-JP" dirty="0"/>
              <a:t>ABA</a:t>
            </a:r>
            <a:r>
              <a:rPr kumimoji="1" lang="ja-JP" altLang="en-US"/>
              <a:t>応答をリン酸化プロテオミクスで調べられているが、当時は</a:t>
            </a:r>
            <a:r>
              <a:rPr kumimoji="1" lang="en-US" altLang="ja-JP" dirty="0"/>
              <a:t>2162</a:t>
            </a:r>
            <a:r>
              <a:rPr kumimoji="1" lang="ja-JP" altLang="en-US"/>
              <a:t>種類のリン酸化ペプチドが同定されていた。今回我々は</a:t>
            </a:r>
            <a:r>
              <a:rPr kumimoji="1" lang="en-US" altLang="ja-JP" dirty="0"/>
              <a:t>18865</a:t>
            </a:r>
            <a:r>
              <a:rPr kumimoji="1" lang="ja-JP" altLang="en-US"/>
              <a:t>種類（約</a:t>
            </a:r>
            <a:r>
              <a:rPr kumimoji="1" lang="en-US" altLang="ja-JP" dirty="0"/>
              <a:t>8.7</a:t>
            </a:r>
            <a:r>
              <a:rPr kumimoji="1" lang="ja-JP" altLang="en-US"/>
              <a:t>倍）のリン酸化ペプチドを同定することができた。</a:t>
            </a:r>
            <a:endParaRPr kumimoji="1" lang="en-US" altLang="ja-JP" dirty="0"/>
          </a:p>
          <a:p>
            <a:r>
              <a:rPr kumimoji="1" lang="ja-JP" altLang="en-US"/>
              <a:t>ダイズのリン酸化プロテオーム研究では、</a:t>
            </a:r>
            <a:endParaRPr kumimoji="1" lang="ja-JP" altLang="en"/>
          </a:p>
        </p:txBody>
      </p:sp>
      <p:sp>
        <p:nvSpPr>
          <p:cNvPr id="4" name="スライド番号プレースホルダー 3">
            <a:extLst>
              <a:ext uri="{FF2B5EF4-FFF2-40B4-BE49-F238E27FC236}">
                <a16:creationId xmlns:a16="http://schemas.microsoft.com/office/drawing/2014/main" id="{58013978-7295-FB56-B84C-CDA2694333EF}"/>
              </a:ext>
            </a:extLst>
          </p:cNvPr>
          <p:cNvSpPr>
            <a:spLocks noGrp="1"/>
          </p:cNvSpPr>
          <p:nvPr>
            <p:ph type="sldNum" sz="quarter" idx="5"/>
          </p:nvPr>
        </p:nvSpPr>
        <p:spPr/>
        <p:txBody>
          <a:bodyPr/>
          <a:lstStyle/>
          <a:p>
            <a:fld id="{7F37041C-9C9F-0542-9320-4ABB0B3E1A57}" type="slidenum">
              <a:rPr kumimoji="1" lang="ja-JP" altLang="en-US" smtClean="0"/>
              <a:t>6</a:t>
            </a:fld>
            <a:endParaRPr kumimoji="1" lang="ja-JP" altLang="en-US"/>
          </a:p>
        </p:txBody>
      </p:sp>
    </p:spTree>
    <p:extLst>
      <p:ext uri="{BB962C8B-B14F-4D97-AF65-F5344CB8AC3E}">
        <p14:creationId xmlns:p14="http://schemas.microsoft.com/office/powerpoint/2010/main" val="24094514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8"/>
            <a:ext cx="5829300" cy="1960033"/>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15686602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6493952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488951"/>
            <a:ext cx="1157288" cy="10401300"/>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257175" y="488951"/>
            <a:ext cx="3357563" cy="10401300"/>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26183575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34298185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16351934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24072387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6184"/>
            <a:ext cx="6172200" cy="1524000"/>
          </a:xfrm>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18420752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21499890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32598369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4067"/>
            <a:ext cx="2256235" cy="154940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17772945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0"/>
            <a:ext cx="4114800" cy="755651"/>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1790DF6-7D48-DA49-B864-C2011E2B4CBC}" type="datetimeFigureOut">
              <a:rPr kumimoji="1" lang="ja-JP" altLang="en-US" smtClean="0"/>
              <a:t>2026/4/15</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21179856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01790DF6-7D48-DA49-B864-C2011E2B4CBC}" type="datetimeFigureOut">
              <a:rPr kumimoji="1" lang="ja-JP" altLang="en-US" smtClean="0"/>
              <a:t>2026/4/15</a:t>
            </a:fld>
            <a:endParaRPr kumimoji="1" lang="ja-JP" altLang="en-US"/>
          </a:p>
        </p:txBody>
      </p:sp>
      <p:sp>
        <p:nvSpPr>
          <p:cNvPr id="5" name="フッター プレースホルダー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03D62F1-3E8D-2441-89F3-87167C2F667E}" type="slidenum">
              <a:rPr kumimoji="1" lang="ja-JP" altLang="en-US" smtClean="0"/>
              <a:t>‹#›</a:t>
            </a:fld>
            <a:endParaRPr kumimoji="1" lang="ja-JP" altLang="en-US"/>
          </a:p>
        </p:txBody>
      </p:sp>
    </p:spTree>
    <p:extLst>
      <p:ext uri="{BB962C8B-B14F-4D97-AF65-F5344CB8AC3E}">
        <p14:creationId xmlns:p14="http://schemas.microsoft.com/office/powerpoint/2010/main" val="12847347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image" Target="../media/image2.emf"/></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F804514F-A4DA-4E60-2C45-03736E7ECF4F}"/>
              </a:ext>
            </a:extLst>
          </p:cNvPr>
          <p:cNvSpPr txBox="1"/>
          <p:nvPr/>
        </p:nvSpPr>
        <p:spPr>
          <a:xfrm>
            <a:off x="880637" y="4432267"/>
            <a:ext cx="5400000" cy="553998"/>
          </a:xfrm>
          <a:prstGeom prst="rect">
            <a:avLst/>
          </a:prstGeom>
          <a:noFill/>
        </p:spPr>
        <p:txBody>
          <a:bodyPr wrap="square">
            <a:spAutoFit/>
          </a:bodyPr>
          <a:lstStyle/>
          <a:p>
            <a:pPr algn="just">
              <a:buNone/>
            </a:pPr>
            <a:r>
              <a:rPr lang="en-US" altLang="ja-JP" sz="1000" b="1" dirty="0">
                <a:latin typeface="Arial" panose="020B0604020202020204" pitchFamily="34" charset="0"/>
                <a:cs typeface="Arial" panose="020B0604020202020204" pitchFamily="34" charset="0"/>
              </a:rPr>
              <a:t>Supplementary Figure S1. </a:t>
            </a:r>
            <a:r>
              <a:rPr lang="en-US" altLang="ja-JP" sz="1000" b="1" kern="100" dirty="0">
                <a:effectLst/>
                <a:latin typeface="Arial" panose="020B0604020202020204" pitchFamily="34" charset="0"/>
                <a:ea typeface="游明朝" panose="02020400000000000000" pitchFamily="18" charset="-128"/>
                <a:cs typeface="Arial" panose="020B0604020202020204" pitchFamily="34" charset="0"/>
              </a:rPr>
              <a:t>Number</a:t>
            </a:r>
            <a:r>
              <a:rPr lang="en-US" altLang="ja-JP" sz="1000" b="1" dirty="0">
                <a:latin typeface="Arial" panose="020B0604020202020204" pitchFamily="34" charset="0"/>
                <a:cs typeface="Arial" panose="020B0604020202020204" pitchFamily="34" charset="0"/>
              </a:rPr>
              <a:t> of identified</a:t>
            </a:r>
            <a:r>
              <a:rPr lang="ja-JP" altLang="en-US" sz="1000" b="1" dirty="0">
                <a:latin typeface="Arial" panose="020B0604020202020204" pitchFamily="34" charset="0"/>
                <a:cs typeface="Arial" panose="020B0604020202020204" pitchFamily="34" charset="0"/>
              </a:rPr>
              <a:t> </a:t>
            </a:r>
            <a:r>
              <a:rPr lang="en-US" altLang="ja-JP" sz="1000" b="1" dirty="0" err="1">
                <a:latin typeface="Arial" panose="020B0604020202020204" pitchFamily="34" charset="0"/>
                <a:cs typeface="Arial" panose="020B0604020202020204" pitchFamily="34" charset="0"/>
              </a:rPr>
              <a:t>phosphopeptides</a:t>
            </a:r>
            <a:r>
              <a:rPr lang="en-US" altLang="ja-JP" sz="1000" b="1" dirty="0">
                <a:latin typeface="Arial" panose="020B0604020202020204" pitchFamily="34" charset="0"/>
                <a:cs typeface="Arial" panose="020B0604020202020204" pitchFamily="34" charset="0"/>
              </a:rPr>
              <a:t> in the </a:t>
            </a:r>
            <a:r>
              <a:rPr lang="en-US" altLang="ja-JP" sz="1000" b="1" dirty="0" err="1">
                <a:latin typeface="Arial" panose="020B0604020202020204" pitchFamily="34" charset="0"/>
                <a:cs typeface="Arial" panose="020B0604020202020204" pitchFamily="34" charset="0"/>
              </a:rPr>
              <a:t>phosphoproteomic</a:t>
            </a:r>
            <a:r>
              <a:rPr lang="en-US" altLang="ja-JP" sz="1000" b="1" dirty="0">
                <a:latin typeface="Arial" panose="020B0604020202020204" pitchFamily="34" charset="0"/>
                <a:cs typeface="Arial" panose="020B0604020202020204" pitchFamily="34" charset="0"/>
              </a:rPr>
              <a:t> analysis. </a:t>
            </a:r>
            <a:r>
              <a:rPr lang="en-US" altLang="ja-JP" sz="1000" dirty="0">
                <a:latin typeface="Arial" panose="020B0604020202020204" pitchFamily="34" charset="0"/>
                <a:cs typeface="Arial" panose="020B0604020202020204" pitchFamily="34" charset="0"/>
              </a:rPr>
              <a:t>Data are presented as means ± SE (n = 4 biologically independent samples).</a:t>
            </a:r>
            <a:endParaRPr lang="en-US" altLang="ja-JP" sz="1000" kern="100" dirty="0">
              <a:latin typeface="Arial" panose="020B0604020202020204" pitchFamily="34" charset="0"/>
              <a:ea typeface="游明朝" panose="02020400000000000000" pitchFamily="18" charset="-128"/>
              <a:cs typeface="Arial" panose="020B0604020202020204" pitchFamily="34" charset="0"/>
            </a:endParaRPr>
          </a:p>
        </p:txBody>
      </p:sp>
      <p:graphicFrame>
        <p:nvGraphicFramePr>
          <p:cNvPr id="2" name="グラフ 1">
            <a:extLst>
              <a:ext uri="{FF2B5EF4-FFF2-40B4-BE49-F238E27FC236}">
                <a16:creationId xmlns:a16="http://schemas.microsoft.com/office/drawing/2014/main" id="{8BC9A3F7-D585-FC91-05D3-504009027624}"/>
              </a:ext>
            </a:extLst>
          </p:cNvPr>
          <p:cNvGraphicFramePr>
            <a:graphicFrameLocks/>
          </p:cNvGraphicFramePr>
          <p:nvPr>
            <p:extLst>
              <p:ext uri="{D42A27DB-BD31-4B8C-83A1-F6EECF244321}">
                <p14:modId xmlns:p14="http://schemas.microsoft.com/office/powerpoint/2010/main" val="922098616"/>
              </p:ext>
            </p:extLst>
          </p:nvPr>
        </p:nvGraphicFramePr>
        <p:xfrm>
          <a:off x="2483543" y="2561967"/>
          <a:ext cx="1800000" cy="1350000"/>
        </p:xfrm>
        <a:graphic>
          <a:graphicData uri="http://schemas.openxmlformats.org/drawingml/2006/chart">
            <c:chart xmlns:c="http://schemas.openxmlformats.org/drawingml/2006/chart" xmlns:r="http://schemas.openxmlformats.org/officeDocument/2006/relationships" r:id="rId2"/>
          </a:graphicData>
        </a:graphic>
      </p:graphicFrame>
      <p:sp>
        <p:nvSpPr>
          <p:cNvPr id="3" name="正方形/長方形 2">
            <a:extLst>
              <a:ext uri="{FF2B5EF4-FFF2-40B4-BE49-F238E27FC236}">
                <a16:creationId xmlns:a16="http://schemas.microsoft.com/office/drawing/2014/main" id="{9F2C9C8D-504A-E530-7A56-2203B20FC5FD}"/>
              </a:ext>
            </a:extLst>
          </p:cNvPr>
          <p:cNvSpPr/>
          <p:nvPr/>
        </p:nvSpPr>
        <p:spPr>
          <a:xfrm>
            <a:off x="2571750" y="2689860"/>
            <a:ext cx="1620000" cy="1080000"/>
          </a:xfrm>
          <a:prstGeom prst="rect">
            <a:avLst/>
          </a:prstGeom>
          <a:noFill/>
          <a:ln w="63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grpSp>
        <p:nvGrpSpPr>
          <p:cNvPr id="15" name="グループ化 14">
            <a:extLst>
              <a:ext uri="{FF2B5EF4-FFF2-40B4-BE49-F238E27FC236}">
                <a16:creationId xmlns:a16="http://schemas.microsoft.com/office/drawing/2014/main" id="{0BE4E3BF-0530-0C14-2A57-A5941E9D662A}"/>
              </a:ext>
            </a:extLst>
          </p:cNvPr>
          <p:cNvGrpSpPr/>
          <p:nvPr/>
        </p:nvGrpSpPr>
        <p:grpSpPr>
          <a:xfrm>
            <a:off x="2418532" y="2609031"/>
            <a:ext cx="219932" cy="1248204"/>
            <a:chOff x="2418532" y="2609031"/>
            <a:chExt cx="219932" cy="1248204"/>
          </a:xfrm>
        </p:grpSpPr>
        <p:cxnSp>
          <p:nvCxnSpPr>
            <p:cNvPr id="6" name="直線コネクタ 5">
              <a:extLst>
                <a:ext uri="{FF2B5EF4-FFF2-40B4-BE49-F238E27FC236}">
                  <a16:creationId xmlns:a16="http://schemas.microsoft.com/office/drawing/2014/main" id="{1E15C652-673D-B3D1-1A8A-FBF276623873}"/>
                </a:ext>
              </a:extLst>
            </p:cNvPr>
            <p:cNvCxnSpPr>
              <a:cxnSpLocks/>
            </p:cNvCxnSpPr>
            <p:nvPr/>
          </p:nvCxnSpPr>
          <p:spPr>
            <a:xfrm>
              <a:off x="2571750" y="2689860"/>
              <a:ext cx="3600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8" name="直線コネクタ 7">
              <a:extLst>
                <a:ext uri="{FF2B5EF4-FFF2-40B4-BE49-F238E27FC236}">
                  <a16:creationId xmlns:a16="http://schemas.microsoft.com/office/drawing/2014/main" id="{335C0A61-C59B-897B-2C4D-9746FA8B1404}"/>
                </a:ext>
              </a:extLst>
            </p:cNvPr>
            <p:cNvCxnSpPr>
              <a:cxnSpLocks/>
            </p:cNvCxnSpPr>
            <p:nvPr/>
          </p:nvCxnSpPr>
          <p:spPr>
            <a:xfrm>
              <a:off x="2571750" y="3049860"/>
              <a:ext cx="3600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9" name="直線コネクタ 8">
              <a:extLst>
                <a:ext uri="{FF2B5EF4-FFF2-40B4-BE49-F238E27FC236}">
                  <a16:creationId xmlns:a16="http://schemas.microsoft.com/office/drawing/2014/main" id="{095971B2-CE22-72B6-EED6-99C93487052D}"/>
                </a:ext>
              </a:extLst>
            </p:cNvPr>
            <p:cNvCxnSpPr>
              <a:cxnSpLocks/>
            </p:cNvCxnSpPr>
            <p:nvPr/>
          </p:nvCxnSpPr>
          <p:spPr>
            <a:xfrm>
              <a:off x="2571750" y="3409860"/>
              <a:ext cx="3600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0" name="直線コネクタ 9">
              <a:extLst>
                <a:ext uri="{FF2B5EF4-FFF2-40B4-BE49-F238E27FC236}">
                  <a16:creationId xmlns:a16="http://schemas.microsoft.com/office/drawing/2014/main" id="{18FFD96D-5822-06A7-2BEB-70C601391963}"/>
                </a:ext>
              </a:extLst>
            </p:cNvPr>
            <p:cNvCxnSpPr>
              <a:cxnSpLocks/>
            </p:cNvCxnSpPr>
            <p:nvPr/>
          </p:nvCxnSpPr>
          <p:spPr>
            <a:xfrm>
              <a:off x="2571750" y="3769860"/>
              <a:ext cx="3600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1" name="テキスト ボックス 10">
              <a:extLst>
                <a:ext uri="{FF2B5EF4-FFF2-40B4-BE49-F238E27FC236}">
                  <a16:creationId xmlns:a16="http://schemas.microsoft.com/office/drawing/2014/main" id="{2E152DA7-B23F-E7FF-94A5-1ED25121D232}"/>
                </a:ext>
              </a:extLst>
            </p:cNvPr>
            <p:cNvSpPr txBox="1"/>
            <p:nvPr/>
          </p:nvSpPr>
          <p:spPr>
            <a:xfrm>
              <a:off x="2418532" y="2609031"/>
              <a:ext cx="219932" cy="169277"/>
            </a:xfrm>
            <a:prstGeom prst="rect">
              <a:avLst/>
            </a:prstGeom>
            <a:noFill/>
          </p:spPr>
          <p:txBody>
            <a:bodyPr wrap="none" rtlCol="0">
              <a:spAutoFit/>
            </a:bodyPr>
            <a:lstStyle/>
            <a:p>
              <a:pPr algn="r"/>
              <a:r>
                <a:rPr kumimoji="1" lang="en-US" altLang="ja-JP" sz="500" dirty="0">
                  <a:latin typeface="Arial"/>
                  <a:cs typeface="Arial"/>
                </a:rPr>
                <a:t>3</a:t>
              </a:r>
              <a:endParaRPr kumimoji="1" lang="ja-JP" altLang="en-US" sz="500" dirty="0">
                <a:latin typeface="Arial"/>
                <a:cs typeface="Arial"/>
              </a:endParaRPr>
            </a:p>
          </p:txBody>
        </p:sp>
        <p:sp>
          <p:nvSpPr>
            <p:cNvPr id="12" name="テキスト ボックス 11">
              <a:extLst>
                <a:ext uri="{FF2B5EF4-FFF2-40B4-BE49-F238E27FC236}">
                  <a16:creationId xmlns:a16="http://schemas.microsoft.com/office/drawing/2014/main" id="{9F51520B-EFE9-80C5-F86D-529339E3AE34}"/>
                </a:ext>
              </a:extLst>
            </p:cNvPr>
            <p:cNvSpPr txBox="1"/>
            <p:nvPr/>
          </p:nvSpPr>
          <p:spPr>
            <a:xfrm>
              <a:off x="2418532" y="2968673"/>
              <a:ext cx="219932" cy="169277"/>
            </a:xfrm>
            <a:prstGeom prst="rect">
              <a:avLst/>
            </a:prstGeom>
            <a:noFill/>
          </p:spPr>
          <p:txBody>
            <a:bodyPr wrap="none" rtlCol="0">
              <a:spAutoFit/>
            </a:bodyPr>
            <a:lstStyle/>
            <a:p>
              <a:pPr algn="r"/>
              <a:r>
                <a:rPr lang="en-US" altLang="ja-JP" sz="500" dirty="0">
                  <a:latin typeface="Arial"/>
                  <a:cs typeface="Arial"/>
                </a:rPr>
                <a:t>2</a:t>
              </a:r>
              <a:endParaRPr kumimoji="1" lang="ja-JP" altLang="en-US" sz="500" dirty="0">
                <a:latin typeface="Arial"/>
                <a:cs typeface="Arial"/>
              </a:endParaRPr>
            </a:p>
          </p:txBody>
        </p:sp>
        <p:sp>
          <p:nvSpPr>
            <p:cNvPr id="13" name="テキスト ボックス 12">
              <a:extLst>
                <a:ext uri="{FF2B5EF4-FFF2-40B4-BE49-F238E27FC236}">
                  <a16:creationId xmlns:a16="http://schemas.microsoft.com/office/drawing/2014/main" id="{979D7CCC-A9D3-0374-319B-689640C1FBC6}"/>
                </a:ext>
              </a:extLst>
            </p:cNvPr>
            <p:cNvSpPr txBox="1"/>
            <p:nvPr/>
          </p:nvSpPr>
          <p:spPr>
            <a:xfrm>
              <a:off x="2418532" y="3328315"/>
              <a:ext cx="219932" cy="169277"/>
            </a:xfrm>
            <a:prstGeom prst="rect">
              <a:avLst/>
            </a:prstGeom>
            <a:noFill/>
          </p:spPr>
          <p:txBody>
            <a:bodyPr wrap="none" rtlCol="0">
              <a:spAutoFit/>
            </a:bodyPr>
            <a:lstStyle/>
            <a:p>
              <a:pPr algn="r"/>
              <a:r>
                <a:rPr lang="en-US" altLang="ja-JP" sz="500" dirty="0">
                  <a:latin typeface="Arial"/>
                  <a:cs typeface="Arial"/>
                </a:rPr>
                <a:t>1</a:t>
              </a:r>
              <a:endParaRPr kumimoji="1" lang="ja-JP" altLang="en-US" sz="500" dirty="0">
                <a:latin typeface="Arial"/>
                <a:cs typeface="Arial"/>
              </a:endParaRPr>
            </a:p>
          </p:txBody>
        </p:sp>
        <p:sp>
          <p:nvSpPr>
            <p:cNvPr id="14" name="テキスト ボックス 13">
              <a:extLst>
                <a:ext uri="{FF2B5EF4-FFF2-40B4-BE49-F238E27FC236}">
                  <a16:creationId xmlns:a16="http://schemas.microsoft.com/office/drawing/2014/main" id="{B3F72838-7666-EDBD-BFDD-1CA7A94E1BE0}"/>
                </a:ext>
              </a:extLst>
            </p:cNvPr>
            <p:cNvSpPr txBox="1"/>
            <p:nvPr/>
          </p:nvSpPr>
          <p:spPr>
            <a:xfrm>
              <a:off x="2418532" y="3687958"/>
              <a:ext cx="219932" cy="169277"/>
            </a:xfrm>
            <a:prstGeom prst="rect">
              <a:avLst/>
            </a:prstGeom>
            <a:noFill/>
          </p:spPr>
          <p:txBody>
            <a:bodyPr wrap="none" rtlCol="0">
              <a:spAutoFit/>
            </a:bodyPr>
            <a:lstStyle/>
            <a:p>
              <a:pPr algn="r"/>
              <a:r>
                <a:rPr lang="en-US" altLang="ja-JP" sz="500" dirty="0">
                  <a:latin typeface="Arial"/>
                  <a:cs typeface="Arial"/>
                </a:rPr>
                <a:t>0</a:t>
              </a:r>
              <a:endParaRPr kumimoji="1" lang="ja-JP" altLang="en-US" sz="500" dirty="0">
                <a:latin typeface="Arial"/>
                <a:cs typeface="Arial"/>
              </a:endParaRPr>
            </a:p>
          </p:txBody>
        </p:sp>
      </p:grpSp>
      <p:sp>
        <p:nvSpPr>
          <p:cNvPr id="16" name="テキスト ボックス 15">
            <a:extLst>
              <a:ext uri="{FF2B5EF4-FFF2-40B4-BE49-F238E27FC236}">
                <a16:creationId xmlns:a16="http://schemas.microsoft.com/office/drawing/2014/main" id="{DF5BCDA0-8ECA-A481-B790-9C3F99D99A1D}"/>
              </a:ext>
            </a:extLst>
          </p:cNvPr>
          <p:cNvSpPr txBox="1"/>
          <p:nvPr/>
        </p:nvSpPr>
        <p:spPr>
          <a:xfrm rot="16200000">
            <a:off x="1829691" y="3153128"/>
            <a:ext cx="1111203" cy="184666"/>
          </a:xfrm>
          <a:prstGeom prst="rect">
            <a:avLst/>
          </a:prstGeom>
          <a:noFill/>
        </p:spPr>
        <p:txBody>
          <a:bodyPr wrap="none" rtlCol="0">
            <a:spAutoFit/>
          </a:bodyPr>
          <a:lstStyle/>
          <a:p>
            <a:pPr algn="r"/>
            <a:r>
              <a:rPr lang="en-US" altLang="ja-JP" sz="600" dirty="0" err="1">
                <a:latin typeface="Arial"/>
                <a:cs typeface="Arial"/>
              </a:rPr>
              <a:t>Phosphopeptides</a:t>
            </a:r>
            <a:r>
              <a:rPr lang="en-US" altLang="ja-JP" sz="600" dirty="0">
                <a:latin typeface="Arial"/>
                <a:cs typeface="Arial"/>
              </a:rPr>
              <a:t> (x10000)</a:t>
            </a:r>
            <a:endParaRPr kumimoji="1" lang="ja-JP" altLang="en-US" sz="600" dirty="0">
              <a:latin typeface="Arial"/>
              <a:cs typeface="Arial"/>
            </a:endParaRPr>
          </a:p>
        </p:txBody>
      </p:sp>
      <p:grpSp>
        <p:nvGrpSpPr>
          <p:cNvPr id="27" name="グループ化 26">
            <a:extLst>
              <a:ext uri="{FF2B5EF4-FFF2-40B4-BE49-F238E27FC236}">
                <a16:creationId xmlns:a16="http://schemas.microsoft.com/office/drawing/2014/main" id="{99B30E1C-6DB7-2CDE-750D-28C1D03A582B}"/>
              </a:ext>
            </a:extLst>
          </p:cNvPr>
          <p:cNvGrpSpPr/>
          <p:nvPr/>
        </p:nvGrpSpPr>
        <p:grpSpPr>
          <a:xfrm>
            <a:off x="2661036" y="3854058"/>
            <a:ext cx="432000" cy="184666"/>
            <a:chOff x="2655118" y="3862935"/>
            <a:chExt cx="432000" cy="184666"/>
          </a:xfrm>
        </p:grpSpPr>
        <p:sp>
          <p:nvSpPr>
            <p:cNvPr id="17" name="テキスト ボックス 16">
              <a:extLst>
                <a:ext uri="{FF2B5EF4-FFF2-40B4-BE49-F238E27FC236}">
                  <a16:creationId xmlns:a16="http://schemas.microsoft.com/office/drawing/2014/main" id="{921BD76C-6C83-3CE1-AE3F-69933C5E1231}"/>
                </a:ext>
              </a:extLst>
            </p:cNvPr>
            <p:cNvSpPr txBox="1"/>
            <p:nvPr/>
          </p:nvSpPr>
          <p:spPr>
            <a:xfrm>
              <a:off x="2685811" y="3862935"/>
              <a:ext cx="370614" cy="184666"/>
            </a:xfrm>
            <a:prstGeom prst="rect">
              <a:avLst/>
            </a:prstGeom>
            <a:noFill/>
          </p:spPr>
          <p:txBody>
            <a:bodyPr wrap="none" rtlCol="0">
              <a:spAutoFit/>
            </a:bodyPr>
            <a:lstStyle/>
            <a:p>
              <a:pPr algn="r"/>
              <a:r>
                <a:rPr kumimoji="1" lang="en-US" altLang="ja-JP" sz="600" dirty="0">
                  <a:latin typeface="Arial"/>
                  <a:cs typeface="Arial"/>
                </a:rPr>
                <a:t>Col-0</a:t>
              </a:r>
              <a:endParaRPr kumimoji="1" lang="ja-JP" altLang="en-US" sz="600" dirty="0">
                <a:latin typeface="Arial"/>
                <a:cs typeface="Arial"/>
              </a:endParaRPr>
            </a:p>
          </p:txBody>
        </p:sp>
        <p:cxnSp>
          <p:nvCxnSpPr>
            <p:cNvPr id="21" name="直線コネクタ 20">
              <a:extLst>
                <a:ext uri="{FF2B5EF4-FFF2-40B4-BE49-F238E27FC236}">
                  <a16:creationId xmlns:a16="http://schemas.microsoft.com/office/drawing/2014/main" id="{588F60AE-98FF-F44B-782F-6EE73974C0E5}"/>
                </a:ext>
              </a:extLst>
            </p:cNvPr>
            <p:cNvCxnSpPr>
              <a:cxnSpLocks/>
            </p:cNvCxnSpPr>
            <p:nvPr/>
          </p:nvCxnSpPr>
          <p:spPr>
            <a:xfrm>
              <a:off x="2655118" y="3874215"/>
              <a:ext cx="43200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26" name="グループ化 25">
            <a:extLst>
              <a:ext uri="{FF2B5EF4-FFF2-40B4-BE49-F238E27FC236}">
                <a16:creationId xmlns:a16="http://schemas.microsoft.com/office/drawing/2014/main" id="{78F023F0-61BB-7CF8-5125-9A427CB90A1D}"/>
              </a:ext>
            </a:extLst>
          </p:cNvPr>
          <p:cNvGrpSpPr/>
          <p:nvPr/>
        </p:nvGrpSpPr>
        <p:grpSpPr>
          <a:xfrm>
            <a:off x="3171171" y="3854058"/>
            <a:ext cx="434735" cy="184666"/>
            <a:chOff x="3165253" y="3862935"/>
            <a:chExt cx="434735" cy="184666"/>
          </a:xfrm>
        </p:grpSpPr>
        <p:sp>
          <p:nvSpPr>
            <p:cNvPr id="18" name="テキスト ボックス 17">
              <a:extLst>
                <a:ext uri="{FF2B5EF4-FFF2-40B4-BE49-F238E27FC236}">
                  <a16:creationId xmlns:a16="http://schemas.microsoft.com/office/drawing/2014/main" id="{16E2C1B1-1641-E206-9763-06E665F85D31}"/>
                </a:ext>
              </a:extLst>
            </p:cNvPr>
            <p:cNvSpPr txBox="1"/>
            <p:nvPr/>
          </p:nvSpPr>
          <p:spPr>
            <a:xfrm>
              <a:off x="3165253" y="3862935"/>
              <a:ext cx="434735" cy="184666"/>
            </a:xfrm>
            <a:prstGeom prst="rect">
              <a:avLst/>
            </a:prstGeom>
            <a:noFill/>
          </p:spPr>
          <p:txBody>
            <a:bodyPr wrap="none" rtlCol="0">
              <a:spAutoFit/>
            </a:bodyPr>
            <a:lstStyle/>
            <a:p>
              <a:pPr algn="r"/>
              <a:r>
                <a:rPr lang="en-US" altLang="ja-JP" sz="600" i="1" dirty="0">
                  <a:latin typeface="Arial"/>
                  <a:cs typeface="Arial"/>
                </a:rPr>
                <a:t>srk2dei</a:t>
              </a:r>
              <a:endParaRPr kumimoji="1" lang="ja-JP" altLang="en-US" sz="600" i="1" dirty="0">
                <a:latin typeface="Arial"/>
                <a:cs typeface="Arial"/>
              </a:endParaRPr>
            </a:p>
          </p:txBody>
        </p:sp>
        <p:cxnSp>
          <p:nvCxnSpPr>
            <p:cNvPr id="23" name="直線コネクタ 22">
              <a:extLst>
                <a:ext uri="{FF2B5EF4-FFF2-40B4-BE49-F238E27FC236}">
                  <a16:creationId xmlns:a16="http://schemas.microsoft.com/office/drawing/2014/main" id="{74B970A2-2D21-6302-29E1-DD88A075771B}"/>
                </a:ext>
              </a:extLst>
            </p:cNvPr>
            <p:cNvCxnSpPr>
              <a:cxnSpLocks/>
            </p:cNvCxnSpPr>
            <p:nvPr/>
          </p:nvCxnSpPr>
          <p:spPr>
            <a:xfrm>
              <a:off x="3166620" y="3874215"/>
              <a:ext cx="43200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25" name="グループ化 24">
            <a:extLst>
              <a:ext uri="{FF2B5EF4-FFF2-40B4-BE49-F238E27FC236}">
                <a16:creationId xmlns:a16="http://schemas.microsoft.com/office/drawing/2014/main" id="{E8080101-947D-1E9B-F358-36B746D96D60}"/>
              </a:ext>
            </a:extLst>
          </p:cNvPr>
          <p:cNvGrpSpPr/>
          <p:nvPr/>
        </p:nvGrpSpPr>
        <p:grpSpPr>
          <a:xfrm>
            <a:off x="3664968" y="3854058"/>
            <a:ext cx="457177" cy="184666"/>
            <a:chOff x="3685681" y="3862935"/>
            <a:chExt cx="457177" cy="184666"/>
          </a:xfrm>
        </p:grpSpPr>
        <p:sp>
          <p:nvSpPr>
            <p:cNvPr id="19" name="テキスト ボックス 18">
              <a:extLst>
                <a:ext uri="{FF2B5EF4-FFF2-40B4-BE49-F238E27FC236}">
                  <a16:creationId xmlns:a16="http://schemas.microsoft.com/office/drawing/2014/main" id="{DE6F5C3B-E047-03BA-E8B3-87008FD8045F}"/>
                </a:ext>
              </a:extLst>
            </p:cNvPr>
            <p:cNvSpPr txBox="1"/>
            <p:nvPr/>
          </p:nvSpPr>
          <p:spPr>
            <a:xfrm>
              <a:off x="3685681" y="3862935"/>
              <a:ext cx="457177" cy="184666"/>
            </a:xfrm>
            <a:prstGeom prst="rect">
              <a:avLst/>
            </a:prstGeom>
            <a:noFill/>
          </p:spPr>
          <p:txBody>
            <a:bodyPr wrap="none" rtlCol="0">
              <a:spAutoFit/>
            </a:bodyPr>
            <a:lstStyle/>
            <a:p>
              <a:pPr algn="r"/>
              <a:r>
                <a:rPr lang="en-US" altLang="ja-JP" sz="600" i="1" dirty="0">
                  <a:latin typeface="Arial"/>
                  <a:cs typeface="Arial"/>
                </a:rPr>
                <a:t>a</a:t>
              </a:r>
              <a:r>
                <a:rPr kumimoji="1" lang="en-US" altLang="ja-JP" sz="600" i="1" dirty="0">
                  <a:latin typeface="Arial"/>
                  <a:cs typeface="Arial"/>
                </a:rPr>
                <a:t>bi1-1C</a:t>
              </a:r>
              <a:endParaRPr kumimoji="1" lang="ja-JP" altLang="en-US" sz="600" i="1" dirty="0">
                <a:latin typeface="Arial"/>
                <a:cs typeface="Arial"/>
              </a:endParaRPr>
            </a:p>
          </p:txBody>
        </p:sp>
        <p:cxnSp>
          <p:nvCxnSpPr>
            <p:cNvPr id="24" name="直線コネクタ 23">
              <a:extLst>
                <a:ext uri="{FF2B5EF4-FFF2-40B4-BE49-F238E27FC236}">
                  <a16:creationId xmlns:a16="http://schemas.microsoft.com/office/drawing/2014/main" id="{EB75B523-6CE4-793A-66F8-790AF2B6E443}"/>
                </a:ext>
              </a:extLst>
            </p:cNvPr>
            <p:cNvCxnSpPr>
              <a:cxnSpLocks/>
            </p:cNvCxnSpPr>
            <p:nvPr/>
          </p:nvCxnSpPr>
          <p:spPr>
            <a:xfrm>
              <a:off x="3698269" y="3874215"/>
              <a:ext cx="432000"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40" name="グループ化 39">
            <a:extLst>
              <a:ext uri="{FF2B5EF4-FFF2-40B4-BE49-F238E27FC236}">
                <a16:creationId xmlns:a16="http://schemas.microsoft.com/office/drawing/2014/main" id="{C3BC79A8-34F1-9248-4D85-0E2F9FA729D7}"/>
              </a:ext>
            </a:extLst>
          </p:cNvPr>
          <p:cNvGrpSpPr/>
          <p:nvPr/>
        </p:nvGrpSpPr>
        <p:grpSpPr>
          <a:xfrm>
            <a:off x="2575092" y="3727682"/>
            <a:ext cx="1643492" cy="169277"/>
            <a:chOff x="2575092" y="3727682"/>
            <a:chExt cx="1643492" cy="169277"/>
          </a:xfrm>
        </p:grpSpPr>
        <p:sp>
          <p:nvSpPr>
            <p:cNvPr id="28" name="テキスト ボックス 27">
              <a:extLst>
                <a:ext uri="{FF2B5EF4-FFF2-40B4-BE49-F238E27FC236}">
                  <a16:creationId xmlns:a16="http://schemas.microsoft.com/office/drawing/2014/main" id="{32E58271-2054-5A35-6913-B1187ADAB9B7}"/>
                </a:ext>
              </a:extLst>
            </p:cNvPr>
            <p:cNvSpPr txBox="1"/>
            <p:nvPr/>
          </p:nvSpPr>
          <p:spPr>
            <a:xfrm>
              <a:off x="2575092" y="3727682"/>
              <a:ext cx="219932" cy="169277"/>
            </a:xfrm>
            <a:prstGeom prst="rect">
              <a:avLst/>
            </a:prstGeom>
            <a:noFill/>
          </p:spPr>
          <p:txBody>
            <a:bodyPr wrap="none" rtlCol="0">
              <a:spAutoFit/>
            </a:bodyPr>
            <a:lstStyle/>
            <a:p>
              <a:pPr algn="ctr"/>
              <a:r>
                <a:rPr lang="en-US" altLang="ja-JP" sz="500" dirty="0">
                  <a:latin typeface="Arial"/>
                  <a:cs typeface="Arial"/>
                </a:rPr>
                <a:t>0</a:t>
              </a:r>
              <a:endParaRPr kumimoji="1" lang="ja-JP" altLang="en-US" sz="500" dirty="0">
                <a:latin typeface="Arial"/>
                <a:cs typeface="Arial"/>
              </a:endParaRPr>
            </a:p>
          </p:txBody>
        </p:sp>
        <p:sp>
          <p:nvSpPr>
            <p:cNvPr id="29" name="テキスト ボックス 28">
              <a:extLst>
                <a:ext uri="{FF2B5EF4-FFF2-40B4-BE49-F238E27FC236}">
                  <a16:creationId xmlns:a16="http://schemas.microsoft.com/office/drawing/2014/main" id="{639F8C31-456B-8E61-C790-0C4D0DD9F838}"/>
                </a:ext>
              </a:extLst>
            </p:cNvPr>
            <p:cNvSpPr txBox="1"/>
            <p:nvPr/>
          </p:nvSpPr>
          <p:spPr>
            <a:xfrm>
              <a:off x="2686979" y="3727682"/>
              <a:ext cx="255198" cy="169277"/>
            </a:xfrm>
            <a:prstGeom prst="rect">
              <a:avLst/>
            </a:prstGeom>
            <a:noFill/>
          </p:spPr>
          <p:txBody>
            <a:bodyPr wrap="none" rtlCol="0">
              <a:spAutoFit/>
            </a:bodyPr>
            <a:lstStyle/>
            <a:p>
              <a:pPr algn="ctr"/>
              <a:r>
                <a:rPr lang="en-US" altLang="ja-JP" sz="500" dirty="0">
                  <a:latin typeface="Arial"/>
                  <a:cs typeface="Arial"/>
                </a:rPr>
                <a:t>15</a:t>
              </a:r>
              <a:endParaRPr kumimoji="1" lang="ja-JP" altLang="en-US" sz="500" dirty="0">
                <a:latin typeface="Arial"/>
                <a:cs typeface="Arial"/>
              </a:endParaRPr>
            </a:p>
          </p:txBody>
        </p:sp>
        <p:sp>
          <p:nvSpPr>
            <p:cNvPr id="30" name="テキスト ボックス 29">
              <a:extLst>
                <a:ext uri="{FF2B5EF4-FFF2-40B4-BE49-F238E27FC236}">
                  <a16:creationId xmlns:a16="http://schemas.microsoft.com/office/drawing/2014/main" id="{A41D18C7-0803-ED86-A315-901A004B04BD}"/>
                </a:ext>
              </a:extLst>
            </p:cNvPr>
            <p:cNvSpPr txBox="1"/>
            <p:nvPr/>
          </p:nvSpPr>
          <p:spPr>
            <a:xfrm>
              <a:off x="2815268" y="3727682"/>
              <a:ext cx="255199" cy="169277"/>
            </a:xfrm>
            <a:prstGeom prst="rect">
              <a:avLst/>
            </a:prstGeom>
            <a:noFill/>
          </p:spPr>
          <p:txBody>
            <a:bodyPr wrap="none" rtlCol="0">
              <a:spAutoFit/>
            </a:bodyPr>
            <a:lstStyle/>
            <a:p>
              <a:pPr algn="ctr"/>
              <a:r>
                <a:rPr kumimoji="1" lang="en-US" altLang="ja-JP" sz="500" dirty="0">
                  <a:latin typeface="Arial"/>
                  <a:cs typeface="Arial"/>
                </a:rPr>
                <a:t>30</a:t>
              </a:r>
              <a:endParaRPr kumimoji="1" lang="ja-JP" altLang="en-US" sz="500" dirty="0">
                <a:latin typeface="Arial"/>
                <a:cs typeface="Arial"/>
              </a:endParaRPr>
            </a:p>
          </p:txBody>
        </p:sp>
        <p:sp>
          <p:nvSpPr>
            <p:cNvPr id="31" name="テキスト ボックス 30">
              <a:extLst>
                <a:ext uri="{FF2B5EF4-FFF2-40B4-BE49-F238E27FC236}">
                  <a16:creationId xmlns:a16="http://schemas.microsoft.com/office/drawing/2014/main" id="{0EC3B8CE-072D-1F9A-7335-E606CC700DCB}"/>
                </a:ext>
              </a:extLst>
            </p:cNvPr>
            <p:cNvSpPr txBox="1"/>
            <p:nvPr/>
          </p:nvSpPr>
          <p:spPr>
            <a:xfrm>
              <a:off x="2947103" y="3727682"/>
              <a:ext cx="255199" cy="169277"/>
            </a:xfrm>
            <a:prstGeom prst="rect">
              <a:avLst/>
            </a:prstGeom>
            <a:noFill/>
          </p:spPr>
          <p:txBody>
            <a:bodyPr wrap="none" rtlCol="0">
              <a:spAutoFit/>
            </a:bodyPr>
            <a:lstStyle/>
            <a:p>
              <a:pPr algn="ctr"/>
              <a:r>
                <a:rPr lang="en-US" altLang="ja-JP" sz="500" dirty="0">
                  <a:latin typeface="Arial"/>
                  <a:cs typeface="Arial"/>
                </a:rPr>
                <a:t>9</a:t>
              </a:r>
              <a:r>
                <a:rPr kumimoji="1" lang="en-US" altLang="ja-JP" sz="500" dirty="0">
                  <a:latin typeface="Arial"/>
                  <a:cs typeface="Arial"/>
                </a:rPr>
                <a:t>0</a:t>
              </a:r>
              <a:endParaRPr kumimoji="1" lang="ja-JP" altLang="en-US" sz="500" dirty="0">
                <a:latin typeface="Arial"/>
                <a:cs typeface="Arial"/>
              </a:endParaRPr>
            </a:p>
          </p:txBody>
        </p:sp>
        <p:sp>
          <p:nvSpPr>
            <p:cNvPr id="32" name="テキスト ボックス 31">
              <a:extLst>
                <a:ext uri="{FF2B5EF4-FFF2-40B4-BE49-F238E27FC236}">
                  <a16:creationId xmlns:a16="http://schemas.microsoft.com/office/drawing/2014/main" id="{0C34CFBE-60C9-44F2-7693-A362133C6403}"/>
                </a:ext>
              </a:extLst>
            </p:cNvPr>
            <p:cNvSpPr txBox="1"/>
            <p:nvPr/>
          </p:nvSpPr>
          <p:spPr>
            <a:xfrm>
              <a:off x="3085262" y="3727682"/>
              <a:ext cx="219932" cy="169277"/>
            </a:xfrm>
            <a:prstGeom prst="rect">
              <a:avLst/>
            </a:prstGeom>
            <a:noFill/>
          </p:spPr>
          <p:txBody>
            <a:bodyPr wrap="none" rtlCol="0">
              <a:spAutoFit/>
            </a:bodyPr>
            <a:lstStyle/>
            <a:p>
              <a:pPr algn="ctr"/>
              <a:r>
                <a:rPr lang="en-US" altLang="ja-JP" sz="500" dirty="0">
                  <a:latin typeface="Arial"/>
                  <a:cs typeface="Arial"/>
                </a:rPr>
                <a:t>0</a:t>
              </a:r>
              <a:endParaRPr kumimoji="1" lang="ja-JP" altLang="en-US" sz="500" dirty="0">
                <a:latin typeface="Arial"/>
                <a:cs typeface="Arial"/>
              </a:endParaRPr>
            </a:p>
          </p:txBody>
        </p:sp>
        <p:sp>
          <p:nvSpPr>
            <p:cNvPr id="33" name="テキスト ボックス 32">
              <a:extLst>
                <a:ext uri="{FF2B5EF4-FFF2-40B4-BE49-F238E27FC236}">
                  <a16:creationId xmlns:a16="http://schemas.microsoft.com/office/drawing/2014/main" id="{65B110E5-59F6-47DD-2A62-2746979062BE}"/>
                </a:ext>
              </a:extLst>
            </p:cNvPr>
            <p:cNvSpPr txBox="1"/>
            <p:nvPr/>
          </p:nvSpPr>
          <p:spPr>
            <a:xfrm>
              <a:off x="3197149" y="3727682"/>
              <a:ext cx="255198" cy="169277"/>
            </a:xfrm>
            <a:prstGeom prst="rect">
              <a:avLst/>
            </a:prstGeom>
            <a:noFill/>
          </p:spPr>
          <p:txBody>
            <a:bodyPr wrap="none" rtlCol="0">
              <a:spAutoFit/>
            </a:bodyPr>
            <a:lstStyle/>
            <a:p>
              <a:pPr algn="ctr"/>
              <a:r>
                <a:rPr lang="en-US" altLang="ja-JP" sz="500" dirty="0">
                  <a:latin typeface="Arial"/>
                  <a:cs typeface="Arial"/>
                </a:rPr>
                <a:t>15</a:t>
              </a:r>
              <a:endParaRPr kumimoji="1" lang="ja-JP" altLang="en-US" sz="500" dirty="0">
                <a:latin typeface="Arial"/>
                <a:cs typeface="Arial"/>
              </a:endParaRPr>
            </a:p>
          </p:txBody>
        </p:sp>
        <p:sp>
          <p:nvSpPr>
            <p:cNvPr id="34" name="テキスト ボックス 33">
              <a:extLst>
                <a:ext uri="{FF2B5EF4-FFF2-40B4-BE49-F238E27FC236}">
                  <a16:creationId xmlns:a16="http://schemas.microsoft.com/office/drawing/2014/main" id="{A462DBCD-815A-3470-CFAC-B9B830675A94}"/>
                </a:ext>
              </a:extLst>
            </p:cNvPr>
            <p:cNvSpPr txBox="1"/>
            <p:nvPr/>
          </p:nvSpPr>
          <p:spPr>
            <a:xfrm>
              <a:off x="3325438" y="3727682"/>
              <a:ext cx="255199" cy="169277"/>
            </a:xfrm>
            <a:prstGeom prst="rect">
              <a:avLst/>
            </a:prstGeom>
            <a:noFill/>
          </p:spPr>
          <p:txBody>
            <a:bodyPr wrap="none" rtlCol="0">
              <a:spAutoFit/>
            </a:bodyPr>
            <a:lstStyle/>
            <a:p>
              <a:pPr algn="ctr"/>
              <a:r>
                <a:rPr kumimoji="1" lang="en-US" altLang="ja-JP" sz="500" dirty="0">
                  <a:latin typeface="Arial"/>
                  <a:cs typeface="Arial"/>
                </a:rPr>
                <a:t>30</a:t>
              </a:r>
              <a:endParaRPr kumimoji="1" lang="ja-JP" altLang="en-US" sz="500" dirty="0">
                <a:latin typeface="Arial"/>
                <a:cs typeface="Arial"/>
              </a:endParaRPr>
            </a:p>
          </p:txBody>
        </p:sp>
        <p:sp>
          <p:nvSpPr>
            <p:cNvPr id="35" name="テキスト ボックス 34">
              <a:extLst>
                <a:ext uri="{FF2B5EF4-FFF2-40B4-BE49-F238E27FC236}">
                  <a16:creationId xmlns:a16="http://schemas.microsoft.com/office/drawing/2014/main" id="{C7B4996F-3087-7167-452F-628BB6CD2C93}"/>
                </a:ext>
              </a:extLst>
            </p:cNvPr>
            <p:cNvSpPr txBox="1"/>
            <p:nvPr/>
          </p:nvSpPr>
          <p:spPr>
            <a:xfrm>
              <a:off x="3457273" y="3727682"/>
              <a:ext cx="255199" cy="169277"/>
            </a:xfrm>
            <a:prstGeom prst="rect">
              <a:avLst/>
            </a:prstGeom>
            <a:noFill/>
          </p:spPr>
          <p:txBody>
            <a:bodyPr wrap="none" rtlCol="0">
              <a:spAutoFit/>
            </a:bodyPr>
            <a:lstStyle/>
            <a:p>
              <a:pPr algn="ctr"/>
              <a:r>
                <a:rPr lang="en-US" altLang="ja-JP" sz="500" dirty="0">
                  <a:latin typeface="Arial"/>
                  <a:cs typeface="Arial"/>
                </a:rPr>
                <a:t>9</a:t>
              </a:r>
              <a:r>
                <a:rPr kumimoji="1" lang="en-US" altLang="ja-JP" sz="500" dirty="0">
                  <a:latin typeface="Arial"/>
                  <a:cs typeface="Arial"/>
                </a:rPr>
                <a:t>0</a:t>
              </a:r>
              <a:endParaRPr kumimoji="1" lang="ja-JP" altLang="en-US" sz="500" dirty="0">
                <a:latin typeface="Arial"/>
                <a:cs typeface="Arial"/>
              </a:endParaRPr>
            </a:p>
          </p:txBody>
        </p:sp>
        <p:sp>
          <p:nvSpPr>
            <p:cNvPr id="36" name="テキスト ボックス 35">
              <a:extLst>
                <a:ext uri="{FF2B5EF4-FFF2-40B4-BE49-F238E27FC236}">
                  <a16:creationId xmlns:a16="http://schemas.microsoft.com/office/drawing/2014/main" id="{6AA10A24-446E-17E5-2918-E64DD9CCACCD}"/>
                </a:ext>
              </a:extLst>
            </p:cNvPr>
            <p:cNvSpPr txBox="1"/>
            <p:nvPr/>
          </p:nvSpPr>
          <p:spPr>
            <a:xfrm>
              <a:off x="3591374" y="3727682"/>
              <a:ext cx="219932" cy="169277"/>
            </a:xfrm>
            <a:prstGeom prst="rect">
              <a:avLst/>
            </a:prstGeom>
            <a:noFill/>
          </p:spPr>
          <p:txBody>
            <a:bodyPr wrap="none" rtlCol="0">
              <a:spAutoFit/>
            </a:bodyPr>
            <a:lstStyle/>
            <a:p>
              <a:pPr algn="ctr"/>
              <a:r>
                <a:rPr lang="en-US" altLang="ja-JP" sz="500" dirty="0">
                  <a:latin typeface="Arial"/>
                  <a:cs typeface="Arial"/>
                </a:rPr>
                <a:t>0</a:t>
              </a:r>
              <a:endParaRPr kumimoji="1" lang="ja-JP" altLang="en-US" sz="500" dirty="0">
                <a:latin typeface="Arial"/>
                <a:cs typeface="Arial"/>
              </a:endParaRPr>
            </a:p>
          </p:txBody>
        </p:sp>
        <p:sp>
          <p:nvSpPr>
            <p:cNvPr id="37" name="テキスト ボックス 36">
              <a:extLst>
                <a:ext uri="{FF2B5EF4-FFF2-40B4-BE49-F238E27FC236}">
                  <a16:creationId xmlns:a16="http://schemas.microsoft.com/office/drawing/2014/main" id="{8F9C5C3E-6500-2287-2559-D4E948536905}"/>
                </a:ext>
              </a:extLst>
            </p:cNvPr>
            <p:cNvSpPr txBox="1"/>
            <p:nvPr/>
          </p:nvSpPr>
          <p:spPr>
            <a:xfrm>
              <a:off x="3703261" y="3727682"/>
              <a:ext cx="255198" cy="169277"/>
            </a:xfrm>
            <a:prstGeom prst="rect">
              <a:avLst/>
            </a:prstGeom>
            <a:noFill/>
          </p:spPr>
          <p:txBody>
            <a:bodyPr wrap="none" rtlCol="0">
              <a:spAutoFit/>
            </a:bodyPr>
            <a:lstStyle/>
            <a:p>
              <a:pPr algn="ctr"/>
              <a:r>
                <a:rPr lang="en-US" altLang="ja-JP" sz="500" dirty="0">
                  <a:latin typeface="Arial"/>
                  <a:cs typeface="Arial"/>
                </a:rPr>
                <a:t>15</a:t>
              </a:r>
              <a:endParaRPr kumimoji="1" lang="ja-JP" altLang="en-US" sz="500" dirty="0">
                <a:latin typeface="Arial"/>
                <a:cs typeface="Arial"/>
              </a:endParaRPr>
            </a:p>
          </p:txBody>
        </p:sp>
        <p:sp>
          <p:nvSpPr>
            <p:cNvPr id="38" name="テキスト ボックス 37">
              <a:extLst>
                <a:ext uri="{FF2B5EF4-FFF2-40B4-BE49-F238E27FC236}">
                  <a16:creationId xmlns:a16="http://schemas.microsoft.com/office/drawing/2014/main" id="{07077F1A-B231-EF72-EFC5-D769F6FF91E5}"/>
                </a:ext>
              </a:extLst>
            </p:cNvPr>
            <p:cNvSpPr txBox="1"/>
            <p:nvPr/>
          </p:nvSpPr>
          <p:spPr>
            <a:xfrm>
              <a:off x="3831550" y="3727682"/>
              <a:ext cx="255199" cy="169277"/>
            </a:xfrm>
            <a:prstGeom prst="rect">
              <a:avLst/>
            </a:prstGeom>
            <a:noFill/>
          </p:spPr>
          <p:txBody>
            <a:bodyPr wrap="none" rtlCol="0">
              <a:spAutoFit/>
            </a:bodyPr>
            <a:lstStyle/>
            <a:p>
              <a:pPr algn="ctr"/>
              <a:r>
                <a:rPr kumimoji="1" lang="en-US" altLang="ja-JP" sz="500" dirty="0">
                  <a:latin typeface="Arial"/>
                  <a:cs typeface="Arial"/>
                </a:rPr>
                <a:t>30</a:t>
              </a:r>
              <a:endParaRPr kumimoji="1" lang="ja-JP" altLang="en-US" sz="500" dirty="0">
                <a:latin typeface="Arial"/>
                <a:cs typeface="Arial"/>
              </a:endParaRPr>
            </a:p>
          </p:txBody>
        </p:sp>
        <p:sp>
          <p:nvSpPr>
            <p:cNvPr id="39" name="テキスト ボックス 38">
              <a:extLst>
                <a:ext uri="{FF2B5EF4-FFF2-40B4-BE49-F238E27FC236}">
                  <a16:creationId xmlns:a16="http://schemas.microsoft.com/office/drawing/2014/main" id="{14E41D9C-8604-5C1D-C9B2-BA7BC555307A}"/>
                </a:ext>
              </a:extLst>
            </p:cNvPr>
            <p:cNvSpPr txBox="1"/>
            <p:nvPr/>
          </p:nvSpPr>
          <p:spPr>
            <a:xfrm>
              <a:off x="3963385" y="3727682"/>
              <a:ext cx="255199" cy="169277"/>
            </a:xfrm>
            <a:prstGeom prst="rect">
              <a:avLst/>
            </a:prstGeom>
            <a:noFill/>
          </p:spPr>
          <p:txBody>
            <a:bodyPr wrap="none" rtlCol="0">
              <a:spAutoFit/>
            </a:bodyPr>
            <a:lstStyle/>
            <a:p>
              <a:pPr algn="ctr"/>
              <a:r>
                <a:rPr lang="en-US" altLang="ja-JP" sz="500" dirty="0">
                  <a:latin typeface="Arial"/>
                  <a:cs typeface="Arial"/>
                </a:rPr>
                <a:t>9</a:t>
              </a:r>
              <a:r>
                <a:rPr kumimoji="1" lang="en-US" altLang="ja-JP" sz="500" dirty="0">
                  <a:latin typeface="Arial"/>
                  <a:cs typeface="Arial"/>
                </a:rPr>
                <a:t>0</a:t>
              </a:r>
              <a:endParaRPr kumimoji="1" lang="ja-JP" altLang="en-US" sz="500" dirty="0">
                <a:latin typeface="Arial"/>
                <a:cs typeface="Arial"/>
              </a:endParaRPr>
            </a:p>
          </p:txBody>
        </p:sp>
      </p:grpSp>
      <p:sp>
        <p:nvSpPr>
          <p:cNvPr id="41" name="テキスト ボックス 40">
            <a:extLst>
              <a:ext uri="{FF2B5EF4-FFF2-40B4-BE49-F238E27FC236}">
                <a16:creationId xmlns:a16="http://schemas.microsoft.com/office/drawing/2014/main" id="{A5C6D41D-1FCC-FCF8-37E1-31A2849FE902}"/>
              </a:ext>
            </a:extLst>
          </p:cNvPr>
          <p:cNvSpPr txBox="1"/>
          <p:nvPr/>
        </p:nvSpPr>
        <p:spPr>
          <a:xfrm>
            <a:off x="4148941" y="3680209"/>
            <a:ext cx="360997" cy="276999"/>
          </a:xfrm>
          <a:prstGeom prst="rect">
            <a:avLst/>
          </a:prstGeom>
          <a:noFill/>
        </p:spPr>
        <p:txBody>
          <a:bodyPr wrap="none" rtlCol="0">
            <a:spAutoFit/>
          </a:bodyPr>
          <a:lstStyle/>
          <a:p>
            <a:pPr algn="ctr"/>
            <a:r>
              <a:rPr kumimoji="1" lang="en-US" altLang="ja-JP" sz="600" dirty="0">
                <a:latin typeface="Arial"/>
                <a:cs typeface="Arial"/>
              </a:rPr>
              <a:t>ABA</a:t>
            </a:r>
          </a:p>
          <a:p>
            <a:pPr algn="ctr"/>
            <a:r>
              <a:rPr lang="en-US" altLang="ja-JP" sz="600" dirty="0">
                <a:latin typeface="Arial"/>
                <a:cs typeface="Arial"/>
              </a:rPr>
              <a:t>(min)</a:t>
            </a:r>
            <a:endParaRPr kumimoji="1" lang="ja-JP" altLang="en-US" sz="600" dirty="0">
              <a:latin typeface="Arial"/>
              <a:cs typeface="Arial"/>
            </a:endParaRPr>
          </a:p>
        </p:txBody>
      </p:sp>
    </p:spTree>
    <p:extLst>
      <p:ext uri="{BB962C8B-B14F-4D97-AF65-F5344CB8AC3E}">
        <p14:creationId xmlns:p14="http://schemas.microsoft.com/office/powerpoint/2010/main" val="7855765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891C08-76F1-809C-4947-A06E87589C75}"/>
            </a:ext>
          </a:extLst>
        </p:cNvPr>
        <p:cNvGrpSpPr/>
        <p:nvPr/>
      </p:nvGrpSpPr>
      <p:grpSpPr>
        <a:xfrm>
          <a:off x="0" y="0"/>
          <a:ext cx="0" cy="0"/>
          <a:chOff x="0" y="0"/>
          <a:chExt cx="0" cy="0"/>
        </a:xfrm>
      </p:grpSpPr>
      <p:sp>
        <p:nvSpPr>
          <p:cNvPr id="16" name="テキスト ボックス 15">
            <a:extLst>
              <a:ext uri="{FF2B5EF4-FFF2-40B4-BE49-F238E27FC236}">
                <a16:creationId xmlns:a16="http://schemas.microsoft.com/office/drawing/2014/main" id="{49C03062-4091-E8D1-C9F0-8E45B5444FA7}"/>
              </a:ext>
            </a:extLst>
          </p:cNvPr>
          <p:cNvSpPr txBox="1"/>
          <p:nvPr/>
        </p:nvSpPr>
        <p:spPr>
          <a:xfrm>
            <a:off x="958578" y="4259035"/>
            <a:ext cx="5400000" cy="553998"/>
          </a:xfrm>
          <a:prstGeom prst="rect">
            <a:avLst/>
          </a:prstGeom>
          <a:noFill/>
        </p:spPr>
        <p:txBody>
          <a:bodyPr wrap="square">
            <a:spAutoFit/>
          </a:bodyPr>
          <a:lstStyle/>
          <a:p>
            <a:pPr algn="just">
              <a:buNone/>
            </a:pPr>
            <a:r>
              <a:rPr lang="en-US" altLang="ja-JP" sz="1000" b="1" dirty="0">
                <a:latin typeface="Arial" panose="020B0604020202020204" pitchFamily="34" charset="0"/>
                <a:cs typeface="Arial" panose="020B0604020202020204" pitchFamily="34" charset="0"/>
              </a:rPr>
              <a:t>Supplementary Figure S2. </a:t>
            </a:r>
            <a:r>
              <a:rPr lang="en-US" altLang="ja-JP" sz="1000" b="1" kern="100" dirty="0">
                <a:latin typeface="Arial" panose="020B0604020202020204" pitchFamily="34" charset="0"/>
                <a:ea typeface="游明朝" panose="02020400000000000000" pitchFamily="18" charset="-128"/>
                <a:cs typeface="Arial" panose="020B0604020202020204" pitchFamily="34" charset="0"/>
              </a:rPr>
              <a:t>Principal component analysis of </a:t>
            </a:r>
            <a:r>
              <a:rPr lang="en-US" altLang="ja-JP" sz="1000" b="1" kern="100" dirty="0" err="1">
                <a:latin typeface="Arial" panose="020B0604020202020204" pitchFamily="34" charset="0"/>
                <a:ea typeface="游明朝" panose="02020400000000000000" pitchFamily="18" charset="-128"/>
                <a:cs typeface="Arial" panose="020B0604020202020204" pitchFamily="34" charset="0"/>
              </a:rPr>
              <a:t>phosphoproteomic</a:t>
            </a:r>
            <a:r>
              <a:rPr lang="en-US" altLang="ja-JP" sz="1000" b="1" kern="100" dirty="0">
                <a:latin typeface="Arial" panose="020B0604020202020204" pitchFamily="34" charset="0"/>
                <a:ea typeface="游明朝" panose="02020400000000000000" pitchFamily="18" charset="-128"/>
                <a:cs typeface="Arial" panose="020B0604020202020204" pitchFamily="34" charset="0"/>
              </a:rPr>
              <a:t> data in Col-0.</a:t>
            </a:r>
            <a:r>
              <a:rPr lang="en-US" altLang="ja-JP" sz="1000" dirty="0">
                <a:latin typeface="Arial" panose="020B0604020202020204" pitchFamily="34" charset="0"/>
                <a:cs typeface="Arial" panose="020B0604020202020204" pitchFamily="34" charset="0"/>
              </a:rPr>
              <a:t> Only </a:t>
            </a:r>
            <a:r>
              <a:rPr lang="en-US" altLang="ja-JP" sz="1000" dirty="0" err="1">
                <a:latin typeface="Arial" panose="020B0604020202020204" pitchFamily="34" charset="0"/>
                <a:cs typeface="Arial" panose="020B0604020202020204" pitchFamily="34" charset="0"/>
              </a:rPr>
              <a:t>phosphopeptides</a:t>
            </a:r>
            <a:r>
              <a:rPr lang="en-US" altLang="ja-JP" sz="1000" dirty="0">
                <a:latin typeface="Arial" panose="020B0604020202020204" pitchFamily="34" charset="0"/>
                <a:cs typeface="Arial" panose="020B0604020202020204" pitchFamily="34" charset="0"/>
              </a:rPr>
              <a:t> quantified in at least three replicates at any time point were included in the PCA.</a:t>
            </a:r>
            <a:endParaRPr lang="en-US" altLang="ja-JP" sz="1000" b="1" kern="100" dirty="0">
              <a:latin typeface="Arial" panose="020B0604020202020204" pitchFamily="34" charset="0"/>
              <a:ea typeface="游明朝" panose="02020400000000000000" pitchFamily="18" charset="-128"/>
              <a:cs typeface="Arial" panose="020B0604020202020204" pitchFamily="34" charset="0"/>
            </a:endParaRPr>
          </a:p>
        </p:txBody>
      </p:sp>
      <p:grpSp>
        <p:nvGrpSpPr>
          <p:cNvPr id="3" name="グループ化 2">
            <a:extLst>
              <a:ext uri="{FF2B5EF4-FFF2-40B4-BE49-F238E27FC236}">
                <a16:creationId xmlns:a16="http://schemas.microsoft.com/office/drawing/2014/main" id="{A774F885-2A1E-746D-706E-123A8D56B11E}"/>
              </a:ext>
            </a:extLst>
          </p:cNvPr>
          <p:cNvGrpSpPr/>
          <p:nvPr/>
        </p:nvGrpSpPr>
        <p:grpSpPr>
          <a:xfrm>
            <a:off x="2359010" y="1652197"/>
            <a:ext cx="2532070" cy="2363390"/>
            <a:chOff x="2359010" y="1652197"/>
            <a:chExt cx="2532070" cy="2363390"/>
          </a:xfrm>
        </p:grpSpPr>
        <p:grpSp>
          <p:nvGrpSpPr>
            <p:cNvPr id="522" name="グループ化 521">
              <a:extLst>
                <a:ext uri="{FF2B5EF4-FFF2-40B4-BE49-F238E27FC236}">
                  <a16:creationId xmlns:a16="http://schemas.microsoft.com/office/drawing/2014/main" id="{A844E9A8-4A96-E162-5821-A85234F3F5C1}"/>
                </a:ext>
              </a:extLst>
            </p:cNvPr>
            <p:cNvGrpSpPr/>
            <p:nvPr/>
          </p:nvGrpSpPr>
          <p:grpSpPr>
            <a:xfrm>
              <a:off x="2359010" y="1652197"/>
              <a:ext cx="2352097" cy="2363390"/>
              <a:chOff x="2156432" y="5097838"/>
              <a:chExt cx="2352097" cy="2363390"/>
            </a:xfrm>
          </p:grpSpPr>
          <p:sp>
            <p:nvSpPr>
              <p:cNvPr id="521" name="フリーフォーム: 図形 520">
                <a:extLst>
                  <a:ext uri="{FF2B5EF4-FFF2-40B4-BE49-F238E27FC236}">
                    <a16:creationId xmlns:a16="http://schemas.microsoft.com/office/drawing/2014/main" id="{A4866007-43BB-DC7D-AFAB-1075895E2140}"/>
                  </a:ext>
                </a:extLst>
              </p:cNvPr>
              <p:cNvSpPr/>
              <p:nvPr/>
            </p:nvSpPr>
            <p:spPr>
              <a:xfrm rot="2339727">
                <a:off x="2871684" y="5097838"/>
                <a:ext cx="455094" cy="1990250"/>
              </a:xfrm>
              <a:custGeom>
                <a:avLst/>
                <a:gdLst>
                  <a:gd name="csX0" fmla="*/ 109481 w 455094"/>
                  <a:gd name="csY0" fmla="*/ 131262 h 1990250"/>
                  <a:gd name="csX1" fmla="*/ 271602 w 455094"/>
                  <a:gd name="csY1" fmla="*/ 0 h 1990250"/>
                  <a:gd name="csX2" fmla="*/ 273406 w 455094"/>
                  <a:gd name="csY2" fmla="*/ 1224 h 1990250"/>
                  <a:gd name="csX3" fmla="*/ 455094 w 455094"/>
                  <a:gd name="csY3" fmla="*/ 991677 h 1990250"/>
                  <a:gd name="csX4" fmla="*/ 273406 w 455094"/>
                  <a:gd name="csY4" fmla="*/ 1982130 h 1990250"/>
                  <a:gd name="csX5" fmla="*/ 261432 w 455094"/>
                  <a:gd name="csY5" fmla="*/ 1990250 h 1990250"/>
                  <a:gd name="csX6" fmla="*/ 84384 w 455094"/>
                  <a:gd name="csY6" fmla="*/ 1771579 h 1990250"/>
                  <a:gd name="csX7" fmla="*/ 66647 w 455094"/>
                  <a:gd name="csY7" fmla="*/ 1706557 h 1990250"/>
                  <a:gd name="csX8" fmla="*/ 0 w 455094"/>
                  <a:gd name="csY8" fmla="*/ 991677 h 1990250"/>
                  <a:gd name="csX9" fmla="*/ 100323 w 455094"/>
                  <a:gd name="csY9" fmla="*/ 153346 h 1990250"/>
                </a:gdLst>
                <a:ahLst/>
                <a:cxnLst>
                  <a:cxn ang="0">
                    <a:pos x="csX0" y="csY0"/>
                  </a:cxn>
                  <a:cxn ang="0">
                    <a:pos x="csX1" y="csY1"/>
                  </a:cxn>
                  <a:cxn ang="0">
                    <a:pos x="csX2" y="csY2"/>
                  </a:cxn>
                  <a:cxn ang="0">
                    <a:pos x="csX3" y="csY3"/>
                  </a:cxn>
                  <a:cxn ang="0">
                    <a:pos x="csX4" y="csY4"/>
                  </a:cxn>
                  <a:cxn ang="0">
                    <a:pos x="csX5" y="csY5"/>
                  </a:cxn>
                  <a:cxn ang="0">
                    <a:pos x="csX6" y="csY6"/>
                  </a:cxn>
                  <a:cxn ang="0">
                    <a:pos x="csX7" y="csY7"/>
                  </a:cxn>
                  <a:cxn ang="0">
                    <a:pos x="csX8" y="csY8"/>
                  </a:cxn>
                  <a:cxn ang="0">
                    <a:pos x="csX9" y="csY9"/>
                  </a:cxn>
                </a:cxnLst>
                <a:rect l="l" t="t" r="r" b="b"/>
                <a:pathLst>
                  <a:path w="455094" h="1990250">
                    <a:moveTo>
                      <a:pt x="109481" y="131262"/>
                    </a:moveTo>
                    <a:lnTo>
                      <a:pt x="271602" y="0"/>
                    </a:lnTo>
                    <a:lnTo>
                      <a:pt x="273406" y="1224"/>
                    </a:lnTo>
                    <a:cubicBezTo>
                      <a:pt x="377095" y="95495"/>
                      <a:pt x="455094" y="503115"/>
                      <a:pt x="455094" y="991677"/>
                    </a:cubicBezTo>
                    <a:cubicBezTo>
                      <a:pt x="455094" y="1480238"/>
                      <a:pt x="377095" y="1887859"/>
                      <a:pt x="273406" y="1982130"/>
                    </a:cubicBezTo>
                    <a:lnTo>
                      <a:pt x="261432" y="1990250"/>
                    </a:lnTo>
                    <a:lnTo>
                      <a:pt x="84384" y="1771579"/>
                    </a:lnTo>
                    <a:lnTo>
                      <a:pt x="66647" y="1706557"/>
                    </a:lnTo>
                    <a:cubicBezTo>
                      <a:pt x="25469" y="1523603"/>
                      <a:pt x="0" y="1270855"/>
                      <a:pt x="0" y="991677"/>
                    </a:cubicBezTo>
                    <a:cubicBezTo>
                      <a:pt x="0" y="642705"/>
                      <a:pt x="39796" y="335029"/>
                      <a:pt x="100323" y="153346"/>
                    </a:cubicBezTo>
                    <a:close/>
                  </a:path>
                </a:pathLst>
              </a:custGeom>
              <a:solidFill>
                <a:srgbClr val="F2F2F2">
                  <a:alpha val="80000"/>
                </a:srgbClr>
              </a:solidFill>
              <a:ln w="12700" cmpd="sng">
                <a:noFill/>
              </a:ln>
              <a:effectLst/>
            </p:spPr>
            <p:style>
              <a:lnRef idx="1">
                <a:schemeClr val="accent1"/>
              </a:lnRef>
              <a:fillRef idx="3">
                <a:schemeClr val="accent1"/>
              </a:fillRef>
              <a:effectRef idx="2">
                <a:schemeClr val="accent1"/>
              </a:effectRef>
              <a:fontRef idx="minor">
                <a:schemeClr val="lt1"/>
              </a:fontRef>
            </p:style>
            <p:txBody>
              <a:bodyPr wrap="square" rtlCol="0" anchor="ctr">
                <a:noAutofit/>
              </a:bodyPr>
              <a:lstStyle/>
              <a:p>
                <a:pPr algn="ctr"/>
                <a:endParaRPr kumimoji="1" lang="ja-JP" altLang="en-US" dirty="0">
                  <a:latin typeface="Arial" panose="020B0604020202020204" pitchFamily="34" charset="0"/>
                  <a:cs typeface="Arial" panose="020B0604020202020204" pitchFamily="34" charset="0"/>
                </a:endParaRPr>
              </a:p>
            </p:txBody>
          </p:sp>
          <p:sp>
            <p:nvSpPr>
              <p:cNvPr id="518" name="フリーフォーム: 図形 517">
                <a:extLst>
                  <a:ext uri="{FF2B5EF4-FFF2-40B4-BE49-F238E27FC236}">
                    <a16:creationId xmlns:a16="http://schemas.microsoft.com/office/drawing/2014/main" id="{8ADF795D-6A04-8875-AA89-CEE6426DCDCF}"/>
                  </a:ext>
                </a:extLst>
              </p:cNvPr>
              <p:cNvSpPr/>
              <p:nvPr/>
            </p:nvSpPr>
            <p:spPr>
              <a:xfrm rot="2944926">
                <a:off x="3552723" y="5502360"/>
                <a:ext cx="352294" cy="1534720"/>
              </a:xfrm>
              <a:custGeom>
                <a:avLst/>
                <a:gdLst>
                  <a:gd name="csX0" fmla="*/ 140647 w 352294"/>
                  <a:gd name="csY0" fmla="*/ 9649 h 1534720"/>
                  <a:gd name="csX1" fmla="*/ 162532 w 352294"/>
                  <a:gd name="csY1" fmla="*/ 0 h 1534720"/>
                  <a:gd name="csX2" fmla="*/ 255789 w 352294"/>
                  <a:gd name="csY2" fmla="*/ 80833 h 1534720"/>
                  <a:gd name="csX3" fmla="*/ 274633 w 352294"/>
                  <a:gd name="csY3" fmla="*/ 125564 h 1534720"/>
                  <a:gd name="csX4" fmla="*/ 352294 w 352294"/>
                  <a:gd name="csY4" fmla="*/ 764359 h 1534720"/>
                  <a:gd name="csX5" fmla="*/ 176147 w 352294"/>
                  <a:gd name="csY5" fmla="*/ 1534720 h 1534720"/>
                  <a:gd name="csX6" fmla="*/ 0 w 352294"/>
                  <a:gd name="csY6" fmla="*/ 764359 h 1534720"/>
                  <a:gd name="csX7" fmla="*/ 140647 w 352294"/>
                  <a:gd name="csY7" fmla="*/ 9649 h 1534720"/>
                </a:gdLst>
                <a:ahLst/>
                <a:cxnLst>
                  <a:cxn ang="0">
                    <a:pos x="csX0" y="csY0"/>
                  </a:cxn>
                  <a:cxn ang="0">
                    <a:pos x="csX1" y="csY1"/>
                  </a:cxn>
                  <a:cxn ang="0">
                    <a:pos x="csX2" y="csY2"/>
                  </a:cxn>
                  <a:cxn ang="0">
                    <a:pos x="csX3" y="csY3"/>
                  </a:cxn>
                  <a:cxn ang="0">
                    <a:pos x="csX4" y="csY4"/>
                  </a:cxn>
                  <a:cxn ang="0">
                    <a:pos x="csX5" y="csY5"/>
                  </a:cxn>
                  <a:cxn ang="0">
                    <a:pos x="csX6" y="csY6"/>
                  </a:cxn>
                  <a:cxn ang="0">
                    <a:pos x="csX7" y="csY7"/>
                  </a:cxn>
                </a:cxnLst>
                <a:rect l="l" t="t" r="r" b="b"/>
                <a:pathLst>
                  <a:path w="352294" h="1534720">
                    <a:moveTo>
                      <a:pt x="140647" y="9649"/>
                    </a:moveTo>
                    <a:lnTo>
                      <a:pt x="162532" y="0"/>
                    </a:lnTo>
                    <a:lnTo>
                      <a:pt x="255789" y="80833"/>
                    </a:lnTo>
                    <a:lnTo>
                      <a:pt x="274633" y="125564"/>
                    </a:lnTo>
                    <a:cubicBezTo>
                      <a:pt x="321488" y="264003"/>
                      <a:pt x="352294" y="498447"/>
                      <a:pt x="352294" y="764359"/>
                    </a:cubicBezTo>
                    <a:cubicBezTo>
                      <a:pt x="352294" y="1189818"/>
                      <a:pt x="273430" y="1534720"/>
                      <a:pt x="176147" y="1534720"/>
                    </a:cubicBezTo>
                    <a:cubicBezTo>
                      <a:pt x="78864" y="1534720"/>
                      <a:pt x="0" y="1189818"/>
                      <a:pt x="0" y="764359"/>
                    </a:cubicBezTo>
                    <a:cubicBezTo>
                      <a:pt x="0" y="392083"/>
                      <a:pt x="60380" y="81482"/>
                      <a:pt x="140647" y="9649"/>
                    </a:cubicBezTo>
                    <a:close/>
                  </a:path>
                </a:pathLst>
              </a:custGeom>
              <a:solidFill>
                <a:srgbClr val="FDEADA">
                  <a:alpha val="69804"/>
                </a:srgbClr>
              </a:solidFill>
              <a:ln w="12700" cmpd="sng">
                <a:noFill/>
              </a:ln>
              <a:effectLst/>
            </p:spPr>
            <p:style>
              <a:lnRef idx="1">
                <a:schemeClr val="accent1"/>
              </a:lnRef>
              <a:fillRef idx="3">
                <a:schemeClr val="accent1"/>
              </a:fillRef>
              <a:effectRef idx="2">
                <a:schemeClr val="accent1"/>
              </a:effectRef>
              <a:fontRef idx="minor">
                <a:schemeClr val="lt1"/>
              </a:fontRef>
            </p:style>
            <p:txBody>
              <a:bodyPr wrap="square" rtlCol="0" anchor="ctr">
                <a:noAutofit/>
              </a:bodyPr>
              <a:lstStyle/>
              <a:p>
                <a:pPr algn="ctr"/>
                <a:endParaRPr kumimoji="1" lang="ja-JP" altLang="en-US" dirty="0">
                  <a:latin typeface="Arial" panose="020B0604020202020204" pitchFamily="34" charset="0"/>
                  <a:cs typeface="Arial" panose="020B0604020202020204" pitchFamily="34" charset="0"/>
                </a:endParaRPr>
              </a:p>
            </p:txBody>
          </p:sp>
          <p:sp>
            <p:nvSpPr>
              <p:cNvPr id="515" name="フリーフォーム: 図形 514">
                <a:extLst>
                  <a:ext uri="{FF2B5EF4-FFF2-40B4-BE49-F238E27FC236}">
                    <a16:creationId xmlns:a16="http://schemas.microsoft.com/office/drawing/2014/main" id="{4A6D27B1-21DF-4B86-617D-BEB95A3A67A2}"/>
                  </a:ext>
                </a:extLst>
              </p:cNvPr>
              <p:cNvSpPr/>
              <p:nvPr/>
            </p:nvSpPr>
            <p:spPr>
              <a:xfrm rot="3006979">
                <a:off x="3616140" y="6308624"/>
                <a:ext cx="652672" cy="1132106"/>
              </a:xfrm>
              <a:custGeom>
                <a:avLst/>
                <a:gdLst>
                  <a:gd name="csX0" fmla="*/ 143879 w 652672"/>
                  <a:gd name="csY0" fmla="*/ 59798 h 1132106"/>
                  <a:gd name="csX1" fmla="*/ 199311 w 652672"/>
                  <a:gd name="csY1" fmla="*/ 3197 h 1132106"/>
                  <a:gd name="csX2" fmla="*/ 204786 w 652672"/>
                  <a:gd name="csY2" fmla="*/ 0 h 1132106"/>
                  <a:gd name="csX3" fmla="*/ 631420 w 652672"/>
                  <a:gd name="csY3" fmla="*/ 356515 h 1132106"/>
                  <a:gd name="csX4" fmla="*/ 646042 w 652672"/>
                  <a:gd name="csY4" fmla="*/ 445128 h 1132106"/>
                  <a:gd name="csX5" fmla="*/ 652672 w 652672"/>
                  <a:gd name="csY5" fmla="*/ 568849 h 1132106"/>
                  <a:gd name="csX6" fmla="*/ 651646 w 652672"/>
                  <a:gd name="csY6" fmla="*/ 588000 h 1132106"/>
                  <a:gd name="csX7" fmla="*/ 196966 w 652672"/>
                  <a:gd name="csY7" fmla="*/ 1132106 h 1132106"/>
                  <a:gd name="csX8" fmla="*/ 143879 w 652672"/>
                  <a:gd name="csY8" fmla="*/ 1077901 h 1132106"/>
                  <a:gd name="csX9" fmla="*/ 0 w 652672"/>
                  <a:gd name="csY9" fmla="*/ 568849 h 1132106"/>
                  <a:gd name="csX10" fmla="*/ 143879 w 652672"/>
                  <a:gd name="csY10" fmla="*/ 59798 h 1132106"/>
                </a:gdLst>
                <a:ahLst/>
                <a:cxnLst>
                  <a:cxn ang="0">
                    <a:pos x="csX0" y="csY0"/>
                  </a:cxn>
                  <a:cxn ang="0">
                    <a:pos x="csX1" y="csY1"/>
                  </a:cxn>
                  <a:cxn ang="0">
                    <a:pos x="csX2" y="csY2"/>
                  </a:cxn>
                  <a:cxn ang="0">
                    <a:pos x="csX3" y="csY3"/>
                  </a:cxn>
                  <a:cxn ang="0">
                    <a:pos x="csX4" y="csY4"/>
                  </a:cxn>
                  <a:cxn ang="0">
                    <a:pos x="csX5" y="csY5"/>
                  </a:cxn>
                  <a:cxn ang="0">
                    <a:pos x="csX6" y="csY6"/>
                  </a:cxn>
                  <a:cxn ang="0">
                    <a:pos x="csX7" y="csY7"/>
                  </a:cxn>
                  <a:cxn ang="0">
                    <a:pos x="csX8" y="csY8"/>
                  </a:cxn>
                  <a:cxn ang="0">
                    <a:pos x="csX9" y="csY9"/>
                  </a:cxn>
                  <a:cxn ang="0">
                    <a:pos x="csX10" y="csY10"/>
                  </a:cxn>
                </a:cxnLst>
                <a:rect l="l" t="t" r="r" b="b"/>
                <a:pathLst>
                  <a:path w="652672" h="1132106">
                    <a:moveTo>
                      <a:pt x="143879" y="59798"/>
                    </a:moveTo>
                    <a:cubicBezTo>
                      <a:pt x="161240" y="37733"/>
                      <a:pt x="179790" y="18729"/>
                      <a:pt x="199311" y="3197"/>
                    </a:cubicBezTo>
                    <a:lnTo>
                      <a:pt x="204786" y="0"/>
                    </a:lnTo>
                    <a:lnTo>
                      <a:pt x="631420" y="356515"/>
                    </a:lnTo>
                    <a:lnTo>
                      <a:pt x="646042" y="445128"/>
                    </a:lnTo>
                    <a:cubicBezTo>
                      <a:pt x="650389" y="485091"/>
                      <a:pt x="652672" y="526469"/>
                      <a:pt x="652672" y="568849"/>
                    </a:cubicBezTo>
                    <a:lnTo>
                      <a:pt x="651646" y="588000"/>
                    </a:lnTo>
                    <a:lnTo>
                      <a:pt x="196966" y="1132106"/>
                    </a:lnTo>
                    <a:lnTo>
                      <a:pt x="143879" y="1077901"/>
                    </a:lnTo>
                    <a:cubicBezTo>
                      <a:pt x="57073" y="967579"/>
                      <a:pt x="0" y="780752"/>
                      <a:pt x="0" y="568849"/>
                    </a:cubicBezTo>
                    <a:cubicBezTo>
                      <a:pt x="0" y="356946"/>
                      <a:pt x="57073" y="170119"/>
                      <a:pt x="143879" y="59798"/>
                    </a:cubicBezTo>
                    <a:close/>
                  </a:path>
                </a:pathLst>
              </a:custGeom>
              <a:solidFill>
                <a:srgbClr val="FAC090">
                  <a:alpha val="60000"/>
                </a:srgbClr>
              </a:solidFill>
              <a:ln w="12700" cmpd="sng">
                <a:noFill/>
              </a:ln>
              <a:effectLst/>
            </p:spPr>
            <p:style>
              <a:lnRef idx="1">
                <a:schemeClr val="accent1"/>
              </a:lnRef>
              <a:fillRef idx="3">
                <a:schemeClr val="accent1"/>
              </a:fillRef>
              <a:effectRef idx="2">
                <a:schemeClr val="accent1"/>
              </a:effectRef>
              <a:fontRef idx="minor">
                <a:schemeClr val="lt1"/>
              </a:fontRef>
            </p:style>
            <p:txBody>
              <a:bodyPr wrap="square" rtlCol="0" anchor="ctr">
                <a:noAutofit/>
              </a:bodyPr>
              <a:lstStyle/>
              <a:p>
                <a:pPr algn="ctr"/>
                <a:endParaRPr kumimoji="1" lang="ja-JP" altLang="en-US" dirty="0">
                  <a:latin typeface="Arial" panose="020B0604020202020204" pitchFamily="34" charset="0"/>
                  <a:cs typeface="Arial" panose="020B0604020202020204" pitchFamily="34" charset="0"/>
                </a:endParaRPr>
              </a:p>
            </p:txBody>
          </p:sp>
          <p:sp>
            <p:nvSpPr>
              <p:cNvPr id="455" name="正方形/長方形 454">
                <a:extLst>
                  <a:ext uri="{FF2B5EF4-FFF2-40B4-BE49-F238E27FC236}">
                    <a16:creationId xmlns:a16="http://schemas.microsoft.com/office/drawing/2014/main" id="{814D44D4-3FE1-0541-24AB-00C02214F66E}"/>
                  </a:ext>
                </a:extLst>
              </p:cNvPr>
              <p:cNvSpPr/>
              <p:nvPr/>
            </p:nvSpPr>
            <p:spPr>
              <a:xfrm>
                <a:off x="2498442" y="5339407"/>
                <a:ext cx="1800000" cy="1800000"/>
              </a:xfrm>
              <a:prstGeom prst="rect">
                <a:avLst/>
              </a:prstGeom>
              <a:noFill/>
              <a:ln w="1270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459" name="Oval 251">
                <a:extLst>
                  <a:ext uri="{FF2B5EF4-FFF2-40B4-BE49-F238E27FC236}">
                    <a16:creationId xmlns:a16="http://schemas.microsoft.com/office/drawing/2014/main" id="{FA067651-F42F-2209-32CE-C6FC1052EBD4}"/>
                  </a:ext>
                </a:extLst>
              </p:cNvPr>
              <p:cNvSpPr>
                <a:spLocks noChangeArrowheads="1"/>
              </p:cNvSpPr>
              <p:nvPr/>
            </p:nvSpPr>
            <p:spPr bwMode="auto">
              <a:xfrm>
                <a:off x="3581746" y="5351965"/>
                <a:ext cx="54000" cy="54000"/>
              </a:xfrm>
              <a:prstGeom prst="ellipse">
                <a:avLst/>
              </a:prstGeom>
              <a:solidFill>
                <a:schemeClr val="bg1">
                  <a:lumMod val="85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63" name="Oval 251">
                <a:extLst>
                  <a:ext uri="{FF2B5EF4-FFF2-40B4-BE49-F238E27FC236}">
                    <a16:creationId xmlns:a16="http://schemas.microsoft.com/office/drawing/2014/main" id="{5A5145F3-9374-B500-FC1D-D378636D90A8}"/>
                  </a:ext>
                </a:extLst>
              </p:cNvPr>
              <p:cNvSpPr>
                <a:spLocks noChangeArrowheads="1"/>
              </p:cNvSpPr>
              <p:nvPr/>
            </p:nvSpPr>
            <p:spPr bwMode="auto">
              <a:xfrm>
                <a:off x="3179420" y="6204126"/>
                <a:ext cx="54000" cy="54000"/>
              </a:xfrm>
              <a:prstGeom prst="ellipse">
                <a:avLst/>
              </a:prstGeom>
              <a:solidFill>
                <a:schemeClr val="bg1">
                  <a:lumMod val="85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64" name="Oval 251">
                <a:extLst>
                  <a:ext uri="{FF2B5EF4-FFF2-40B4-BE49-F238E27FC236}">
                    <a16:creationId xmlns:a16="http://schemas.microsoft.com/office/drawing/2014/main" id="{ABB8746B-A1EE-2CF0-BEB2-41235CF54C58}"/>
                  </a:ext>
                </a:extLst>
              </p:cNvPr>
              <p:cNvSpPr>
                <a:spLocks noChangeArrowheads="1"/>
              </p:cNvSpPr>
              <p:nvPr/>
            </p:nvSpPr>
            <p:spPr bwMode="auto">
              <a:xfrm>
                <a:off x="3112787" y="6251446"/>
                <a:ext cx="54000" cy="54000"/>
              </a:xfrm>
              <a:prstGeom prst="ellipse">
                <a:avLst/>
              </a:prstGeom>
              <a:solidFill>
                <a:schemeClr val="bg1">
                  <a:lumMod val="85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65" name="Oval 251">
                <a:extLst>
                  <a:ext uri="{FF2B5EF4-FFF2-40B4-BE49-F238E27FC236}">
                    <a16:creationId xmlns:a16="http://schemas.microsoft.com/office/drawing/2014/main" id="{BB8A1FC7-CA6E-04CC-95C1-A2BA73F0AC9B}"/>
                  </a:ext>
                </a:extLst>
              </p:cNvPr>
              <p:cNvSpPr>
                <a:spLocks noChangeArrowheads="1"/>
              </p:cNvSpPr>
              <p:nvPr/>
            </p:nvSpPr>
            <p:spPr bwMode="auto">
              <a:xfrm>
                <a:off x="2513613" y="6584186"/>
                <a:ext cx="54000" cy="54000"/>
              </a:xfrm>
              <a:prstGeom prst="ellipse">
                <a:avLst/>
              </a:prstGeom>
              <a:solidFill>
                <a:schemeClr val="bg1">
                  <a:lumMod val="85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66" name="Oval 251">
                <a:extLst>
                  <a:ext uri="{FF2B5EF4-FFF2-40B4-BE49-F238E27FC236}">
                    <a16:creationId xmlns:a16="http://schemas.microsoft.com/office/drawing/2014/main" id="{78DECAB3-2421-150B-CD99-484F1071ED50}"/>
                  </a:ext>
                </a:extLst>
              </p:cNvPr>
              <p:cNvSpPr>
                <a:spLocks noChangeArrowheads="1"/>
              </p:cNvSpPr>
              <p:nvPr/>
            </p:nvSpPr>
            <p:spPr bwMode="auto">
              <a:xfrm>
                <a:off x="4212581" y="5775946"/>
                <a:ext cx="54000" cy="54000"/>
              </a:xfrm>
              <a:prstGeom prst="ellipse">
                <a:avLst/>
              </a:prstGeom>
              <a:solidFill>
                <a:schemeClr val="accent6">
                  <a:lumMod val="40000"/>
                  <a:lumOff val="60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67" name="Oval 251">
                <a:extLst>
                  <a:ext uri="{FF2B5EF4-FFF2-40B4-BE49-F238E27FC236}">
                    <a16:creationId xmlns:a16="http://schemas.microsoft.com/office/drawing/2014/main" id="{6E17EE50-C4AC-3956-9C6B-EE70A788D1E4}"/>
                  </a:ext>
                </a:extLst>
              </p:cNvPr>
              <p:cNvSpPr>
                <a:spLocks noChangeArrowheads="1"/>
              </p:cNvSpPr>
              <p:nvPr/>
            </p:nvSpPr>
            <p:spPr bwMode="auto">
              <a:xfrm>
                <a:off x="3402000" y="6504172"/>
                <a:ext cx="54000" cy="54000"/>
              </a:xfrm>
              <a:prstGeom prst="ellipse">
                <a:avLst/>
              </a:prstGeom>
              <a:solidFill>
                <a:schemeClr val="accent6">
                  <a:lumMod val="40000"/>
                  <a:lumOff val="60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68" name="Oval 251">
                <a:extLst>
                  <a:ext uri="{FF2B5EF4-FFF2-40B4-BE49-F238E27FC236}">
                    <a16:creationId xmlns:a16="http://schemas.microsoft.com/office/drawing/2014/main" id="{2C2CE758-2094-6027-CC40-7C1553A3DA35}"/>
                  </a:ext>
                </a:extLst>
              </p:cNvPr>
              <p:cNvSpPr>
                <a:spLocks noChangeArrowheads="1"/>
              </p:cNvSpPr>
              <p:nvPr/>
            </p:nvSpPr>
            <p:spPr bwMode="auto">
              <a:xfrm>
                <a:off x="3461921" y="6576185"/>
                <a:ext cx="54000" cy="54000"/>
              </a:xfrm>
              <a:prstGeom prst="ellipse">
                <a:avLst/>
              </a:prstGeom>
              <a:solidFill>
                <a:schemeClr val="accent6">
                  <a:lumMod val="40000"/>
                  <a:lumOff val="60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69" name="Oval 251">
                <a:extLst>
                  <a:ext uri="{FF2B5EF4-FFF2-40B4-BE49-F238E27FC236}">
                    <a16:creationId xmlns:a16="http://schemas.microsoft.com/office/drawing/2014/main" id="{A529A22D-60D9-61F3-077E-644BF6ABAA9F}"/>
                  </a:ext>
                </a:extLst>
              </p:cNvPr>
              <p:cNvSpPr>
                <a:spLocks noChangeArrowheads="1"/>
              </p:cNvSpPr>
              <p:nvPr/>
            </p:nvSpPr>
            <p:spPr bwMode="auto">
              <a:xfrm>
                <a:off x="3248079" y="6606995"/>
                <a:ext cx="54000" cy="54000"/>
              </a:xfrm>
              <a:prstGeom prst="ellipse">
                <a:avLst/>
              </a:prstGeom>
              <a:solidFill>
                <a:schemeClr val="accent6">
                  <a:lumMod val="40000"/>
                  <a:lumOff val="60000"/>
                </a:schemeClr>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0" name="Oval 251">
                <a:extLst>
                  <a:ext uri="{FF2B5EF4-FFF2-40B4-BE49-F238E27FC236}">
                    <a16:creationId xmlns:a16="http://schemas.microsoft.com/office/drawing/2014/main" id="{7FB4D8A3-1415-AE86-356D-5A8ECE6ABA95}"/>
                  </a:ext>
                </a:extLst>
              </p:cNvPr>
              <p:cNvSpPr>
                <a:spLocks noChangeArrowheads="1"/>
              </p:cNvSpPr>
              <p:nvPr/>
            </p:nvSpPr>
            <p:spPr bwMode="auto">
              <a:xfrm>
                <a:off x="3659989" y="6778339"/>
                <a:ext cx="54000" cy="54000"/>
              </a:xfrm>
              <a:prstGeom prst="ellipse">
                <a:avLst/>
              </a:prstGeom>
              <a:solidFill>
                <a:schemeClr val="accent6"/>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1" name="Oval 251">
                <a:extLst>
                  <a:ext uri="{FF2B5EF4-FFF2-40B4-BE49-F238E27FC236}">
                    <a16:creationId xmlns:a16="http://schemas.microsoft.com/office/drawing/2014/main" id="{6D7A6E66-621F-9951-896C-7685E2CE3447}"/>
                  </a:ext>
                </a:extLst>
              </p:cNvPr>
              <p:cNvSpPr>
                <a:spLocks noChangeArrowheads="1"/>
              </p:cNvSpPr>
              <p:nvPr/>
            </p:nvSpPr>
            <p:spPr bwMode="auto">
              <a:xfrm>
                <a:off x="4212581" y="6433724"/>
                <a:ext cx="54000" cy="54000"/>
              </a:xfrm>
              <a:prstGeom prst="ellipse">
                <a:avLst/>
              </a:prstGeom>
              <a:solidFill>
                <a:schemeClr val="accent6"/>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2" name="Oval 251">
                <a:extLst>
                  <a:ext uri="{FF2B5EF4-FFF2-40B4-BE49-F238E27FC236}">
                    <a16:creationId xmlns:a16="http://schemas.microsoft.com/office/drawing/2014/main" id="{D2B66DFE-6A12-7389-B2E6-6833805145E9}"/>
                  </a:ext>
                </a:extLst>
              </p:cNvPr>
              <p:cNvSpPr>
                <a:spLocks noChangeArrowheads="1"/>
              </p:cNvSpPr>
              <p:nvPr/>
            </p:nvSpPr>
            <p:spPr bwMode="auto">
              <a:xfrm>
                <a:off x="3458111" y="7074267"/>
                <a:ext cx="54000" cy="54000"/>
              </a:xfrm>
              <a:prstGeom prst="ellipse">
                <a:avLst/>
              </a:prstGeom>
              <a:solidFill>
                <a:schemeClr val="accent6"/>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3" name="Oval 251">
                <a:extLst>
                  <a:ext uri="{FF2B5EF4-FFF2-40B4-BE49-F238E27FC236}">
                    <a16:creationId xmlns:a16="http://schemas.microsoft.com/office/drawing/2014/main" id="{AAD7C9D0-C150-6393-18F7-137964F36332}"/>
                  </a:ext>
                </a:extLst>
              </p:cNvPr>
              <p:cNvSpPr>
                <a:spLocks noChangeArrowheads="1"/>
              </p:cNvSpPr>
              <p:nvPr/>
            </p:nvSpPr>
            <p:spPr bwMode="auto">
              <a:xfrm>
                <a:off x="4091236" y="7066317"/>
                <a:ext cx="54000" cy="54000"/>
              </a:xfrm>
              <a:prstGeom prst="ellipse">
                <a:avLst/>
              </a:prstGeom>
              <a:solidFill>
                <a:schemeClr val="accent6"/>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4" name="Oval 251">
                <a:extLst>
                  <a:ext uri="{FF2B5EF4-FFF2-40B4-BE49-F238E27FC236}">
                    <a16:creationId xmlns:a16="http://schemas.microsoft.com/office/drawing/2014/main" id="{03140D56-A959-AF59-643D-92ABC49287B1}"/>
                  </a:ext>
                </a:extLst>
              </p:cNvPr>
              <p:cNvSpPr>
                <a:spLocks noChangeArrowheads="1"/>
              </p:cNvSpPr>
              <p:nvPr/>
            </p:nvSpPr>
            <p:spPr bwMode="auto">
              <a:xfrm>
                <a:off x="4009733" y="6741484"/>
                <a:ext cx="54000" cy="54000"/>
              </a:xfrm>
              <a:prstGeom prst="ellipse">
                <a:avLst/>
              </a:prstGeom>
              <a:solidFill>
                <a:srgbClr val="C00000"/>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5" name="Oval 251">
                <a:extLst>
                  <a:ext uri="{FF2B5EF4-FFF2-40B4-BE49-F238E27FC236}">
                    <a16:creationId xmlns:a16="http://schemas.microsoft.com/office/drawing/2014/main" id="{79202EF5-F2FE-8831-6A43-E7AD4BB4BC41}"/>
                  </a:ext>
                </a:extLst>
              </p:cNvPr>
              <p:cNvSpPr>
                <a:spLocks noChangeArrowheads="1"/>
              </p:cNvSpPr>
              <p:nvPr/>
            </p:nvSpPr>
            <p:spPr bwMode="auto">
              <a:xfrm>
                <a:off x="3617636" y="6920345"/>
                <a:ext cx="54000" cy="54000"/>
              </a:xfrm>
              <a:prstGeom prst="ellipse">
                <a:avLst/>
              </a:prstGeom>
              <a:solidFill>
                <a:srgbClr val="C00000"/>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6" name="Oval 251">
                <a:extLst>
                  <a:ext uri="{FF2B5EF4-FFF2-40B4-BE49-F238E27FC236}">
                    <a16:creationId xmlns:a16="http://schemas.microsoft.com/office/drawing/2014/main" id="{1B2B40C2-CEC9-4567-FC11-9AA3044BBFE5}"/>
                  </a:ext>
                </a:extLst>
              </p:cNvPr>
              <p:cNvSpPr>
                <a:spLocks noChangeArrowheads="1"/>
              </p:cNvSpPr>
              <p:nvPr/>
            </p:nvSpPr>
            <p:spPr bwMode="auto">
              <a:xfrm>
                <a:off x="3573445" y="6730054"/>
                <a:ext cx="54000" cy="54000"/>
              </a:xfrm>
              <a:prstGeom prst="ellipse">
                <a:avLst/>
              </a:prstGeom>
              <a:solidFill>
                <a:srgbClr val="C00000"/>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7" name="Oval 251">
                <a:extLst>
                  <a:ext uri="{FF2B5EF4-FFF2-40B4-BE49-F238E27FC236}">
                    <a16:creationId xmlns:a16="http://schemas.microsoft.com/office/drawing/2014/main" id="{90F9AB53-3B68-1B72-6854-E5BCD3FD6185}"/>
                  </a:ext>
                </a:extLst>
              </p:cNvPr>
              <p:cNvSpPr>
                <a:spLocks noChangeArrowheads="1"/>
              </p:cNvSpPr>
              <p:nvPr/>
            </p:nvSpPr>
            <p:spPr bwMode="auto">
              <a:xfrm>
                <a:off x="3835212" y="6677959"/>
                <a:ext cx="54000" cy="54000"/>
              </a:xfrm>
              <a:prstGeom prst="ellipse">
                <a:avLst/>
              </a:prstGeom>
              <a:solidFill>
                <a:srgbClr val="C00000"/>
              </a:solidFill>
              <a:ln w="6350"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a:latin typeface="Arial" panose="020B0604020202020204" pitchFamily="34" charset="0"/>
                  <a:cs typeface="Arial" panose="020B0604020202020204" pitchFamily="34" charset="0"/>
                </a:endParaRPr>
              </a:p>
            </p:txBody>
          </p:sp>
          <p:sp>
            <p:nvSpPr>
              <p:cNvPr id="478" name="テキスト ボックス 477">
                <a:extLst>
                  <a:ext uri="{FF2B5EF4-FFF2-40B4-BE49-F238E27FC236}">
                    <a16:creationId xmlns:a16="http://schemas.microsoft.com/office/drawing/2014/main" id="{140E510B-59FB-6321-7E40-B3677C236670}"/>
                  </a:ext>
                </a:extLst>
              </p:cNvPr>
              <p:cNvSpPr txBox="1"/>
              <p:nvPr/>
            </p:nvSpPr>
            <p:spPr>
              <a:xfrm>
                <a:off x="2298732" y="6454675"/>
                <a:ext cx="227948"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cxnSp>
            <p:nvCxnSpPr>
              <p:cNvPr id="480" name="直線コネクタ 479">
                <a:extLst>
                  <a:ext uri="{FF2B5EF4-FFF2-40B4-BE49-F238E27FC236}">
                    <a16:creationId xmlns:a16="http://schemas.microsoft.com/office/drawing/2014/main" id="{9B04A1AD-F14F-1112-1538-5BD58509BEBF}"/>
                  </a:ext>
                </a:extLst>
              </p:cNvPr>
              <p:cNvCxnSpPr>
                <a:cxnSpLocks/>
              </p:cNvCxnSpPr>
              <p:nvPr/>
            </p:nvCxnSpPr>
            <p:spPr>
              <a:xfrm flipV="1">
                <a:off x="2457132" y="5545931"/>
                <a:ext cx="36000"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2" name="直線コネクタ 481">
                <a:extLst>
                  <a:ext uri="{FF2B5EF4-FFF2-40B4-BE49-F238E27FC236}">
                    <a16:creationId xmlns:a16="http://schemas.microsoft.com/office/drawing/2014/main" id="{2904065E-5D41-9E9E-0688-7772C348B7A8}"/>
                  </a:ext>
                </a:extLst>
              </p:cNvPr>
              <p:cNvCxnSpPr>
                <a:cxnSpLocks/>
              </p:cNvCxnSpPr>
              <p:nvPr/>
            </p:nvCxnSpPr>
            <p:spPr>
              <a:xfrm flipV="1">
                <a:off x="2457132" y="5795592"/>
                <a:ext cx="36000"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3" name="直線コネクタ 482">
                <a:extLst>
                  <a:ext uri="{FF2B5EF4-FFF2-40B4-BE49-F238E27FC236}">
                    <a16:creationId xmlns:a16="http://schemas.microsoft.com/office/drawing/2014/main" id="{6CDD09FA-80AE-20DF-70CA-84B03942B788}"/>
                  </a:ext>
                </a:extLst>
              </p:cNvPr>
              <p:cNvCxnSpPr>
                <a:cxnSpLocks/>
              </p:cNvCxnSpPr>
              <p:nvPr/>
            </p:nvCxnSpPr>
            <p:spPr>
              <a:xfrm flipV="1">
                <a:off x="2457132" y="6045253"/>
                <a:ext cx="36000"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4" name="直線コネクタ 483">
                <a:extLst>
                  <a:ext uri="{FF2B5EF4-FFF2-40B4-BE49-F238E27FC236}">
                    <a16:creationId xmlns:a16="http://schemas.microsoft.com/office/drawing/2014/main" id="{E3B252B2-60F8-58F5-B176-B91F49D0B081}"/>
                  </a:ext>
                </a:extLst>
              </p:cNvPr>
              <p:cNvCxnSpPr>
                <a:cxnSpLocks/>
              </p:cNvCxnSpPr>
              <p:nvPr/>
            </p:nvCxnSpPr>
            <p:spPr>
              <a:xfrm flipV="1">
                <a:off x="2457132" y="6294914"/>
                <a:ext cx="36000"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5" name="直線コネクタ 484">
                <a:extLst>
                  <a:ext uri="{FF2B5EF4-FFF2-40B4-BE49-F238E27FC236}">
                    <a16:creationId xmlns:a16="http://schemas.microsoft.com/office/drawing/2014/main" id="{80ED24D0-DEA4-2011-9EEE-F8DB41123A65}"/>
                  </a:ext>
                </a:extLst>
              </p:cNvPr>
              <p:cNvCxnSpPr>
                <a:cxnSpLocks/>
              </p:cNvCxnSpPr>
              <p:nvPr/>
            </p:nvCxnSpPr>
            <p:spPr>
              <a:xfrm flipV="1">
                <a:off x="2457132" y="6544575"/>
                <a:ext cx="36000"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6" name="直線コネクタ 485">
                <a:extLst>
                  <a:ext uri="{FF2B5EF4-FFF2-40B4-BE49-F238E27FC236}">
                    <a16:creationId xmlns:a16="http://schemas.microsoft.com/office/drawing/2014/main" id="{60C16A60-F768-A521-E3C1-FEB3ADBEAA77}"/>
                  </a:ext>
                </a:extLst>
              </p:cNvPr>
              <p:cNvCxnSpPr>
                <a:cxnSpLocks/>
              </p:cNvCxnSpPr>
              <p:nvPr/>
            </p:nvCxnSpPr>
            <p:spPr>
              <a:xfrm flipV="1">
                <a:off x="2457132" y="6794236"/>
                <a:ext cx="36000"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7" name="直線コネクタ 486">
                <a:extLst>
                  <a:ext uri="{FF2B5EF4-FFF2-40B4-BE49-F238E27FC236}">
                    <a16:creationId xmlns:a16="http://schemas.microsoft.com/office/drawing/2014/main" id="{BC9E52D3-3C6C-5B2B-4BFA-4042FA8B2414}"/>
                  </a:ext>
                </a:extLst>
              </p:cNvPr>
              <p:cNvCxnSpPr>
                <a:cxnSpLocks/>
              </p:cNvCxnSpPr>
              <p:nvPr/>
            </p:nvCxnSpPr>
            <p:spPr>
              <a:xfrm flipV="1">
                <a:off x="2457132" y="7043899"/>
                <a:ext cx="36000"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8" name="直線コネクタ 487">
                <a:extLst>
                  <a:ext uri="{FF2B5EF4-FFF2-40B4-BE49-F238E27FC236}">
                    <a16:creationId xmlns:a16="http://schemas.microsoft.com/office/drawing/2014/main" id="{7DA9BA1D-5F33-31DF-1362-CF08B30822DA}"/>
                  </a:ext>
                </a:extLst>
              </p:cNvPr>
              <p:cNvCxnSpPr>
                <a:cxnSpLocks/>
              </p:cNvCxnSpPr>
              <p:nvPr/>
            </p:nvCxnSpPr>
            <p:spPr>
              <a:xfrm flipV="1">
                <a:off x="3604925" y="7143217"/>
                <a:ext cx="0" cy="360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9" name="直線コネクタ 488">
                <a:extLst>
                  <a:ext uri="{FF2B5EF4-FFF2-40B4-BE49-F238E27FC236}">
                    <a16:creationId xmlns:a16="http://schemas.microsoft.com/office/drawing/2014/main" id="{1AE45EE2-7F0C-C3D3-3096-18FA38B9837E}"/>
                  </a:ext>
                </a:extLst>
              </p:cNvPr>
              <p:cNvCxnSpPr>
                <a:cxnSpLocks/>
              </p:cNvCxnSpPr>
              <p:nvPr/>
            </p:nvCxnSpPr>
            <p:spPr>
              <a:xfrm flipV="1">
                <a:off x="3363463" y="7143217"/>
                <a:ext cx="0" cy="360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90" name="直線コネクタ 489">
                <a:extLst>
                  <a:ext uri="{FF2B5EF4-FFF2-40B4-BE49-F238E27FC236}">
                    <a16:creationId xmlns:a16="http://schemas.microsoft.com/office/drawing/2014/main" id="{24A5080E-3931-CC76-E52B-0AFCE352FDC0}"/>
                  </a:ext>
                </a:extLst>
              </p:cNvPr>
              <p:cNvCxnSpPr>
                <a:cxnSpLocks/>
              </p:cNvCxnSpPr>
              <p:nvPr/>
            </p:nvCxnSpPr>
            <p:spPr>
              <a:xfrm flipV="1">
                <a:off x="3122001" y="7143217"/>
                <a:ext cx="0" cy="360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91" name="直線コネクタ 490">
                <a:extLst>
                  <a:ext uri="{FF2B5EF4-FFF2-40B4-BE49-F238E27FC236}">
                    <a16:creationId xmlns:a16="http://schemas.microsoft.com/office/drawing/2014/main" id="{A21C9EF0-35C5-53C1-71FC-11A52180ACAB}"/>
                  </a:ext>
                </a:extLst>
              </p:cNvPr>
              <p:cNvCxnSpPr>
                <a:cxnSpLocks/>
              </p:cNvCxnSpPr>
              <p:nvPr/>
            </p:nvCxnSpPr>
            <p:spPr>
              <a:xfrm flipV="1">
                <a:off x="2880539" y="7143217"/>
                <a:ext cx="0" cy="360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92" name="直線コネクタ 491">
                <a:extLst>
                  <a:ext uri="{FF2B5EF4-FFF2-40B4-BE49-F238E27FC236}">
                    <a16:creationId xmlns:a16="http://schemas.microsoft.com/office/drawing/2014/main" id="{C9ED6446-955F-AB18-6B8F-27A49ABDB686}"/>
                  </a:ext>
                </a:extLst>
              </p:cNvPr>
              <p:cNvCxnSpPr>
                <a:cxnSpLocks/>
              </p:cNvCxnSpPr>
              <p:nvPr/>
            </p:nvCxnSpPr>
            <p:spPr>
              <a:xfrm flipV="1">
                <a:off x="2639077" y="7143217"/>
                <a:ext cx="0" cy="360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93" name="直線コネクタ 492">
                <a:extLst>
                  <a:ext uri="{FF2B5EF4-FFF2-40B4-BE49-F238E27FC236}">
                    <a16:creationId xmlns:a16="http://schemas.microsoft.com/office/drawing/2014/main" id="{71251EAB-51CF-B597-3304-AD18EC4A38E6}"/>
                  </a:ext>
                </a:extLst>
              </p:cNvPr>
              <p:cNvCxnSpPr>
                <a:cxnSpLocks/>
              </p:cNvCxnSpPr>
              <p:nvPr/>
            </p:nvCxnSpPr>
            <p:spPr>
              <a:xfrm flipV="1">
                <a:off x="3846387" y="7143217"/>
                <a:ext cx="0" cy="360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94" name="直線コネクタ 493">
                <a:extLst>
                  <a:ext uri="{FF2B5EF4-FFF2-40B4-BE49-F238E27FC236}">
                    <a16:creationId xmlns:a16="http://schemas.microsoft.com/office/drawing/2014/main" id="{709C6B6B-45D4-7E38-A466-F7CCC838E856}"/>
                  </a:ext>
                </a:extLst>
              </p:cNvPr>
              <p:cNvCxnSpPr>
                <a:cxnSpLocks/>
              </p:cNvCxnSpPr>
              <p:nvPr/>
            </p:nvCxnSpPr>
            <p:spPr>
              <a:xfrm flipV="1">
                <a:off x="4087851" y="7143217"/>
                <a:ext cx="0" cy="3600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95" name="テキスト ボックス 494">
                <a:extLst>
                  <a:ext uri="{FF2B5EF4-FFF2-40B4-BE49-F238E27FC236}">
                    <a16:creationId xmlns:a16="http://schemas.microsoft.com/office/drawing/2014/main" id="{0E5FF421-8D7B-81E0-E40D-06A17F5EBCE4}"/>
                  </a:ext>
                </a:extLst>
              </p:cNvPr>
              <p:cNvSpPr txBox="1"/>
              <p:nvPr/>
            </p:nvSpPr>
            <p:spPr>
              <a:xfrm>
                <a:off x="2255452" y="6206403"/>
                <a:ext cx="271228"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20</a:t>
                </a:r>
                <a:endParaRPr kumimoji="1" lang="ja-JP" altLang="en-US" sz="600" dirty="0">
                  <a:latin typeface="Arial" panose="020B0604020202020204" pitchFamily="34" charset="0"/>
                  <a:cs typeface="Arial" panose="020B0604020202020204" pitchFamily="34" charset="0"/>
                </a:endParaRPr>
              </a:p>
            </p:txBody>
          </p:sp>
          <p:sp>
            <p:nvSpPr>
              <p:cNvPr id="496" name="テキスト ボックス 495">
                <a:extLst>
                  <a:ext uri="{FF2B5EF4-FFF2-40B4-BE49-F238E27FC236}">
                    <a16:creationId xmlns:a16="http://schemas.microsoft.com/office/drawing/2014/main" id="{09EFA931-BDD5-1784-BA60-AAD987543118}"/>
                  </a:ext>
                </a:extLst>
              </p:cNvPr>
              <p:cNvSpPr txBox="1"/>
              <p:nvPr/>
            </p:nvSpPr>
            <p:spPr>
              <a:xfrm>
                <a:off x="2255452" y="5958131"/>
                <a:ext cx="271228" cy="184666"/>
              </a:xfrm>
              <a:prstGeom prst="rect">
                <a:avLst/>
              </a:prstGeom>
              <a:noFill/>
            </p:spPr>
            <p:txBody>
              <a:bodyPr wrap="none" rtlCol="0">
                <a:spAutoFit/>
              </a:bodyPr>
              <a:lstStyle/>
              <a:p>
                <a:pPr algn="r"/>
                <a:r>
                  <a:rPr lang="en-US" altLang="ja-JP" sz="600" dirty="0">
                    <a:latin typeface="Arial" panose="020B0604020202020204" pitchFamily="34" charset="0"/>
                    <a:cs typeface="Arial" panose="020B0604020202020204" pitchFamily="34" charset="0"/>
                  </a:rPr>
                  <a:t>4</a:t>
                </a:r>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497" name="テキスト ボックス 496">
                <a:extLst>
                  <a:ext uri="{FF2B5EF4-FFF2-40B4-BE49-F238E27FC236}">
                    <a16:creationId xmlns:a16="http://schemas.microsoft.com/office/drawing/2014/main" id="{E7EC9358-C3B1-C5F7-E767-71E155872161}"/>
                  </a:ext>
                </a:extLst>
              </p:cNvPr>
              <p:cNvSpPr txBox="1"/>
              <p:nvPr/>
            </p:nvSpPr>
            <p:spPr>
              <a:xfrm>
                <a:off x="2255452" y="5709859"/>
                <a:ext cx="271228"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60</a:t>
                </a:r>
                <a:endParaRPr kumimoji="1" lang="ja-JP" altLang="en-US" sz="600" dirty="0">
                  <a:latin typeface="Arial" panose="020B0604020202020204" pitchFamily="34" charset="0"/>
                  <a:cs typeface="Arial" panose="020B0604020202020204" pitchFamily="34" charset="0"/>
                </a:endParaRPr>
              </a:p>
            </p:txBody>
          </p:sp>
          <p:sp>
            <p:nvSpPr>
              <p:cNvPr id="498" name="テキスト ボックス 497">
                <a:extLst>
                  <a:ext uri="{FF2B5EF4-FFF2-40B4-BE49-F238E27FC236}">
                    <a16:creationId xmlns:a16="http://schemas.microsoft.com/office/drawing/2014/main" id="{3F6AADA3-C321-6F9D-3FFA-539E0452119D}"/>
                  </a:ext>
                </a:extLst>
              </p:cNvPr>
              <p:cNvSpPr txBox="1"/>
              <p:nvPr/>
            </p:nvSpPr>
            <p:spPr>
              <a:xfrm>
                <a:off x="2255452" y="5461587"/>
                <a:ext cx="271228" cy="184666"/>
              </a:xfrm>
              <a:prstGeom prst="rect">
                <a:avLst/>
              </a:prstGeom>
              <a:noFill/>
            </p:spPr>
            <p:txBody>
              <a:bodyPr wrap="none" rtlCol="0">
                <a:spAutoFit/>
              </a:bodyPr>
              <a:lstStyle/>
              <a:p>
                <a:pPr algn="r"/>
                <a:r>
                  <a:rPr lang="en-US" altLang="ja-JP" sz="600" dirty="0">
                    <a:latin typeface="Arial" panose="020B0604020202020204" pitchFamily="34" charset="0"/>
                    <a:cs typeface="Arial" panose="020B0604020202020204" pitchFamily="34" charset="0"/>
                  </a:rPr>
                  <a:t>8</a:t>
                </a:r>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499" name="テキスト ボックス 498">
                <a:extLst>
                  <a:ext uri="{FF2B5EF4-FFF2-40B4-BE49-F238E27FC236}">
                    <a16:creationId xmlns:a16="http://schemas.microsoft.com/office/drawing/2014/main" id="{C2EFF405-F8A7-3AEF-4DDB-0CB489C5EAA7}"/>
                  </a:ext>
                </a:extLst>
              </p:cNvPr>
              <p:cNvSpPr txBox="1"/>
              <p:nvPr/>
            </p:nvSpPr>
            <p:spPr>
              <a:xfrm>
                <a:off x="2229804" y="6702947"/>
                <a:ext cx="296876"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20</a:t>
                </a:r>
                <a:endParaRPr kumimoji="1" lang="ja-JP" altLang="en-US" sz="600" dirty="0">
                  <a:latin typeface="Arial" panose="020B0604020202020204" pitchFamily="34" charset="0"/>
                  <a:cs typeface="Arial" panose="020B0604020202020204" pitchFamily="34" charset="0"/>
                </a:endParaRPr>
              </a:p>
            </p:txBody>
          </p:sp>
          <p:sp>
            <p:nvSpPr>
              <p:cNvPr id="500" name="テキスト ボックス 499">
                <a:extLst>
                  <a:ext uri="{FF2B5EF4-FFF2-40B4-BE49-F238E27FC236}">
                    <a16:creationId xmlns:a16="http://schemas.microsoft.com/office/drawing/2014/main" id="{71DF56CE-2BE4-511F-72AC-F12A02B74A9C}"/>
                  </a:ext>
                </a:extLst>
              </p:cNvPr>
              <p:cNvSpPr txBox="1"/>
              <p:nvPr/>
            </p:nvSpPr>
            <p:spPr>
              <a:xfrm>
                <a:off x="2229804" y="6951221"/>
                <a:ext cx="296876"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40</a:t>
                </a:r>
                <a:endParaRPr kumimoji="1" lang="ja-JP" altLang="en-US" sz="600" dirty="0">
                  <a:latin typeface="Arial" panose="020B0604020202020204" pitchFamily="34" charset="0"/>
                  <a:cs typeface="Arial" panose="020B0604020202020204" pitchFamily="34" charset="0"/>
                </a:endParaRPr>
              </a:p>
            </p:txBody>
          </p:sp>
          <p:sp>
            <p:nvSpPr>
              <p:cNvPr id="503" name="楕円 502">
                <a:extLst>
                  <a:ext uri="{FF2B5EF4-FFF2-40B4-BE49-F238E27FC236}">
                    <a16:creationId xmlns:a16="http://schemas.microsoft.com/office/drawing/2014/main" id="{F3B67BC3-069C-F2DA-D429-8436ACA85050}"/>
                  </a:ext>
                </a:extLst>
              </p:cNvPr>
              <p:cNvSpPr/>
              <p:nvPr/>
            </p:nvSpPr>
            <p:spPr>
              <a:xfrm rot="3637429">
                <a:off x="3580281" y="6495758"/>
                <a:ext cx="451769" cy="596414"/>
              </a:xfrm>
              <a:prstGeom prst="ellipse">
                <a:avLst/>
              </a:prstGeom>
              <a:solidFill>
                <a:srgbClr val="E46C0A">
                  <a:alpha val="49804"/>
                </a:srgbClr>
              </a:solidFill>
              <a:ln w="12700" cmpd="sng">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dirty="0">
                  <a:latin typeface="Arial" panose="020B0604020202020204" pitchFamily="34" charset="0"/>
                  <a:cs typeface="Arial" panose="020B0604020202020204" pitchFamily="34" charset="0"/>
                </a:endParaRPr>
              </a:p>
            </p:txBody>
          </p:sp>
          <p:sp>
            <p:nvSpPr>
              <p:cNvPr id="504" name="テキスト ボックス 503">
                <a:extLst>
                  <a:ext uri="{FF2B5EF4-FFF2-40B4-BE49-F238E27FC236}">
                    <a16:creationId xmlns:a16="http://schemas.microsoft.com/office/drawing/2014/main" id="{132D6D73-30B6-C6B9-BF9E-F726F88AF101}"/>
                  </a:ext>
                </a:extLst>
              </p:cNvPr>
              <p:cNvSpPr txBox="1"/>
              <p:nvPr/>
            </p:nvSpPr>
            <p:spPr>
              <a:xfrm>
                <a:off x="3504679" y="7166673"/>
                <a:ext cx="227948"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505" name="テキスト ボックス 504">
                <a:extLst>
                  <a:ext uri="{FF2B5EF4-FFF2-40B4-BE49-F238E27FC236}">
                    <a16:creationId xmlns:a16="http://schemas.microsoft.com/office/drawing/2014/main" id="{609DD3E4-A3DE-8065-01FD-8CD27B7602C2}"/>
                  </a:ext>
                </a:extLst>
              </p:cNvPr>
              <p:cNvSpPr txBox="1"/>
              <p:nvPr/>
            </p:nvSpPr>
            <p:spPr>
              <a:xfrm>
                <a:off x="3245253" y="7166673"/>
                <a:ext cx="296877"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20</a:t>
                </a:r>
                <a:endParaRPr kumimoji="1" lang="ja-JP" altLang="en-US" sz="600" dirty="0">
                  <a:latin typeface="Arial" panose="020B0604020202020204" pitchFamily="34" charset="0"/>
                  <a:cs typeface="Arial" panose="020B0604020202020204" pitchFamily="34" charset="0"/>
                </a:endParaRPr>
              </a:p>
            </p:txBody>
          </p:sp>
          <p:sp>
            <p:nvSpPr>
              <p:cNvPr id="506" name="テキスト ボックス 505">
                <a:extLst>
                  <a:ext uri="{FF2B5EF4-FFF2-40B4-BE49-F238E27FC236}">
                    <a16:creationId xmlns:a16="http://schemas.microsoft.com/office/drawing/2014/main" id="{7478FE7F-807D-D2D0-3A8B-A29BBE3053FB}"/>
                  </a:ext>
                </a:extLst>
              </p:cNvPr>
              <p:cNvSpPr txBox="1"/>
              <p:nvPr/>
            </p:nvSpPr>
            <p:spPr>
              <a:xfrm>
                <a:off x="2985827" y="7166673"/>
                <a:ext cx="296877" cy="184666"/>
              </a:xfrm>
              <a:prstGeom prst="rect">
                <a:avLst/>
              </a:prstGeom>
              <a:noFill/>
            </p:spPr>
            <p:txBody>
              <a:bodyPr wrap="none" rtlCol="0">
                <a:spAutoFit/>
              </a:bodyPr>
              <a:lstStyle/>
              <a:p>
                <a:pPr algn="r"/>
                <a:r>
                  <a:rPr lang="en-US" altLang="ja-JP" sz="600" dirty="0">
                    <a:latin typeface="Arial" panose="020B0604020202020204" pitchFamily="34" charset="0"/>
                    <a:cs typeface="Arial" panose="020B0604020202020204" pitchFamily="34" charset="0"/>
                  </a:rPr>
                  <a:t>-4</a:t>
                </a:r>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507" name="テキスト ボックス 506">
                <a:extLst>
                  <a:ext uri="{FF2B5EF4-FFF2-40B4-BE49-F238E27FC236}">
                    <a16:creationId xmlns:a16="http://schemas.microsoft.com/office/drawing/2014/main" id="{2CCDF2C1-4F53-FD92-FF54-C59ACF66F965}"/>
                  </a:ext>
                </a:extLst>
              </p:cNvPr>
              <p:cNvSpPr txBox="1"/>
              <p:nvPr/>
            </p:nvSpPr>
            <p:spPr>
              <a:xfrm>
                <a:off x="2726401" y="7166673"/>
                <a:ext cx="296877"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60</a:t>
                </a:r>
                <a:endParaRPr kumimoji="1" lang="ja-JP" altLang="en-US" sz="600" dirty="0">
                  <a:latin typeface="Arial" panose="020B0604020202020204" pitchFamily="34" charset="0"/>
                  <a:cs typeface="Arial" panose="020B0604020202020204" pitchFamily="34" charset="0"/>
                </a:endParaRPr>
              </a:p>
            </p:txBody>
          </p:sp>
          <p:sp>
            <p:nvSpPr>
              <p:cNvPr id="508" name="テキスト ボックス 507">
                <a:extLst>
                  <a:ext uri="{FF2B5EF4-FFF2-40B4-BE49-F238E27FC236}">
                    <a16:creationId xmlns:a16="http://schemas.microsoft.com/office/drawing/2014/main" id="{5F1C3B14-409B-B628-7F49-3EF1F38C8BD4}"/>
                  </a:ext>
                </a:extLst>
              </p:cNvPr>
              <p:cNvSpPr txBox="1"/>
              <p:nvPr/>
            </p:nvSpPr>
            <p:spPr>
              <a:xfrm>
                <a:off x="2466975" y="7166673"/>
                <a:ext cx="296877" cy="184666"/>
              </a:xfrm>
              <a:prstGeom prst="rect">
                <a:avLst/>
              </a:prstGeom>
              <a:noFill/>
            </p:spPr>
            <p:txBody>
              <a:bodyPr wrap="none" rtlCol="0">
                <a:spAutoFit/>
              </a:bodyPr>
              <a:lstStyle/>
              <a:p>
                <a:pPr algn="r"/>
                <a:r>
                  <a:rPr lang="en-US" altLang="ja-JP" sz="600" dirty="0">
                    <a:latin typeface="Arial" panose="020B0604020202020204" pitchFamily="34" charset="0"/>
                    <a:cs typeface="Arial" panose="020B0604020202020204" pitchFamily="34" charset="0"/>
                  </a:rPr>
                  <a:t>-8</a:t>
                </a:r>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509" name="テキスト ボックス 508">
                <a:extLst>
                  <a:ext uri="{FF2B5EF4-FFF2-40B4-BE49-F238E27FC236}">
                    <a16:creationId xmlns:a16="http://schemas.microsoft.com/office/drawing/2014/main" id="{C4672108-A726-3C3D-1CD7-0055E6401326}"/>
                  </a:ext>
                </a:extLst>
              </p:cNvPr>
              <p:cNvSpPr txBox="1"/>
              <p:nvPr/>
            </p:nvSpPr>
            <p:spPr>
              <a:xfrm>
                <a:off x="3695176" y="7166673"/>
                <a:ext cx="271228"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20</a:t>
                </a:r>
                <a:endParaRPr kumimoji="1" lang="ja-JP" altLang="en-US" sz="600" dirty="0">
                  <a:latin typeface="Arial" panose="020B0604020202020204" pitchFamily="34" charset="0"/>
                  <a:cs typeface="Arial" panose="020B0604020202020204" pitchFamily="34" charset="0"/>
                </a:endParaRPr>
              </a:p>
            </p:txBody>
          </p:sp>
          <p:sp>
            <p:nvSpPr>
              <p:cNvPr id="510" name="テキスト ボックス 509">
                <a:extLst>
                  <a:ext uri="{FF2B5EF4-FFF2-40B4-BE49-F238E27FC236}">
                    <a16:creationId xmlns:a16="http://schemas.microsoft.com/office/drawing/2014/main" id="{C68AB320-E4E8-9993-34B7-AC455B94E51C}"/>
                  </a:ext>
                </a:extLst>
              </p:cNvPr>
              <p:cNvSpPr txBox="1"/>
              <p:nvPr/>
            </p:nvSpPr>
            <p:spPr>
              <a:xfrm>
                <a:off x="3928952" y="7166673"/>
                <a:ext cx="271228" cy="184666"/>
              </a:xfrm>
              <a:prstGeom prst="rect">
                <a:avLst/>
              </a:prstGeom>
              <a:noFill/>
            </p:spPr>
            <p:txBody>
              <a:bodyPr wrap="none" rtlCol="0">
                <a:spAutoFit/>
              </a:bodyPr>
              <a:lstStyle/>
              <a:p>
                <a:pPr algn="r"/>
                <a:r>
                  <a:rPr kumimoji="1" lang="en-US" altLang="ja-JP" sz="600" dirty="0">
                    <a:latin typeface="Arial" panose="020B0604020202020204" pitchFamily="34" charset="0"/>
                    <a:cs typeface="Arial" panose="020B0604020202020204" pitchFamily="34" charset="0"/>
                  </a:rPr>
                  <a:t>40</a:t>
                </a:r>
                <a:endParaRPr kumimoji="1" lang="ja-JP" altLang="en-US" sz="600" dirty="0">
                  <a:latin typeface="Arial" panose="020B0604020202020204" pitchFamily="34" charset="0"/>
                  <a:cs typeface="Arial" panose="020B0604020202020204" pitchFamily="34" charset="0"/>
                </a:endParaRPr>
              </a:p>
            </p:txBody>
          </p:sp>
          <p:sp>
            <p:nvSpPr>
              <p:cNvPr id="511" name="Rectangle 114">
                <a:extLst>
                  <a:ext uri="{FF2B5EF4-FFF2-40B4-BE49-F238E27FC236}">
                    <a16:creationId xmlns:a16="http://schemas.microsoft.com/office/drawing/2014/main" id="{910B008D-8F92-37A7-AD18-90888760EE95}"/>
                  </a:ext>
                </a:extLst>
              </p:cNvPr>
              <p:cNvSpPr>
                <a:spLocks noChangeArrowheads="1"/>
              </p:cNvSpPr>
              <p:nvPr/>
            </p:nvSpPr>
            <p:spPr bwMode="auto">
              <a:xfrm rot="16200000">
                <a:off x="1981384" y="6250901"/>
                <a:ext cx="442429"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600" b="0" i="0" u="none" strike="noStrike" cap="none" normalizeH="0" baseline="0" dirty="0">
                    <a:ln>
                      <a:noFill/>
                    </a:ln>
                    <a:solidFill>
                      <a:srgbClr val="000000"/>
                    </a:solidFill>
                    <a:effectLst/>
                    <a:cs typeface="Arial" panose="020B0604020202020204" pitchFamily="34" charset="0"/>
                  </a:rPr>
                  <a:t>PC3 (10.5%)</a:t>
                </a:r>
                <a:endParaRPr kumimoji="0" lang="ja-JP" altLang="ja-JP" sz="600" b="0" i="0" u="none" strike="noStrike" cap="none" normalizeH="0" baseline="0" dirty="0">
                  <a:ln>
                    <a:noFill/>
                  </a:ln>
                  <a:solidFill>
                    <a:schemeClr val="tx1"/>
                  </a:solidFill>
                  <a:effectLst/>
                  <a:cs typeface="Arial" panose="020B0604020202020204" pitchFamily="34" charset="0"/>
                </a:endParaRPr>
              </a:p>
            </p:txBody>
          </p:sp>
          <p:sp>
            <p:nvSpPr>
              <p:cNvPr id="512" name="Rectangle 114">
                <a:extLst>
                  <a:ext uri="{FF2B5EF4-FFF2-40B4-BE49-F238E27FC236}">
                    <a16:creationId xmlns:a16="http://schemas.microsoft.com/office/drawing/2014/main" id="{D67DD56B-65AE-E084-8A9C-0D809770DDBE}"/>
                  </a:ext>
                </a:extLst>
              </p:cNvPr>
              <p:cNvSpPr>
                <a:spLocks noChangeArrowheads="1"/>
              </p:cNvSpPr>
              <p:nvPr/>
            </p:nvSpPr>
            <p:spPr bwMode="auto">
              <a:xfrm>
                <a:off x="3140559" y="7368895"/>
                <a:ext cx="442429"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600" b="0" i="0" u="none" strike="noStrike" cap="none" normalizeH="0" baseline="0" dirty="0">
                    <a:ln>
                      <a:noFill/>
                    </a:ln>
                    <a:solidFill>
                      <a:srgbClr val="000000"/>
                    </a:solidFill>
                    <a:effectLst/>
                    <a:cs typeface="Arial" panose="020B0604020202020204" pitchFamily="34" charset="0"/>
                  </a:rPr>
                  <a:t>PC2 (1</a:t>
                </a:r>
                <a:r>
                  <a:rPr kumimoji="0" lang="en-US" altLang="ja-JP" sz="600" dirty="0">
                    <a:solidFill>
                      <a:srgbClr val="000000"/>
                    </a:solidFill>
                    <a:cs typeface="Arial" panose="020B0604020202020204" pitchFamily="34" charset="0"/>
                  </a:rPr>
                  <a:t>1</a:t>
                </a:r>
                <a:r>
                  <a:rPr kumimoji="0" lang="en-US" altLang="ja-JP" sz="600" b="0" i="0" u="none" strike="noStrike" cap="none" normalizeH="0" baseline="0" dirty="0">
                    <a:ln>
                      <a:noFill/>
                    </a:ln>
                    <a:solidFill>
                      <a:srgbClr val="000000"/>
                    </a:solidFill>
                    <a:effectLst/>
                    <a:cs typeface="Arial" panose="020B0604020202020204" pitchFamily="34" charset="0"/>
                  </a:rPr>
                  <a:t>.</a:t>
                </a:r>
                <a:r>
                  <a:rPr kumimoji="0" lang="en-US" altLang="ja-JP" sz="600" dirty="0">
                    <a:solidFill>
                      <a:srgbClr val="000000"/>
                    </a:solidFill>
                    <a:cs typeface="Arial" panose="020B0604020202020204" pitchFamily="34" charset="0"/>
                  </a:rPr>
                  <a:t>0</a:t>
                </a:r>
                <a:r>
                  <a:rPr kumimoji="0" lang="en-US" altLang="ja-JP" sz="600" b="0" i="0" u="none" strike="noStrike" cap="none" normalizeH="0" baseline="0" dirty="0">
                    <a:ln>
                      <a:noFill/>
                    </a:ln>
                    <a:solidFill>
                      <a:srgbClr val="000000"/>
                    </a:solidFill>
                    <a:effectLst/>
                    <a:cs typeface="Arial" panose="020B0604020202020204" pitchFamily="34" charset="0"/>
                  </a:rPr>
                  <a:t>%)</a:t>
                </a:r>
                <a:endParaRPr kumimoji="0" lang="ja-JP" altLang="ja-JP" sz="600" b="0" i="0" u="none" strike="noStrike" cap="none" normalizeH="0" baseline="0" dirty="0">
                  <a:ln>
                    <a:noFill/>
                  </a:ln>
                  <a:solidFill>
                    <a:schemeClr val="tx1"/>
                  </a:solidFill>
                  <a:effectLst/>
                  <a:cs typeface="Arial" panose="020B0604020202020204" pitchFamily="34" charset="0"/>
                </a:endParaRPr>
              </a:p>
            </p:txBody>
          </p:sp>
        </p:grpSp>
        <p:grpSp>
          <p:nvGrpSpPr>
            <p:cNvPr id="536" name="グループ化 535">
              <a:extLst>
                <a:ext uri="{FF2B5EF4-FFF2-40B4-BE49-F238E27FC236}">
                  <a16:creationId xmlns:a16="http://schemas.microsoft.com/office/drawing/2014/main" id="{2DFD3284-4D72-3543-4D34-FAC9994FAF8A}"/>
                </a:ext>
              </a:extLst>
            </p:cNvPr>
            <p:cNvGrpSpPr/>
            <p:nvPr/>
          </p:nvGrpSpPr>
          <p:grpSpPr>
            <a:xfrm>
              <a:off x="4688002" y="2512123"/>
              <a:ext cx="203078" cy="512300"/>
              <a:chOff x="4695073" y="5401924"/>
              <a:chExt cx="203078" cy="512300"/>
            </a:xfrm>
          </p:grpSpPr>
          <p:sp>
            <p:nvSpPr>
              <p:cNvPr id="524" name="Rectangle 218">
                <a:extLst>
                  <a:ext uri="{FF2B5EF4-FFF2-40B4-BE49-F238E27FC236}">
                    <a16:creationId xmlns:a16="http://schemas.microsoft.com/office/drawing/2014/main" id="{02402180-2810-7527-0E3E-DB7A569E9E1E}"/>
                  </a:ext>
                </a:extLst>
              </p:cNvPr>
              <p:cNvSpPr>
                <a:spLocks noChangeArrowheads="1"/>
              </p:cNvSpPr>
              <p:nvPr/>
            </p:nvSpPr>
            <p:spPr bwMode="auto">
              <a:xfrm>
                <a:off x="4834814" y="5401924"/>
                <a:ext cx="43282"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ja-JP" altLang="ja-JP" sz="600" b="0" i="0" u="none" strike="noStrike" cap="none" normalizeH="0" baseline="0" dirty="0">
                    <a:ln>
                      <a:noFill/>
                    </a:ln>
                    <a:effectLst/>
                    <a:cs typeface="Arial" panose="020B0604020202020204" pitchFamily="34" charset="0"/>
                  </a:rPr>
                  <a:t>0</a:t>
                </a:r>
              </a:p>
            </p:txBody>
          </p:sp>
          <p:sp>
            <p:nvSpPr>
              <p:cNvPr id="525" name="Oval 220">
                <a:extLst>
                  <a:ext uri="{FF2B5EF4-FFF2-40B4-BE49-F238E27FC236}">
                    <a16:creationId xmlns:a16="http://schemas.microsoft.com/office/drawing/2014/main" id="{EDA4F5F7-9BEB-233A-D71D-7B6005C0CF56}"/>
                  </a:ext>
                </a:extLst>
              </p:cNvPr>
              <p:cNvSpPr>
                <a:spLocks noChangeArrowheads="1"/>
              </p:cNvSpPr>
              <p:nvPr/>
            </p:nvSpPr>
            <p:spPr bwMode="auto">
              <a:xfrm>
                <a:off x="4695073" y="5412090"/>
                <a:ext cx="72000" cy="72000"/>
              </a:xfrm>
              <a:prstGeom prst="ellipse">
                <a:avLst/>
              </a:prstGeom>
              <a:solidFill>
                <a:schemeClr val="bg1">
                  <a:lumMod val="85000"/>
                </a:schemeClr>
              </a:solidFill>
              <a:ln w="3175"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sz="600" dirty="0">
                  <a:latin typeface="Arial" panose="020B0604020202020204" pitchFamily="34" charset="0"/>
                  <a:cs typeface="Arial" panose="020B0604020202020204" pitchFamily="34" charset="0"/>
                </a:endParaRPr>
              </a:p>
            </p:txBody>
          </p:sp>
          <p:sp>
            <p:nvSpPr>
              <p:cNvPr id="526" name="Oval 223">
                <a:extLst>
                  <a:ext uri="{FF2B5EF4-FFF2-40B4-BE49-F238E27FC236}">
                    <a16:creationId xmlns:a16="http://schemas.microsoft.com/office/drawing/2014/main" id="{4D73B304-6B5F-CDD3-39CB-E848A071E4EB}"/>
                  </a:ext>
                </a:extLst>
              </p:cNvPr>
              <p:cNvSpPr>
                <a:spLocks noChangeArrowheads="1"/>
              </p:cNvSpPr>
              <p:nvPr/>
            </p:nvSpPr>
            <p:spPr bwMode="auto">
              <a:xfrm>
                <a:off x="4695073" y="5552079"/>
                <a:ext cx="72000" cy="72000"/>
              </a:xfrm>
              <a:prstGeom prst="ellipse">
                <a:avLst/>
              </a:prstGeom>
              <a:solidFill>
                <a:schemeClr val="accent6">
                  <a:lumMod val="40000"/>
                  <a:lumOff val="60000"/>
                </a:schemeClr>
              </a:solidFill>
              <a:ln w="3175"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sz="600">
                  <a:latin typeface="Arial" panose="020B0604020202020204" pitchFamily="34" charset="0"/>
                  <a:cs typeface="Arial" panose="020B0604020202020204" pitchFamily="34" charset="0"/>
                </a:endParaRPr>
              </a:p>
            </p:txBody>
          </p:sp>
          <p:sp>
            <p:nvSpPr>
              <p:cNvPr id="529" name="Rectangle 218">
                <a:extLst>
                  <a:ext uri="{FF2B5EF4-FFF2-40B4-BE49-F238E27FC236}">
                    <a16:creationId xmlns:a16="http://schemas.microsoft.com/office/drawing/2014/main" id="{2573CC81-E4C6-D749-1D99-D3109E8249A2}"/>
                  </a:ext>
                </a:extLst>
              </p:cNvPr>
              <p:cNvSpPr>
                <a:spLocks noChangeArrowheads="1"/>
              </p:cNvSpPr>
              <p:nvPr/>
            </p:nvSpPr>
            <p:spPr bwMode="auto">
              <a:xfrm>
                <a:off x="4811588" y="5541913"/>
                <a:ext cx="86563"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ja-JP" sz="600" dirty="0">
                    <a:cs typeface="Arial" panose="020B0604020202020204" pitchFamily="34" charset="0"/>
                  </a:rPr>
                  <a:t>15</a:t>
                </a:r>
                <a:endParaRPr kumimoji="0" lang="ja-JP" altLang="ja-JP" sz="600" b="0" i="0" u="none" strike="noStrike" cap="none" normalizeH="0" baseline="0" dirty="0">
                  <a:ln>
                    <a:noFill/>
                  </a:ln>
                  <a:effectLst/>
                  <a:cs typeface="Arial" panose="020B0604020202020204" pitchFamily="34" charset="0"/>
                </a:endParaRPr>
              </a:p>
            </p:txBody>
          </p:sp>
          <p:sp>
            <p:nvSpPr>
              <p:cNvPr id="527" name="Oval 225">
                <a:extLst>
                  <a:ext uri="{FF2B5EF4-FFF2-40B4-BE49-F238E27FC236}">
                    <a16:creationId xmlns:a16="http://schemas.microsoft.com/office/drawing/2014/main" id="{2F799D18-436B-B5AD-5DB1-24DC3E2DA17A}"/>
                  </a:ext>
                </a:extLst>
              </p:cNvPr>
              <p:cNvSpPr>
                <a:spLocks noChangeArrowheads="1"/>
              </p:cNvSpPr>
              <p:nvPr/>
            </p:nvSpPr>
            <p:spPr bwMode="auto">
              <a:xfrm>
                <a:off x="4695073" y="5692068"/>
                <a:ext cx="72000" cy="72000"/>
              </a:xfrm>
              <a:prstGeom prst="ellipse">
                <a:avLst/>
              </a:prstGeom>
              <a:solidFill>
                <a:schemeClr val="accent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ja-JP" altLang="en-US" sz="600" dirty="0">
                  <a:latin typeface="Arial" panose="020B0604020202020204" pitchFamily="34" charset="0"/>
                  <a:cs typeface="Arial" panose="020B0604020202020204" pitchFamily="34" charset="0"/>
                </a:endParaRPr>
              </a:p>
            </p:txBody>
          </p:sp>
          <p:sp>
            <p:nvSpPr>
              <p:cNvPr id="530" name="Rectangle 218">
                <a:extLst>
                  <a:ext uri="{FF2B5EF4-FFF2-40B4-BE49-F238E27FC236}">
                    <a16:creationId xmlns:a16="http://schemas.microsoft.com/office/drawing/2014/main" id="{24B1FC2B-B29C-E117-4EB3-75394D348E27}"/>
                  </a:ext>
                </a:extLst>
              </p:cNvPr>
              <p:cNvSpPr>
                <a:spLocks noChangeArrowheads="1"/>
              </p:cNvSpPr>
              <p:nvPr/>
            </p:nvSpPr>
            <p:spPr bwMode="auto">
              <a:xfrm>
                <a:off x="4811588" y="5681902"/>
                <a:ext cx="86563"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ja-JP" sz="600" b="0" i="0" u="none" strike="noStrike" cap="none" normalizeH="0" baseline="0" dirty="0">
                    <a:ln>
                      <a:noFill/>
                    </a:ln>
                    <a:effectLst/>
                    <a:cs typeface="Arial" panose="020B0604020202020204" pitchFamily="34" charset="0"/>
                  </a:rPr>
                  <a:t>30</a:t>
                </a:r>
                <a:endParaRPr kumimoji="0" lang="ja-JP" altLang="ja-JP" sz="600" b="0" i="0" u="none" strike="noStrike" cap="none" normalizeH="0" baseline="0" dirty="0">
                  <a:ln>
                    <a:noFill/>
                  </a:ln>
                  <a:effectLst/>
                  <a:cs typeface="Arial" panose="020B0604020202020204" pitchFamily="34" charset="0"/>
                </a:endParaRPr>
              </a:p>
            </p:txBody>
          </p:sp>
          <p:sp>
            <p:nvSpPr>
              <p:cNvPr id="528" name="Oval 229">
                <a:extLst>
                  <a:ext uri="{FF2B5EF4-FFF2-40B4-BE49-F238E27FC236}">
                    <a16:creationId xmlns:a16="http://schemas.microsoft.com/office/drawing/2014/main" id="{B3DCD580-0DFF-CAA5-6CE1-0CE18B2E5D31}"/>
                  </a:ext>
                </a:extLst>
              </p:cNvPr>
              <p:cNvSpPr>
                <a:spLocks noChangeArrowheads="1"/>
              </p:cNvSpPr>
              <p:nvPr/>
            </p:nvSpPr>
            <p:spPr bwMode="auto">
              <a:xfrm>
                <a:off x="4695073" y="5832057"/>
                <a:ext cx="72000" cy="72000"/>
              </a:xfrm>
              <a:prstGeom prst="ellipse">
                <a:avLst/>
              </a:prstGeom>
              <a:solidFill>
                <a:srgbClr val="C00000"/>
              </a:solidFill>
              <a:ln w="3175" cap="flat">
                <a:solidFill>
                  <a:srgbClr val="00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ja-JP" altLang="en-US" sz="600">
                  <a:latin typeface="Arial" panose="020B0604020202020204" pitchFamily="34" charset="0"/>
                  <a:cs typeface="Arial" panose="020B0604020202020204" pitchFamily="34" charset="0"/>
                </a:endParaRPr>
              </a:p>
            </p:txBody>
          </p:sp>
          <p:sp>
            <p:nvSpPr>
              <p:cNvPr id="531" name="Rectangle 218">
                <a:extLst>
                  <a:ext uri="{FF2B5EF4-FFF2-40B4-BE49-F238E27FC236}">
                    <a16:creationId xmlns:a16="http://schemas.microsoft.com/office/drawing/2014/main" id="{96BCD865-D53B-EEE5-F0D7-32418297C766}"/>
                  </a:ext>
                </a:extLst>
              </p:cNvPr>
              <p:cNvSpPr>
                <a:spLocks noChangeArrowheads="1"/>
              </p:cNvSpPr>
              <p:nvPr/>
            </p:nvSpPr>
            <p:spPr bwMode="auto">
              <a:xfrm>
                <a:off x="4811588" y="5821891"/>
                <a:ext cx="86563" cy="923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ja-JP" sz="600" dirty="0">
                    <a:cs typeface="Arial" panose="020B0604020202020204" pitchFamily="34" charset="0"/>
                  </a:rPr>
                  <a:t>9</a:t>
                </a:r>
                <a:r>
                  <a:rPr kumimoji="0" lang="en-US" altLang="ja-JP" sz="600" b="0" i="0" u="none" strike="noStrike" cap="none" normalizeH="0" baseline="0" dirty="0">
                    <a:ln>
                      <a:noFill/>
                    </a:ln>
                    <a:effectLst/>
                    <a:cs typeface="Arial" panose="020B0604020202020204" pitchFamily="34" charset="0"/>
                  </a:rPr>
                  <a:t>0</a:t>
                </a:r>
                <a:endParaRPr kumimoji="0" lang="ja-JP" altLang="ja-JP" sz="600" b="0" i="0" u="none" strike="noStrike" cap="none" normalizeH="0" baseline="0" dirty="0">
                  <a:ln>
                    <a:noFill/>
                  </a:ln>
                  <a:effectLst/>
                  <a:cs typeface="Arial" panose="020B0604020202020204" pitchFamily="34" charset="0"/>
                </a:endParaRPr>
              </a:p>
            </p:txBody>
          </p:sp>
        </p:grpSp>
        <p:sp>
          <p:nvSpPr>
            <p:cNvPr id="2" name="Rectangle 218">
              <a:extLst>
                <a:ext uri="{FF2B5EF4-FFF2-40B4-BE49-F238E27FC236}">
                  <a16:creationId xmlns:a16="http://schemas.microsoft.com/office/drawing/2014/main" id="{C175CDB6-837F-9CE5-787D-BD80EED6B8B0}"/>
                </a:ext>
              </a:extLst>
            </p:cNvPr>
            <p:cNvSpPr>
              <a:spLocks noChangeArrowheads="1"/>
            </p:cNvSpPr>
            <p:nvPr/>
          </p:nvSpPr>
          <p:spPr bwMode="auto">
            <a:xfrm>
              <a:off x="4691547" y="2279383"/>
              <a:ext cx="176330"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ja-JP" sz="600" dirty="0">
                  <a:cs typeface="Arial" panose="020B0604020202020204" pitchFamily="34" charset="0"/>
                </a:rPr>
                <a:t>ABA</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ja-JP" sz="600" b="0" u="none" strike="noStrike" cap="none" normalizeH="0" baseline="0" dirty="0">
                  <a:ln>
                    <a:noFill/>
                  </a:ln>
                  <a:effectLst/>
                  <a:cs typeface="Arial" panose="020B0604020202020204" pitchFamily="34" charset="0"/>
                </a:rPr>
                <a:t>(min)</a:t>
              </a:r>
              <a:endParaRPr kumimoji="0" lang="ja-JP" altLang="ja-JP" sz="600" b="0" u="none" strike="noStrike" cap="none" normalizeH="0" baseline="0" dirty="0">
                <a:ln>
                  <a:noFill/>
                </a:ln>
                <a:effectLst/>
                <a:cs typeface="Arial" panose="020B0604020202020204" pitchFamily="34" charset="0"/>
              </a:endParaRPr>
            </a:p>
          </p:txBody>
        </p:sp>
      </p:grpSp>
    </p:spTree>
    <p:extLst>
      <p:ext uri="{BB962C8B-B14F-4D97-AF65-F5344CB8AC3E}">
        <p14:creationId xmlns:p14="http://schemas.microsoft.com/office/powerpoint/2010/main" val="11756355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グループ化 9">
            <a:extLst>
              <a:ext uri="{FF2B5EF4-FFF2-40B4-BE49-F238E27FC236}">
                <a16:creationId xmlns:a16="http://schemas.microsoft.com/office/drawing/2014/main" id="{F841D7F5-5D9A-CFFF-5229-71AE9DD613C2}"/>
              </a:ext>
            </a:extLst>
          </p:cNvPr>
          <p:cNvGrpSpPr/>
          <p:nvPr/>
        </p:nvGrpSpPr>
        <p:grpSpPr>
          <a:xfrm>
            <a:off x="2805581" y="1187672"/>
            <a:ext cx="1357200" cy="900000"/>
            <a:chOff x="2531049" y="2133599"/>
            <a:chExt cx="1357200" cy="900000"/>
          </a:xfrm>
        </p:grpSpPr>
        <p:sp>
          <p:nvSpPr>
            <p:cNvPr id="4" name="楕円 3">
              <a:extLst>
                <a:ext uri="{FF2B5EF4-FFF2-40B4-BE49-F238E27FC236}">
                  <a16:creationId xmlns:a16="http://schemas.microsoft.com/office/drawing/2014/main" id="{BEDDEEAF-AA33-276C-EFFB-1C9E93A96645}"/>
                </a:ext>
              </a:extLst>
            </p:cNvPr>
            <p:cNvSpPr/>
            <p:nvPr/>
          </p:nvSpPr>
          <p:spPr>
            <a:xfrm>
              <a:off x="2531049" y="2133599"/>
              <a:ext cx="900000" cy="900000"/>
            </a:xfrm>
            <a:prstGeom prst="ellipse">
              <a:avLst/>
            </a:prstGeom>
            <a:noFill/>
            <a:ln w="190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 name="楕円 4">
              <a:extLst>
                <a:ext uri="{FF2B5EF4-FFF2-40B4-BE49-F238E27FC236}">
                  <a16:creationId xmlns:a16="http://schemas.microsoft.com/office/drawing/2014/main" id="{DA2C4017-7077-EF24-DC3C-757D2F1F2EDF}"/>
                </a:ext>
              </a:extLst>
            </p:cNvPr>
            <p:cNvSpPr/>
            <p:nvPr/>
          </p:nvSpPr>
          <p:spPr>
            <a:xfrm>
              <a:off x="2988249" y="2133599"/>
              <a:ext cx="900000" cy="900000"/>
            </a:xfrm>
            <a:prstGeom prst="ellipse">
              <a:avLst/>
            </a:prstGeom>
            <a:noFill/>
            <a:ln w="19050" cmpd="sng">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grpSp>
      <p:grpSp>
        <p:nvGrpSpPr>
          <p:cNvPr id="11" name="グループ化 10">
            <a:extLst>
              <a:ext uri="{FF2B5EF4-FFF2-40B4-BE49-F238E27FC236}">
                <a16:creationId xmlns:a16="http://schemas.microsoft.com/office/drawing/2014/main" id="{DE43DC67-DC98-D87C-98FF-427771C135D6}"/>
              </a:ext>
            </a:extLst>
          </p:cNvPr>
          <p:cNvGrpSpPr/>
          <p:nvPr/>
        </p:nvGrpSpPr>
        <p:grpSpPr>
          <a:xfrm>
            <a:off x="2805581" y="2240072"/>
            <a:ext cx="1357200" cy="900000"/>
            <a:chOff x="2531049" y="3185999"/>
            <a:chExt cx="1357200" cy="900000"/>
          </a:xfrm>
        </p:grpSpPr>
        <p:sp>
          <p:nvSpPr>
            <p:cNvPr id="6" name="楕円 5">
              <a:extLst>
                <a:ext uri="{FF2B5EF4-FFF2-40B4-BE49-F238E27FC236}">
                  <a16:creationId xmlns:a16="http://schemas.microsoft.com/office/drawing/2014/main" id="{DCEB85A7-56A9-120E-119E-AA0D91E09F75}"/>
                </a:ext>
              </a:extLst>
            </p:cNvPr>
            <p:cNvSpPr/>
            <p:nvPr/>
          </p:nvSpPr>
          <p:spPr>
            <a:xfrm>
              <a:off x="2531049" y="3185999"/>
              <a:ext cx="900000" cy="900000"/>
            </a:xfrm>
            <a:prstGeom prst="ellipse">
              <a:avLst/>
            </a:prstGeom>
            <a:noFill/>
            <a:ln w="190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7" name="楕円 6">
              <a:extLst>
                <a:ext uri="{FF2B5EF4-FFF2-40B4-BE49-F238E27FC236}">
                  <a16:creationId xmlns:a16="http://schemas.microsoft.com/office/drawing/2014/main" id="{D25AC16A-DD4D-0400-73FD-65CCF27187AF}"/>
                </a:ext>
              </a:extLst>
            </p:cNvPr>
            <p:cNvSpPr/>
            <p:nvPr/>
          </p:nvSpPr>
          <p:spPr>
            <a:xfrm>
              <a:off x="2988249" y="3185999"/>
              <a:ext cx="900000" cy="900000"/>
            </a:xfrm>
            <a:prstGeom prst="ellipse">
              <a:avLst/>
            </a:prstGeom>
            <a:noFill/>
            <a:ln w="19050" cmpd="sng">
              <a:solidFill>
                <a:srgbClr val="0070C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grpSp>
      <p:grpSp>
        <p:nvGrpSpPr>
          <p:cNvPr id="12" name="グループ化 11">
            <a:extLst>
              <a:ext uri="{FF2B5EF4-FFF2-40B4-BE49-F238E27FC236}">
                <a16:creationId xmlns:a16="http://schemas.microsoft.com/office/drawing/2014/main" id="{829DB56F-7B58-DE9D-370A-F8D210B870C3}"/>
              </a:ext>
            </a:extLst>
          </p:cNvPr>
          <p:cNvGrpSpPr/>
          <p:nvPr/>
        </p:nvGrpSpPr>
        <p:grpSpPr>
          <a:xfrm>
            <a:off x="2805581" y="3292472"/>
            <a:ext cx="1357200" cy="900000"/>
            <a:chOff x="2521800" y="4238399"/>
            <a:chExt cx="1357200" cy="900000"/>
          </a:xfrm>
        </p:grpSpPr>
        <p:sp>
          <p:nvSpPr>
            <p:cNvPr id="8" name="楕円 7">
              <a:extLst>
                <a:ext uri="{FF2B5EF4-FFF2-40B4-BE49-F238E27FC236}">
                  <a16:creationId xmlns:a16="http://schemas.microsoft.com/office/drawing/2014/main" id="{C6B94F15-9CDB-C612-EF8D-AE9BCE31AFE4}"/>
                </a:ext>
              </a:extLst>
            </p:cNvPr>
            <p:cNvSpPr/>
            <p:nvPr/>
          </p:nvSpPr>
          <p:spPr>
            <a:xfrm>
              <a:off x="2521800" y="4238399"/>
              <a:ext cx="900000" cy="900000"/>
            </a:xfrm>
            <a:prstGeom prst="ellipse">
              <a:avLst/>
            </a:prstGeom>
            <a:noFill/>
            <a:ln w="190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9" name="楕円 8">
              <a:extLst>
                <a:ext uri="{FF2B5EF4-FFF2-40B4-BE49-F238E27FC236}">
                  <a16:creationId xmlns:a16="http://schemas.microsoft.com/office/drawing/2014/main" id="{6B781BFC-1EDF-0BFC-5B62-903C4FD0B802}"/>
                </a:ext>
              </a:extLst>
            </p:cNvPr>
            <p:cNvSpPr/>
            <p:nvPr/>
          </p:nvSpPr>
          <p:spPr>
            <a:xfrm>
              <a:off x="2979000" y="4238399"/>
              <a:ext cx="900000" cy="900000"/>
            </a:xfrm>
            <a:prstGeom prst="ellipse">
              <a:avLst/>
            </a:prstGeom>
            <a:noFill/>
            <a:ln w="19050" cmpd="sng">
              <a:solidFill>
                <a:srgbClr val="0070C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grpSp>
      <p:sp>
        <p:nvSpPr>
          <p:cNvPr id="13" name="テキスト ボックス 12">
            <a:extLst>
              <a:ext uri="{FF2B5EF4-FFF2-40B4-BE49-F238E27FC236}">
                <a16:creationId xmlns:a16="http://schemas.microsoft.com/office/drawing/2014/main" id="{C67A6E8D-6054-FAEF-8E3F-BBB88AD518EB}"/>
              </a:ext>
            </a:extLst>
          </p:cNvPr>
          <p:cNvSpPr txBox="1"/>
          <p:nvPr/>
        </p:nvSpPr>
        <p:spPr>
          <a:xfrm>
            <a:off x="2237070" y="956839"/>
            <a:ext cx="722486" cy="461665"/>
          </a:xfrm>
          <a:prstGeom prst="rect">
            <a:avLst/>
          </a:prstGeom>
          <a:noFill/>
        </p:spPr>
        <p:txBody>
          <a:bodyPr wrap="square" rtlCol="0" anchor="ctr">
            <a:spAutoFit/>
          </a:bodyPr>
          <a:lstStyle/>
          <a:p>
            <a:pPr algn="ctr"/>
            <a:r>
              <a:rPr lang="en-US" altLang="ja-JP" sz="600" dirty="0">
                <a:latin typeface="Arial"/>
                <a:cs typeface="Arial"/>
              </a:rPr>
              <a:t>Changed in</a:t>
            </a:r>
          </a:p>
          <a:p>
            <a:pPr algn="ctr"/>
            <a:r>
              <a:rPr lang="en-US" altLang="ja-JP" sz="600" dirty="0">
                <a:latin typeface="Arial"/>
                <a:cs typeface="Arial"/>
              </a:rPr>
              <a:t>Col-0 with ABA</a:t>
            </a:r>
          </a:p>
          <a:p>
            <a:pPr algn="ctr"/>
            <a:r>
              <a:rPr lang="en-US" altLang="ja-JP" sz="600" dirty="0">
                <a:latin typeface="Arial"/>
                <a:cs typeface="Arial"/>
              </a:rPr>
              <a:t>in this study</a:t>
            </a:r>
            <a:br>
              <a:rPr lang="en-US" altLang="ja-JP" sz="600" dirty="0">
                <a:latin typeface="Arial"/>
                <a:cs typeface="Arial"/>
              </a:rPr>
            </a:br>
            <a:r>
              <a:rPr lang="en-US" altLang="ja-JP" sz="600" dirty="0">
                <a:latin typeface="Arial"/>
                <a:cs typeface="Arial"/>
              </a:rPr>
              <a:t>(1135)</a:t>
            </a:r>
            <a:endParaRPr lang="ja-JP" altLang="en-US" sz="600" dirty="0">
              <a:latin typeface="Arial"/>
              <a:cs typeface="Arial"/>
            </a:endParaRPr>
          </a:p>
        </p:txBody>
      </p:sp>
      <p:sp>
        <p:nvSpPr>
          <p:cNvPr id="14" name="テキスト ボックス 13">
            <a:extLst>
              <a:ext uri="{FF2B5EF4-FFF2-40B4-BE49-F238E27FC236}">
                <a16:creationId xmlns:a16="http://schemas.microsoft.com/office/drawing/2014/main" id="{F3C99068-AE67-8D4C-573D-184D2793D049}"/>
              </a:ext>
            </a:extLst>
          </p:cNvPr>
          <p:cNvSpPr txBox="1"/>
          <p:nvPr/>
        </p:nvSpPr>
        <p:spPr>
          <a:xfrm>
            <a:off x="3919961" y="956839"/>
            <a:ext cx="722486" cy="461665"/>
          </a:xfrm>
          <a:prstGeom prst="rect">
            <a:avLst/>
          </a:prstGeom>
          <a:noFill/>
        </p:spPr>
        <p:txBody>
          <a:bodyPr wrap="square" rtlCol="0" anchor="ctr">
            <a:spAutoFit/>
          </a:bodyPr>
          <a:lstStyle/>
          <a:p>
            <a:pPr algn="ctr"/>
            <a:r>
              <a:rPr lang="en-US" altLang="ja-JP" sz="600" dirty="0">
                <a:solidFill>
                  <a:schemeClr val="accent1"/>
                </a:solidFill>
                <a:latin typeface="Arial"/>
                <a:cs typeface="Arial"/>
              </a:rPr>
              <a:t>Changed in</a:t>
            </a:r>
          </a:p>
          <a:p>
            <a:pPr algn="ctr"/>
            <a:r>
              <a:rPr lang="en-US" altLang="ja-JP" sz="600" dirty="0">
                <a:solidFill>
                  <a:schemeClr val="accent1"/>
                </a:solidFill>
                <a:latin typeface="Arial"/>
                <a:cs typeface="Arial"/>
              </a:rPr>
              <a:t>Col-0 with ABA</a:t>
            </a:r>
          </a:p>
          <a:p>
            <a:pPr algn="ctr"/>
            <a:r>
              <a:rPr lang="en-US" altLang="ja-JP" sz="600" dirty="0">
                <a:solidFill>
                  <a:schemeClr val="accent1"/>
                </a:solidFill>
                <a:latin typeface="Arial"/>
                <a:cs typeface="Arial"/>
              </a:rPr>
              <a:t>in GCPs</a:t>
            </a:r>
            <a:br>
              <a:rPr lang="en-US" altLang="ja-JP" sz="600" dirty="0">
                <a:solidFill>
                  <a:schemeClr val="accent1"/>
                </a:solidFill>
                <a:latin typeface="Arial"/>
                <a:cs typeface="Arial"/>
              </a:rPr>
            </a:br>
            <a:r>
              <a:rPr lang="en-US" altLang="ja-JP" sz="600" dirty="0">
                <a:solidFill>
                  <a:schemeClr val="accent1"/>
                </a:solidFill>
                <a:latin typeface="Arial"/>
                <a:cs typeface="Arial"/>
              </a:rPr>
              <a:t>(1352)</a:t>
            </a:r>
            <a:endParaRPr lang="ja-JP" altLang="en-US" sz="600" dirty="0">
              <a:solidFill>
                <a:schemeClr val="accent1"/>
              </a:solidFill>
              <a:latin typeface="Arial"/>
              <a:cs typeface="Arial"/>
            </a:endParaRPr>
          </a:p>
        </p:txBody>
      </p:sp>
      <p:sp>
        <p:nvSpPr>
          <p:cNvPr id="15" name="テキスト ボックス 14">
            <a:extLst>
              <a:ext uri="{FF2B5EF4-FFF2-40B4-BE49-F238E27FC236}">
                <a16:creationId xmlns:a16="http://schemas.microsoft.com/office/drawing/2014/main" id="{B859925F-5482-7079-A8EC-2D67864BD3A4}"/>
              </a:ext>
            </a:extLst>
          </p:cNvPr>
          <p:cNvSpPr txBox="1"/>
          <p:nvPr/>
        </p:nvSpPr>
        <p:spPr>
          <a:xfrm>
            <a:off x="3129962" y="1543632"/>
            <a:ext cx="722486" cy="184666"/>
          </a:xfrm>
          <a:prstGeom prst="rect">
            <a:avLst/>
          </a:prstGeom>
          <a:noFill/>
        </p:spPr>
        <p:txBody>
          <a:bodyPr wrap="square" rtlCol="0" anchor="ctr">
            <a:spAutoFit/>
          </a:bodyPr>
          <a:lstStyle/>
          <a:p>
            <a:pPr algn="ctr"/>
            <a:r>
              <a:rPr lang="en-US" altLang="ja-JP" sz="600" dirty="0">
                <a:latin typeface="Arial"/>
                <a:cs typeface="Arial"/>
              </a:rPr>
              <a:t>450</a:t>
            </a:r>
            <a:endParaRPr lang="ja-JP" altLang="en-US" sz="600" dirty="0">
              <a:latin typeface="Arial"/>
              <a:cs typeface="Arial"/>
            </a:endParaRPr>
          </a:p>
        </p:txBody>
      </p:sp>
      <p:sp>
        <p:nvSpPr>
          <p:cNvPr id="17" name="テキスト ボックス 16">
            <a:extLst>
              <a:ext uri="{FF2B5EF4-FFF2-40B4-BE49-F238E27FC236}">
                <a16:creationId xmlns:a16="http://schemas.microsoft.com/office/drawing/2014/main" id="{6876FBC8-D792-BBF9-8576-8C1DA2205C66}"/>
              </a:ext>
            </a:extLst>
          </p:cNvPr>
          <p:cNvSpPr txBox="1"/>
          <p:nvPr/>
        </p:nvSpPr>
        <p:spPr>
          <a:xfrm>
            <a:off x="2237070" y="2017477"/>
            <a:ext cx="722486" cy="461665"/>
          </a:xfrm>
          <a:prstGeom prst="rect">
            <a:avLst/>
          </a:prstGeom>
          <a:noFill/>
        </p:spPr>
        <p:txBody>
          <a:bodyPr wrap="square">
            <a:spAutoFit/>
          </a:bodyPr>
          <a:lstStyle/>
          <a:p>
            <a:pPr algn="ctr"/>
            <a:r>
              <a:rPr lang="en-US" altLang="ja-JP" sz="600" dirty="0">
                <a:latin typeface="Arial"/>
                <a:cs typeface="Arial"/>
              </a:rPr>
              <a:t>Changed in</a:t>
            </a:r>
          </a:p>
          <a:p>
            <a:pPr algn="ctr"/>
            <a:r>
              <a:rPr lang="en-US" altLang="ja-JP" sz="600" i="1" dirty="0">
                <a:latin typeface="Arial"/>
                <a:cs typeface="Arial"/>
              </a:rPr>
              <a:t>srk2dei</a:t>
            </a:r>
            <a:r>
              <a:rPr lang="en-US" altLang="ja-JP" sz="600" dirty="0">
                <a:latin typeface="Arial"/>
                <a:cs typeface="Arial"/>
              </a:rPr>
              <a:t>/Col-0</a:t>
            </a:r>
          </a:p>
          <a:p>
            <a:pPr algn="ctr"/>
            <a:r>
              <a:rPr lang="en-US" altLang="ja-JP" sz="600" dirty="0">
                <a:latin typeface="Arial"/>
                <a:cs typeface="Arial"/>
              </a:rPr>
              <a:t>i</a:t>
            </a:r>
            <a:r>
              <a:rPr kumimoji="1" lang="en-US" altLang="ja-JP" sz="600" dirty="0">
                <a:latin typeface="Arial"/>
                <a:cs typeface="Arial"/>
              </a:rPr>
              <a:t>n this study</a:t>
            </a:r>
          </a:p>
          <a:p>
            <a:pPr algn="ctr"/>
            <a:r>
              <a:rPr lang="en-US" altLang="ja-JP" sz="600" dirty="0">
                <a:latin typeface="Arial"/>
                <a:cs typeface="Arial"/>
              </a:rPr>
              <a:t>(1810)</a:t>
            </a:r>
            <a:endParaRPr kumimoji="1" lang="ja-JP" altLang="en-US" sz="600" dirty="0">
              <a:latin typeface="Arial"/>
              <a:cs typeface="Arial"/>
            </a:endParaRPr>
          </a:p>
        </p:txBody>
      </p:sp>
      <p:sp>
        <p:nvSpPr>
          <p:cNvPr id="18" name="テキスト ボックス 17">
            <a:extLst>
              <a:ext uri="{FF2B5EF4-FFF2-40B4-BE49-F238E27FC236}">
                <a16:creationId xmlns:a16="http://schemas.microsoft.com/office/drawing/2014/main" id="{A29A30CB-2425-C37F-9125-8C362AF6C97F}"/>
              </a:ext>
            </a:extLst>
          </p:cNvPr>
          <p:cNvSpPr txBox="1"/>
          <p:nvPr/>
        </p:nvSpPr>
        <p:spPr>
          <a:xfrm>
            <a:off x="2237070" y="3055327"/>
            <a:ext cx="722486" cy="461665"/>
          </a:xfrm>
          <a:prstGeom prst="rect">
            <a:avLst/>
          </a:prstGeom>
          <a:noFill/>
        </p:spPr>
        <p:txBody>
          <a:bodyPr wrap="square">
            <a:spAutoFit/>
          </a:bodyPr>
          <a:lstStyle/>
          <a:p>
            <a:pPr algn="ctr"/>
            <a:r>
              <a:rPr lang="en-US" altLang="ja-JP" sz="600" dirty="0">
                <a:latin typeface="Arial"/>
                <a:cs typeface="Arial"/>
              </a:rPr>
              <a:t>Changed in</a:t>
            </a:r>
          </a:p>
          <a:p>
            <a:pPr algn="ctr"/>
            <a:r>
              <a:rPr lang="en-US" altLang="ja-JP" sz="600" i="1" dirty="0">
                <a:latin typeface="Arial"/>
                <a:cs typeface="Arial"/>
              </a:rPr>
              <a:t>abi1-1C</a:t>
            </a:r>
            <a:r>
              <a:rPr lang="en-US" altLang="ja-JP" sz="600" dirty="0">
                <a:latin typeface="Arial"/>
                <a:cs typeface="Arial"/>
              </a:rPr>
              <a:t>/Col-0</a:t>
            </a:r>
          </a:p>
          <a:p>
            <a:pPr algn="ctr"/>
            <a:r>
              <a:rPr lang="en-US" altLang="ja-JP" sz="600" dirty="0">
                <a:latin typeface="Arial"/>
                <a:cs typeface="Arial"/>
              </a:rPr>
              <a:t>i</a:t>
            </a:r>
            <a:r>
              <a:rPr kumimoji="1" lang="en-US" altLang="ja-JP" sz="600" dirty="0">
                <a:latin typeface="Arial"/>
                <a:cs typeface="Arial"/>
              </a:rPr>
              <a:t>n this study</a:t>
            </a:r>
          </a:p>
          <a:p>
            <a:pPr algn="ctr"/>
            <a:r>
              <a:rPr lang="en-US" altLang="ja-JP" sz="600" dirty="0">
                <a:latin typeface="Arial"/>
                <a:cs typeface="Arial"/>
              </a:rPr>
              <a:t>(1718)</a:t>
            </a:r>
            <a:endParaRPr kumimoji="1" lang="ja-JP" altLang="en-US" sz="600" dirty="0">
              <a:latin typeface="Arial"/>
              <a:cs typeface="Arial"/>
            </a:endParaRPr>
          </a:p>
        </p:txBody>
      </p:sp>
      <p:sp>
        <p:nvSpPr>
          <p:cNvPr id="19" name="テキスト ボックス 18">
            <a:extLst>
              <a:ext uri="{FF2B5EF4-FFF2-40B4-BE49-F238E27FC236}">
                <a16:creationId xmlns:a16="http://schemas.microsoft.com/office/drawing/2014/main" id="{F9AEE212-CD85-FEBE-9EE7-1A4B9FB821E9}"/>
              </a:ext>
            </a:extLst>
          </p:cNvPr>
          <p:cNvSpPr txBox="1"/>
          <p:nvPr/>
        </p:nvSpPr>
        <p:spPr>
          <a:xfrm>
            <a:off x="3919961" y="2017477"/>
            <a:ext cx="722486" cy="461665"/>
          </a:xfrm>
          <a:prstGeom prst="rect">
            <a:avLst/>
          </a:prstGeom>
          <a:noFill/>
        </p:spPr>
        <p:txBody>
          <a:bodyPr wrap="square">
            <a:spAutoFit/>
          </a:bodyPr>
          <a:lstStyle/>
          <a:p>
            <a:pPr algn="ctr"/>
            <a:r>
              <a:rPr lang="en-US" altLang="ja-JP" sz="600" dirty="0">
                <a:solidFill>
                  <a:schemeClr val="accent1"/>
                </a:solidFill>
                <a:latin typeface="Arial"/>
                <a:cs typeface="Arial"/>
              </a:rPr>
              <a:t>Changed in</a:t>
            </a:r>
          </a:p>
          <a:p>
            <a:pPr algn="ctr"/>
            <a:r>
              <a:rPr lang="en-US" altLang="ja-JP" sz="600" i="1" dirty="0">
                <a:solidFill>
                  <a:schemeClr val="accent1"/>
                </a:solidFill>
                <a:latin typeface="Arial"/>
                <a:cs typeface="Arial"/>
              </a:rPr>
              <a:t>srk2de</a:t>
            </a:r>
            <a:r>
              <a:rPr lang="en-US" altLang="ja-JP" sz="600" dirty="0">
                <a:solidFill>
                  <a:schemeClr val="accent1"/>
                </a:solidFill>
                <a:latin typeface="Arial"/>
                <a:cs typeface="Arial"/>
              </a:rPr>
              <a:t>/Col-0</a:t>
            </a:r>
          </a:p>
          <a:p>
            <a:pPr algn="ctr"/>
            <a:r>
              <a:rPr lang="en-US" altLang="ja-JP" sz="600" dirty="0">
                <a:solidFill>
                  <a:schemeClr val="accent1"/>
                </a:solidFill>
                <a:latin typeface="Arial"/>
                <a:cs typeface="Arial"/>
              </a:rPr>
              <a:t>i</a:t>
            </a:r>
            <a:r>
              <a:rPr kumimoji="1" lang="en-US" altLang="ja-JP" sz="600" dirty="0">
                <a:solidFill>
                  <a:schemeClr val="accent1"/>
                </a:solidFill>
                <a:latin typeface="Arial"/>
                <a:cs typeface="Arial"/>
              </a:rPr>
              <a:t>n GCPs</a:t>
            </a:r>
          </a:p>
          <a:p>
            <a:pPr algn="ctr"/>
            <a:r>
              <a:rPr lang="en-US" altLang="ja-JP" sz="600" dirty="0">
                <a:solidFill>
                  <a:schemeClr val="accent1"/>
                </a:solidFill>
                <a:latin typeface="Arial"/>
                <a:cs typeface="Arial"/>
              </a:rPr>
              <a:t>(2356)</a:t>
            </a:r>
            <a:endParaRPr kumimoji="1" lang="ja-JP" altLang="en-US" sz="600" dirty="0">
              <a:solidFill>
                <a:schemeClr val="accent1"/>
              </a:solidFill>
              <a:latin typeface="Arial"/>
              <a:cs typeface="Arial"/>
            </a:endParaRPr>
          </a:p>
        </p:txBody>
      </p:sp>
      <p:sp>
        <p:nvSpPr>
          <p:cNvPr id="20" name="テキスト ボックス 19">
            <a:extLst>
              <a:ext uri="{FF2B5EF4-FFF2-40B4-BE49-F238E27FC236}">
                <a16:creationId xmlns:a16="http://schemas.microsoft.com/office/drawing/2014/main" id="{317F6E47-46E8-4398-A29A-CAA56713AB63}"/>
              </a:ext>
            </a:extLst>
          </p:cNvPr>
          <p:cNvSpPr txBox="1"/>
          <p:nvPr/>
        </p:nvSpPr>
        <p:spPr>
          <a:xfrm>
            <a:off x="3919961" y="3055327"/>
            <a:ext cx="722486" cy="461665"/>
          </a:xfrm>
          <a:prstGeom prst="rect">
            <a:avLst/>
          </a:prstGeom>
          <a:noFill/>
        </p:spPr>
        <p:txBody>
          <a:bodyPr wrap="square">
            <a:spAutoFit/>
          </a:bodyPr>
          <a:lstStyle/>
          <a:p>
            <a:pPr algn="ctr"/>
            <a:r>
              <a:rPr lang="en-US" altLang="ja-JP" sz="600" dirty="0">
                <a:solidFill>
                  <a:schemeClr val="accent1"/>
                </a:solidFill>
                <a:latin typeface="Arial"/>
                <a:cs typeface="Arial"/>
              </a:rPr>
              <a:t>Changed in</a:t>
            </a:r>
          </a:p>
          <a:p>
            <a:pPr algn="ctr"/>
            <a:r>
              <a:rPr lang="en-US" altLang="ja-JP" sz="600" i="1" dirty="0">
                <a:solidFill>
                  <a:schemeClr val="accent1"/>
                </a:solidFill>
                <a:latin typeface="Arial"/>
                <a:cs typeface="Arial"/>
              </a:rPr>
              <a:t>abi1-1C</a:t>
            </a:r>
            <a:r>
              <a:rPr lang="en-US" altLang="ja-JP" sz="600" dirty="0">
                <a:solidFill>
                  <a:schemeClr val="accent1"/>
                </a:solidFill>
                <a:latin typeface="Arial"/>
                <a:cs typeface="Arial"/>
              </a:rPr>
              <a:t>/Col-0</a:t>
            </a:r>
          </a:p>
          <a:p>
            <a:pPr algn="ctr"/>
            <a:r>
              <a:rPr lang="en-US" altLang="ja-JP" sz="600" dirty="0">
                <a:solidFill>
                  <a:schemeClr val="accent1"/>
                </a:solidFill>
                <a:latin typeface="Arial"/>
                <a:cs typeface="Arial"/>
              </a:rPr>
              <a:t>i</a:t>
            </a:r>
            <a:r>
              <a:rPr kumimoji="1" lang="en-US" altLang="ja-JP" sz="600" dirty="0">
                <a:solidFill>
                  <a:schemeClr val="accent1"/>
                </a:solidFill>
                <a:latin typeface="Arial"/>
                <a:cs typeface="Arial"/>
              </a:rPr>
              <a:t>n GCPs</a:t>
            </a:r>
          </a:p>
          <a:p>
            <a:pPr algn="ctr"/>
            <a:r>
              <a:rPr lang="en-US" altLang="ja-JP" sz="600" dirty="0">
                <a:solidFill>
                  <a:schemeClr val="accent1"/>
                </a:solidFill>
                <a:latin typeface="Arial"/>
                <a:cs typeface="Arial"/>
              </a:rPr>
              <a:t>(1119)</a:t>
            </a:r>
            <a:endParaRPr kumimoji="1" lang="ja-JP" altLang="en-US" sz="600" dirty="0">
              <a:solidFill>
                <a:schemeClr val="accent1"/>
              </a:solidFill>
              <a:latin typeface="Arial"/>
              <a:cs typeface="Arial"/>
            </a:endParaRPr>
          </a:p>
        </p:txBody>
      </p:sp>
      <p:sp>
        <p:nvSpPr>
          <p:cNvPr id="21" name="テキスト ボックス 20">
            <a:extLst>
              <a:ext uri="{FF2B5EF4-FFF2-40B4-BE49-F238E27FC236}">
                <a16:creationId xmlns:a16="http://schemas.microsoft.com/office/drawing/2014/main" id="{B4AB3C46-8D97-841D-4C23-EC7CCCC41962}"/>
              </a:ext>
            </a:extLst>
          </p:cNvPr>
          <p:cNvSpPr txBox="1"/>
          <p:nvPr/>
        </p:nvSpPr>
        <p:spPr>
          <a:xfrm>
            <a:off x="3129962" y="2597739"/>
            <a:ext cx="722486" cy="184666"/>
          </a:xfrm>
          <a:prstGeom prst="rect">
            <a:avLst/>
          </a:prstGeom>
          <a:noFill/>
        </p:spPr>
        <p:txBody>
          <a:bodyPr wrap="square" rtlCol="0" anchor="ctr">
            <a:spAutoFit/>
          </a:bodyPr>
          <a:lstStyle/>
          <a:p>
            <a:pPr algn="ctr"/>
            <a:r>
              <a:rPr lang="en-US" altLang="ja-JP" sz="600" dirty="0">
                <a:latin typeface="Arial"/>
                <a:cs typeface="Arial"/>
              </a:rPr>
              <a:t>934</a:t>
            </a:r>
            <a:endParaRPr lang="ja-JP" altLang="en-US" sz="600" dirty="0">
              <a:latin typeface="Arial"/>
              <a:cs typeface="Arial"/>
            </a:endParaRPr>
          </a:p>
        </p:txBody>
      </p:sp>
      <p:grpSp>
        <p:nvGrpSpPr>
          <p:cNvPr id="22" name="グループ化 21">
            <a:extLst>
              <a:ext uri="{FF2B5EF4-FFF2-40B4-BE49-F238E27FC236}">
                <a16:creationId xmlns:a16="http://schemas.microsoft.com/office/drawing/2014/main" id="{4213BCA9-8B70-B53E-7A93-C92DF0378A0A}"/>
              </a:ext>
            </a:extLst>
          </p:cNvPr>
          <p:cNvGrpSpPr/>
          <p:nvPr/>
        </p:nvGrpSpPr>
        <p:grpSpPr>
          <a:xfrm>
            <a:off x="2805581" y="4397351"/>
            <a:ext cx="1357200" cy="900000"/>
            <a:chOff x="2521800" y="4238399"/>
            <a:chExt cx="1357200" cy="900000"/>
          </a:xfrm>
        </p:grpSpPr>
        <p:sp>
          <p:nvSpPr>
            <p:cNvPr id="23" name="楕円 22">
              <a:extLst>
                <a:ext uri="{FF2B5EF4-FFF2-40B4-BE49-F238E27FC236}">
                  <a16:creationId xmlns:a16="http://schemas.microsoft.com/office/drawing/2014/main" id="{C72CE67B-F4F0-8198-2786-C5EC8B6DE4F5}"/>
                </a:ext>
              </a:extLst>
            </p:cNvPr>
            <p:cNvSpPr/>
            <p:nvPr/>
          </p:nvSpPr>
          <p:spPr>
            <a:xfrm>
              <a:off x="2521800" y="4238399"/>
              <a:ext cx="900000" cy="900000"/>
            </a:xfrm>
            <a:prstGeom prst="ellipse">
              <a:avLst/>
            </a:prstGeom>
            <a:noFill/>
            <a:ln w="190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24" name="楕円 23">
              <a:extLst>
                <a:ext uri="{FF2B5EF4-FFF2-40B4-BE49-F238E27FC236}">
                  <a16:creationId xmlns:a16="http://schemas.microsoft.com/office/drawing/2014/main" id="{321A1B9E-4968-1703-30A7-97E4F2C8AA3D}"/>
                </a:ext>
              </a:extLst>
            </p:cNvPr>
            <p:cNvSpPr/>
            <p:nvPr/>
          </p:nvSpPr>
          <p:spPr>
            <a:xfrm>
              <a:off x="2979000" y="4238399"/>
              <a:ext cx="900000" cy="900000"/>
            </a:xfrm>
            <a:prstGeom prst="ellipse">
              <a:avLst/>
            </a:prstGeom>
            <a:noFill/>
            <a:ln w="19050" cmpd="sng">
              <a:solidFill>
                <a:srgbClr val="0070C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grpSp>
      <p:sp>
        <p:nvSpPr>
          <p:cNvPr id="25" name="テキスト ボックス 24">
            <a:extLst>
              <a:ext uri="{FF2B5EF4-FFF2-40B4-BE49-F238E27FC236}">
                <a16:creationId xmlns:a16="http://schemas.microsoft.com/office/drawing/2014/main" id="{9EC7CFA7-C8F3-8708-622A-F25AC3BC7789}"/>
              </a:ext>
            </a:extLst>
          </p:cNvPr>
          <p:cNvSpPr txBox="1"/>
          <p:nvPr/>
        </p:nvSpPr>
        <p:spPr>
          <a:xfrm>
            <a:off x="2173045" y="4160206"/>
            <a:ext cx="850537" cy="461665"/>
          </a:xfrm>
          <a:prstGeom prst="rect">
            <a:avLst/>
          </a:prstGeom>
          <a:noFill/>
        </p:spPr>
        <p:txBody>
          <a:bodyPr wrap="square">
            <a:spAutoFit/>
          </a:bodyPr>
          <a:lstStyle/>
          <a:p>
            <a:pPr algn="ctr"/>
            <a:r>
              <a:rPr lang="en-US" altLang="ja-JP" sz="600" dirty="0">
                <a:latin typeface="Arial"/>
                <a:cs typeface="Arial"/>
              </a:rPr>
              <a:t>Putative</a:t>
            </a:r>
            <a:r>
              <a:rPr kumimoji="1" lang="en-US" altLang="ja-JP" sz="600" dirty="0">
                <a:latin typeface="Arial"/>
                <a:cs typeface="Arial"/>
              </a:rPr>
              <a:t> SnRK2 substrates</a:t>
            </a:r>
          </a:p>
          <a:p>
            <a:pPr algn="ctr"/>
            <a:r>
              <a:rPr lang="en-US" altLang="ja-JP" sz="600" dirty="0">
                <a:latin typeface="Arial"/>
                <a:cs typeface="Arial"/>
              </a:rPr>
              <a:t>in this study</a:t>
            </a:r>
          </a:p>
          <a:p>
            <a:pPr algn="ctr"/>
            <a:r>
              <a:rPr kumimoji="1" lang="en-US" altLang="ja-JP" sz="600" dirty="0">
                <a:latin typeface="Arial"/>
                <a:cs typeface="Arial"/>
              </a:rPr>
              <a:t>(442)</a:t>
            </a:r>
            <a:endParaRPr kumimoji="1" lang="ja-JP" altLang="en-US" sz="600" dirty="0">
              <a:latin typeface="Arial"/>
              <a:cs typeface="Arial"/>
            </a:endParaRPr>
          </a:p>
        </p:txBody>
      </p:sp>
      <p:sp>
        <p:nvSpPr>
          <p:cNvPr id="27" name="テキスト ボックス 26">
            <a:extLst>
              <a:ext uri="{FF2B5EF4-FFF2-40B4-BE49-F238E27FC236}">
                <a16:creationId xmlns:a16="http://schemas.microsoft.com/office/drawing/2014/main" id="{04CC936D-6ACF-EBF9-5CA1-FDF42B57CDAB}"/>
              </a:ext>
            </a:extLst>
          </p:cNvPr>
          <p:cNvSpPr txBox="1"/>
          <p:nvPr/>
        </p:nvSpPr>
        <p:spPr>
          <a:xfrm>
            <a:off x="3855936" y="4160206"/>
            <a:ext cx="850537" cy="461665"/>
          </a:xfrm>
          <a:prstGeom prst="rect">
            <a:avLst/>
          </a:prstGeom>
          <a:noFill/>
        </p:spPr>
        <p:txBody>
          <a:bodyPr wrap="square">
            <a:spAutoFit/>
          </a:bodyPr>
          <a:lstStyle/>
          <a:p>
            <a:pPr algn="ctr"/>
            <a:r>
              <a:rPr lang="en-US" altLang="ja-JP" sz="600" dirty="0">
                <a:solidFill>
                  <a:schemeClr val="accent1"/>
                </a:solidFill>
                <a:latin typeface="Arial"/>
                <a:cs typeface="Arial"/>
              </a:rPr>
              <a:t>Putative</a:t>
            </a:r>
            <a:r>
              <a:rPr kumimoji="1" lang="en-US" altLang="ja-JP" sz="600" dirty="0">
                <a:solidFill>
                  <a:schemeClr val="accent1"/>
                </a:solidFill>
                <a:latin typeface="Arial"/>
                <a:cs typeface="Arial"/>
              </a:rPr>
              <a:t> SnRK2 substrates</a:t>
            </a:r>
          </a:p>
          <a:p>
            <a:pPr algn="ctr"/>
            <a:r>
              <a:rPr lang="en-US" altLang="ja-JP" sz="600" dirty="0">
                <a:solidFill>
                  <a:schemeClr val="accent1"/>
                </a:solidFill>
                <a:latin typeface="Arial"/>
                <a:cs typeface="Arial"/>
              </a:rPr>
              <a:t>in GCPs</a:t>
            </a:r>
          </a:p>
          <a:p>
            <a:pPr algn="ctr"/>
            <a:r>
              <a:rPr kumimoji="1" lang="en-US" altLang="ja-JP" sz="600" dirty="0">
                <a:solidFill>
                  <a:schemeClr val="accent1"/>
                </a:solidFill>
                <a:latin typeface="Arial"/>
                <a:cs typeface="Arial"/>
              </a:rPr>
              <a:t>(715)</a:t>
            </a:r>
            <a:endParaRPr kumimoji="1" lang="ja-JP" altLang="en-US" sz="600" dirty="0">
              <a:solidFill>
                <a:schemeClr val="accent1"/>
              </a:solidFill>
              <a:latin typeface="Arial"/>
              <a:cs typeface="Arial"/>
            </a:endParaRPr>
          </a:p>
        </p:txBody>
      </p:sp>
      <p:sp>
        <p:nvSpPr>
          <p:cNvPr id="28" name="テキスト ボックス 27">
            <a:extLst>
              <a:ext uri="{FF2B5EF4-FFF2-40B4-BE49-F238E27FC236}">
                <a16:creationId xmlns:a16="http://schemas.microsoft.com/office/drawing/2014/main" id="{961C6800-E3BE-32F9-86B6-43F87762991D}"/>
              </a:ext>
            </a:extLst>
          </p:cNvPr>
          <p:cNvSpPr txBox="1"/>
          <p:nvPr/>
        </p:nvSpPr>
        <p:spPr>
          <a:xfrm>
            <a:off x="3129962" y="3668205"/>
            <a:ext cx="722486" cy="184666"/>
          </a:xfrm>
          <a:prstGeom prst="rect">
            <a:avLst/>
          </a:prstGeom>
          <a:noFill/>
        </p:spPr>
        <p:txBody>
          <a:bodyPr wrap="square" rtlCol="0" anchor="ctr">
            <a:spAutoFit/>
          </a:bodyPr>
          <a:lstStyle/>
          <a:p>
            <a:pPr algn="ctr"/>
            <a:r>
              <a:rPr lang="en-US" altLang="ja-JP" sz="600" dirty="0">
                <a:latin typeface="Arial"/>
                <a:cs typeface="Arial"/>
              </a:rPr>
              <a:t>838</a:t>
            </a:r>
            <a:endParaRPr lang="ja-JP" altLang="en-US" sz="600" dirty="0">
              <a:latin typeface="Arial"/>
              <a:cs typeface="Arial"/>
            </a:endParaRPr>
          </a:p>
        </p:txBody>
      </p:sp>
      <p:sp>
        <p:nvSpPr>
          <p:cNvPr id="29" name="テキスト ボックス 28">
            <a:extLst>
              <a:ext uri="{FF2B5EF4-FFF2-40B4-BE49-F238E27FC236}">
                <a16:creationId xmlns:a16="http://schemas.microsoft.com/office/drawing/2014/main" id="{512D52DE-5D2E-A4CD-3A57-C70399D31C46}"/>
              </a:ext>
            </a:extLst>
          </p:cNvPr>
          <p:cNvSpPr txBox="1"/>
          <p:nvPr/>
        </p:nvSpPr>
        <p:spPr>
          <a:xfrm>
            <a:off x="3129962" y="4763940"/>
            <a:ext cx="722486" cy="184666"/>
          </a:xfrm>
          <a:prstGeom prst="rect">
            <a:avLst/>
          </a:prstGeom>
          <a:noFill/>
        </p:spPr>
        <p:txBody>
          <a:bodyPr wrap="square" rtlCol="0" anchor="ctr">
            <a:spAutoFit/>
          </a:bodyPr>
          <a:lstStyle/>
          <a:p>
            <a:pPr algn="ctr"/>
            <a:r>
              <a:rPr lang="en-US" altLang="ja-JP" sz="600" dirty="0">
                <a:latin typeface="Arial"/>
                <a:cs typeface="Arial"/>
              </a:rPr>
              <a:t>121</a:t>
            </a:r>
            <a:endParaRPr lang="ja-JP" altLang="en-US" sz="600" dirty="0">
              <a:latin typeface="Arial"/>
              <a:cs typeface="Arial"/>
            </a:endParaRPr>
          </a:p>
        </p:txBody>
      </p:sp>
      <p:sp>
        <p:nvSpPr>
          <p:cNvPr id="30" name="テキスト ボックス 29">
            <a:extLst>
              <a:ext uri="{FF2B5EF4-FFF2-40B4-BE49-F238E27FC236}">
                <a16:creationId xmlns:a16="http://schemas.microsoft.com/office/drawing/2014/main" id="{6FA04096-DC92-1A60-A3C6-1BE94FC5053D}"/>
              </a:ext>
            </a:extLst>
          </p:cNvPr>
          <p:cNvSpPr txBox="1"/>
          <p:nvPr/>
        </p:nvSpPr>
        <p:spPr>
          <a:xfrm>
            <a:off x="2713088" y="1543632"/>
            <a:ext cx="722486" cy="184666"/>
          </a:xfrm>
          <a:prstGeom prst="rect">
            <a:avLst/>
          </a:prstGeom>
          <a:noFill/>
        </p:spPr>
        <p:txBody>
          <a:bodyPr wrap="square" rtlCol="0" anchor="ctr">
            <a:spAutoFit/>
          </a:bodyPr>
          <a:lstStyle/>
          <a:p>
            <a:pPr algn="ctr"/>
            <a:r>
              <a:rPr lang="en-US" altLang="ja-JP" sz="600" dirty="0">
                <a:latin typeface="Arial"/>
                <a:cs typeface="Arial"/>
              </a:rPr>
              <a:t>685</a:t>
            </a:r>
            <a:endParaRPr lang="ja-JP" altLang="en-US" sz="600" dirty="0">
              <a:latin typeface="Arial"/>
              <a:cs typeface="Arial"/>
            </a:endParaRPr>
          </a:p>
        </p:txBody>
      </p:sp>
      <p:sp>
        <p:nvSpPr>
          <p:cNvPr id="31" name="テキスト ボックス 30">
            <a:extLst>
              <a:ext uri="{FF2B5EF4-FFF2-40B4-BE49-F238E27FC236}">
                <a16:creationId xmlns:a16="http://schemas.microsoft.com/office/drawing/2014/main" id="{CD0EE556-5850-24A6-0C28-19B9D730E029}"/>
              </a:ext>
            </a:extLst>
          </p:cNvPr>
          <p:cNvSpPr txBox="1"/>
          <p:nvPr/>
        </p:nvSpPr>
        <p:spPr>
          <a:xfrm>
            <a:off x="3523149" y="1543632"/>
            <a:ext cx="722486" cy="184666"/>
          </a:xfrm>
          <a:prstGeom prst="rect">
            <a:avLst/>
          </a:prstGeom>
          <a:noFill/>
        </p:spPr>
        <p:txBody>
          <a:bodyPr wrap="square" rtlCol="0" anchor="ctr">
            <a:spAutoFit/>
          </a:bodyPr>
          <a:lstStyle/>
          <a:p>
            <a:pPr algn="ctr"/>
            <a:r>
              <a:rPr lang="en-US" altLang="ja-JP" sz="600" dirty="0">
                <a:latin typeface="Arial"/>
                <a:cs typeface="Arial"/>
              </a:rPr>
              <a:t>902</a:t>
            </a:r>
            <a:endParaRPr lang="ja-JP" altLang="en-US" sz="600" dirty="0">
              <a:latin typeface="Arial"/>
              <a:cs typeface="Arial"/>
            </a:endParaRPr>
          </a:p>
        </p:txBody>
      </p:sp>
      <p:sp>
        <p:nvSpPr>
          <p:cNvPr id="32" name="テキスト ボックス 31">
            <a:extLst>
              <a:ext uri="{FF2B5EF4-FFF2-40B4-BE49-F238E27FC236}">
                <a16:creationId xmlns:a16="http://schemas.microsoft.com/office/drawing/2014/main" id="{8FA02A56-C712-CF48-4A60-A2BDAC1D81C8}"/>
              </a:ext>
            </a:extLst>
          </p:cNvPr>
          <p:cNvSpPr txBox="1"/>
          <p:nvPr/>
        </p:nvSpPr>
        <p:spPr>
          <a:xfrm>
            <a:off x="2713088" y="2597739"/>
            <a:ext cx="722486" cy="184666"/>
          </a:xfrm>
          <a:prstGeom prst="rect">
            <a:avLst/>
          </a:prstGeom>
          <a:noFill/>
        </p:spPr>
        <p:txBody>
          <a:bodyPr wrap="square" rtlCol="0" anchor="ctr">
            <a:spAutoFit/>
          </a:bodyPr>
          <a:lstStyle/>
          <a:p>
            <a:pPr algn="ctr"/>
            <a:r>
              <a:rPr lang="en-US" altLang="ja-JP" sz="600" dirty="0">
                <a:latin typeface="Arial"/>
                <a:cs typeface="Arial"/>
              </a:rPr>
              <a:t>876</a:t>
            </a:r>
            <a:endParaRPr lang="ja-JP" altLang="en-US" sz="600" dirty="0">
              <a:latin typeface="Arial"/>
              <a:cs typeface="Arial"/>
            </a:endParaRPr>
          </a:p>
        </p:txBody>
      </p:sp>
      <p:sp>
        <p:nvSpPr>
          <p:cNvPr id="33" name="テキスト ボックス 32">
            <a:extLst>
              <a:ext uri="{FF2B5EF4-FFF2-40B4-BE49-F238E27FC236}">
                <a16:creationId xmlns:a16="http://schemas.microsoft.com/office/drawing/2014/main" id="{3CA7EF6B-711D-358A-16F2-CDE12BE6E7D1}"/>
              </a:ext>
            </a:extLst>
          </p:cNvPr>
          <p:cNvSpPr txBox="1"/>
          <p:nvPr/>
        </p:nvSpPr>
        <p:spPr>
          <a:xfrm>
            <a:off x="3523149" y="2597739"/>
            <a:ext cx="722486" cy="184666"/>
          </a:xfrm>
          <a:prstGeom prst="rect">
            <a:avLst/>
          </a:prstGeom>
          <a:noFill/>
        </p:spPr>
        <p:txBody>
          <a:bodyPr wrap="square" rtlCol="0" anchor="ctr">
            <a:spAutoFit/>
          </a:bodyPr>
          <a:lstStyle/>
          <a:p>
            <a:pPr algn="ctr"/>
            <a:r>
              <a:rPr lang="en-US" altLang="ja-JP" sz="600" dirty="0">
                <a:latin typeface="Arial"/>
                <a:cs typeface="Arial"/>
              </a:rPr>
              <a:t>1422</a:t>
            </a:r>
            <a:endParaRPr lang="ja-JP" altLang="en-US" sz="600" dirty="0">
              <a:latin typeface="Arial"/>
              <a:cs typeface="Arial"/>
            </a:endParaRPr>
          </a:p>
        </p:txBody>
      </p:sp>
      <p:sp>
        <p:nvSpPr>
          <p:cNvPr id="34" name="テキスト ボックス 33">
            <a:extLst>
              <a:ext uri="{FF2B5EF4-FFF2-40B4-BE49-F238E27FC236}">
                <a16:creationId xmlns:a16="http://schemas.microsoft.com/office/drawing/2014/main" id="{DFB35216-3CBA-BE99-F0FF-5699066AC2F5}"/>
              </a:ext>
            </a:extLst>
          </p:cNvPr>
          <p:cNvSpPr txBox="1"/>
          <p:nvPr/>
        </p:nvSpPr>
        <p:spPr>
          <a:xfrm>
            <a:off x="2713088" y="3668205"/>
            <a:ext cx="722486" cy="184666"/>
          </a:xfrm>
          <a:prstGeom prst="rect">
            <a:avLst/>
          </a:prstGeom>
          <a:noFill/>
        </p:spPr>
        <p:txBody>
          <a:bodyPr wrap="square" rtlCol="0" anchor="ctr">
            <a:spAutoFit/>
          </a:bodyPr>
          <a:lstStyle/>
          <a:p>
            <a:pPr algn="ctr"/>
            <a:r>
              <a:rPr lang="en-US" altLang="ja-JP" sz="600" dirty="0">
                <a:latin typeface="Arial"/>
                <a:cs typeface="Arial"/>
              </a:rPr>
              <a:t>880</a:t>
            </a:r>
            <a:endParaRPr lang="ja-JP" altLang="en-US" sz="600" dirty="0">
              <a:latin typeface="Arial"/>
              <a:cs typeface="Arial"/>
            </a:endParaRPr>
          </a:p>
        </p:txBody>
      </p:sp>
      <p:sp>
        <p:nvSpPr>
          <p:cNvPr id="35" name="テキスト ボックス 34">
            <a:extLst>
              <a:ext uri="{FF2B5EF4-FFF2-40B4-BE49-F238E27FC236}">
                <a16:creationId xmlns:a16="http://schemas.microsoft.com/office/drawing/2014/main" id="{89D3E4C4-188F-1D8F-606D-BC37B962A187}"/>
              </a:ext>
            </a:extLst>
          </p:cNvPr>
          <p:cNvSpPr txBox="1"/>
          <p:nvPr/>
        </p:nvSpPr>
        <p:spPr>
          <a:xfrm>
            <a:off x="3523149" y="3668205"/>
            <a:ext cx="722486" cy="184666"/>
          </a:xfrm>
          <a:prstGeom prst="rect">
            <a:avLst/>
          </a:prstGeom>
          <a:noFill/>
        </p:spPr>
        <p:txBody>
          <a:bodyPr wrap="square" rtlCol="0" anchor="ctr">
            <a:spAutoFit/>
          </a:bodyPr>
          <a:lstStyle/>
          <a:p>
            <a:pPr algn="ctr"/>
            <a:r>
              <a:rPr lang="en-US" altLang="ja-JP" sz="600" dirty="0">
                <a:latin typeface="Arial"/>
                <a:cs typeface="Arial"/>
              </a:rPr>
              <a:t>450</a:t>
            </a:r>
            <a:endParaRPr lang="ja-JP" altLang="en-US" sz="600" dirty="0">
              <a:latin typeface="Arial"/>
              <a:cs typeface="Arial"/>
            </a:endParaRPr>
          </a:p>
        </p:txBody>
      </p:sp>
      <p:sp>
        <p:nvSpPr>
          <p:cNvPr id="36" name="テキスト ボックス 35">
            <a:extLst>
              <a:ext uri="{FF2B5EF4-FFF2-40B4-BE49-F238E27FC236}">
                <a16:creationId xmlns:a16="http://schemas.microsoft.com/office/drawing/2014/main" id="{6BFE5FDF-7671-06BB-8AA4-37294F86A7B3}"/>
              </a:ext>
            </a:extLst>
          </p:cNvPr>
          <p:cNvSpPr txBox="1"/>
          <p:nvPr/>
        </p:nvSpPr>
        <p:spPr>
          <a:xfrm>
            <a:off x="2713088" y="4763940"/>
            <a:ext cx="722486" cy="184666"/>
          </a:xfrm>
          <a:prstGeom prst="rect">
            <a:avLst/>
          </a:prstGeom>
          <a:noFill/>
        </p:spPr>
        <p:txBody>
          <a:bodyPr wrap="square" rtlCol="0" anchor="ctr">
            <a:spAutoFit/>
          </a:bodyPr>
          <a:lstStyle/>
          <a:p>
            <a:pPr algn="ctr"/>
            <a:r>
              <a:rPr lang="en-US" altLang="ja-JP" sz="600" dirty="0">
                <a:latin typeface="Arial"/>
                <a:cs typeface="Arial"/>
              </a:rPr>
              <a:t>321</a:t>
            </a:r>
            <a:endParaRPr lang="ja-JP" altLang="en-US" sz="600" dirty="0">
              <a:latin typeface="Arial"/>
              <a:cs typeface="Arial"/>
            </a:endParaRPr>
          </a:p>
        </p:txBody>
      </p:sp>
      <p:sp>
        <p:nvSpPr>
          <p:cNvPr id="37" name="テキスト ボックス 36">
            <a:extLst>
              <a:ext uri="{FF2B5EF4-FFF2-40B4-BE49-F238E27FC236}">
                <a16:creationId xmlns:a16="http://schemas.microsoft.com/office/drawing/2014/main" id="{7690C9DB-B9C6-18F5-B5C9-9C7EFBCA4FAE}"/>
              </a:ext>
            </a:extLst>
          </p:cNvPr>
          <p:cNvSpPr txBox="1"/>
          <p:nvPr/>
        </p:nvSpPr>
        <p:spPr>
          <a:xfrm>
            <a:off x="3523149" y="4763940"/>
            <a:ext cx="722486" cy="184666"/>
          </a:xfrm>
          <a:prstGeom prst="rect">
            <a:avLst/>
          </a:prstGeom>
          <a:noFill/>
        </p:spPr>
        <p:txBody>
          <a:bodyPr wrap="square" rtlCol="0" anchor="ctr">
            <a:spAutoFit/>
          </a:bodyPr>
          <a:lstStyle/>
          <a:p>
            <a:pPr algn="ctr"/>
            <a:r>
              <a:rPr lang="en-US" altLang="ja-JP" sz="600" dirty="0">
                <a:latin typeface="Arial"/>
                <a:cs typeface="Arial"/>
              </a:rPr>
              <a:t>265</a:t>
            </a:r>
            <a:endParaRPr lang="ja-JP" altLang="en-US" sz="600" dirty="0">
              <a:latin typeface="Arial"/>
              <a:cs typeface="Arial"/>
            </a:endParaRPr>
          </a:p>
        </p:txBody>
      </p:sp>
      <p:sp>
        <p:nvSpPr>
          <p:cNvPr id="39" name="テキスト ボックス 38">
            <a:extLst>
              <a:ext uri="{FF2B5EF4-FFF2-40B4-BE49-F238E27FC236}">
                <a16:creationId xmlns:a16="http://schemas.microsoft.com/office/drawing/2014/main" id="{67B56430-D4BE-565B-481F-5017F5431A82}"/>
              </a:ext>
            </a:extLst>
          </p:cNvPr>
          <p:cNvSpPr txBox="1"/>
          <p:nvPr/>
        </p:nvSpPr>
        <p:spPr>
          <a:xfrm>
            <a:off x="2038232" y="874047"/>
            <a:ext cx="269626" cy="246221"/>
          </a:xfrm>
          <a:prstGeom prst="rect">
            <a:avLst/>
          </a:prstGeom>
          <a:noFill/>
        </p:spPr>
        <p:txBody>
          <a:bodyPr wrap="none" rtlCol="0">
            <a:spAutoFit/>
          </a:bodyPr>
          <a:lstStyle/>
          <a:p>
            <a:r>
              <a:rPr kumimoji="1" lang="en-US" altLang="ja-JP" sz="1000" dirty="0">
                <a:latin typeface="Arial"/>
                <a:cs typeface="Arial"/>
              </a:rPr>
              <a:t>A</a:t>
            </a:r>
            <a:endParaRPr kumimoji="1" lang="ja-JP" altLang="en-US" sz="1000" dirty="0">
              <a:latin typeface="Arial"/>
              <a:cs typeface="Arial"/>
            </a:endParaRPr>
          </a:p>
        </p:txBody>
      </p:sp>
      <p:sp>
        <p:nvSpPr>
          <p:cNvPr id="41" name="テキスト ボックス 40">
            <a:extLst>
              <a:ext uri="{FF2B5EF4-FFF2-40B4-BE49-F238E27FC236}">
                <a16:creationId xmlns:a16="http://schemas.microsoft.com/office/drawing/2014/main" id="{0BCD9898-861C-6620-8ED7-D009CBAEC2A6}"/>
              </a:ext>
            </a:extLst>
          </p:cNvPr>
          <p:cNvSpPr txBox="1"/>
          <p:nvPr/>
        </p:nvSpPr>
        <p:spPr>
          <a:xfrm>
            <a:off x="763754" y="5607890"/>
            <a:ext cx="5400000" cy="1169551"/>
          </a:xfrm>
          <a:prstGeom prst="rect">
            <a:avLst/>
          </a:prstGeom>
          <a:noFill/>
        </p:spPr>
        <p:txBody>
          <a:bodyPr wrap="square">
            <a:spAutoFit/>
          </a:bodyPr>
          <a:lstStyle/>
          <a:p>
            <a:pPr algn="just"/>
            <a:r>
              <a:rPr lang="en-US" altLang="ja-JP" sz="1000" b="1" dirty="0">
                <a:latin typeface="Arial" panose="020B0604020202020204" pitchFamily="34" charset="0"/>
                <a:cs typeface="Arial" panose="020B0604020202020204" pitchFamily="34" charset="0"/>
              </a:rPr>
              <a:t>Supplementary Figure S3. </a:t>
            </a:r>
            <a:r>
              <a:rPr lang="en" altLang="ja-JP" sz="1000" b="1" dirty="0">
                <a:latin typeface="Arial" panose="020B0604020202020204" pitchFamily="34" charset="0"/>
                <a:cs typeface="Arial" panose="020B0604020202020204" pitchFamily="34" charset="0"/>
              </a:rPr>
              <a:t>Venn diagram showing the overlap </a:t>
            </a:r>
            <a:r>
              <a:rPr lang="en-US" altLang="ja-JP" sz="1000" b="1" dirty="0">
                <a:latin typeface="Arial" panose="020B0604020202020204" pitchFamily="34" charset="0"/>
                <a:cs typeface="Arial" panose="020B0604020202020204" pitchFamily="34" charset="0"/>
              </a:rPr>
              <a:t>between phosphoproteins identified in this study and those reported in the previous guard cell protoplast study. </a:t>
            </a:r>
            <a:r>
              <a:rPr lang="en-US" altLang="ja-JP" sz="1000" dirty="0">
                <a:latin typeface="Arial" panose="020B0604020202020204" pitchFamily="34" charset="0"/>
                <a:cs typeface="Arial" panose="020B0604020202020204" pitchFamily="34" charset="0"/>
              </a:rPr>
              <a:t>(</a:t>
            </a:r>
            <a:r>
              <a:rPr lang="en-US" altLang="ja-JP" sz="1000" b="1" dirty="0">
                <a:latin typeface="Arial" panose="020B0604020202020204" pitchFamily="34" charset="0"/>
                <a:cs typeface="Arial" panose="020B0604020202020204" pitchFamily="34" charset="0"/>
              </a:rPr>
              <a:t>A</a:t>
            </a:r>
            <a:r>
              <a:rPr lang="en-US" altLang="ja-JP" sz="1000" dirty="0">
                <a:latin typeface="Arial" panose="020B0604020202020204" pitchFamily="34" charset="0"/>
                <a:cs typeface="Arial" panose="020B0604020202020204" pitchFamily="34" charset="0"/>
              </a:rPr>
              <a:t>-</a:t>
            </a:r>
            <a:r>
              <a:rPr lang="en-US" altLang="ja-JP" sz="1000" b="1" dirty="0">
                <a:latin typeface="Arial" panose="020B0604020202020204" pitchFamily="34" charset="0"/>
                <a:cs typeface="Arial" panose="020B0604020202020204" pitchFamily="34" charset="0"/>
              </a:rPr>
              <a:t>C</a:t>
            </a:r>
            <a:r>
              <a:rPr lang="en-US" altLang="ja-JP" sz="1000" dirty="0">
                <a:latin typeface="Arial" panose="020B0604020202020204" pitchFamily="34" charset="0"/>
                <a:cs typeface="Arial" panose="020B0604020202020204" pitchFamily="34" charset="0"/>
              </a:rPr>
              <a:t>) Significantly (</a:t>
            </a:r>
            <a:r>
              <a:rPr lang="en-US" altLang="ja-JP" sz="1000" i="1" dirty="0">
                <a:latin typeface="Arial" panose="020B0604020202020204" pitchFamily="34" charset="0"/>
                <a:cs typeface="Arial" panose="020B0604020202020204" pitchFamily="34" charset="0"/>
              </a:rPr>
              <a:t>P</a:t>
            </a:r>
            <a:r>
              <a:rPr lang="en-US" altLang="ja-JP" sz="1000" dirty="0">
                <a:latin typeface="Arial" panose="020B0604020202020204" pitchFamily="34" charset="0"/>
                <a:cs typeface="Arial" panose="020B0604020202020204" pitchFamily="34" charset="0"/>
              </a:rPr>
              <a:t> &lt; 0.05) up-regulated more than 2-fold or down-regulated less than ½-fold changes in (A) Col-0 with/without ABA ratio (Named “ABA-Changed”), (B) </a:t>
            </a:r>
            <a:r>
              <a:rPr lang="en-US" altLang="ja-JP" sz="1000" i="1" dirty="0">
                <a:latin typeface="Arial" panose="020B0604020202020204" pitchFamily="34" charset="0"/>
                <a:cs typeface="Arial" panose="020B0604020202020204" pitchFamily="34" charset="0"/>
              </a:rPr>
              <a:t>srk2dei</a:t>
            </a:r>
            <a:r>
              <a:rPr lang="en-US" altLang="ja-JP" sz="1000" dirty="0">
                <a:latin typeface="Arial" panose="020B0604020202020204" pitchFamily="34" charset="0"/>
                <a:cs typeface="Arial" panose="020B0604020202020204" pitchFamily="34" charset="0"/>
              </a:rPr>
              <a:t> or </a:t>
            </a:r>
            <a:r>
              <a:rPr lang="en-US" altLang="ja-JP" sz="1000" i="1" dirty="0">
                <a:latin typeface="Arial" panose="020B0604020202020204" pitchFamily="34" charset="0"/>
                <a:cs typeface="Arial" panose="020B0604020202020204" pitchFamily="34" charset="0"/>
              </a:rPr>
              <a:t>srk2de</a:t>
            </a:r>
            <a:r>
              <a:rPr lang="en-US" altLang="ja-JP" sz="1000" dirty="0">
                <a:latin typeface="Arial" panose="020B0604020202020204" pitchFamily="34" charset="0"/>
                <a:cs typeface="Arial" panose="020B0604020202020204" pitchFamily="34" charset="0"/>
              </a:rPr>
              <a:t>/Col-0 ratio, (C) </a:t>
            </a:r>
            <a:r>
              <a:rPr lang="en-US" altLang="ja-JP" sz="1000" i="1" dirty="0">
                <a:latin typeface="Arial" panose="020B0604020202020204" pitchFamily="34" charset="0"/>
                <a:cs typeface="Arial" panose="020B0604020202020204" pitchFamily="34" charset="0"/>
              </a:rPr>
              <a:t>abi1-1C</a:t>
            </a:r>
            <a:r>
              <a:rPr lang="en-US" altLang="ja-JP" sz="1000" dirty="0">
                <a:latin typeface="Arial" panose="020B0604020202020204" pitchFamily="34" charset="0"/>
                <a:cs typeface="Arial" panose="020B0604020202020204" pitchFamily="34" charset="0"/>
              </a:rPr>
              <a:t>/Col-0 ratio.</a:t>
            </a:r>
            <a:r>
              <a:rPr lang="ja-JP" altLang="en-US" sz="1000" dirty="0">
                <a:latin typeface="Arial" panose="020B0604020202020204" pitchFamily="34" charset="0"/>
                <a:cs typeface="Arial" panose="020B0604020202020204" pitchFamily="34" charset="0"/>
              </a:rPr>
              <a:t> </a:t>
            </a:r>
            <a:r>
              <a:rPr lang="en-US" altLang="ja-JP" sz="1000" dirty="0">
                <a:latin typeface="Arial" panose="020B0604020202020204" pitchFamily="34" charset="0"/>
                <a:cs typeface="Arial" panose="020B0604020202020204" pitchFamily="34" charset="0"/>
              </a:rPr>
              <a:t>(</a:t>
            </a:r>
            <a:r>
              <a:rPr lang="en-US" altLang="ja-JP" sz="1000" b="1" dirty="0">
                <a:latin typeface="Arial" panose="020B0604020202020204" pitchFamily="34" charset="0"/>
                <a:cs typeface="Arial" panose="020B0604020202020204" pitchFamily="34" charset="0"/>
              </a:rPr>
              <a:t>D</a:t>
            </a:r>
            <a:r>
              <a:rPr lang="en-US" altLang="ja-JP" sz="1000" dirty="0">
                <a:latin typeface="Arial" panose="020B0604020202020204" pitchFamily="34" charset="0"/>
                <a:cs typeface="Arial" panose="020B0604020202020204" pitchFamily="34" charset="0"/>
              </a:rPr>
              <a:t>) Among "ABA-Changed", significantly up-regulated more than 2-fold or down-regulated less than ½-fold changes in both </a:t>
            </a:r>
            <a:r>
              <a:rPr lang="en-US" altLang="ja-JP" sz="1000" i="1" dirty="0">
                <a:latin typeface="Arial" panose="020B0604020202020204" pitchFamily="34" charset="0"/>
                <a:cs typeface="Arial" panose="020B0604020202020204" pitchFamily="34" charset="0"/>
              </a:rPr>
              <a:t>abi1-1</a:t>
            </a:r>
            <a:r>
              <a:rPr lang="en-US" altLang="ja-JP" sz="1000" dirty="0">
                <a:latin typeface="Arial" panose="020B0604020202020204" pitchFamily="34" charset="0"/>
                <a:cs typeface="Arial" panose="020B0604020202020204" pitchFamily="34" charset="0"/>
              </a:rPr>
              <a:t>/Col-0 ratio and </a:t>
            </a:r>
            <a:r>
              <a:rPr lang="en-US" altLang="ja-JP" sz="1000" i="1" dirty="0">
                <a:latin typeface="Arial" panose="020B0604020202020204" pitchFamily="34" charset="0"/>
                <a:cs typeface="Arial" panose="020B0604020202020204" pitchFamily="34" charset="0"/>
              </a:rPr>
              <a:t>srk2dei</a:t>
            </a:r>
            <a:r>
              <a:rPr lang="en-US" altLang="ja-JP" sz="1000" dirty="0">
                <a:latin typeface="Arial" panose="020B0604020202020204" pitchFamily="34" charset="0"/>
                <a:cs typeface="Arial" panose="020B0604020202020204" pitchFamily="34" charset="0"/>
              </a:rPr>
              <a:t> or </a:t>
            </a:r>
            <a:r>
              <a:rPr lang="en-US" altLang="ja-JP" sz="1000" i="1" dirty="0">
                <a:latin typeface="Arial" panose="020B0604020202020204" pitchFamily="34" charset="0"/>
                <a:cs typeface="Arial" panose="020B0604020202020204" pitchFamily="34" charset="0"/>
              </a:rPr>
              <a:t>srk2de</a:t>
            </a:r>
            <a:r>
              <a:rPr lang="en-US" altLang="ja-JP" sz="1000" dirty="0">
                <a:latin typeface="Arial" panose="020B0604020202020204" pitchFamily="34" charset="0"/>
                <a:cs typeface="Arial" panose="020B0604020202020204" pitchFamily="34" charset="0"/>
              </a:rPr>
              <a:t>/Col-0 Ratio.</a:t>
            </a:r>
          </a:p>
        </p:txBody>
      </p:sp>
      <p:sp>
        <p:nvSpPr>
          <p:cNvPr id="42" name="テキスト ボックス 41">
            <a:extLst>
              <a:ext uri="{FF2B5EF4-FFF2-40B4-BE49-F238E27FC236}">
                <a16:creationId xmlns:a16="http://schemas.microsoft.com/office/drawing/2014/main" id="{3DDCF1B6-030B-D75D-192B-DCE6D4FF2690}"/>
              </a:ext>
            </a:extLst>
          </p:cNvPr>
          <p:cNvSpPr txBox="1"/>
          <p:nvPr/>
        </p:nvSpPr>
        <p:spPr>
          <a:xfrm>
            <a:off x="2038232" y="1938204"/>
            <a:ext cx="269626" cy="246221"/>
          </a:xfrm>
          <a:prstGeom prst="rect">
            <a:avLst/>
          </a:prstGeom>
          <a:noFill/>
        </p:spPr>
        <p:txBody>
          <a:bodyPr wrap="none" rtlCol="0">
            <a:spAutoFit/>
          </a:bodyPr>
          <a:lstStyle/>
          <a:p>
            <a:r>
              <a:rPr lang="en-US" altLang="ja-JP" sz="1000" dirty="0">
                <a:latin typeface="Arial"/>
                <a:cs typeface="Arial"/>
              </a:rPr>
              <a:t>B</a:t>
            </a:r>
            <a:endParaRPr kumimoji="1" lang="ja-JP" altLang="en-US" sz="1000" dirty="0">
              <a:latin typeface="Arial"/>
              <a:cs typeface="Arial"/>
            </a:endParaRPr>
          </a:p>
        </p:txBody>
      </p:sp>
      <p:sp>
        <p:nvSpPr>
          <p:cNvPr id="43" name="テキスト ボックス 42">
            <a:extLst>
              <a:ext uri="{FF2B5EF4-FFF2-40B4-BE49-F238E27FC236}">
                <a16:creationId xmlns:a16="http://schemas.microsoft.com/office/drawing/2014/main" id="{A2DDC693-91E5-3BFC-A084-AB0CF45615AC}"/>
              </a:ext>
            </a:extLst>
          </p:cNvPr>
          <p:cNvSpPr txBox="1"/>
          <p:nvPr/>
        </p:nvSpPr>
        <p:spPr>
          <a:xfrm>
            <a:off x="2038232" y="3002361"/>
            <a:ext cx="277640" cy="246221"/>
          </a:xfrm>
          <a:prstGeom prst="rect">
            <a:avLst/>
          </a:prstGeom>
          <a:noFill/>
        </p:spPr>
        <p:txBody>
          <a:bodyPr wrap="none" rtlCol="0">
            <a:spAutoFit/>
          </a:bodyPr>
          <a:lstStyle/>
          <a:p>
            <a:r>
              <a:rPr lang="en-US" altLang="ja-JP" sz="1000" dirty="0">
                <a:latin typeface="Arial"/>
                <a:cs typeface="Arial"/>
              </a:rPr>
              <a:t>C</a:t>
            </a:r>
            <a:endParaRPr kumimoji="1" lang="ja-JP" altLang="en-US" sz="1000" dirty="0">
              <a:latin typeface="Arial"/>
              <a:cs typeface="Arial"/>
            </a:endParaRPr>
          </a:p>
        </p:txBody>
      </p:sp>
      <p:sp>
        <p:nvSpPr>
          <p:cNvPr id="44" name="テキスト ボックス 43">
            <a:extLst>
              <a:ext uri="{FF2B5EF4-FFF2-40B4-BE49-F238E27FC236}">
                <a16:creationId xmlns:a16="http://schemas.microsoft.com/office/drawing/2014/main" id="{E077BBEC-E4CA-3E61-63A1-C3675E3013E5}"/>
              </a:ext>
            </a:extLst>
          </p:cNvPr>
          <p:cNvSpPr txBox="1"/>
          <p:nvPr/>
        </p:nvSpPr>
        <p:spPr>
          <a:xfrm>
            <a:off x="2038232" y="4066519"/>
            <a:ext cx="277640" cy="246221"/>
          </a:xfrm>
          <a:prstGeom prst="rect">
            <a:avLst/>
          </a:prstGeom>
          <a:noFill/>
        </p:spPr>
        <p:txBody>
          <a:bodyPr wrap="none" rtlCol="0">
            <a:spAutoFit/>
          </a:bodyPr>
          <a:lstStyle/>
          <a:p>
            <a:r>
              <a:rPr lang="en-US" altLang="ja-JP" sz="1000" dirty="0">
                <a:latin typeface="Arial"/>
                <a:cs typeface="Arial"/>
              </a:rPr>
              <a:t>D</a:t>
            </a:r>
            <a:endParaRPr kumimoji="1" lang="ja-JP" altLang="en-US" sz="1000" dirty="0">
              <a:latin typeface="Arial"/>
              <a:cs typeface="Arial"/>
            </a:endParaRPr>
          </a:p>
        </p:txBody>
      </p:sp>
    </p:spTree>
    <p:extLst>
      <p:ext uri="{BB962C8B-B14F-4D97-AF65-F5344CB8AC3E}">
        <p14:creationId xmlns:p14="http://schemas.microsoft.com/office/powerpoint/2010/main" val="11742973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E7F7ACC-643A-988D-8F20-2281B120383B}"/>
            </a:ext>
          </a:extLst>
        </p:cNvPr>
        <p:cNvGrpSpPr/>
        <p:nvPr/>
      </p:nvGrpSpPr>
      <p:grpSpPr>
        <a:xfrm>
          <a:off x="0" y="0"/>
          <a:ext cx="0" cy="0"/>
          <a:chOff x="0" y="0"/>
          <a:chExt cx="0" cy="0"/>
        </a:xfrm>
      </p:grpSpPr>
      <p:sp>
        <p:nvSpPr>
          <p:cNvPr id="16" name="テキスト ボックス 15">
            <a:extLst>
              <a:ext uri="{FF2B5EF4-FFF2-40B4-BE49-F238E27FC236}">
                <a16:creationId xmlns:a16="http://schemas.microsoft.com/office/drawing/2014/main" id="{84DCA851-0E30-2E99-3B53-35D2602523AA}"/>
              </a:ext>
            </a:extLst>
          </p:cNvPr>
          <p:cNvSpPr txBox="1"/>
          <p:nvPr/>
        </p:nvSpPr>
        <p:spPr>
          <a:xfrm>
            <a:off x="758073" y="4704521"/>
            <a:ext cx="5400000" cy="1015663"/>
          </a:xfrm>
          <a:prstGeom prst="rect">
            <a:avLst/>
          </a:prstGeom>
          <a:noFill/>
        </p:spPr>
        <p:txBody>
          <a:bodyPr wrap="square">
            <a:spAutoFit/>
          </a:bodyPr>
          <a:lstStyle/>
          <a:p>
            <a:pPr algn="just">
              <a:buNone/>
            </a:pPr>
            <a:r>
              <a:rPr lang="en-US" altLang="ja-JP" sz="1000" b="1" dirty="0">
                <a:latin typeface="Arial" panose="020B0604020202020204" pitchFamily="34" charset="0"/>
                <a:cs typeface="Arial" panose="020B0604020202020204" pitchFamily="34" charset="0"/>
              </a:rPr>
              <a:t>Supplementary Figure S4. </a:t>
            </a:r>
            <a:r>
              <a:rPr lang="en" altLang="ja-JP" sz="1000" b="1" dirty="0">
                <a:latin typeface="Arial" panose="020B0604020202020204" pitchFamily="34" charset="0"/>
                <a:cs typeface="Arial" panose="020B0604020202020204" pitchFamily="34" charset="0"/>
              </a:rPr>
              <a:t>ABA‑induced phosphoprotein interaction networks and active subnetworks.</a:t>
            </a:r>
            <a:r>
              <a:rPr lang="ja-JP" altLang="en-US" sz="1000" b="1" dirty="0">
                <a:latin typeface="Arial" panose="020B0604020202020204" pitchFamily="34" charset="0"/>
                <a:cs typeface="Arial" panose="020B0604020202020204" pitchFamily="34" charset="0"/>
              </a:rPr>
              <a:t> </a:t>
            </a:r>
            <a:r>
              <a:rPr lang="en" altLang="ja-JP" sz="1000" dirty="0">
                <a:latin typeface="Arial" panose="020B0604020202020204" pitchFamily="34" charset="0"/>
                <a:cs typeface="Arial" panose="020B0604020202020204" pitchFamily="34" charset="0"/>
              </a:rPr>
              <a:t>Proteins showing ABA‑dependent changes in phosphorylation were mapped onto protein–protein interaction networks constructed from PhosPhAt 4.0 and STRING. Multi‑layer temporal networks were generated using TimeNexus, and active subnetworks were extracted with PathLinker using nodes with |log₂FC| ≥ 1 and </a:t>
            </a:r>
            <a:r>
              <a:rPr lang="en" altLang="ja-JP" sz="1000" i="1" dirty="0">
                <a:latin typeface="Arial" panose="020B0604020202020204" pitchFamily="34" charset="0"/>
                <a:cs typeface="Arial" panose="020B0604020202020204" pitchFamily="34" charset="0"/>
              </a:rPr>
              <a:t>P</a:t>
            </a:r>
            <a:r>
              <a:rPr lang="en" altLang="ja-JP" sz="1000" dirty="0">
                <a:latin typeface="Arial" panose="020B0604020202020204" pitchFamily="34" charset="0"/>
                <a:cs typeface="Arial" panose="020B0604020202020204" pitchFamily="34" charset="0"/>
              </a:rPr>
              <a:t> &lt; 0.01 as queries.</a:t>
            </a:r>
          </a:p>
        </p:txBody>
      </p:sp>
      <p:grpSp>
        <p:nvGrpSpPr>
          <p:cNvPr id="2" name="グループ化 1">
            <a:extLst>
              <a:ext uri="{FF2B5EF4-FFF2-40B4-BE49-F238E27FC236}">
                <a16:creationId xmlns:a16="http://schemas.microsoft.com/office/drawing/2014/main" id="{FD671BFD-92D3-1B4A-374C-F293F77636C4}"/>
              </a:ext>
            </a:extLst>
          </p:cNvPr>
          <p:cNvGrpSpPr/>
          <p:nvPr/>
        </p:nvGrpSpPr>
        <p:grpSpPr>
          <a:xfrm>
            <a:off x="801500" y="2378726"/>
            <a:ext cx="1562474" cy="2160000"/>
            <a:chOff x="530157" y="4280972"/>
            <a:chExt cx="1562474" cy="2160000"/>
          </a:xfrm>
        </p:grpSpPr>
        <p:sp>
          <p:nvSpPr>
            <p:cNvPr id="3" name="楕円 2">
              <a:extLst>
                <a:ext uri="{FF2B5EF4-FFF2-40B4-BE49-F238E27FC236}">
                  <a16:creationId xmlns:a16="http://schemas.microsoft.com/office/drawing/2014/main" id="{13A5A4CC-1E66-19EA-A485-D024DD023E26}"/>
                </a:ext>
              </a:extLst>
            </p:cNvPr>
            <p:cNvSpPr/>
            <p:nvPr/>
          </p:nvSpPr>
          <p:spPr>
            <a:xfrm rot="19146084">
              <a:off x="530157" y="4280972"/>
              <a:ext cx="1512000" cy="2160000"/>
            </a:xfrm>
            <a:prstGeom prst="ellipse">
              <a:avLst/>
            </a:prstGeom>
            <a:solidFill>
              <a:srgbClr val="FFFF99">
                <a:alpha val="49804"/>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b="1">
                <a:latin typeface="Arial" panose="020B0604020202020204" pitchFamily="34" charset="0"/>
                <a:cs typeface="Arial" panose="020B0604020202020204" pitchFamily="34" charset="0"/>
              </a:endParaRPr>
            </a:p>
          </p:txBody>
        </p:sp>
        <p:sp>
          <p:nvSpPr>
            <p:cNvPr id="4" name="フリーフォーム: 図形 3">
              <a:extLst>
                <a:ext uri="{FF2B5EF4-FFF2-40B4-BE49-F238E27FC236}">
                  <a16:creationId xmlns:a16="http://schemas.microsoft.com/office/drawing/2014/main" id="{70DDC5FF-B199-2116-DFDC-AEB95113F4C6}"/>
                </a:ext>
              </a:extLst>
            </p:cNvPr>
            <p:cNvSpPr/>
            <p:nvPr/>
          </p:nvSpPr>
          <p:spPr>
            <a:xfrm>
              <a:off x="1153761" y="5433066"/>
              <a:ext cx="276074" cy="47616"/>
            </a:xfrm>
            <a:custGeom>
              <a:avLst/>
              <a:gdLst>
                <a:gd name="csX0" fmla="*/ -1299 w 276074"/>
                <a:gd name="csY0" fmla="*/ 250 h 47616"/>
                <a:gd name="csX1" fmla="*/ 274775 w 276074"/>
                <a:gd name="csY1" fmla="*/ 47866 h 47616"/>
              </a:gdLst>
              <a:ahLst/>
              <a:cxnLst>
                <a:cxn ang="0">
                  <a:pos x="csX0" y="csY0"/>
                </a:cxn>
                <a:cxn ang="0">
                  <a:pos x="csX1" y="csY1"/>
                </a:cxn>
              </a:cxnLst>
              <a:rect l="l" t="t" r="r" b="b"/>
              <a:pathLst>
                <a:path w="276074" h="47616">
                  <a:moveTo>
                    <a:pt x="-1299" y="250"/>
                  </a:moveTo>
                  <a:lnTo>
                    <a:pt x="274775" y="47866"/>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 name="フリーフォーム: 図形 4">
              <a:extLst>
                <a:ext uri="{FF2B5EF4-FFF2-40B4-BE49-F238E27FC236}">
                  <a16:creationId xmlns:a16="http://schemas.microsoft.com/office/drawing/2014/main" id="{F812593E-F93C-028B-94DA-553580A1381C}"/>
                </a:ext>
              </a:extLst>
            </p:cNvPr>
            <p:cNvSpPr/>
            <p:nvPr/>
          </p:nvSpPr>
          <p:spPr>
            <a:xfrm rot="11387157">
              <a:off x="1147903" y="5426664"/>
              <a:ext cx="5900" cy="11801"/>
            </a:xfrm>
            <a:custGeom>
              <a:avLst/>
              <a:gdLst>
                <a:gd name="csX0" fmla="*/ 289 w 5900"/>
                <a:gd name="csY0" fmla="*/ 12062 h 11801"/>
                <a:gd name="csX1" fmla="*/ 6189 w 5900"/>
                <a:gd name="csY1" fmla="*/ 6161 h 11801"/>
                <a:gd name="csX2" fmla="*/ 289 w 5900"/>
                <a:gd name="csY2" fmla="*/ 260 h 11801"/>
              </a:gdLst>
              <a:ahLst/>
              <a:cxnLst>
                <a:cxn ang="0">
                  <a:pos x="csX0" y="csY0"/>
                </a:cxn>
                <a:cxn ang="0">
                  <a:pos x="csX1" y="csY1"/>
                </a:cxn>
                <a:cxn ang="0">
                  <a:pos x="csX2" y="csY2"/>
                </a:cxn>
              </a:cxnLst>
              <a:rect l="l" t="t" r="r" b="b"/>
              <a:pathLst>
                <a:path w="5900" h="11801">
                  <a:moveTo>
                    <a:pt x="289" y="12062"/>
                  </a:moveTo>
                  <a:cubicBezTo>
                    <a:pt x="3547" y="12062"/>
                    <a:pt x="6189" y="9420"/>
                    <a:pt x="6189" y="6161"/>
                  </a:cubicBezTo>
                  <a:cubicBezTo>
                    <a:pt x="6189" y="2902"/>
                    <a:pt x="3547" y="260"/>
                    <a:pt x="289" y="260"/>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 name="フリーフォーム: 図形 5">
              <a:extLst>
                <a:ext uri="{FF2B5EF4-FFF2-40B4-BE49-F238E27FC236}">
                  <a16:creationId xmlns:a16="http://schemas.microsoft.com/office/drawing/2014/main" id="{A1A4D70B-0AE1-F507-CDE6-639126DA5CE4}"/>
                </a:ext>
              </a:extLst>
            </p:cNvPr>
            <p:cNvSpPr/>
            <p:nvPr/>
          </p:nvSpPr>
          <p:spPr>
            <a:xfrm rot="587157">
              <a:off x="1429458" y="5472114"/>
              <a:ext cx="51926" cy="25963"/>
            </a:xfrm>
            <a:custGeom>
              <a:avLst/>
              <a:gdLst>
                <a:gd name="csX0" fmla="*/ 349 w 51926"/>
                <a:gd name="csY0" fmla="*/ 270 h 25963"/>
                <a:gd name="csX1" fmla="*/ 52275 w 51926"/>
                <a:gd name="csY1" fmla="*/ 13252 h 25963"/>
                <a:gd name="csX2" fmla="*/ 349 w 51926"/>
                <a:gd name="csY2" fmla="*/ 26234 h 25963"/>
              </a:gdLst>
              <a:ahLst/>
              <a:cxnLst>
                <a:cxn ang="0">
                  <a:pos x="csX0" y="csY0"/>
                </a:cxn>
                <a:cxn ang="0">
                  <a:pos x="csX1" y="csY1"/>
                </a:cxn>
                <a:cxn ang="0">
                  <a:pos x="csX2" y="csY2"/>
                </a:cxn>
              </a:cxnLst>
              <a:rect l="l" t="t" r="r" b="b"/>
              <a:pathLst>
                <a:path w="51926" h="25963">
                  <a:moveTo>
                    <a:pt x="349" y="270"/>
                  </a:moveTo>
                  <a:cubicBezTo>
                    <a:pt x="17657" y="8925"/>
                    <a:pt x="34966" y="13252"/>
                    <a:pt x="52275" y="13252"/>
                  </a:cubicBezTo>
                  <a:cubicBezTo>
                    <a:pt x="34966" y="13252"/>
                    <a:pt x="17657" y="17579"/>
                    <a:pt x="349" y="26234"/>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 name="フリーフォーム: 図形 6">
              <a:extLst>
                <a:ext uri="{FF2B5EF4-FFF2-40B4-BE49-F238E27FC236}">
                  <a16:creationId xmlns:a16="http://schemas.microsoft.com/office/drawing/2014/main" id="{D6C51B69-C276-D6BA-3AB4-BA46116B6244}"/>
                </a:ext>
              </a:extLst>
            </p:cNvPr>
            <p:cNvSpPr/>
            <p:nvPr/>
          </p:nvSpPr>
          <p:spPr>
            <a:xfrm>
              <a:off x="1317232" y="5335567"/>
              <a:ext cx="184624" cy="133092"/>
            </a:xfrm>
            <a:custGeom>
              <a:avLst/>
              <a:gdLst>
                <a:gd name="csX0" fmla="*/ 183298 w 184624"/>
                <a:gd name="csY0" fmla="*/ 133354 h 133092"/>
                <a:gd name="csX1" fmla="*/ -1327 w 184624"/>
                <a:gd name="csY1" fmla="*/ 262 h 133092"/>
              </a:gdLst>
              <a:ahLst/>
              <a:cxnLst>
                <a:cxn ang="0">
                  <a:pos x="csX0" y="csY0"/>
                </a:cxn>
                <a:cxn ang="0">
                  <a:pos x="csX1" y="csY1"/>
                </a:cxn>
              </a:cxnLst>
              <a:rect l="l" t="t" r="r" b="b"/>
              <a:pathLst>
                <a:path w="184624" h="133092">
                  <a:moveTo>
                    <a:pt x="183298" y="133354"/>
                  </a:moveTo>
                  <a:lnTo>
                    <a:pt x="-1327" y="262"/>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 name="フリーフォーム: 図形 7">
              <a:extLst>
                <a:ext uri="{FF2B5EF4-FFF2-40B4-BE49-F238E27FC236}">
                  <a16:creationId xmlns:a16="http://schemas.microsoft.com/office/drawing/2014/main" id="{D6CBDA34-0278-81AB-4A00-8B0BBCD8BDF9}"/>
                </a:ext>
              </a:extLst>
            </p:cNvPr>
            <p:cNvSpPr/>
            <p:nvPr/>
          </p:nvSpPr>
          <p:spPr>
            <a:xfrm rot="2147225">
              <a:off x="1501299" y="5464484"/>
              <a:ext cx="5900" cy="11801"/>
            </a:xfrm>
            <a:custGeom>
              <a:avLst/>
              <a:gdLst>
                <a:gd name="csX0" fmla="*/ 357 w 5900"/>
                <a:gd name="csY0" fmla="*/ 12069 h 11801"/>
                <a:gd name="csX1" fmla="*/ 6258 w 5900"/>
                <a:gd name="csY1" fmla="*/ 6168 h 11801"/>
                <a:gd name="csX2" fmla="*/ 357 w 5900"/>
                <a:gd name="csY2" fmla="*/ 268 h 11801"/>
              </a:gdLst>
              <a:ahLst/>
              <a:cxnLst>
                <a:cxn ang="0">
                  <a:pos x="csX0" y="csY0"/>
                </a:cxn>
                <a:cxn ang="0">
                  <a:pos x="csX1" y="csY1"/>
                </a:cxn>
                <a:cxn ang="0">
                  <a:pos x="csX2" y="csY2"/>
                </a:cxn>
              </a:cxnLst>
              <a:rect l="l" t="t" r="r" b="b"/>
              <a:pathLst>
                <a:path w="5900" h="11801">
                  <a:moveTo>
                    <a:pt x="357" y="12069"/>
                  </a:moveTo>
                  <a:cubicBezTo>
                    <a:pt x="3616" y="12069"/>
                    <a:pt x="6258" y="9427"/>
                    <a:pt x="6258" y="6168"/>
                  </a:cubicBezTo>
                  <a:cubicBezTo>
                    <a:pt x="6258" y="2909"/>
                    <a:pt x="3616" y="268"/>
                    <a:pt x="357" y="268"/>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9" name="フリーフォーム: 図形 8">
              <a:extLst>
                <a:ext uri="{FF2B5EF4-FFF2-40B4-BE49-F238E27FC236}">
                  <a16:creationId xmlns:a16="http://schemas.microsoft.com/office/drawing/2014/main" id="{109FC31A-3F1C-9B55-0C68-71C5B3FC081F}"/>
                </a:ext>
              </a:extLst>
            </p:cNvPr>
            <p:cNvSpPr/>
            <p:nvPr/>
          </p:nvSpPr>
          <p:spPr>
            <a:xfrm rot="12947225">
              <a:off x="1270207" y="5307403"/>
              <a:ext cx="51926" cy="25963"/>
            </a:xfrm>
            <a:custGeom>
              <a:avLst/>
              <a:gdLst>
                <a:gd name="csX0" fmla="*/ 318 w 51926"/>
                <a:gd name="csY0" fmla="*/ 239 h 25963"/>
                <a:gd name="csX1" fmla="*/ 52245 w 51926"/>
                <a:gd name="csY1" fmla="*/ 13220 h 25963"/>
                <a:gd name="csX2" fmla="*/ 318 w 51926"/>
                <a:gd name="csY2" fmla="*/ 26202 h 25963"/>
              </a:gdLst>
              <a:ahLst/>
              <a:cxnLst>
                <a:cxn ang="0">
                  <a:pos x="csX0" y="csY0"/>
                </a:cxn>
                <a:cxn ang="0">
                  <a:pos x="csX1" y="csY1"/>
                </a:cxn>
                <a:cxn ang="0">
                  <a:pos x="csX2" y="csY2"/>
                </a:cxn>
              </a:cxnLst>
              <a:rect l="l" t="t" r="r" b="b"/>
              <a:pathLst>
                <a:path w="51926" h="25963">
                  <a:moveTo>
                    <a:pt x="318" y="239"/>
                  </a:moveTo>
                  <a:cubicBezTo>
                    <a:pt x="17627" y="8893"/>
                    <a:pt x="34936" y="13220"/>
                    <a:pt x="52245" y="13220"/>
                  </a:cubicBezTo>
                  <a:cubicBezTo>
                    <a:pt x="34936" y="13220"/>
                    <a:pt x="17627" y="17547"/>
                    <a:pt x="318" y="26202"/>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0" name="フリーフォーム: 図形 9">
              <a:extLst>
                <a:ext uri="{FF2B5EF4-FFF2-40B4-BE49-F238E27FC236}">
                  <a16:creationId xmlns:a16="http://schemas.microsoft.com/office/drawing/2014/main" id="{96C7D8F4-F65C-EB14-3CE3-9CCD10EBA30B}"/>
                </a:ext>
              </a:extLst>
            </p:cNvPr>
            <p:cNvSpPr/>
            <p:nvPr/>
          </p:nvSpPr>
          <p:spPr>
            <a:xfrm>
              <a:off x="1109195" y="5198418"/>
              <a:ext cx="73846" cy="45432"/>
            </a:xfrm>
            <a:custGeom>
              <a:avLst/>
              <a:gdLst>
                <a:gd name="csX0" fmla="*/ 72581 w 73846"/>
                <a:gd name="csY0" fmla="*/ 45736 h 45432"/>
                <a:gd name="csX1" fmla="*/ -1266 w 73846"/>
                <a:gd name="csY1" fmla="*/ 304 h 45432"/>
              </a:gdLst>
              <a:ahLst/>
              <a:cxnLst>
                <a:cxn ang="0">
                  <a:pos x="csX0" y="csY0"/>
                </a:cxn>
                <a:cxn ang="0">
                  <a:pos x="csX1" y="csY1"/>
                </a:cxn>
              </a:cxnLst>
              <a:rect l="l" t="t" r="r" b="b"/>
              <a:pathLst>
                <a:path w="73846" h="45432">
                  <a:moveTo>
                    <a:pt x="72581" y="45736"/>
                  </a:moveTo>
                  <a:lnTo>
                    <a:pt x="-1266" y="304"/>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 name="フリーフォーム: 図形 10">
              <a:extLst>
                <a:ext uri="{FF2B5EF4-FFF2-40B4-BE49-F238E27FC236}">
                  <a16:creationId xmlns:a16="http://schemas.microsoft.com/office/drawing/2014/main" id="{F0E05003-4694-CB6E-CEC3-8369894B99A9}"/>
                </a:ext>
              </a:extLst>
            </p:cNvPr>
            <p:cNvSpPr/>
            <p:nvPr/>
          </p:nvSpPr>
          <p:spPr>
            <a:xfrm rot="1896049">
              <a:off x="1182604" y="5239495"/>
              <a:ext cx="5900" cy="11801"/>
            </a:xfrm>
            <a:custGeom>
              <a:avLst/>
              <a:gdLst>
                <a:gd name="csX0" fmla="*/ 295 w 5900"/>
                <a:gd name="csY0" fmla="*/ 12026 h 11801"/>
                <a:gd name="csX1" fmla="*/ 6196 w 5900"/>
                <a:gd name="csY1" fmla="*/ 6125 h 11801"/>
                <a:gd name="csX2" fmla="*/ 295 w 5900"/>
                <a:gd name="csY2" fmla="*/ 224 h 11801"/>
              </a:gdLst>
              <a:ahLst/>
              <a:cxnLst>
                <a:cxn ang="0">
                  <a:pos x="csX0" y="csY0"/>
                </a:cxn>
                <a:cxn ang="0">
                  <a:pos x="csX1" y="csY1"/>
                </a:cxn>
                <a:cxn ang="0">
                  <a:pos x="csX2" y="csY2"/>
                </a:cxn>
              </a:cxnLst>
              <a:rect l="l" t="t" r="r" b="b"/>
              <a:pathLst>
                <a:path w="5900" h="11801">
                  <a:moveTo>
                    <a:pt x="295" y="12026"/>
                  </a:moveTo>
                  <a:cubicBezTo>
                    <a:pt x="3554" y="12026"/>
                    <a:pt x="6196" y="9384"/>
                    <a:pt x="6196" y="6125"/>
                  </a:cubicBezTo>
                  <a:cubicBezTo>
                    <a:pt x="6196" y="2866"/>
                    <a:pt x="3554" y="224"/>
                    <a:pt x="295" y="224"/>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2" name="フリーフォーム: 図形 11">
              <a:extLst>
                <a:ext uri="{FF2B5EF4-FFF2-40B4-BE49-F238E27FC236}">
                  <a16:creationId xmlns:a16="http://schemas.microsoft.com/office/drawing/2014/main" id="{B1752043-0E9E-C825-75BA-C53184DA52F1}"/>
                </a:ext>
              </a:extLst>
            </p:cNvPr>
            <p:cNvSpPr/>
            <p:nvPr/>
          </p:nvSpPr>
          <p:spPr>
            <a:xfrm rot="12696049">
              <a:off x="1061118" y="5171831"/>
              <a:ext cx="51926" cy="25963"/>
            </a:xfrm>
            <a:custGeom>
              <a:avLst/>
              <a:gdLst>
                <a:gd name="csX0" fmla="*/ 278 w 51926"/>
                <a:gd name="csY0" fmla="*/ 212 h 25963"/>
                <a:gd name="csX1" fmla="*/ 52204 w 51926"/>
                <a:gd name="csY1" fmla="*/ 13194 h 25963"/>
                <a:gd name="csX2" fmla="*/ 278 w 51926"/>
                <a:gd name="csY2" fmla="*/ 26176 h 25963"/>
              </a:gdLst>
              <a:ahLst/>
              <a:cxnLst>
                <a:cxn ang="0">
                  <a:pos x="csX0" y="csY0"/>
                </a:cxn>
                <a:cxn ang="0">
                  <a:pos x="csX1" y="csY1"/>
                </a:cxn>
                <a:cxn ang="0">
                  <a:pos x="csX2" y="csY2"/>
                </a:cxn>
              </a:cxnLst>
              <a:rect l="l" t="t" r="r" b="b"/>
              <a:pathLst>
                <a:path w="51926" h="25963">
                  <a:moveTo>
                    <a:pt x="278" y="212"/>
                  </a:moveTo>
                  <a:cubicBezTo>
                    <a:pt x="17586" y="8867"/>
                    <a:pt x="34895" y="13194"/>
                    <a:pt x="52204" y="13194"/>
                  </a:cubicBezTo>
                  <a:cubicBezTo>
                    <a:pt x="34895" y="13194"/>
                    <a:pt x="17586" y="17521"/>
                    <a:pt x="278" y="26176"/>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3" name="フリーフォーム: 図形 12">
              <a:extLst>
                <a:ext uri="{FF2B5EF4-FFF2-40B4-BE49-F238E27FC236}">
                  <a16:creationId xmlns:a16="http://schemas.microsoft.com/office/drawing/2014/main" id="{3925AFF2-8C7F-C968-53F9-1300EFF303B9}"/>
                </a:ext>
              </a:extLst>
            </p:cNvPr>
            <p:cNvSpPr/>
            <p:nvPr/>
          </p:nvSpPr>
          <p:spPr>
            <a:xfrm>
              <a:off x="1294735" y="5544881"/>
              <a:ext cx="219076" cy="296086"/>
            </a:xfrm>
            <a:custGeom>
              <a:avLst/>
              <a:gdLst>
                <a:gd name="csX0" fmla="*/ 217751 w 219076"/>
                <a:gd name="csY0" fmla="*/ 195 h 296086"/>
                <a:gd name="csX1" fmla="*/ -1325 w 219076"/>
                <a:gd name="csY1" fmla="*/ 296282 h 296086"/>
              </a:gdLst>
              <a:ahLst/>
              <a:cxnLst>
                <a:cxn ang="0">
                  <a:pos x="csX0" y="csY0"/>
                </a:cxn>
                <a:cxn ang="0">
                  <a:pos x="csX1" y="csY1"/>
                </a:cxn>
              </a:cxnLst>
              <a:rect l="l" t="t" r="r" b="b"/>
              <a:pathLst>
                <a:path w="219076" h="296086">
                  <a:moveTo>
                    <a:pt x="217751" y="195"/>
                  </a:moveTo>
                  <a:lnTo>
                    <a:pt x="-1325" y="296282"/>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4" name="フリーフォーム: 図形 13">
              <a:extLst>
                <a:ext uri="{FF2B5EF4-FFF2-40B4-BE49-F238E27FC236}">
                  <a16:creationId xmlns:a16="http://schemas.microsoft.com/office/drawing/2014/main" id="{E539091B-5467-B8A7-D775-C0E2A86E8480}"/>
                </a:ext>
              </a:extLst>
            </p:cNvPr>
            <p:cNvSpPr/>
            <p:nvPr/>
          </p:nvSpPr>
          <p:spPr>
            <a:xfrm rot="18389876">
              <a:off x="1512616" y="5536609"/>
              <a:ext cx="5900" cy="11801"/>
            </a:xfrm>
            <a:custGeom>
              <a:avLst/>
              <a:gdLst>
                <a:gd name="csX0" fmla="*/ 359 w 5900"/>
                <a:gd name="csY0" fmla="*/ 12083 h 11801"/>
                <a:gd name="csX1" fmla="*/ 6260 w 5900"/>
                <a:gd name="csY1" fmla="*/ 6182 h 11801"/>
                <a:gd name="csX2" fmla="*/ 359 w 5900"/>
                <a:gd name="csY2" fmla="*/ 281 h 11801"/>
              </a:gdLst>
              <a:ahLst/>
              <a:cxnLst>
                <a:cxn ang="0">
                  <a:pos x="csX0" y="csY0"/>
                </a:cxn>
                <a:cxn ang="0">
                  <a:pos x="csX1" y="csY1"/>
                </a:cxn>
                <a:cxn ang="0">
                  <a:pos x="csX2" y="csY2"/>
                </a:cxn>
              </a:cxnLst>
              <a:rect l="l" t="t" r="r" b="b"/>
              <a:pathLst>
                <a:path w="5900" h="11801">
                  <a:moveTo>
                    <a:pt x="359" y="12083"/>
                  </a:moveTo>
                  <a:cubicBezTo>
                    <a:pt x="3618" y="12083"/>
                    <a:pt x="6260" y="9441"/>
                    <a:pt x="6260" y="6182"/>
                  </a:cubicBezTo>
                  <a:cubicBezTo>
                    <a:pt x="6260" y="2923"/>
                    <a:pt x="3618" y="281"/>
                    <a:pt x="359" y="281"/>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5" name="フリーフォーム: 図形 14">
              <a:extLst>
                <a:ext uri="{FF2B5EF4-FFF2-40B4-BE49-F238E27FC236}">
                  <a16:creationId xmlns:a16="http://schemas.microsoft.com/office/drawing/2014/main" id="{039A9F3F-BEB8-AD06-4EE8-1D00069C220F}"/>
                </a:ext>
              </a:extLst>
            </p:cNvPr>
            <p:cNvSpPr/>
            <p:nvPr/>
          </p:nvSpPr>
          <p:spPr>
            <a:xfrm rot="7589876">
              <a:off x="1253329" y="5848858"/>
              <a:ext cx="51926" cy="25963"/>
            </a:xfrm>
            <a:custGeom>
              <a:avLst/>
              <a:gdLst>
                <a:gd name="csX0" fmla="*/ 315 w 51926"/>
                <a:gd name="csY0" fmla="*/ 343 h 25963"/>
                <a:gd name="csX1" fmla="*/ 52241 w 51926"/>
                <a:gd name="csY1" fmla="*/ 13325 h 25963"/>
                <a:gd name="csX2" fmla="*/ 315 w 51926"/>
                <a:gd name="csY2" fmla="*/ 26306 h 25963"/>
              </a:gdLst>
              <a:ahLst/>
              <a:cxnLst>
                <a:cxn ang="0">
                  <a:pos x="csX0" y="csY0"/>
                </a:cxn>
                <a:cxn ang="0">
                  <a:pos x="csX1" y="csY1"/>
                </a:cxn>
                <a:cxn ang="0">
                  <a:pos x="csX2" y="csY2"/>
                </a:cxn>
              </a:cxnLst>
              <a:rect l="l" t="t" r="r" b="b"/>
              <a:pathLst>
                <a:path w="51926" h="25963">
                  <a:moveTo>
                    <a:pt x="315" y="343"/>
                  </a:moveTo>
                  <a:cubicBezTo>
                    <a:pt x="17623" y="8997"/>
                    <a:pt x="34932" y="13325"/>
                    <a:pt x="52241" y="13325"/>
                  </a:cubicBezTo>
                  <a:cubicBezTo>
                    <a:pt x="34932" y="13325"/>
                    <a:pt x="17623" y="17652"/>
                    <a:pt x="315" y="26306"/>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7" name="フリーフォーム: 図形 16">
              <a:extLst>
                <a:ext uri="{FF2B5EF4-FFF2-40B4-BE49-F238E27FC236}">
                  <a16:creationId xmlns:a16="http://schemas.microsoft.com/office/drawing/2014/main" id="{CB06CE64-C7F3-A285-E1FE-6C7062BD18FA}"/>
                </a:ext>
              </a:extLst>
            </p:cNvPr>
            <p:cNvSpPr/>
            <p:nvPr/>
          </p:nvSpPr>
          <p:spPr>
            <a:xfrm>
              <a:off x="1331896" y="5623984"/>
              <a:ext cx="532449" cy="261536"/>
            </a:xfrm>
            <a:custGeom>
              <a:avLst/>
              <a:gdLst>
                <a:gd name="csX0" fmla="*/ 531079 w 532449"/>
                <a:gd name="csY0" fmla="*/ 181 h 261536"/>
                <a:gd name="csX1" fmla="*/ -1370 w 532449"/>
                <a:gd name="csY1" fmla="*/ 261718 h 261536"/>
              </a:gdLst>
              <a:ahLst/>
              <a:cxnLst>
                <a:cxn ang="0">
                  <a:pos x="csX0" y="csY0"/>
                </a:cxn>
                <a:cxn ang="0">
                  <a:pos x="csX1" y="csY1"/>
                </a:cxn>
              </a:cxnLst>
              <a:rect l="l" t="t" r="r" b="b"/>
              <a:pathLst>
                <a:path w="532449" h="261536">
                  <a:moveTo>
                    <a:pt x="531079" y="181"/>
                  </a:moveTo>
                  <a:lnTo>
                    <a:pt x="-1370" y="261718"/>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8" name="フリーフォーム: 図形 17">
              <a:extLst>
                <a:ext uri="{FF2B5EF4-FFF2-40B4-BE49-F238E27FC236}">
                  <a16:creationId xmlns:a16="http://schemas.microsoft.com/office/drawing/2014/main" id="{302F3BC6-1A92-95EB-AAEF-1EE9D9C6E7ED}"/>
                </a:ext>
              </a:extLst>
            </p:cNvPr>
            <p:cNvSpPr/>
            <p:nvPr/>
          </p:nvSpPr>
          <p:spPr>
            <a:xfrm rot="20030396">
              <a:off x="1864043" y="5616783"/>
              <a:ext cx="5900" cy="11801"/>
            </a:xfrm>
            <a:custGeom>
              <a:avLst/>
              <a:gdLst>
                <a:gd name="csX0" fmla="*/ 427 w 5900"/>
                <a:gd name="csY0" fmla="*/ 12098 h 11801"/>
                <a:gd name="csX1" fmla="*/ 6327 w 5900"/>
                <a:gd name="csY1" fmla="*/ 6198 h 11801"/>
                <a:gd name="csX2" fmla="*/ 427 w 5900"/>
                <a:gd name="csY2" fmla="*/ 297 h 11801"/>
              </a:gdLst>
              <a:ahLst/>
              <a:cxnLst>
                <a:cxn ang="0">
                  <a:pos x="csX0" y="csY0"/>
                </a:cxn>
                <a:cxn ang="0">
                  <a:pos x="csX1" y="csY1"/>
                </a:cxn>
                <a:cxn ang="0">
                  <a:pos x="csX2" y="csY2"/>
                </a:cxn>
              </a:cxnLst>
              <a:rect l="l" t="t" r="r" b="b"/>
              <a:pathLst>
                <a:path w="5900" h="11801">
                  <a:moveTo>
                    <a:pt x="427" y="12098"/>
                  </a:moveTo>
                  <a:cubicBezTo>
                    <a:pt x="3686" y="12098"/>
                    <a:pt x="6327" y="9457"/>
                    <a:pt x="6327" y="6198"/>
                  </a:cubicBezTo>
                  <a:cubicBezTo>
                    <a:pt x="6327" y="2939"/>
                    <a:pt x="3686" y="297"/>
                    <a:pt x="427" y="297"/>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9" name="フリーフォーム: 図形 18">
              <a:extLst>
                <a:ext uri="{FF2B5EF4-FFF2-40B4-BE49-F238E27FC236}">
                  <a16:creationId xmlns:a16="http://schemas.microsoft.com/office/drawing/2014/main" id="{F867C269-EECF-C7FB-0117-C5B5A6F489C8}"/>
                </a:ext>
              </a:extLst>
            </p:cNvPr>
            <p:cNvSpPr/>
            <p:nvPr/>
          </p:nvSpPr>
          <p:spPr>
            <a:xfrm rot="9230396">
              <a:off x="1282629" y="5883986"/>
              <a:ext cx="51926" cy="25963"/>
            </a:xfrm>
            <a:custGeom>
              <a:avLst/>
              <a:gdLst>
                <a:gd name="csX0" fmla="*/ 320 w 51926"/>
                <a:gd name="csY0" fmla="*/ 350 h 25963"/>
                <a:gd name="csX1" fmla="*/ 52247 w 51926"/>
                <a:gd name="csY1" fmla="*/ 13331 h 25963"/>
                <a:gd name="csX2" fmla="*/ 320 w 51926"/>
                <a:gd name="csY2" fmla="*/ 26313 h 25963"/>
              </a:gdLst>
              <a:ahLst/>
              <a:cxnLst>
                <a:cxn ang="0">
                  <a:pos x="csX0" y="csY0"/>
                </a:cxn>
                <a:cxn ang="0">
                  <a:pos x="csX1" y="csY1"/>
                </a:cxn>
                <a:cxn ang="0">
                  <a:pos x="csX2" y="csY2"/>
                </a:cxn>
              </a:cxnLst>
              <a:rect l="l" t="t" r="r" b="b"/>
              <a:pathLst>
                <a:path w="51926" h="25963">
                  <a:moveTo>
                    <a:pt x="320" y="350"/>
                  </a:moveTo>
                  <a:cubicBezTo>
                    <a:pt x="17629" y="9004"/>
                    <a:pt x="34938" y="13331"/>
                    <a:pt x="52247" y="13331"/>
                  </a:cubicBezTo>
                  <a:cubicBezTo>
                    <a:pt x="34938" y="13331"/>
                    <a:pt x="17629" y="17659"/>
                    <a:pt x="320" y="26313"/>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0" name="フリーフォーム: 図形 19">
              <a:extLst>
                <a:ext uri="{FF2B5EF4-FFF2-40B4-BE49-F238E27FC236}">
                  <a16:creationId xmlns:a16="http://schemas.microsoft.com/office/drawing/2014/main" id="{CEBA63C4-E7F3-8CE3-4813-2A4D262AAA75}"/>
                </a:ext>
              </a:extLst>
            </p:cNvPr>
            <p:cNvSpPr/>
            <p:nvPr/>
          </p:nvSpPr>
          <p:spPr>
            <a:xfrm>
              <a:off x="1204360" y="5685303"/>
              <a:ext cx="9008" cy="131879"/>
            </a:xfrm>
            <a:custGeom>
              <a:avLst/>
              <a:gdLst>
                <a:gd name="csX0" fmla="*/ -1280 w 9008"/>
                <a:gd name="csY0" fmla="*/ 182 h 131879"/>
                <a:gd name="csX1" fmla="*/ 7728 w 9008"/>
                <a:gd name="csY1" fmla="*/ 132061 h 131879"/>
              </a:gdLst>
              <a:ahLst/>
              <a:cxnLst>
                <a:cxn ang="0">
                  <a:pos x="csX0" y="csY0"/>
                </a:cxn>
                <a:cxn ang="0">
                  <a:pos x="csX1" y="csY1"/>
                </a:cxn>
              </a:cxnLst>
              <a:rect l="l" t="t" r="r" b="b"/>
              <a:pathLst>
                <a:path w="9008" h="131879">
                  <a:moveTo>
                    <a:pt x="-1280" y="182"/>
                  </a:moveTo>
                  <a:lnTo>
                    <a:pt x="7728" y="132061"/>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1" name="フリーフォーム: 図形 20">
              <a:extLst>
                <a:ext uri="{FF2B5EF4-FFF2-40B4-BE49-F238E27FC236}">
                  <a16:creationId xmlns:a16="http://schemas.microsoft.com/office/drawing/2014/main" id="{52518DCA-46E1-370E-3C9D-716D0702B58F}"/>
                </a:ext>
              </a:extLst>
            </p:cNvPr>
            <p:cNvSpPr/>
            <p:nvPr/>
          </p:nvSpPr>
          <p:spPr>
            <a:xfrm rot="15965538">
              <a:off x="1201208" y="5676459"/>
              <a:ext cx="5900" cy="11801"/>
            </a:xfrm>
            <a:custGeom>
              <a:avLst/>
              <a:gdLst>
                <a:gd name="csX0" fmla="*/ 299 w 5900"/>
                <a:gd name="csY0" fmla="*/ 12110 h 11801"/>
                <a:gd name="csX1" fmla="*/ 6200 w 5900"/>
                <a:gd name="csY1" fmla="*/ 6209 h 11801"/>
                <a:gd name="csX2" fmla="*/ 299 w 5900"/>
                <a:gd name="csY2" fmla="*/ 308 h 11801"/>
              </a:gdLst>
              <a:ahLst/>
              <a:cxnLst>
                <a:cxn ang="0">
                  <a:pos x="csX0" y="csY0"/>
                </a:cxn>
                <a:cxn ang="0">
                  <a:pos x="csX1" y="csY1"/>
                </a:cxn>
                <a:cxn ang="0">
                  <a:pos x="csX2" y="csY2"/>
                </a:cxn>
              </a:cxnLst>
              <a:rect l="l" t="t" r="r" b="b"/>
              <a:pathLst>
                <a:path w="5900" h="11801">
                  <a:moveTo>
                    <a:pt x="299" y="12110"/>
                  </a:moveTo>
                  <a:cubicBezTo>
                    <a:pt x="3558" y="12110"/>
                    <a:pt x="6200" y="9468"/>
                    <a:pt x="6200" y="6209"/>
                  </a:cubicBezTo>
                  <a:cubicBezTo>
                    <a:pt x="6200" y="2950"/>
                    <a:pt x="3558" y="308"/>
                    <a:pt x="299" y="308"/>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2" name="フリーフォーム: 図形 21">
              <a:extLst>
                <a:ext uri="{FF2B5EF4-FFF2-40B4-BE49-F238E27FC236}">
                  <a16:creationId xmlns:a16="http://schemas.microsoft.com/office/drawing/2014/main" id="{AC1817A4-6A28-B44B-6977-9B168F346637}"/>
                </a:ext>
              </a:extLst>
            </p:cNvPr>
            <p:cNvSpPr/>
            <p:nvPr/>
          </p:nvSpPr>
          <p:spPr>
            <a:xfrm rot="5165538">
              <a:off x="1189174" y="5830104"/>
              <a:ext cx="51926" cy="25963"/>
            </a:xfrm>
            <a:custGeom>
              <a:avLst/>
              <a:gdLst>
                <a:gd name="csX0" fmla="*/ 302 w 51926"/>
                <a:gd name="csY0" fmla="*/ 339 h 25963"/>
                <a:gd name="csX1" fmla="*/ 52229 w 51926"/>
                <a:gd name="csY1" fmla="*/ 13321 h 25963"/>
                <a:gd name="csX2" fmla="*/ 302 w 51926"/>
                <a:gd name="csY2" fmla="*/ 26303 h 25963"/>
              </a:gdLst>
              <a:ahLst/>
              <a:cxnLst>
                <a:cxn ang="0">
                  <a:pos x="csX0" y="csY0"/>
                </a:cxn>
                <a:cxn ang="0">
                  <a:pos x="csX1" y="csY1"/>
                </a:cxn>
                <a:cxn ang="0">
                  <a:pos x="csX2" y="csY2"/>
                </a:cxn>
              </a:cxnLst>
              <a:rect l="l" t="t" r="r" b="b"/>
              <a:pathLst>
                <a:path w="51926" h="25963">
                  <a:moveTo>
                    <a:pt x="302" y="339"/>
                  </a:moveTo>
                  <a:cubicBezTo>
                    <a:pt x="17611" y="8994"/>
                    <a:pt x="34920" y="13321"/>
                    <a:pt x="52229" y="13321"/>
                  </a:cubicBezTo>
                  <a:cubicBezTo>
                    <a:pt x="34920" y="13321"/>
                    <a:pt x="17611" y="17648"/>
                    <a:pt x="302" y="26303"/>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3" name="フリーフォーム: 図形 22">
              <a:extLst>
                <a:ext uri="{FF2B5EF4-FFF2-40B4-BE49-F238E27FC236}">
                  <a16:creationId xmlns:a16="http://schemas.microsoft.com/office/drawing/2014/main" id="{2FC62A9E-C8FF-8A21-20BF-CC5835961AAC}"/>
                </a:ext>
              </a:extLst>
            </p:cNvPr>
            <p:cNvSpPr/>
            <p:nvPr/>
          </p:nvSpPr>
          <p:spPr>
            <a:xfrm>
              <a:off x="1047801" y="4692000"/>
              <a:ext cx="152696" cy="101718"/>
            </a:xfrm>
            <a:custGeom>
              <a:avLst/>
              <a:gdLst>
                <a:gd name="csX0" fmla="*/ -1261 w 152696"/>
                <a:gd name="csY0" fmla="*/ 415 h 101718"/>
                <a:gd name="csX1" fmla="*/ 151436 w 152696"/>
                <a:gd name="csY1" fmla="*/ 102133 h 101718"/>
              </a:gdLst>
              <a:ahLst/>
              <a:cxnLst>
                <a:cxn ang="0">
                  <a:pos x="csX0" y="csY0"/>
                </a:cxn>
                <a:cxn ang="0">
                  <a:pos x="csX1" y="csY1"/>
                </a:cxn>
              </a:cxnLst>
              <a:rect l="l" t="t" r="r" b="b"/>
              <a:pathLst>
                <a:path w="152696" h="101718">
                  <a:moveTo>
                    <a:pt x="-1261" y="415"/>
                  </a:moveTo>
                  <a:lnTo>
                    <a:pt x="151436" y="102133"/>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4" name="フリーフォーム: 図形 23">
              <a:extLst>
                <a:ext uri="{FF2B5EF4-FFF2-40B4-BE49-F238E27FC236}">
                  <a16:creationId xmlns:a16="http://schemas.microsoft.com/office/drawing/2014/main" id="{A0960C70-8D1F-8544-1A06-4E20283E4108}"/>
                </a:ext>
              </a:extLst>
            </p:cNvPr>
            <p:cNvSpPr/>
            <p:nvPr/>
          </p:nvSpPr>
          <p:spPr>
            <a:xfrm>
              <a:off x="826451" y="4673035"/>
              <a:ext cx="94578" cy="28288"/>
            </a:xfrm>
            <a:custGeom>
              <a:avLst/>
              <a:gdLst>
                <a:gd name="csX0" fmla="*/ 93376 w 94578"/>
                <a:gd name="csY0" fmla="*/ 427 h 28288"/>
                <a:gd name="csX1" fmla="*/ -1203 w 94578"/>
                <a:gd name="csY1" fmla="*/ 28716 h 28288"/>
              </a:gdLst>
              <a:ahLst/>
              <a:cxnLst>
                <a:cxn ang="0">
                  <a:pos x="csX0" y="csY0"/>
                </a:cxn>
                <a:cxn ang="0">
                  <a:pos x="csX1" y="csY1"/>
                </a:cxn>
              </a:cxnLst>
              <a:rect l="l" t="t" r="r" b="b"/>
              <a:pathLst>
                <a:path w="94578" h="28288">
                  <a:moveTo>
                    <a:pt x="93376" y="427"/>
                  </a:moveTo>
                  <a:lnTo>
                    <a:pt x="-1203" y="28716"/>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5" name="フリーフォーム: 図形 24">
              <a:extLst>
                <a:ext uri="{FF2B5EF4-FFF2-40B4-BE49-F238E27FC236}">
                  <a16:creationId xmlns:a16="http://schemas.microsoft.com/office/drawing/2014/main" id="{4BCF7800-752D-921F-A14F-D871DD06193E}"/>
                </a:ext>
              </a:extLst>
            </p:cNvPr>
            <p:cNvSpPr/>
            <p:nvPr/>
          </p:nvSpPr>
          <p:spPr>
            <a:xfrm>
              <a:off x="899243" y="4720040"/>
              <a:ext cx="67600" cy="206539"/>
            </a:xfrm>
            <a:custGeom>
              <a:avLst/>
              <a:gdLst>
                <a:gd name="csX0" fmla="*/ 66384 w 67600"/>
                <a:gd name="csY0" fmla="*/ 396 h 206539"/>
                <a:gd name="csX1" fmla="*/ -1217 w 67600"/>
                <a:gd name="csY1" fmla="*/ 206936 h 206539"/>
              </a:gdLst>
              <a:ahLst/>
              <a:cxnLst>
                <a:cxn ang="0">
                  <a:pos x="csX0" y="csY0"/>
                </a:cxn>
                <a:cxn ang="0">
                  <a:pos x="csX1" y="csY1"/>
                </a:cxn>
              </a:cxnLst>
              <a:rect l="l" t="t" r="r" b="b"/>
              <a:pathLst>
                <a:path w="67600" h="206539">
                  <a:moveTo>
                    <a:pt x="66384" y="396"/>
                  </a:moveTo>
                  <a:lnTo>
                    <a:pt x="-1217" y="206936"/>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6" name="フリーフォーム: 図形 25">
              <a:extLst>
                <a:ext uri="{FF2B5EF4-FFF2-40B4-BE49-F238E27FC236}">
                  <a16:creationId xmlns:a16="http://schemas.microsoft.com/office/drawing/2014/main" id="{C8352380-CCBD-CB83-5B2D-D4DECCF2F039}"/>
                </a:ext>
              </a:extLst>
            </p:cNvPr>
            <p:cNvSpPr/>
            <p:nvPr/>
          </p:nvSpPr>
          <p:spPr>
            <a:xfrm>
              <a:off x="1635331" y="5638463"/>
              <a:ext cx="243492" cy="261836"/>
            </a:xfrm>
            <a:custGeom>
              <a:avLst/>
              <a:gdLst>
                <a:gd name="csX0" fmla="*/ 242086 w 243492"/>
                <a:gd name="csY0" fmla="*/ 178 h 261836"/>
                <a:gd name="csX1" fmla="*/ -1407 w 243492"/>
                <a:gd name="csY1" fmla="*/ 262014 h 261836"/>
              </a:gdLst>
              <a:ahLst/>
              <a:cxnLst>
                <a:cxn ang="0">
                  <a:pos x="csX0" y="csY0"/>
                </a:cxn>
                <a:cxn ang="0">
                  <a:pos x="csX1" y="csY1"/>
                </a:cxn>
              </a:cxnLst>
              <a:rect l="l" t="t" r="r" b="b"/>
              <a:pathLst>
                <a:path w="243492" h="261836">
                  <a:moveTo>
                    <a:pt x="242086" y="178"/>
                  </a:moveTo>
                  <a:lnTo>
                    <a:pt x="-1407" y="262014"/>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7" name="フリーフォーム: 図形 26">
              <a:extLst>
                <a:ext uri="{FF2B5EF4-FFF2-40B4-BE49-F238E27FC236}">
                  <a16:creationId xmlns:a16="http://schemas.microsoft.com/office/drawing/2014/main" id="{7165B5D9-672C-8342-2C6E-DFF26E1D9780}"/>
                </a:ext>
              </a:extLst>
            </p:cNvPr>
            <p:cNvSpPr/>
            <p:nvPr/>
          </p:nvSpPr>
          <p:spPr>
            <a:xfrm rot="18775262">
              <a:off x="1877883" y="5630402"/>
              <a:ext cx="5900" cy="11801"/>
            </a:xfrm>
            <a:custGeom>
              <a:avLst/>
              <a:gdLst>
                <a:gd name="csX0" fmla="*/ 429 w 5900"/>
                <a:gd name="csY0" fmla="*/ 12101 h 11801"/>
                <a:gd name="csX1" fmla="*/ 6330 w 5900"/>
                <a:gd name="csY1" fmla="*/ 6200 h 11801"/>
                <a:gd name="csX2" fmla="*/ 429 w 5900"/>
                <a:gd name="csY2" fmla="*/ 300 h 11801"/>
              </a:gdLst>
              <a:ahLst/>
              <a:cxnLst>
                <a:cxn ang="0">
                  <a:pos x="csX0" y="csY0"/>
                </a:cxn>
                <a:cxn ang="0">
                  <a:pos x="csX1" y="csY1"/>
                </a:cxn>
                <a:cxn ang="0">
                  <a:pos x="csX2" y="csY2"/>
                </a:cxn>
              </a:cxnLst>
              <a:rect l="l" t="t" r="r" b="b"/>
              <a:pathLst>
                <a:path w="5900" h="11801">
                  <a:moveTo>
                    <a:pt x="429" y="12101"/>
                  </a:moveTo>
                  <a:cubicBezTo>
                    <a:pt x="3688" y="12101"/>
                    <a:pt x="6330" y="9459"/>
                    <a:pt x="6330" y="6200"/>
                  </a:cubicBezTo>
                  <a:cubicBezTo>
                    <a:pt x="6330" y="2941"/>
                    <a:pt x="3688" y="300"/>
                    <a:pt x="429" y="300"/>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8" name="フリーフォーム: 図形 27">
              <a:extLst>
                <a:ext uri="{FF2B5EF4-FFF2-40B4-BE49-F238E27FC236}">
                  <a16:creationId xmlns:a16="http://schemas.microsoft.com/office/drawing/2014/main" id="{94062FB4-25CC-DECA-7882-5C507ABDF8C3}"/>
                </a:ext>
              </a:extLst>
            </p:cNvPr>
            <p:cNvSpPr/>
            <p:nvPr/>
          </p:nvSpPr>
          <p:spPr>
            <a:xfrm rot="7975262">
              <a:off x="1591687" y="5906331"/>
              <a:ext cx="51926" cy="25963"/>
            </a:xfrm>
            <a:custGeom>
              <a:avLst/>
              <a:gdLst>
                <a:gd name="csX0" fmla="*/ 380 w 51926"/>
                <a:gd name="csY0" fmla="*/ 354 h 25963"/>
                <a:gd name="csX1" fmla="*/ 52307 w 51926"/>
                <a:gd name="csY1" fmla="*/ 13336 h 25963"/>
                <a:gd name="csX2" fmla="*/ 380 w 51926"/>
                <a:gd name="csY2" fmla="*/ 26317 h 25963"/>
              </a:gdLst>
              <a:ahLst/>
              <a:cxnLst>
                <a:cxn ang="0">
                  <a:pos x="csX0" y="csY0"/>
                </a:cxn>
                <a:cxn ang="0">
                  <a:pos x="csX1" y="csY1"/>
                </a:cxn>
                <a:cxn ang="0">
                  <a:pos x="csX2" y="csY2"/>
                </a:cxn>
              </a:cxnLst>
              <a:rect l="l" t="t" r="r" b="b"/>
              <a:pathLst>
                <a:path w="51926" h="25963">
                  <a:moveTo>
                    <a:pt x="380" y="354"/>
                  </a:moveTo>
                  <a:cubicBezTo>
                    <a:pt x="17689" y="9009"/>
                    <a:pt x="34998" y="13336"/>
                    <a:pt x="52307" y="13336"/>
                  </a:cubicBezTo>
                  <a:cubicBezTo>
                    <a:pt x="34998" y="13336"/>
                    <a:pt x="17689" y="17663"/>
                    <a:pt x="380" y="26317"/>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29" name="フリーフォーム: 図形 28">
              <a:extLst>
                <a:ext uri="{FF2B5EF4-FFF2-40B4-BE49-F238E27FC236}">
                  <a16:creationId xmlns:a16="http://schemas.microsoft.com/office/drawing/2014/main" id="{4347980C-A278-7645-C618-B070B3BA74A9}"/>
                </a:ext>
              </a:extLst>
            </p:cNvPr>
            <p:cNvSpPr/>
            <p:nvPr/>
          </p:nvSpPr>
          <p:spPr>
            <a:xfrm>
              <a:off x="1670511" y="5314824"/>
              <a:ext cx="209720" cy="242738"/>
            </a:xfrm>
            <a:custGeom>
              <a:avLst/>
              <a:gdLst>
                <a:gd name="csX0" fmla="*/ 208309 w 209720"/>
                <a:gd name="csY0" fmla="*/ 242993 h 242738"/>
                <a:gd name="csX1" fmla="*/ -1411 w 209720"/>
                <a:gd name="csY1" fmla="*/ 254 h 242738"/>
              </a:gdLst>
              <a:ahLst/>
              <a:cxnLst>
                <a:cxn ang="0">
                  <a:pos x="csX0" y="csY0"/>
                </a:cxn>
                <a:cxn ang="0">
                  <a:pos x="csX1" y="csY1"/>
                </a:cxn>
              </a:cxnLst>
              <a:rect l="l" t="t" r="r" b="b"/>
              <a:pathLst>
                <a:path w="209720" h="242738">
                  <a:moveTo>
                    <a:pt x="208309" y="242993"/>
                  </a:moveTo>
                  <a:lnTo>
                    <a:pt x="-1411" y="254"/>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0" name="フリーフォーム: 図形 29">
              <a:extLst>
                <a:ext uri="{FF2B5EF4-FFF2-40B4-BE49-F238E27FC236}">
                  <a16:creationId xmlns:a16="http://schemas.microsoft.com/office/drawing/2014/main" id="{FA19DF96-D560-B9DB-384F-C18E38667D1A}"/>
                </a:ext>
              </a:extLst>
            </p:cNvPr>
            <p:cNvSpPr/>
            <p:nvPr/>
          </p:nvSpPr>
          <p:spPr>
            <a:xfrm rot="2950428">
              <a:off x="1879209" y="5553894"/>
              <a:ext cx="5900" cy="11801"/>
            </a:xfrm>
            <a:custGeom>
              <a:avLst/>
              <a:gdLst>
                <a:gd name="csX0" fmla="*/ 430 w 5900"/>
                <a:gd name="csY0" fmla="*/ 12086 h 11801"/>
                <a:gd name="csX1" fmla="*/ 6330 w 5900"/>
                <a:gd name="csY1" fmla="*/ 6186 h 11801"/>
                <a:gd name="csX2" fmla="*/ 430 w 5900"/>
                <a:gd name="csY2" fmla="*/ 285 h 11801"/>
              </a:gdLst>
              <a:ahLst/>
              <a:cxnLst>
                <a:cxn ang="0">
                  <a:pos x="csX0" y="csY0"/>
                </a:cxn>
                <a:cxn ang="0">
                  <a:pos x="csX1" y="csY1"/>
                </a:cxn>
                <a:cxn ang="0">
                  <a:pos x="csX2" y="csY2"/>
                </a:cxn>
              </a:cxnLst>
              <a:rect l="l" t="t" r="r" b="b"/>
              <a:pathLst>
                <a:path w="5900" h="11801">
                  <a:moveTo>
                    <a:pt x="430" y="12086"/>
                  </a:moveTo>
                  <a:cubicBezTo>
                    <a:pt x="3689" y="12086"/>
                    <a:pt x="6330" y="9444"/>
                    <a:pt x="6330" y="6186"/>
                  </a:cubicBezTo>
                  <a:cubicBezTo>
                    <a:pt x="6330" y="2927"/>
                    <a:pt x="3689" y="285"/>
                    <a:pt x="430" y="285"/>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1" name="フリーフォーム: 図形 30">
              <a:extLst>
                <a:ext uri="{FF2B5EF4-FFF2-40B4-BE49-F238E27FC236}">
                  <a16:creationId xmlns:a16="http://schemas.microsoft.com/office/drawing/2014/main" id="{BA3086F1-6847-C2F6-C637-E62CD4001CAE}"/>
                </a:ext>
              </a:extLst>
            </p:cNvPr>
            <p:cNvSpPr/>
            <p:nvPr/>
          </p:nvSpPr>
          <p:spPr>
            <a:xfrm rot="13750428">
              <a:off x="1627573" y="5282196"/>
              <a:ext cx="51926" cy="25963"/>
            </a:xfrm>
            <a:custGeom>
              <a:avLst/>
              <a:gdLst>
                <a:gd name="csX0" fmla="*/ 387 w 51926"/>
                <a:gd name="csY0" fmla="*/ 234 h 25963"/>
                <a:gd name="csX1" fmla="*/ 52313 w 51926"/>
                <a:gd name="csY1" fmla="*/ 13215 h 25963"/>
                <a:gd name="csX2" fmla="*/ 387 w 51926"/>
                <a:gd name="csY2" fmla="*/ 26197 h 25963"/>
              </a:gdLst>
              <a:ahLst/>
              <a:cxnLst>
                <a:cxn ang="0">
                  <a:pos x="csX0" y="csY0"/>
                </a:cxn>
                <a:cxn ang="0">
                  <a:pos x="csX1" y="csY1"/>
                </a:cxn>
                <a:cxn ang="0">
                  <a:pos x="csX2" y="csY2"/>
                </a:cxn>
              </a:cxnLst>
              <a:rect l="l" t="t" r="r" b="b"/>
              <a:pathLst>
                <a:path w="51926" h="25963">
                  <a:moveTo>
                    <a:pt x="387" y="234"/>
                  </a:moveTo>
                  <a:cubicBezTo>
                    <a:pt x="17696" y="8888"/>
                    <a:pt x="35005" y="13215"/>
                    <a:pt x="52313" y="13215"/>
                  </a:cubicBezTo>
                  <a:cubicBezTo>
                    <a:pt x="35005" y="13215"/>
                    <a:pt x="17696" y="17543"/>
                    <a:pt x="387" y="26197"/>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2" name="フリーフォーム: 図形 31">
              <a:extLst>
                <a:ext uri="{FF2B5EF4-FFF2-40B4-BE49-F238E27FC236}">
                  <a16:creationId xmlns:a16="http://schemas.microsoft.com/office/drawing/2014/main" id="{973F9BB0-6A0C-AC5D-6F5F-1D69BDF0F0B8}"/>
                </a:ext>
              </a:extLst>
            </p:cNvPr>
            <p:cNvSpPr/>
            <p:nvPr/>
          </p:nvSpPr>
          <p:spPr>
            <a:xfrm>
              <a:off x="1607067" y="5516868"/>
              <a:ext cx="248085" cy="65772"/>
            </a:xfrm>
            <a:custGeom>
              <a:avLst/>
              <a:gdLst>
                <a:gd name="csX0" fmla="*/ -1401 w 248085"/>
                <a:gd name="csY0" fmla="*/ 228 h 65772"/>
                <a:gd name="csX1" fmla="*/ 246685 w 248085"/>
                <a:gd name="csY1" fmla="*/ 66001 h 65772"/>
              </a:gdLst>
              <a:ahLst/>
              <a:cxnLst>
                <a:cxn ang="0">
                  <a:pos x="csX0" y="csY0"/>
                </a:cxn>
                <a:cxn ang="0">
                  <a:pos x="csX1" y="csY1"/>
                </a:cxn>
              </a:cxnLst>
              <a:rect l="l" t="t" r="r" b="b"/>
              <a:pathLst>
                <a:path w="248085" h="65772">
                  <a:moveTo>
                    <a:pt x="-1401" y="228"/>
                  </a:moveTo>
                  <a:lnTo>
                    <a:pt x="246685" y="66001"/>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3" name="フリーフォーム: 図形 32">
              <a:extLst>
                <a:ext uri="{FF2B5EF4-FFF2-40B4-BE49-F238E27FC236}">
                  <a16:creationId xmlns:a16="http://schemas.microsoft.com/office/drawing/2014/main" id="{377AE1D9-A6D3-D3C2-E25E-E6699A4D6252}"/>
                </a:ext>
              </a:extLst>
            </p:cNvPr>
            <p:cNvSpPr/>
            <p:nvPr/>
          </p:nvSpPr>
          <p:spPr>
            <a:xfrm>
              <a:off x="1274614" y="5600267"/>
              <a:ext cx="566014" cy="11680"/>
            </a:xfrm>
            <a:custGeom>
              <a:avLst/>
              <a:gdLst>
                <a:gd name="csX0" fmla="*/ -1361 w 566014"/>
                <a:gd name="csY0" fmla="*/ 11895 h 11680"/>
                <a:gd name="csX1" fmla="*/ 564654 w 566014"/>
                <a:gd name="csY1" fmla="*/ 215 h 11680"/>
              </a:gdLst>
              <a:ahLst/>
              <a:cxnLst>
                <a:cxn ang="0">
                  <a:pos x="csX0" y="csY0"/>
                </a:cxn>
                <a:cxn ang="0">
                  <a:pos x="csX1" y="csY1"/>
                </a:cxn>
              </a:cxnLst>
              <a:rect l="l" t="t" r="r" b="b"/>
              <a:pathLst>
                <a:path w="566014" h="11680">
                  <a:moveTo>
                    <a:pt x="-1361" y="11895"/>
                  </a:moveTo>
                  <a:lnTo>
                    <a:pt x="564654" y="215"/>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4" name="フリーフォーム: 図形 33">
              <a:extLst>
                <a:ext uri="{FF2B5EF4-FFF2-40B4-BE49-F238E27FC236}">
                  <a16:creationId xmlns:a16="http://schemas.microsoft.com/office/drawing/2014/main" id="{64D7395B-2BFE-0C63-5192-FF83FE973455}"/>
                </a:ext>
              </a:extLst>
            </p:cNvPr>
            <p:cNvSpPr/>
            <p:nvPr/>
          </p:nvSpPr>
          <p:spPr>
            <a:xfrm>
              <a:off x="824963" y="5164825"/>
              <a:ext cx="115897" cy="55806"/>
            </a:xfrm>
            <a:custGeom>
              <a:avLst/>
              <a:gdLst>
                <a:gd name="csX0" fmla="*/ 114692 w 115897"/>
                <a:gd name="csY0" fmla="*/ 311 h 55806"/>
                <a:gd name="csX1" fmla="*/ -1205 w 115897"/>
                <a:gd name="csY1" fmla="*/ 56117 h 55806"/>
              </a:gdLst>
              <a:ahLst/>
              <a:cxnLst>
                <a:cxn ang="0">
                  <a:pos x="csX0" y="csY0"/>
                </a:cxn>
                <a:cxn ang="0">
                  <a:pos x="csX1" y="csY1"/>
                </a:cxn>
              </a:cxnLst>
              <a:rect l="l" t="t" r="r" b="b"/>
              <a:pathLst>
                <a:path w="115897" h="55806">
                  <a:moveTo>
                    <a:pt x="114692" y="311"/>
                  </a:moveTo>
                  <a:lnTo>
                    <a:pt x="-1205" y="56117"/>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5" name="フリーフォーム: 図形 34">
              <a:extLst>
                <a:ext uri="{FF2B5EF4-FFF2-40B4-BE49-F238E27FC236}">
                  <a16:creationId xmlns:a16="http://schemas.microsoft.com/office/drawing/2014/main" id="{5B228A55-F4E0-0731-D9C6-86E87BF8CD63}"/>
                </a:ext>
              </a:extLst>
            </p:cNvPr>
            <p:cNvSpPr/>
            <p:nvPr/>
          </p:nvSpPr>
          <p:spPr>
            <a:xfrm>
              <a:off x="1080203" y="4867460"/>
              <a:ext cx="132696" cy="169912"/>
            </a:xfrm>
            <a:custGeom>
              <a:avLst/>
              <a:gdLst>
                <a:gd name="csX0" fmla="*/ 131431 w 132696"/>
                <a:gd name="csY0" fmla="*/ 366 h 169912"/>
                <a:gd name="csX1" fmla="*/ -1266 w 132696"/>
                <a:gd name="csY1" fmla="*/ 170279 h 169912"/>
              </a:gdLst>
              <a:ahLst/>
              <a:cxnLst>
                <a:cxn ang="0">
                  <a:pos x="csX0" y="csY0"/>
                </a:cxn>
                <a:cxn ang="0">
                  <a:pos x="csX1" y="csY1"/>
                </a:cxn>
              </a:cxnLst>
              <a:rect l="l" t="t" r="r" b="b"/>
              <a:pathLst>
                <a:path w="132696" h="169912">
                  <a:moveTo>
                    <a:pt x="131431" y="366"/>
                  </a:moveTo>
                  <a:lnTo>
                    <a:pt x="-1266" y="170279"/>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6" name="フリーフォーム: 図形 35">
              <a:extLst>
                <a:ext uri="{FF2B5EF4-FFF2-40B4-BE49-F238E27FC236}">
                  <a16:creationId xmlns:a16="http://schemas.microsoft.com/office/drawing/2014/main" id="{BBD07288-F5BA-1378-7CDA-8DDF483DA3CD}"/>
                </a:ext>
              </a:extLst>
            </p:cNvPr>
            <p:cNvSpPr/>
            <p:nvPr/>
          </p:nvSpPr>
          <p:spPr>
            <a:xfrm rot="18479323">
              <a:off x="1211765" y="4859234"/>
              <a:ext cx="5900" cy="11801"/>
            </a:xfrm>
            <a:custGeom>
              <a:avLst/>
              <a:gdLst>
                <a:gd name="csX0" fmla="*/ 301 w 5900"/>
                <a:gd name="csY0" fmla="*/ 11952 h 11801"/>
                <a:gd name="csX1" fmla="*/ 6202 w 5900"/>
                <a:gd name="csY1" fmla="*/ 6052 h 11801"/>
                <a:gd name="csX2" fmla="*/ 301 w 5900"/>
                <a:gd name="csY2" fmla="*/ 151 h 11801"/>
              </a:gdLst>
              <a:ahLst/>
              <a:cxnLst>
                <a:cxn ang="0">
                  <a:pos x="csX0" y="csY0"/>
                </a:cxn>
                <a:cxn ang="0">
                  <a:pos x="csX1" y="csY1"/>
                </a:cxn>
                <a:cxn ang="0">
                  <a:pos x="csX2" y="csY2"/>
                </a:cxn>
              </a:cxnLst>
              <a:rect l="l" t="t" r="r" b="b"/>
              <a:pathLst>
                <a:path w="5900" h="11801">
                  <a:moveTo>
                    <a:pt x="301" y="11952"/>
                  </a:moveTo>
                  <a:cubicBezTo>
                    <a:pt x="3560" y="11952"/>
                    <a:pt x="6202" y="9310"/>
                    <a:pt x="6202" y="6052"/>
                  </a:cubicBezTo>
                  <a:cubicBezTo>
                    <a:pt x="6202" y="2793"/>
                    <a:pt x="3560" y="151"/>
                    <a:pt x="301" y="151"/>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7" name="フリーフォーム: 図形 36">
              <a:extLst>
                <a:ext uri="{FF2B5EF4-FFF2-40B4-BE49-F238E27FC236}">
                  <a16:creationId xmlns:a16="http://schemas.microsoft.com/office/drawing/2014/main" id="{10E67FC3-B629-E73C-5DAA-4720D76AFC91}"/>
                </a:ext>
              </a:extLst>
            </p:cNvPr>
            <p:cNvSpPr/>
            <p:nvPr/>
          </p:nvSpPr>
          <p:spPr>
            <a:xfrm rot="7679323">
              <a:off x="1038259" y="5044854"/>
              <a:ext cx="51926" cy="25963"/>
            </a:xfrm>
            <a:custGeom>
              <a:avLst/>
              <a:gdLst>
                <a:gd name="csX0" fmla="*/ 273 w 51926"/>
                <a:gd name="csY0" fmla="*/ 188 h 25963"/>
                <a:gd name="csX1" fmla="*/ 52200 w 51926"/>
                <a:gd name="csY1" fmla="*/ 13170 h 25963"/>
                <a:gd name="csX2" fmla="*/ 273 w 51926"/>
                <a:gd name="csY2" fmla="*/ 26151 h 25963"/>
              </a:gdLst>
              <a:ahLst/>
              <a:cxnLst>
                <a:cxn ang="0">
                  <a:pos x="csX0" y="csY0"/>
                </a:cxn>
                <a:cxn ang="0">
                  <a:pos x="csX1" y="csY1"/>
                </a:cxn>
                <a:cxn ang="0">
                  <a:pos x="csX2" y="csY2"/>
                </a:cxn>
              </a:cxnLst>
              <a:rect l="l" t="t" r="r" b="b"/>
              <a:pathLst>
                <a:path w="51926" h="25963">
                  <a:moveTo>
                    <a:pt x="273" y="188"/>
                  </a:moveTo>
                  <a:cubicBezTo>
                    <a:pt x="17582" y="8842"/>
                    <a:pt x="34891" y="13170"/>
                    <a:pt x="52200" y="13170"/>
                  </a:cubicBezTo>
                  <a:cubicBezTo>
                    <a:pt x="34891" y="13170"/>
                    <a:pt x="17582" y="17497"/>
                    <a:pt x="273" y="26151"/>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8" name="フリーフォーム: 図形 37">
              <a:extLst>
                <a:ext uri="{FF2B5EF4-FFF2-40B4-BE49-F238E27FC236}">
                  <a16:creationId xmlns:a16="http://schemas.microsoft.com/office/drawing/2014/main" id="{8657F210-A3A8-CA99-73D4-19D237560604}"/>
                </a:ext>
              </a:extLst>
            </p:cNvPr>
            <p:cNvSpPr/>
            <p:nvPr/>
          </p:nvSpPr>
          <p:spPr>
            <a:xfrm>
              <a:off x="915128" y="5026283"/>
              <a:ext cx="44295" cy="53344"/>
            </a:xfrm>
            <a:custGeom>
              <a:avLst/>
              <a:gdLst>
                <a:gd name="csX0" fmla="*/ 43077 w 44295"/>
                <a:gd name="csY0" fmla="*/ 53688 h 53344"/>
                <a:gd name="csX1" fmla="*/ -1218 w 44295"/>
                <a:gd name="csY1" fmla="*/ 343 h 53344"/>
              </a:gdLst>
              <a:ahLst/>
              <a:cxnLst>
                <a:cxn ang="0">
                  <a:pos x="csX0" y="csY0"/>
                </a:cxn>
                <a:cxn ang="0">
                  <a:pos x="csX1" y="csY1"/>
                </a:cxn>
              </a:cxnLst>
              <a:rect l="l" t="t" r="r" b="b"/>
              <a:pathLst>
                <a:path w="44295" h="53344">
                  <a:moveTo>
                    <a:pt x="43077" y="53688"/>
                  </a:moveTo>
                  <a:lnTo>
                    <a:pt x="-1218" y="343"/>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39" name="フリーフォーム: 図形 38">
              <a:extLst>
                <a:ext uri="{FF2B5EF4-FFF2-40B4-BE49-F238E27FC236}">
                  <a16:creationId xmlns:a16="http://schemas.microsoft.com/office/drawing/2014/main" id="{52E4B50A-512A-C918-0127-4A595F1DA0F5}"/>
                </a:ext>
              </a:extLst>
            </p:cNvPr>
            <p:cNvSpPr/>
            <p:nvPr/>
          </p:nvSpPr>
          <p:spPr>
            <a:xfrm>
              <a:off x="810200" y="4832982"/>
              <a:ext cx="45843" cy="98966"/>
            </a:xfrm>
            <a:custGeom>
              <a:avLst/>
              <a:gdLst>
                <a:gd name="csX0" fmla="*/ 44650 w 45843"/>
                <a:gd name="csY0" fmla="*/ 99349 h 98966"/>
                <a:gd name="csX1" fmla="*/ -1194 w 45843"/>
                <a:gd name="csY1" fmla="*/ 382 h 98966"/>
              </a:gdLst>
              <a:ahLst/>
              <a:cxnLst>
                <a:cxn ang="0">
                  <a:pos x="csX0" y="csY0"/>
                </a:cxn>
                <a:cxn ang="0">
                  <a:pos x="csX1" y="csY1"/>
                </a:cxn>
              </a:cxnLst>
              <a:rect l="l" t="t" r="r" b="b"/>
              <a:pathLst>
                <a:path w="45843" h="98966">
                  <a:moveTo>
                    <a:pt x="44650" y="99349"/>
                  </a:moveTo>
                  <a:lnTo>
                    <a:pt x="-1194" y="382"/>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0" name="フリーフォーム: 図形 39">
              <a:extLst>
                <a:ext uri="{FF2B5EF4-FFF2-40B4-BE49-F238E27FC236}">
                  <a16:creationId xmlns:a16="http://schemas.microsoft.com/office/drawing/2014/main" id="{00061286-D64A-3998-FF6D-E3E10BAC12F9}"/>
                </a:ext>
              </a:extLst>
            </p:cNvPr>
            <p:cNvSpPr/>
            <p:nvPr/>
          </p:nvSpPr>
          <p:spPr>
            <a:xfrm rot="3908731">
              <a:off x="854333" y="4928725"/>
              <a:ext cx="5900" cy="11801"/>
            </a:xfrm>
            <a:custGeom>
              <a:avLst/>
              <a:gdLst>
                <a:gd name="csX0" fmla="*/ 232 w 5900"/>
                <a:gd name="csY0" fmla="*/ 11966 h 11801"/>
                <a:gd name="csX1" fmla="*/ 6133 w 5900"/>
                <a:gd name="csY1" fmla="*/ 6065 h 11801"/>
                <a:gd name="csX2" fmla="*/ 232 w 5900"/>
                <a:gd name="csY2" fmla="*/ 164 h 11801"/>
              </a:gdLst>
              <a:ahLst/>
              <a:cxnLst>
                <a:cxn ang="0">
                  <a:pos x="csX0" y="csY0"/>
                </a:cxn>
                <a:cxn ang="0">
                  <a:pos x="csX1" y="csY1"/>
                </a:cxn>
                <a:cxn ang="0">
                  <a:pos x="csX2" y="csY2"/>
                </a:cxn>
              </a:cxnLst>
              <a:rect l="l" t="t" r="r" b="b"/>
              <a:pathLst>
                <a:path w="5900" h="11801">
                  <a:moveTo>
                    <a:pt x="232" y="11966"/>
                  </a:moveTo>
                  <a:cubicBezTo>
                    <a:pt x="3491" y="11966"/>
                    <a:pt x="6133" y="9324"/>
                    <a:pt x="6133" y="6065"/>
                  </a:cubicBezTo>
                  <a:cubicBezTo>
                    <a:pt x="6133" y="2806"/>
                    <a:pt x="3491" y="164"/>
                    <a:pt x="232" y="164"/>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1" name="フリーフォーム: 図形 40">
              <a:extLst>
                <a:ext uri="{FF2B5EF4-FFF2-40B4-BE49-F238E27FC236}">
                  <a16:creationId xmlns:a16="http://schemas.microsoft.com/office/drawing/2014/main" id="{7A061134-4220-6C56-0058-B4AC37F8679D}"/>
                </a:ext>
              </a:extLst>
            </p:cNvPr>
            <p:cNvSpPr/>
            <p:nvPr/>
          </p:nvSpPr>
          <p:spPr>
            <a:xfrm rot="14708731">
              <a:off x="773324" y="4796442"/>
              <a:ext cx="51926" cy="25963"/>
            </a:xfrm>
            <a:custGeom>
              <a:avLst/>
              <a:gdLst>
                <a:gd name="csX0" fmla="*/ 222 w 51926"/>
                <a:gd name="csY0" fmla="*/ 140 h 25963"/>
                <a:gd name="csX1" fmla="*/ 52149 w 51926"/>
                <a:gd name="csY1" fmla="*/ 13122 h 25963"/>
                <a:gd name="csX2" fmla="*/ 222 w 51926"/>
                <a:gd name="csY2" fmla="*/ 26103 h 25963"/>
              </a:gdLst>
              <a:ahLst/>
              <a:cxnLst>
                <a:cxn ang="0">
                  <a:pos x="csX0" y="csY0"/>
                </a:cxn>
                <a:cxn ang="0">
                  <a:pos x="csX1" y="csY1"/>
                </a:cxn>
                <a:cxn ang="0">
                  <a:pos x="csX2" y="csY2"/>
                </a:cxn>
              </a:cxnLst>
              <a:rect l="l" t="t" r="r" b="b"/>
              <a:pathLst>
                <a:path w="51926" h="25963">
                  <a:moveTo>
                    <a:pt x="222" y="140"/>
                  </a:moveTo>
                  <a:cubicBezTo>
                    <a:pt x="17531" y="8794"/>
                    <a:pt x="34840" y="13122"/>
                    <a:pt x="52149" y="13122"/>
                  </a:cubicBezTo>
                  <a:cubicBezTo>
                    <a:pt x="34840" y="13122"/>
                    <a:pt x="17531" y="17449"/>
                    <a:pt x="222" y="26103"/>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2" name="フリーフォーム: 図形 41">
              <a:extLst>
                <a:ext uri="{FF2B5EF4-FFF2-40B4-BE49-F238E27FC236}">
                  <a16:creationId xmlns:a16="http://schemas.microsoft.com/office/drawing/2014/main" id="{63C454B2-A8B3-F6FA-E150-673598FDFB37}"/>
                </a:ext>
              </a:extLst>
            </p:cNvPr>
            <p:cNvSpPr/>
            <p:nvPr/>
          </p:nvSpPr>
          <p:spPr>
            <a:xfrm>
              <a:off x="933714" y="4868499"/>
              <a:ext cx="211852" cy="92551"/>
            </a:xfrm>
            <a:custGeom>
              <a:avLst/>
              <a:gdLst>
                <a:gd name="csX0" fmla="*/ -1241 w 211852"/>
                <a:gd name="csY0" fmla="*/ 92927 h 92551"/>
                <a:gd name="csX1" fmla="*/ 210611 w 211852"/>
                <a:gd name="csY1" fmla="*/ 375 h 92551"/>
              </a:gdLst>
              <a:ahLst/>
              <a:cxnLst>
                <a:cxn ang="0">
                  <a:pos x="csX0" y="csY0"/>
                </a:cxn>
                <a:cxn ang="0">
                  <a:pos x="csX1" y="csY1"/>
                </a:cxn>
              </a:cxnLst>
              <a:rect l="l" t="t" r="r" b="b"/>
              <a:pathLst>
                <a:path w="211852" h="92551">
                  <a:moveTo>
                    <a:pt x="-1241" y="92927"/>
                  </a:moveTo>
                  <a:lnTo>
                    <a:pt x="210611" y="375"/>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3" name="フリーフォーム: 図形 42">
              <a:extLst>
                <a:ext uri="{FF2B5EF4-FFF2-40B4-BE49-F238E27FC236}">
                  <a16:creationId xmlns:a16="http://schemas.microsoft.com/office/drawing/2014/main" id="{C47C5F54-0C2E-DE78-C865-0826D87BA8F5}"/>
                </a:ext>
              </a:extLst>
            </p:cNvPr>
            <p:cNvSpPr/>
            <p:nvPr/>
          </p:nvSpPr>
          <p:spPr>
            <a:xfrm rot="9384055">
              <a:off x="928060" y="4956331"/>
              <a:ext cx="5900" cy="11801"/>
            </a:xfrm>
            <a:custGeom>
              <a:avLst/>
              <a:gdLst>
                <a:gd name="csX0" fmla="*/ 246 w 5900"/>
                <a:gd name="csY0" fmla="*/ 11971 h 11801"/>
                <a:gd name="csX1" fmla="*/ 6147 w 5900"/>
                <a:gd name="csY1" fmla="*/ 6070 h 11801"/>
                <a:gd name="csX2" fmla="*/ 246 w 5900"/>
                <a:gd name="csY2" fmla="*/ 170 h 11801"/>
              </a:gdLst>
              <a:ahLst/>
              <a:cxnLst>
                <a:cxn ang="0">
                  <a:pos x="csX0" y="csY0"/>
                </a:cxn>
                <a:cxn ang="0">
                  <a:pos x="csX1" y="csY1"/>
                </a:cxn>
                <a:cxn ang="0">
                  <a:pos x="csX2" y="csY2"/>
                </a:cxn>
              </a:cxnLst>
              <a:rect l="l" t="t" r="r" b="b"/>
              <a:pathLst>
                <a:path w="5900" h="11801">
                  <a:moveTo>
                    <a:pt x="246" y="11971"/>
                  </a:moveTo>
                  <a:cubicBezTo>
                    <a:pt x="3505" y="11971"/>
                    <a:pt x="6147" y="9329"/>
                    <a:pt x="6147" y="6070"/>
                  </a:cubicBezTo>
                  <a:cubicBezTo>
                    <a:pt x="6147" y="2811"/>
                    <a:pt x="3505" y="170"/>
                    <a:pt x="246" y="170"/>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4" name="フリーフォーム: 図形 43">
              <a:extLst>
                <a:ext uri="{FF2B5EF4-FFF2-40B4-BE49-F238E27FC236}">
                  <a16:creationId xmlns:a16="http://schemas.microsoft.com/office/drawing/2014/main" id="{BF968EF1-B237-E33D-67A9-A2B02920E52C}"/>
                </a:ext>
              </a:extLst>
            </p:cNvPr>
            <p:cNvSpPr/>
            <p:nvPr/>
          </p:nvSpPr>
          <p:spPr>
            <a:xfrm rot="20184055">
              <a:off x="1143395" y="4845123"/>
              <a:ext cx="51926" cy="25963"/>
            </a:xfrm>
            <a:custGeom>
              <a:avLst/>
              <a:gdLst>
                <a:gd name="csX0" fmla="*/ 293 w 51926"/>
                <a:gd name="csY0" fmla="*/ 149 h 25963"/>
                <a:gd name="csX1" fmla="*/ 52220 w 51926"/>
                <a:gd name="csY1" fmla="*/ 13131 h 25963"/>
                <a:gd name="csX2" fmla="*/ 293 w 51926"/>
                <a:gd name="csY2" fmla="*/ 26113 h 25963"/>
              </a:gdLst>
              <a:ahLst/>
              <a:cxnLst>
                <a:cxn ang="0">
                  <a:pos x="csX0" y="csY0"/>
                </a:cxn>
                <a:cxn ang="0">
                  <a:pos x="csX1" y="csY1"/>
                </a:cxn>
                <a:cxn ang="0">
                  <a:pos x="csX2" y="csY2"/>
                </a:cxn>
              </a:cxnLst>
              <a:rect l="l" t="t" r="r" b="b"/>
              <a:pathLst>
                <a:path w="51926" h="25963">
                  <a:moveTo>
                    <a:pt x="293" y="149"/>
                  </a:moveTo>
                  <a:cubicBezTo>
                    <a:pt x="17602" y="8804"/>
                    <a:pt x="34911" y="13131"/>
                    <a:pt x="52220" y="13131"/>
                  </a:cubicBezTo>
                  <a:cubicBezTo>
                    <a:pt x="34911" y="13131"/>
                    <a:pt x="17602" y="17458"/>
                    <a:pt x="293" y="26113"/>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5" name="フリーフォーム: 図形 44">
              <a:extLst>
                <a:ext uri="{FF2B5EF4-FFF2-40B4-BE49-F238E27FC236}">
                  <a16:creationId xmlns:a16="http://schemas.microsoft.com/office/drawing/2014/main" id="{0A8F9B01-D8B6-0BF6-3305-F1EAE2D6C9E5}"/>
                </a:ext>
              </a:extLst>
            </p:cNvPr>
            <p:cNvSpPr/>
            <p:nvPr/>
          </p:nvSpPr>
          <p:spPr>
            <a:xfrm>
              <a:off x="1556854" y="5343197"/>
              <a:ext cx="14354" cy="91307"/>
            </a:xfrm>
            <a:custGeom>
              <a:avLst/>
              <a:gdLst>
                <a:gd name="csX0" fmla="*/ -1362 w 14354"/>
                <a:gd name="csY0" fmla="*/ 91573 h 91307"/>
                <a:gd name="csX1" fmla="*/ 12992 w 14354"/>
                <a:gd name="csY1" fmla="*/ 265 h 91307"/>
              </a:gdLst>
              <a:ahLst/>
              <a:cxnLst>
                <a:cxn ang="0">
                  <a:pos x="csX0" y="csY0"/>
                </a:cxn>
                <a:cxn ang="0">
                  <a:pos x="csX1" y="csY1"/>
                </a:cxn>
              </a:cxnLst>
              <a:rect l="l" t="t" r="r" b="b"/>
              <a:pathLst>
                <a:path w="14354" h="91307">
                  <a:moveTo>
                    <a:pt x="-1362" y="91573"/>
                  </a:moveTo>
                  <a:lnTo>
                    <a:pt x="12992" y="265"/>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6" name="フリーフォーム: 図形 45">
              <a:extLst>
                <a:ext uri="{FF2B5EF4-FFF2-40B4-BE49-F238E27FC236}">
                  <a16:creationId xmlns:a16="http://schemas.microsoft.com/office/drawing/2014/main" id="{7AE04EA2-48BC-0C41-EEDA-5A3E88A23F3E}"/>
                </a:ext>
              </a:extLst>
            </p:cNvPr>
            <p:cNvSpPr/>
            <p:nvPr/>
          </p:nvSpPr>
          <p:spPr>
            <a:xfrm rot="5936068">
              <a:off x="1553445" y="5431518"/>
              <a:ext cx="5900" cy="11801"/>
            </a:xfrm>
            <a:custGeom>
              <a:avLst/>
              <a:gdLst>
                <a:gd name="csX0" fmla="*/ 367 w 5900"/>
                <a:gd name="csY0" fmla="*/ 12063 h 11801"/>
                <a:gd name="csX1" fmla="*/ 6268 w 5900"/>
                <a:gd name="csY1" fmla="*/ 6162 h 11801"/>
                <a:gd name="csX2" fmla="*/ 367 w 5900"/>
                <a:gd name="csY2" fmla="*/ 261 h 11801"/>
              </a:gdLst>
              <a:ahLst/>
              <a:cxnLst>
                <a:cxn ang="0">
                  <a:pos x="csX0" y="csY0"/>
                </a:cxn>
                <a:cxn ang="0">
                  <a:pos x="csX1" y="csY1"/>
                </a:cxn>
                <a:cxn ang="0">
                  <a:pos x="csX2" y="csY2"/>
                </a:cxn>
              </a:cxnLst>
              <a:rect l="l" t="t" r="r" b="b"/>
              <a:pathLst>
                <a:path w="5900" h="11801">
                  <a:moveTo>
                    <a:pt x="367" y="12063"/>
                  </a:moveTo>
                  <a:cubicBezTo>
                    <a:pt x="3626" y="12063"/>
                    <a:pt x="6268" y="9421"/>
                    <a:pt x="6268" y="6162"/>
                  </a:cubicBezTo>
                  <a:cubicBezTo>
                    <a:pt x="6268" y="2903"/>
                    <a:pt x="3626" y="261"/>
                    <a:pt x="367" y="261"/>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7" name="フリーフォーム: 図形 46">
              <a:extLst>
                <a:ext uri="{FF2B5EF4-FFF2-40B4-BE49-F238E27FC236}">
                  <a16:creationId xmlns:a16="http://schemas.microsoft.com/office/drawing/2014/main" id="{98440B5E-90AA-05E2-C763-96837D342282}"/>
                </a:ext>
              </a:extLst>
            </p:cNvPr>
            <p:cNvSpPr/>
            <p:nvPr/>
          </p:nvSpPr>
          <p:spPr>
            <a:xfrm rot="16736068">
              <a:off x="1549278" y="5304567"/>
              <a:ext cx="51926" cy="25963"/>
            </a:xfrm>
            <a:custGeom>
              <a:avLst/>
              <a:gdLst>
                <a:gd name="csX0" fmla="*/ 372 w 51926"/>
                <a:gd name="csY0" fmla="*/ 238 h 25963"/>
                <a:gd name="csX1" fmla="*/ 52298 w 51926"/>
                <a:gd name="csY1" fmla="*/ 13220 h 25963"/>
                <a:gd name="csX2" fmla="*/ 372 w 51926"/>
                <a:gd name="csY2" fmla="*/ 26201 h 25963"/>
              </a:gdLst>
              <a:ahLst/>
              <a:cxnLst>
                <a:cxn ang="0">
                  <a:pos x="csX0" y="csY0"/>
                </a:cxn>
                <a:cxn ang="0">
                  <a:pos x="csX1" y="csY1"/>
                </a:cxn>
                <a:cxn ang="0">
                  <a:pos x="csX2" y="csY2"/>
                </a:cxn>
              </a:cxnLst>
              <a:rect l="l" t="t" r="r" b="b"/>
              <a:pathLst>
                <a:path w="51926" h="25963">
                  <a:moveTo>
                    <a:pt x="372" y="238"/>
                  </a:moveTo>
                  <a:cubicBezTo>
                    <a:pt x="17681" y="8892"/>
                    <a:pt x="34989" y="13220"/>
                    <a:pt x="52298" y="13220"/>
                  </a:cubicBezTo>
                  <a:cubicBezTo>
                    <a:pt x="34989" y="13220"/>
                    <a:pt x="17681" y="17547"/>
                    <a:pt x="372" y="26201"/>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8" name="フリーフォーム: 図形 47">
              <a:extLst>
                <a:ext uri="{FF2B5EF4-FFF2-40B4-BE49-F238E27FC236}">
                  <a16:creationId xmlns:a16="http://schemas.microsoft.com/office/drawing/2014/main" id="{DE799708-7A46-C6C2-E2CB-A58DB5C09C55}"/>
                </a:ext>
              </a:extLst>
            </p:cNvPr>
            <p:cNvSpPr/>
            <p:nvPr/>
          </p:nvSpPr>
          <p:spPr>
            <a:xfrm>
              <a:off x="1632089" y="5564501"/>
              <a:ext cx="255339" cy="189911"/>
            </a:xfrm>
            <a:custGeom>
              <a:avLst/>
              <a:gdLst>
                <a:gd name="csX0" fmla="*/ 253932 w 255339"/>
                <a:gd name="csY0" fmla="*/ 190114 h 189911"/>
                <a:gd name="csX1" fmla="*/ -1407 w 255339"/>
                <a:gd name="csY1" fmla="*/ 203 h 189911"/>
              </a:gdLst>
              <a:ahLst/>
              <a:cxnLst>
                <a:cxn ang="0">
                  <a:pos x="csX0" y="csY0"/>
                </a:cxn>
                <a:cxn ang="0">
                  <a:pos x="csX1" y="csY1"/>
                </a:cxn>
              </a:cxnLst>
              <a:rect l="l" t="t" r="r" b="b"/>
              <a:pathLst>
                <a:path w="255339" h="189911">
                  <a:moveTo>
                    <a:pt x="253932" y="190114"/>
                  </a:moveTo>
                  <a:lnTo>
                    <a:pt x="-1407" y="203"/>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49" name="フリーフォーム: 図形 48">
              <a:extLst>
                <a:ext uri="{FF2B5EF4-FFF2-40B4-BE49-F238E27FC236}">
                  <a16:creationId xmlns:a16="http://schemas.microsoft.com/office/drawing/2014/main" id="{A08D2943-CEB9-C4AD-CF08-61BDE42D509B}"/>
                </a:ext>
              </a:extLst>
            </p:cNvPr>
            <p:cNvSpPr/>
            <p:nvPr/>
          </p:nvSpPr>
          <p:spPr>
            <a:xfrm rot="2198424">
              <a:off x="1886846" y="5750272"/>
              <a:ext cx="5900" cy="11801"/>
            </a:xfrm>
            <a:custGeom>
              <a:avLst/>
              <a:gdLst>
                <a:gd name="csX0" fmla="*/ 431 w 5900"/>
                <a:gd name="csY0" fmla="*/ 12124 h 11801"/>
                <a:gd name="csX1" fmla="*/ 6332 w 5900"/>
                <a:gd name="csY1" fmla="*/ 6223 h 11801"/>
                <a:gd name="csX2" fmla="*/ 431 w 5900"/>
                <a:gd name="csY2" fmla="*/ 323 h 11801"/>
              </a:gdLst>
              <a:ahLst/>
              <a:cxnLst>
                <a:cxn ang="0">
                  <a:pos x="csX0" y="csY0"/>
                </a:cxn>
                <a:cxn ang="0">
                  <a:pos x="csX1" y="csY1"/>
                </a:cxn>
                <a:cxn ang="0">
                  <a:pos x="csX2" y="csY2"/>
                </a:cxn>
              </a:cxnLst>
              <a:rect l="l" t="t" r="r" b="b"/>
              <a:pathLst>
                <a:path w="5900" h="11801">
                  <a:moveTo>
                    <a:pt x="431" y="12124"/>
                  </a:moveTo>
                  <a:cubicBezTo>
                    <a:pt x="3690" y="12124"/>
                    <a:pt x="6332" y="9482"/>
                    <a:pt x="6332" y="6223"/>
                  </a:cubicBezTo>
                  <a:cubicBezTo>
                    <a:pt x="6332" y="2965"/>
                    <a:pt x="3690" y="323"/>
                    <a:pt x="431" y="323"/>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0" name="フリーフォーム: 図形 49">
              <a:extLst>
                <a:ext uri="{FF2B5EF4-FFF2-40B4-BE49-F238E27FC236}">
                  <a16:creationId xmlns:a16="http://schemas.microsoft.com/office/drawing/2014/main" id="{323F052D-2364-6580-779D-3087DAA8A522}"/>
                </a:ext>
              </a:extLst>
            </p:cNvPr>
            <p:cNvSpPr/>
            <p:nvPr/>
          </p:nvSpPr>
          <p:spPr>
            <a:xfrm rot="12998424">
              <a:off x="1585293" y="5536025"/>
              <a:ext cx="51926" cy="25963"/>
            </a:xfrm>
            <a:custGeom>
              <a:avLst/>
              <a:gdLst>
                <a:gd name="csX0" fmla="*/ 379 w 51926"/>
                <a:gd name="csY0" fmla="*/ 283 h 25963"/>
                <a:gd name="csX1" fmla="*/ 52305 w 51926"/>
                <a:gd name="csY1" fmla="*/ 13264 h 25963"/>
                <a:gd name="csX2" fmla="*/ 379 w 51926"/>
                <a:gd name="csY2" fmla="*/ 26246 h 25963"/>
              </a:gdLst>
              <a:ahLst/>
              <a:cxnLst>
                <a:cxn ang="0">
                  <a:pos x="csX0" y="csY0"/>
                </a:cxn>
                <a:cxn ang="0">
                  <a:pos x="csX1" y="csY1"/>
                </a:cxn>
                <a:cxn ang="0">
                  <a:pos x="csX2" y="csY2"/>
                </a:cxn>
              </a:cxnLst>
              <a:rect l="l" t="t" r="r" b="b"/>
              <a:pathLst>
                <a:path w="51926" h="25963">
                  <a:moveTo>
                    <a:pt x="379" y="283"/>
                  </a:moveTo>
                  <a:cubicBezTo>
                    <a:pt x="17688" y="8937"/>
                    <a:pt x="34996" y="13264"/>
                    <a:pt x="52305" y="13264"/>
                  </a:cubicBezTo>
                  <a:cubicBezTo>
                    <a:pt x="34996" y="13264"/>
                    <a:pt x="17688" y="17592"/>
                    <a:pt x="379" y="26246"/>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1" name="フリーフォーム: 図形 50">
              <a:extLst>
                <a:ext uri="{FF2B5EF4-FFF2-40B4-BE49-F238E27FC236}">
                  <a16:creationId xmlns:a16="http://schemas.microsoft.com/office/drawing/2014/main" id="{404719D9-E859-B3E2-D7AB-C1E80A8395E8}"/>
                </a:ext>
              </a:extLst>
            </p:cNvPr>
            <p:cNvSpPr/>
            <p:nvPr/>
          </p:nvSpPr>
          <p:spPr>
            <a:xfrm>
              <a:off x="1446647" y="5288726"/>
              <a:ext cx="75240" cy="159902"/>
            </a:xfrm>
            <a:custGeom>
              <a:avLst/>
              <a:gdLst>
                <a:gd name="csX0" fmla="*/ 73896 w 75240"/>
                <a:gd name="csY0" fmla="*/ 160173 h 159902"/>
                <a:gd name="csX1" fmla="*/ -1344 w 75240"/>
                <a:gd name="csY1" fmla="*/ 270 h 159902"/>
              </a:gdLst>
              <a:ahLst/>
              <a:cxnLst>
                <a:cxn ang="0">
                  <a:pos x="csX0" y="csY0"/>
                </a:cxn>
                <a:cxn ang="0">
                  <a:pos x="csX1" y="csY1"/>
                </a:cxn>
              </a:cxnLst>
              <a:rect l="l" t="t" r="r" b="b"/>
              <a:pathLst>
                <a:path w="75240" h="159902">
                  <a:moveTo>
                    <a:pt x="73896" y="160173"/>
                  </a:moveTo>
                  <a:lnTo>
                    <a:pt x="-1344" y="270"/>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2" name="フリーフォーム: 図形 51">
              <a:extLst>
                <a:ext uri="{FF2B5EF4-FFF2-40B4-BE49-F238E27FC236}">
                  <a16:creationId xmlns:a16="http://schemas.microsoft.com/office/drawing/2014/main" id="{21D514E1-E7D0-6E9E-EAE9-3337D34CBFC9}"/>
                </a:ext>
              </a:extLst>
            </p:cNvPr>
            <p:cNvSpPr/>
            <p:nvPr/>
          </p:nvSpPr>
          <p:spPr>
            <a:xfrm rot="3888076">
              <a:off x="1520193" y="5445397"/>
              <a:ext cx="5900" cy="11801"/>
            </a:xfrm>
            <a:custGeom>
              <a:avLst/>
              <a:gdLst>
                <a:gd name="csX0" fmla="*/ 360 w 5900"/>
                <a:gd name="csY0" fmla="*/ 12065 h 11801"/>
                <a:gd name="csX1" fmla="*/ 6261 w 5900"/>
                <a:gd name="csY1" fmla="*/ 6165 h 11801"/>
                <a:gd name="csX2" fmla="*/ 360 w 5900"/>
                <a:gd name="csY2" fmla="*/ 264 h 11801"/>
              </a:gdLst>
              <a:ahLst/>
              <a:cxnLst>
                <a:cxn ang="0">
                  <a:pos x="csX0" y="csY0"/>
                </a:cxn>
                <a:cxn ang="0">
                  <a:pos x="csX1" y="csY1"/>
                </a:cxn>
                <a:cxn ang="0">
                  <a:pos x="csX2" y="csY2"/>
                </a:cxn>
              </a:cxnLst>
              <a:rect l="l" t="t" r="r" b="b"/>
              <a:pathLst>
                <a:path w="5900" h="11801">
                  <a:moveTo>
                    <a:pt x="360" y="12065"/>
                  </a:moveTo>
                  <a:cubicBezTo>
                    <a:pt x="3619" y="12065"/>
                    <a:pt x="6261" y="9423"/>
                    <a:pt x="6261" y="6165"/>
                  </a:cubicBezTo>
                  <a:cubicBezTo>
                    <a:pt x="6261" y="2906"/>
                    <a:pt x="3619" y="264"/>
                    <a:pt x="360" y="264"/>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3" name="フリーフォーム: 図形 52">
              <a:extLst>
                <a:ext uri="{FF2B5EF4-FFF2-40B4-BE49-F238E27FC236}">
                  <a16:creationId xmlns:a16="http://schemas.microsoft.com/office/drawing/2014/main" id="{A1F42A2F-B294-C112-A1DD-9BBCC1A4D6FE}"/>
                </a:ext>
              </a:extLst>
            </p:cNvPr>
            <p:cNvSpPr/>
            <p:nvPr/>
          </p:nvSpPr>
          <p:spPr>
            <a:xfrm rot="14688076">
              <a:off x="1409629" y="5252251"/>
              <a:ext cx="51926" cy="25963"/>
            </a:xfrm>
            <a:custGeom>
              <a:avLst/>
              <a:gdLst>
                <a:gd name="csX0" fmla="*/ 345 w 51926"/>
                <a:gd name="csY0" fmla="*/ 228 h 25963"/>
                <a:gd name="csX1" fmla="*/ 52271 w 51926"/>
                <a:gd name="csY1" fmla="*/ 13210 h 25963"/>
                <a:gd name="csX2" fmla="*/ 345 w 51926"/>
                <a:gd name="csY2" fmla="*/ 26191 h 25963"/>
              </a:gdLst>
              <a:ahLst/>
              <a:cxnLst>
                <a:cxn ang="0">
                  <a:pos x="csX0" y="csY0"/>
                </a:cxn>
                <a:cxn ang="0">
                  <a:pos x="csX1" y="csY1"/>
                </a:cxn>
                <a:cxn ang="0">
                  <a:pos x="csX2" y="csY2"/>
                </a:cxn>
              </a:cxnLst>
              <a:rect l="l" t="t" r="r" b="b"/>
              <a:pathLst>
                <a:path w="51926" h="25963">
                  <a:moveTo>
                    <a:pt x="345" y="228"/>
                  </a:moveTo>
                  <a:cubicBezTo>
                    <a:pt x="17654" y="8882"/>
                    <a:pt x="34963" y="13210"/>
                    <a:pt x="52271" y="13210"/>
                  </a:cubicBezTo>
                  <a:cubicBezTo>
                    <a:pt x="34963" y="13210"/>
                    <a:pt x="17654" y="17537"/>
                    <a:pt x="345" y="26191"/>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4" name="フリーフォーム: 図形 53">
              <a:extLst>
                <a:ext uri="{FF2B5EF4-FFF2-40B4-BE49-F238E27FC236}">
                  <a16:creationId xmlns:a16="http://schemas.microsoft.com/office/drawing/2014/main" id="{29E1B21E-1440-2F18-85C4-C0C9BA715486}"/>
                </a:ext>
              </a:extLst>
            </p:cNvPr>
            <p:cNvSpPr/>
            <p:nvPr/>
          </p:nvSpPr>
          <p:spPr>
            <a:xfrm>
              <a:off x="1576435" y="5547500"/>
              <a:ext cx="210398" cy="327536"/>
            </a:xfrm>
            <a:custGeom>
              <a:avLst/>
              <a:gdLst>
                <a:gd name="csX0" fmla="*/ -1389 w 210398"/>
                <a:gd name="csY0" fmla="*/ 191 h 327536"/>
                <a:gd name="csX1" fmla="*/ 209009 w 210398"/>
                <a:gd name="csY1" fmla="*/ 327728 h 327536"/>
              </a:gdLst>
              <a:ahLst/>
              <a:cxnLst>
                <a:cxn ang="0">
                  <a:pos x="csX0" y="csY0"/>
                </a:cxn>
                <a:cxn ang="0">
                  <a:pos x="csX1" y="csY1"/>
                </a:cxn>
              </a:cxnLst>
              <a:rect l="l" t="t" r="r" b="b"/>
              <a:pathLst>
                <a:path w="210398" h="327536">
                  <a:moveTo>
                    <a:pt x="-1389" y="191"/>
                  </a:moveTo>
                  <a:lnTo>
                    <a:pt x="209009" y="327728"/>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5" name="フリーフォーム: 図形 54">
              <a:extLst>
                <a:ext uri="{FF2B5EF4-FFF2-40B4-BE49-F238E27FC236}">
                  <a16:creationId xmlns:a16="http://schemas.microsoft.com/office/drawing/2014/main" id="{8B1A3EC1-7CDE-8999-5D6D-B9EBD535C141}"/>
                </a:ext>
              </a:extLst>
            </p:cNvPr>
            <p:cNvSpPr/>
            <p:nvPr/>
          </p:nvSpPr>
          <p:spPr>
            <a:xfrm rot="14237081">
              <a:off x="1571890" y="5539117"/>
              <a:ext cx="5900" cy="11801"/>
            </a:xfrm>
            <a:custGeom>
              <a:avLst/>
              <a:gdLst>
                <a:gd name="csX0" fmla="*/ 370 w 5900"/>
                <a:gd name="csY0" fmla="*/ 12083 h 11801"/>
                <a:gd name="csX1" fmla="*/ 6271 w 5900"/>
                <a:gd name="csY1" fmla="*/ 6183 h 11801"/>
                <a:gd name="csX2" fmla="*/ 370 w 5900"/>
                <a:gd name="csY2" fmla="*/ 282 h 11801"/>
              </a:gdLst>
              <a:ahLst/>
              <a:cxnLst>
                <a:cxn ang="0">
                  <a:pos x="csX0" y="csY0"/>
                </a:cxn>
                <a:cxn ang="0">
                  <a:pos x="csX1" y="csY1"/>
                </a:cxn>
                <a:cxn ang="0">
                  <a:pos x="csX2" y="csY2"/>
                </a:cxn>
              </a:cxnLst>
              <a:rect l="l" t="t" r="r" b="b"/>
              <a:pathLst>
                <a:path w="5900" h="11801">
                  <a:moveTo>
                    <a:pt x="370" y="12083"/>
                  </a:moveTo>
                  <a:cubicBezTo>
                    <a:pt x="3629" y="12083"/>
                    <a:pt x="6271" y="9442"/>
                    <a:pt x="6271" y="6183"/>
                  </a:cubicBezTo>
                  <a:cubicBezTo>
                    <a:pt x="6271" y="2924"/>
                    <a:pt x="3629" y="282"/>
                    <a:pt x="370" y="282"/>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6" name="フリーフォーム: 図形 55">
              <a:extLst>
                <a:ext uri="{FF2B5EF4-FFF2-40B4-BE49-F238E27FC236}">
                  <a16:creationId xmlns:a16="http://schemas.microsoft.com/office/drawing/2014/main" id="{9534F28F-A062-0406-7203-E728FBF6345C}"/>
                </a:ext>
              </a:extLst>
            </p:cNvPr>
            <p:cNvSpPr/>
            <p:nvPr/>
          </p:nvSpPr>
          <p:spPr>
            <a:xfrm rot="3437081">
              <a:off x="1774903" y="5883900"/>
              <a:ext cx="51926" cy="25963"/>
            </a:xfrm>
            <a:custGeom>
              <a:avLst/>
              <a:gdLst>
                <a:gd name="csX0" fmla="*/ 415 w 51926"/>
                <a:gd name="csY0" fmla="*/ 350 h 25963"/>
                <a:gd name="csX1" fmla="*/ 52342 w 51926"/>
                <a:gd name="csY1" fmla="*/ 13331 h 25963"/>
                <a:gd name="csX2" fmla="*/ 415 w 51926"/>
                <a:gd name="csY2" fmla="*/ 26313 h 25963"/>
              </a:gdLst>
              <a:ahLst/>
              <a:cxnLst>
                <a:cxn ang="0">
                  <a:pos x="csX0" y="csY0"/>
                </a:cxn>
                <a:cxn ang="0">
                  <a:pos x="csX1" y="csY1"/>
                </a:cxn>
                <a:cxn ang="0">
                  <a:pos x="csX2" y="csY2"/>
                </a:cxn>
              </a:cxnLst>
              <a:rect l="l" t="t" r="r" b="b"/>
              <a:pathLst>
                <a:path w="51926" h="25963">
                  <a:moveTo>
                    <a:pt x="415" y="350"/>
                  </a:moveTo>
                  <a:cubicBezTo>
                    <a:pt x="17724" y="9004"/>
                    <a:pt x="35033" y="13331"/>
                    <a:pt x="52342" y="13331"/>
                  </a:cubicBezTo>
                  <a:cubicBezTo>
                    <a:pt x="35033" y="13331"/>
                    <a:pt x="17724" y="17659"/>
                    <a:pt x="415" y="26313"/>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7" name="フリーフォーム: 図形 56">
              <a:extLst>
                <a:ext uri="{FF2B5EF4-FFF2-40B4-BE49-F238E27FC236}">
                  <a16:creationId xmlns:a16="http://schemas.microsoft.com/office/drawing/2014/main" id="{6FCDEB34-86BA-20C9-BD25-08FC4529D1F0}"/>
                </a:ext>
              </a:extLst>
            </p:cNvPr>
            <p:cNvSpPr/>
            <p:nvPr/>
          </p:nvSpPr>
          <p:spPr>
            <a:xfrm>
              <a:off x="1603283" y="5410250"/>
              <a:ext cx="202342" cy="70683"/>
            </a:xfrm>
            <a:custGeom>
              <a:avLst/>
              <a:gdLst>
                <a:gd name="csX0" fmla="*/ -1395 w 202342"/>
                <a:gd name="csY0" fmla="*/ 70936 h 70683"/>
                <a:gd name="csX1" fmla="*/ 200947 w 202342"/>
                <a:gd name="csY1" fmla="*/ 252 h 70683"/>
              </a:gdLst>
              <a:ahLst/>
              <a:cxnLst>
                <a:cxn ang="0">
                  <a:pos x="csX0" y="csY0"/>
                </a:cxn>
                <a:cxn ang="0">
                  <a:pos x="csX1" y="csY1"/>
                </a:cxn>
              </a:cxnLst>
              <a:rect l="l" t="t" r="r" b="b"/>
              <a:pathLst>
                <a:path w="202342" h="70683">
                  <a:moveTo>
                    <a:pt x="-1395" y="70936"/>
                  </a:moveTo>
                  <a:lnTo>
                    <a:pt x="200947" y="252"/>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8" name="フリーフォーム: 図形 57">
              <a:extLst>
                <a:ext uri="{FF2B5EF4-FFF2-40B4-BE49-F238E27FC236}">
                  <a16:creationId xmlns:a16="http://schemas.microsoft.com/office/drawing/2014/main" id="{6E8F663F-45EE-5CEF-8E2C-9EA9D660495D}"/>
                </a:ext>
              </a:extLst>
            </p:cNvPr>
            <p:cNvSpPr/>
            <p:nvPr/>
          </p:nvSpPr>
          <p:spPr>
            <a:xfrm rot="9644654">
              <a:off x="1597547" y="5476006"/>
              <a:ext cx="5900" cy="11801"/>
            </a:xfrm>
            <a:custGeom>
              <a:avLst/>
              <a:gdLst>
                <a:gd name="csX0" fmla="*/ 375 w 5900"/>
                <a:gd name="csY0" fmla="*/ 12071 h 11801"/>
                <a:gd name="csX1" fmla="*/ 6276 w 5900"/>
                <a:gd name="csY1" fmla="*/ 6171 h 11801"/>
                <a:gd name="csX2" fmla="*/ 375 w 5900"/>
                <a:gd name="csY2" fmla="*/ 270 h 11801"/>
              </a:gdLst>
              <a:ahLst/>
              <a:cxnLst>
                <a:cxn ang="0">
                  <a:pos x="csX0" y="csY0"/>
                </a:cxn>
                <a:cxn ang="0">
                  <a:pos x="csX1" y="csY1"/>
                </a:cxn>
                <a:cxn ang="0">
                  <a:pos x="csX2" y="csY2"/>
                </a:cxn>
              </a:cxnLst>
              <a:rect l="l" t="t" r="r" b="b"/>
              <a:pathLst>
                <a:path w="5900" h="11801">
                  <a:moveTo>
                    <a:pt x="375" y="12071"/>
                  </a:moveTo>
                  <a:cubicBezTo>
                    <a:pt x="3634" y="12071"/>
                    <a:pt x="6276" y="9429"/>
                    <a:pt x="6276" y="6171"/>
                  </a:cubicBezTo>
                  <a:cubicBezTo>
                    <a:pt x="6276" y="2912"/>
                    <a:pt x="3634" y="270"/>
                    <a:pt x="375" y="270"/>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59" name="フリーフォーム: 図形 58">
              <a:extLst>
                <a:ext uri="{FF2B5EF4-FFF2-40B4-BE49-F238E27FC236}">
                  <a16:creationId xmlns:a16="http://schemas.microsoft.com/office/drawing/2014/main" id="{136A617D-FCD6-CEB0-D745-74D5DA44EB4A}"/>
                </a:ext>
              </a:extLst>
            </p:cNvPr>
            <p:cNvSpPr/>
            <p:nvPr/>
          </p:nvSpPr>
          <p:spPr>
            <a:xfrm rot="20444654">
              <a:off x="1804173" y="5388706"/>
              <a:ext cx="51926" cy="25963"/>
            </a:xfrm>
            <a:custGeom>
              <a:avLst/>
              <a:gdLst>
                <a:gd name="csX0" fmla="*/ 421 w 51926"/>
                <a:gd name="csY0" fmla="*/ 254 h 25963"/>
                <a:gd name="csX1" fmla="*/ 52348 w 51926"/>
                <a:gd name="csY1" fmla="*/ 13236 h 25963"/>
                <a:gd name="csX2" fmla="*/ 421 w 51926"/>
                <a:gd name="csY2" fmla="*/ 26218 h 25963"/>
              </a:gdLst>
              <a:ahLst/>
              <a:cxnLst>
                <a:cxn ang="0">
                  <a:pos x="csX0" y="csY0"/>
                </a:cxn>
                <a:cxn ang="0">
                  <a:pos x="csX1" y="csY1"/>
                </a:cxn>
                <a:cxn ang="0">
                  <a:pos x="csX2" y="csY2"/>
                </a:cxn>
              </a:cxnLst>
              <a:rect l="l" t="t" r="r" b="b"/>
              <a:pathLst>
                <a:path w="51926" h="25963">
                  <a:moveTo>
                    <a:pt x="421" y="254"/>
                  </a:moveTo>
                  <a:cubicBezTo>
                    <a:pt x="17730" y="8909"/>
                    <a:pt x="35039" y="13236"/>
                    <a:pt x="52348" y="13236"/>
                  </a:cubicBezTo>
                  <a:cubicBezTo>
                    <a:pt x="35039" y="13236"/>
                    <a:pt x="17730" y="17563"/>
                    <a:pt x="421" y="26218"/>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0" name="フリーフォーム: 図形 59">
              <a:extLst>
                <a:ext uri="{FF2B5EF4-FFF2-40B4-BE49-F238E27FC236}">
                  <a16:creationId xmlns:a16="http://schemas.microsoft.com/office/drawing/2014/main" id="{6B4C13AD-A0EC-1F3C-2FC7-C63E5DE98866}"/>
                </a:ext>
              </a:extLst>
            </p:cNvPr>
            <p:cNvSpPr/>
            <p:nvPr/>
          </p:nvSpPr>
          <p:spPr>
            <a:xfrm>
              <a:off x="1547257" y="5576678"/>
              <a:ext cx="3158" cy="290771"/>
            </a:xfrm>
            <a:custGeom>
              <a:avLst/>
              <a:gdLst>
                <a:gd name="csX0" fmla="*/ -1359 w 3158"/>
                <a:gd name="csY0" fmla="*/ 189 h 290771"/>
                <a:gd name="csX1" fmla="*/ 1800 w 3158"/>
                <a:gd name="csY1" fmla="*/ 290960 h 290771"/>
              </a:gdLst>
              <a:ahLst/>
              <a:cxnLst>
                <a:cxn ang="0">
                  <a:pos x="csX0" y="csY0"/>
                </a:cxn>
                <a:cxn ang="0">
                  <a:pos x="csX1" y="csY1"/>
                </a:cxn>
              </a:cxnLst>
              <a:rect l="l" t="t" r="r" b="b"/>
              <a:pathLst>
                <a:path w="3158" h="290771">
                  <a:moveTo>
                    <a:pt x="-1359" y="189"/>
                  </a:moveTo>
                  <a:lnTo>
                    <a:pt x="1800" y="290960"/>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1" name="フリーフォーム: 図形 60">
              <a:extLst>
                <a:ext uri="{FF2B5EF4-FFF2-40B4-BE49-F238E27FC236}">
                  <a16:creationId xmlns:a16="http://schemas.microsoft.com/office/drawing/2014/main" id="{F4135388-C5E9-2CE6-E3A8-06B33C162921}"/>
                </a:ext>
              </a:extLst>
            </p:cNvPr>
            <p:cNvSpPr/>
            <p:nvPr/>
          </p:nvSpPr>
          <p:spPr>
            <a:xfrm rot="16162653">
              <a:off x="1544275" y="5567827"/>
              <a:ext cx="5900" cy="11801"/>
            </a:xfrm>
            <a:custGeom>
              <a:avLst/>
              <a:gdLst>
                <a:gd name="csX0" fmla="*/ 365 w 5900"/>
                <a:gd name="csY0" fmla="*/ 12089 h 11801"/>
                <a:gd name="csX1" fmla="*/ 6266 w 5900"/>
                <a:gd name="csY1" fmla="*/ 6188 h 11801"/>
                <a:gd name="csX2" fmla="*/ 365 w 5900"/>
                <a:gd name="csY2" fmla="*/ 287 h 11801"/>
              </a:gdLst>
              <a:ahLst/>
              <a:cxnLst>
                <a:cxn ang="0">
                  <a:pos x="csX0" y="csY0"/>
                </a:cxn>
                <a:cxn ang="0">
                  <a:pos x="csX1" y="csY1"/>
                </a:cxn>
                <a:cxn ang="0">
                  <a:pos x="csX2" y="csY2"/>
                </a:cxn>
              </a:cxnLst>
              <a:rect l="l" t="t" r="r" b="b"/>
              <a:pathLst>
                <a:path w="5900" h="11801">
                  <a:moveTo>
                    <a:pt x="365" y="12089"/>
                  </a:moveTo>
                  <a:cubicBezTo>
                    <a:pt x="3624" y="12089"/>
                    <a:pt x="6266" y="9447"/>
                    <a:pt x="6266" y="6188"/>
                  </a:cubicBezTo>
                  <a:cubicBezTo>
                    <a:pt x="6266" y="2929"/>
                    <a:pt x="3624" y="287"/>
                    <a:pt x="365" y="287"/>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2" name="フリーフォーム: 図形 61">
              <a:extLst>
                <a:ext uri="{FF2B5EF4-FFF2-40B4-BE49-F238E27FC236}">
                  <a16:creationId xmlns:a16="http://schemas.microsoft.com/office/drawing/2014/main" id="{58088157-36EA-F49A-C220-24D8E35E0350}"/>
                </a:ext>
              </a:extLst>
            </p:cNvPr>
            <p:cNvSpPr/>
            <p:nvPr/>
          </p:nvSpPr>
          <p:spPr>
            <a:xfrm rot="5362653">
              <a:off x="1524735" y="5880430"/>
              <a:ext cx="51926" cy="25963"/>
            </a:xfrm>
            <a:custGeom>
              <a:avLst/>
              <a:gdLst>
                <a:gd name="csX0" fmla="*/ 367 w 51926"/>
                <a:gd name="csY0" fmla="*/ 349 h 25963"/>
                <a:gd name="csX1" fmla="*/ 52294 w 51926"/>
                <a:gd name="csY1" fmla="*/ 13331 h 25963"/>
                <a:gd name="csX2" fmla="*/ 367 w 51926"/>
                <a:gd name="csY2" fmla="*/ 26312 h 25963"/>
              </a:gdLst>
              <a:ahLst/>
              <a:cxnLst>
                <a:cxn ang="0">
                  <a:pos x="csX0" y="csY0"/>
                </a:cxn>
                <a:cxn ang="0">
                  <a:pos x="csX1" y="csY1"/>
                </a:cxn>
                <a:cxn ang="0">
                  <a:pos x="csX2" y="csY2"/>
                </a:cxn>
              </a:cxnLst>
              <a:rect l="l" t="t" r="r" b="b"/>
              <a:pathLst>
                <a:path w="51926" h="25963">
                  <a:moveTo>
                    <a:pt x="367" y="349"/>
                  </a:moveTo>
                  <a:cubicBezTo>
                    <a:pt x="17676" y="9004"/>
                    <a:pt x="34985" y="13331"/>
                    <a:pt x="52294" y="13331"/>
                  </a:cubicBezTo>
                  <a:cubicBezTo>
                    <a:pt x="34985" y="13331"/>
                    <a:pt x="17676" y="17658"/>
                    <a:pt x="367" y="26312"/>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3" name="フリーフォーム: 図形 62">
              <a:extLst>
                <a:ext uri="{FF2B5EF4-FFF2-40B4-BE49-F238E27FC236}">
                  <a16:creationId xmlns:a16="http://schemas.microsoft.com/office/drawing/2014/main" id="{9989D54B-E91E-B9A3-420C-284EB767430D}"/>
                </a:ext>
              </a:extLst>
            </p:cNvPr>
            <p:cNvSpPr/>
            <p:nvPr/>
          </p:nvSpPr>
          <p:spPr>
            <a:xfrm>
              <a:off x="1257357" y="5519601"/>
              <a:ext cx="231173" cy="75089"/>
            </a:xfrm>
            <a:custGeom>
              <a:avLst/>
              <a:gdLst>
                <a:gd name="csX0" fmla="*/ -1318 w 231173"/>
                <a:gd name="csY0" fmla="*/ 75316 h 75089"/>
                <a:gd name="csX1" fmla="*/ 229855 w 231173"/>
                <a:gd name="csY1" fmla="*/ 227 h 75089"/>
              </a:gdLst>
              <a:ahLst/>
              <a:cxnLst>
                <a:cxn ang="0">
                  <a:pos x="csX0" y="csY0"/>
                </a:cxn>
                <a:cxn ang="0">
                  <a:pos x="csX1" y="csY1"/>
                </a:cxn>
              </a:cxnLst>
              <a:rect l="l" t="t" r="r" b="b"/>
              <a:pathLst>
                <a:path w="231173" h="75089">
                  <a:moveTo>
                    <a:pt x="-1318" y="75316"/>
                  </a:moveTo>
                  <a:lnTo>
                    <a:pt x="229855" y="227"/>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4" name="フリーフォーム: 図形 63">
              <a:extLst>
                <a:ext uri="{FF2B5EF4-FFF2-40B4-BE49-F238E27FC236}">
                  <a16:creationId xmlns:a16="http://schemas.microsoft.com/office/drawing/2014/main" id="{F5603241-97FD-F380-DC9A-BC502CA8AFC0}"/>
                </a:ext>
              </a:extLst>
            </p:cNvPr>
            <p:cNvSpPr/>
            <p:nvPr/>
          </p:nvSpPr>
          <p:spPr>
            <a:xfrm>
              <a:off x="1248689" y="5640974"/>
              <a:ext cx="542646" cy="302823"/>
            </a:xfrm>
            <a:custGeom>
              <a:avLst/>
              <a:gdLst>
                <a:gd name="csX0" fmla="*/ 541295 w 542646"/>
                <a:gd name="csY0" fmla="*/ 302995 h 302823"/>
                <a:gd name="csX1" fmla="*/ -1352 w 542646"/>
                <a:gd name="csY1" fmla="*/ 172 h 302823"/>
              </a:gdLst>
              <a:ahLst/>
              <a:cxnLst>
                <a:cxn ang="0">
                  <a:pos x="csX0" y="csY0"/>
                </a:cxn>
                <a:cxn ang="0">
                  <a:pos x="csX1" y="csY1"/>
                </a:cxn>
              </a:cxnLst>
              <a:rect l="l" t="t" r="r" b="b"/>
              <a:pathLst>
                <a:path w="542646" h="302823">
                  <a:moveTo>
                    <a:pt x="541295" y="302995"/>
                  </a:moveTo>
                  <a:lnTo>
                    <a:pt x="-1352" y="172"/>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5" name="フリーフォーム: 図形 64">
              <a:extLst>
                <a:ext uri="{FF2B5EF4-FFF2-40B4-BE49-F238E27FC236}">
                  <a16:creationId xmlns:a16="http://schemas.microsoft.com/office/drawing/2014/main" id="{ED2EB202-08E9-DAD6-901F-974E2F89D8A1}"/>
                </a:ext>
              </a:extLst>
            </p:cNvPr>
            <p:cNvSpPr/>
            <p:nvPr/>
          </p:nvSpPr>
          <p:spPr>
            <a:xfrm>
              <a:off x="1236527" y="5653136"/>
              <a:ext cx="231385" cy="247401"/>
            </a:xfrm>
            <a:custGeom>
              <a:avLst/>
              <a:gdLst>
                <a:gd name="csX0" fmla="*/ -1313 w 231385"/>
                <a:gd name="csY0" fmla="*/ 176 h 247401"/>
                <a:gd name="csX1" fmla="*/ 230072 w 231385"/>
                <a:gd name="csY1" fmla="*/ 247578 h 247401"/>
              </a:gdLst>
              <a:ahLst/>
              <a:cxnLst>
                <a:cxn ang="0">
                  <a:pos x="csX0" y="csY0"/>
                </a:cxn>
                <a:cxn ang="0">
                  <a:pos x="csX1" y="csY1"/>
                </a:cxn>
              </a:cxnLst>
              <a:rect l="l" t="t" r="r" b="b"/>
              <a:pathLst>
                <a:path w="231385" h="247401">
                  <a:moveTo>
                    <a:pt x="-1313" y="176"/>
                  </a:moveTo>
                  <a:lnTo>
                    <a:pt x="230072" y="247578"/>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6" name="フリーフォーム: 図形 65">
              <a:extLst>
                <a:ext uri="{FF2B5EF4-FFF2-40B4-BE49-F238E27FC236}">
                  <a16:creationId xmlns:a16="http://schemas.microsoft.com/office/drawing/2014/main" id="{7EC230E0-F817-6ED3-40A3-2C48B52A09F9}"/>
                </a:ext>
              </a:extLst>
            </p:cNvPr>
            <p:cNvSpPr/>
            <p:nvPr/>
          </p:nvSpPr>
          <p:spPr>
            <a:xfrm rot="13614956">
              <a:off x="1231561" y="5645081"/>
              <a:ext cx="5900" cy="11801"/>
            </a:xfrm>
            <a:custGeom>
              <a:avLst/>
              <a:gdLst>
                <a:gd name="csX0" fmla="*/ 305 w 5900"/>
                <a:gd name="csY0" fmla="*/ 12104 h 11801"/>
                <a:gd name="csX1" fmla="*/ 6205 w 5900"/>
                <a:gd name="csY1" fmla="*/ 6203 h 11801"/>
                <a:gd name="csX2" fmla="*/ 305 w 5900"/>
                <a:gd name="csY2" fmla="*/ 302 h 11801"/>
              </a:gdLst>
              <a:ahLst/>
              <a:cxnLst>
                <a:cxn ang="0">
                  <a:pos x="csX0" y="csY0"/>
                </a:cxn>
                <a:cxn ang="0">
                  <a:pos x="csX1" y="csY1"/>
                </a:cxn>
                <a:cxn ang="0">
                  <a:pos x="csX2" y="csY2"/>
                </a:cxn>
              </a:cxnLst>
              <a:rect l="l" t="t" r="r" b="b"/>
              <a:pathLst>
                <a:path w="5900" h="11801">
                  <a:moveTo>
                    <a:pt x="305" y="12104"/>
                  </a:moveTo>
                  <a:cubicBezTo>
                    <a:pt x="3564" y="12104"/>
                    <a:pt x="6205" y="9462"/>
                    <a:pt x="6205" y="6203"/>
                  </a:cubicBezTo>
                  <a:cubicBezTo>
                    <a:pt x="6205" y="2944"/>
                    <a:pt x="3564" y="302"/>
                    <a:pt x="305" y="302"/>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7" name="フリーフォーム: 図形 66">
              <a:extLst>
                <a:ext uri="{FF2B5EF4-FFF2-40B4-BE49-F238E27FC236}">
                  <a16:creationId xmlns:a16="http://schemas.microsoft.com/office/drawing/2014/main" id="{42321A14-5C66-C8E8-F318-4D2488A044C7}"/>
                </a:ext>
              </a:extLst>
            </p:cNvPr>
            <p:cNvSpPr/>
            <p:nvPr/>
          </p:nvSpPr>
          <p:spPr>
            <a:xfrm rot="2814956">
              <a:off x="1459684" y="5906519"/>
              <a:ext cx="51926" cy="25963"/>
            </a:xfrm>
            <a:custGeom>
              <a:avLst/>
              <a:gdLst>
                <a:gd name="csX0" fmla="*/ 354 w 51926"/>
                <a:gd name="csY0" fmla="*/ 354 h 25963"/>
                <a:gd name="csX1" fmla="*/ 52281 w 51926"/>
                <a:gd name="csY1" fmla="*/ 13336 h 25963"/>
                <a:gd name="csX2" fmla="*/ 354 w 51926"/>
                <a:gd name="csY2" fmla="*/ 26317 h 25963"/>
              </a:gdLst>
              <a:ahLst/>
              <a:cxnLst>
                <a:cxn ang="0">
                  <a:pos x="csX0" y="csY0"/>
                </a:cxn>
                <a:cxn ang="0">
                  <a:pos x="csX1" y="csY1"/>
                </a:cxn>
                <a:cxn ang="0">
                  <a:pos x="csX2" y="csY2"/>
                </a:cxn>
              </a:cxnLst>
              <a:rect l="l" t="t" r="r" b="b"/>
              <a:pathLst>
                <a:path w="51926" h="25963">
                  <a:moveTo>
                    <a:pt x="354" y="354"/>
                  </a:moveTo>
                  <a:cubicBezTo>
                    <a:pt x="17663" y="9009"/>
                    <a:pt x="34972" y="13336"/>
                    <a:pt x="52281" y="13336"/>
                  </a:cubicBezTo>
                  <a:cubicBezTo>
                    <a:pt x="34972" y="13336"/>
                    <a:pt x="17663" y="17663"/>
                    <a:pt x="354" y="26317"/>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8" name="フリーフォーム: 図形 67">
              <a:extLst>
                <a:ext uri="{FF2B5EF4-FFF2-40B4-BE49-F238E27FC236}">
                  <a16:creationId xmlns:a16="http://schemas.microsoft.com/office/drawing/2014/main" id="{8550CEE5-C118-F866-9B8F-BA03E1F01650}"/>
                </a:ext>
              </a:extLst>
            </p:cNvPr>
            <p:cNvSpPr/>
            <p:nvPr/>
          </p:nvSpPr>
          <p:spPr>
            <a:xfrm>
              <a:off x="1237774" y="5308819"/>
              <a:ext cx="265790" cy="266288"/>
            </a:xfrm>
            <a:custGeom>
              <a:avLst/>
              <a:gdLst>
                <a:gd name="csX0" fmla="*/ -1318 w 265790"/>
                <a:gd name="csY0" fmla="*/ 266542 h 266288"/>
                <a:gd name="csX1" fmla="*/ 264473 w 265790"/>
                <a:gd name="csY1" fmla="*/ 253 h 266288"/>
              </a:gdLst>
              <a:ahLst/>
              <a:cxnLst>
                <a:cxn ang="0">
                  <a:pos x="csX0" y="csY0"/>
                </a:cxn>
                <a:cxn ang="0">
                  <a:pos x="csX1" y="csY1"/>
                </a:cxn>
              </a:cxnLst>
              <a:rect l="l" t="t" r="r" b="b"/>
              <a:pathLst>
                <a:path w="265790" h="266288">
                  <a:moveTo>
                    <a:pt x="-1318" y="266542"/>
                  </a:moveTo>
                  <a:lnTo>
                    <a:pt x="264473" y="253"/>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69" name="フリーフォーム: 図形 68">
              <a:extLst>
                <a:ext uri="{FF2B5EF4-FFF2-40B4-BE49-F238E27FC236}">
                  <a16:creationId xmlns:a16="http://schemas.microsoft.com/office/drawing/2014/main" id="{70EDB5AF-6D6A-E940-604F-4B64043B6F3E}"/>
                </a:ext>
              </a:extLst>
            </p:cNvPr>
            <p:cNvSpPr/>
            <p:nvPr/>
          </p:nvSpPr>
          <p:spPr>
            <a:xfrm rot="8096780">
              <a:off x="1232739" y="5571295"/>
              <a:ext cx="5900" cy="11801"/>
            </a:xfrm>
            <a:custGeom>
              <a:avLst/>
              <a:gdLst>
                <a:gd name="csX0" fmla="*/ 305 w 5900"/>
                <a:gd name="csY0" fmla="*/ 12090 h 11801"/>
                <a:gd name="csX1" fmla="*/ 6206 w 5900"/>
                <a:gd name="csY1" fmla="*/ 6189 h 11801"/>
                <a:gd name="csX2" fmla="*/ 305 w 5900"/>
                <a:gd name="csY2" fmla="*/ 288 h 11801"/>
              </a:gdLst>
              <a:ahLst/>
              <a:cxnLst>
                <a:cxn ang="0">
                  <a:pos x="csX0" y="csY0"/>
                </a:cxn>
                <a:cxn ang="0">
                  <a:pos x="csX1" y="csY1"/>
                </a:cxn>
                <a:cxn ang="0">
                  <a:pos x="csX2" y="csY2"/>
                </a:cxn>
              </a:cxnLst>
              <a:rect l="l" t="t" r="r" b="b"/>
              <a:pathLst>
                <a:path w="5900" h="11801">
                  <a:moveTo>
                    <a:pt x="305" y="12090"/>
                  </a:moveTo>
                  <a:cubicBezTo>
                    <a:pt x="3564" y="12090"/>
                    <a:pt x="6206" y="9448"/>
                    <a:pt x="6206" y="6189"/>
                  </a:cubicBezTo>
                  <a:cubicBezTo>
                    <a:pt x="6206" y="2930"/>
                    <a:pt x="3564" y="288"/>
                    <a:pt x="305" y="288"/>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0" name="フリーフォーム: 図形 69">
              <a:extLst>
                <a:ext uri="{FF2B5EF4-FFF2-40B4-BE49-F238E27FC236}">
                  <a16:creationId xmlns:a16="http://schemas.microsoft.com/office/drawing/2014/main" id="{71E8622B-A6D6-3774-9F49-ED812C35F95D}"/>
                </a:ext>
              </a:extLst>
            </p:cNvPr>
            <p:cNvSpPr/>
            <p:nvPr/>
          </p:nvSpPr>
          <p:spPr>
            <a:xfrm rot="18896780">
              <a:off x="1495942" y="5277461"/>
              <a:ext cx="51926" cy="25963"/>
            </a:xfrm>
            <a:custGeom>
              <a:avLst/>
              <a:gdLst>
                <a:gd name="csX0" fmla="*/ 361 w 51926"/>
                <a:gd name="csY0" fmla="*/ 233 h 25963"/>
                <a:gd name="csX1" fmla="*/ 52288 w 51926"/>
                <a:gd name="csY1" fmla="*/ 13214 h 25963"/>
                <a:gd name="csX2" fmla="*/ 361 w 51926"/>
                <a:gd name="csY2" fmla="*/ 26196 h 25963"/>
              </a:gdLst>
              <a:ahLst/>
              <a:cxnLst>
                <a:cxn ang="0">
                  <a:pos x="csX0" y="csY0"/>
                </a:cxn>
                <a:cxn ang="0">
                  <a:pos x="csX1" y="csY1"/>
                </a:cxn>
                <a:cxn ang="0">
                  <a:pos x="csX2" y="csY2"/>
                </a:cxn>
              </a:cxnLst>
              <a:rect l="l" t="t" r="r" b="b"/>
              <a:pathLst>
                <a:path w="51926" h="25963">
                  <a:moveTo>
                    <a:pt x="361" y="233"/>
                  </a:moveTo>
                  <a:cubicBezTo>
                    <a:pt x="17670" y="8887"/>
                    <a:pt x="34979" y="13214"/>
                    <a:pt x="52288" y="13214"/>
                  </a:cubicBezTo>
                  <a:cubicBezTo>
                    <a:pt x="34979" y="13214"/>
                    <a:pt x="17670" y="17542"/>
                    <a:pt x="361" y="26196"/>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1" name="フリーフォーム: 図形 70">
              <a:extLst>
                <a:ext uri="{FF2B5EF4-FFF2-40B4-BE49-F238E27FC236}">
                  <a16:creationId xmlns:a16="http://schemas.microsoft.com/office/drawing/2014/main" id="{C0B63BAB-13F5-1F99-27F6-97B88E0020AD}"/>
                </a:ext>
              </a:extLst>
            </p:cNvPr>
            <p:cNvSpPr/>
            <p:nvPr/>
          </p:nvSpPr>
          <p:spPr>
            <a:xfrm>
              <a:off x="878712" y="4746912"/>
              <a:ext cx="304461" cy="64129"/>
            </a:xfrm>
            <a:custGeom>
              <a:avLst/>
              <a:gdLst>
                <a:gd name="csX0" fmla="*/ 303222 w 304461"/>
                <a:gd name="csY0" fmla="*/ 64536 h 64129"/>
                <a:gd name="csX1" fmla="*/ -1239 w 304461"/>
                <a:gd name="csY1" fmla="*/ 406 h 64129"/>
              </a:gdLst>
              <a:ahLst/>
              <a:cxnLst>
                <a:cxn ang="0">
                  <a:pos x="csX0" y="csY0"/>
                </a:cxn>
                <a:cxn ang="0">
                  <a:pos x="csX1" y="csY1"/>
                </a:cxn>
              </a:cxnLst>
              <a:rect l="l" t="t" r="r" b="b"/>
              <a:pathLst>
                <a:path w="304461" h="64129">
                  <a:moveTo>
                    <a:pt x="303222" y="64536"/>
                  </a:moveTo>
                  <a:lnTo>
                    <a:pt x="-1239" y="406"/>
                  </a:lnTo>
                </a:path>
              </a:pathLst>
            </a:custGeom>
            <a:noFill/>
            <a:ln w="11787" cap="flat">
              <a:solidFill>
                <a:srgbClr val="FDAE61"/>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2" name="フリーフォーム: 図形 71">
              <a:extLst>
                <a:ext uri="{FF2B5EF4-FFF2-40B4-BE49-F238E27FC236}">
                  <a16:creationId xmlns:a16="http://schemas.microsoft.com/office/drawing/2014/main" id="{C1FB1FF8-B2D7-F436-9ECE-E5B44A70D0D5}"/>
                </a:ext>
              </a:extLst>
            </p:cNvPr>
            <p:cNvSpPr/>
            <p:nvPr/>
          </p:nvSpPr>
          <p:spPr>
            <a:xfrm rot="713673">
              <a:off x="1183111" y="4805749"/>
              <a:ext cx="5900" cy="11801"/>
            </a:xfrm>
            <a:custGeom>
              <a:avLst/>
              <a:gdLst>
                <a:gd name="csX0" fmla="*/ 295 w 5900"/>
                <a:gd name="csY0" fmla="*/ 11942 h 11801"/>
                <a:gd name="csX1" fmla="*/ 6196 w 5900"/>
                <a:gd name="csY1" fmla="*/ 6041 h 11801"/>
                <a:gd name="csX2" fmla="*/ 295 w 5900"/>
                <a:gd name="csY2" fmla="*/ 140 h 11801"/>
              </a:gdLst>
              <a:ahLst/>
              <a:cxnLst>
                <a:cxn ang="0">
                  <a:pos x="csX0" y="csY0"/>
                </a:cxn>
                <a:cxn ang="0">
                  <a:pos x="csX1" y="csY1"/>
                </a:cxn>
                <a:cxn ang="0">
                  <a:pos x="csX2" y="csY2"/>
                </a:cxn>
              </a:cxnLst>
              <a:rect l="l" t="t" r="r" b="b"/>
              <a:pathLst>
                <a:path w="5900" h="11801">
                  <a:moveTo>
                    <a:pt x="295" y="11942"/>
                  </a:moveTo>
                  <a:cubicBezTo>
                    <a:pt x="3554" y="11942"/>
                    <a:pt x="6196" y="9300"/>
                    <a:pt x="6196" y="6041"/>
                  </a:cubicBezTo>
                  <a:cubicBezTo>
                    <a:pt x="6196" y="2782"/>
                    <a:pt x="3554" y="140"/>
                    <a:pt x="295" y="140"/>
                  </a:cubicBezTo>
                  <a:close/>
                </a:path>
              </a:pathLst>
            </a:custGeom>
            <a:solidFill>
              <a:srgbClr val="FDAE61"/>
            </a:solidFill>
            <a:ln w="1178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3" name="フリーフォーム: 図形 72">
              <a:extLst>
                <a:ext uri="{FF2B5EF4-FFF2-40B4-BE49-F238E27FC236}">
                  <a16:creationId xmlns:a16="http://schemas.microsoft.com/office/drawing/2014/main" id="{E00BCC6A-6622-CAB7-8812-2DE3086CD35A}"/>
                </a:ext>
              </a:extLst>
            </p:cNvPr>
            <p:cNvSpPr/>
            <p:nvPr/>
          </p:nvSpPr>
          <p:spPr>
            <a:xfrm rot="11513673">
              <a:off x="827343" y="4728579"/>
              <a:ext cx="51926" cy="25963"/>
            </a:xfrm>
            <a:custGeom>
              <a:avLst/>
              <a:gdLst>
                <a:gd name="csX0" fmla="*/ 232 w 51926"/>
                <a:gd name="csY0" fmla="*/ 127 h 25963"/>
                <a:gd name="csX1" fmla="*/ 52159 w 51926"/>
                <a:gd name="csY1" fmla="*/ 13109 h 25963"/>
                <a:gd name="csX2" fmla="*/ 232 w 51926"/>
                <a:gd name="csY2" fmla="*/ 26090 h 25963"/>
              </a:gdLst>
              <a:ahLst/>
              <a:cxnLst>
                <a:cxn ang="0">
                  <a:pos x="csX0" y="csY0"/>
                </a:cxn>
                <a:cxn ang="0">
                  <a:pos x="csX1" y="csY1"/>
                </a:cxn>
                <a:cxn ang="0">
                  <a:pos x="csX2" y="csY2"/>
                </a:cxn>
              </a:cxnLst>
              <a:rect l="l" t="t" r="r" b="b"/>
              <a:pathLst>
                <a:path w="51926" h="25963">
                  <a:moveTo>
                    <a:pt x="232" y="127"/>
                  </a:moveTo>
                  <a:cubicBezTo>
                    <a:pt x="17541" y="8781"/>
                    <a:pt x="34850" y="13109"/>
                    <a:pt x="52159" y="13109"/>
                  </a:cubicBezTo>
                  <a:cubicBezTo>
                    <a:pt x="34850" y="13109"/>
                    <a:pt x="17541" y="17436"/>
                    <a:pt x="232" y="26090"/>
                  </a:cubicBezTo>
                  <a:close/>
                </a:path>
              </a:pathLst>
            </a:custGeom>
            <a:solidFill>
              <a:srgbClr val="FDAE61"/>
            </a:solidFill>
            <a:ln w="25932"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4" name="フリーフォーム: 図形 73">
              <a:extLst>
                <a:ext uri="{FF2B5EF4-FFF2-40B4-BE49-F238E27FC236}">
                  <a16:creationId xmlns:a16="http://schemas.microsoft.com/office/drawing/2014/main" id="{2073FB1E-531C-633B-7657-266DDBF5D985}"/>
                </a:ext>
              </a:extLst>
            </p:cNvPr>
            <p:cNvSpPr/>
            <p:nvPr/>
          </p:nvSpPr>
          <p:spPr>
            <a:xfrm>
              <a:off x="1654932" y="5250809"/>
              <a:ext cx="201900" cy="90106"/>
            </a:xfrm>
            <a:custGeom>
              <a:avLst/>
              <a:gdLst>
                <a:gd name="csX0" fmla="*/ 200494 w 201900"/>
                <a:gd name="csY0" fmla="*/ 90394 h 90106"/>
                <a:gd name="csX1" fmla="*/ -1407 w 201900"/>
                <a:gd name="csY1" fmla="*/ 287 h 90106"/>
              </a:gdLst>
              <a:ahLst/>
              <a:cxnLst>
                <a:cxn ang="0">
                  <a:pos x="csX0" y="csY0"/>
                </a:cxn>
                <a:cxn ang="0">
                  <a:pos x="csX1" y="csY1"/>
                </a:cxn>
              </a:cxnLst>
              <a:rect l="l" t="t" r="r" b="b"/>
              <a:pathLst>
                <a:path w="201900" h="90106">
                  <a:moveTo>
                    <a:pt x="200494" y="90394"/>
                  </a:moveTo>
                  <a:lnTo>
                    <a:pt x="-1407" y="287"/>
                  </a:lnTo>
                </a:path>
              </a:pathLst>
            </a:custGeom>
            <a:noFill/>
            <a:ln w="9429" cap="rnd">
              <a:solidFill>
                <a:srgbClr val="96969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5" name="フリーフォーム: 図形 74">
              <a:extLst>
                <a:ext uri="{FF2B5EF4-FFF2-40B4-BE49-F238E27FC236}">
                  <a16:creationId xmlns:a16="http://schemas.microsoft.com/office/drawing/2014/main" id="{9499F499-F6A1-8922-4901-300D26D0BEC1}"/>
                </a:ext>
              </a:extLst>
            </p:cNvPr>
            <p:cNvSpPr/>
            <p:nvPr/>
          </p:nvSpPr>
          <p:spPr>
            <a:xfrm>
              <a:off x="1017527" y="5350973"/>
              <a:ext cx="141618" cy="141617"/>
            </a:xfrm>
            <a:custGeom>
              <a:avLst/>
              <a:gdLst>
                <a:gd name="csX0" fmla="*/ 69557 w 141618"/>
                <a:gd name="csY0" fmla="*/ 258 h 141617"/>
                <a:gd name="csX1" fmla="*/ 140366 w 141618"/>
                <a:gd name="csY1" fmla="*/ 71067 h 141617"/>
                <a:gd name="csX2" fmla="*/ 69557 w 141618"/>
                <a:gd name="csY2" fmla="*/ 141876 h 141617"/>
                <a:gd name="csX3" fmla="*/ -1253 w 141618"/>
                <a:gd name="csY3" fmla="*/ 71067 h 141617"/>
              </a:gdLst>
              <a:ahLst/>
              <a:cxnLst>
                <a:cxn ang="0">
                  <a:pos x="csX0" y="csY0"/>
                </a:cxn>
                <a:cxn ang="0">
                  <a:pos x="csX1" y="csY1"/>
                </a:cxn>
                <a:cxn ang="0">
                  <a:pos x="csX2" y="csY2"/>
                </a:cxn>
                <a:cxn ang="0">
                  <a:pos x="csX3" y="csY3"/>
                </a:cxn>
              </a:cxnLst>
              <a:rect l="l" t="t" r="r" b="b"/>
              <a:pathLst>
                <a:path w="141618" h="141617">
                  <a:moveTo>
                    <a:pt x="69557" y="258"/>
                  </a:moveTo>
                  <a:lnTo>
                    <a:pt x="140366" y="71067"/>
                  </a:lnTo>
                  <a:lnTo>
                    <a:pt x="69557" y="141876"/>
                  </a:lnTo>
                  <a:lnTo>
                    <a:pt x="-1253" y="71067"/>
                  </a:lnTo>
                  <a:close/>
                </a:path>
              </a:pathLst>
            </a:custGeom>
            <a:noFill/>
            <a:ln w="11787" cap="rnd">
              <a:solidFill>
                <a:srgbClr val="4292C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6" name="フリーフォーム: 図形 75">
              <a:extLst>
                <a:ext uri="{FF2B5EF4-FFF2-40B4-BE49-F238E27FC236}">
                  <a16:creationId xmlns:a16="http://schemas.microsoft.com/office/drawing/2014/main" id="{F09918C5-FACD-4673-1DD6-DCF817034B31}"/>
                </a:ext>
              </a:extLst>
            </p:cNvPr>
            <p:cNvSpPr/>
            <p:nvPr/>
          </p:nvSpPr>
          <p:spPr>
            <a:xfrm>
              <a:off x="1017527" y="5350973"/>
              <a:ext cx="141618" cy="141617"/>
            </a:xfrm>
            <a:custGeom>
              <a:avLst/>
              <a:gdLst>
                <a:gd name="csX0" fmla="*/ 69557 w 141618"/>
                <a:gd name="csY0" fmla="*/ 258 h 141617"/>
                <a:gd name="csX1" fmla="*/ 140366 w 141618"/>
                <a:gd name="csY1" fmla="*/ 71067 h 141617"/>
                <a:gd name="csX2" fmla="*/ 69557 w 141618"/>
                <a:gd name="csY2" fmla="*/ 141876 h 141617"/>
                <a:gd name="csX3" fmla="*/ -1253 w 141618"/>
                <a:gd name="csY3" fmla="*/ 71067 h 141617"/>
              </a:gdLst>
              <a:ahLst/>
              <a:cxnLst>
                <a:cxn ang="0">
                  <a:pos x="csX0" y="csY0"/>
                </a:cxn>
                <a:cxn ang="0">
                  <a:pos x="csX1" y="csY1"/>
                </a:cxn>
                <a:cxn ang="0">
                  <a:pos x="csX2" y="csY2"/>
                </a:cxn>
                <a:cxn ang="0">
                  <a:pos x="csX3" y="csY3"/>
                </a:cxn>
              </a:cxnLst>
              <a:rect l="l" t="t" r="r" b="b"/>
              <a:pathLst>
                <a:path w="141618" h="141617">
                  <a:moveTo>
                    <a:pt x="69557" y="258"/>
                  </a:moveTo>
                  <a:lnTo>
                    <a:pt x="140366" y="71067"/>
                  </a:lnTo>
                  <a:lnTo>
                    <a:pt x="69557" y="141876"/>
                  </a:lnTo>
                  <a:lnTo>
                    <a:pt x="-1253" y="71067"/>
                  </a:lnTo>
                  <a:close/>
                </a:path>
              </a:pathLst>
            </a:custGeom>
            <a:solidFill>
              <a:srgbClr val="4292C6"/>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7" name="テキスト ボックス 76">
              <a:extLst>
                <a:ext uri="{FF2B5EF4-FFF2-40B4-BE49-F238E27FC236}">
                  <a16:creationId xmlns:a16="http://schemas.microsoft.com/office/drawing/2014/main" id="{C5399F4A-B709-EBE2-AD42-86C2F6D9D154}"/>
                </a:ext>
              </a:extLst>
            </p:cNvPr>
            <p:cNvSpPr txBox="1"/>
            <p:nvPr/>
          </p:nvSpPr>
          <p:spPr>
            <a:xfrm>
              <a:off x="912986" y="5344626"/>
              <a:ext cx="348172"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RAF24</a:t>
              </a:r>
            </a:p>
          </p:txBody>
        </p:sp>
        <p:sp>
          <p:nvSpPr>
            <p:cNvPr id="78" name="フリーフォーム: 図形 77">
              <a:extLst>
                <a:ext uri="{FF2B5EF4-FFF2-40B4-BE49-F238E27FC236}">
                  <a16:creationId xmlns:a16="http://schemas.microsoft.com/office/drawing/2014/main" id="{0099524A-2BBD-486C-7DF7-24AFCA69C108}"/>
                </a:ext>
              </a:extLst>
            </p:cNvPr>
            <p:cNvSpPr/>
            <p:nvPr/>
          </p:nvSpPr>
          <p:spPr>
            <a:xfrm>
              <a:off x="1159724" y="5202259"/>
              <a:ext cx="141618" cy="141617"/>
            </a:xfrm>
            <a:custGeom>
              <a:avLst/>
              <a:gdLst>
                <a:gd name="csX0" fmla="*/ 69524 w 141618"/>
                <a:gd name="csY0" fmla="*/ 292 h 141617"/>
                <a:gd name="csX1" fmla="*/ 140333 w 141618"/>
                <a:gd name="csY1" fmla="*/ 71101 h 141617"/>
                <a:gd name="csX2" fmla="*/ 69524 w 141618"/>
                <a:gd name="csY2" fmla="*/ 141910 h 141617"/>
                <a:gd name="csX3" fmla="*/ -1285 w 141618"/>
                <a:gd name="csY3" fmla="*/ 71101 h 141617"/>
              </a:gdLst>
              <a:ahLst/>
              <a:cxnLst>
                <a:cxn ang="0">
                  <a:pos x="csX0" y="csY0"/>
                </a:cxn>
                <a:cxn ang="0">
                  <a:pos x="csX1" y="csY1"/>
                </a:cxn>
                <a:cxn ang="0">
                  <a:pos x="csX2" y="csY2"/>
                </a:cxn>
                <a:cxn ang="0">
                  <a:pos x="csX3" y="csY3"/>
                </a:cxn>
              </a:cxnLst>
              <a:rect l="l" t="t" r="r" b="b"/>
              <a:pathLst>
                <a:path w="141618" h="141617">
                  <a:moveTo>
                    <a:pt x="69524" y="292"/>
                  </a:moveTo>
                  <a:lnTo>
                    <a:pt x="140333" y="71101"/>
                  </a:lnTo>
                  <a:lnTo>
                    <a:pt x="69524" y="141910"/>
                  </a:lnTo>
                  <a:lnTo>
                    <a:pt x="-1285" y="71101"/>
                  </a:lnTo>
                  <a:close/>
                </a:path>
              </a:pathLst>
            </a:custGeom>
            <a:noFill/>
            <a:ln w="11787" cap="rnd">
              <a:solidFill>
                <a:srgbClr val="4292C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79" name="フリーフォーム: 図形 78">
              <a:extLst>
                <a:ext uri="{FF2B5EF4-FFF2-40B4-BE49-F238E27FC236}">
                  <a16:creationId xmlns:a16="http://schemas.microsoft.com/office/drawing/2014/main" id="{6BEF84E6-BE0A-2A03-1AA4-71136B3944F6}"/>
                </a:ext>
              </a:extLst>
            </p:cNvPr>
            <p:cNvSpPr/>
            <p:nvPr/>
          </p:nvSpPr>
          <p:spPr>
            <a:xfrm>
              <a:off x="1159724" y="5202259"/>
              <a:ext cx="141618" cy="141617"/>
            </a:xfrm>
            <a:custGeom>
              <a:avLst/>
              <a:gdLst>
                <a:gd name="csX0" fmla="*/ 69524 w 141618"/>
                <a:gd name="csY0" fmla="*/ 292 h 141617"/>
                <a:gd name="csX1" fmla="*/ 140333 w 141618"/>
                <a:gd name="csY1" fmla="*/ 71101 h 141617"/>
                <a:gd name="csX2" fmla="*/ 69524 w 141618"/>
                <a:gd name="csY2" fmla="*/ 141910 h 141617"/>
                <a:gd name="csX3" fmla="*/ -1285 w 141618"/>
                <a:gd name="csY3" fmla="*/ 71101 h 141617"/>
              </a:gdLst>
              <a:ahLst/>
              <a:cxnLst>
                <a:cxn ang="0">
                  <a:pos x="csX0" y="csY0"/>
                </a:cxn>
                <a:cxn ang="0">
                  <a:pos x="csX1" y="csY1"/>
                </a:cxn>
                <a:cxn ang="0">
                  <a:pos x="csX2" y="csY2"/>
                </a:cxn>
                <a:cxn ang="0">
                  <a:pos x="csX3" y="csY3"/>
                </a:cxn>
              </a:cxnLst>
              <a:rect l="l" t="t" r="r" b="b"/>
              <a:pathLst>
                <a:path w="141618" h="141617">
                  <a:moveTo>
                    <a:pt x="69524" y="292"/>
                  </a:moveTo>
                  <a:lnTo>
                    <a:pt x="140333" y="71101"/>
                  </a:lnTo>
                  <a:lnTo>
                    <a:pt x="69524" y="141910"/>
                  </a:lnTo>
                  <a:lnTo>
                    <a:pt x="-1285" y="71101"/>
                  </a:lnTo>
                  <a:close/>
                </a:path>
              </a:pathLst>
            </a:custGeom>
            <a:solidFill>
              <a:srgbClr val="CEE0EC"/>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0" name="テキスト ボックス 79">
              <a:extLst>
                <a:ext uri="{FF2B5EF4-FFF2-40B4-BE49-F238E27FC236}">
                  <a16:creationId xmlns:a16="http://schemas.microsoft.com/office/drawing/2014/main" id="{C75DC4D3-9BC6-3CCC-A42D-597575407970}"/>
                </a:ext>
              </a:extLst>
            </p:cNvPr>
            <p:cNvSpPr txBox="1"/>
            <p:nvPr/>
          </p:nvSpPr>
          <p:spPr>
            <a:xfrm>
              <a:off x="1068019" y="5196446"/>
              <a:ext cx="317716"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TOT3</a:t>
              </a:r>
            </a:p>
          </p:txBody>
        </p:sp>
        <p:sp>
          <p:nvSpPr>
            <p:cNvPr id="81" name="フリーフォーム: 図形 80">
              <a:extLst>
                <a:ext uri="{FF2B5EF4-FFF2-40B4-BE49-F238E27FC236}">
                  <a16:creationId xmlns:a16="http://schemas.microsoft.com/office/drawing/2014/main" id="{57649743-424C-F93E-CC3C-601B0CA2F763}"/>
                </a:ext>
              </a:extLst>
            </p:cNvPr>
            <p:cNvSpPr/>
            <p:nvPr/>
          </p:nvSpPr>
          <p:spPr>
            <a:xfrm>
              <a:off x="1156824" y="5874724"/>
              <a:ext cx="129816" cy="129816"/>
            </a:xfrm>
            <a:custGeom>
              <a:avLst/>
              <a:gdLst>
                <a:gd name="csX0" fmla="*/ 128533 w 129816"/>
                <a:gd name="csY0" fmla="*/ 65047 h 129816"/>
                <a:gd name="csX1" fmla="*/ 63625 w 129816"/>
                <a:gd name="csY1" fmla="*/ 129955 h 129816"/>
                <a:gd name="csX2" fmla="*/ -1283 w 129816"/>
                <a:gd name="csY2" fmla="*/ 65047 h 129816"/>
                <a:gd name="csX3" fmla="*/ 63625 w 129816"/>
                <a:gd name="csY3" fmla="*/ 138 h 129816"/>
                <a:gd name="csX4" fmla="*/ 128533 w 129816"/>
                <a:gd name="csY4" fmla="*/ 65047 h 129816"/>
              </a:gdLst>
              <a:ahLst/>
              <a:cxnLst>
                <a:cxn ang="0">
                  <a:pos x="csX0" y="csY0"/>
                </a:cxn>
                <a:cxn ang="0">
                  <a:pos x="csX1" y="csY1"/>
                </a:cxn>
                <a:cxn ang="0">
                  <a:pos x="csX2" y="csY2"/>
                </a:cxn>
                <a:cxn ang="0">
                  <a:pos x="csX3" y="csY3"/>
                </a:cxn>
                <a:cxn ang="0">
                  <a:pos x="csX4" y="csY4"/>
                </a:cxn>
              </a:cxnLst>
              <a:rect l="l" t="t" r="r" b="b"/>
              <a:pathLst>
                <a:path w="129816" h="129816">
                  <a:moveTo>
                    <a:pt x="128533" y="65047"/>
                  </a:moveTo>
                  <a:cubicBezTo>
                    <a:pt x="128533" y="100894"/>
                    <a:pt x="99473" y="129955"/>
                    <a:pt x="63625" y="129955"/>
                  </a:cubicBezTo>
                  <a:cubicBezTo>
                    <a:pt x="27777" y="129955"/>
                    <a:pt x="-1283" y="100894"/>
                    <a:pt x="-1283" y="65047"/>
                  </a:cubicBezTo>
                  <a:cubicBezTo>
                    <a:pt x="-1283" y="29199"/>
                    <a:pt x="27777" y="138"/>
                    <a:pt x="63625" y="138"/>
                  </a:cubicBezTo>
                  <a:cubicBezTo>
                    <a:pt x="99473" y="138"/>
                    <a:pt x="128533" y="29199"/>
                    <a:pt x="128533" y="65047"/>
                  </a:cubicBez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2" name="フリーフォーム: 図形 81">
              <a:extLst>
                <a:ext uri="{FF2B5EF4-FFF2-40B4-BE49-F238E27FC236}">
                  <a16:creationId xmlns:a16="http://schemas.microsoft.com/office/drawing/2014/main" id="{6FAE3EEF-3648-AA5F-B0DE-373C850A65CD}"/>
                </a:ext>
              </a:extLst>
            </p:cNvPr>
            <p:cNvSpPr/>
            <p:nvPr/>
          </p:nvSpPr>
          <p:spPr>
            <a:xfrm>
              <a:off x="1156824" y="5874724"/>
              <a:ext cx="129816" cy="129816"/>
            </a:xfrm>
            <a:custGeom>
              <a:avLst/>
              <a:gdLst>
                <a:gd name="csX0" fmla="*/ 128533 w 129816"/>
                <a:gd name="csY0" fmla="*/ 65047 h 129816"/>
                <a:gd name="csX1" fmla="*/ 63625 w 129816"/>
                <a:gd name="csY1" fmla="*/ 129955 h 129816"/>
                <a:gd name="csX2" fmla="*/ -1283 w 129816"/>
                <a:gd name="csY2" fmla="*/ 65047 h 129816"/>
                <a:gd name="csX3" fmla="*/ 63625 w 129816"/>
                <a:gd name="csY3" fmla="*/ 138 h 129816"/>
                <a:gd name="csX4" fmla="*/ 128533 w 129816"/>
                <a:gd name="csY4" fmla="*/ 65047 h 129816"/>
              </a:gdLst>
              <a:ahLst/>
              <a:cxnLst>
                <a:cxn ang="0">
                  <a:pos x="csX0" y="csY0"/>
                </a:cxn>
                <a:cxn ang="0">
                  <a:pos x="csX1" y="csY1"/>
                </a:cxn>
                <a:cxn ang="0">
                  <a:pos x="csX2" y="csY2"/>
                </a:cxn>
                <a:cxn ang="0">
                  <a:pos x="csX3" y="csY3"/>
                </a:cxn>
                <a:cxn ang="0">
                  <a:pos x="csX4" y="csY4"/>
                </a:cxn>
              </a:cxnLst>
              <a:rect l="l" t="t" r="r" b="b"/>
              <a:pathLst>
                <a:path w="129816" h="129816">
                  <a:moveTo>
                    <a:pt x="128533" y="65047"/>
                  </a:moveTo>
                  <a:cubicBezTo>
                    <a:pt x="128533" y="100894"/>
                    <a:pt x="99473" y="129955"/>
                    <a:pt x="63625" y="129955"/>
                  </a:cubicBezTo>
                  <a:cubicBezTo>
                    <a:pt x="27777" y="129955"/>
                    <a:pt x="-1283" y="100894"/>
                    <a:pt x="-1283" y="65047"/>
                  </a:cubicBezTo>
                  <a:cubicBezTo>
                    <a:pt x="-1283" y="29199"/>
                    <a:pt x="27777" y="138"/>
                    <a:pt x="63625" y="138"/>
                  </a:cubicBezTo>
                  <a:cubicBezTo>
                    <a:pt x="99473" y="138"/>
                    <a:pt x="128533" y="29199"/>
                    <a:pt x="128533" y="65047"/>
                  </a:cubicBezTo>
                  <a:close/>
                </a:path>
              </a:pathLst>
            </a:custGeom>
            <a:solidFill>
              <a:srgbClr val="FA7837"/>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3" name="テキスト ボックス 82">
              <a:extLst>
                <a:ext uri="{FF2B5EF4-FFF2-40B4-BE49-F238E27FC236}">
                  <a16:creationId xmlns:a16="http://schemas.microsoft.com/office/drawing/2014/main" id="{B928DA74-71C0-367B-9A47-DB09B4B5FA6F}"/>
                </a:ext>
              </a:extLst>
            </p:cNvPr>
            <p:cNvSpPr txBox="1"/>
            <p:nvPr/>
          </p:nvSpPr>
          <p:spPr>
            <a:xfrm>
              <a:off x="1061523" y="5861839"/>
              <a:ext cx="319318"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ABF3</a:t>
              </a:r>
            </a:p>
          </p:txBody>
        </p:sp>
        <p:sp>
          <p:nvSpPr>
            <p:cNvPr id="84" name="フリーフォーム: 図形 83">
              <a:extLst>
                <a:ext uri="{FF2B5EF4-FFF2-40B4-BE49-F238E27FC236}">
                  <a16:creationId xmlns:a16="http://schemas.microsoft.com/office/drawing/2014/main" id="{11B8FC74-A765-A68C-DA51-9882BF4028CF}"/>
                </a:ext>
              </a:extLst>
            </p:cNvPr>
            <p:cNvSpPr/>
            <p:nvPr/>
          </p:nvSpPr>
          <p:spPr>
            <a:xfrm>
              <a:off x="923961" y="4587836"/>
              <a:ext cx="129816" cy="129816"/>
            </a:xfrm>
            <a:custGeom>
              <a:avLst/>
              <a:gdLst>
                <a:gd name="csX0" fmla="*/ 128587 w 129816"/>
                <a:gd name="csY0" fmla="*/ 65344 h 129816"/>
                <a:gd name="csX1" fmla="*/ 63679 w 129816"/>
                <a:gd name="csY1" fmla="*/ 130252 h 129816"/>
                <a:gd name="csX2" fmla="*/ -1230 w 129816"/>
                <a:gd name="csY2" fmla="*/ 65344 h 129816"/>
                <a:gd name="csX3" fmla="*/ 63679 w 129816"/>
                <a:gd name="csY3" fmla="*/ 435 h 129816"/>
                <a:gd name="csX4" fmla="*/ 128587 w 129816"/>
                <a:gd name="csY4" fmla="*/ 65344 h 129816"/>
              </a:gdLst>
              <a:ahLst/>
              <a:cxnLst>
                <a:cxn ang="0">
                  <a:pos x="csX0" y="csY0"/>
                </a:cxn>
                <a:cxn ang="0">
                  <a:pos x="csX1" y="csY1"/>
                </a:cxn>
                <a:cxn ang="0">
                  <a:pos x="csX2" y="csY2"/>
                </a:cxn>
                <a:cxn ang="0">
                  <a:pos x="csX3" y="csY3"/>
                </a:cxn>
                <a:cxn ang="0">
                  <a:pos x="csX4" y="csY4"/>
                </a:cxn>
              </a:cxnLst>
              <a:rect l="l" t="t" r="r" b="b"/>
              <a:pathLst>
                <a:path w="129816" h="129816">
                  <a:moveTo>
                    <a:pt x="128587" y="65344"/>
                  </a:moveTo>
                  <a:cubicBezTo>
                    <a:pt x="128587" y="101191"/>
                    <a:pt x="99527" y="130252"/>
                    <a:pt x="63679" y="130252"/>
                  </a:cubicBezTo>
                  <a:cubicBezTo>
                    <a:pt x="27831" y="130252"/>
                    <a:pt x="-1230" y="101191"/>
                    <a:pt x="-1230" y="65344"/>
                  </a:cubicBezTo>
                  <a:cubicBezTo>
                    <a:pt x="-1230" y="29496"/>
                    <a:pt x="27831" y="435"/>
                    <a:pt x="63679" y="435"/>
                  </a:cubicBezTo>
                  <a:cubicBezTo>
                    <a:pt x="99527" y="435"/>
                    <a:pt x="128587" y="29496"/>
                    <a:pt x="128587" y="65344"/>
                  </a:cubicBezTo>
                  <a:close/>
                </a:path>
              </a:pathLst>
            </a:custGeom>
            <a:noFill/>
            <a:ln w="11787" cap="rnd">
              <a:solidFill>
                <a:srgbClr val="4292C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5" name="フリーフォーム: 図形 84">
              <a:extLst>
                <a:ext uri="{FF2B5EF4-FFF2-40B4-BE49-F238E27FC236}">
                  <a16:creationId xmlns:a16="http://schemas.microsoft.com/office/drawing/2014/main" id="{AEC1D329-A40B-F34F-0BA0-7875E2A76CBD}"/>
                </a:ext>
              </a:extLst>
            </p:cNvPr>
            <p:cNvSpPr/>
            <p:nvPr/>
          </p:nvSpPr>
          <p:spPr>
            <a:xfrm>
              <a:off x="923961" y="4587836"/>
              <a:ext cx="129816" cy="129816"/>
            </a:xfrm>
            <a:custGeom>
              <a:avLst/>
              <a:gdLst>
                <a:gd name="csX0" fmla="*/ 128587 w 129816"/>
                <a:gd name="csY0" fmla="*/ 65344 h 129816"/>
                <a:gd name="csX1" fmla="*/ 63679 w 129816"/>
                <a:gd name="csY1" fmla="*/ 130252 h 129816"/>
                <a:gd name="csX2" fmla="*/ -1230 w 129816"/>
                <a:gd name="csY2" fmla="*/ 65344 h 129816"/>
                <a:gd name="csX3" fmla="*/ 63679 w 129816"/>
                <a:gd name="csY3" fmla="*/ 435 h 129816"/>
                <a:gd name="csX4" fmla="*/ 128587 w 129816"/>
                <a:gd name="csY4" fmla="*/ 65344 h 129816"/>
              </a:gdLst>
              <a:ahLst/>
              <a:cxnLst>
                <a:cxn ang="0">
                  <a:pos x="csX0" y="csY0"/>
                </a:cxn>
                <a:cxn ang="0">
                  <a:pos x="csX1" y="csY1"/>
                </a:cxn>
                <a:cxn ang="0">
                  <a:pos x="csX2" y="csY2"/>
                </a:cxn>
                <a:cxn ang="0">
                  <a:pos x="csX3" y="csY3"/>
                </a:cxn>
                <a:cxn ang="0">
                  <a:pos x="csX4" y="csY4"/>
                </a:cxn>
              </a:cxnLst>
              <a:rect l="l" t="t" r="r" b="b"/>
              <a:pathLst>
                <a:path w="129816" h="129816">
                  <a:moveTo>
                    <a:pt x="128587" y="65344"/>
                  </a:moveTo>
                  <a:cubicBezTo>
                    <a:pt x="128587" y="101191"/>
                    <a:pt x="99527" y="130252"/>
                    <a:pt x="63679" y="130252"/>
                  </a:cubicBezTo>
                  <a:cubicBezTo>
                    <a:pt x="27831" y="130252"/>
                    <a:pt x="-1230" y="101191"/>
                    <a:pt x="-1230" y="65344"/>
                  </a:cubicBezTo>
                  <a:cubicBezTo>
                    <a:pt x="-1230" y="29496"/>
                    <a:pt x="27831" y="435"/>
                    <a:pt x="63679" y="435"/>
                  </a:cubicBezTo>
                  <a:cubicBezTo>
                    <a:pt x="99527" y="435"/>
                    <a:pt x="128587" y="29496"/>
                    <a:pt x="128587" y="65344"/>
                  </a:cubicBezTo>
                  <a:close/>
                </a:path>
              </a:pathLst>
            </a:custGeom>
            <a:solidFill>
              <a:srgbClr val="4292C6"/>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6" name="テキスト ボックス 85">
              <a:extLst>
                <a:ext uri="{FF2B5EF4-FFF2-40B4-BE49-F238E27FC236}">
                  <a16:creationId xmlns:a16="http://schemas.microsoft.com/office/drawing/2014/main" id="{F2892A35-2269-116B-6792-813CCBEFEA7A}"/>
                </a:ext>
              </a:extLst>
            </p:cNvPr>
            <p:cNvSpPr txBox="1"/>
            <p:nvPr/>
          </p:nvSpPr>
          <p:spPr>
            <a:xfrm>
              <a:off x="832201" y="4573758"/>
              <a:ext cx="316112"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JAC1</a:t>
              </a:r>
            </a:p>
          </p:txBody>
        </p:sp>
        <p:sp>
          <p:nvSpPr>
            <p:cNvPr id="87" name="フリーフォーム: 図形 86">
              <a:extLst>
                <a:ext uri="{FF2B5EF4-FFF2-40B4-BE49-F238E27FC236}">
                  <a16:creationId xmlns:a16="http://schemas.microsoft.com/office/drawing/2014/main" id="{B13609EC-AB53-1242-D08F-43CDC91AFF06}"/>
                </a:ext>
              </a:extLst>
            </p:cNvPr>
            <p:cNvSpPr/>
            <p:nvPr/>
          </p:nvSpPr>
          <p:spPr>
            <a:xfrm>
              <a:off x="1844978" y="5527907"/>
              <a:ext cx="141618" cy="141617"/>
            </a:xfrm>
            <a:custGeom>
              <a:avLst/>
              <a:gdLst>
                <a:gd name="csX0" fmla="*/ 69366 w 141618"/>
                <a:gd name="csY0" fmla="*/ 217 h 141617"/>
                <a:gd name="csX1" fmla="*/ 140175 w 141618"/>
                <a:gd name="csY1" fmla="*/ 71026 h 141617"/>
                <a:gd name="csX2" fmla="*/ 69366 w 141618"/>
                <a:gd name="csY2" fmla="*/ 141835 h 141617"/>
                <a:gd name="csX3" fmla="*/ -1444 w 141618"/>
                <a:gd name="csY3" fmla="*/ 71026 h 141617"/>
              </a:gdLst>
              <a:ahLst/>
              <a:cxnLst>
                <a:cxn ang="0">
                  <a:pos x="csX0" y="csY0"/>
                </a:cxn>
                <a:cxn ang="0">
                  <a:pos x="csX1" y="csY1"/>
                </a:cxn>
                <a:cxn ang="0">
                  <a:pos x="csX2" y="csY2"/>
                </a:cxn>
                <a:cxn ang="0">
                  <a:pos x="csX3" y="csY3"/>
                </a:cxn>
              </a:cxnLst>
              <a:rect l="l" t="t" r="r" b="b"/>
              <a:pathLst>
                <a:path w="141618" h="141617">
                  <a:moveTo>
                    <a:pt x="69366" y="217"/>
                  </a:moveTo>
                  <a:lnTo>
                    <a:pt x="140175" y="71026"/>
                  </a:lnTo>
                  <a:lnTo>
                    <a:pt x="69366" y="141835"/>
                  </a:lnTo>
                  <a:lnTo>
                    <a:pt x="-1444" y="71026"/>
                  </a:ln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8" name="フリーフォーム: 図形 87">
              <a:extLst>
                <a:ext uri="{FF2B5EF4-FFF2-40B4-BE49-F238E27FC236}">
                  <a16:creationId xmlns:a16="http://schemas.microsoft.com/office/drawing/2014/main" id="{55387E9D-466C-27AA-4CF8-4ADE515A140E}"/>
                </a:ext>
              </a:extLst>
            </p:cNvPr>
            <p:cNvSpPr/>
            <p:nvPr/>
          </p:nvSpPr>
          <p:spPr>
            <a:xfrm>
              <a:off x="1844978" y="5527907"/>
              <a:ext cx="141618" cy="141617"/>
            </a:xfrm>
            <a:custGeom>
              <a:avLst/>
              <a:gdLst>
                <a:gd name="csX0" fmla="*/ 69366 w 141618"/>
                <a:gd name="csY0" fmla="*/ 217 h 141617"/>
                <a:gd name="csX1" fmla="*/ 140175 w 141618"/>
                <a:gd name="csY1" fmla="*/ 71026 h 141617"/>
                <a:gd name="csX2" fmla="*/ 69366 w 141618"/>
                <a:gd name="csY2" fmla="*/ 141835 h 141617"/>
                <a:gd name="csX3" fmla="*/ -1444 w 141618"/>
                <a:gd name="csY3" fmla="*/ 71026 h 141617"/>
              </a:gdLst>
              <a:ahLst/>
              <a:cxnLst>
                <a:cxn ang="0">
                  <a:pos x="csX0" y="csY0"/>
                </a:cxn>
                <a:cxn ang="0">
                  <a:pos x="csX1" y="csY1"/>
                </a:cxn>
                <a:cxn ang="0">
                  <a:pos x="csX2" y="csY2"/>
                </a:cxn>
                <a:cxn ang="0">
                  <a:pos x="csX3" y="csY3"/>
                </a:cxn>
              </a:cxnLst>
              <a:rect l="l" t="t" r="r" b="b"/>
              <a:pathLst>
                <a:path w="141618" h="141617">
                  <a:moveTo>
                    <a:pt x="69366" y="217"/>
                  </a:moveTo>
                  <a:lnTo>
                    <a:pt x="140175" y="71026"/>
                  </a:lnTo>
                  <a:lnTo>
                    <a:pt x="69366" y="141835"/>
                  </a:lnTo>
                  <a:lnTo>
                    <a:pt x="-1444" y="71026"/>
                  </a:lnTo>
                  <a:close/>
                </a:path>
              </a:pathLst>
            </a:custGeom>
            <a:solidFill>
              <a:srgbClr val="F7E4DA"/>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89" name="テキスト ボックス 88">
              <a:extLst>
                <a:ext uri="{FF2B5EF4-FFF2-40B4-BE49-F238E27FC236}">
                  <a16:creationId xmlns:a16="http://schemas.microsoft.com/office/drawing/2014/main" id="{FBC2A1E2-B799-F1C3-EA9D-37D0F96B8C4E}"/>
                </a:ext>
              </a:extLst>
            </p:cNvPr>
            <p:cNvSpPr txBox="1"/>
            <p:nvPr/>
          </p:nvSpPr>
          <p:spPr>
            <a:xfrm>
              <a:off x="1757283" y="5525126"/>
              <a:ext cx="335348"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SRK2I</a:t>
              </a:r>
            </a:p>
          </p:txBody>
        </p:sp>
        <p:sp>
          <p:nvSpPr>
            <p:cNvPr id="90" name="フリーフォーム: 図形 89">
              <a:extLst>
                <a:ext uri="{FF2B5EF4-FFF2-40B4-BE49-F238E27FC236}">
                  <a16:creationId xmlns:a16="http://schemas.microsoft.com/office/drawing/2014/main" id="{A5AB8037-DF98-CE69-04D0-D5F2ACDD0E5E}"/>
                </a:ext>
              </a:extLst>
            </p:cNvPr>
            <p:cNvSpPr/>
            <p:nvPr/>
          </p:nvSpPr>
          <p:spPr>
            <a:xfrm>
              <a:off x="939750" y="5069196"/>
              <a:ext cx="129816" cy="129816"/>
            </a:xfrm>
            <a:custGeom>
              <a:avLst/>
              <a:gdLst>
                <a:gd name="csX0" fmla="*/ 128583 w 129816"/>
                <a:gd name="csY0" fmla="*/ 65232 h 129816"/>
                <a:gd name="csX1" fmla="*/ 63675 w 129816"/>
                <a:gd name="csY1" fmla="*/ 130141 h 129816"/>
                <a:gd name="csX2" fmla="*/ -1233 w 129816"/>
                <a:gd name="csY2" fmla="*/ 65232 h 129816"/>
                <a:gd name="csX3" fmla="*/ 63675 w 129816"/>
                <a:gd name="csY3" fmla="*/ 324 h 129816"/>
                <a:gd name="csX4" fmla="*/ 128583 w 129816"/>
                <a:gd name="csY4" fmla="*/ 65232 h 129816"/>
              </a:gdLst>
              <a:ahLst/>
              <a:cxnLst>
                <a:cxn ang="0">
                  <a:pos x="csX0" y="csY0"/>
                </a:cxn>
                <a:cxn ang="0">
                  <a:pos x="csX1" y="csY1"/>
                </a:cxn>
                <a:cxn ang="0">
                  <a:pos x="csX2" y="csY2"/>
                </a:cxn>
                <a:cxn ang="0">
                  <a:pos x="csX3" y="csY3"/>
                </a:cxn>
                <a:cxn ang="0">
                  <a:pos x="csX4" y="csY4"/>
                </a:cxn>
              </a:cxnLst>
              <a:rect l="l" t="t" r="r" b="b"/>
              <a:pathLst>
                <a:path w="129816" h="129816">
                  <a:moveTo>
                    <a:pt x="128583" y="65232"/>
                  </a:moveTo>
                  <a:cubicBezTo>
                    <a:pt x="128583" y="101080"/>
                    <a:pt x="99523" y="130141"/>
                    <a:pt x="63675" y="130141"/>
                  </a:cubicBezTo>
                  <a:cubicBezTo>
                    <a:pt x="27827" y="130141"/>
                    <a:pt x="-1233" y="101080"/>
                    <a:pt x="-1233" y="65232"/>
                  </a:cubicBezTo>
                  <a:cubicBezTo>
                    <a:pt x="-1233" y="29385"/>
                    <a:pt x="27827" y="324"/>
                    <a:pt x="63675" y="324"/>
                  </a:cubicBezTo>
                  <a:cubicBezTo>
                    <a:pt x="99523" y="324"/>
                    <a:pt x="128583" y="29385"/>
                    <a:pt x="128583" y="65232"/>
                  </a:cubicBezTo>
                  <a:close/>
                </a:path>
              </a:pathLst>
            </a:custGeom>
            <a:noFill/>
            <a:ln w="11787" cap="rnd">
              <a:solidFill>
                <a:srgbClr val="4292C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91" name="フリーフォーム: 図形 90">
              <a:extLst>
                <a:ext uri="{FF2B5EF4-FFF2-40B4-BE49-F238E27FC236}">
                  <a16:creationId xmlns:a16="http://schemas.microsoft.com/office/drawing/2014/main" id="{A710E837-5EC4-75D3-7C3F-2FDD8E710CF8}"/>
                </a:ext>
              </a:extLst>
            </p:cNvPr>
            <p:cNvSpPr/>
            <p:nvPr/>
          </p:nvSpPr>
          <p:spPr>
            <a:xfrm>
              <a:off x="939750" y="5069196"/>
              <a:ext cx="129816" cy="129816"/>
            </a:xfrm>
            <a:custGeom>
              <a:avLst/>
              <a:gdLst>
                <a:gd name="csX0" fmla="*/ 128583 w 129816"/>
                <a:gd name="csY0" fmla="*/ 65232 h 129816"/>
                <a:gd name="csX1" fmla="*/ 63675 w 129816"/>
                <a:gd name="csY1" fmla="*/ 130141 h 129816"/>
                <a:gd name="csX2" fmla="*/ -1233 w 129816"/>
                <a:gd name="csY2" fmla="*/ 65232 h 129816"/>
                <a:gd name="csX3" fmla="*/ 63675 w 129816"/>
                <a:gd name="csY3" fmla="*/ 324 h 129816"/>
                <a:gd name="csX4" fmla="*/ 128583 w 129816"/>
                <a:gd name="csY4" fmla="*/ 65232 h 129816"/>
              </a:gdLst>
              <a:ahLst/>
              <a:cxnLst>
                <a:cxn ang="0">
                  <a:pos x="csX0" y="csY0"/>
                </a:cxn>
                <a:cxn ang="0">
                  <a:pos x="csX1" y="csY1"/>
                </a:cxn>
                <a:cxn ang="0">
                  <a:pos x="csX2" y="csY2"/>
                </a:cxn>
                <a:cxn ang="0">
                  <a:pos x="csX3" y="csY3"/>
                </a:cxn>
                <a:cxn ang="0">
                  <a:pos x="csX4" y="csY4"/>
                </a:cxn>
              </a:cxnLst>
              <a:rect l="l" t="t" r="r" b="b"/>
              <a:pathLst>
                <a:path w="129816" h="129816">
                  <a:moveTo>
                    <a:pt x="128583" y="65232"/>
                  </a:moveTo>
                  <a:cubicBezTo>
                    <a:pt x="128583" y="101080"/>
                    <a:pt x="99523" y="130141"/>
                    <a:pt x="63675" y="130141"/>
                  </a:cubicBezTo>
                  <a:cubicBezTo>
                    <a:pt x="27827" y="130141"/>
                    <a:pt x="-1233" y="101080"/>
                    <a:pt x="-1233" y="65232"/>
                  </a:cubicBezTo>
                  <a:cubicBezTo>
                    <a:pt x="-1233" y="29385"/>
                    <a:pt x="27827" y="324"/>
                    <a:pt x="63675" y="324"/>
                  </a:cubicBezTo>
                  <a:cubicBezTo>
                    <a:pt x="99523" y="324"/>
                    <a:pt x="128583" y="29385"/>
                    <a:pt x="128583" y="65232"/>
                  </a:cubicBezTo>
                  <a:close/>
                </a:path>
              </a:pathLst>
            </a:custGeom>
            <a:solidFill>
              <a:srgbClr val="E7EEF3"/>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92" name="テキスト ボックス 91">
              <a:extLst>
                <a:ext uri="{FF2B5EF4-FFF2-40B4-BE49-F238E27FC236}">
                  <a16:creationId xmlns:a16="http://schemas.microsoft.com/office/drawing/2014/main" id="{DFD0904C-8F8D-2591-E1EE-1E020E9A8F52}"/>
                </a:ext>
              </a:extLst>
            </p:cNvPr>
            <p:cNvSpPr txBox="1"/>
            <p:nvPr/>
          </p:nvSpPr>
          <p:spPr>
            <a:xfrm>
              <a:off x="842434" y="5055449"/>
              <a:ext cx="324128"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AHA1</a:t>
              </a:r>
            </a:p>
          </p:txBody>
        </p:sp>
        <p:sp>
          <p:nvSpPr>
            <p:cNvPr id="93" name="フリーフォーム: 図形 92">
              <a:extLst>
                <a:ext uri="{FF2B5EF4-FFF2-40B4-BE49-F238E27FC236}">
                  <a16:creationId xmlns:a16="http://schemas.microsoft.com/office/drawing/2014/main" id="{658578CE-FEFF-6D55-EB55-57A013115814}"/>
                </a:ext>
              </a:extLst>
            </p:cNvPr>
            <p:cNvSpPr/>
            <p:nvPr/>
          </p:nvSpPr>
          <p:spPr>
            <a:xfrm>
              <a:off x="696256" y="5186443"/>
              <a:ext cx="129816" cy="129816"/>
            </a:xfrm>
            <a:custGeom>
              <a:avLst/>
              <a:gdLst>
                <a:gd name="csX0" fmla="*/ 128640 w 129816"/>
                <a:gd name="csY0" fmla="*/ 65205 h 129816"/>
                <a:gd name="csX1" fmla="*/ 63731 w 129816"/>
                <a:gd name="csY1" fmla="*/ 130114 h 129816"/>
                <a:gd name="csX2" fmla="*/ -1177 w 129816"/>
                <a:gd name="csY2" fmla="*/ 65205 h 129816"/>
                <a:gd name="csX3" fmla="*/ 63731 w 129816"/>
                <a:gd name="csY3" fmla="*/ 297 h 129816"/>
                <a:gd name="csX4" fmla="*/ 128640 w 129816"/>
                <a:gd name="csY4" fmla="*/ 65205 h 129816"/>
              </a:gdLst>
              <a:ahLst/>
              <a:cxnLst>
                <a:cxn ang="0">
                  <a:pos x="csX0" y="csY0"/>
                </a:cxn>
                <a:cxn ang="0">
                  <a:pos x="csX1" y="csY1"/>
                </a:cxn>
                <a:cxn ang="0">
                  <a:pos x="csX2" y="csY2"/>
                </a:cxn>
                <a:cxn ang="0">
                  <a:pos x="csX3" y="csY3"/>
                </a:cxn>
                <a:cxn ang="0">
                  <a:pos x="csX4" y="csY4"/>
                </a:cxn>
              </a:cxnLst>
              <a:rect l="l" t="t" r="r" b="b"/>
              <a:pathLst>
                <a:path w="129816" h="129816">
                  <a:moveTo>
                    <a:pt x="128640" y="65205"/>
                  </a:moveTo>
                  <a:cubicBezTo>
                    <a:pt x="128640" y="101053"/>
                    <a:pt x="99579" y="130114"/>
                    <a:pt x="63731" y="130114"/>
                  </a:cubicBezTo>
                  <a:cubicBezTo>
                    <a:pt x="27883" y="130114"/>
                    <a:pt x="-1177" y="101053"/>
                    <a:pt x="-1177" y="65205"/>
                  </a:cubicBezTo>
                  <a:cubicBezTo>
                    <a:pt x="-1177" y="29358"/>
                    <a:pt x="27883" y="297"/>
                    <a:pt x="63731" y="297"/>
                  </a:cubicBezTo>
                  <a:cubicBezTo>
                    <a:pt x="99579" y="297"/>
                    <a:pt x="128640" y="29358"/>
                    <a:pt x="128640" y="65205"/>
                  </a:cubicBezTo>
                  <a:close/>
                </a:path>
              </a:pathLst>
            </a:custGeom>
            <a:noFill/>
            <a:ln w="11787" cap="rnd">
              <a:solidFill>
                <a:srgbClr val="4292C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94" name="フリーフォーム: 図形 93">
              <a:extLst>
                <a:ext uri="{FF2B5EF4-FFF2-40B4-BE49-F238E27FC236}">
                  <a16:creationId xmlns:a16="http://schemas.microsoft.com/office/drawing/2014/main" id="{5B00ED20-9731-7D9E-A189-38C5650720CE}"/>
                </a:ext>
              </a:extLst>
            </p:cNvPr>
            <p:cNvSpPr/>
            <p:nvPr/>
          </p:nvSpPr>
          <p:spPr>
            <a:xfrm>
              <a:off x="696256" y="5186443"/>
              <a:ext cx="129816" cy="129816"/>
            </a:xfrm>
            <a:custGeom>
              <a:avLst/>
              <a:gdLst>
                <a:gd name="csX0" fmla="*/ 128640 w 129816"/>
                <a:gd name="csY0" fmla="*/ 65205 h 129816"/>
                <a:gd name="csX1" fmla="*/ 63731 w 129816"/>
                <a:gd name="csY1" fmla="*/ 130114 h 129816"/>
                <a:gd name="csX2" fmla="*/ -1177 w 129816"/>
                <a:gd name="csY2" fmla="*/ 65205 h 129816"/>
                <a:gd name="csX3" fmla="*/ 63731 w 129816"/>
                <a:gd name="csY3" fmla="*/ 297 h 129816"/>
                <a:gd name="csX4" fmla="*/ 128640 w 129816"/>
                <a:gd name="csY4" fmla="*/ 65205 h 129816"/>
              </a:gdLst>
              <a:ahLst/>
              <a:cxnLst>
                <a:cxn ang="0">
                  <a:pos x="csX0" y="csY0"/>
                </a:cxn>
                <a:cxn ang="0">
                  <a:pos x="csX1" y="csY1"/>
                </a:cxn>
                <a:cxn ang="0">
                  <a:pos x="csX2" y="csY2"/>
                </a:cxn>
                <a:cxn ang="0">
                  <a:pos x="csX3" y="csY3"/>
                </a:cxn>
                <a:cxn ang="0">
                  <a:pos x="csX4" y="csY4"/>
                </a:cxn>
              </a:cxnLst>
              <a:rect l="l" t="t" r="r" b="b"/>
              <a:pathLst>
                <a:path w="129816" h="129816">
                  <a:moveTo>
                    <a:pt x="128640" y="65205"/>
                  </a:moveTo>
                  <a:cubicBezTo>
                    <a:pt x="128640" y="101053"/>
                    <a:pt x="99579" y="130114"/>
                    <a:pt x="63731" y="130114"/>
                  </a:cubicBezTo>
                  <a:cubicBezTo>
                    <a:pt x="27883" y="130114"/>
                    <a:pt x="-1177" y="101053"/>
                    <a:pt x="-1177" y="65205"/>
                  </a:cubicBezTo>
                  <a:cubicBezTo>
                    <a:pt x="-1177" y="29358"/>
                    <a:pt x="27883" y="297"/>
                    <a:pt x="63731" y="297"/>
                  </a:cubicBezTo>
                  <a:cubicBezTo>
                    <a:pt x="99579" y="297"/>
                    <a:pt x="128640" y="29358"/>
                    <a:pt x="128640" y="65205"/>
                  </a:cubicBezTo>
                  <a:close/>
                </a:path>
              </a:pathLst>
            </a:custGeom>
            <a:solidFill>
              <a:srgbClr val="DCE8F0"/>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95" name="テキスト ボックス 94">
              <a:extLst>
                <a:ext uri="{FF2B5EF4-FFF2-40B4-BE49-F238E27FC236}">
                  <a16:creationId xmlns:a16="http://schemas.microsoft.com/office/drawing/2014/main" id="{907D27CF-8A1A-1054-1764-198DDB5761E3}"/>
                </a:ext>
              </a:extLst>
            </p:cNvPr>
            <p:cNvSpPr txBox="1"/>
            <p:nvPr/>
          </p:nvSpPr>
          <p:spPr>
            <a:xfrm>
              <a:off x="590724" y="5173865"/>
              <a:ext cx="341760"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PIP2-6</a:t>
              </a:r>
            </a:p>
          </p:txBody>
        </p:sp>
        <p:sp>
          <p:nvSpPr>
            <p:cNvPr id="96" name="フリーフォーム: 図形 95">
              <a:extLst>
                <a:ext uri="{FF2B5EF4-FFF2-40B4-BE49-F238E27FC236}">
                  <a16:creationId xmlns:a16="http://schemas.microsoft.com/office/drawing/2014/main" id="{27D8403D-A4B5-827A-EDBF-E7C541B9CFA0}"/>
                </a:ext>
              </a:extLst>
            </p:cNvPr>
            <p:cNvSpPr/>
            <p:nvPr/>
          </p:nvSpPr>
          <p:spPr>
            <a:xfrm>
              <a:off x="809518" y="4913565"/>
              <a:ext cx="141618" cy="141617"/>
            </a:xfrm>
            <a:custGeom>
              <a:avLst/>
              <a:gdLst>
                <a:gd name="csX0" fmla="*/ 69605 w 141618"/>
                <a:gd name="csY0" fmla="*/ 359 h 141617"/>
                <a:gd name="csX1" fmla="*/ 140414 w 141618"/>
                <a:gd name="csY1" fmla="*/ 71168 h 141617"/>
                <a:gd name="csX2" fmla="*/ 69605 w 141618"/>
                <a:gd name="csY2" fmla="*/ 141977 h 141617"/>
                <a:gd name="csX3" fmla="*/ -1205 w 141618"/>
                <a:gd name="csY3" fmla="*/ 71168 h 141617"/>
              </a:gdLst>
              <a:ahLst/>
              <a:cxnLst>
                <a:cxn ang="0">
                  <a:pos x="csX0" y="csY0"/>
                </a:cxn>
                <a:cxn ang="0">
                  <a:pos x="csX1" y="csY1"/>
                </a:cxn>
                <a:cxn ang="0">
                  <a:pos x="csX2" y="csY2"/>
                </a:cxn>
                <a:cxn ang="0">
                  <a:pos x="csX3" y="csY3"/>
                </a:cxn>
              </a:cxnLst>
              <a:rect l="l" t="t" r="r" b="b"/>
              <a:pathLst>
                <a:path w="141618" h="141617">
                  <a:moveTo>
                    <a:pt x="69605" y="359"/>
                  </a:moveTo>
                  <a:lnTo>
                    <a:pt x="140414" y="71168"/>
                  </a:lnTo>
                  <a:lnTo>
                    <a:pt x="69605" y="141977"/>
                  </a:lnTo>
                  <a:lnTo>
                    <a:pt x="-1205" y="71168"/>
                  </a:lnTo>
                  <a:close/>
                </a:path>
              </a:pathLst>
            </a:custGeom>
            <a:noFill/>
            <a:ln w="11787" cap="rnd">
              <a:solidFill>
                <a:srgbClr val="4292C6"/>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97" name="フリーフォーム: 図形 96">
              <a:extLst>
                <a:ext uri="{FF2B5EF4-FFF2-40B4-BE49-F238E27FC236}">
                  <a16:creationId xmlns:a16="http://schemas.microsoft.com/office/drawing/2014/main" id="{63264700-A378-2194-1DD4-319B334D8D85}"/>
                </a:ext>
              </a:extLst>
            </p:cNvPr>
            <p:cNvSpPr/>
            <p:nvPr/>
          </p:nvSpPr>
          <p:spPr>
            <a:xfrm>
              <a:off x="809518" y="4913565"/>
              <a:ext cx="141618" cy="141617"/>
            </a:xfrm>
            <a:custGeom>
              <a:avLst/>
              <a:gdLst>
                <a:gd name="csX0" fmla="*/ 69605 w 141618"/>
                <a:gd name="csY0" fmla="*/ 359 h 141617"/>
                <a:gd name="csX1" fmla="*/ 140414 w 141618"/>
                <a:gd name="csY1" fmla="*/ 71168 h 141617"/>
                <a:gd name="csX2" fmla="*/ 69605 w 141618"/>
                <a:gd name="csY2" fmla="*/ 141977 h 141617"/>
                <a:gd name="csX3" fmla="*/ -1205 w 141618"/>
                <a:gd name="csY3" fmla="*/ 71168 h 141617"/>
              </a:gdLst>
              <a:ahLst/>
              <a:cxnLst>
                <a:cxn ang="0">
                  <a:pos x="csX0" y="csY0"/>
                </a:cxn>
                <a:cxn ang="0">
                  <a:pos x="csX1" y="csY1"/>
                </a:cxn>
                <a:cxn ang="0">
                  <a:pos x="csX2" y="csY2"/>
                </a:cxn>
                <a:cxn ang="0">
                  <a:pos x="csX3" y="csY3"/>
                </a:cxn>
              </a:cxnLst>
              <a:rect l="l" t="t" r="r" b="b"/>
              <a:pathLst>
                <a:path w="141618" h="141617">
                  <a:moveTo>
                    <a:pt x="69605" y="359"/>
                  </a:moveTo>
                  <a:lnTo>
                    <a:pt x="140414" y="71168"/>
                  </a:lnTo>
                  <a:lnTo>
                    <a:pt x="69605" y="141977"/>
                  </a:lnTo>
                  <a:lnTo>
                    <a:pt x="-1205" y="71168"/>
                  </a:lnTo>
                  <a:close/>
                </a:path>
              </a:pathLst>
            </a:custGeom>
            <a:solidFill>
              <a:srgbClr val="F1F4F5"/>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98" name="テキスト ボックス 97">
              <a:extLst>
                <a:ext uri="{FF2B5EF4-FFF2-40B4-BE49-F238E27FC236}">
                  <a16:creationId xmlns:a16="http://schemas.microsoft.com/office/drawing/2014/main" id="{7649243F-22E0-D760-0EEE-D628EB4111E9}"/>
                </a:ext>
              </a:extLst>
            </p:cNvPr>
            <p:cNvSpPr txBox="1"/>
            <p:nvPr/>
          </p:nvSpPr>
          <p:spPr>
            <a:xfrm>
              <a:off x="702262" y="4907870"/>
              <a:ext cx="356188"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PHOT2</a:t>
              </a:r>
            </a:p>
          </p:txBody>
        </p:sp>
        <p:sp>
          <p:nvSpPr>
            <p:cNvPr id="99" name="フリーフォーム: 図形 98">
              <a:extLst>
                <a:ext uri="{FF2B5EF4-FFF2-40B4-BE49-F238E27FC236}">
                  <a16:creationId xmlns:a16="http://schemas.microsoft.com/office/drawing/2014/main" id="{02382B37-624A-7B75-0565-2F094E5ABFDE}"/>
                </a:ext>
              </a:extLst>
            </p:cNvPr>
            <p:cNvSpPr/>
            <p:nvPr/>
          </p:nvSpPr>
          <p:spPr>
            <a:xfrm>
              <a:off x="1475623" y="5429984"/>
              <a:ext cx="141618" cy="141617"/>
            </a:xfrm>
            <a:custGeom>
              <a:avLst/>
              <a:gdLst>
                <a:gd name="csX0" fmla="*/ 69451 w 141618"/>
                <a:gd name="csY0" fmla="*/ 240 h 141617"/>
                <a:gd name="csX1" fmla="*/ 140260 w 141618"/>
                <a:gd name="csY1" fmla="*/ 71049 h 141617"/>
                <a:gd name="csX2" fmla="*/ 69451 w 141618"/>
                <a:gd name="csY2" fmla="*/ 141858 h 141617"/>
                <a:gd name="csX3" fmla="*/ -1358 w 141618"/>
                <a:gd name="csY3" fmla="*/ 71049 h 141617"/>
              </a:gdLst>
              <a:ahLst/>
              <a:cxnLst>
                <a:cxn ang="0">
                  <a:pos x="csX0" y="csY0"/>
                </a:cxn>
                <a:cxn ang="0">
                  <a:pos x="csX1" y="csY1"/>
                </a:cxn>
                <a:cxn ang="0">
                  <a:pos x="csX2" y="csY2"/>
                </a:cxn>
                <a:cxn ang="0">
                  <a:pos x="csX3" y="csY3"/>
                </a:cxn>
              </a:cxnLst>
              <a:rect l="l" t="t" r="r" b="b"/>
              <a:pathLst>
                <a:path w="141618" h="141617">
                  <a:moveTo>
                    <a:pt x="69451" y="240"/>
                  </a:moveTo>
                  <a:lnTo>
                    <a:pt x="140260" y="71049"/>
                  </a:lnTo>
                  <a:lnTo>
                    <a:pt x="69451" y="141858"/>
                  </a:lnTo>
                  <a:lnTo>
                    <a:pt x="-1358" y="71049"/>
                  </a:ln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00" name="フリーフォーム: 図形 99">
              <a:extLst>
                <a:ext uri="{FF2B5EF4-FFF2-40B4-BE49-F238E27FC236}">
                  <a16:creationId xmlns:a16="http://schemas.microsoft.com/office/drawing/2014/main" id="{A22FB189-7F42-D053-479F-18DC270539ED}"/>
                </a:ext>
              </a:extLst>
            </p:cNvPr>
            <p:cNvSpPr/>
            <p:nvPr/>
          </p:nvSpPr>
          <p:spPr>
            <a:xfrm>
              <a:off x="1475623" y="5429984"/>
              <a:ext cx="141618" cy="141617"/>
            </a:xfrm>
            <a:custGeom>
              <a:avLst/>
              <a:gdLst>
                <a:gd name="csX0" fmla="*/ 69451 w 141618"/>
                <a:gd name="csY0" fmla="*/ 240 h 141617"/>
                <a:gd name="csX1" fmla="*/ 140260 w 141618"/>
                <a:gd name="csY1" fmla="*/ 71049 h 141617"/>
                <a:gd name="csX2" fmla="*/ 69451 w 141618"/>
                <a:gd name="csY2" fmla="*/ 141858 h 141617"/>
                <a:gd name="csX3" fmla="*/ -1358 w 141618"/>
                <a:gd name="csY3" fmla="*/ 71049 h 141617"/>
              </a:gdLst>
              <a:ahLst/>
              <a:cxnLst>
                <a:cxn ang="0">
                  <a:pos x="csX0" y="csY0"/>
                </a:cxn>
                <a:cxn ang="0">
                  <a:pos x="csX1" y="csY1"/>
                </a:cxn>
                <a:cxn ang="0">
                  <a:pos x="csX2" y="csY2"/>
                </a:cxn>
                <a:cxn ang="0">
                  <a:pos x="csX3" y="csY3"/>
                </a:cxn>
              </a:cxnLst>
              <a:rect l="l" t="t" r="r" b="b"/>
              <a:pathLst>
                <a:path w="141618" h="141617">
                  <a:moveTo>
                    <a:pt x="69451" y="240"/>
                  </a:moveTo>
                  <a:lnTo>
                    <a:pt x="140260" y="71049"/>
                  </a:lnTo>
                  <a:lnTo>
                    <a:pt x="69451" y="141858"/>
                  </a:lnTo>
                  <a:lnTo>
                    <a:pt x="-1358" y="71049"/>
                  </a:lnTo>
                  <a:close/>
                </a:path>
              </a:pathLst>
            </a:custGeom>
            <a:solidFill>
              <a:srgbClr val="F8DED1"/>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01" name="テキスト ボックス 100">
              <a:extLst>
                <a:ext uri="{FF2B5EF4-FFF2-40B4-BE49-F238E27FC236}">
                  <a16:creationId xmlns:a16="http://schemas.microsoft.com/office/drawing/2014/main" id="{A55F4FDC-AE94-3AD8-E788-5AFFD3819296}"/>
                </a:ext>
              </a:extLst>
            </p:cNvPr>
            <p:cNvSpPr txBox="1"/>
            <p:nvPr/>
          </p:nvSpPr>
          <p:spPr>
            <a:xfrm>
              <a:off x="1371958" y="5424139"/>
              <a:ext cx="354584"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SRK2E</a:t>
              </a:r>
            </a:p>
          </p:txBody>
        </p:sp>
        <p:grpSp>
          <p:nvGrpSpPr>
            <p:cNvPr id="102" name="グループ化 101">
              <a:extLst>
                <a:ext uri="{FF2B5EF4-FFF2-40B4-BE49-F238E27FC236}">
                  <a16:creationId xmlns:a16="http://schemas.microsoft.com/office/drawing/2014/main" id="{8F8FBEF7-189D-1493-532D-7DC92D742CA7}"/>
                </a:ext>
              </a:extLst>
            </p:cNvPr>
            <p:cNvGrpSpPr/>
            <p:nvPr/>
          </p:nvGrpSpPr>
          <p:grpSpPr>
            <a:xfrm>
              <a:off x="1248457" y="5093974"/>
              <a:ext cx="292068" cy="153888"/>
              <a:chOff x="1212897" y="5093974"/>
              <a:chExt cx="292068" cy="153888"/>
            </a:xfrm>
          </p:grpSpPr>
          <p:sp>
            <p:nvSpPr>
              <p:cNvPr id="124" name="フリーフォーム: 図形 123">
                <a:extLst>
                  <a:ext uri="{FF2B5EF4-FFF2-40B4-BE49-F238E27FC236}">
                    <a16:creationId xmlns:a16="http://schemas.microsoft.com/office/drawing/2014/main" id="{A265019B-F521-B2FC-77B6-05721B2D3F42}"/>
                  </a:ext>
                </a:extLst>
              </p:cNvPr>
              <p:cNvSpPr/>
              <p:nvPr/>
            </p:nvSpPr>
            <p:spPr>
              <a:xfrm>
                <a:off x="1286931" y="5098918"/>
                <a:ext cx="144000" cy="144000"/>
              </a:xfrm>
              <a:custGeom>
                <a:avLst/>
                <a:gdLst>
                  <a:gd name="csX0" fmla="*/ 128493 w 129816"/>
                  <a:gd name="csY0" fmla="*/ 65222 h 129816"/>
                  <a:gd name="csX1" fmla="*/ 63585 w 129816"/>
                  <a:gd name="csY1" fmla="*/ 130131 h 129816"/>
                  <a:gd name="csX2" fmla="*/ -1323 w 129816"/>
                  <a:gd name="csY2" fmla="*/ 65222 h 129816"/>
                  <a:gd name="csX3" fmla="*/ 63585 w 129816"/>
                  <a:gd name="csY3" fmla="*/ 314 h 129816"/>
                  <a:gd name="csX4" fmla="*/ 128493 w 129816"/>
                  <a:gd name="csY4" fmla="*/ 65222 h 129816"/>
                </a:gdLst>
                <a:ahLst/>
                <a:cxnLst>
                  <a:cxn ang="0">
                    <a:pos x="csX0" y="csY0"/>
                  </a:cxn>
                  <a:cxn ang="0">
                    <a:pos x="csX1" y="csY1"/>
                  </a:cxn>
                  <a:cxn ang="0">
                    <a:pos x="csX2" y="csY2"/>
                  </a:cxn>
                  <a:cxn ang="0">
                    <a:pos x="csX3" y="csY3"/>
                  </a:cxn>
                  <a:cxn ang="0">
                    <a:pos x="csX4" y="csY4"/>
                  </a:cxn>
                </a:cxnLst>
                <a:rect l="l" t="t" r="r" b="b"/>
                <a:pathLst>
                  <a:path w="129816" h="129816">
                    <a:moveTo>
                      <a:pt x="128493" y="65222"/>
                    </a:moveTo>
                    <a:cubicBezTo>
                      <a:pt x="128493" y="101070"/>
                      <a:pt x="99433" y="130131"/>
                      <a:pt x="63585" y="130131"/>
                    </a:cubicBezTo>
                    <a:cubicBezTo>
                      <a:pt x="27737" y="130131"/>
                      <a:pt x="-1323" y="101070"/>
                      <a:pt x="-1323" y="65222"/>
                    </a:cubicBezTo>
                    <a:cubicBezTo>
                      <a:pt x="-1323" y="29375"/>
                      <a:pt x="27737" y="314"/>
                      <a:pt x="63585" y="314"/>
                    </a:cubicBezTo>
                    <a:cubicBezTo>
                      <a:pt x="99433" y="314"/>
                      <a:pt x="128493" y="29375"/>
                      <a:pt x="128493" y="65222"/>
                    </a:cubicBezTo>
                    <a:close/>
                  </a:path>
                </a:pathLst>
              </a:custGeom>
              <a:solidFill>
                <a:srgbClr val="4292C6"/>
              </a:solidFill>
              <a:ln w="6350" cap="sq">
                <a:solidFill>
                  <a:srgbClr val="0070C0"/>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25" name="テキスト ボックス 124">
                <a:extLst>
                  <a:ext uri="{FF2B5EF4-FFF2-40B4-BE49-F238E27FC236}">
                    <a16:creationId xmlns:a16="http://schemas.microsoft.com/office/drawing/2014/main" id="{72E0ED22-5C87-DBB0-395A-676F905C77F7}"/>
                  </a:ext>
                </a:extLst>
              </p:cNvPr>
              <p:cNvSpPr txBox="1"/>
              <p:nvPr/>
            </p:nvSpPr>
            <p:spPr>
              <a:xfrm>
                <a:off x="1212897" y="5093974"/>
                <a:ext cx="292068"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VCR</a:t>
                </a:r>
              </a:p>
            </p:txBody>
          </p:sp>
        </p:grpSp>
        <p:sp>
          <p:nvSpPr>
            <p:cNvPr id="103" name="フリーフォーム: 図形 102">
              <a:extLst>
                <a:ext uri="{FF2B5EF4-FFF2-40B4-BE49-F238E27FC236}">
                  <a16:creationId xmlns:a16="http://schemas.microsoft.com/office/drawing/2014/main" id="{480244D9-BDA6-A88E-95DF-35FA85307092}"/>
                </a:ext>
              </a:extLst>
            </p:cNvPr>
            <p:cNvSpPr/>
            <p:nvPr/>
          </p:nvSpPr>
          <p:spPr>
            <a:xfrm>
              <a:off x="1128646" y="5542689"/>
              <a:ext cx="141618" cy="141617"/>
            </a:xfrm>
            <a:custGeom>
              <a:avLst/>
              <a:gdLst>
                <a:gd name="csX0" fmla="*/ 69531 w 141618"/>
                <a:gd name="csY0" fmla="*/ 214 h 141617"/>
                <a:gd name="csX1" fmla="*/ 140340 w 141618"/>
                <a:gd name="csY1" fmla="*/ 71023 h 141617"/>
                <a:gd name="csX2" fmla="*/ 69531 w 141618"/>
                <a:gd name="csY2" fmla="*/ 141832 h 141617"/>
                <a:gd name="csX3" fmla="*/ -1278 w 141618"/>
                <a:gd name="csY3" fmla="*/ 71023 h 141617"/>
              </a:gdLst>
              <a:ahLst/>
              <a:cxnLst>
                <a:cxn ang="0">
                  <a:pos x="csX0" y="csY0"/>
                </a:cxn>
                <a:cxn ang="0">
                  <a:pos x="csX1" y="csY1"/>
                </a:cxn>
                <a:cxn ang="0">
                  <a:pos x="csX2" y="csY2"/>
                </a:cxn>
                <a:cxn ang="0">
                  <a:pos x="csX3" y="csY3"/>
                </a:cxn>
              </a:cxnLst>
              <a:rect l="l" t="t" r="r" b="b"/>
              <a:pathLst>
                <a:path w="141618" h="141617">
                  <a:moveTo>
                    <a:pt x="69531" y="214"/>
                  </a:moveTo>
                  <a:lnTo>
                    <a:pt x="140340" y="71023"/>
                  </a:lnTo>
                  <a:lnTo>
                    <a:pt x="69531" y="141832"/>
                  </a:lnTo>
                  <a:lnTo>
                    <a:pt x="-1278" y="71023"/>
                  </a:ln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04" name="フリーフォーム: 図形 103">
              <a:extLst>
                <a:ext uri="{FF2B5EF4-FFF2-40B4-BE49-F238E27FC236}">
                  <a16:creationId xmlns:a16="http://schemas.microsoft.com/office/drawing/2014/main" id="{CADF26AE-35F4-0524-4701-CC74F36CB157}"/>
                </a:ext>
              </a:extLst>
            </p:cNvPr>
            <p:cNvSpPr/>
            <p:nvPr/>
          </p:nvSpPr>
          <p:spPr>
            <a:xfrm>
              <a:off x="1128646" y="5542689"/>
              <a:ext cx="141618" cy="141617"/>
            </a:xfrm>
            <a:custGeom>
              <a:avLst/>
              <a:gdLst>
                <a:gd name="csX0" fmla="*/ 69531 w 141618"/>
                <a:gd name="csY0" fmla="*/ 214 h 141617"/>
                <a:gd name="csX1" fmla="*/ 140340 w 141618"/>
                <a:gd name="csY1" fmla="*/ 71023 h 141617"/>
                <a:gd name="csX2" fmla="*/ 69531 w 141618"/>
                <a:gd name="csY2" fmla="*/ 141832 h 141617"/>
                <a:gd name="csX3" fmla="*/ -1278 w 141618"/>
                <a:gd name="csY3" fmla="*/ 71023 h 141617"/>
              </a:gdLst>
              <a:ahLst/>
              <a:cxnLst>
                <a:cxn ang="0">
                  <a:pos x="csX0" y="csY0"/>
                </a:cxn>
                <a:cxn ang="0">
                  <a:pos x="csX1" y="csY1"/>
                </a:cxn>
                <a:cxn ang="0">
                  <a:pos x="csX2" y="csY2"/>
                </a:cxn>
                <a:cxn ang="0">
                  <a:pos x="csX3" y="csY3"/>
                </a:cxn>
              </a:cxnLst>
              <a:rect l="l" t="t" r="r" b="b"/>
              <a:pathLst>
                <a:path w="141618" h="141617">
                  <a:moveTo>
                    <a:pt x="69531" y="214"/>
                  </a:moveTo>
                  <a:lnTo>
                    <a:pt x="140340" y="71023"/>
                  </a:lnTo>
                  <a:lnTo>
                    <a:pt x="69531" y="141832"/>
                  </a:lnTo>
                  <a:lnTo>
                    <a:pt x="-1278" y="71023"/>
                  </a:lnTo>
                  <a:close/>
                </a:path>
              </a:pathLst>
            </a:custGeom>
            <a:solidFill>
              <a:srgbClr val="F8DDD0"/>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05" name="テキスト ボックス 104">
              <a:extLst>
                <a:ext uri="{FF2B5EF4-FFF2-40B4-BE49-F238E27FC236}">
                  <a16:creationId xmlns:a16="http://schemas.microsoft.com/office/drawing/2014/main" id="{F5C457D6-3645-7FDB-5D3A-4F67FCC9DAB0}"/>
                </a:ext>
              </a:extLst>
            </p:cNvPr>
            <p:cNvSpPr txBox="1"/>
            <p:nvPr/>
          </p:nvSpPr>
          <p:spPr>
            <a:xfrm>
              <a:off x="1024037" y="5535130"/>
              <a:ext cx="357790"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SRK2D</a:t>
              </a:r>
            </a:p>
          </p:txBody>
        </p:sp>
        <p:sp>
          <p:nvSpPr>
            <p:cNvPr id="106" name="フリーフォーム: 図形 105">
              <a:extLst>
                <a:ext uri="{FF2B5EF4-FFF2-40B4-BE49-F238E27FC236}">
                  <a16:creationId xmlns:a16="http://schemas.microsoft.com/office/drawing/2014/main" id="{36A190EE-251E-89C5-0C83-6B7A45C0EA30}"/>
                </a:ext>
              </a:extLst>
            </p:cNvPr>
            <p:cNvSpPr/>
            <p:nvPr/>
          </p:nvSpPr>
          <p:spPr>
            <a:xfrm>
              <a:off x="1788260" y="5913394"/>
              <a:ext cx="129816" cy="129816"/>
            </a:xfrm>
            <a:custGeom>
              <a:avLst/>
              <a:gdLst>
                <a:gd name="csX0" fmla="*/ 128388 w 129816"/>
                <a:gd name="csY0" fmla="*/ 65038 h 129816"/>
                <a:gd name="csX1" fmla="*/ 63479 w 129816"/>
                <a:gd name="csY1" fmla="*/ 129946 h 129816"/>
                <a:gd name="csX2" fmla="*/ -1429 w 129816"/>
                <a:gd name="csY2" fmla="*/ 65038 h 129816"/>
                <a:gd name="csX3" fmla="*/ 63479 w 129816"/>
                <a:gd name="csY3" fmla="*/ 129 h 129816"/>
                <a:gd name="csX4" fmla="*/ 128388 w 129816"/>
                <a:gd name="csY4" fmla="*/ 65038 h 129816"/>
              </a:gdLst>
              <a:ahLst/>
              <a:cxnLst>
                <a:cxn ang="0">
                  <a:pos x="csX0" y="csY0"/>
                </a:cxn>
                <a:cxn ang="0">
                  <a:pos x="csX1" y="csY1"/>
                </a:cxn>
                <a:cxn ang="0">
                  <a:pos x="csX2" y="csY2"/>
                </a:cxn>
                <a:cxn ang="0">
                  <a:pos x="csX3" y="csY3"/>
                </a:cxn>
                <a:cxn ang="0">
                  <a:pos x="csX4" y="csY4"/>
                </a:cxn>
              </a:cxnLst>
              <a:rect l="l" t="t" r="r" b="b"/>
              <a:pathLst>
                <a:path w="129816" h="129816">
                  <a:moveTo>
                    <a:pt x="128388" y="65038"/>
                  </a:moveTo>
                  <a:cubicBezTo>
                    <a:pt x="128388" y="100885"/>
                    <a:pt x="99327" y="129946"/>
                    <a:pt x="63479" y="129946"/>
                  </a:cubicBezTo>
                  <a:cubicBezTo>
                    <a:pt x="27631" y="129946"/>
                    <a:pt x="-1429" y="100885"/>
                    <a:pt x="-1429" y="65038"/>
                  </a:cubicBezTo>
                  <a:cubicBezTo>
                    <a:pt x="-1429" y="29190"/>
                    <a:pt x="27631" y="129"/>
                    <a:pt x="63479" y="129"/>
                  </a:cubicBezTo>
                  <a:cubicBezTo>
                    <a:pt x="99327" y="129"/>
                    <a:pt x="128388" y="29190"/>
                    <a:pt x="128388" y="65038"/>
                  </a:cubicBez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07" name="フリーフォーム: 図形 106">
              <a:extLst>
                <a:ext uri="{FF2B5EF4-FFF2-40B4-BE49-F238E27FC236}">
                  <a16:creationId xmlns:a16="http://schemas.microsoft.com/office/drawing/2014/main" id="{FF1234A1-DA25-EA2F-01CC-E2AB725674FD}"/>
                </a:ext>
              </a:extLst>
            </p:cNvPr>
            <p:cNvSpPr/>
            <p:nvPr/>
          </p:nvSpPr>
          <p:spPr>
            <a:xfrm>
              <a:off x="1788260" y="5913394"/>
              <a:ext cx="129816" cy="129816"/>
            </a:xfrm>
            <a:custGeom>
              <a:avLst/>
              <a:gdLst>
                <a:gd name="csX0" fmla="*/ 128388 w 129816"/>
                <a:gd name="csY0" fmla="*/ 65038 h 129816"/>
                <a:gd name="csX1" fmla="*/ 63479 w 129816"/>
                <a:gd name="csY1" fmla="*/ 129946 h 129816"/>
                <a:gd name="csX2" fmla="*/ -1429 w 129816"/>
                <a:gd name="csY2" fmla="*/ 65038 h 129816"/>
                <a:gd name="csX3" fmla="*/ 63479 w 129816"/>
                <a:gd name="csY3" fmla="*/ 129 h 129816"/>
                <a:gd name="csX4" fmla="*/ 128388 w 129816"/>
                <a:gd name="csY4" fmla="*/ 65038 h 129816"/>
              </a:gdLst>
              <a:ahLst/>
              <a:cxnLst>
                <a:cxn ang="0">
                  <a:pos x="csX0" y="csY0"/>
                </a:cxn>
                <a:cxn ang="0">
                  <a:pos x="csX1" y="csY1"/>
                </a:cxn>
                <a:cxn ang="0">
                  <a:pos x="csX2" y="csY2"/>
                </a:cxn>
                <a:cxn ang="0">
                  <a:pos x="csX3" y="csY3"/>
                </a:cxn>
                <a:cxn ang="0">
                  <a:pos x="csX4" y="csY4"/>
                </a:cxn>
              </a:cxnLst>
              <a:rect l="l" t="t" r="r" b="b"/>
              <a:pathLst>
                <a:path w="129816" h="129816">
                  <a:moveTo>
                    <a:pt x="128388" y="65038"/>
                  </a:moveTo>
                  <a:cubicBezTo>
                    <a:pt x="128388" y="100885"/>
                    <a:pt x="99327" y="129946"/>
                    <a:pt x="63479" y="129946"/>
                  </a:cubicBezTo>
                  <a:cubicBezTo>
                    <a:pt x="27631" y="129946"/>
                    <a:pt x="-1429" y="100885"/>
                    <a:pt x="-1429" y="65038"/>
                  </a:cubicBezTo>
                  <a:cubicBezTo>
                    <a:pt x="-1429" y="29190"/>
                    <a:pt x="27631" y="129"/>
                    <a:pt x="63479" y="129"/>
                  </a:cubicBezTo>
                  <a:cubicBezTo>
                    <a:pt x="99327" y="129"/>
                    <a:pt x="128388" y="29190"/>
                    <a:pt x="128388" y="65038"/>
                  </a:cubicBezTo>
                  <a:close/>
                </a:path>
              </a:pathLst>
            </a:custGeom>
            <a:solidFill>
              <a:srgbClr val="F8E1D5"/>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08" name="テキスト ボックス 107">
              <a:extLst>
                <a:ext uri="{FF2B5EF4-FFF2-40B4-BE49-F238E27FC236}">
                  <a16:creationId xmlns:a16="http://schemas.microsoft.com/office/drawing/2014/main" id="{127A4AD9-021A-0233-AFAF-5AB6C1C31B38}"/>
                </a:ext>
              </a:extLst>
            </p:cNvPr>
            <p:cNvSpPr txBox="1"/>
            <p:nvPr/>
          </p:nvSpPr>
          <p:spPr>
            <a:xfrm>
              <a:off x="1695540" y="5901445"/>
              <a:ext cx="317716"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SNS1</a:t>
              </a:r>
            </a:p>
          </p:txBody>
        </p:sp>
        <p:sp>
          <p:nvSpPr>
            <p:cNvPr id="109" name="フリーフォーム: 図形 108">
              <a:extLst>
                <a:ext uri="{FF2B5EF4-FFF2-40B4-BE49-F238E27FC236}">
                  <a16:creationId xmlns:a16="http://schemas.microsoft.com/office/drawing/2014/main" id="{44E9768C-C7B9-393C-5A16-5FCA6660E1F4}"/>
                </a:ext>
              </a:extLst>
            </p:cNvPr>
            <p:cNvSpPr/>
            <p:nvPr/>
          </p:nvSpPr>
          <p:spPr>
            <a:xfrm>
              <a:off x="1173232" y="4760015"/>
              <a:ext cx="144000" cy="144000"/>
            </a:xfrm>
            <a:custGeom>
              <a:avLst/>
              <a:gdLst>
                <a:gd name="csX0" fmla="*/ 69520 w 141618"/>
                <a:gd name="csY0" fmla="*/ 396 h 141617"/>
                <a:gd name="csX1" fmla="*/ 140329 w 141618"/>
                <a:gd name="csY1" fmla="*/ 71205 h 141617"/>
                <a:gd name="csX2" fmla="*/ 69520 w 141618"/>
                <a:gd name="csY2" fmla="*/ 142014 h 141617"/>
                <a:gd name="csX3" fmla="*/ -1289 w 141618"/>
                <a:gd name="csY3" fmla="*/ 71205 h 141617"/>
              </a:gdLst>
              <a:ahLst/>
              <a:cxnLst>
                <a:cxn ang="0">
                  <a:pos x="csX0" y="csY0"/>
                </a:cxn>
                <a:cxn ang="0">
                  <a:pos x="csX1" y="csY1"/>
                </a:cxn>
                <a:cxn ang="0">
                  <a:pos x="csX2" y="csY2"/>
                </a:cxn>
                <a:cxn ang="0">
                  <a:pos x="csX3" y="csY3"/>
                </a:cxn>
              </a:cxnLst>
              <a:rect l="l" t="t" r="r" b="b"/>
              <a:pathLst>
                <a:path w="141618" h="141617">
                  <a:moveTo>
                    <a:pt x="69520" y="396"/>
                  </a:moveTo>
                  <a:lnTo>
                    <a:pt x="140329" y="71205"/>
                  </a:lnTo>
                  <a:lnTo>
                    <a:pt x="69520" y="142014"/>
                  </a:lnTo>
                  <a:lnTo>
                    <a:pt x="-1289" y="71205"/>
                  </a:lnTo>
                  <a:close/>
                </a:path>
              </a:pathLst>
            </a:custGeom>
            <a:solidFill>
              <a:srgbClr val="F8DBCD"/>
            </a:solidFill>
            <a:ln w="6350" cap="sq">
              <a:solidFill>
                <a:schemeClr val="accent2"/>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0" name="テキスト ボックス 109">
              <a:extLst>
                <a:ext uri="{FF2B5EF4-FFF2-40B4-BE49-F238E27FC236}">
                  <a16:creationId xmlns:a16="http://schemas.microsoft.com/office/drawing/2014/main" id="{FBD3F58C-E7BE-E59C-3DFD-DF102692DE3F}"/>
                </a:ext>
              </a:extLst>
            </p:cNvPr>
            <p:cNvSpPr txBox="1"/>
            <p:nvPr/>
          </p:nvSpPr>
          <p:spPr>
            <a:xfrm>
              <a:off x="1077174" y="4752879"/>
              <a:ext cx="356188"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PHOT1</a:t>
              </a:r>
            </a:p>
          </p:txBody>
        </p:sp>
        <p:sp>
          <p:nvSpPr>
            <p:cNvPr id="111" name="フリーフォーム: 図形 110">
              <a:extLst>
                <a:ext uri="{FF2B5EF4-FFF2-40B4-BE49-F238E27FC236}">
                  <a16:creationId xmlns:a16="http://schemas.microsoft.com/office/drawing/2014/main" id="{35FD06B5-7EF9-BB1D-25FA-3B175B84755B}"/>
                </a:ext>
              </a:extLst>
            </p:cNvPr>
            <p:cNvSpPr/>
            <p:nvPr/>
          </p:nvSpPr>
          <p:spPr>
            <a:xfrm>
              <a:off x="693704" y="4656706"/>
              <a:ext cx="129816" cy="129816"/>
            </a:xfrm>
            <a:custGeom>
              <a:avLst/>
              <a:gdLst>
                <a:gd name="csX0" fmla="*/ 128640 w 129816"/>
                <a:gd name="csY0" fmla="*/ 65328 h 129816"/>
                <a:gd name="csX1" fmla="*/ 63732 w 129816"/>
                <a:gd name="csY1" fmla="*/ 130236 h 129816"/>
                <a:gd name="csX2" fmla="*/ -1176 w 129816"/>
                <a:gd name="csY2" fmla="*/ 65328 h 129816"/>
                <a:gd name="csX3" fmla="*/ 63732 w 129816"/>
                <a:gd name="csY3" fmla="*/ 419 h 129816"/>
                <a:gd name="csX4" fmla="*/ 128640 w 129816"/>
                <a:gd name="csY4" fmla="*/ 65328 h 129816"/>
              </a:gdLst>
              <a:ahLst/>
              <a:cxnLst>
                <a:cxn ang="0">
                  <a:pos x="csX0" y="csY0"/>
                </a:cxn>
                <a:cxn ang="0">
                  <a:pos x="csX1" y="csY1"/>
                </a:cxn>
                <a:cxn ang="0">
                  <a:pos x="csX2" y="csY2"/>
                </a:cxn>
                <a:cxn ang="0">
                  <a:pos x="csX3" y="csY3"/>
                </a:cxn>
                <a:cxn ang="0">
                  <a:pos x="csX4" y="csY4"/>
                </a:cxn>
              </a:cxnLst>
              <a:rect l="l" t="t" r="r" b="b"/>
              <a:pathLst>
                <a:path w="129816" h="129816">
                  <a:moveTo>
                    <a:pt x="128640" y="65328"/>
                  </a:moveTo>
                  <a:cubicBezTo>
                    <a:pt x="128640" y="101176"/>
                    <a:pt x="99580" y="130236"/>
                    <a:pt x="63732" y="130236"/>
                  </a:cubicBezTo>
                  <a:cubicBezTo>
                    <a:pt x="27884" y="130236"/>
                    <a:pt x="-1176" y="101176"/>
                    <a:pt x="-1176" y="65328"/>
                  </a:cubicBezTo>
                  <a:cubicBezTo>
                    <a:pt x="-1176" y="29480"/>
                    <a:pt x="27884" y="419"/>
                    <a:pt x="63732" y="419"/>
                  </a:cubicBezTo>
                  <a:cubicBezTo>
                    <a:pt x="99580" y="419"/>
                    <a:pt x="128640" y="29480"/>
                    <a:pt x="128640" y="65328"/>
                  </a:cubicBez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2" name="フリーフォーム: 図形 111">
              <a:extLst>
                <a:ext uri="{FF2B5EF4-FFF2-40B4-BE49-F238E27FC236}">
                  <a16:creationId xmlns:a16="http://schemas.microsoft.com/office/drawing/2014/main" id="{CDB5D64C-445C-4F95-4DD6-164AA37D333C}"/>
                </a:ext>
              </a:extLst>
            </p:cNvPr>
            <p:cNvSpPr/>
            <p:nvPr/>
          </p:nvSpPr>
          <p:spPr>
            <a:xfrm>
              <a:off x="693704" y="4656706"/>
              <a:ext cx="129816" cy="129816"/>
            </a:xfrm>
            <a:custGeom>
              <a:avLst/>
              <a:gdLst>
                <a:gd name="csX0" fmla="*/ 128640 w 129816"/>
                <a:gd name="csY0" fmla="*/ 65328 h 129816"/>
                <a:gd name="csX1" fmla="*/ 63732 w 129816"/>
                <a:gd name="csY1" fmla="*/ 130236 h 129816"/>
                <a:gd name="csX2" fmla="*/ -1176 w 129816"/>
                <a:gd name="csY2" fmla="*/ 65328 h 129816"/>
                <a:gd name="csX3" fmla="*/ 63732 w 129816"/>
                <a:gd name="csY3" fmla="*/ 419 h 129816"/>
                <a:gd name="csX4" fmla="*/ 128640 w 129816"/>
                <a:gd name="csY4" fmla="*/ 65328 h 129816"/>
              </a:gdLst>
              <a:ahLst/>
              <a:cxnLst>
                <a:cxn ang="0">
                  <a:pos x="csX0" y="csY0"/>
                </a:cxn>
                <a:cxn ang="0">
                  <a:pos x="csX1" y="csY1"/>
                </a:cxn>
                <a:cxn ang="0">
                  <a:pos x="csX2" y="csY2"/>
                </a:cxn>
                <a:cxn ang="0">
                  <a:pos x="csX3" y="csY3"/>
                </a:cxn>
                <a:cxn ang="0">
                  <a:pos x="csX4" y="csY4"/>
                </a:cxn>
              </a:cxnLst>
              <a:rect l="l" t="t" r="r" b="b"/>
              <a:pathLst>
                <a:path w="129816" h="129816">
                  <a:moveTo>
                    <a:pt x="128640" y="65328"/>
                  </a:moveTo>
                  <a:cubicBezTo>
                    <a:pt x="128640" y="101176"/>
                    <a:pt x="99580" y="130236"/>
                    <a:pt x="63732" y="130236"/>
                  </a:cubicBezTo>
                  <a:cubicBezTo>
                    <a:pt x="27884" y="130236"/>
                    <a:pt x="-1176" y="101176"/>
                    <a:pt x="-1176" y="65328"/>
                  </a:cubicBezTo>
                  <a:cubicBezTo>
                    <a:pt x="-1176" y="29480"/>
                    <a:pt x="27884" y="419"/>
                    <a:pt x="63732" y="419"/>
                  </a:cubicBezTo>
                  <a:cubicBezTo>
                    <a:pt x="99580" y="419"/>
                    <a:pt x="128640" y="29480"/>
                    <a:pt x="128640" y="65328"/>
                  </a:cubicBezTo>
                  <a:close/>
                </a:path>
              </a:pathLst>
            </a:custGeom>
            <a:solidFill>
              <a:srgbClr val="FA7837"/>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3" name="テキスト ボックス 112">
              <a:extLst>
                <a:ext uri="{FF2B5EF4-FFF2-40B4-BE49-F238E27FC236}">
                  <a16:creationId xmlns:a16="http://schemas.microsoft.com/office/drawing/2014/main" id="{8D381DCE-D07B-F630-FF9F-F03F289E38E8}"/>
                </a:ext>
              </a:extLst>
            </p:cNvPr>
            <p:cNvSpPr txBox="1"/>
            <p:nvPr/>
          </p:nvSpPr>
          <p:spPr>
            <a:xfrm>
              <a:off x="600044" y="4646604"/>
              <a:ext cx="316112"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RPT2</a:t>
              </a:r>
            </a:p>
          </p:txBody>
        </p:sp>
        <p:sp>
          <p:nvSpPr>
            <p:cNvPr id="114" name="フリーフォーム: 図形 113">
              <a:extLst>
                <a:ext uri="{FF2B5EF4-FFF2-40B4-BE49-F238E27FC236}">
                  <a16:creationId xmlns:a16="http://schemas.microsoft.com/office/drawing/2014/main" id="{BBBF2311-EC18-66A6-E5E9-63E8D91730D2}"/>
                </a:ext>
              </a:extLst>
            </p:cNvPr>
            <p:cNvSpPr/>
            <p:nvPr/>
          </p:nvSpPr>
          <p:spPr>
            <a:xfrm>
              <a:off x="1486841" y="5925270"/>
              <a:ext cx="129816" cy="129816"/>
            </a:xfrm>
            <a:custGeom>
              <a:avLst/>
              <a:gdLst>
                <a:gd name="csX0" fmla="*/ 128457 w 129816"/>
                <a:gd name="csY0" fmla="*/ 65035 h 129816"/>
                <a:gd name="csX1" fmla="*/ 63549 w 129816"/>
                <a:gd name="csY1" fmla="*/ 129943 h 129816"/>
                <a:gd name="csX2" fmla="*/ -1359 w 129816"/>
                <a:gd name="csY2" fmla="*/ 65035 h 129816"/>
                <a:gd name="csX3" fmla="*/ 63549 w 129816"/>
                <a:gd name="csY3" fmla="*/ 127 h 129816"/>
                <a:gd name="csX4" fmla="*/ 128457 w 129816"/>
                <a:gd name="csY4" fmla="*/ 65035 h 129816"/>
              </a:gdLst>
              <a:ahLst/>
              <a:cxnLst>
                <a:cxn ang="0">
                  <a:pos x="csX0" y="csY0"/>
                </a:cxn>
                <a:cxn ang="0">
                  <a:pos x="csX1" y="csY1"/>
                </a:cxn>
                <a:cxn ang="0">
                  <a:pos x="csX2" y="csY2"/>
                </a:cxn>
                <a:cxn ang="0">
                  <a:pos x="csX3" y="csY3"/>
                </a:cxn>
                <a:cxn ang="0">
                  <a:pos x="csX4" y="csY4"/>
                </a:cxn>
              </a:cxnLst>
              <a:rect l="l" t="t" r="r" b="b"/>
              <a:pathLst>
                <a:path w="129816" h="129816">
                  <a:moveTo>
                    <a:pt x="128457" y="65035"/>
                  </a:moveTo>
                  <a:cubicBezTo>
                    <a:pt x="128457" y="100883"/>
                    <a:pt x="99397" y="129943"/>
                    <a:pt x="63549" y="129943"/>
                  </a:cubicBezTo>
                  <a:cubicBezTo>
                    <a:pt x="27701" y="129943"/>
                    <a:pt x="-1359" y="100883"/>
                    <a:pt x="-1359" y="65035"/>
                  </a:cubicBezTo>
                  <a:cubicBezTo>
                    <a:pt x="-1359" y="29187"/>
                    <a:pt x="27701" y="127"/>
                    <a:pt x="63549" y="127"/>
                  </a:cubicBezTo>
                  <a:cubicBezTo>
                    <a:pt x="99397" y="127"/>
                    <a:pt x="128457" y="29187"/>
                    <a:pt x="128457" y="65035"/>
                  </a:cubicBez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5" name="フリーフォーム: 図形 114">
              <a:extLst>
                <a:ext uri="{FF2B5EF4-FFF2-40B4-BE49-F238E27FC236}">
                  <a16:creationId xmlns:a16="http://schemas.microsoft.com/office/drawing/2014/main" id="{0352EFF2-6609-3C8A-6096-4FF953D1FC8C}"/>
                </a:ext>
              </a:extLst>
            </p:cNvPr>
            <p:cNvSpPr/>
            <p:nvPr/>
          </p:nvSpPr>
          <p:spPr>
            <a:xfrm>
              <a:off x="1486841" y="5925270"/>
              <a:ext cx="129816" cy="129816"/>
            </a:xfrm>
            <a:custGeom>
              <a:avLst/>
              <a:gdLst>
                <a:gd name="csX0" fmla="*/ 128457 w 129816"/>
                <a:gd name="csY0" fmla="*/ 65035 h 129816"/>
                <a:gd name="csX1" fmla="*/ 63549 w 129816"/>
                <a:gd name="csY1" fmla="*/ 129943 h 129816"/>
                <a:gd name="csX2" fmla="*/ -1359 w 129816"/>
                <a:gd name="csY2" fmla="*/ 65035 h 129816"/>
                <a:gd name="csX3" fmla="*/ 63549 w 129816"/>
                <a:gd name="csY3" fmla="*/ 127 h 129816"/>
                <a:gd name="csX4" fmla="*/ 128457 w 129816"/>
                <a:gd name="csY4" fmla="*/ 65035 h 129816"/>
              </a:gdLst>
              <a:ahLst/>
              <a:cxnLst>
                <a:cxn ang="0">
                  <a:pos x="csX0" y="csY0"/>
                </a:cxn>
                <a:cxn ang="0">
                  <a:pos x="csX1" y="csY1"/>
                </a:cxn>
                <a:cxn ang="0">
                  <a:pos x="csX2" y="csY2"/>
                </a:cxn>
                <a:cxn ang="0">
                  <a:pos x="csX3" y="csY3"/>
                </a:cxn>
                <a:cxn ang="0">
                  <a:pos x="csX4" y="csY4"/>
                </a:cxn>
              </a:cxnLst>
              <a:rect l="l" t="t" r="r" b="b"/>
              <a:pathLst>
                <a:path w="129816" h="129816">
                  <a:moveTo>
                    <a:pt x="128457" y="65035"/>
                  </a:moveTo>
                  <a:cubicBezTo>
                    <a:pt x="128457" y="100883"/>
                    <a:pt x="99397" y="129943"/>
                    <a:pt x="63549" y="129943"/>
                  </a:cubicBezTo>
                  <a:cubicBezTo>
                    <a:pt x="27701" y="129943"/>
                    <a:pt x="-1359" y="100883"/>
                    <a:pt x="-1359" y="65035"/>
                  </a:cubicBezTo>
                  <a:cubicBezTo>
                    <a:pt x="-1359" y="29187"/>
                    <a:pt x="27701" y="127"/>
                    <a:pt x="63549" y="127"/>
                  </a:cubicBezTo>
                  <a:cubicBezTo>
                    <a:pt x="99397" y="127"/>
                    <a:pt x="128457" y="29187"/>
                    <a:pt x="128457" y="65035"/>
                  </a:cubicBezTo>
                  <a:close/>
                </a:path>
              </a:pathLst>
            </a:custGeom>
            <a:solidFill>
              <a:srgbClr val="F8CBB4"/>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6" name="テキスト ボックス 115">
              <a:extLst>
                <a:ext uri="{FF2B5EF4-FFF2-40B4-BE49-F238E27FC236}">
                  <a16:creationId xmlns:a16="http://schemas.microsoft.com/office/drawing/2014/main" id="{6654545F-77E9-9A9D-0A6C-C4D033A1665F}"/>
                </a:ext>
              </a:extLst>
            </p:cNvPr>
            <p:cNvSpPr txBox="1"/>
            <p:nvPr/>
          </p:nvSpPr>
          <p:spPr>
            <a:xfrm>
              <a:off x="1346504" y="5913429"/>
              <a:ext cx="413896"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BHLH122</a:t>
              </a:r>
            </a:p>
          </p:txBody>
        </p:sp>
        <p:sp>
          <p:nvSpPr>
            <p:cNvPr id="117" name="フリーフォーム: 図形 116">
              <a:extLst>
                <a:ext uri="{FF2B5EF4-FFF2-40B4-BE49-F238E27FC236}">
                  <a16:creationId xmlns:a16="http://schemas.microsoft.com/office/drawing/2014/main" id="{C44C4943-C7ED-2E1E-7378-FA42C290DECB}"/>
                </a:ext>
              </a:extLst>
            </p:cNvPr>
            <p:cNvSpPr/>
            <p:nvPr/>
          </p:nvSpPr>
          <p:spPr>
            <a:xfrm>
              <a:off x="1856586" y="5304865"/>
              <a:ext cx="129816" cy="129816"/>
            </a:xfrm>
            <a:custGeom>
              <a:avLst/>
              <a:gdLst>
                <a:gd name="csX0" fmla="*/ 128372 w 129816"/>
                <a:gd name="csY0" fmla="*/ 65178 h 129816"/>
                <a:gd name="csX1" fmla="*/ 63463 w 129816"/>
                <a:gd name="csY1" fmla="*/ 130086 h 129816"/>
                <a:gd name="csX2" fmla="*/ -1445 w 129816"/>
                <a:gd name="csY2" fmla="*/ 65178 h 129816"/>
                <a:gd name="csX3" fmla="*/ 63463 w 129816"/>
                <a:gd name="csY3" fmla="*/ 270 h 129816"/>
                <a:gd name="csX4" fmla="*/ 128372 w 129816"/>
                <a:gd name="csY4" fmla="*/ 65178 h 129816"/>
              </a:gdLst>
              <a:ahLst/>
              <a:cxnLst>
                <a:cxn ang="0">
                  <a:pos x="csX0" y="csY0"/>
                </a:cxn>
                <a:cxn ang="0">
                  <a:pos x="csX1" y="csY1"/>
                </a:cxn>
                <a:cxn ang="0">
                  <a:pos x="csX2" y="csY2"/>
                </a:cxn>
                <a:cxn ang="0">
                  <a:pos x="csX3" y="csY3"/>
                </a:cxn>
                <a:cxn ang="0">
                  <a:pos x="csX4" y="csY4"/>
                </a:cxn>
              </a:cxnLst>
              <a:rect l="l" t="t" r="r" b="b"/>
              <a:pathLst>
                <a:path w="129816" h="129816">
                  <a:moveTo>
                    <a:pt x="128372" y="65178"/>
                  </a:moveTo>
                  <a:cubicBezTo>
                    <a:pt x="128372" y="101026"/>
                    <a:pt x="99311" y="130086"/>
                    <a:pt x="63463" y="130086"/>
                  </a:cubicBezTo>
                  <a:cubicBezTo>
                    <a:pt x="27616" y="130086"/>
                    <a:pt x="-1445" y="101026"/>
                    <a:pt x="-1445" y="65178"/>
                  </a:cubicBezTo>
                  <a:cubicBezTo>
                    <a:pt x="-1445" y="29330"/>
                    <a:pt x="27616" y="270"/>
                    <a:pt x="63463" y="270"/>
                  </a:cubicBezTo>
                  <a:cubicBezTo>
                    <a:pt x="99311" y="270"/>
                    <a:pt x="128372" y="29330"/>
                    <a:pt x="128372" y="65178"/>
                  </a:cubicBezTo>
                  <a:close/>
                </a:path>
              </a:pathLst>
            </a:custGeom>
            <a:noFill/>
            <a:ln w="11787" cap="rnd">
              <a:solidFill>
                <a:srgbClr val="FA7837"/>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8" name="フリーフォーム: 図形 117">
              <a:extLst>
                <a:ext uri="{FF2B5EF4-FFF2-40B4-BE49-F238E27FC236}">
                  <a16:creationId xmlns:a16="http://schemas.microsoft.com/office/drawing/2014/main" id="{F6F7F946-A47C-CB88-E94D-BD157094BB01}"/>
                </a:ext>
              </a:extLst>
            </p:cNvPr>
            <p:cNvSpPr/>
            <p:nvPr/>
          </p:nvSpPr>
          <p:spPr>
            <a:xfrm>
              <a:off x="1856586" y="5304865"/>
              <a:ext cx="129816" cy="129816"/>
            </a:xfrm>
            <a:custGeom>
              <a:avLst/>
              <a:gdLst>
                <a:gd name="csX0" fmla="*/ 128372 w 129816"/>
                <a:gd name="csY0" fmla="*/ 65178 h 129816"/>
                <a:gd name="csX1" fmla="*/ 63463 w 129816"/>
                <a:gd name="csY1" fmla="*/ 130086 h 129816"/>
                <a:gd name="csX2" fmla="*/ -1445 w 129816"/>
                <a:gd name="csY2" fmla="*/ 65178 h 129816"/>
                <a:gd name="csX3" fmla="*/ 63463 w 129816"/>
                <a:gd name="csY3" fmla="*/ 270 h 129816"/>
                <a:gd name="csX4" fmla="*/ 128372 w 129816"/>
                <a:gd name="csY4" fmla="*/ 65178 h 129816"/>
              </a:gdLst>
              <a:ahLst/>
              <a:cxnLst>
                <a:cxn ang="0">
                  <a:pos x="csX0" y="csY0"/>
                </a:cxn>
                <a:cxn ang="0">
                  <a:pos x="csX1" y="csY1"/>
                </a:cxn>
                <a:cxn ang="0">
                  <a:pos x="csX2" y="csY2"/>
                </a:cxn>
                <a:cxn ang="0">
                  <a:pos x="csX3" y="csY3"/>
                </a:cxn>
                <a:cxn ang="0">
                  <a:pos x="csX4" y="csY4"/>
                </a:cxn>
              </a:cxnLst>
              <a:rect l="l" t="t" r="r" b="b"/>
              <a:pathLst>
                <a:path w="129816" h="129816">
                  <a:moveTo>
                    <a:pt x="128372" y="65178"/>
                  </a:moveTo>
                  <a:cubicBezTo>
                    <a:pt x="128372" y="101026"/>
                    <a:pt x="99311" y="130086"/>
                    <a:pt x="63463" y="130086"/>
                  </a:cubicBezTo>
                  <a:cubicBezTo>
                    <a:pt x="27616" y="130086"/>
                    <a:pt x="-1445" y="101026"/>
                    <a:pt x="-1445" y="65178"/>
                  </a:cubicBezTo>
                  <a:cubicBezTo>
                    <a:pt x="-1445" y="29330"/>
                    <a:pt x="27616" y="270"/>
                    <a:pt x="63463" y="270"/>
                  </a:cubicBezTo>
                  <a:cubicBezTo>
                    <a:pt x="99311" y="270"/>
                    <a:pt x="128372" y="29330"/>
                    <a:pt x="128372" y="65178"/>
                  </a:cubicBezTo>
                  <a:close/>
                </a:path>
              </a:pathLst>
            </a:custGeom>
            <a:solidFill>
              <a:srgbClr val="F7E4DA"/>
            </a:solidFill>
            <a:ln w="2357" cap="sq">
              <a:no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19" name="テキスト ボックス 118">
              <a:extLst>
                <a:ext uri="{FF2B5EF4-FFF2-40B4-BE49-F238E27FC236}">
                  <a16:creationId xmlns:a16="http://schemas.microsoft.com/office/drawing/2014/main" id="{69C2436F-58BB-3493-347C-330A385D8F54}"/>
                </a:ext>
              </a:extLst>
            </p:cNvPr>
            <p:cNvSpPr txBox="1"/>
            <p:nvPr/>
          </p:nvSpPr>
          <p:spPr>
            <a:xfrm>
              <a:off x="1746756" y="5293110"/>
              <a:ext cx="344966"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CLC-A</a:t>
              </a:r>
            </a:p>
          </p:txBody>
        </p:sp>
        <p:sp>
          <p:nvSpPr>
            <p:cNvPr id="120" name="フリーフォーム: 図形 119">
              <a:extLst>
                <a:ext uri="{FF2B5EF4-FFF2-40B4-BE49-F238E27FC236}">
                  <a16:creationId xmlns:a16="http://schemas.microsoft.com/office/drawing/2014/main" id="{CFDD5161-FF20-AFF3-4948-C0BB04ADADB4}"/>
                </a:ext>
              </a:extLst>
            </p:cNvPr>
            <p:cNvSpPr/>
            <p:nvPr/>
          </p:nvSpPr>
          <p:spPr>
            <a:xfrm>
              <a:off x="1520012" y="5152415"/>
              <a:ext cx="144000" cy="144000"/>
            </a:xfrm>
            <a:custGeom>
              <a:avLst/>
              <a:gdLst>
                <a:gd name="csX0" fmla="*/ 128448 w 129816"/>
                <a:gd name="csY0" fmla="*/ 65212 h 129816"/>
                <a:gd name="csX1" fmla="*/ 63540 w 129816"/>
                <a:gd name="csY1" fmla="*/ 130120 h 129816"/>
                <a:gd name="csX2" fmla="*/ -1368 w 129816"/>
                <a:gd name="csY2" fmla="*/ 65212 h 129816"/>
                <a:gd name="csX3" fmla="*/ 63540 w 129816"/>
                <a:gd name="csY3" fmla="*/ 304 h 129816"/>
                <a:gd name="csX4" fmla="*/ 128448 w 129816"/>
                <a:gd name="csY4" fmla="*/ 65212 h 129816"/>
              </a:gdLst>
              <a:ahLst/>
              <a:cxnLst>
                <a:cxn ang="0">
                  <a:pos x="csX0" y="csY0"/>
                </a:cxn>
                <a:cxn ang="0">
                  <a:pos x="csX1" y="csY1"/>
                </a:cxn>
                <a:cxn ang="0">
                  <a:pos x="csX2" y="csY2"/>
                </a:cxn>
                <a:cxn ang="0">
                  <a:pos x="csX3" y="csY3"/>
                </a:cxn>
                <a:cxn ang="0">
                  <a:pos x="csX4" y="csY4"/>
                </a:cxn>
              </a:cxnLst>
              <a:rect l="l" t="t" r="r" b="b"/>
              <a:pathLst>
                <a:path w="129816" h="129816">
                  <a:moveTo>
                    <a:pt x="128448" y="65212"/>
                  </a:moveTo>
                  <a:cubicBezTo>
                    <a:pt x="128448" y="101060"/>
                    <a:pt x="99388" y="130120"/>
                    <a:pt x="63540" y="130120"/>
                  </a:cubicBezTo>
                  <a:cubicBezTo>
                    <a:pt x="27692" y="130120"/>
                    <a:pt x="-1368" y="101060"/>
                    <a:pt x="-1368" y="65212"/>
                  </a:cubicBezTo>
                  <a:cubicBezTo>
                    <a:pt x="-1368" y="29364"/>
                    <a:pt x="27692" y="304"/>
                    <a:pt x="63540" y="304"/>
                  </a:cubicBezTo>
                  <a:cubicBezTo>
                    <a:pt x="99388" y="304"/>
                    <a:pt x="128448" y="29364"/>
                    <a:pt x="128448" y="65212"/>
                  </a:cubicBezTo>
                  <a:close/>
                </a:path>
              </a:pathLst>
            </a:custGeom>
            <a:solidFill>
              <a:srgbClr val="FA7837"/>
            </a:solidFill>
            <a:ln w="6350" cap="sq">
              <a:solidFill>
                <a:schemeClr val="accent2"/>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21" name="テキスト ボックス 120">
              <a:extLst>
                <a:ext uri="{FF2B5EF4-FFF2-40B4-BE49-F238E27FC236}">
                  <a16:creationId xmlns:a16="http://schemas.microsoft.com/office/drawing/2014/main" id="{508303D5-BE21-9192-4903-359E8B8AA5F8}"/>
                </a:ext>
              </a:extLst>
            </p:cNvPr>
            <p:cNvSpPr txBox="1"/>
            <p:nvPr/>
          </p:nvSpPr>
          <p:spPr>
            <a:xfrm>
              <a:off x="1416069" y="5151097"/>
              <a:ext cx="359394"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NPF6.3</a:t>
              </a:r>
            </a:p>
          </p:txBody>
        </p:sp>
        <p:sp>
          <p:nvSpPr>
            <p:cNvPr id="122" name="フリーフォーム: 図形 121">
              <a:extLst>
                <a:ext uri="{FF2B5EF4-FFF2-40B4-BE49-F238E27FC236}">
                  <a16:creationId xmlns:a16="http://schemas.microsoft.com/office/drawing/2014/main" id="{D0652516-A7A1-33BF-89E7-5D602BB37183}"/>
                </a:ext>
              </a:extLst>
            </p:cNvPr>
            <p:cNvSpPr/>
            <p:nvPr/>
          </p:nvSpPr>
          <p:spPr>
            <a:xfrm>
              <a:off x="1865719" y="5715059"/>
              <a:ext cx="144000" cy="144000"/>
            </a:xfrm>
            <a:custGeom>
              <a:avLst/>
              <a:gdLst>
                <a:gd name="csX0" fmla="*/ 69362 w 141618"/>
                <a:gd name="csY0" fmla="*/ 173 h 141617"/>
                <a:gd name="csX1" fmla="*/ 140171 w 141618"/>
                <a:gd name="csY1" fmla="*/ 70982 h 141617"/>
                <a:gd name="csX2" fmla="*/ 69362 w 141618"/>
                <a:gd name="csY2" fmla="*/ 141791 h 141617"/>
                <a:gd name="csX3" fmla="*/ -1447 w 141618"/>
                <a:gd name="csY3" fmla="*/ 70982 h 141617"/>
              </a:gdLst>
              <a:ahLst/>
              <a:cxnLst>
                <a:cxn ang="0">
                  <a:pos x="csX0" y="csY0"/>
                </a:cxn>
                <a:cxn ang="0">
                  <a:pos x="csX1" y="csY1"/>
                </a:cxn>
                <a:cxn ang="0">
                  <a:pos x="csX2" y="csY2"/>
                </a:cxn>
                <a:cxn ang="0">
                  <a:pos x="csX3" y="csY3"/>
                </a:cxn>
              </a:cxnLst>
              <a:rect l="l" t="t" r="r" b="b"/>
              <a:pathLst>
                <a:path w="141618" h="141617">
                  <a:moveTo>
                    <a:pt x="69362" y="173"/>
                  </a:moveTo>
                  <a:lnTo>
                    <a:pt x="140171" y="70982"/>
                  </a:lnTo>
                  <a:lnTo>
                    <a:pt x="69362" y="141791"/>
                  </a:lnTo>
                  <a:lnTo>
                    <a:pt x="-1447" y="70982"/>
                  </a:lnTo>
                  <a:close/>
                </a:path>
              </a:pathLst>
            </a:custGeom>
            <a:solidFill>
              <a:srgbClr val="D5E4EE"/>
            </a:solidFill>
            <a:ln w="6350" cap="sq">
              <a:solidFill>
                <a:srgbClr val="0070C0"/>
              </a:solidFill>
              <a:prstDash val="solid"/>
              <a:miter/>
            </a:ln>
          </p:spPr>
          <p:txBody>
            <a:bodyPr/>
            <a:lstStyle/>
            <a:p>
              <a:endParaRPr lang="ja-JP" altLang="en-US" sz="400" b="1">
                <a:ln w="0"/>
                <a:latin typeface="Arial" panose="020B0604020202020204" pitchFamily="34" charset="0"/>
                <a:cs typeface="Arial" panose="020B0604020202020204" pitchFamily="34" charset="0"/>
              </a:endParaRPr>
            </a:p>
          </p:txBody>
        </p:sp>
        <p:sp>
          <p:nvSpPr>
            <p:cNvPr id="123" name="テキスト ボックス 122">
              <a:extLst>
                <a:ext uri="{FF2B5EF4-FFF2-40B4-BE49-F238E27FC236}">
                  <a16:creationId xmlns:a16="http://schemas.microsoft.com/office/drawing/2014/main" id="{5E5ED30C-B943-6D04-3514-B7836171308A}"/>
                </a:ext>
              </a:extLst>
            </p:cNvPr>
            <p:cNvSpPr txBox="1"/>
            <p:nvPr/>
          </p:nvSpPr>
          <p:spPr>
            <a:xfrm>
              <a:off x="1790723" y="5711269"/>
              <a:ext cx="295274" cy="153888"/>
            </a:xfrm>
            <a:prstGeom prst="rect">
              <a:avLst/>
            </a:prstGeom>
            <a:no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p>
              <a:pPr algn="l"/>
              <a:r>
                <a:rPr lang="ja-JP" altLang="en-US" sz="400" b="1" baseline="0" dirty="0">
                  <a:ln w="0"/>
                  <a:latin typeface="Arial" panose="020B0604020202020204" pitchFamily="34" charset="0"/>
                  <a:cs typeface="Arial" panose="020B0604020202020204" pitchFamily="34" charset="0"/>
                  <a:sym typeface="Helvetica"/>
                  <a:rtl val="0"/>
                </a:rPr>
                <a:t>SIS8</a:t>
              </a:r>
            </a:p>
          </p:txBody>
        </p:sp>
      </p:grpSp>
      <p:grpSp>
        <p:nvGrpSpPr>
          <p:cNvPr id="126" name="グループ化 125">
            <a:extLst>
              <a:ext uri="{FF2B5EF4-FFF2-40B4-BE49-F238E27FC236}">
                <a16:creationId xmlns:a16="http://schemas.microsoft.com/office/drawing/2014/main" id="{6880ACC4-E9DB-85A6-C98C-718326CC7E69}"/>
              </a:ext>
            </a:extLst>
          </p:cNvPr>
          <p:cNvGrpSpPr/>
          <p:nvPr/>
        </p:nvGrpSpPr>
        <p:grpSpPr>
          <a:xfrm>
            <a:off x="4738604" y="1260354"/>
            <a:ext cx="1405014" cy="1800000"/>
            <a:chOff x="4925641" y="3936256"/>
            <a:chExt cx="1405014" cy="1800000"/>
          </a:xfrm>
        </p:grpSpPr>
        <p:sp>
          <p:nvSpPr>
            <p:cNvPr id="127" name="楕円 126">
              <a:extLst>
                <a:ext uri="{FF2B5EF4-FFF2-40B4-BE49-F238E27FC236}">
                  <a16:creationId xmlns:a16="http://schemas.microsoft.com/office/drawing/2014/main" id="{0CE64768-CCFC-6D1B-E680-1AA624C7EB91}"/>
                </a:ext>
              </a:extLst>
            </p:cNvPr>
            <p:cNvSpPr/>
            <p:nvPr/>
          </p:nvSpPr>
          <p:spPr>
            <a:xfrm rot="19171770">
              <a:off x="4925641" y="3936256"/>
              <a:ext cx="1368000" cy="1800000"/>
            </a:xfrm>
            <a:prstGeom prst="ellipse">
              <a:avLst/>
            </a:prstGeom>
            <a:solidFill>
              <a:schemeClr val="accent6">
                <a:lumMod val="20000"/>
                <a:lumOff val="80000"/>
                <a:alpha val="50196"/>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b="1">
                <a:latin typeface="Arial" panose="020B0604020202020204" pitchFamily="34" charset="0"/>
                <a:cs typeface="Arial" panose="020B0604020202020204" pitchFamily="34" charset="0"/>
              </a:endParaRPr>
            </a:p>
          </p:txBody>
        </p:sp>
        <p:sp>
          <p:nvSpPr>
            <p:cNvPr id="128" name="フリーフォーム: 図形 127">
              <a:extLst>
                <a:ext uri="{FF2B5EF4-FFF2-40B4-BE49-F238E27FC236}">
                  <a16:creationId xmlns:a16="http://schemas.microsoft.com/office/drawing/2014/main" id="{9CF813E1-4A31-5E8C-7BDB-BD4A3C9386AB}"/>
                </a:ext>
              </a:extLst>
            </p:cNvPr>
            <p:cNvSpPr/>
            <p:nvPr/>
          </p:nvSpPr>
          <p:spPr>
            <a:xfrm>
              <a:off x="5687075" y="4840793"/>
              <a:ext cx="75737" cy="85789"/>
            </a:xfrm>
            <a:custGeom>
              <a:avLst/>
              <a:gdLst>
                <a:gd name="csX0" fmla="*/ -5322 w 75737"/>
                <a:gd name="csY0" fmla="*/ 317 h 85789"/>
                <a:gd name="csX1" fmla="*/ 70415 w 75737"/>
                <a:gd name="csY1" fmla="*/ 86107 h 85789"/>
              </a:gdLst>
              <a:ahLst/>
              <a:cxnLst>
                <a:cxn ang="0">
                  <a:pos x="csX0" y="csY0"/>
                </a:cxn>
                <a:cxn ang="0">
                  <a:pos x="csX1" y="csY1"/>
                </a:cxn>
              </a:cxnLst>
              <a:rect l="l" t="t" r="r" b="b"/>
              <a:pathLst>
                <a:path w="75737" h="85789">
                  <a:moveTo>
                    <a:pt x="-5322" y="317"/>
                  </a:moveTo>
                  <a:lnTo>
                    <a:pt x="70415" y="86107"/>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29" name="フリーフォーム: 図形 128">
              <a:extLst>
                <a:ext uri="{FF2B5EF4-FFF2-40B4-BE49-F238E27FC236}">
                  <a16:creationId xmlns:a16="http://schemas.microsoft.com/office/drawing/2014/main" id="{2181507F-A720-5C6A-0E88-C4800A6DA2C2}"/>
                </a:ext>
              </a:extLst>
            </p:cNvPr>
            <p:cNvSpPr/>
            <p:nvPr/>
          </p:nvSpPr>
          <p:spPr>
            <a:xfrm rot="2913659">
              <a:off x="5754120" y="4932999"/>
              <a:ext cx="51407" cy="25703"/>
            </a:xfrm>
            <a:custGeom>
              <a:avLst/>
              <a:gdLst>
                <a:gd name="csX0" fmla="*/ 402 w 51407"/>
                <a:gd name="csY0" fmla="*/ 211 h 25703"/>
                <a:gd name="csX1" fmla="*/ 51809 w 51407"/>
                <a:gd name="csY1" fmla="*/ 13063 h 25703"/>
                <a:gd name="csX2" fmla="*/ 402 w 51407"/>
                <a:gd name="csY2" fmla="*/ 25915 h 25703"/>
              </a:gdLst>
              <a:ahLst/>
              <a:cxnLst>
                <a:cxn ang="0">
                  <a:pos x="csX0" y="csY0"/>
                </a:cxn>
                <a:cxn ang="0">
                  <a:pos x="csX1" y="csY1"/>
                </a:cxn>
                <a:cxn ang="0">
                  <a:pos x="csX2" y="csY2"/>
                </a:cxn>
              </a:cxnLst>
              <a:rect l="l" t="t" r="r" b="b"/>
              <a:pathLst>
                <a:path w="51407" h="25703">
                  <a:moveTo>
                    <a:pt x="402" y="211"/>
                  </a:moveTo>
                  <a:cubicBezTo>
                    <a:pt x="17537" y="8779"/>
                    <a:pt x="34673" y="13063"/>
                    <a:pt x="51809" y="13063"/>
                  </a:cubicBezTo>
                  <a:cubicBezTo>
                    <a:pt x="34673" y="13063"/>
                    <a:pt x="17537" y="17347"/>
                    <a:pt x="402" y="25915"/>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0" name="フリーフォーム: 図形 129">
              <a:extLst>
                <a:ext uri="{FF2B5EF4-FFF2-40B4-BE49-F238E27FC236}">
                  <a16:creationId xmlns:a16="http://schemas.microsoft.com/office/drawing/2014/main" id="{687A3930-8F5C-B556-DA23-35911671EDB3}"/>
                </a:ext>
              </a:extLst>
            </p:cNvPr>
            <p:cNvSpPr/>
            <p:nvPr/>
          </p:nvSpPr>
          <p:spPr>
            <a:xfrm>
              <a:off x="5714499" y="4752526"/>
              <a:ext cx="171009" cy="35023"/>
            </a:xfrm>
            <a:custGeom>
              <a:avLst/>
              <a:gdLst>
                <a:gd name="csX0" fmla="*/ -5340 w 171009"/>
                <a:gd name="csY0" fmla="*/ 35367 h 35023"/>
                <a:gd name="csX1" fmla="*/ 165669 w 171009"/>
                <a:gd name="csY1" fmla="*/ 344 h 35023"/>
              </a:gdLst>
              <a:ahLst/>
              <a:cxnLst>
                <a:cxn ang="0">
                  <a:pos x="csX0" y="csY0"/>
                </a:cxn>
                <a:cxn ang="0">
                  <a:pos x="csX1" y="csY1"/>
                </a:cxn>
              </a:cxnLst>
              <a:rect l="l" t="t" r="r" b="b"/>
              <a:pathLst>
                <a:path w="171009" h="35023">
                  <a:moveTo>
                    <a:pt x="-5340" y="35367"/>
                  </a:moveTo>
                  <a:lnTo>
                    <a:pt x="165669" y="344"/>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1" name="フリーフォーム: 図形 130">
              <a:extLst>
                <a:ext uri="{FF2B5EF4-FFF2-40B4-BE49-F238E27FC236}">
                  <a16:creationId xmlns:a16="http://schemas.microsoft.com/office/drawing/2014/main" id="{78269D79-2745-8398-8422-E18B968DC685}"/>
                </a:ext>
              </a:extLst>
            </p:cNvPr>
            <p:cNvSpPr/>
            <p:nvPr/>
          </p:nvSpPr>
          <p:spPr>
            <a:xfrm rot="10105540">
              <a:off x="5708717" y="4782294"/>
              <a:ext cx="5841" cy="11683"/>
            </a:xfrm>
            <a:custGeom>
              <a:avLst/>
              <a:gdLst>
                <a:gd name="csX0" fmla="*/ 387 w 5841"/>
                <a:gd name="csY0" fmla="*/ 11864 h 11683"/>
                <a:gd name="csX1" fmla="*/ 6229 w 5841"/>
                <a:gd name="csY1" fmla="*/ 6022 h 11683"/>
                <a:gd name="csX2" fmla="*/ 387 w 5841"/>
                <a:gd name="csY2" fmla="*/ 181 h 11683"/>
              </a:gdLst>
              <a:ahLst/>
              <a:cxnLst>
                <a:cxn ang="0">
                  <a:pos x="csX0" y="csY0"/>
                </a:cxn>
                <a:cxn ang="0">
                  <a:pos x="csX1" y="csY1"/>
                </a:cxn>
                <a:cxn ang="0">
                  <a:pos x="csX2" y="csY2"/>
                </a:cxn>
              </a:cxnLst>
              <a:rect l="l" t="t" r="r" b="b"/>
              <a:pathLst>
                <a:path w="5841" h="11683">
                  <a:moveTo>
                    <a:pt x="387" y="11864"/>
                  </a:moveTo>
                  <a:cubicBezTo>
                    <a:pt x="3613" y="11864"/>
                    <a:pt x="6229" y="9249"/>
                    <a:pt x="6229" y="6022"/>
                  </a:cubicBezTo>
                  <a:cubicBezTo>
                    <a:pt x="6229" y="2796"/>
                    <a:pt x="3613" y="181"/>
                    <a:pt x="387" y="181"/>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2" name="フリーフォーム: 図形 131">
              <a:extLst>
                <a:ext uri="{FF2B5EF4-FFF2-40B4-BE49-F238E27FC236}">
                  <a16:creationId xmlns:a16="http://schemas.microsoft.com/office/drawing/2014/main" id="{23E470F0-60AB-2E41-D2A8-019CBC914D54}"/>
                </a:ext>
              </a:extLst>
            </p:cNvPr>
            <p:cNvSpPr/>
            <p:nvPr/>
          </p:nvSpPr>
          <p:spPr>
            <a:xfrm rot="20905540">
              <a:off x="5884986" y="4734517"/>
              <a:ext cx="51407" cy="25703"/>
            </a:xfrm>
            <a:custGeom>
              <a:avLst/>
              <a:gdLst>
                <a:gd name="csX0" fmla="*/ 427 w 51407"/>
                <a:gd name="csY0" fmla="*/ 173 h 25703"/>
                <a:gd name="csX1" fmla="*/ 51834 w 51407"/>
                <a:gd name="csY1" fmla="*/ 13025 h 25703"/>
                <a:gd name="csX2" fmla="*/ 427 w 51407"/>
                <a:gd name="csY2" fmla="*/ 25876 h 25703"/>
              </a:gdLst>
              <a:ahLst/>
              <a:cxnLst>
                <a:cxn ang="0">
                  <a:pos x="csX0" y="csY0"/>
                </a:cxn>
                <a:cxn ang="0">
                  <a:pos x="csX1" y="csY1"/>
                </a:cxn>
                <a:cxn ang="0">
                  <a:pos x="csX2" y="csY2"/>
                </a:cxn>
              </a:cxnLst>
              <a:rect l="l" t="t" r="r" b="b"/>
              <a:pathLst>
                <a:path w="51407" h="25703">
                  <a:moveTo>
                    <a:pt x="427" y="173"/>
                  </a:moveTo>
                  <a:cubicBezTo>
                    <a:pt x="17563" y="8741"/>
                    <a:pt x="34698" y="13025"/>
                    <a:pt x="51834" y="13025"/>
                  </a:cubicBezTo>
                  <a:cubicBezTo>
                    <a:pt x="34698" y="13025"/>
                    <a:pt x="17563" y="17309"/>
                    <a:pt x="427" y="25876"/>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3" name="フリーフォーム: 図形 132">
              <a:extLst>
                <a:ext uri="{FF2B5EF4-FFF2-40B4-BE49-F238E27FC236}">
                  <a16:creationId xmlns:a16="http://schemas.microsoft.com/office/drawing/2014/main" id="{656CF7ED-B14E-5E1B-31F9-74DD7B886ECD}"/>
                </a:ext>
              </a:extLst>
            </p:cNvPr>
            <p:cNvSpPr/>
            <p:nvPr/>
          </p:nvSpPr>
          <p:spPr>
            <a:xfrm>
              <a:off x="5669843" y="4394687"/>
              <a:ext cx="111157" cy="348205"/>
            </a:xfrm>
            <a:custGeom>
              <a:avLst/>
              <a:gdLst>
                <a:gd name="csX0" fmla="*/ -5322 w 111157"/>
                <a:gd name="csY0" fmla="*/ 348597 h 348205"/>
                <a:gd name="csX1" fmla="*/ 105835 w 111157"/>
                <a:gd name="csY1" fmla="*/ 391 h 348205"/>
              </a:gdLst>
              <a:ahLst/>
              <a:cxnLst>
                <a:cxn ang="0">
                  <a:pos x="csX0" y="csY0"/>
                </a:cxn>
                <a:cxn ang="0">
                  <a:pos x="csX1" y="csY1"/>
                </a:cxn>
              </a:cxnLst>
              <a:rect l="l" t="t" r="r" b="b"/>
              <a:pathLst>
                <a:path w="111157" h="348205">
                  <a:moveTo>
                    <a:pt x="-5322" y="348597"/>
                  </a:moveTo>
                  <a:lnTo>
                    <a:pt x="105835" y="391"/>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4" name="フリーフォーム: 図形 133">
              <a:extLst>
                <a:ext uri="{FF2B5EF4-FFF2-40B4-BE49-F238E27FC236}">
                  <a16:creationId xmlns:a16="http://schemas.microsoft.com/office/drawing/2014/main" id="{D86F7331-FF35-C00C-9437-280FAD1E3129}"/>
                </a:ext>
              </a:extLst>
            </p:cNvPr>
            <p:cNvSpPr/>
            <p:nvPr/>
          </p:nvSpPr>
          <p:spPr>
            <a:xfrm rot="6462276">
              <a:off x="5666034" y="4739834"/>
              <a:ext cx="5841" cy="11683"/>
            </a:xfrm>
            <a:custGeom>
              <a:avLst/>
              <a:gdLst>
                <a:gd name="csX0" fmla="*/ 379 w 5841"/>
                <a:gd name="csY0" fmla="*/ 11856 h 11683"/>
                <a:gd name="csX1" fmla="*/ 6221 w 5841"/>
                <a:gd name="csY1" fmla="*/ 6014 h 11683"/>
                <a:gd name="csX2" fmla="*/ 379 w 5841"/>
                <a:gd name="csY2" fmla="*/ 172 h 11683"/>
              </a:gdLst>
              <a:ahLst/>
              <a:cxnLst>
                <a:cxn ang="0">
                  <a:pos x="csX0" y="csY0"/>
                </a:cxn>
                <a:cxn ang="0">
                  <a:pos x="csX1" y="csY1"/>
                </a:cxn>
                <a:cxn ang="0">
                  <a:pos x="csX2" y="csY2"/>
                </a:cxn>
              </a:cxnLst>
              <a:rect l="l" t="t" r="r" b="b"/>
              <a:pathLst>
                <a:path w="5841" h="11683">
                  <a:moveTo>
                    <a:pt x="379" y="11856"/>
                  </a:moveTo>
                  <a:cubicBezTo>
                    <a:pt x="3605" y="11856"/>
                    <a:pt x="6221" y="9240"/>
                    <a:pt x="6221" y="6014"/>
                  </a:cubicBezTo>
                  <a:cubicBezTo>
                    <a:pt x="6221" y="2788"/>
                    <a:pt x="3605" y="172"/>
                    <a:pt x="379" y="172"/>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5" name="フリーフォーム: 図形 134">
              <a:extLst>
                <a:ext uri="{FF2B5EF4-FFF2-40B4-BE49-F238E27FC236}">
                  <a16:creationId xmlns:a16="http://schemas.microsoft.com/office/drawing/2014/main" id="{B8A5D0F8-F5F5-8660-2E75-95C134716A0A}"/>
                </a:ext>
              </a:extLst>
            </p:cNvPr>
            <p:cNvSpPr/>
            <p:nvPr/>
          </p:nvSpPr>
          <p:spPr>
            <a:xfrm rot="17262276">
              <a:off x="5755684" y="4354437"/>
              <a:ext cx="54000" cy="36000"/>
            </a:xfrm>
            <a:custGeom>
              <a:avLst/>
              <a:gdLst>
                <a:gd name="csX0" fmla="*/ 403 w 51407"/>
                <a:gd name="csY0" fmla="*/ 100 h 25703"/>
                <a:gd name="csX1" fmla="*/ 51811 w 51407"/>
                <a:gd name="csY1" fmla="*/ 12952 h 25703"/>
                <a:gd name="csX2" fmla="*/ 403 w 51407"/>
                <a:gd name="csY2" fmla="*/ 25804 h 25703"/>
              </a:gdLst>
              <a:ahLst/>
              <a:cxnLst>
                <a:cxn ang="0">
                  <a:pos x="csX0" y="csY0"/>
                </a:cxn>
                <a:cxn ang="0">
                  <a:pos x="csX1" y="csY1"/>
                </a:cxn>
                <a:cxn ang="0">
                  <a:pos x="csX2" y="csY2"/>
                </a:cxn>
              </a:cxnLst>
              <a:rect l="l" t="t" r="r" b="b"/>
              <a:pathLst>
                <a:path w="51407" h="25703">
                  <a:moveTo>
                    <a:pt x="403" y="100"/>
                  </a:moveTo>
                  <a:cubicBezTo>
                    <a:pt x="17539" y="8668"/>
                    <a:pt x="34675" y="12952"/>
                    <a:pt x="51811" y="12952"/>
                  </a:cubicBezTo>
                  <a:cubicBezTo>
                    <a:pt x="34675" y="12952"/>
                    <a:pt x="17539" y="17236"/>
                    <a:pt x="403" y="25804"/>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6" name="フリーフォーム: 図形 135">
              <a:extLst>
                <a:ext uri="{FF2B5EF4-FFF2-40B4-BE49-F238E27FC236}">
                  <a16:creationId xmlns:a16="http://schemas.microsoft.com/office/drawing/2014/main" id="{B9CA1F9C-4896-BE07-B35A-E8FFABBF1D41}"/>
                </a:ext>
              </a:extLst>
            </p:cNvPr>
            <p:cNvSpPr/>
            <p:nvPr/>
          </p:nvSpPr>
          <p:spPr>
            <a:xfrm>
              <a:off x="5564075" y="4359862"/>
              <a:ext cx="252628" cy="70255"/>
            </a:xfrm>
            <a:custGeom>
              <a:avLst/>
              <a:gdLst>
                <a:gd name="csX0" fmla="*/ 247314 w 252628"/>
                <a:gd name="csY0" fmla="*/ 70688 h 70255"/>
                <a:gd name="csX1" fmla="*/ -5314 w 252628"/>
                <a:gd name="csY1" fmla="*/ 432 h 70255"/>
              </a:gdLst>
              <a:ahLst/>
              <a:cxnLst>
                <a:cxn ang="0">
                  <a:pos x="csX0" y="csY0"/>
                </a:cxn>
                <a:cxn ang="0">
                  <a:pos x="csX1" y="csY1"/>
                </a:cxn>
              </a:cxnLst>
              <a:rect l="l" t="t" r="r" b="b"/>
              <a:pathLst>
                <a:path w="252628" h="70255">
                  <a:moveTo>
                    <a:pt x="247314" y="70688"/>
                  </a:moveTo>
                  <a:lnTo>
                    <a:pt x="-5314" y="432"/>
                  </a:lnTo>
                </a:path>
              </a:pathLst>
            </a:custGeom>
            <a:noFill/>
            <a:ln w="9335"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7" name="フリーフォーム: 図形 136">
              <a:extLst>
                <a:ext uri="{FF2B5EF4-FFF2-40B4-BE49-F238E27FC236}">
                  <a16:creationId xmlns:a16="http://schemas.microsoft.com/office/drawing/2014/main" id="{F9FECD82-434D-991E-EC2C-FEBF48101CF3}"/>
                </a:ext>
              </a:extLst>
            </p:cNvPr>
            <p:cNvSpPr/>
            <p:nvPr/>
          </p:nvSpPr>
          <p:spPr>
            <a:xfrm>
              <a:off x="5535368" y="4456216"/>
              <a:ext cx="96944" cy="287452"/>
            </a:xfrm>
            <a:custGeom>
              <a:avLst/>
              <a:gdLst>
                <a:gd name="csX0" fmla="*/ 91655 w 96944"/>
                <a:gd name="csY0" fmla="*/ 287837 h 287452"/>
                <a:gd name="csX1" fmla="*/ -5289 w 96944"/>
                <a:gd name="csY1" fmla="*/ 384 h 287452"/>
              </a:gdLst>
              <a:ahLst/>
              <a:cxnLst>
                <a:cxn ang="0">
                  <a:pos x="csX0" y="csY0"/>
                </a:cxn>
                <a:cxn ang="0">
                  <a:pos x="csX1" y="csY1"/>
                </a:cxn>
              </a:cxnLst>
              <a:rect l="l" t="t" r="r" b="b"/>
              <a:pathLst>
                <a:path w="96944" h="287452">
                  <a:moveTo>
                    <a:pt x="91655" y="287837"/>
                  </a:moveTo>
                  <a:lnTo>
                    <a:pt x="-5289" y="384"/>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8" name="フリーフォーム: 図形 137">
              <a:extLst>
                <a:ext uri="{FF2B5EF4-FFF2-40B4-BE49-F238E27FC236}">
                  <a16:creationId xmlns:a16="http://schemas.microsoft.com/office/drawing/2014/main" id="{1B65BDCF-A452-9544-D823-A6FC2F974CAF}"/>
                </a:ext>
              </a:extLst>
            </p:cNvPr>
            <p:cNvSpPr/>
            <p:nvPr/>
          </p:nvSpPr>
          <p:spPr>
            <a:xfrm rot="4281784">
              <a:off x="5630325" y="4740595"/>
              <a:ext cx="5841" cy="11683"/>
            </a:xfrm>
            <a:custGeom>
              <a:avLst/>
              <a:gdLst>
                <a:gd name="csX0" fmla="*/ 372 w 5841"/>
                <a:gd name="csY0" fmla="*/ 11856 h 11683"/>
                <a:gd name="csX1" fmla="*/ 6214 w 5841"/>
                <a:gd name="csY1" fmla="*/ 6014 h 11683"/>
                <a:gd name="csX2" fmla="*/ 372 w 5841"/>
                <a:gd name="csY2" fmla="*/ 173 h 11683"/>
              </a:gdLst>
              <a:ahLst/>
              <a:cxnLst>
                <a:cxn ang="0">
                  <a:pos x="csX0" y="csY0"/>
                </a:cxn>
                <a:cxn ang="0">
                  <a:pos x="csX1" y="csY1"/>
                </a:cxn>
                <a:cxn ang="0">
                  <a:pos x="csX2" y="csY2"/>
                </a:cxn>
              </a:cxnLst>
              <a:rect l="l" t="t" r="r" b="b"/>
              <a:pathLst>
                <a:path w="5841" h="11683">
                  <a:moveTo>
                    <a:pt x="372" y="11856"/>
                  </a:moveTo>
                  <a:cubicBezTo>
                    <a:pt x="3598" y="11856"/>
                    <a:pt x="6214" y="9241"/>
                    <a:pt x="6214" y="6014"/>
                  </a:cubicBezTo>
                  <a:cubicBezTo>
                    <a:pt x="6214" y="2788"/>
                    <a:pt x="3598" y="173"/>
                    <a:pt x="372" y="173"/>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39" name="フリーフォーム: 図形 138">
              <a:extLst>
                <a:ext uri="{FF2B5EF4-FFF2-40B4-BE49-F238E27FC236}">
                  <a16:creationId xmlns:a16="http://schemas.microsoft.com/office/drawing/2014/main" id="{60A86C64-169B-3107-93D8-D1E73AB25878}"/>
                </a:ext>
              </a:extLst>
            </p:cNvPr>
            <p:cNvSpPr/>
            <p:nvPr/>
          </p:nvSpPr>
          <p:spPr>
            <a:xfrm rot="15081784">
              <a:off x="5501450" y="4419009"/>
              <a:ext cx="51407" cy="25703"/>
            </a:xfrm>
            <a:custGeom>
              <a:avLst/>
              <a:gdLst>
                <a:gd name="csX0" fmla="*/ 353 w 51407"/>
                <a:gd name="csY0" fmla="*/ 112 h 25703"/>
                <a:gd name="csX1" fmla="*/ 51760 w 51407"/>
                <a:gd name="csY1" fmla="*/ 12964 h 25703"/>
                <a:gd name="csX2" fmla="*/ 353 w 51407"/>
                <a:gd name="csY2" fmla="*/ 25816 h 25703"/>
              </a:gdLst>
              <a:ahLst/>
              <a:cxnLst>
                <a:cxn ang="0">
                  <a:pos x="csX0" y="csY0"/>
                </a:cxn>
                <a:cxn ang="0">
                  <a:pos x="csX1" y="csY1"/>
                </a:cxn>
                <a:cxn ang="0">
                  <a:pos x="csX2" y="csY2"/>
                </a:cxn>
              </a:cxnLst>
              <a:rect l="l" t="t" r="r" b="b"/>
              <a:pathLst>
                <a:path w="51407" h="25703">
                  <a:moveTo>
                    <a:pt x="353" y="112"/>
                  </a:moveTo>
                  <a:cubicBezTo>
                    <a:pt x="17489" y="8680"/>
                    <a:pt x="34624" y="12964"/>
                    <a:pt x="51760" y="12964"/>
                  </a:cubicBezTo>
                  <a:cubicBezTo>
                    <a:pt x="34624" y="12964"/>
                    <a:pt x="17489" y="17248"/>
                    <a:pt x="353" y="25816"/>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0" name="フリーフォーム: 図形 139">
              <a:extLst>
                <a:ext uri="{FF2B5EF4-FFF2-40B4-BE49-F238E27FC236}">
                  <a16:creationId xmlns:a16="http://schemas.microsoft.com/office/drawing/2014/main" id="{8E006ABE-701C-4DAC-8B71-7B067FA9E372}"/>
                </a:ext>
              </a:extLst>
            </p:cNvPr>
            <p:cNvSpPr/>
            <p:nvPr/>
          </p:nvSpPr>
          <p:spPr>
            <a:xfrm>
              <a:off x="5695861" y="4654628"/>
              <a:ext cx="160822" cy="114282"/>
            </a:xfrm>
            <a:custGeom>
              <a:avLst/>
              <a:gdLst>
                <a:gd name="csX0" fmla="*/ -5334 w 160822"/>
                <a:gd name="csY0" fmla="*/ 114641 h 114282"/>
                <a:gd name="csX1" fmla="*/ 155488 w 160822"/>
                <a:gd name="csY1" fmla="*/ 358 h 114282"/>
              </a:gdLst>
              <a:ahLst/>
              <a:cxnLst>
                <a:cxn ang="0">
                  <a:pos x="csX0" y="csY0"/>
                </a:cxn>
                <a:cxn ang="0">
                  <a:pos x="csX1" y="csY1"/>
                </a:cxn>
              </a:cxnLst>
              <a:rect l="l" t="t" r="r" b="b"/>
              <a:pathLst>
                <a:path w="160822" h="114282">
                  <a:moveTo>
                    <a:pt x="-5334" y="114641"/>
                  </a:moveTo>
                  <a:lnTo>
                    <a:pt x="155488" y="358"/>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1" name="フリーフォーム: 図形 140">
              <a:extLst>
                <a:ext uri="{FF2B5EF4-FFF2-40B4-BE49-F238E27FC236}">
                  <a16:creationId xmlns:a16="http://schemas.microsoft.com/office/drawing/2014/main" id="{C93BDA81-D41C-3BCA-181B-4C2930BC10BB}"/>
                </a:ext>
              </a:extLst>
            </p:cNvPr>
            <p:cNvSpPr/>
            <p:nvPr/>
          </p:nvSpPr>
          <p:spPr>
            <a:xfrm rot="8676107">
              <a:off x="5690559" y="4764761"/>
              <a:ext cx="5841" cy="11683"/>
            </a:xfrm>
            <a:custGeom>
              <a:avLst/>
              <a:gdLst>
                <a:gd name="csX0" fmla="*/ 384 w 5841"/>
                <a:gd name="csY0" fmla="*/ 11861 h 11683"/>
                <a:gd name="csX1" fmla="*/ 6225 w 5841"/>
                <a:gd name="csY1" fmla="*/ 6019 h 11683"/>
                <a:gd name="csX2" fmla="*/ 384 w 5841"/>
                <a:gd name="csY2" fmla="*/ 177 h 11683"/>
              </a:gdLst>
              <a:ahLst/>
              <a:cxnLst>
                <a:cxn ang="0">
                  <a:pos x="csX0" y="csY0"/>
                </a:cxn>
                <a:cxn ang="0">
                  <a:pos x="csX1" y="csY1"/>
                </a:cxn>
                <a:cxn ang="0">
                  <a:pos x="csX2" y="csY2"/>
                </a:cxn>
              </a:cxnLst>
              <a:rect l="l" t="t" r="r" b="b"/>
              <a:pathLst>
                <a:path w="5841" h="11683">
                  <a:moveTo>
                    <a:pt x="384" y="11861"/>
                  </a:moveTo>
                  <a:cubicBezTo>
                    <a:pt x="3610" y="11861"/>
                    <a:pt x="6225" y="9245"/>
                    <a:pt x="6225" y="6019"/>
                  </a:cubicBezTo>
                  <a:cubicBezTo>
                    <a:pt x="6225" y="2793"/>
                    <a:pt x="3610" y="177"/>
                    <a:pt x="384" y="177"/>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2" name="フリーフォーム: 図形 141">
              <a:extLst>
                <a:ext uri="{FF2B5EF4-FFF2-40B4-BE49-F238E27FC236}">
                  <a16:creationId xmlns:a16="http://schemas.microsoft.com/office/drawing/2014/main" id="{137559FC-A752-A5B1-D5EE-DA68A1404ECE}"/>
                </a:ext>
              </a:extLst>
            </p:cNvPr>
            <p:cNvSpPr/>
            <p:nvPr/>
          </p:nvSpPr>
          <p:spPr>
            <a:xfrm rot="19476107">
              <a:off x="5851932" y="4626888"/>
              <a:ext cx="51407" cy="25703"/>
            </a:xfrm>
            <a:custGeom>
              <a:avLst/>
              <a:gdLst>
                <a:gd name="csX0" fmla="*/ 420 w 51407"/>
                <a:gd name="csY0" fmla="*/ 152 h 25703"/>
                <a:gd name="csX1" fmla="*/ 51828 w 51407"/>
                <a:gd name="csY1" fmla="*/ 13004 h 25703"/>
                <a:gd name="csX2" fmla="*/ 420 w 51407"/>
                <a:gd name="csY2" fmla="*/ 25856 h 25703"/>
              </a:gdLst>
              <a:ahLst/>
              <a:cxnLst>
                <a:cxn ang="0">
                  <a:pos x="csX0" y="csY0"/>
                </a:cxn>
                <a:cxn ang="0">
                  <a:pos x="csX1" y="csY1"/>
                </a:cxn>
                <a:cxn ang="0">
                  <a:pos x="csX2" y="csY2"/>
                </a:cxn>
              </a:cxnLst>
              <a:rect l="l" t="t" r="r" b="b"/>
              <a:pathLst>
                <a:path w="51407" h="25703">
                  <a:moveTo>
                    <a:pt x="420" y="152"/>
                  </a:moveTo>
                  <a:cubicBezTo>
                    <a:pt x="17556" y="8720"/>
                    <a:pt x="34692" y="13004"/>
                    <a:pt x="51828" y="13004"/>
                  </a:cubicBezTo>
                  <a:cubicBezTo>
                    <a:pt x="34692" y="13004"/>
                    <a:pt x="17556" y="17288"/>
                    <a:pt x="420" y="25856"/>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3" name="フリーフォーム: 図形 142">
              <a:extLst>
                <a:ext uri="{FF2B5EF4-FFF2-40B4-BE49-F238E27FC236}">
                  <a16:creationId xmlns:a16="http://schemas.microsoft.com/office/drawing/2014/main" id="{D33702DE-FDD1-6DF0-6921-1CB018E0258E}"/>
                </a:ext>
              </a:extLst>
            </p:cNvPr>
            <p:cNvSpPr/>
            <p:nvPr/>
          </p:nvSpPr>
          <p:spPr>
            <a:xfrm>
              <a:off x="5378435" y="4780778"/>
              <a:ext cx="202194" cy="14574"/>
            </a:xfrm>
            <a:custGeom>
              <a:avLst/>
              <a:gdLst>
                <a:gd name="csX0" fmla="*/ 196930 w 202194"/>
                <a:gd name="csY0" fmla="*/ 14915 h 14574"/>
                <a:gd name="csX1" fmla="*/ -5265 w 202194"/>
                <a:gd name="csY1" fmla="*/ 340 h 14574"/>
              </a:gdLst>
              <a:ahLst/>
              <a:cxnLst>
                <a:cxn ang="0">
                  <a:pos x="csX0" y="csY0"/>
                </a:cxn>
                <a:cxn ang="0">
                  <a:pos x="csX1" y="csY1"/>
                </a:cxn>
              </a:cxnLst>
              <a:rect l="l" t="t" r="r" b="b"/>
              <a:pathLst>
                <a:path w="202194" h="14574">
                  <a:moveTo>
                    <a:pt x="196930" y="14915"/>
                  </a:moveTo>
                  <a:lnTo>
                    <a:pt x="-5265" y="340"/>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4" name="フリーフォーム: 図形 143">
              <a:extLst>
                <a:ext uri="{FF2B5EF4-FFF2-40B4-BE49-F238E27FC236}">
                  <a16:creationId xmlns:a16="http://schemas.microsoft.com/office/drawing/2014/main" id="{E17460CE-FBAA-6F1E-0B6D-8C65848698A2}"/>
                </a:ext>
              </a:extLst>
            </p:cNvPr>
            <p:cNvSpPr/>
            <p:nvPr/>
          </p:nvSpPr>
          <p:spPr>
            <a:xfrm rot="247376">
              <a:off x="5580622" y="4789721"/>
              <a:ext cx="5841" cy="11683"/>
            </a:xfrm>
            <a:custGeom>
              <a:avLst/>
              <a:gdLst>
                <a:gd name="csX0" fmla="*/ 362 w 5841"/>
                <a:gd name="csY0" fmla="*/ 11866 h 11683"/>
                <a:gd name="csX1" fmla="*/ 6204 w 5841"/>
                <a:gd name="csY1" fmla="*/ 6024 h 11683"/>
                <a:gd name="csX2" fmla="*/ 362 w 5841"/>
                <a:gd name="csY2" fmla="*/ 182 h 11683"/>
              </a:gdLst>
              <a:ahLst/>
              <a:cxnLst>
                <a:cxn ang="0">
                  <a:pos x="csX0" y="csY0"/>
                </a:cxn>
                <a:cxn ang="0">
                  <a:pos x="csX1" y="csY1"/>
                </a:cxn>
                <a:cxn ang="0">
                  <a:pos x="csX2" y="csY2"/>
                </a:cxn>
              </a:cxnLst>
              <a:rect l="l" t="t" r="r" b="b"/>
              <a:pathLst>
                <a:path w="5841" h="11683">
                  <a:moveTo>
                    <a:pt x="362" y="11866"/>
                  </a:moveTo>
                  <a:cubicBezTo>
                    <a:pt x="3589" y="11866"/>
                    <a:pt x="6204" y="9250"/>
                    <a:pt x="6204" y="6024"/>
                  </a:cubicBezTo>
                  <a:cubicBezTo>
                    <a:pt x="6204" y="2797"/>
                    <a:pt x="3589" y="182"/>
                    <a:pt x="362" y="182"/>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5" name="フリーフォーム: 図形 144">
              <a:extLst>
                <a:ext uri="{FF2B5EF4-FFF2-40B4-BE49-F238E27FC236}">
                  <a16:creationId xmlns:a16="http://schemas.microsoft.com/office/drawing/2014/main" id="{166B4325-5143-9E01-DFE4-7B4194ED1D32}"/>
                </a:ext>
              </a:extLst>
            </p:cNvPr>
            <p:cNvSpPr/>
            <p:nvPr/>
          </p:nvSpPr>
          <p:spPr>
            <a:xfrm rot="11047376">
              <a:off x="5327095" y="4766078"/>
              <a:ext cx="51407" cy="25703"/>
            </a:xfrm>
            <a:custGeom>
              <a:avLst/>
              <a:gdLst>
                <a:gd name="csX0" fmla="*/ 319 w 51407"/>
                <a:gd name="csY0" fmla="*/ 179 h 25703"/>
                <a:gd name="csX1" fmla="*/ 51727 w 51407"/>
                <a:gd name="csY1" fmla="*/ 13031 h 25703"/>
                <a:gd name="csX2" fmla="*/ 319 w 51407"/>
                <a:gd name="csY2" fmla="*/ 25883 h 25703"/>
              </a:gdLst>
              <a:ahLst/>
              <a:cxnLst>
                <a:cxn ang="0">
                  <a:pos x="csX0" y="csY0"/>
                </a:cxn>
                <a:cxn ang="0">
                  <a:pos x="csX1" y="csY1"/>
                </a:cxn>
                <a:cxn ang="0">
                  <a:pos x="csX2" y="csY2"/>
                </a:cxn>
              </a:cxnLst>
              <a:rect l="l" t="t" r="r" b="b"/>
              <a:pathLst>
                <a:path w="51407" h="25703">
                  <a:moveTo>
                    <a:pt x="319" y="179"/>
                  </a:moveTo>
                  <a:cubicBezTo>
                    <a:pt x="17455" y="8747"/>
                    <a:pt x="34591" y="13031"/>
                    <a:pt x="51727" y="13031"/>
                  </a:cubicBezTo>
                  <a:cubicBezTo>
                    <a:pt x="34591" y="13031"/>
                    <a:pt x="17455" y="17315"/>
                    <a:pt x="319" y="25883"/>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6" name="フリーフォーム: 図形 145">
              <a:extLst>
                <a:ext uri="{FF2B5EF4-FFF2-40B4-BE49-F238E27FC236}">
                  <a16:creationId xmlns:a16="http://schemas.microsoft.com/office/drawing/2014/main" id="{7A5CF5A6-021A-015E-F5F4-23677742284F}"/>
                </a:ext>
              </a:extLst>
            </p:cNvPr>
            <p:cNvSpPr/>
            <p:nvPr/>
          </p:nvSpPr>
          <p:spPr>
            <a:xfrm>
              <a:off x="5681719" y="4550213"/>
              <a:ext cx="135441" cy="204555"/>
            </a:xfrm>
            <a:custGeom>
              <a:avLst/>
              <a:gdLst>
                <a:gd name="csX0" fmla="*/ -5328 w 135441"/>
                <a:gd name="csY0" fmla="*/ 204928 h 204555"/>
                <a:gd name="csX1" fmla="*/ 130114 w 135441"/>
                <a:gd name="csY1" fmla="*/ 372 h 204555"/>
              </a:gdLst>
              <a:ahLst/>
              <a:cxnLst>
                <a:cxn ang="0">
                  <a:pos x="csX0" y="csY0"/>
                </a:cxn>
                <a:cxn ang="0">
                  <a:pos x="csX1" y="csY1"/>
                </a:cxn>
              </a:cxnLst>
              <a:rect l="l" t="t" r="r" b="b"/>
              <a:pathLst>
                <a:path w="135441" h="204555">
                  <a:moveTo>
                    <a:pt x="-5328" y="204928"/>
                  </a:moveTo>
                  <a:lnTo>
                    <a:pt x="130114" y="372"/>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7" name="フリーフォーム: 図形 146">
              <a:extLst>
                <a:ext uri="{FF2B5EF4-FFF2-40B4-BE49-F238E27FC236}">
                  <a16:creationId xmlns:a16="http://schemas.microsoft.com/office/drawing/2014/main" id="{79D36AAB-2AA3-B6CE-0822-0DB95662C4E5}"/>
                </a:ext>
              </a:extLst>
            </p:cNvPr>
            <p:cNvSpPr/>
            <p:nvPr/>
          </p:nvSpPr>
          <p:spPr>
            <a:xfrm rot="7410570">
              <a:off x="5677186" y="4751363"/>
              <a:ext cx="5841" cy="11683"/>
            </a:xfrm>
            <a:custGeom>
              <a:avLst/>
              <a:gdLst>
                <a:gd name="csX0" fmla="*/ 381 w 5841"/>
                <a:gd name="csY0" fmla="*/ 11858 h 11683"/>
                <a:gd name="csX1" fmla="*/ 6223 w 5841"/>
                <a:gd name="csY1" fmla="*/ 6016 h 11683"/>
                <a:gd name="csX2" fmla="*/ 381 w 5841"/>
                <a:gd name="csY2" fmla="*/ 175 h 11683"/>
              </a:gdLst>
              <a:ahLst/>
              <a:cxnLst>
                <a:cxn ang="0">
                  <a:pos x="csX0" y="csY0"/>
                </a:cxn>
                <a:cxn ang="0">
                  <a:pos x="csX1" y="csY1"/>
                </a:cxn>
                <a:cxn ang="0">
                  <a:pos x="csX2" y="csY2"/>
                </a:cxn>
              </a:cxnLst>
              <a:rect l="l" t="t" r="r" b="b"/>
              <a:pathLst>
                <a:path w="5841" h="11683">
                  <a:moveTo>
                    <a:pt x="381" y="11858"/>
                  </a:moveTo>
                  <a:cubicBezTo>
                    <a:pt x="3607" y="11858"/>
                    <a:pt x="6223" y="9243"/>
                    <a:pt x="6223" y="6016"/>
                  </a:cubicBezTo>
                  <a:cubicBezTo>
                    <a:pt x="6223" y="2790"/>
                    <a:pt x="3607" y="175"/>
                    <a:pt x="381" y="175"/>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8" name="フリーフォーム: 図形 147">
              <a:extLst>
                <a:ext uri="{FF2B5EF4-FFF2-40B4-BE49-F238E27FC236}">
                  <a16:creationId xmlns:a16="http://schemas.microsoft.com/office/drawing/2014/main" id="{F99D21ED-F1A7-3AD6-EA17-313916ACAE09}"/>
                </a:ext>
              </a:extLst>
            </p:cNvPr>
            <p:cNvSpPr/>
            <p:nvPr/>
          </p:nvSpPr>
          <p:spPr>
            <a:xfrm rot="18210570">
              <a:off x="5805647" y="4515930"/>
              <a:ext cx="51407" cy="25703"/>
            </a:xfrm>
            <a:custGeom>
              <a:avLst/>
              <a:gdLst>
                <a:gd name="csX0" fmla="*/ 412 w 51407"/>
                <a:gd name="csY0" fmla="*/ 131 h 25703"/>
                <a:gd name="csX1" fmla="*/ 51819 w 51407"/>
                <a:gd name="csY1" fmla="*/ 12982 h 25703"/>
                <a:gd name="csX2" fmla="*/ 412 w 51407"/>
                <a:gd name="csY2" fmla="*/ 25834 h 25703"/>
              </a:gdLst>
              <a:ahLst/>
              <a:cxnLst>
                <a:cxn ang="0">
                  <a:pos x="csX0" y="csY0"/>
                </a:cxn>
                <a:cxn ang="0">
                  <a:pos x="csX1" y="csY1"/>
                </a:cxn>
                <a:cxn ang="0">
                  <a:pos x="csX2" y="csY2"/>
                </a:cxn>
              </a:cxnLst>
              <a:rect l="l" t="t" r="r" b="b"/>
              <a:pathLst>
                <a:path w="51407" h="25703">
                  <a:moveTo>
                    <a:pt x="412" y="131"/>
                  </a:moveTo>
                  <a:cubicBezTo>
                    <a:pt x="17547" y="8698"/>
                    <a:pt x="34683" y="12982"/>
                    <a:pt x="51819" y="12982"/>
                  </a:cubicBezTo>
                  <a:cubicBezTo>
                    <a:pt x="34683" y="12982"/>
                    <a:pt x="17547" y="17266"/>
                    <a:pt x="412" y="25834"/>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49" name="フリーフォーム: 図形 148">
              <a:extLst>
                <a:ext uri="{FF2B5EF4-FFF2-40B4-BE49-F238E27FC236}">
                  <a16:creationId xmlns:a16="http://schemas.microsoft.com/office/drawing/2014/main" id="{BDDFE7F5-0798-61B0-DD2B-C22E7BC21901}"/>
                </a:ext>
              </a:extLst>
            </p:cNvPr>
            <p:cNvSpPr/>
            <p:nvPr/>
          </p:nvSpPr>
          <p:spPr>
            <a:xfrm>
              <a:off x="5191867" y="4525961"/>
              <a:ext cx="54132" cy="45505"/>
            </a:xfrm>
            <a:custGeom>
              <a:avLst/>
              <a:gdLst>
                <a:gd name="csX0" fmla="*/ 48929 w 54132"/>
                <a:gd name="csY0" fmla="*/ 45902 h 45505"/>
                <a:gd name="csX1" fmla="*/ -5203 w 54132"/>
                <a:gd name="csY1" fmla="*/ 396 h 45505"/>
              </a:gdLst>
              <a:ahLst/>
              <a:cxnLst>
                <a:cxn ang="0">
                  <a:pos x="csX0" y="csY0"/>
                </a:cxn>
                <a:cxn ang="0">
                  <a:pos x="csX1" y="csY1"/>
                </a:cxn>
              </a:cxnLst>
              <a:rect l="l" t="t" r="r" b="b"/>
              <a:pathLst>
                <a:path w="54132" h="45505">
                  <a:moveTo>
                    <a:pt x="48929" y="45902"/>
                  </a:moveTo>
                  <a:lnTo>
                    <a:pt x="-5203" y="396"/>
                  </a:lnTo>
                </a:path>
              </a:pathLst>
            </a:custGeom>
            <a:noFill/>
            <a:ln w="9335"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0" name="フリーフォーム: 図形 149">
              <a:extLst>
                <a:ext uri="{FF2B5EF4-FFF2-40B4-BE49-F238E27FC236}">
                  <a16:creationId xmlns:a16="http://schemas.microsoft.com/office/drawing/2014/main" id="{088056A2-B4E8-067A-7224-C0C244770420}"/>
                </a:ext>
              </a:extLst>
            </p:cNvPr>
            <p:cNvSpPr/>
            <p:nvPr/>
          </p:nvSpPr>
          <p:spPr>
            <a:xfrm>
              <a:off x="5648235" y="4604223"/>
              <a:ext cx="2001" cy="121523"/>
            </a:xfrm>
            <a:custGeom>
              <a:avLst/>
              <a:gdLst>
                <a:gd name="csX0" fmla="*/ -3303 w 2001"/>
                <a:gd name="csY0" fmla="*/ 121892 h 121523"/>
                <a:gd name="csX1" fmla="*/ -5304 w 2001"/>
                <a:gd name="csY1" fmla="*/ 369 h 121523"/>
              </a:gdLst>
              <a:ahLst/>
              <a:cxnLst>
                <a:cxn ang="0">
                  <a:pos x="csX0" y="csY0"/>
                </a:cxn>
                <a:cxn ang="0">
                  <a:pos x="csX1" y="csY1"/>
                </a:cxn>
              </a:cxnLst>
              <a:rect l="l" t="t" r="r" b="b"/>
              <a:pathLst>
                <a:path w="2001" h="121523">
                  <a:moveTo>
                    <a:pt x="-3303" y="121892"/>
                  </a:moveTo>
                  <a:lnTo>
                    <a:pt x="-5304" y="369"/>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1" name="フリーフォーム: 図形 150">
              <a:extLst>
                <a:ext uri="{FF2B5EF4-FFF2-40B4-BE49-F238E27FC236}">
                  <a16:creationId xmlns:a16="http://schemas.microsoft.com/office/drawing/2014/main" id="{EE893373-A948-EF88-DA25-5990166DFB68}"/>
                </a:ext>
              </a:extLst>
            </p:cNvPr>
            <p:cNvSpPr/>
            <p:nvPr/>
          </p:nvSpPr>
          <p:spPr>
            <a:xfrm rot="5343390">
              <a:off x="5647364" y="4722825"/>
              <a:ext cx="5841" cy="11683"/>
            </a:xfrm>
            <a:custGeom>
              <a:avLst/>
              <a:gdLst>
                <a:gd name="csX0" fmla="*/ 375 w 5841"/>
                <a:gd name="csY0" fmla="*/ 11853 h 11683"/>
                <a:gd name="csX1" fmla="*/ 6217 w 5841"/>
                <a:gd name="csY1" fmla="*/ 6011 h 11683"/>
                <a:gd name="csX2" fmla="*/ 375 w 5841"/>
                <a:gd name="csY2" fmla="*/ 169 h 11683"/>
              </a:gdLst>
              <a:ahLst/>
              <a:cxnLst>
                <a:cxn ang="0">
                  <a:pos x="csX0" y="csY0"/>
                </a:cxn>
                <a:cxn ang="0">
                  <a:pos x="csX1" y="csY1"/>
                </a:cxn>
                <a:cxn ang="0">
                  <a:pos x="csX2" y="csY2"/>
                </a:cxn>
              </a:cxnLst>
              <a:rect l="l" t="t" r="r" b="b"/>
              <a:pathLst>
                <a:path w="5841" h="11683">
                  <a:moveTo>
                    <a:pt x="375" y="11853"/>
                  </a:moveTo>
                  <a:cubicBezTo>
                    <a:pt x="3602" y="11853"/>
                    <a:pt x="6217" y="9237"/>
                    <a:pt x="6217" y="6011"/>
                  </a:cubicBezTo>
                  <a:cubicBezTo>
                    <a:pt x="6217" y="2785"/>
                    <a:pt x="3602" y="169"/>
                    <a:pt x="375" y="169"/>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2" name="フリーフォーム: 図形 151">
              <a:extLst>
                <a:ext uri="{FF2B5EF4-FFF2-40B4-BE49-F238E27FC236}">
                  <a16:creationId xmlns:a16="http://schemas.microsoft.com/office/drawing/2014/main" id="{8E78CA25-1DB3-18E1-2025-E9275DBC0DDF}"/>
                </a:ext>
              </a:extLst>
            </p:cNvPr>
            <p:cNvSpPr/>
            <p:nvPr/>
          </p:nvSpPr>
          <p:spPr>
            <a:xfrm rot="16143390">
              <a:off x="5622108" y="4565671"/>
              <a:ext cx="51407" cy="25703"/>
            </a:xfrm>
            <a:custGeom>
              <a:avLst/>
              <a:gdLst>
                <a:gd name="csX0" fmla="*/ 376 w 51407"/>
                <a:gd name="csY0" fmla="*/ 140 h 25703"/>
                <a:gd name="csX1" fmla="*/ 51784 w 51407"/>
                <a:gd name="csY1" fmla="*/ 12992 h 25703"/>
                <a:gd name="csX2" fmla="*/ 376 w 51407"/>
                <a:gd name="csY2" fmla="*/ 25844 h 25703"/>
              </a:gdLst>
              <a:ahLst/>
              <a:cxnLst>
                <a:cxn ang="0">
                  <a:pos x="csX0" y="csY0"/>
                </a:cxn>
                <a:cxn ang="0">
                  <a:pos x="csX1" y="csY1"/>
                </a:cxn>
                <a:cxn ang="0">
                  <a:pos x="csX2" y="csY2"/>
                </a:cxn>
              </a:cxnLst>
              <a:rect l="l" t="t" r="r" b="b"/>
              <a:pathLst>
                <a:path w="51407" h="25703">
                  <a:moveTo>
                    <a:pt x="376" y="140"/>
                  </a:moveTo>
                  <a:cubicBezTo>
                    <a:pt x="17512" y="8708"/>
                    <a:pt x="34648" y="12992"/>
                    <a:pt x="51784" y="12992"/>
                  </a:cubicBezTo>
                  <a:cubicBezTo>
                    <a:pt x="34648" y="12992"/>
                    <a:pt x="17512" y="17276"/>
                    <a:pt x="376" y="25844"/>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3" name="フリーフォーム: 図形 152">
              <a:extLst>
                <a:ext uri="{FF2B5EF4-FFF2-40B4-BE49-F238E27FC236}">
                  <a16:creationId xmlns:a16="http://schemas.microsoft.com/office/drawing/2014/main" id="{278A422A-F0A3-A931-B7A1-DE7A727BEB78}"/>
                </a:ext>
              </a:extLst>
            </p:cNvPr>
            <p:cNvSpPr/>
            <p:nvPr/>
          </p:nvSpPr>
          <p:spPr>
            <a:xfrm rot="673198" flipH="1">
              <a:off x="5223893" y="4302304"/>
              <a:ext cx="180208" cy="154581"/>
            </a:xfrm>
            <a:custGeom>
              <a:avLst/>
              <a:gdLst>
                <a:gd name="csX0" fmla="*/ -5279 w 75424"/>
                <a:gd name="csY0" fmla="*/ 15467 h 15060"/>
                <a:gd name="csX1" fmla="*/ 70146 w 75424"/>
                <a:gd name="csY1" fmla="*/ 407 h 15060"/>
              </a:gdLst>
              <a:ahLst/>
              <a:cxnLst>
                <a:cxn ang="0">
                  <a:pos x="csX0" y="csY0"/>
                </a:cxn>
                <a:cxn ang="0">
                  <a:pos x="csX1" y="csY1"/>
                </a:cxn>
              </a:cxnLst>
              <a:rect l="l" t="t" r="r" b="b"/>
              <a:pathLst>
                <a:path w="75424" h="15060">
                  <a:moveTo>
                    <a:pt x="-5279" y="15467"/>
                  </a:moveTo>
                  <a:lnTo>
                    <a:pt x="70146" y="407"/>
                  </a:lnTo>
                </a:path>
              </a:pathLst>
            </a:custGeom>
            <a:noFill/>
            <a:ln w="9335"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4" name="フリーフォーム: 図形 153">
              <a:extLst>
                <a:ext uri="{FF2B5EF4-FFF2-40B4-BE49-F238E27FC236}">
                  <a16:creationId xmlns:a16="http://schemas.microsoft.com/office/drawing/2014/main" id="{F3A047FE-893E-0AEA-DB51-8969BF303025}"/>
                </a:ext>
              </a:extLst>
            </p:cNvPr>
            <p:cNvSpPr/>
            <p:nvPr/>
          </p:nvSpPr>
          <p:spPr>
            <a:xfrm>
              <a:off x="5619676" y="4871050"/>
              <a:ext cx="36000" cy="180000"/>
            </a:xfrm>
            <a:custGeom>
              <a:avLst/>
              <a:gdLst>
                <a:gd name="csX0" fmla="*/ 8308 w 13609"/>
                <a:gd name="csY0" fmla="*/ 308 h 114136"/>
                <a:gd name="csX1" fmla="*/ -5301 w 13609"/>
                <a:gd name="csY1" fmla="*/ 114444 h 114136"/>
              </a:gdLst>
              <a:ahLst/>
              <a:cxnLst>
                <a:cxn ang="0">
                  <a:pos x="csX0" y="csY0"/>
                </a:cxn>
                <a:cxn ang="0">
                  <a:pos x="csX1" y="csY1"/>
                </a:cxn>
              </a:cxnLst>
              <a:rect l="l" t="t" r="r" b="b"/>
              <a:pathLst>
                <a:path w="13609" h="114136">
                  <a:moveTo>
                    <a:pt x="8308" y="308"/>
                  </a:moveTo>
                  <a:lnTo>
                    <a:pt x="-5301" y="114444"/>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5" name="フリーフォーム: 図形 154">
              <a:extLst>
                <a:ext uri="{FF2B5EF4-FFF2-40B4-BE49-F238E27FC236}">
                  <a16:creationId xmlns:a16="http://schemas.microsoft.com/office/drawing/2014/main" id="{E88FB10F-4120-9FEF-B584-A3748A99255C}"/>
                </a:ext>
              </a:extLst>
            </p:cNvPr>
            <p:cNvSpPr/>
            <p:nvPr/>
          </p:nvSpPr>
          <p:spPr>
            <a:xfrm rot="6162718">
              <a:off x="5575406" y="5041627"/>
              <a:ext cx="54000" cy="36000"/>
            </a:xfrm>
            <a:custGeom>
              <a:avLst/>
              <a:gdLst>
                <a:gd name="csX0" fmla="*/ 372 w 51407"/>
                <a:gd name="csY0" fmla="*/ 223 h 25703"/>
                <a:gd name="csX1" fmla="*/ 51779 w 51407"/>
                <a:gd name="csY1" fmla="*/ 13075 h 25703"/>
                <a:gd name="csX2" fmla="*/ 372 w 51407"/>
                <a:gd name="csY2" fmla="*/ 25927 h 25703"/>
              </a:gdLst>
              <a:ahLst/>
              <a:cxnLst>
                <a:cxn ang="0">
                  <a:pos x="csX0" y="csY0"/>
                </a:cxn>
                <a:cxn ang="0">
                  <a:pos x="csX1" y="csY1"/>
                </a:cxn>
                <a:cxn ang="0">
                  <a:pos x="csX2" y="csY2"/>
                </a:cxn>
              </a:cxnLst>
              <a:rect l="l" t="t" r="r" b="b"/>
              <a:pathLst>
                <a:path w="51407" h="25703">
                  <a:moveTo>
                    <a:pt x="372" y="223"/>
                  </a:moveTo>
                  <a:cubicBezTo>
                    <a:pt x="17508" y="8791"/>
                    <a:pt x="34644" y="13075"/>
                    <a:pt x="51779" y="13075"/>
                  </a:cubicBezTo>
                  <a:cubicBezTo>
                    <a:pt x="34644" y="13075"/>
                    <a:pt x="17508" y="17359"/>
                    <a:pt x="372" y="25927"/>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6" name="フリーフォーム: 図形 155">
              <a:extLst>
                <a:ext uri="{FF2B5EF4-FFF2-40B4-BE49-F238E27FC236}">
                  <a16:creationId xmlns:a16="http://schemas.microsoft.com/office/drawing/2014/main" id="{1BB7AADF-1DB7-5AC2-FBC3-E938693EF11B}"/>
                </a:ext>
              </a:extLst>
            </p:cNvPr>
            <p:cNvSpPr/>
            <p:nvPr/>
          </p:nvSpPr>
          <p:spPr>
            <a:xfrm>
              <a:off x="5383855" y="4821560"/>
              <a:ext cx="212769" cy="81867"/>
            </a:xfrm>
            <a:custGeom>
              <a:avLst/>
              <a:gdLst>
                <a:gd name="csX0" fmla="*/ 207503 w 212769"/>
                <a:gd name="csY0" fmla="*/ 322 h 81867"/>
                <a:gd name="csX1" fmla="*/ -5267 w 212769"/>
                <a:gd name="csY1" fmla="*/ 82190 h 81867"/>
              </a:gdLst>
              <a:ahLst/>
              <a:cxnLst>
                <a:cxn ang="0">
                  <a:pos x="csX0" y="csY0"/>
                </a:cxn>
                <a:cxn ang="0">
                  <a:pos x="csX1" y="csY1"/>
                </a:cxn>
              </a:cxnLst>
              <a:rect l="l" t="t" r="r" b="b"/>
              <a:pathLst>
                <a:path w="212769" h="81867">
                  <a:moveTo>
                    <a:pt x="207503" y="322"/>
                  </a:moveTo>
                  <a:lnTo>
                    <a:pt x="-5267" y="82190"/>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7" name="フリーフォーム: 図形 156">
              <a:extLst>
                <a:ext uri="{FF2B5EF4-FFF2-40B4-BE49-F238E27FC236}">
                  <a16:creationId xmlns:a16="http://schemas.microsoft.com/office/drawing/2014/main" id="{1BFFF323-ADD6-D4D7-145D-0FE349E7AA08}"/>
                </a:ext>
              </a:extLst>
            </p:cNvPr>
            <p:cNvSpPr/>
            <p:nvPr/>
          </p:nvSpPr>
          <p:spPr>
            <a:xfrm rot="20337282">
              <a:off x="5596430" y="4814670"/>
              <a:ext cx="5841" cy="11683"/>
            </a:xfrm>
            <a:custGeom>
              <a:avLst/>
              <a:gdLst>
                <a:gd name="csX0" fmla="*/ 366 w 5841"/>
                <a:gd name="csY0" fmla="*/ 11870 h 11683"/>
                <a:gd name="csX1" fmla="*/ 6207 w 5841"/>
                <a:gd name="csY1" fmla="*/ 6029 h 11683"/>
                <a:gd name="csX2" fmla="*/ 366 w 5841"/>
                <a:gd name="csY2" fmla="*/ 187 h 11683"/>
              </a:gdLst>
              <a:ahLst/>
              <a:cxnLst>
                <a:cxn ang="0">
                  <a:pos x="csX0" y="csY0"/>
                </a:cxn>
                <a:cxn ang="0">
                  <a:pos x="csX1" y="csY1"/>
                </a:cxn>
                <a:cxn ang="0">
                  <a:pos x="csX2" y="csY2"/>
                </a:cxn>
              </a:cxnLst>
              <a:rect l="l" t="t" r="r" b="b"/>
              <a:pathLst>
                <a:path w="5841" h="11683">
                  <a:moveTo>
                    <a:pt x="366" y="11870"/>
                  </a:moveTo>
                  <a:cubicBezTo>
                    <a:pt x="3592" y="11870"/>
                    <a:pt x="6207" y="9255"/>
                    <a:pt x="6207" y="6029"/>
                  </a:cubicBezTo>
                  <a:cubicBezTo>
                    <a:pt x="6207" y="2802"/>
                    <a:pt x="3592" y="187"/>
                    <a:pt x="366" y="187"/>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8" name="フリーフォーム: 図形 157">
              <a:extLst>
                <a:ext uri="{FF2B5EF4-FFF2-40B4-BE49-F238E27FC236}">
                  <a16:creationId xmlns:a16="http://schemas.microsoft.com/office/drawing/2014/main" id="{1FC61F3A-CE9E-5B8F-2664-83917CBE8E80}"/>
                </a:ext>
              </a:extLst>
            </p:cNvPr>
            <p:cNvSpPr/>
            <p:nvPr/>
          </p:nvSpPr>
          <p:spPr>
            <a:xfrm rot="9537282">
              <a:off x="5334162" y="4899807"/>
              <a:ext cx="51407" cy="25703"/>
            </a:xfrm>
            <a:custGeom>
              <a:avLst/>
              <a:gdLst>
                <a:gd name="csX0" fmla="*/ 321 w 51407"/>
                <a:gd name="csY0" fmla="*/ 205 h 25703"/>
                <a:gd name="csX1" fmla="*/ 51728 w 51407"/>
                <a:gd name="csY1" fmla="*/ 13056 h 25703"/>
                <a:gd name="csX2" fmla="*/ 321 w 51407"/>
                <a:gd name="csY2" fmla="*/ 25908 h 25703"/>
              </a:gdLst>
              <a:ahLst/>
              <a:cxnLst>
                <a:cxn ang="0">
                  <a:pos x="csX0" y="csY0"/>
                </a:cxn>
                <a:cxn ang="0">
                  <a:pos x="csX1" y="csY1"/>
                </a:cxn>
                <a:cxn ang="0">
                  <a:pos x="csX2" y="csY2"/>
                </a:cxn>
              </a:cxnLst>
              <a:rect l="l" t="t" r="r" b="b"/>
              <a:pathLst>
                <a:path w="51407" h="25703">
                  <a:moveTo>
                    <a:pt x="321" y="205"/>
                  </a:moveTo>
                  <a:cubicBezTo>
                    <a:pt x="17456" y="8773"/>
                    <a:pt x="34592" y="13056"/>
                    <a:pt x="51728" y="13056"/>
                  </a:cubicBezTo>
                  <a:cubicBezTo>
                    <a:pt x="34592" y="13056"/>
                    <a:pt x="17456" y="17340"/>
                    <a:pt x="321" y="25908"/>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59" name="フリーフォーム: 図形 158">
              <a:extLst>
                <a:ext uri="{FF2B5EF4-FFF2-40B4-BE49-F238E27FC236}">
                  <a16:creationId xmlns:a16="http://schemas.microsoft.com/office/drawing/2014/main" id="{D8B17687-EE88-4512-DE6F-8124F439274C}"/>
                </a:ext>
              </a:extLst>
            </p:cNvPr>
            <p:cNvSpPr/>
            <p:nvPr/>
          </p:nvSpPr>
          <p:spPr>
            <a:xfrm>
              <a:off x="5326890" y="4988641"/>
              <a:ext cx="48233" cy="35532"/>
            </a:xfrm>
            <a:custGeom>
              <a:avLst/>
              <a:gdLst>
                <a:gd name="csX0" fmla="*/ -5234 w 48233"/>
                <a:gd name="csY0" fmla="*/ 289 h 35532"/>
                <a:gd name="csX1" fmla="*/ 42999 w 48233"/>
                <a:gd name="csY1" fmla="*/ 35821 h 35532"/>
              </a:gdLst>
              <a:ahLst/>
              <a:cxnLst>
                <a:cxn ang="0">
                  <a:pos x="csX0" y="csY0"/>
                </a:cxn>
                <a:cxn ang="0">
                  <a:pos x="csX1" y="csY1"/>
                </a:cxn>
              </a:cxnLst>
              <a:rect l="l" t="t" r="r" b="b"/>
              <a:pathLst>
                <a:path w="48233" h="35532">
                  <a:moveTo>
                    <a:pt x="-5234" y="289"/>
                  </a:moveTo>
                  <a:lnTo>
                    <a:pt x="42999" y="35821"/>
                  </a:lnTo>
                </a:path>
              </a:pathLst>
            </a:custGeom>
            <a:noFill/>
            <a:ln w="9335"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0" name="フリーフォーム: 図形 159">
              <a:extLst>
                <a:ext uri="{FF2B5EF4-FFF2-40B4-BE49-F238E27FC236}">
                  <a16:creationId xmlns:a16="http://schemas.microsoft.com/office/drawing/2014/main" id="{AFCE01D4-F544-1E90-8824-1CAB349FDEB7}"/>
                </a:ext>
              </a:extLst>
            </p:cNvPr>
            <p:cNvSpPr/>
            <p:nvPr/>
          </p:nvSpPr>
          <p:spPr>
            <a:xfrm>
              <a:off x="5830350" y="5251287"/>
              <a:ext cx="130695" cy="58236"/>
            </a:xfrm>
            <a:custGeom>
              <a:avLst/>
              <a:gdLst>
                <a:gd name="csX0" fmla="*/ -5362 w 130695"/>
                <a:gd name="csY0" fmla="*/ 224 h 58236"/>
                <a:gd name="csX1" fmla="*/ 125333 w 130695"/>
                <a:gd name="csY1" fmla="*/ 58460 h 58236"/>
              </a:gdLst>
              <a:ahLst/>
              <a:cxnLst>
                <a:cxn ang="0">
                  <a:pos x="csX0" y="csY0"/>
                </a:cxn>
                <a:cxn ang="0">
                  <a:pos x="csX1" y="csY1"/>
                </a:cxn>
              </a:cxnLst>
              <a:rect l="l" t="t" r="r" b="b"/>
              <a:pathLst>
                <a:path w="130695" h="58236">
                  <a:moveTo>
                    <a:pt x="-5362" y="224"/>
                  </a:moveTo>
                  <a:lnTo>
                    <a:pt x="125333" y="58460"/>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1" name="フリーフォーム: 図形 160">
              <a:extLst>
                <a:ext uri="{FF2B5EF4-FFF2-40B4-BE49-F238E27FC236}">
                  <a16:creationId xmlns:a16="http://schemas.microsoft.com/office/drawing/2014/main" id="{D4E7A4A2-79BA-75FD-4BCD-0CA727E9C3A8}"/>
                </a:ext>
              </a:extLst>
            </p:cNvPr>
            <p:cNvSpPr/>
            <p:nvPr/>
          </p:nvSpPr>
          <p:spPr>
            <a:xfrm rot="12241030">
              <a:off x="5824762" y="5244256"/>
              <a:ext cx="5841" cy="11683"/>
            </a:xfrm>
            <a:custGeom>
              <a:avLst/>
              <a:gdLst>
                <a:gd name="csX0" fmla="*/ 410 w 5841"/>
                <a:gd name="csY0" fmla="*/ 11953 h 11683"/>
                <a:gd name="csX1" fmla="*/ 6251 w 5841"/>
                <a:gd name="csY1" fmla="*/ 6111 h 11683"/>
                <a:gd name="csX2" fmla="*/ 410 w 5841"/>
                <a:gd name="csY2" fmla="*/ 270 h 11683"/>
              </a:gdLst>
              <a:ahLst/>
              <a:cxnLst>
                <a:cxn ang="0">
                  <a:pos x="csX0" y="csY0"/>
                </a:cxn>
                <a:cxn ang="0">
                  <a:pos x="csX1" y="csY1"/>
                </a:cxn>
                <a:cxn ang="0">
                  <a:pos x="csX2" y="csY2"/>
                </a:cxn>
              </a:cxnLst>
              <a:rect l="l" t="t" r="r" b="b"/>
              <a:pathLst>
                <a:path w="5841" h="11683">
                  <a:moveTo>
                    <a:pt x="410" y="11953"/>
                  </a:moveTo>
                  <a:cubicBezTo>
                    <a:pt x="3636" y="11953"/>
                    <a:pt x="6251" y="9338"/>
                    <a:pt x="6251" y="6111"/>
                  </a:cubicBezTo>
                  <a:cubicBezTo>
                    <a:pt x="6251" y="2885"/>
                    <a:pt x="3636" y="270"/>
                    <a:pt x="410" y="270"/>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2" name="フリーフォーム: 図形 161">
              <a:extLst>
                <a:ext uri="{FF2B5EF4-FFF2-40B4-BE49-F238E27FC236}">
                  <a16:creationId xmlns:a16="http://schemas.microsoft.com/office/drawing/2014/main" id="{DE2206B1-6843-36F6-3400-72A98C691F61}"/>
                </a:ext>
              </a:extLst>
            </p:cNvPr>
            <p:cNvSpPr/>
            <p:nvPr/>
          </p:nvSpPr>
          <p:spPr>
            <a:xfrm rot="1441030">
              <a:off x="5958820" y="5307133"/>
              <a:ext cx="51407" cy="25703"/>
            </a:xfrm>
            <a:custGeom>
              <a:avLst/>
              <a:gdLst>
                <a:gd name="csX0" fmla="*/ 441 w 51407"/>
                <a:gd name="csY0" fmla="*/ 283 h 25703"/>
                <a:gd name="csX1" fmla="*/ 51848 w 51407"/>
                <a:gd name="csY1" fmla="*/ 13135 h 25703"/>
                <a:gd name="csX2" fmla="*/ 441 w 51407"/>
                <a:gd name="csY2" fmla="*/ 25987 h 25703"/>
              </a:gdLst>
              <a:ahLst/>
              <a:cxnLst>
                <a:cxn ang="0">
                  <a:pos x="csX0" y="csY0"/>
                </a:cxn>
                <a:cxn ang="0">
                  <a:pos x="csX1" y="csY1"/>
                </a:cxn>
                <a:cxn ang="0">
                  <a:pos x="csX2" y="csY2"/>
                </a:cxn>
              </a:cxnLst>
              <a:rect l="l" t="t" r="r" b="b"/>
              <a:pathLst>
                <a:path w="51407" h="25703">
                  <a:moveTo>
                    <a:pt x="441" y="283"/>
                  </a:moveTo>
                  <a:cubicBezTo>
                    <a:pt x="17577" y="8851"/>
                    <a:pt x="34713" y="13135"/>
                    <a:pt x="51848" y="13135"/>
                  </a:cubicBezTo>
                  <a:cubicBezTo>
                    <a:pt x="34713" y="13135"/>
                    <a:pt x="17577" y="17419"/>
                    <a:pt x="441" y="25987"/>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3" name="フリーフォーム: 図形 162">
              <a:extLst>
                <a:ext uri="{FF2B5EF4-FFF2-40B4-BE49-F238E27FC236}">
                  <a16:creationId xmlns:a16="http://schemas.microsoft.com/office/drawing/2014/main" id="{D7CEA4A0-9EAA-B5E7-C4B4-5A4065E331B2}"/>
                </a:ext>
              </a:extLst>
            </p:cNvPr>
            <p:cNvSpPr/>
            <p:nvPr/>
          </p:nvSpPr>
          <p:spPr>
            <a:xfrm>
              <a:off x="5407345" y="4672860"/>
              <a:ext cx="194247" cy="101530"/>
            </a:xfrm>
            <a:custGeom>
              <a:avLst/>
              <a:gdLst>
                <a:gd name="csX0" fmla="*/ 188977 w 194247"/>
                <a:gd name="csY0" fmla="*/ 101885 h 101530"/>
                <a:gd name="csX1" fmla="*/ -5270 w 194247"/>
                <a:gd name="csY1" fmla="*/ 355 h 101530"/>
              </a:gdLst>
              <a:ahLst/>
              <a:cxnLst>
                <a:cxn ang="0">
                  <a:pos x="csX0" y="csY0"/>
                </a:cxn>
                <a:cxn ang="0">
                  <a:pos x="csX1" y="csY1"/>
                </a:cxn>
              </a:cxnLst>
              <a:rect l="l" t="t" r="r" b="b"/>
              <a:pathLst>
                <a:path w="194247" h="101530">
                  <a:moveTo>
                    <a:pt x="188977" y="101885"/>
                  </a:moveTo>
                  <a:lnTo>
                    <a:pt x="-5270" y="355"/>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4" name="フリーフォーム: 図形 163">
              <a:extLst>
                <a:ext uri="{FF2B5EF4-FFF2-40B4-BE49-F238E27FC236}">
                  <a16:creationId xmlns:a16="http://schemas.microsoft.com/office/drawing/2014/main" id="{1E9868C1-2DE9-6AF1-8B2E-721FA890847D}"/>
                </a:ext>
              </a:extLst>
            </p:cNvPr>
            <p:cNvSpPr/>
            <p:nvPr/>
          </p:nvSpPr>
          <p:spPr>
            <a:xfrm rot="1655732">
              <a:off x="5601260" y="4769902"/>
              <a:ext cx="5841" cy="11683"/>
            </a:xfrm>
            <a:custGeom>
              <a:avLst/>
              <a:gdLst>
                <a:gd name="csX0" fmla="*/ 366 w 5841"/>
                <a:gd name="csY0" fmla="*/ 11862 h 11683"/>
                <a:gd name="csX1" fmla="*/ 6208 w 5841"/>
                <a:gd name="csY1" fmla="*/ 6020 h 11683"/>
                <a:gd name="csX2" fmla="*/ 366 w 5841"/>
                <a:gd name="csY2" fmla="*/ 178 h 11683"/>
              </a:gdLst>
              <a:ahLst/>
              <a:cxnLst>
                <a:cxn ang="0">
                  <a:pos x="csX0" y="csY0"/>
                </a:cxn>
                <a:cxn ang="0">
                  <a:pos x="csX1" y="csY1"/>
                </a:cxn>
                <a:cxn ang="0">
                  <a:pos x="csX2" y="csY2"/>
                </a:cxn>
              </a:cxnLst>
              <a:rect l="l" t="t" r="r" b="b"/>
              <a:pathLst>
                <a:path w="5841" h="11683">
                  <a:moveTo>
                    <a:pt x="366" y="11862"/>
                  </a:moveTo>
                  <a:cubicBezTo>
                    <a:pt x="3593" y="11862"/>
                    <a:pt x="6208" y="9246"/>
                    <a:pt x="6208" y="6020"/>
                  </a:cubicBezTo>
                  <a:cubicBezTo>
                    <a:pt x="6208" y="2794"/>
                    <a:pt x="3593" y="178"/>
                    <a:pt x="366" y="178"/>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5" name="フリーフォーム: 図形 164">
              <a:extLst>
                <a:ext uri="{FF2B5EF4-FFF2-40B4-BE49-F238E27FC236}">
                  <a16:creationId xmlns:a16="http://schemas.microsoft.com/office/drawing/2014/main" id="{96AF3B74-A008-A834-295A-1CD044FAF238}"/>
                </a:ext>
              </a:extLst>
            </p:cNvPr>
            <p:cNvSpPr/>
            <p:nvPr/>
          </p:nvSpPr>
          <p:spPr>
            <a:xfrm rot="12455732">
              <a:off x="5358862" y="4648102"/>
              <a:ext cx="51407" cy="25703"/>
            </a:xfrm>
            <a:custGeom>
              <a:avLst/>
              <a:gdLst>
                <a:gd name="csX0" fmla="*/ 325 w 51407"/>
                <a:gd name="csY0" fmla="*/ 156 h 25703"/>
                <a:gd name="csX1" fmla="*/ 51733 w 51407"/>
                <a:gd name="csY1" fmla="*/ 13008 h 25703"/>
                <a:gd name="csX2" fmla="*/ 325 w 51407"/>
                <a:gd name="csY2" fmla="*/ 25860 h 25703"/>
              </a:gdLst>
              <a:ahLst/>
              <a:cxnLst>
                <a:cxn ang="0">
                  <a:pos x="csX0" y="csY0"/>
                </a:cxn>
                <a:cxn ang="0">
                  <a:pos x="csX1" y="csY1"/>
                </a:cxn>
                <a:cxn ang="0">
                  <a:pos x="csX2" y="csY2"/>
                </a:cxn>
              </a:cxnLst>
              <a:rect l="l" t="t" r="r" b="b"/>
              <a:pathLst>
                <a:path w="51407" h="25703">
                  <a:moveTo>
                    <a:pt x="325" y="156"/>
                  </a:moveTo>
                  <a:cubicBezTo>
                    <a:pt x="17461" y="8724"/>
                    <a:pt x="34597" y="13008"/>
                    <a:pt x="51733" y="13008"/>
                  </a:cubicBezTo>
                  <a:cubicBezTo>
                    <a:pt x="34597" y="13008"/>
                    <a:pt x="17461" y="17292"/>
                    <a:pt x="325" y="25860"/>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6" name="フリーフォーム: 図形 165">
              <a:extLst>
                <a:ext uri="{FF2B5EF4-FFF2-40B4-BE49-F238E27FC236}">
                  <a16:creationId xmlns:a16="http://schemas.microsoft.com/office/drawing/2014/main" id="{75BADAFF-2D68-BF04-4835-9EFDF32E21C7}"/>
                </a:ext>
              </a:extLst>
            </p:cNvPr>
            <p:cNvSpPr/>
            <p:nvPr/>
          </p:nvSpPr>
          <p:spPr>
            <a:xfrm>
              <a:off x="5714213" y="4813656"/>
              <a:ext cx="216886" cy="45614"/>
            </a:xfrm>
            <a:custGeom>
              <a:avLst/>
              <a:gdLst>
                <a:gd name="csX0" fmla="*/ -5345 w 216886"/>
                <a:gd name="csY0" fmla="*/ 329 h 45614"/>
                <a:gd name="csX1" fmla="*/ 211541 w 216886"/>
                <a:gd name="csY1" fmla="*/ 45943 h 45614"/>
              </a:gdLst>
              <a:ahLst/>
              <a:cxnLst>
                <a:cxn ang="0">
                  <a:pos x="csX0" y="csY0"/>
                </a:cxn>
                <a:cxn ang="0">
                  <a:pos x="csX1" y="csY1"/>
                </a:cxn>
              </a:cxnLst>
              <a:rect l="l" t="t" r="r" b="b"/>
              <a:pathLst>
                <a:path w="216886" h="45614">
                  <a:moveTo>
                    <a:pt x="-5345" y="329"/>
                  </a:moveTo>
                  <a:lnTo>
                    <a:pt x="211541" y="45943"/>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7" name="フリーフォーム: 図形 166">
              <a:extLst>
                <a:ext uri="{FF2B5EF4-FFF2-40B4-BE49-F238E27FC236}">
                  <a16:creationId xmlns:a16="http://schemas.microsoft.com/office/drawing/2014/main" id="{179AF8EE-C5CA-D4F1-3280-8CD37594C0BE}"/>
                </a:ext>
              </a:extLst>
            </p:cNvPr>
            <p:cNvSpPr/>
            <p:nvPr/>
          </p:nvSpPr>
          <p:spPr>
            <a:xfrm rot="11512630">
              <a:off x="5708433" y="4807213"/>
              <a:ext cx="5841" cy="11683"/>
            </a:xfrm>
            <a:custGeom>
              <a:avLst/>
              <a:gdLst>
                <a:gd name="csX0" fmla="*/ 387 w 5841"/>
                <a:gd name="csY0" fmla="*/ 11869 h 11683"/>
                <a:gd name="csX1" fmla="*/ 6229 w 5841"/>
                <a:gd name="csY1" fmla="*/ 6027 h 11683"/>
                <a:gd name="csX2" fmla="*/ 387 w 5841"/>
                <a:gd name="csY2" fmla="*/ 185 h 11683"/>
              </a:gdLst>
              <a:ahLst/>
              <a:cxnLst>
                <a:cxn ang="0">
                  <a:pos x="csX0" y="csY0"/>
                </a:cxn>
                <a:cxn ang="0">
                  <a:pos x="csX1" y="csY1"/>
                </a:cxn>
                <a:cxn ang="0">
                  <a:pos x="csX2" y="csY2"/>
                </a:cxn>
              </a:cxnLst>
              <a:rect l="l" t="t" r="r" b="b"/>
              <a:pathLst>
                <a:path w="5841" h="11683">
                  <a:moveTo>
                    <a:pt x="387" y="11869"/>
                  </a:moveTo>
                  <a:cubicBezTo>
                    <a:pt x="3613" y="11869"/>
                    <a:pt x="6229" y="9253"/>
                    <a:pt x="6229" y="6027"/>
                  </a:cubicBezTo>
                  <a:cubicBezTo>
                    <a:pt x="6229" y="2801"/>
                    <a:pt x="3613" y="185"/>
                    <a:pt x="387" y="185"/>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8" name="フリーフォーム: 図形 167">
              <a:extLst>
                <a:ext uri="{FF2B5EF4-FFF2-40B4-BE49-F238E27FC236}">
                  <a16:creationId xmlns:a16="http://schemas.microsoft.com/office/drawing/2014/main" id="{CA44ABDF-EB8F-E91E-EEF5-2423E684A661}"/>
                </a:ext>
              </a:extLst>
            </p:cNvPr>
            <p:cNvSpPr/>
            <p:nvPr/>
          </p:nvSpPr>
          <p:spPr>
            <a:xfrm rot="712630">
              <a:off x="5930548" y="4851709"/>
              <a:ext cx="51407" cy="25703"/>
            </a:xfrm>
            <a:custGeom>
              <a:avLst/>
              <a:gdLst>
                <a:gd name="csX0" fmla="*/ 436 w 51407"/>
                <a:gd name="csY0" fmla="*/ 195 h 25703"/>
                <a:gd name="csX1" fmla="*/ 51843 w 51407"/>
                <a:gd name="csY1" fmla="*/ 13047 h 25703"/>
                <a:gd name="csX2" fmla="*/ 436 w 51407"/>
                <a:gd name="csY2" fmla="*/ 25899 h 25703"/>
              </a:gdLst>
              <a:ahLst/>
              <a:cxnLst>
                <a:cxn ang="0">
                  <a:pos x="csX0" y="csY0"/>
                </a:cxn>
                <a:cxn ang="0">
                  <a:pos x="csX1" y="csY1"/>
                </a:cxn>
                <a:cxn ang="0">
                  <a:pos x="csX2" y="csY2"/>
                </a:cxn>
              </a:cxnLst>
              <a:rect l="l" t="t" r="r" b="b"/>
              <a:pathLst>
                <a:path w="51407" h="25703">
                  <a:moveTo>
                    <a:pt x="436" y="195"/>
                  </a:moveTo>
                  <a:cubicBezTo>
                    <a:pt x="17571" y="8763"/>
                    <a:pt x="34707" y="13047"/>
                    <a:pt x="51843" y="13047"/>
                  </a:cubicBezTo>
                  <a:cubicBezTo>
                    <a:pt x="34707" y="13047"/>
                    <a:pt x="17571" y="17331"/>
                    <a:pt x="436" y="25899"/>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69" name="フリーフォーム: 図形 168">
              <a:extLst>
                <a:ext uri="{FF2B5EF4-FFF2-40B4-BE49-F238E27FC236}">
                  <a16:creationId xmlns:a16="http://schemas.microsoft.com/office/drawing/2014/main" id="{52DBFDE4-1CB0-F609-D34D-707EDE4CD983}"/>
                </a:ext>
              </a:extLst>
            </p:cNvPr>
            <p:cNvSpPr/>
            <p:nvPr/>
          </p:nvSpPr>
          <p:spPr>
            <a:xfrm>
              <a:off x="5236525" y="5128745"/>
              <a:ext cx="91133" cy="55251"/>
            </a:xfrm>
            <a:custGeom>
              <a:avLst/>
              <a:gdLst>
                <a:gd name="csX0" fmla="*/ -5218 w 91133"/>
                <a:gd name="csY0" fmla="*/ 55505 h 55251"/>
                <a:gd name="csX1" fmla="*/ 85915 w 91133"/>
                <a:gd name="csY1" fmla="*/ 253 h 55251"/>
              </a:gdLst>
              <a:ahLst/>
              <a:cxnLst>
                <a:cxn ang="0">
                  <a:pos x="csX0" y="csY0"/>
                </a:cxn>
                <a:cxn ang="0">
                  <a:pos x="csX1" y="csY1"/>
                </a:cxn>
              </a:cxnLst>
              <a:rect l="l" t="t" r="r" b="b"/>
              <a:pathLst>
                <a:path w="91133" h="55251">
                  <a:moveTo>
                    <a:pt x="-5218" y="55505"/>
                  </a:moveTo>
                  <a:lnTo>
                    <a:pt x="85915" y="253"/>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0" name="フリーフォーム: 図形 169">
              <a:extLst>
                <a:ext uri="{FF2B5EF4-FFF2-40B4-BE49-F238E27FC236}">
                  <a16:creationId xmlns:a16="http://schemas.microsoft.com/office/drawing/2014/main" id="{4D22F3C5-A4A3-200E-A91A-CE2A917F65CF}"/>
                </a:ext>
              </a:extLst>
            </p:cNvPr>
            <p:cNvSpPr/>
            <p:nvPr/>
          </p:nvSpPr>
          <p:spPr>
            <a:xfrm rot="8926355">
              <a:off x="5231107" y="5179670"/>
              <a:ext cx="5841" cy="11683"/>
            </a:xfrm>
            <a:custGeom>
              <a:avLst/>
              <a:gdLst>
                <a:gd name="csX0" fmla="*/ 295 w 5841"/>
                <a:gd name="csY0" fmla="*/ 11941 h 11683"/>
                <a:gd name="csX1" fmla="*/ 6137 w 5841"/>
                <a:gd name="csY1" fmla="*/ 6099 h 11683"/>
                <a:gd name="csX2" fmla="*/ 295 w 5841"/>
                <a:gd name="csY2" fmla="*/ 257 h 11683"/>
              </a:gdLst>
              <a:ahLst/>
              <a:cxnLst>
                <a:cxn ang="0">
                  <a:pos x="csX0" y="csY0"/>
                </a:cxn>
                <a:cxn ang="0">
                  <a:pos x="csX1" y="csY1"/>
                </a:cxn>
                <a:cxn ang="0">
                  <a:pos x="csX2" y="csY2"/>
                </a:cxn>
              </a:cxnLst>
              <a:rect l="l" t="t" r="r" b="b"/>
              <a:pathLst>
                <a:path w="5841" h="11683">
                  <a:moveTo>
                    <a:pt x="295" y="11941"/>
                  </a:moveTo>
                  <a:cubicBezTo>
                    <a:pt x="3521" y="11941"/>
                    <a:pt x="6137" y="9325"/>
                    <a:pt x="6137" y="6099"/>
                  </a:cubicBezTo>
                  <a:cubicBezTo>
                    <a:pt x="6137" y="2873"/>
                    <a:pt x="3521" y="257"/>
                    <a:pt x="295" y="257"/>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1" name="フリーフォーム: 図形 170">
              <a:extLst>
                <a:ext uri="{FF2B5EF4-FFF2-40B4-BE49-F238E27FC236}">
                  <a16:creationId xmlns:a16="http://schemas.microsoft.com/office/drawing/2014/main" id="{FEF75CC1-8E7D-875D-1BB2-757D7C3C0D62}"/>
                </a:ext>
              </a:extLst>
            </p:cNvPr>
            <p:cNvSpPr/>
            <p:nvPr/>
          </p:nvSpPr>
          <p:spPr>
            <a:xfrm rot="19726355">
              <a:off x="5323935" y="5102568"/>
              <a:ext cx="51407" cy="25703"/>
            </a:xfrm>
            <a:custGeom>
              <a:avLst/>
              <a:gdLst>
                <a:gd name="csX0" fmla="*/ 319 w 51407"/>
                <a:gd name="csY0" fmla="*/ 244 h 25703"/>
                <a:gd name="csX1" fmla="*/ 51726 w 51407"/>
                <a:gd name="csY1" fmla="*/ 13096 h 25703"/>
                <a:gd name="csX2" fmla="*/ 319 w 51407"/>
                <a:gd name="csY2" fmla="*/ 25947 h 25703"/>
              </a:gdLst>
              <a:ahLst/>
              <a:cxnLst>
                <a:cxn ang="0">
                  <a:pos x="csX0" y="csY0"/>
                </a:cxn>
                <a:cxn ang="0">
                  <a:pos x="csX1" y="csY1"/>
                </a:cxn>
                <a:cxn ang="0">
                  <a:pos x="csX2" y="csY2"/>
                </a:cxn>
              </a:cxnLst>
              <a:rect l="l" t="t" r="r" b="b"/>
              <a:pathLst>
                <a:path w="51407" h="25703">
                  <a:moveTo>
                    <a:pt x="319" y="244"/>
                  </a:moveTo>
                  <a:cubicBezTo>
                    <a:pt x="17454" y="8812"/>
                    <a:pt x="34590" y="13096"/>
                    <a:pt x="51726" y="13096"/>
                  </a:cubicBezTo>
                  <a:cubicBezTo>
                    <a:pt x="34590" y="13096"/>
                    <a:pt x="17454" y="17380"/>
                    <a:pt x="319" y="25947"/>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2" name="フリーフォーム: 図形 171">
              <a:extLst>
                <a:ext uri="{FF2B5EF4-FFF2-40B4-BE49-F238E27FC236}">
                  <a16:creationId xmlns:a16="http://schemas.microsoft.com/office/drawing/2014/main" id="{8B589F02-977F-9A88-F06D-EDA2068306B4}"/>
                </a:ext>
              </a:extLst>
            </p:cNvPr>
            <p:cNvSpPr/>
            <p:nvPr/>
          </p:nvSpPr>
          <p:spPr>
            <a:xfrm>
              <a:off x="5509106" y="4841983"/>
              <a:ext cx="107941" cy="130220"/>
            </a:xfrm>
            <a:custGeom>
              <a:avLst/>
              <a:gdLst>
                <a:gd name="csX0" fmla="*/ 102657 w 107941"/>
                <a:gd name="csY0" fmla="*/ 312 h 130220"/>
                <a:gd name="csX1" fmla="*/ -5284 w 107941"/>
                <a:gd name="csY1" fmla="*/ 130532 h 130220"/>
              </a:gdLst>
              <a:ahLst/>
              <a:cxnLst>
                <a:cxn ang="0">
                  <a:pos x="csX0" y="csY0"/>
                </a:cxn>
                <a:cxn ang="0">
                  <a:pos x="csX1" y="csY1"/>
                </a:cxn>
              </a:cxnLst>
              <a:rect l="l" t="t" r="r" b="b"/>
              <a:pathLst>
                <a:path w="107941" h="130220">
                  <a:moveTo>
                    <a:pt x="102657" y="312"/>
                  </a:moveTo>
                  <a:lnTo>
                    <a:pt x="-5284" y="130532"/>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3" name="フリーフォーム: 図形 172">
              <a:extLst>
                <a:ext uri="{FF2B5EF4-FFF2-40B4-BE49-F238E27FC236}">
                  <a16:creationId xmlns:a16="http://schemas.microsoft.com/office/drawing/2014/main" id="{469FBDAA-A053-1123-42B6-58F7B4BC9A19}"/>
                </a:ext>
              </a:extLst>
            </p:cNvPr>
            <p:cNvSpPr/>
            <p:nvPr/>
          </p:nvSpPr>
          <p:spPr>
            <a:xfrm rot="18579351">
              <a:off x="5615990" y="4833892"/>
              <a:ext cx="5841" cy="11683"/>
            </a:xfrm>
            <a:custGeom>
              <a:avLst/>
              <a:gdLst>
                <a:gd name="csX0" fmla="*/ 369 w 5841"/>
                <a:gd name="csY0" fmla="*/ 11874 h 11683"/>
                <a:gd name="csX1" fmla="*/ 6211 w 5841"/>
                <a:gd name="csY1" fmla="*/ 6032 h 11683"/>
                <a:gd name="csX2" fmla="*/ 369 w 5841"/>
                <a:gd name="csY2" fmla="*/ 191 h 11683"/>
              </a:gdLst>
              <a:ahLst/>
              <a:cxnLst>
                <a:cxn ang="0">
                  <a:pos x="csX0" y="csY0"/>
                </a:cxn>
                <a:cxn ang="0">
                  <a:pos x="csX1" y="csY1"/>
                </a:cxn>
                <a:cxn ang="0">
                  <a:pos x="csX2" y="csY2"/>
                </a:cxn>
              </a:cxnLst>
              <a:rect l="l" t="t" r="r" b="b"/>
              <a:pathLst>
                <a:path w="5841" h="11683">
                  <a:moveTo>
                    <a:pt x="369" y="11874"/>
                  </a:moveTo>
                  <a:cubicBezTo>
                    <a:pt x="3596" y="11874"/>
                    <a:pt x="6211" y="9259"/>
                    <a:pt x="6211" y="6032"/>
                  </a:cubicBezTo>
                  <a:cubicBezTo>
                    <a:pt x="6211" y="2806"/>
                    <a:pt x="3596" y="191"/>
                    <a:pt x="369" y="191"/>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4" name="フリーフォーム: 図形 173">
              <a:extLst>
                <a:ext uri="{FF2B5EF4-FFF2-40B4-BE49-F238E27FC236}">
                  <a16:creationId xmlns:a16="http://schemas.microsoft.com/office/drawing/2014/main" id="{76573805-E0E4-0199-3B19-F357FE23556F}"/>
                </a:ext>
              </a:extLst>
            </p:cNvPr>
            <p:cNvSpPr/>
            <p:nvPr/>
          </p:nvSpPr>
          <p:spPr>
            <a:xfrm rot="7779351">
              <a:off x="5466998" y="4979140"/>
              <a:ext cx="51407" cy="25703"/>
            </a:xfrm>
            <a:custGeom>
              <a:avLst/>
              <a:gdLst>
                <a:gd name="csX0" fmla="*/ 346 w 51407"/>
                <a:gd name="csY0" fmla="*/ 220 h 25703"/>
                <a:gd name="csX1" fmla="*/ 51754 w 51407"/>
                <a:gd name="csY1" fmla="*/ 13072 h 25703"/>
                <a:gd name="csX2" fmla="*/ 346 w 51407"/>
                <a:gd name="csY2" fmla="*/ 25924 h 25703"/>
              </a:gdLst>
              <a:ahLst/>
              <a:cxnLst>
                <a:cxn ang="0">
                  <a:pos x="csX0" y="csY0"/>
                </a:cxn>
                <a:cxn ang="0">
                  <a:pos x="csX1" y="csY1"/>
                </a:cxn>
                <a:cxn ang="0">
                  <a:pos x="csX2" y="csY2"/>
                </a:cxn>
              </a:cxnLst>
              <a:rect l="l" t="t" r="r" b="b"/>
              <a:pathLst>
                <a:path w="51407" h="25703">
                  <a:moveTo>
                    <a:pt x="346" y="220"/>
                  </a:moveTo>
                  <a:cubicBezTo>
                    <a:pt x="17482" y="8788"/>
                    <a:pt x="34618" y="13072"/>
                    <a:pt x="51754" y="13072"/>
                  </a:cubicBezTo>
                  <a:cubicBezTo>
                    <a:pt x="34618" y="13072"/>
                    <a:pt x="17482" y="17356"/>
                    <a:pt x="346" y="25924"/>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5" name="フリーフォーム: 図形 174">
              <a:extLst>
                <a:ext uri="{FF2B5EF4-FFF2-40B4-BE49-F238E27FC236}">
                  <a16:creationId xmlns:a16="http://schemas.microsoft.com/office/drawing/2014/main" id="{1FF0FEE7-678B-C942-C725-354F793C8C5A}"/>
                </a:ext>
              </a:extLst>
            </p:cNvPr>
            <p:cNvSpPr/>
            <p:nvPr/>
          </p:nvSpPr>
          <p:spPr>
            <a:xfrm>
              <a:off x="5876568" y="5078413"/>
              <a:ext cx="226599" cy="104099"/>
            </a:xfrm>
            <a:custGeom>
              <a:avLst/>
              <a:gdLst>
                <a:gd name="csX0" fmla="*/ 221215 w 226599"/>
                <a:gd name="csY0" fmla="*/ 259 h 104099"/>
                <a:gd name="csX1" fmla="*/ -5385 w 226599"/>
                <a:gd name="csY1" fmla="*/ 104359 h 104099"/>
              </a:gdLst>
              <a:ahLst/>
              <a:cxnLst>
                <a:cxn ang="0">
                  <a:pos x="csX0" y="csY0"/>
                </a:cxn>
                <a:cxn ang="0">
                  <a:pos x="csX1" y="csY1"/>
                </a:cxn>
              </a:cxnLst>
              <a:rect l="l" t="t" r="r" b="b"/>
              <a:pathLst>
                <a:path w="226599" h="104099">
                  <a:moveTo>
                    <a:pt x="221215" y="259"/>
                  </a:moveTo>
                  <a:lnTo>
                    <a:pt x="-5385" y="104359"/>
                  </a:lnTo>
                </a:path>
              </a:pathLst>
            </a:custGeom>
            <a:noFill/>
            <a:ln w="11669" cap="flat">
              <a:solidFill>
                <a:srgbClr val="F46D43"/>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6" name="フリーフォーム: 図形 175">
              <a:extLst>
                <a:ext uri="{FF2B5EF4-FFF2-40B4-BE49-F238E27FC236}">
                  <a16:creationId xmlns:a16="http://schemas.microsoft.com/office/drawing/2014/main" id="{0D505657-E5F5-6E69-4295-F6BF97BEBDB6}"/>
                </a:ext>
              </a:extLst>
            </p:cNvPr>
            <p:cNvSpPr/>
            <p:nvPr/>
          </p:nvSpPr>
          <p:spPr>
            <a:xfrm rot="20119556">
              <a:off x="6102900" y="5071352"/>
              <a:ext cx="5841" cy="11683"/>
            </a:xfrm>
            <a:custGeom>
              <a:avLst/>
              <a:gdLst>
                <a:gd name="csX0" fmla="*/ 463 w 5841"/>
                <a:gd name="csY0" fmla="*/ 11920 h 11683"/>
                <a:gd name="csX1" fmla="*/ 6305 w 5841"/>
                <a:gd name="csY1" fmla="*/ 6078 h 11683"/>
                <a:gd name="csX2" fmla="*/ 463 w 5841"/>
                <a:gd name="csY2" fmla="*/ 236 h 11683"/>
              </a:gdLst>
              <a:ahLst/>
              <a:cxnLst>
                <a:cxn ang="0">
                  <a:pos x="csX0" y="csY0"/>
                </a:cxn>
                <a:cxn ang="0">
                  <a:pos x="csX1" y="csY1"/>
                </a:cxn>
                <a:cxn ang="0">
                  <a:pos x="csX2" y="csY2"/>
                </a:cxn>
              </a:cxnLst>
              <a:rect l="l" t="t" r="r" b="b"/>
              <a:pathLst>
                <a:path w="5841" h="11683">
                  <a:moveTo>
                    <a:pt x="463" y="11920"/>
                  </a:moveTo>
                  <a:cubicBezTo>
                    <a:pt x="3690" y="11920"/>
                    <a:pt x="6305" y="9304"/>
                    <a:pt x="6305" y="6078"/>
                  </a:cubicBezTo>
                  <a:cubicBezTo>
                    <a:pt x="6305" y="2852"/>
                    <a:pt x="3690" y="236"/>
                    <a:pt x="463" y="236"/>
                  </a:cubicBezTo>
                  <a:close/>
                </a:path>
              </a:pathLst>
            </a:custGeom>
            <a:solidFill>
              <a:srgbClr val="F46D43"/>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7" name="フリーフォーム: 図形 176">
              <a:extLst>
                <a:ext uri="{FF2B5EF4-FFF2-40B4-BE49-F238E27FC236}">
                  <a16:creationId xmlns:a16="http://schemas.microsoft.com/office/drawing/2014/main" id="{DAE55387-A40E-8D89-B9E5-1318F3BC6544}"/>
                </a:ext>
              </a:extLst>
            </p:cNvPr>
            <p:cNvSpPr/>
            <p:nvPr/>
          </p:nvSpPr>
          <p:spPr>
            <a:xfrm rot="9319556">
              <a:off x="5827507" y="5180391"/>
              <a:ext cx="51407" cy="25703"/>
            </a:xfrm>
            <a:custGeom>
              <a:avLst/>
              <a:gdLst>
                <a:gd name="csX0" fmla="*/ 416 w 51407"/>
                <a:gd name="csY0" fmla="*/ 259 h 25703"/>
                <a:gd name="csX1" fmla="*/ 51823 w 51407"/>
                <a:gd name="csY1" fmla="*/ 13111 h 25703"/>
                <a:gd name="csX2" fmla="*/ 416 w 51407"/>
                <a:gd name="csY2" fmla="*/ 25962 h 25703"/>
              </a:gdLst>
              <a:ahLst/>
              <a:cxnLst>
                <a:cxn ang="0">
                  <a:pos x="csX0" y="csY0"/>
                </a:cxn>
                <a:cxn ang="0">
                  <a:pos x="csX1" y="csY1"/>
                </a:cxn>
                <a:cxn ang="0">
                  <a:pos x="csX2" y="csY2"/>
                </a:cxn>
              </a:cxnLst>
              <a:rect l="l" t="t" r="r" b="b"/>
              <a:pathLst>
                <a:path w="51407" h="25703">
                  <a:moveTo>
                    <a:pt x="416" y="259"/>
                  </a:moveTo>
                  <a:lnTo>
                    <a:pt x="51823" y="13111"/>
                  </a:lnTo>
                  <a:lnTo>
                    <a:pt x="416" y="25962"/>
                  </a:lnTo>
                  <a:close/>
                </a:path>
              </a:pathLst>
            </a:custGeom>
            <a:solidFill>
              <a:srgbClr val="F46D43"/>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8" name="フリーフォーム: 図形 177">
              <a:extLst>
                <a:ext uri="{FF2B5EF4-FFF2-40B4-BE49-F238E27FC236}">
                  <a16:creationId xmlns:a16="http://schemas.microsoft.com/office/drawing/2014/main" id="{E804177F-F581-4F59-26B8-3BBED00A2138}"/>
                </a:ext>
              </a:extLst>
            </p:cNvPr>
            <p:cNvSpPr/>
            <p:nvPr/>
          </p:nvSpPr>
          <p:spPr>
            <a:xfrm>
              <a:off x="5677415" y="4882300"/>
              <a:ext cx="88051" cy="297864"/>
            </a:xfrm>
            <a:custGeom>
              <a:avLst/>
              <a:gdLst>
                <a:gd name="csX0" fmla="*/ 82732 w 88051"/>
                <a:gd name="csY0" fmla="*/ 298150 h 297864"/>
                <a:gd name="csX1" fmla="*/ -5320 w 88051"/>
                <a:gd name="csY1" fmla="*/ 285 h 297864"/>
              </a:gdLst>
              <a:ahLst/>
              <a:cxnLst>
                <a:cxn ang="0">
                  <a:pos x="csX0" y="csY0"/>
                </a:cxn>
                <a:cxn ang="0">
                  <a:pos x="csX1" y="csY1"/>
                </a:cxn>
              </a:cxnLst>
              <a:rect l="l" t="t" r="r" b="b"/>
              <a:pathLst>
                <a:path w="88051" h="297864">
                  <a:moveTo>
                    <a:pt x="82732" y="298150"/>
                  </a:moveTo>
                  <a:lnTo>
                    <a:pt x="-5320" y="285"/>
                  </a:lnTo>
                </a:path>
              </a:pathLst>
            </a:custGeom>
            <a:noFill/>
            <a:ln w="11669" cap="flat">
              <a:solidFill>
                <a:srgbClr val="FEE08B"/>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79" name="フリーフォーム: 図形 178">
              <a:extLst>
                <a:ext uri="{FF2B5EF4-FFF2-40B4-BE49-F238E27FC236}">
                  <a16:creationId xmlns:a16="http://schemas.microsoft.com/office/drawing/2014/main" id="{21FED65F-C190-2B05-2013-A1058EFCF42B}"/>
                </a:ext>
              </a:extLst>
            </p:cNvPr>
            <p:cNvSpPr/>
            <p:nvPr/>
          </p:nvSpPr>
          <p:spPr>
            <a:xfrm rot="4411909">
              <a:off x="5758396" y="5166222"/>
              <a:ext cx="5841" cy="11683"/>
            </a:xfrm>
            <a:custGeom>
              <a:avLst/>
              <a:gdLst>
                <a:gd name="csX0" fmla="*/ 397 w 5841"/>
                <a:gd name="csY0" fmla="*/ 11938 h 11683"/>
                <a:gd name="csX1" fmla="*/ 6239 w 5841"/>
                <a:gd name="csY1" fmla="*/ 6096 h 11683"/>
                <a:gd name="csX2" fmla="*/ 397 w 5841"/>
                <a:gd name="csY2" fmla="*/ 255 h 11683"/>
              </a:gdLst>
              <a:ahLst/>
              <a:cxnLst>
                <a:cxn ang="0">
                  <a:pos x="csX0" y="csY0"/>
                </a:cxn>
                <a:cxn ang="0">
                  <a:pos x="csX1" y="csY1"/>
                </a:cxn>
                <a:cxn ang="0">
                  <a:pos x="csX2" y="csY2"/>
                </a:cxn>
              </a:cxnLst>
              <a:rect l="l" t="t" r="r" b="b"/>
              <a:pathLst>
                <a:path w="5841" h="11683">
                  <a:moveTo>
                    <a:pt x="397" y="11938"/>
                  </a:moveTo>
                  <a:cubicBezTo>
                    <a:pt x="3623" y="11938"/>
                    <a:pt x="6239" y="9323"/>
                    <a:pt x="6239" y="6096"/>
                  </a:cubicBezTo>
                  <a:cubicBezTo>
                    <a:pt x="6239" y="2870"/>
                    <a:pt x="3623" y="255"/>
                    <a:pt x="397" y="255"/>
                  </a:cubicBezTo>
                  <a:close/>
                </a:path>
              </a:pathLst>
            </a:custGeom>
            <a:solidFill>
              <a:srgbClr val="FEE08B"/>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0" name="フリーフォーム: 図形 179">
              <a:extLst>
                <a:ext uri="{FF2B5EF4-FFF2-40B4-BE49-F238E27FC236}">
                  <a16:creationId xmlns:a16="http://schemas.microsoft.com/office/drawing/2014/main" id="{B7F144EE-345C-5143-82EA-1DE17BAE0EA5}"/>
                </a:ext>
              </a:extLst>
            </p:cNvPr>
            <p:cNvSpPr/>
            <p:nvPr/>
          </p:nvSpPr>
          <p:spPr>
            <a:xfrm rot="15211909">
              <a:off x="5654116" y="4862394"/>
              <a:ext cx="36000" cy="36000"/>
            </a:xfrm>
            <a:custGeom>
              <a:avLst/>
              <a:gdLst>
                <a:gd name="csX0" fmla="*/ 380 w 12851"/>
                <a:gd name="csY0" fmla="*/ 195 h 25703"/>
                <a:gd name="csX1" fmla="*/ 13232 w 12851"/>
                <a:gd name="csY1" fmla="*/ 13047 h 25703"/>
                <a:gd name="csX2" fmla="*/ 380 w 12851"/>
                <a:gd name="csY2" fmla="*/ 25899 h 25703"/>
              </a:gdLst>
              <a:ahLst/>
              <a:cxnLst>
                <a:cxn ang="0">
                  <a:pos x="csX0" y="csY0"/>
                </a:cxn>
                <a:cxn ang="0">
                  <a:pos x="csX1" y="csY1"/>
                </a:cxn>
                <a:cxn ang="0">
                  <a:pos x="csX2" y="csY2"/>
                </a:cxn>
              </a:cxnLst>
              <a:rect l="l" t="t" r="r" b="b"/>
              <a:pathLst>
                <a:path w="12851" h="25703">
                  <a:moveTo>
                    <a:pt x="380" y="195"/>
                  </a:moveTo>
                  <a:lnTo>
                    <a:pt x="13232" y="13047"/>
                  </a:lnTo>
                  <a:lnTo>
                    <a:pt x="380" y="25899"/>
                  </a:lnTo>
                  <a:close/>
                </a:path>
              </a:pathLst>
            </a:custGeom>
            <a:solidFill>
              <a:srgbClr val="FEE08B"/>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1" name="フリーフォーム: 図形 180">
              <a:extLst>
                <a:ext uri="{FF2B5EF4-FFF2-40B4-BE49-F238E27FC236}">
                  <a16:creationId xmlns:a16="http://schemas.microsoft.com/office/drawing/2014/main" id="{CF329CCF-BDAA-6E00-4297-F37221E0F158}"/>
                </a:ext>
              </a:extLst>
            </p:cNvPr>
            <p:cNvSpPr/>
            <p:nvPr/>
          </p:nvSpPr>
          <p:spPr>
            <a:xfrm>
              <a:off x="5452110" y="4554855"/>
              <a:ext cx="161967" cy="216000"/>
            </a:xfrm>
            <a:custGeom>
              <a:avLst/>
              <a:gdLst>
                <a:gd name="csX0" fmla="*/ 103805 w 109088"/>
                <a:gd name="csY0" fmla="*/ 137992 h 137628"/>
                <a:gd name="csX1" fmla="*/ -5284 w 109088"/>
                <a:gd name="csY1" fmla="*/ 363 h 137628"/>
              </a:gdLst>
              <a:ahLst/>
              <a:cxnLst>
                <a:cxn ang="0">
                  <a:pos x="csX0" y="csY0"/>
                </a:cxn>
                <a:cxn ang="0">
                  <a:pos x="csX1" y="csY1"/>
                </a:cxn>
              </a:cxnLst>
              <a:rect l="l" t="t" r="r" b="b"/>
              <a:pathLst>
                <a:path w="109088" h="137628">
                  <a:moveTo>
                    <a:pt x="103805" y="137992"/>
                  </a:moveTo>
                  <a:lnTo>
                    <a:pt x="-5284" y="363"/>
                  </a:lnTo>
                </a:path>
              </a:pathLst>
            </a:custGeom>
            <a:noFill/>
            <a:ln w="11669"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2" name="フリーフォーム: 図形 181">
              <a:extLst>
                <a:ext uri="{FF2B5EF4-FFF2-40B4-BE49-F238E27FC236}">
                  <a16:creationId xmlns:a16="http://schemas.microsoft.com/office/drawing/2014/main" id="{BC6256EA-5649-A81B-5D6A-7AA6DF32FDA1}"/>
                </a:ext>
              </a:extLst>
            </p:cNvPr>
            <p:cNvSpPr/>
            <p:nvPr/>
          </p:nvSpPr>
          <p:spPr>
            <a:xfrm rot="3095917">
              <a:off x="5616781" y="4754543"/>
              <a:ext cx="5841" cy="11683"/>
            </a:xfrm>
            <a:custGeom>
              <a:avLst/>
              <a:gdLst>
                <a:gd name="csX0" fmla="*/ 369 w 5841"/>
                <a:gd name="csY0" fmla="*/ 11859 h 11683"/>
                <a:gd name="csX1" fmla="*/ 6211 w 5841"/>
                <a:gd name="csY1" fmla="*/ 6017 h 11683"/>
                <a:gd name="csX2" fmla="*/ 369 w 5841"/>
                <a:gd name="csY2" fmla="*/ 175 h 11683"/>
              </a:gdLst>
              <a:ahLst/>
              <a:cxnLst>
                <a:cxn ang="0">
                  <a:pos x="csX0" y="csY0"/>
                </a:cxn>
                <a:cxn ang="0">
                  <a:pos x="csX1" y="csY1"/>
                </a:cxn>
                <a:cxn ang="0">
                  <a:pos x="csX2" y="csY2"/>
                </a:cxn>
              </a:cxnLst>
              <a:rect l="l" t="t" r="r" b="b"/>
              <a:pathLst>
                <a:path w="5841" h="11683">
                  <a:moveTo>
                    <a:pt x="369" y="11859"/>
                  </a:moveTo>
                  <a:cubicBezTo>
                    <a:pt x="3596" y="11859"/>
                    <a:pt x="6211" y="9243"/>
                    <a:pt x="6211" y="6017"/>
                  </a:cubicBezTo>
                  <a:cubicBezTo>
                    <a:pt x="6211" y="2791"/>
                    <a:pt x="3596" y="175"/>
                    <a:pt x="369" y="175"/>
                  </a:cubicBezTo>
                  <a:close/>
                </a:path>
              </a:pathLst>
            </a:custGeom>
            <a:solidFill>
              <a:srgbClr val="FDAE61"/>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3" name="フリーフォーム: 図形 182">
              <a:extLst>
                <a:ext uri="{FF2B5EF4-FFF2-40B4-BE49-F238E27FC236}">
                  <a16:creationId xmlns:a16="http://schemas.microsoft.com/office/drawing/2014/main" id="{E070A1E8-F070-7E6D-B3AD-544ABF8C5267}"/>
                </a:ext>
              </a:extLst>
            </p:cNvPr>
            <p:cNvSpPr/>
            <p:nvPr/>
          </p:nvSpPr>
          <p:spPr>
            <a:xfrm rot="13895917">
              <a:off x="5406520" y="4519055"/>
              <a:ext cx="54000" cy="36000"/>
            </a:xfrm>
            <a:custGeom>
              <a:avLst/>
              <a:gdLst>
                <a:gd name="csX0" fmla="*/ 346 w 51407"/>
                <a:gd name="csY0" fmla="*/ 144 h 25703"/>
                <a:gd name="csX1" fmla="*/ 51754 w 51407"/>
                <a:gd name="csY1" fmla="*/ 12996 h 25703"/>
                <a:gd name="csX2" fmla="*/ 346 w 51407"/>
                <a:gd name="csY2" fmla="*/ 25848 h 25703"/>
              </a:gdLst>
              <a:ahLst/>
              <a:cxnLst>
                <a:cxn ang="0">
                  <a:pos x="csX0" y="csY0"/>
                </a:cxn>
                <a:cxn ang="0">
                  <a:pos x="csX1" y="csY1"/>
                </a:cxn>
                <a:cxn ang="0">
                  <a:pos x="csX2" y="csY2"/>
                </a:cxn>
              </a:cxnLst>
              <a:rect l="l" t="t" r="r" b="b"/>
              <a:pathLst>
                <a:path w="51407" h="25703">
                  <a:moveTo>
                    <a:pt x="346" y="144"/>
                  </a:moveTo>
                  <a:cubicBezTo>
                    <a:pt x="17482" y="8712"/>
                    <a:pt x="34618" y="12996"/>
                    <a:pt x="51754" y="12996"/>
                  </a:cubicBezTo>
                  <a:cubicBezTo>
                    <a:pt x="34618" y="12996"/>
                    <a:pt x="17482" y="17280"/>
                    <a:pt x="346" y="25848"/>
                  </a:cubicBezTo>
                  <a:close/>
                </a:path>
              </a:pathLst>
            </a:custGeom>
            <a:solidFill>
              <a:srgbClr val="FDAE61"/>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4" name="フリーフォーム: 図形 183">
              <a:extLst>
                <a:ext uri="{FF2B5EF4-FFF2-40B4-BE49-F238E27FC236}">
                  <a16:creationId xmlns:a16="http://schemas.microsoft.com/office/drawing/2014/main" id="{DE8E3439-B2F0-A647-713D-5A3193BC116D}"/>
                </a:ext>
              </a:extLst>
            </p:cNvPr>
            <p:cNvSpPr/>
            <p:nvPr/>
          </p:nvSpPr>
          <p:spPr>
            <a:xfrm>
              <a:off x="5747849" y="4849068"/>
              <a:ext cx="356871" cy="179979"/>
            </a:xfrm>
            <a:custGeom>
              <a:avLst/>
              <a:gdLst>
                <a:gd name="csX0" fmla="*/ 351502 w 356871"/>
                <a:gd name="csY0" fmla="*/ 180284 h 179979"/>
                <a:gd name="csX1" fmla="*/ -5370 w 356871"/>
                <a:gd name="csY1" fmla="*/ 304 h 179979"/>
              </a:gdLst>
              <a:ahLst/>
              <a:cxnLst>
                <a:cxn ang="0">
                  <a:pos x="csX0" y="csY0"/>
                </a:cxn>
                <a:cxn ang="0">
                  <a:pos x="csX1" y="csY1"/>
                </a:cxn>
              </a:cxnLst>
              <a:rect l="l" t="t" r="r" b="b"/>
              <a:pathLst>
                <a:path w="356871" h="179979">
                  <a:moveTo>
                    <a:pt x="351502" y="180284"/>
                  </a:moveTo>
                  <a:lnTo>
                    <a:pt x="-5370" y="304"/>
                  </a:lnTo>
                </a:path>
              </a:pathLst>
            </a:custGeom>
            <a:noFill/>
            <a:ln w="11669" cap="flat">
              <a:solidFill>
                <a:srgbClr val="F46D43"/>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5" name="フリーフォーム: 図形 184">
              <a:extLst>
                <a:ext uri="{FF2B5EF4-FFF2-40B4-BE49-F238E27FC236}">
                  <a16:creationId xmlns:a16="http://schemas.microsoft.com/office/drawing/2014/main" id="{62803CB1-63D2-075D-42AE-3052B1ADB173}"/>
                </a:ext>
              </a:extLst>
            </p:cNvPr>
            <p:cNvSpPr/>
            <p:nvPr/>
          </p:nvSpPr>
          <p:spPr>
            <a:xfrm rot="1605784">
              <a:off x="6104408" y="5024521"/>
              <a:ext cx="5841" cy="11683"/>
            </a:xfrm>
            <a:custGeom>
              <a:avLst/>
              <a:gdLst>
                <a:gd name="csX0" fmla="*/ 463 w 5841"/>
                <a:gd name="csY0" fmla="*/ 11911 h 11683"/>
                <a:gd name="csX1" fmla="*/ 6305 w 5841"/>
                <a:gd name="csY1" fmla="*/ 6069 h 11683"/>
                <a:gd name="csX2" fmla="*/ 463 w 5841"/>
                <a:gd name="csY2" fmla="*/ 227 h 11683"/>
              </a:gdLst>
              <a:ahLst/>
              <a:cxnLst>
                <a:cxn ang="0">
                  <a:pos x="csX0" y="csY0"/>
                </a:cxn>
                <a:cxn ang="0">
                  <a:pos x="csX1" y="csY1"/>
                </a:cxn>
                <a:cxn ang="0">
                  <a:pos x="csX2" y="csY2"/>
                </a:cxn>
              </a:cxnLst>
              <a:rect l="l" t="t" r="r" b="b"/>
              <a:pathLst>
                <a:path w="5841" h="11683">
                  <a:moveTo>
                    <a:pt x="463" y="11911"/>
                  </a:moveTo>
                  <a:cubicBezTo>
                    <a:pt x="3690" y="11911"/>
                    <a:pt x="6305" y="9295"/>
                    <a:pt x="6305" y="6069"/>
                  </a:cubicBezTo>
                  <a:cubicBezTo>
                    <a:pt x="6305" y="2843"/>
                    <a:pt x="3690" y="227"/>
                    <a:pt x="463" y="227"/>
                  </a:cubicBezTo>
                  <a:close/>
                </a:path>
              </a:pathLst>
            </a:custGeom>
            <a:solidFill>
              <a:srgbClr val="F46D43"/>
            </a:solidFill>
            <a:ln w="11670"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6" name="フリーフォーム: 図形 185">
              <a:extLst>
                <a:ext uri="{FF2B5EF4-FFF2-40B4-BE49-F238E27FC236}">
                  <a16:creationId xmlns:a16="http://schemas.microsoft.com/office/drawing/2014/main" id="{00A9225D-0F88-2895-82F5-73F2A1B1AEB4}"/>
                </a:ext>
              </a:extLst>
            </p:cNvPr>
            <p:cNvSpPr/>
            <p:nvPr/>
          </p:nvSpPr>
          <p:spPr>
            <a:xfrm rot="12405784">
              <a:off x="5699196" y="4824641"/>
              <a:ext cx="51407" cy="25703"/>
            </a:xfrm>
            <a:custGeom>
              <a:avLst/>
              <a:gdLst>
                <a:gd name="csX0" fmla="*/ 391 w 51407"/>
                <a:gd name="csY0" fmla="*/ 190 h 25703"/>
                <a:gd name="csX1" fmla="*/ 51798 w 51407"/>
                <a:gd name="csY1" fmla="*/ 13042 h 25703"/>
                <a:gd name="csX2" fmla="*/ 391 w 51407"/>
                <a:gd name="csY2" fmla="*/ 25894 h 25703"/>
              </a:gdLst>
              <a:ahLst/>
              <a:cxnLst>
                <a:cxn ang="0">
                  <a:pos x="csX0" y="csY0"/>
                </a:cxn>
                <a:cxn ang="0">
                  <a:pos x="csX1" y="csY1"/>
                </a:cxn>
                <a:cxn ang="0">
                  <a:pos x="csX2" y="csY2"/>
                </a:cxn>
              </a:cxnLst>
              <a:rect l="l" t="t" r="r" b="b"/>
              <a:pathLst>
                <a:path w="51407" h="25703">
                  <a:moveTo>
                    <a:pt x="391" y="190"/>
                  </a:moveTo>
                  <a:lnTo>
                    <a:pt x="51798" y="13042"/>
                  </a:lnTo>
                  <a:lnTo>
                    <a:pt x="391" y="25894"/>
                  </a:lnTo>
                  <a:close/>
                </a:path>
              </a:pathLst>
            </a:custGeom>
            <a:solidFill>
              <a:srgbClr val="F46D43"/>
            </a:solidFill>
            <a:ln w="25673"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7" name="フリーフォーム: 図形 186">
              <a:extLst>
                <a:ext uri="{FF2B5EF4-FFF2-40B4-BE49-F238E27FC236}">
                  <a16:creationId xmlns:a16="http://schemas.microsoft.com/office/drawing/2014/main" id="{1994CDE0-A5AB-6A90-BD44-5B25E187B823}"/>
                </a:ext>
              </a:extLst>
            </p:cNvPr>
            <p:cNvSpPr/>
            <p:nvPr/>
          </p:nvSpPr>
          <p:spPr>
            <a:xfrm>
              <a:off x="5778970" y="4953413"/>
              <a:ext cx="128518" cy="128518"/>
            </a:xfrm>
            <a:custGeom>
              <a:avLst/>
              <a:gdLst>
                <a:gd name="csX0" fmla="*/ 123168 w 128518"/>
                <a:gd name="csY0" fmla="*/ 64545 h 128518"/>
                <a:gd name="csX1" fmla="*/ 58909 w 128518"/>
                <a:gd name="csY1" fmla="*/ 128804 h 128518"/>
                <a:gd name="csX2" fmla="*/ -5350 w 128518"/>
                <a:gd name="csY2" fmla="*/ 64545 h 128518"/>
                <a:gd name="csX3" fmla="*/ 58909 w 128518"/>
                <a:gd name="csY3" fmla="*/ 286 h 128518"/>
                <a:gd name="csX4" fmla="*/ 123168 w 128518"/>
                <a:gd name="csY4" fmla="*/ 64545 h 128518"/>
              </a:gdLst>
              <a:ahLst/>
              <a:cxnLst>
                <a:cxn ang="0">
                  <a:pos x="csX0" y="csY0"/>
                </a:cxn>
                <a:cxn ang="0">
                  <a:pos x="csX1" y="csY1"/>
                </a:cxn>
                <a:cxn ang="0">
                  <a:pos x="csX2" y="csY2"/>
                </a:cxn>
                <a:cxn ang="0">
                  <a:pos x="csX3" y="csY3"/>
                </a:cxn>
                <a:cxn ang="0">
                  <a:pos x="csX4" y="csY4"/>
                </a:cxn>
              </a:cxnLst>
              <a:rect l="l" t="t" r="r" b="b"/>
              <a:pathLst>
                <a:path w="128518" h="128518">
                  <a:moveTo>
                    <a:pt x="123168" y="64545"/>
                  </a:moveTo>
                  <a:cubicBezTo>
                    <a:pt x="123168" y="100034"/>
                    <a:pt x="94399" y="128804"/>
                    <a:pt x="58909" y="128804"/>
                  </a:cubicBezTo>
                  <a:cubicBezTo>
                    <a:pt x="23419" y="128804"/>
                    <a:pt x="-5350" y="100034"/>
                    <a:pt x="-5350" y="64545"/>
                  </a:cubicBezTo>
                  <a:cubicBezTo>
                    <a:pt x="-5350" y="29056"/>
                    <a:pt x="23419" y="286"/>
                    <a:pt x="58909" y="286"/>
                  </a:cubicBezTo>
                  <a:cubicBezTo>
                    <a:pt x="94399" y="286"/>
                    <a:pt x="123168" y="29056"/>
                    <a:pt x="123168" y="64545"/>
                  </a:cubicBezTo>
                  <a:close/>
                </a:path>
              </a:pathLst>
            </a:custGeom>
            <a:noFill/>
            <a:ln w="11669"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8" name="フリーフォーム: 図形 187">
              <a:extLst>
                <a:ext uri="{FF2B5EF4-FFF2-40B4-BE49-F238E27FC236}">
                  <a16:creationId xmlns:a16="http://schemas.microsoft.com/office/drawing/2014/main" id="{176A6998-41AF-AA61-44FC-1F3FB7140B68}"/>
                </a:ext>
              </a:extLst>
            </p:cNvPr>
            <p:cNvSpPr/>
            <p:nvPr/>
          </p:nvSpPr>
          <p:spPr>
            <a:xfrm>
              <a:off x="5778970" y="4953413"/>
              <a:ext cx="128518" cy="128518"/>
            </a:xfrm>
            <a:custGeom>
              <a:avLst/>
              <a:gdLst>
                <a:gd name="csX0" fmla="*/ 123168 w 128518"/>
                <a:gd name="csY0" fmla="*/ 64545 h 128518"/>
                <a:gd name="csX1" fmla="*/ 58909 w 128518"/>
                <a:gd name="csY1" fmla="*/ 128804 h 128518"/>
                <a:gd name="csX2" fmla="*/ -5350 w 128518"/>
                <a:gd name="csY2" fmla="*/ 64545 h 128518"/>
                <a:gd name="csX3" fmla="*/ 58909 w 128518"/>
                <a:gd name="csY3" fmla="*/ 286 h 128518"/>
                <a:gd name="csX4" fmla="*/ 123168 w 128518"/>
                <a:gd name="csY4" fmla="*/ 64545 h 128518"/>
              </a:gdLst>
              <a:ahLst/>
              <a:cxnLst>
                <a:cxn ang="0">
                  <a:pos x="csX0" y="csY0"/>
                </a:cxn>
                <a:cxn ang="0">
                  <a:pos x="csX1" y="csY1"/>
                </a:cxn>
                <a:cxn ang="0">
                  <a:pos x="csX2" y="csY2"/>
                </a:cxn>
                <a:cxn ang="0">
                  <a:pos x="csX3" y="csY3"/>
                </a:cxn>
                <a:cxn ang="0">
                  <a:pos x="csX4" y="csY4"/>
                </a:cxn>
              </a:cxnLst>
              <a:rect l="l" t="t" r="r" b="b"/>
              <a:pathLst>
                <a:path w="128518" h="128518">
                  <a:moveTo>
                    <a:pt x="123168" y="64545"/>
                  </a:moveTo>
                  <a:cubicBezTo>
                    <a:pt x="123168" y="100034"/>
                    <a:pt x="94399" y="128804"/>
                    <a:pt x="58909" y="128804"/>
                  </a:cubicBezTo>
                  <a:cubicBezTo>
                    <a:pt x="23419" y="128804"/>
                    <a:pt x="-5350" y="100034"/>
                    <a:pt x="-5350" y="64545"/>
                  </a:cubicBezTo>
                  <a:cubicBezTo>
                    <a:pt x="-5350" y="29056"/>
                    <a:pt x="23419" y="286"/>
                    <a:pt x="58909" y="286"/>
                  </a:cubicBezTo>
                  <a:cubicBezTo>
                    <a:pt x="94399" y="286"/>
                    <a:pt x="123168" y="29056"/>
                    <a:pt x="123168" y="64545"/>
                  </a:cubicBezTo>
                  <a:close/>
                </a:path>
              </a:pathLst>
            </a:custGeom>
            <a:solidFill>
              <a:srgbClr val="D5E4EE"/>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89" name="テキスト ボックス 188">
              <a:extLst>
                <a:ext uri="{FF2B5EF4-FFF2-40B4-BE49-F238E27FC236}">
                  <a16:creationId xmlns:a16="http://schemas.microsoft.com/office/drawing/2014/main" id="{F9E2F9F1-9040-DE87-25B3-46A805D0F643}"/>
                </a:ext>
              </a:extLst>
            </p:cNvPr>
            <p:cNvSpPr txBox="1"/>
            <p:nvPr/>
          </p:nvSpPr>
          <p:spPr>
            <a:xfrm>
              <a:off x="5651866" y="4940340"/>
              <a:ext cx="37221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TRM9-2</a:t>
              </a:r>
            </a:p>
          </p:txBody>
        </p:sp>
        <p:sp>
          <p:nvSpPr>
            <p:cNvPr id="190" name="フリーフォーム: 図形 189">
              <a:extLst>
                <a:ext uri="{FF2B5EF4-FFF2-40B4-BE49-F238E27FC236}">
                  <a16:creationId xmlns:a16="http://schemas.microsoft.com/office/drawing/2014/main" id="{B2293CC8-24EE-B485-A3FA-62F3FF9FFD4E}"/>
                </a:ext>
              </a:extLst>
            </p:cNvPr>
            <p:cNvSpPr/>
            <p:nvPr/>
          </p:nvSpPr>
          <p:spPr>
            <a:xfrm>
              <a:off x="5946643" y="4656106"/>
              <a:ext cx="144000" cy="144000"/>
            </a:xfrm>
            <a:custGeom>
              <a:avLst/>
              <a:gdLst>
                <a:gd name="csX0" fmla="*/ 123131 w 128518"/>
                <a:gd name="csY0" fmla="*/ 64613 h 128518"/>
                <a:gd name="csX1" fmla="*/ 58871 w 128518"/>
                <a:gd name="csY1" fmla="*/ 128872 h 128518"/>
                <a:gd name="csX2" fmla="*/ -5388 w 128518"/>
                <a:gd name="csY2" fmla="*/ 64613 h 128518"/>
                <a:gd name="csX3" fmla="*/ 58871 w 128518"/>
                <a:gd name="csY3" fmla="*/ 354 h 128518"/>
                <a:gd name="csX4" fmla="*/ 123131 w 128518"/>
                <a:gd name="csY4" fmla="*/ 64613 h 128518"/>
              </a:gdLst>
              <a:ahLst/>
              <a:cxnLst>
                <a:cxn ang="0">
                  <a:pos x="csX0" y="csY0"/>
                </a:cxn>
                <a:cxn ang="0">
                  <a:pos x="csX1" y="csY1"/>
                </a:cxn>
                <a:cxn ang="0">
                  <a:pos x="csX2" y="csY2"/>
                </a:cxn>
                <a:cxn ang="0">
                  <a:pos x="csX3" y="csY3"/>
                </a:cxn>
                <a:cxn ang="0">
                  <a:pos x="csX4" y="csY4"/>
                </a:cxn>
              </a:cxnLst>
              <a:rect l="l" t="t" r="r" b="b"/>
              <a:pathLst>
                <a:path w="128518" h="128518">
                  <a:moveTo>
                    <a:pt x="123131" y="64613"/>
                  </a:moveTo>
                  <a:cubicBezTo>
                    <a:pt x="123131" y="100103"/>
                    <a:pt x="94361" y="128872"/>
                    <a:pt x="58871" y="128872"/>
                  </a:cubicBezTo>
                  <a:cubicBezTo>
                    <a:pt x="23382" y="128872"/>
                    <a:pt x="-5388" y="100103"/>
                    <a:pt x="-5388" y="64613"/>
                  </a:cubicBezTo>
                  <a:cubicBezTo>
                    <a:pt x="-5388" y="29124"/>
                    <a:pt x="23382" y="354"/>
                    <a:pt x="58871" y="354"/>
                  </a:cubicBezTo>
                  <a:cubicBezTo>
                    <a:pt x="94361" y="354"/>
                    <a:pt x="123131" y="29124"/>
                    <a:pt x="123131" y="64613"/>
                  </a:cubicBezTo>
                  <a:close/>
                </a:path>
              </a:pathLst>
            </a:custGeom>
            <a:solidFill>
              <a:srgbClr val="D7E5EE"/>
            </a:solidFill>
            <a:ln w="6350" cap="sq">
              <a:solidFill>
                <a:srgbClr val="0070C0"/>
              </a:solidFill>
              <a:prstDash val="solid"/>
              <a:miter/>
            </a:ln>
          </p:spPr>
          <p:txBody>
            <a:bodyPr anchor="ctr"/>
            <a:lstStyle/>
            <a:p>
              <a:pPr algn="ctr"/>
              <a:endParaRPr lang="ja-JP" altLang="en-US" sz="400" b="1" dirty="0">
                <a:ln w="0"/>
                <a:latin typeface="Arial" panose="020B0604020202020204" pitchFamily="34" charset="0"/>
                <a:cs typeface="Arial" panose="020B0604020202020204" pitchFamily="34" charset="0"/>
              </a:endParaRPr>
            </a:p>
          </p:txBody>
        </p:sp>
        <p:sp>
          <p:nvSpPr>
            <p:cNvPr id="191" name="テキスト ボックス 190">
              <a:extLst>
                <a:ext uri="{FF2B5EF4-FFF2-40B4-BE49-F238E27FC236}">
                  <a16:creationId xmlns:a16="http://schemas.microsoft.com/office/drawing/2014/main" id="{3D56953C-7DA2-997C-DA72-6308F57B1068}"/>
                </a:ext>
              </a:extLst>
            </p:cNvPr>
            <p:cNvSpPr txBox="1"/>
            <p:nvPr/>
          </p:nvSpPr>
          <p:spPr>
            <a:xfrm>
              <a:off x="5853373" y="4651162"/>
              <a:ext cx="33054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WDL5</a:t>
              </a:r>
            </a:p>
          </p:txBody>
        </p:sp>
        <p:grpSp>
          <p:nvGrpSpPr>
            <p:cNvPr id="192" name="グループ化 191">
              <a:extLst>
                <a:ext uri="{FF2B5EF4-FFF2-40B4-BE49-F238E27FC236}">
                  <a16:creationId xmlns:a16="http://schemas.microsoft.com/office/drawing/2014/main" id="{5C8C8497-A943-99E8-BBE8-5D2D748DD750}"/>
                </a:ext>
              </a:extLst>
            </p:cNvPr>
            <p:cNvGrpSpPr/>
            <p:nvPr/>
          </p:nvGrpSpPr>
          <p:grpSpPr>
            <a:xfrm>
              <a:off x="5638117" y="4196964"/>
              <a:ext cx="317716" cy="153888"/>
              <a:chOff x="5766380" y="4067424"/>
              <a:chExt cx="317716" cy="153888"/>
            </a:xfrm>
          </p:grpSpPr>
          <p:sp>
            <p:nvSpPr>
              <p:cNvPr id="242" name="フリーフォーム: 図形 241">
                <a:extLst>
                  <a:ext uri="{FF2B5EF4-FFF2-40B4-BE49-F238E27FC236}">
                    <a16:creationId xmlns:a16="http://schemas.microsoft.com/office/drawing/2014/main" id="{FED6E64A-84E7-F206-2EA7-9718E11CEEE9}"/>
                  </a:ext>
                </a:extLst>
              </p:cNvPr>
              <p:cNvSpPr/>
              <p:nvPr/>
            </p:nvSpPr>
            <p:spPr>
              <a:xfrm>
                <a:off x="5853238" y="4072368"/>
                <a:ext cx="144000" cy="144000"/>
              </a:xfrm>
              <a:custGeom>
                <a:avLst/>
                <a:gdLst>
                  <a:gd name="csX0" fmla="*/ 123174 w 128518"/>
                  <a:gd name="csY0" fmla="*/ 64719 h 128518"/>
                  <a:gd name="csX1" fmla="*/ 58915 w 128518"/>
                  <a:gd name="csY1" fmla="*/ 128978 h 128518"/>
                  <a:gd name="csX2" fmla="*/ -5344 w 128518"/>
                  <a:gd name="csY2" fmla="*/ 64719 h 128518"/>
                  <a:gd name="csX3" fmla="*/ 58915 w 128518"/>
                  <a:gd name="csY3" fmla="*/ 460 h 128518"/>
                  <a:gd name="csX4" fmla="*/ 123174 w 128518"/>
                  <a:gd name="csY4" fmla="*/ 64719 h 128518"/>
                </a:gdLst>
                <a:ahLst/>
                <a:cxnLst>
                  <a:cxn ang="0">
                    <a:pos x="csX0" y="csY0"/>
                  </a:cxn>
                  <a:cxn ang="0">
                    <a:pos x="csX1" y="csY1"/>
                  </a:cxn>
                  <a:cxn ang="0">
                    <a:pos x="csX2" y="csY2"/>
                  </a:cxn>
                  <a:cxn ang="0">
                    <a:pos x="csX3" y="csY3"/>
                  </a:cxn>
                  <a:cxn ang="0">
                    <a:pos x="csX4" y="csY4"/>
                  </a:cxn>
                </a:cxnLst>
                <a:rect l="l" t="t" r="r" b="b"/>
                <a:pathLst>
                  <a:path w="128518" h="128518">
                    <a:moveTo>
                      <a:pt x="123174" y="64719"/>
                    </a:moveTo>
                    <a:cubicBezTo>
                      <a:pt x="123174" y="100208"/>
                      <a:pt x="94405" y="128978"/>
                      <a:pt x="58915" y="128978"/>
                    </a:cubicBezTo>
                    <a:cubicBezTo>
                      <a:pt x="23425" y="128978"/>
                      <a:pt x="-5344" y="100208"/>
                      <a:pt x="-5344" y="64719"/>
                    </a:cubicBezTo>
                    <a:cubicBezTo>
                      <a:pt x="-5344" y="29229"/>
                      <a:pt x="23425" y="460"/>
                      <a:pt x="58915" y="460"/>
                    </a:cubicBezTo>
                    <a:cubicBezTo>
                      <a:pt x="94405" y="460"/>
                      <a:pt x="123174" y="29229"/>
                      <a:pt x="123174" y="64719"/>
                    </a:cubicBezTo>
                    <a:close/>
                  </a:path>
                </a:pathLst>
              </a:custGeom>
              <a:solidFill>
                <a:srgbClr val="F8DED1"/>
              </a:solidFill>
              <a:ln w="6350" cap="sq">
                <a:solidFill>
                  <a:schemeClr val="accent2"/>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43" name="テキスト ボックス 242">
                <a:extLst>
                  <a:ext uri="{FF2B5EF4-FFF2-40B4-BE49-F238E27FC236}">
                    <a16:creationId xmlns:a16="http://schemas.microsoft.com/office/drawing/2014/main" id="{4D688FA8-B072-2A80-9DC3-1AAF726842CB}"/>
                  </a:ext>
                </a:extLst>
              </p:cNvPr>
              <p:cNvSpPr txBox="1"/>
              <p:nvPr/>
            </p:nvSpPr>
            <p:spPr>
              <a:xfrm>
                <a:off x="5766380" y="4067424"/>
                <a:ext cx="31771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TOL1</a:t>
                </a:r>
              </a:p>
            </p:txBody>
          </p:sp>
        </p:grpSp>
        <p:sp>
          <p:nvSpPr>
            <p:cNvPr id="193" name="フリーフォーム: 図形 192">
              <a:extLst>
                <a:ext uri="{FF2B5EF4-FFF2-40B4-BE49-F238E27FC236}">
                  <a16:creationId xmlns:a16="http://schemas.microsoft.com/office/drawing/2014/main" id="{11C6865B-EC6C-F8B9-AFD1-9BF99EF641CA}"/>
                </a:ext>
              </a:extLst>
            </p:cNvPr>
            <p:cNvSpPr/>
            <p:nvPr/>
          </p:nvSpPr>
          <p:spPr>
            <a:xfrm>
              <a:off x="5432278" y="4276821"/>
              <a:ext cx="128518" cy="128518"/>
            </a:xfrm>
            <a:custGeom>
              <a:avLst/>
              <a:gdLst>
                <a:gd name="csX0" fmla="*/ 123250 w 128518"/>
                <a:gd name="csY0" fmla="*/ 64704 h 128518"/>
                <a:gd name="csX1" fmla="*/ 58991 w 128518"/>
                <a:gd name="csY1" fmla="*/ 128963 h 128518"/>
                <a:gd name="csX2" fmla="*/ -5269 w 128518"/>
                <a:gd name="csY2" fmla="*/ 64704 h 128518"/>
                <a:gd name="csX3" fmla="*/ 58991 w 128518"/>
                <a:gd name="csY3" fmla="*/ 445 h 128518"/>
                <a:gd name="csX4" fmla="*/ 123250 w 128518"/>
                <a:gd name="csY4" fmla="*/ 64704 h 128518"/>
              </a:gdLst>
              <a:ahLst/>
              <a:cxnLst>
                <a:cxn ang="0">
                  <a:pos x="csX0" y="csY0"/>
                </a:cxn>
                <a:cxn ang="0">
                  <a:pos x="csX1" y="csY1"/>
                </a:cxn>
                <a:cxn ang="0">
                  <a:pos x="csX2" y="csY2"/>
                </a:cxn>
                <a:cxn ang="0">
                  <a:pos x="csX3" y="csY3"/>
                </a:cxn>
                <a:cxn ang="0">
                  <a:pos x="csX4" y="csY4"/>
                </a:cxn>
              </a:cxnLst>
              <a:rect l="l" t="t" r="r" b="b"/>
              <a:pathLst>
                <a:path w="128518" h="128518">
                  <a:moveTo>
                    <a:pt x="123250" y="64704"/>
                  </a:moveTo>
                  <a:cubicBezTo>
                    <a:pt x="123250" y="100194"/>
                    <a:pt x="94480" y="128963"/>
                    <a:pt x="58991" y="128963"/>
                  </a:cubicBezTo>
                  <a:cubicBezTo>
                    <a:pt x="23501" y="128963"/>
                    <a:pt x="-5269" y="100194"/>
                    <a:pt x="-5269" y="64704"/>
                  </a:cubicBezTo>
                  <a:cubicBezTo>
                    <a:pt x="-5269" y="29215"/>
                    <a:pt x="23501" y="445"/>
                    <a:pt x="58991" y="445"/>
                  </a:cubicBezTo>
                  <a:cubicBezTo>
                    <a:pt x="94480" y="445"/>
                    <a:pt x="123250" y="29215"/>
                    <a:pt x="123250" y="64704"/>
                  </a:cubicBez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94" name="フリーフォーム: 図形 193">
              <a:extLst>
                <a:ext uri="{FF2B5EF4-FFF2-40B4-BE49-F238E27FC236}">
                  <a16:creationId xmlns:a16="http://schemas.microsoft.com/office/drawing/2014/main" id="{A2F26BE1-2C0F-6287-47A5-185CC8319CF6}"/>
                </a:ext>
              </a:extLst>
            </p:cNvPr>
            <p:cNvSpPr/>
            <p:nvPr/>
          </p:nvSpPr>
          <p:spPr>
            <a:xfrm>
              <a:off x="5432278" y="4276821"/>
              <a:ext cx="128518" cy="128518"/>
            </a:xfrm>
            <a:custGeom>
              <a:avLst/>
              <a:gdLst>
                <a:gd name="csX0" fmla="*/ 123250 w 128518"/>
                <a:gd name="csY0" fmla="*/ 64704 h 128518"/>
                <a:gd name="csX1" fmla="*/ 58991 w 128518"/>
                <a:gd name="csY1" fmla="*/ 128963 h 128518"/>
                <a:gd name="csX2" fmla="*/ -5269 w 128518"/>
                <a:gd name="csY2" fmla="*/ 64704 h 128518"/>
                <a:gd name="csX3" fmla="*/ 58991 w 128518"/>
                <a:gd name="csY3" fmla="*/ 445 h 128518"/>
                <a:gd name="csX4" fmla="*/ 123250 w 128518"/>
                <a:gd name="csY4" fmla="*/ 64704 h 128518"/>
              </a:gdLst>
              <a:ahLst/>
              <a:cxnLst>
                <a:cxn ang="0">
                  <a:pos x="csX0" y="csY0"/>
                </a:cxn>
                <a:cxn ang="0">
                  <a:pos x="csX1" y="csY1"/>
                </a:cxn>
                <a:cxn ang="0">
                  <a:pos x="csX2" y="csY2"/>
                </a:cxn>
                <a:cxn ang="0">
                  <a:pos x="csX3" y="csY3"/>
                </a:cxn>
                <a:cxn ang="0">
                  <a:pos x="csX4" y="csY4"/>
                </a:cxn>
              </a:cxnLst>
              <a:rect l="l" t="t" r="r" b="b"/>
              <a:pathLst>
                <a:path w="128518" h="128518">
                  <a:moveTo>
                    <a:pt x="123250" y="64704"/>
                  </a:moveTo>
                  <a:cubicBezTo>
                    <a:pt x="123250" y="100194"/>
                    <a:pt x="94480" y="128963"/>
                    <a:pt x="58991" y="128963"/>
                  </a:cubicBezTo>
                  <a:cubicBezTo>
                    <a:pt x="23501" y="128963"/>
                    <a:pt x="-5269" y="100194"/>
                    <a:pt x="-5269" y="64704"/>
                  </a:cubicBezTo>
                  <a:cubicBezTo>
                    <a:pt x="-5269" y="29215"/>
                    <a:pt x="23501" y="445"/>
                    <a:pt x="58991" y="445"/>
                  </a:cubicBezTo>
                  <a:cubicBezTo>
                    <a:pt x="94480" y="445"/>
                    <a:pt x="123250" y="29215"/>
                    <a:pt x="123250" y="64704"/>
                  </a:cubicBezTo>
                  <a:close/>
                </a:path>
              </a:pathLst>
            </a:custGeom>
            <a:solidFill>
              <a:srgbClr val="F8CDB8"/>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95" name="テキスト ボックス 194">
              <a:extLst>
                <a:ext uri="{FF2B5EF4-FFF2-40B4-BE49-F238E27FC236}">
                  <a16:creationId xmlns:a16="http://schemas.microsoft.com/office/drawing/2014/main" id="{501878A9-4F81-A98E-EA89-010752D2D73E}"/>
                </a:ext>
              </a:extLst>
            </p:cNvPr>
            <p:cNvSpPr txBox="1"/>
            <p:nvPr/>
          </p:nvSpPr>
          <p:spPr>
            <a:xfrm>
              <a:off x="5335451" y="4262718"/>
              <a:ext cx="31451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ZAT6</a:t>
              </a:r>
            </a:p>
          </p:txBody>
        </p:sp>
        <p:sp>
          <p:nvSpPr>
            <p:cNvPr id="196" name="フリーフォーム: 図形 195">
              <a:extLst>
                <a:ext uri="{FF2B5EF4-FFF2-40B4-BE49-F238E27FC236}">
                  <a16:creationId xmlns:a16="http://schemas.microsoft.com/office/drawing/2014/main" id="{560BF8C9-9C00-60BC-050D-D80765F9B23E}"/>
                </a:ext>
              </a:extLst>
            </p:cNvPr>
            <p:cNvSpPr/>
            <p:nvPr/>
          </p:nvSpPr>
          <p:spPr>
            <a:xfrm>
              <a:off x="5891472" y="4519985"/>
              <a:ext cx="128518" cy="128518"/>
            </a:xfrm>
            <a:custGeom>
              <a:avLst/>
              <a:gdLst>
                <a:gd name="csX0" fmla="*/ 123142 w 128518"/>
                <a:gd name="csY0" fmla="*/ 64647 h 128518"/>
                <a:gd name="csX1" fmla="*/ 58883 w 128518"/>
                <a:gd name="csY1" fmla="*/ 128906 h 128518"/>
                <a:gd name="csX2" fmla="*/ -5376 w 128518"/>
                <a:gd name="csY2" fmla="*/ 64647 h 128518"/>
                <a:gd name="csX3" fmla="*/ 58883 w 128518"/>
                <a:gd name="csY3" fmla="*/ 388 h 128518"/>
                <a:gd name="csX4" fmla="*/ 123142 w 128518"/>
                <a:gd name="csY4" fmla="*/ 64647 h 128518"/>
              </a:gdLst>
              <a:ahLst/>
              <a:cxnLst>
                <a:cxn ang="0">
                  <a:pos x="csX0" y="csY0"/>
                </a:cxn>
                <a:cxn ang="0">
                  <a:pos x="csX1" y="csY1"/>
                </a:cxn>
                <a:cxn ang="0">
                  <a:pos x="csX2" y="csY2"/>
                </a:cxn>
                <a:cxn ang="0">
                  <a:pos x="csX3" y="csY3"/>
                </a:cxn>
                <a:cxn ang="0">
                  <a:pos x="csX4" y="csY4"/>
                </a:cxn>
              </a:cxnLst>
              <a:rect l="l" t="t" r="r" b="b"/>
              <a:pathLst>
                <a:path w="128518" h="128518">
                  <a:moveTo>
                    <a:pt x="123142" y="64647"/>
                  </a:moveTo>
                  <a:cubicBezTo>
                    <a:pt x="123142" y="100136"/>
                    <a:pt x="94373" y="128906"/>
                    <a:pt x="58883" y="128906"/>
                  </a:cubicBezTo>
                  <a:cubicBezTo>
                    <a:pt x="23393" y="128906"/>
                    <a:pt x="-5376" y="100136"/>
                    <a:pt x="-5376" y="64647"/>
                  </a:cubicBezTo>
                  <a:cubicBezTo>
                    <a:pt x="-5376" y="29158"/>
                    <a:pt x="23393" y="388"/>
                    <a:pt x="58883" y="388"/>
                  </a:cubicBezTo>
                  <a:cubicBezTo>
                    <a:pt x="94373" y="388"/>
                    <a:pt x="123142" y="29158"/>
                    <a:pt x="123142" y="64647"/>
                  </a:cubicBezTo>
                  <a:close/>
                </a:path>
              </a:pathLst>
            </a:custGeom>
            <a:noFill/>
            <a:ln w="11669"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97" name="フリーフォーム: 図形 196">
              <a:extLst>
                <a:ext uri="{FF2B5EF4-FFF2-40B4-BE49-F238E27FC236}">
                  <a16:creationId xmlns:a16="http://schemas.microsoft.com/office/drawing/2014/main" id="{A55A4BE2-E92A-11C8-2D59-FD7421988220}"/>
                </a:ext>
              </a:extLst>
            </p:cNvPr>
            <p:cNvSpPr/>
            <p:nvPr/>
          </p:nvSpPr>
          <p:spPr>
            <a:xfrm>
              <a:off x="5891472" y="4519985"/>
              <a:ext cx="128518" cy="128518"/>
            </a:xfrm>
            <a:custGeom>
              <a:avLst/>
              <a:gdLst>
                <a:gd name="csX0" fmla="*/ 123142 w 128518"/>
                <a:gd name="csY0" fmla="*/ 64647 h 128518"/>
                <a:gd name="csX1" fmla="*/ 58883 w 128518"/>
                <a:gd name="csY1" fmla="*/ 128906 h 128518"/>
                <a:gd name="csX2" fmla="*/ -5376 w 128518"/>
                <a:gd name="csY2" fmla="*/ 64647 h 128518"/>
                <a:gd name="csX3" fmla="*/ 58883 w 128518"/>
                <a:gd name="csY3" fmla="*/ 388 h 128518"/>
                <a:gd name="csX4" fmla="*/ 123142 w 128518"/>
                <a:gd name="csY4" fmla="*/ 64647 h 128518"/>
              </a:gdLst>
              <a:ahLst/>
              <a:cxnLst>
                <a:cxn ang="0">
                  <a:pos x="csX0" y="csY0"/>
                </a:cxn>
                <a:cxn ang="0">
                  <a:pos x="csX1" y="csY1"/>
                </a:cxn>
                <a:cxn ang="0">
                  <a:pos x="csX2" y="csY2"/>
                </a:cxn>
                <a:cxn ang="0">
                  <a:pos x="csX3" y="csY3"/>
                </a:cxn>
                <a:cxn ang="0">
                  <a:pos x="csX4" y="csY4"/>
                </a:cxn>
              </a:cxnLst>
              <a:rect l="l" t="t" r="r" b="b"/>
              <a:pathLst>
                <a:path w="128518" h="128518">
                  <a:moveTo>
                    <a:pt x="123142" y="64647"/>
                  </a:moveTo>
                  <a:cubicBezTo>
                    <a:pt x="123142" y="100136"/>
                    <a:pt x="94373" y="128906"/>
                    <a:pt x="58883" y="128906"/>
                  </a:cubicBezTo>
                  <a:cubicBezTo>
                    <a:pt x="23393" y="128906"/>
                    <a:pt x="-5376" y="100136"/>
                    <a:pt x="-5376" y="64647"/>
                  </a:cubicBezTo>
                  <a:cubicBezTo>
                    <a:pt x="-5376" y="29158"/>
                    <a:pt x="23393" y="388"/>
                    <a:pt x="58883" y="388"/>
                  </a:cubicBezTo>
                  <a:cubicBezTo>
                    <a:pt x="94373" y="388"/>
                    <a:pt x="123142" y="29158"/>
                    <a:pt x="123142" y="64647"/>
                  </a:cubicBezTo>
                  <a:close/>
                </a:path>
              </a:pathLst>
            </a:custGeom>
            <a:solidFill>
              <a:srgbClr val="4292C6"/>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198" name="テキスト ボックス 197">
              <a:extLst>
                <a:ext uri="{FF2B5EF4-FFF2-40B4-BE49-F238E27FC236}">
                  <a16:creationId xmlns:a16="http://schemas.microsoft.com/office/drawing/2014/main" id="{E153191A-448B-5145-9DA5-9FAA477EB392}"/>
                </a:ext>
              </a:extLst>
            </p:cNvPr>
            <p:cNvSpPr txBox="1"/>
            <p:nvPr/>
          </p:nvSpPr>
          <p:spPr>
            <a:xfrm>
              <a:off x="5788193" y="4505882"/>
              <a:ext cx="32252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GRF4</a:t>
              </a:r>
            </a:p>
          </p:txBody>
        </p:sp>
        <p:sp>
          <p:nvSpPr>
            <p:cNvPr id="199" name="フリーフォーム: 図形 198">
              <a:extLst>
                <a:ext uri="{FF2B5EF4-FFF2-40B4-BE49-F238E27FC236}">
                  <a16:creationId xmlns:a16="http://schemas.microsoft.com/office/drawing/2014/main" id="{2D972A65-83CD-4877-5231-94DDA1E4C37A}"/>
                </a:ext>
              </a:extLst>
            </p:cNvPr>
            <p:cNvSpPr/>
            <p:nvPr/>
          </p:nvSpPr>
          <p:spPr>
            <a:xfrm>
              <a:off x="5192983" y="4707783"/>
              <a:ext cx="128518" cy="128518"/>
            </a:xfrm>
            <a:custGeom>
              <a:avLst/>
              <a:gdLst>
                <a:gd name="csX0" fmla="*/ 123306 w 128518"/>
                <a:gd name="csY0" fmla="*/ 64603 h 128518"/>
                <a:gd name="csX1" fmla="*/ 59047 w 128518"/>
                <a:gd name="csY1" fmla="*/ 128862 h 128518"/>
                <a:gd name="csX2" fmla="*/ -5212 w 128518"/>
                <a:gd name="csY2" fmla="*/ 64603 h 128518"/>
                <a:gd name="csX3" fmla="*/ 59047 w 128518"/>
                <a:gd name="csY3" fmla="*/ 344 h 128518"/>
                <a:gd name="csX4" fmla="*/ 123306 w 128518"/>
                <a:gd name="csY4" fmla="*/ 64603 h 128518"/>
              </a:gdLst>
              <a:ahLst/>
              <a:cxnLst>
                <a:cxn ang="0">
                  <a:pos x="csX0" y="csY0"/>
                </a:cxn>
                <a:cxn ang="0">
                  <a:pos x="csX1" y="csY1"/>
                </a:cxn>
                <a:cxn ang="0">
                  <a:pos x="csX2" y="csY2"/>
                </a:cxn>
                <a:cxn ang="0">
                  <a:pos x="csX3" y="csY3"/>
                </a:cxn>
                <a:cxn ang="0">
                  <a:pos x="csX4" y="csY4"/>
                </a:cxn>
              </a:cxnLst>
              <a:rect l="l" t="t" r="r" b="b"/>
              <a:pathLst>
                <a:path w="128518" h="128518">
                  <a:moveTo>
                    <a:pt x="123306" y="64603"/>
                  </a:moveTo>
                  <a:cubicBezTo>
                    <a:pt x="123306" y="100092"/>
                    <a:pt x="94537" y="128862"/>
                    <a:pt x="59047" y="128862"/>
                  </a:cubicBezTo>
                  <a:cubicBezTo>
                    <a:pt x="23557" y="128862"/>
                    <a:pt x="-5212" y="100092"/>
                    <a:pt x="-5212" y="64603"/>
                  </a:cubicBezTo>
                  <a:cubicBezTo>
                    <a:pt x="-5212" y="29113"/>
                    <a:pt x="23557" y="344"/>
                    <a:pt x="59047" y="344"/>
                  </a:cubicBezTo>
                  <a:cubicBezTo>
                    <a:pt x="94537" y="344"/>
                    <a:pt x="123306" y="29113"/>
                    <a:pt x="123306" y="64603"/>
                  </a:cubicBez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00" name="フリーフォーム: 図形 199">
              <a:extLst>
                <a:ext uri="{FF2B5EF4-FFF2-40B4-BE49-F238E27FC236}">
                  <a16:creationId xmlns:a16="http://schemas.microsoft.com/office/drawing/2014/main" id="{CE3E67FC-6B9D-5B2A-91DC-A0D2B53C46F9}"/>
                </a:ext>
              </a:extLst>
            </p:cNvPr>
            <p:cNvSpPr/>
            <p:nvPr/>
          </p:nvSpPr>
          <p:spPr>
            <a:xfrm>
              <a:off x="5192983" y="4707783"/>
              <a:ext cx="128518" cy="128518"/>
            </a:xfrm>
            <a:custGeom>
              <a:avLst/>
              <a:gdLst>
                <a:gd name="csX0" fmla="*/ 123306 w 128518"/>
                <a:gd name="csY0" fmla="*/ 64603 h 128518"/>
                <a:gd name="csX1" fmla="*/ 59047 w 128518"/>
                <a:gd name="csY1" fmla="*/ 128862 h 128518"/>
                <a:gd name="csX2" fmla="*/ -5212 w 128518"/>
                <a:gd name="csY2" fmla="*/ 64603 h 128518"/>
                <a:gd name="csX3" fmla="*/ 59047 w 128518"/>
                <a:gd name="csY3" fmla="*/ 344 h 128518"/>
                <a:gd name="csX4" fmla="*/ 123306 w 128518"/>
                <a:gd name="csY4" fmla="*/ 64603 h 128518"/>
              </a:gdLst>
              <a:ahLst/>
              <a:cxnLst>
                <a:cxn ang="0">
                  <a:pos x="csX0" y="csY0"/>
                </a:cxn>
                <a:cxn ang="0">
                  <a:pos x="csX1" y="csY1"/>
                </a:cxn>
                <a:cxn ang="0">
                  <a:pos x="csX2" y="csY2"/>
                </a:cxn>
                <a:cxn ang="0">
                  <a:pos x="csX3" y="csY3"/>
                </a:cxn>
                <a:cxn ang="0">
                  <a:pos x="csX4" y="csY4"/>
                </a:cxn>
              </a:cxnLst>
              <a:rect l="l" t="t" r="r" b="b"/>
              <a:pathLst>
                <a:path w="128518" h="128518">
                  <a:moveTo>
                    <a:pt x="123306" y="64603"/>
                  </a:moveTo>
                  <a:cubicBezTo>
                    <a:pt x="123306" y="100092"/>
                    <a:pt x="94537" y="128862"/>
                    <a:pt x="59047" y="128862"/>
                  </a:cubicBezTo>
                  <a:cubicBezTo>
                    <a:pt x="23557" y="128862"/>
                    <a:pt x="-5212" y="100092"/>
                    <a:pt x="-5212" y="64603"/>
                  </a:cubicBezTo>
                  <a:cubicBezTo>
                    <a:pt x="-5212" y="29113"/>
                    <a:pt x="23557" y="344"/>
                    <a:pt x="59047" y="344"/>
                  </a:cubicBezTo>
                  <a:cubicBezTo>
                    <a:pt x="94537" y="344"/>
                    <a:pt x="123306" y="29113"/>
                    <a:pt x="123306" y="64603"/>
                  </a:cubicBezTo>
                  <a:close/>
                </a:path>
              </a:pathLst>
            </a:custGeom>
            <a:solidFill>
              <a:srgbClr val="FA7837"/>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01" name="テキスト ボックス 200">
              <a:extLst>
                <a:ext uri="{FF2B5EF4-FFF2-40B4-BE49-F238E27FC236}">
                  <a16:creationId xmlns:a16="http://schemas.microsoft.com/office/drawing/2014/main" id="{702E8148-B215-9D26-6D94-F38C688B57A9}"/>
                </a:ext>
              </a:extLst>
            </p:cNvPr>
            <p:cNvSpPr txBox="1"/>
            <p:nvPr/>
          </p:nvSpPr>
          <p:spPr>
            <a:xfrm>
              <a:off x="5105619" y="4696360"/>
              <a:ext cx="298479"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IN2</a:t>
              </a:r>
            </a:p>
          </p:txBody>
        </p:sp>
        <p:grpSp>
          <p:nvGrpSpPr>
            <p:cNvPr id="202" name="グループ化 201">
              <a:extLst>
                <a:ext uri="{FF2B5EF4-FFF2-40B4-BE49-F238E27FC236}">
                  <a16:creationId xmlns:a16="http://schemas.microsoft.com/office/drawing/2014/main" id="{B8CFCDE8-6EDA-A05B-9FF0-8DCBEAD644A3}"/>
                </a:ext>
              </a:extLst>
            </p:cNvPr>
            <p:cNvGrpSpPr/>
            <p:nvPr/>
          </p:nvGrpSpPr>
          <p:grpSpPr>
            <a:xfrm>
              <a:off x="5734070" y="4368633"/>
              <a:ext cx="282449" cy="153888"/>
              <a:chOff x="5955833" y="4153368"/>
              <a:chExt cx="282449" cy="153888"/>
            </a:xfrm>
          </p:grpSpPr>
          <p:sp>
            <p:nvSpPr>
              <p:cNvPr id="240" name="フリーフォーム: 図形 239">
                <a:extLst>
                  <a:ext uri="{FF2B5EF4-FFF2-40B4-BE49-F238E27FC236}">
                    <a16:creationId xmlns:a16="http://schemas.microsoft.com/office/drawing/2014/main" id="{ACD073C2-E9AB-7473-CE00-32D6F6B7A6B6}"/>
                  </a:ext>
                </a:extLst>
              </p:cNvPr>
              <p:cNvSpPr/>
              <p:nvPr/>
            </p:nvSpPr>
            <p:spPr>
              <a:xfrm>
                <a:off x="6028867" y="4158312"/>
                <a:ext cx="144000" cy="144000"/>
              </a:xfrm>
              <a:custGeom>
                <a:avLst/>
                <a:gdLst>
                  <a:gd name="csX0" fmla="*/ 123159 w 128518"/>
                  <a:gd name="csY0" fmla="*/ 64679 h 128518"/>
                  <a:gd name="csX1" fmla="*/ 58900 w 128518"/>
                  <a:gd name="csY1" fmla="*/ 128938 h 128518"/>
                  <a:gd name="csX2" fmla="*/ -5360 w 128518"/>
                  <a:gd name="csY2" fmla="*/ 64679 h 128518"/>
                  <a:gd name="csX3" fmla="*/ 58900 w 128518"/>
                  <a:gd name="csY3" fmla="*/ 420 h 128518"/>
                  <a:gd name="csX4" fmla="*/ 123159 w 128518"/>
                  <a:gd name="csY4" fmla="*/ 64679 h 128518"/>
                </a:gdLst>
                <a:ahLst/>
                <a:cxnLst>
                  <a:cxn ang="0">
                    <a:pos x="csX0" y="csY0"/>
                  </a:cxn>
                  <a:cxn ang="0">
                    <a:pos x="csX1" y="csY1"/>
                  </a:cxn>
                  <a:cxn ang="0">
                    <a:pos x="csX2" y="csY2"/>
                  </a:cxn>
                  <a:cxn ang="0">
                    <a:pos x="csX3" y="csY3"/>
                  </a:cxn>
                  <a:cxn ang="0">
                    <a:pos x="csX4" y="csY4"/>
                  </a:cxn>
                </a:cxnLst>
                <a:rect l="l" t="t" r="r" b="b"/>
                <a:pathLst>
                  <a:path w="128518" h="128518">
                    <a:moveTo>
                      <a:pt x="123159" y="64679"/>
                    </a:moveTo>
                    <a:cubicBezTo>
                      <a:pt x="123159" y="100168"/>
                      <a:pt x="94389" y="128938"/>
                      <a:pt x="58900" y="128938"/>
                    </a:cubicBezTo>
                    <a:cubicBezTo>
                      <a:pt x="23410" y="128938"/>
                      <a:pt x="-5360" y="100168"/>
                      <a:pt x="-5360" y="64679"/>
                    </a:cubicBezTo>
                    <a:cubicBezTo>
                      <a:pt x="-5360" y="29189"/>
                      <a:pt x="23410" y="420"/>
                      <a:pt x="58900" y="420"/>
                    </a:cubicBezTo>
                    <a:cubicBezTo>
                      <a:pt x="94389" y="420"/>
                      <a:pt x="123159" y="29189"/>
                      <a:pt x="123159" y="64679"/>
                    </a:cubicBezTo>
                    <a:close/>
                  </a:path>
                </a:pathLst>
              </a:custGeom>
              <a:solidFill>
                <a:srgbClr val="D4E4EE"/>
              </a:solidFill>
              <a:ln w="6350" cap="sq">
                <a:solidFill>
                  <a:srgbClr val="0070C0"/>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41" name="テキスト ボックス 240">
                <a:extLst>
                  <a:ext uri="{FF2B5EF4-FFF2-40B4-BE49-F238E27FC236}">
                    <a16:creationId xmlns:a16="http://schemas.microsoft.com/office/drawing/2014/main" id="{40EADA3D-2CC0-36B2-E53A-77FE277CE486}"/>
                  </a:ext>
                </a:extLst>
              </p:cNvPr>
              <p:cNvSpPr txBox="1"/>
              <p:nvPr/>
            </p:nvSpPr>
            <p:spPr>
              <a:xfrm>
                <a:off x="5955833" y="4153368"/>
                <a:ext cx="282449"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TPL</a:t>
                </a:r>
              </a:p>
            </p:txBody>
          </p:sp>
        </p:grpSp>
        <p:sp>
          <p:nvSpPr>
            <p:cNvPr id="203" name="フリーフォーム: 図形 202">
              <a:extLst>
                <a:ext uri="{FF2B5EF4-FFF2-40B4-BE49-F238E27FC236}">
                  <a16:creationId xmlns:a16="http://schemas.microsoft.com/office/drawing/2014/main" id="{35365685-D507-E008-E9AB-AAEDD0EF759A}"/>
                </a:ext>
              </a:extLst>
            </p:cNvPr>
            <p:cNvSpPr/>
            <p:nvPr/>
          </p:nvSpPr>
          <p:spPr>
            <a:xfrm>
              <a:off x="5073947" y="4416594"/>
              <a:ext cx="128518" cy="128518"/>
            </a:xfrm>
            <a:custGeom>
              <a:avLst/>
              <a:gdLst>
                <a:gd name="csX0" fmla="*/ 123334 w 128518"/>
                <a:gd name="csY0" fmla="*/ 64671 h 128518"/>
                <a:gd name="csX1" fmla="*/ 59075 w 128518"/>
                <a:gd name="csY1" fmla="*/ 128930 h 128518"/>
                <a:gd name="csX2" fmla="*/ -5184 w 128518"/>
                <a:gd name="csY2" fmla="*/ 64671 h 128518"/>
                <a:gd name="csX3" fmla="*/ 59075 w 128518"/>
                <a:gd name="csY3" fmla="*/ 412 h 128518"/>
                <a:gd name="csX4" fmla="*/ 123334 w 128518"/>
                <a:gd name="csY4" fmla="*/ 64671 h 128518"/>
              </a:gdLst>
              <a:ahLst/>
              <a:cxnLst>
                <a:cxn ang="0">
                  <a:pos x="csX0" y="csY0"/>
                </a:cxn>
                <a:cxn ang="0">
                  <a:pos x="csX1" y="csY1"/>
                </a:cxn>
                <a:cxn ang="0">
                  <a:pos x="csX2" y="csY2"/>
                </a:cxn>
                <a:cxn ang="0">
                  <a:pos x="csX3" y="csY3"/>
                </a:cxn>
                <a:cxn ang="0">
                  <a:pos x="csX4" y="csY4"/>
                </a:cxn>
              </a:cxnLst>
              <a:rect l="l" t="t" r="r" b="b"/>
              <a:pathLst>
                <a:path w="128518" h="128518">
                  <a:moveTo>
                    <a:pt x="123334" y="64671"/>
                  </a:moveTo>
                  <a:cubicBezTo>
                    <a:pt x="123334" y="100161"/>
                    <a:pt x="94565" y="128930"/>
                    <a:pt x="59075" y="128930"/>
                  </a:cubicBezTo>
                  <a:cubicBezTo>
                    <a:pt x="23585" y="128930"/>
                    <a:pt x="-5184" y="100161"/>
                    <a:pt x="-5184" y="64671"/>
                  </a:cubicBezTo>
                  <a:cubicBezTo>
                    <a:pt x="-5184" y="29182"/>
                    <a:pt x="23585" y="412"/>
                    <a:pt x="59075" y="412"/>
                  </a:cubicBezTo>
                  <a:cubicBezTo>
                    <a:pt x="94565" y="412"/>
                    <a:pt x="123334" y="29182"/>
                    <a:pt x="123334" y="64671"/>
                  </a:cubicBezTo>
                  <a:close/>
                </a:path>
              </a:pathLst>
            </a:custGeom>
            <a:noFill/>
            <a:ln w="11669"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04" name="フリーフォーム: 図形 203">
              <a:extLst>
                <a:ext uri="{FF2B5EF4-FFF2-40B4-BE49-F238E27FC236}">
                  <a16:creationId xmlns:a16="http://schemas.microsoft.com/office/drawing/2014/main" id="{CE20B721-B197-91CA-D1CD-8B4C2E8376E0}"/>
                </a:ext>
              </a:extLst>
            </p:cNvPr>
            <p:cNvSpPr/>
            <p:nvPr/>
          </p:nvSpPr>
          <p:spPr>
            <a:xfrm>
              <a:off x="5073947" y="4416594"/>
              <a:ext cx="128518" cy="128518"/>
            </a:xfrm>
            <a:custGeom>
              <a:avLst/>
              <a:gdLst>
                <a:gd name="csX0" fmla="*/ 123334 w 128518"/>
                <a:gd name="csY0" fmla="*/ 64671 h 128518"/>
                <a:gd name="csX1" fmla="*/ 59075 w 128518"/>
                <a:gd name="csY1" fmla="*/ 128930 h 128518"/>
                <a:gd name="csX2" fmla="*/ -5184 w 128518"/>
                <a:gd name="csY2" fmla="*/ 64671 h 128518"/>
                <a:gd name="csX3" fmla="*/ 59075 w 128518"/>
                <a:gd name="csY3" fmla="*/ 412 h 128518"/>
                <a:gd name="csX4" fmla="*/ 123334 w 128518"/>
                <a:gd name="csY4" fmla="*/ 64671 h 128518"/>
              </a:gdLst>
              <a:ahLst/>
              <a:cxnLst>
                <a:cxn ang="0">
                  <a:pos x="csX0" y="csY0"/>
                </a:cxn>
                <a:cxn ang="0">
                  <a:pos x="csX1" y="csY1"/>
                </a:cxn>
                <a:cxn ang="0">
                  <a:pos x="csX2" y="csY2"/>
                </a:cxn>
                <a:cxn ang="0">
                  <a:pos x="csX3" y="csY3"/>
                </a:cxn>
                <a:cxn ang="0">
                  <a:pos x="csX4" y="csY4"/>
                </a:cxn>
              </a:cxnLst>
              <a:rect l="l" t="t" r="r" b="b"/>
              <a:pathLst>
                <a:path w="128518" h="128518">
                  <a:moveTo>
                    <a:pt x="123334" y="64671"/>
                  </a:moveTo>
                  <a:cubicBezTo>
                    <a:pt x="123334" y="100161"/>
                    <a:pt x="94565" y="128930"/>
                    <a:pt x="59075" y="128930"/>
                  </a:cubicBezTo>
                  <a:cubicBezTo>
                    <a:pt x="23585" y="128930"/>
                    <a:pt x="-5184" y="100161"/>
                    <a:pt x="-5184" y="64671"/>
                  </a:cubicBezTo>
                  <a:cubicBezTo>
                    <a:pt x="-5184" y="29182"/>
                    <a:pt x="23585" y="412"/>
                    <a:pt x="59075" y="412"/>
                  </a:cubicBezTo>
                  <a:cubicBezTo>
                    <a:pt x="94565" y="412"/>
                    <a:pt x="123334" y="29182"/>
                    <a:pt x="123334" y="64671"/>
                  </a:cubicBezTo>
                  <a:close/>
                </a:path>
              </a:pathLst>
            </a:custGeom>
            <a:solidFill>
              <a:srgbClr val="4292C6"/>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05" name="テキスト ボックス 204">
              <a:extLst>
                <a:ext uri="{FF2B5EF4-FFF2-40B4-BE49-F238E27FC236}">
                  <a16:creationId xmlns:a16="http://schemas.microsoft.com/office/drawing/2014/main" id="{A59D06D0-D690-CEEE-D5D7-34174FF2F0EF}"/>
                </a:ext>
              </a:extLst>
            </p:cNvPr>
            <p:cNvSpPr txBox="1"/>
            <p:nvPr/>
          </p:nvSpPr>
          <p:spPr>
            <a:xfrm>
              <a:off x="4981930" y="4404396"/>
              <a:ext cx="298479"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MK</a:t>
              </a:r>
            </a:p>
          </p:txBody>
        </p:sp>
        <p:grpSp>
          <p:nvGrpSpPr>
            <p:cNvPr id="206" name="グループ化 205">
              <a:extLst>
                <a:ext uri="{FF2B5EF4-FFF2-40B4-BE49-F238E27FC236}">
                  <a16:creationId xmlns:a16="http://schemas.microsoft.com/office/drawing/2014/main" id="{C9C0AA8F-06CD-F743-6FBA-E7CC5C96DBE5}"/>
                </a:ext>
              </a:extLst>
            </p:cNvPr>
            <p:cNvGrpSpPr/>
            <p:nvPr/>
          </p:nvGrpSpPr>
          <p:grpSpPr>
            <a:xfrm>
              <a:off x="5063781" y="4157104"/>
              <a:ext cx="327334" cy="153888"/>
              <a:chOff x="5202449" y="4126624"/>
              <a:chExt cx="327334" cy="153888"/>
            </a:xfrm>
          </p:grpSpPr>
          <p:sp>
            <p:nvSpPr>
              <p:cNvPr id="238" name="フリーフォーム: 図形 237">
                <a:extLst>
                  <a:ext uri="{FF2B5EF4-FFF2-40B4-BE49-F238E27FC236}">
                    <a16:creationId xmlns:a16="http://schemas.microsoft.com/office/drawing/2014/main" id="{C2951DD5-D2AD-4079-09D1-CAC5EF9E728C}"/>
                  </a:ext>
                </a:extLst>
              </p:cNvPr>
              <p:cNvSpPr/>
              <p:nvPr/>
            </p:nvSpPr>
            <p:spPr>
              <a:xfrm>
                <a:off x="5297926" y="4131568"/>
                <a:ext cx="144000" cy="144000"/>
              </a:xfrm>
              <a:custGeom>
                <a:avLst/>
                <a:gdLst>
                  <a:gd name="csX0" fmla="*/ 123215 w 128518"/>
                  <a:gd name="csY0" fmla="*/ 64671 h 128518"/>
                  <a:gd name="csX1" fmla="*/ 58956 w 128518"/>
                  <a:gd name="csY1" fmla="*/ 128930 h 128518"/>
                  <a:gd name="csX2" fmla="*/ -5304 w 128518"/>
                  <a:gd name="csY2" fmla="*/ 64671 h 128518"/>
                  <a:gd name="csX3" fmla="*/ 58956 w 128518"/>
                  <a:gd name="csY3" fmla="*/ 412 h 128518"/>
                  <a:gd name="csX4" fmla="*/ 123215 w 128518"/>
                  <a:gd name="csY4" fmla="*/ 64671 h 128518"/>
                </a:gdLst>
                <a:ahLst/>
                <a:cxnLst>
                  <a:cxn ang="0">
                    <a:pos x="csX0" y="csY0"/>
                  </a:cxn>
                  <a:cxn ang="0">
                    <a:pos x="csX1" y="csY1"/>
                  </a:cxn>
                  <a:cxn ang="0">
                    <a:pos x="csX2" y="csY2"/>
                  </a:cxn>
                  <a:cxn ang="0">
                    <a:pos x="csX3" y="csY3"/>
                  </a:cxn>
                  <a:cxn ang="0">
                    <a:pos x="csX4" y="csY4"/>
                  </a:cxn>
                </a:cxnLst>
                <a:rect l="l" t="t" r="r" b="b"/>
                <a:pathLst>
                  <a:path w="128518" h="128518">
                    <a:moveTo>
                      <a:pt x="123215" y="64671"/>
                    </a:moveTo>
                    <a:cubicBezTo>
                      <a:pt x="123215" y="100160"/>
                      <a:pt x="94445" y="128930"/>
                      <a:pt x="58956" y="128930"/>
                    </a:cubicBezTo>
                    <a:cubicBezTo>
                      <a:pt x="23466" y="128930"/>
                      <a:pt x="-5304" y="100160"/>
                      <a:pt x="-5304" y="64671"/>
                    </a:cubicBezTo>
                    <a:cubicBezTo>
                      <a:pt x="-5304" y="29181"/>
                      <a:pt x="23466" y="412"/>
                      <a:pt x="58956" y="412"/>
                    </a:cubicBezTo>
                    <a:cubicBezTo>
                      <a:pt x="94445" y="412"/>
                      <a:pt x="123215" y="29181"/>
                      <a:pt x="123215" y="64671"/>
                    </a:cubicBezTo>
                    <a:close/>
                  </a:path>
                </a:pathLst>
              </a:custGeom>
              <a:solidFill>
                <a:srgbClr val="F8DFD3"/>
              </a:solidFill>
              <a:ln w="6350" cap="sq">
                <a:solidFill>
                  <a:schemeClr val="accent2"/>
                </a:solidFill>
                <a:prstDash val="solid"/>
                <a:miter/>
              </a:ln>
            </p:spPr>
            <p:txBody>
              <a:bodyPr anchor="ctr"/>
              <a:lstStyle/>
              <a:p>
                <a:pPr algn="ctr"/>
                <a:endParaRPr lang="ja-JP" altLang="en-US" sz="400" b="1" dirty="0">
                  <a:ln w="0"/>
                  <a:latin typeface="Arial" panose="020B0604020202020204" pitchFamily="34" charset="0"/>
                  <a:cs typeface="Arial" panose="020B0604020202020204" pitchFamily="34" charset="0"/>
                </a:endParaRPr>
              </a:p>
            </p:txBody>
          </p:sp>
          <p:sp>
            <p:nvSpPr>
              <p:cNvPr id="239" name="テキスト ボックス 238">
                <a:extLst>
                  <a:ext uri="{FF2B5EF4-FFF2-40B4-BE49-F238E27FC236}">
                    <a16:creationId xmlns:a16="http://schemas.microsoft.com/office/drawing/2014/main" id="{330B23F9-1250-EF6C-EE18-F19C3896540C}"/>
                  </a:ext>
                </a:extLst>
              </p:cNvPr>
              <p:cNvSpPr txBox="1"/>
              <p:nvPr/>
            </p:nvSpPr>
            <p:spPr>
              <a:xfrm>
                <a:off x="5202449" y="4126624"/>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UGD4</a:t>
                </a:r>
              </a:p>
            </p:txBody>
          </p:sp>
        </p:grpSp>
        <p:sp>
          <p:nvSpPr>
            <p:cNvPr id="207" name="フリーフォーム: 図形 206">
              <a:extLst>
                <a:ext uri="{FF2B5EF4-FFF2-40B4-BE49-F238E27FC236}">
                  <a16:creationId xmlns:a16="http://schemas.microsoft.com/office/drawing/2014/main" id="{13858170-0408-AA1E-3A0A-C97E858D6D5B}"/>
                </a:ext>
              </a:extLst>
            </p:cNvPr>
            <p:cNvSpPr/>
            <p:nvPr/>
          </p:nvSpPr>
          <p:spPr>
            <a:xfrm>
              <a:off x="5525680" y="5076631"/>
              <a:ext cx="144000" cy="144000"/>
            </a:xfrm>
            <a:custGeom>
              <a:avLst/>
              <a:gdLst>
                <a:gd name="csX0" fmla="*/ 123222 w 128518"/>
                <a:gd name="csY0" fmla="*/ 64525 h 128518"/>
                <a:gd name="csX1" fmla="*/ 58963 w 128518"/>
                <a:gd name="csY1" fmla="*/ 128784 h 128518"/>
                <a:gd name="csX2" fmla="*/ -5296 w 128518"/>
                <a:gd name="csY2" fmla="*/ 64525 h 128518"/>
                <a:gd name="csX3" fmla="*/ 58963 w 128518"/>
                <a:gd name="csY3" fmla="*/ 266 h 128518"/>
                <a:gd name="csX4" fmla="*/ 123222 w 128518"/>
                <a:gd name="csY4" fmla="*/ 64525 h 128518"/>
              </a:gdLst>
              <a:ahLst/>
              <a:cxnLst>
                <a:cxn ang="0">
                  <a:pos x="csX0" y="csY0"/>
                </a:cxn>
                <a:cxn ang="0">
                  <a:pos x="csX1" y="csY1"/>
                </a:cxn>
                <a:cxn ang="0">
                  <a:pos x="csX2" y="csY2"/>
                </a:cxn>
                <a:cxn ang="0">
                  <a:pos x="csX3" y="csY3"/>
                </a:cxn>
                <a:cxn ang="0">
                  <a:pos x="csX4" y="csY4"/>
                </a:cxn>
              </a:cxnLst>
              <a:rect l="l" t="t" r="r" b="b"/>
              <a:pathLst>
                <a:path w="128518" h="128518">
                  <a:moveTo>
                    <a:pt x="123222" y="64525"/>
                  </a:moveTo>
                  <a:cubicBezTo>
                    <a:pt x="123222" y="100014"/>
                    <a:pt x="94453" y="128784"/>
                    <a:pt x="58963" y="128784"/>
                  </a:cubicBezTo>
                  <a:cubicBezTo>
                    <a:pt x="23473" y="128784"/>
                    <a:pt x="-5296" y="100014"/>
                    <a:pt x="-5296" y="64525"/>
                  </a:cubicBezTo>
                  <a:cubicBezTo>
                    <a:pt x="-5296" y="29036"/>
                    <a:pt x="23473" y="266"/>
                    <a:pt x="58963" y="266"/>
                  </a:cubicBezTo>
                  <a:cubicBezTo>
                    <a:pt x="94453" y="266"/>
                    <a:pt x="123222" y="29036"/>
                    <a:pt x="123222" y="64525"/>
                  </a:cubicBezTo>
                  <a:close/>
                </a:path>
              </a:pathLst>
            </a:custGeom>
            <a:solidFill>
              <a:srgbClr val="4292C6"/>
            </a:solidFill>
            <a:ln w="6350" cap="sq">
              <a:solidFill>
                <a:srgbClr val="0070C0"/>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08" name="テキスト ボックス 207">
              <a:extLst>
                <a:ext uri="{FF2B5EF4-FFF2-40B4-BE49-F238E27FC236}">
                  <a16:creationId xmlns:a16="http://schemas.microsoft.com/office/drawing/2014/main" id="{68C7C912-4CDE-4FAB-F0E8-95EDB90387D4}"/>
                </a:ext>
              </a:extLst>
            </p:cNvPr>
            <p:cNvSpPr txBox="1"/>
            <p:nvPr/>
          </p:nvSpPr>
          <p:spPr>
            <a:xfrm>
              <a:off x="5412824" y="5073189"/>
              <a:ext cx="35939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ATCTH</a:t>
              </a:r>
            </a:p>
          </p:txBody>
        </p:sp>
        <p:sp>
          <p:nvSpPr>
            <p:cNvPr id="209" name="フリーフォーム: 図形 208">
              <a:extLst>
                <a:ext uri="{FF2B5EF4-FFF2-40B4-BE49-F238E27FC236}">
                  <a16:creationId xmlns:a16="http://schemas.microsoft.com/office/drawing/2014/main" id="{59EC69E4-D431-C3E6-6D97-7DF0C2F6F95A}"/>
                </a:ext>
              </a:extLst>
            </p:cNvPr>
            <p:cNvSpPr/>
            <p:nvPr/>
          </p:nvSpPr>
          <p:spPr>
            <a:xfrm>
              <a:off x="5206192" y="4882803"/>
              <a:ext cx="128518" cy="128518"/>
            </a:xfrm>
            <a:custGeom>
              <a:avLst/>
              <a:gdLst>
                <a:gd name="csX0" fmla="*/ 123303 w 128518"/>
                <a:gd name="csY0" fmla="*/ 64562 h 128518"/>
                <a:gd name="csX1" fmla="*/ 59044 w 128518"/>
                <a:gd name="csY1" fmla="*/ 128821 h 128518"/>
                <a:gd name="csX2" fmla="*/ -5215 w 128518"/>
                <a:gd name="csY2" fmla="*/ 64562 h 128518"/>
                <a:gd name="csX3" fmla="*/ 59044 w 128518"/>
                <a:gd name="csY3" fmla="*/ 303 h 128518"/>
                <a:gd name="csX4" fmla="*/ 123303 w 128518"/>
                <a:gd name="csY4" fmla="*/ 64562 h 128518"/>
              </a:gdLst>
              <a:ahLst/>
              <a:cxnLst>
                <a:cxn ang="0">
                  <a:pos x="csX0" y="csY0"/>
                </a:cxn>
                <a:cxn ang="0">
                  <a:pos x="csX1" y="csY1"/>
                </a:cxn>
                <a:cxn ang="0">
                  <a:pos x="csX2" y="csY2"/>
                </a:cxn>
                <a:cxn ang="0">
                  <a:pos x="csX3" y="csY3"/>
                </a:cxn>
                <a:cxn ang="0">
                  <a:pos x="csX4" y="csY4"/>
                </a:cxn>
              </a:cxnLst>
              <a:rect l="l" t="t" r="r" b="b"/>
              <a:pathLst>
                <a:path w="128518" h="128518">
                  <a:moveTo>
                    <a:pt x="123303" y="64562"/>
                  </a:moveTo>
                  <a:cubicBezTo>
                    <a:pt x="123303" y="100051"/>
                    <a:pt x="94534" y="128821"/>
                    <a:pt x="59044" y="128821"/>
                  </a:cubicBezTo>
                  <a:cubicBezTo>
                    <a:pt x="23554" y="128821"/>
                    <a:pt x="-5215" y="100051"/>
                    <a:pt x="-5215" y="64562"/>
                  </a:cubicBezTo>
                  <a:cubicBezTo>
                    <a:pt x="-5215" y="29072"/>
                    <a:pt x="23554" y="303"/>
                    <a:pt x="59044" y="303"/>
                  </a:cubicBezTo>
                  <a:cubicBezTo>
                    <a:pt x="94534" y="303"/>
                    <a:pt x="123303" y="29072"/>
                    <a:pt x="123303" y="64562"/>
                  </a:cubicBez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10" name="フリーフォーム: 図形 209">
              <a:extLst>
                <a:ext uri="{FF2B5EF4-FFF2-40B4-BE49-F238E27FC236}">
                  <a16:creationId xmlns:a16="http://schemas.microsoft.com/office/drawing/2014/main" id="{CA1FC69E-0C2E-0186-D9DB-EE1636CAF0EF}"/>
                </a:ext>
              </a:extLst>
            </p:cNvPr>
            <p:cNvSpPr/>
            <p:nvPr/>
          </p:nvSpPr>
          <p:spPr>
            <a:xfrm>
              <a:off x="5206192" y="4882803"/>
              <a:ext cx="128518" cy="128518"/>
            </a:xfrm>
            <a:custGeom>
              <a:avLst/>
              <a:gdLst>
                <a:gd name="csX0" fmla="*/ 123303 w 128518"/>
                <a:gd name="csY0" fmla="*/ 64562 h 128518"/>
                <a:gd name="csX1" fmla="*/ 59044 w 128518"/>
                <a:gd name="csY1" fmla="*/ 128821 h 128518"/>
                <a:gd name="csX2" fmla="*/ -5215 w 128518"/>
                <a:gd name="csY2" fmla="*/ 64562 h 128518"/>
                <a:gd name="csX3" fmla="*/ 59044 w 128518"/>
                <a:gd name="csY3" fmla="*/ 303 h 128518"/>
                <a:gd name="csX4" fmla="*/ 123303 w 128518"/>
                <a:gd name="csY4" fmla="*/ 64562 h 128518"/>
              </a:gdLst>
              <a:ahLst/>
              <a:cxnLst>
                <a:cxn ang="0">
                  <a:pos x="csX0" y="csY0"/>
                </a:cxn>
                <a:cxn ang="0">
                  <a:pos x="csX1" y="csY1"/>
                </a:cxn>
                <a:cxn ang="0">
                  <a:pos x="csX2" y="csY2"/>
                </a:cxn>
                <a:cxn ang="0">
                  <a:pos x="csX3" y="csY3"/>
                </a:cxn>
                <a:cxn ang="0">
                  <a:pos x="csX4" y="csY4"/>
                </a:cxn>
              </a:cxnLst>
              <a:rect l="l" t="t" r="r" b="b"/>
              <a:pathLst>
                <a:path w="128518" h="128518">
                  <a:moveTo>
                    <a:pt x="123303" y="64562"/>
                  </a:moveTo>
                  <a:cubicBezTo>
                    <a:pt x="123303" y="100051"/>
                    <a:pt x="94534" y="128821"/>
                    <a:pt x="59044" y="128821"/>
                  </a:cubicBezTo>
                  <a:cubicBezTo>
                    <a:pt x="23554" y="128821"/>
                    <a:pt x="-5215" y="100051"/>
                    <a:pt x="-5215" y="64562"/>
                  </a:cubicBezTo>
                  <a:cubicBezTo>
                    <a:pt x="-5215" y="29072"/>
                    <a:pt x="23554" y="303"/>
                    <a:pt x="59044" y="303"/>
                  </a:cubicBezTo>
                  <a:cubicBezTo>
                    <a:pt x="94534" y="303"/>
                    <a:pt x="123303" y="29072"/>
                    <a:pt x="123303" y="64562"/>
                  </a:cubicBezTo>
                  <a:close/>
                </a:path>
              </a:pathLst>
            </a:custGeom>
            <a:solidFill>
              <a:srgbClr val="FA7837"/>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11" name="テキスト ボックス 210">
              <a:extLst>
                <a:ext uri="{FF2B5EF4-FFF2-40B4-BE49-F238E27FC236}">
                  <a16:creationId xmlns:a16="http://schemas.microsoft.com/office/drawing/2014/main" id="{8BA1421F-6AF6-6D7C-D32B-3588E457AF5D}"/>
                </a:ext>
              </a:extLst>
            </p:cNvPr>
            <p:cNvSpPr txBox="1"/>
            <p:nvPr/>
          </p:nvSpPr>
          <p:spPr>
            <a:xfrm>
              <a:off x="5109336" y="4875232"/>
              <a:ext cx="31771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EXA1</a:t>
              </a:r>
            </a:p>
          </p:txBody>
        </p:sp>
        <p:sp>
          <p:nvSpPr>
            <p:cNvPr id="212" name="フリーフォーム: 図形 211">
              <a:extLst>
                <a:ext uri="{FF2B5EF4-FFF2-40B4-BE49-F238E27FC236}">
                  <a16:creationId xmlns:a16="http://schemas.microsoft.com/office/drawing/2014/main" id="{2A4F2E14-3696-F2BF-77A2-4E04D9FC1222}"/>
                </a:ext>
              </a:extLst>
            </p:cNvPr>
            <p:cNvSpPr/>
            <p:nvPr/>
          </p:nvSpPr>
          <p:spPr>
            <a:xfrm>
              <a:off x="6007775" y="5294719"/>
              <a:ext cx="128518" cy="128518"/>
            </a:xfrm>
            <a:custGeom>
              <a:avLst/>
              <a:gdLst>
                <a:gd name="csX0" fmla="*/ 123115 w 128518"/>
                <a:gd name="csY0" fmla="*/ 64465 h 128518"/>
                <a:gd name="csX1" fmla="*/ 58855 w 128518"/>
                <a:gd name="csY1" fmla="*/ 128724 h 128518"/>
                <a:gd name="csX2" fmla="*/ -5404 w 128518"/>
                <a:gd name="csY2" fmla="*/ 64465 h 128518"/>
                <a:gd name="csX3" fmla="*/ 58855 w 128518"/>
                <a:gd name="csY3" fmla="*/ 206 h 128518"/>
                <a:gd name="csX4" fmla="*/ 123115 w 128518"/>
                <a:gd name="csY4" fmla="*/ 64465 h 128518"/>
              </a:gdLst>
              <a:ahLst/>
              <a:cxnLst>
                <a:cxn ang="0">
                  <a:pos x="csX0" y="csY0"/>
                </a:cxn>
                <a:cxn ang="0">
                  <a:pos x="csX1" y="csY1"/>
                </a:cxn>
                <a:cxn ang="0">
                  <a:pos x="csX2" y="csY2"/>
                </a:cxn>
                <a:cxn ang="0">
                  <a:pos x="csX3" y="csY3"/>
                </a:cxn>
                <a:cxn ang="0">
                  <a:pos x="csX4" y="csY4"/>
                </a:cxn>
              </a:cxnLst>
              <a:rect l="l" t="t" r="r" b="b"/>
              <a:pathLst>
                <a:path w="128518" h="128518">
                  <a:moveTo>
                    <a:pt x="123115" y="64465"/>
                  </a:moveTo>
                  <a:cubicBezTo>
                    <a:pt x="123115" y="99954"/>
                    <a:pt x="94345" y="128724"/>
                    <a:pt x="58855" y="128724"/>
                  </a:cubicBezTo>
                  <a:cubicBezTo>
                    <a:pt x="23366" y="128724"/>
                    <a:pt x="-5404" y="99954"/>
                    <a:pt x="-5404" y="64465"/>
                  </a:cubicBezTo>
                  <a:cubicBezTo>
                    <a:pt x="-5404" y="28975"/>
                    <a:pt x="23366" y="206"/>
                    <a:pt x="58855" y="206"/>
                  </a:cubicBezTo>
                  <a:cubicBezTo>
                    <a:pt x="94345" y="206"/>
                    <a:pt x="123115" y="28975"/>
                    <a:pt x="123115" y="64465"/>
                  </a:cubicBez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13" name="フリーフォーム: 図形 212">
              <a:extLst>
                <a:ext uri="{FF2B5EF4-FFF2-40B4-BE49-F238E27FC236}">
                  <a16:creationId xmlns:a16="http://schemas.microsoft.com/office/drawing/2014/main" id="{A3C2DF76-6EFD-6F8B-9615-6912A5037A8C}"/>
                </a:ext>
              </a:extLst>
            </p:cNvPr>
            <p:cNvSpPr/>
            <p:nvPr/>
          </p:nvSpPr>
          <p:spPr>
            <a:xfrm>
              <a:off x="6007775" y="5294719"/>
              <a:ext cx="128518" cy="128518"/>
            </a:xfrm>
            <a:custGeom>
              <a:avLst/>
              <a:gdLst>
                <a:gd name="csX0" fmla="*/ 123115 w 128518"/>
                <a:gd name="csY0" fmla="*/ 64465 h 128518"/>
                <a:gd name="csX1" fmla="*/ 58855 w 128518"/>
                <a:gd name="csY1" fmla="*/ 128724 h 128518"/>
                <a:gd name="csX2" fmla="*/ -5404 w 128518"/>
                <a:gd name="csY2" fmla="*/ 64465 h 128518"/>
                <a:gd name="csX3" fmla="*/ 58855 w 128518"/>
                <a:gd name="csY3" fmla="*/ 206 h 128518"/>
                <a:gd name="csX4" fmla="*/ 123115 w 128518"/>
                <a:gd name="csY4" fmla="*/ 64465 h 128518"/>
              </a:gdLst>
              <a:ahLst/>
              <a:cxnLst>
                <a:cxn ang="0">
                  <a:pos x="csX0" y="csY0"/>
                </a:cxn>
                <a:cxn ang="0">
                  <a:pos x="csX1" y="csY1"/>
                </a:cxn>
                <a:cxn ang="0">
                  <a:pos x="csX2" y="csY2"/>
                </a:cxn>
                <a:cxn ang="0">
                  <a:pos x="csX3" y="csY3"/>
                </a:cxn>
                <a:cxn ang="0">
                  <a:pos x="csX4" y="csY4"/>
                </a:cxn>
              </a:cxnLst>
              <a:rect l="l" t="t" r="r" b="b"/>
              <a:pathLst>
                <a:path w="128518" h="128518">
                  <a:moveTo>
                    <a:pt x="123115" y="64465"/>
                  </a:moveTo>
                  <a:cubicBezTo>
                    <a:pt x="123115" y="99954"/>
                    <a:pt x="94345" y="128724"/>
                    <a:pt x="58855" y="128724"/>
                  </a:cubicBezTo>
                  <a:cubicBezTo>
                    <a:pt x="23366" y="128724"/>
                    <a:pt x="-5404" y="99954"/>
                    <a:pt x="-5404" y="64465"/>
                  </a:cubicBezTo>
                  <a:cubicBezTo>
                    <a:pt x="-5404" y="28975"/>
                    <a:pt x="23366" y="206"/>
                    <a:pt x="58855" y="206"/>
                  </a:cubicBezTo>
                  <a:cubicBezTo>
                    <a:pt x="94345" y="206"/>
                    <a:pt x="123115" y="28975"/>
                    <a:pt x="123115" y="64465"/>
                  </a:cubicBezTo>
                  <a:close/>
                </a:path>
              </a:pathLst>
            </a:custGeom>
            <a:solidFill>
              <a:srgbClr val="F8CCB6"/>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14" name="テキスト ボックス 213">
              <a:extLst>
                <a:ext uri="{FF2B5EF4-FFF2-40B4-BE49-F238E27FC236}">
                  <a16:creationId xmlns:a16="http://schemas.microsoft.com/office/drawing/2014/main" id="{04998527-3039-6FB9-00E5-ED407CE3CF61}"/>
                </a:ext>
              </a:extLst>
            </p:cNvPr>
            <p:cNvSpPr txBox="1"/>
            <p:nvPr/>
          </p:nvSpPr>
          <p:spPr>
            <a:xfrm>
              <a:off x="5889277" y="5284608"/>
              <a:ext cx="35939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BD10</a:t>
              </a:r>
            </a:p>
          </p:txBody>
        </p:sp>
        <p:sp>
          <p:nvSpPr>
            <p:cNvPr id="215" name="フリーフォーム: 図形 214">
              <a:extLst>
                <a:ext uri="{FF2B5EF4-FFF2-40B4-BE49-F238E27FC236}">
                  <a16:creationId xmlns:a16="http://schemas.microsoft.com/office/drawing/2014/main" id="{8A959F88-B16E-8BEB-CACD-5710AEA7DA0E}"/>
                </a:ext>
              </a:extLst>
            </p:cNvPr>
            <p:cNvSpPr/>
            <p:nvPr/>
          </p:nvSpPr>
          <p:spPr>
            <a:xfrm>
              <a:off x="5235400" y="4552315"/>
              <a:ext cx="128518" cy="128518"/>
            </a:xfrm>
            <a:custGeom>
              <a:avLst/>
              <a:gdLst>
                <a:gd name="csX0" fmla="*/ 123296 w 128518"/>
                <a:gd name="csY0" fmla="*/ 64639 h 128518"/>
                <a:gd name="csX1" fmla="*/ 59037 w 128518"/>
                <a:gd name="csY1" fmla="*/ 128899 h 128518"/>
                <a:gd name="csX2" fmla="*/ -5222 w 128518"/>
                <a:gd name="csY2" fmla="*/ 64639 h 128518"/>
                <a:gd name="csX3" fmla="*/ 59037 w 128518"/>
                <a:gd name="csY3" fmla="*/ 380 h 128518"/>
                <a:gd name="csX4" fmla="*/ 123296 w 128518"/>
                <a:gd name="csY4" fmla="*/ 64639 h 128518"/>
              </a:gdLst>
              <a:ahLst/>
              <a:cxnLst>
                <a:cxn ang="0">
                  <a:pos x="csX0" y="csY0"/>
                </a:cxn>
                <a:cxn ang="0">
                  <a:pos x="csX1" y="csY1"/>
                </a:cxn>
                <a:cxn ang="0">
                  <a:pos x="csX2" y="csY2"/>
                </a:cxn>
                <a:cxn ang="0">
                  <a:pos x="csX3" y="csY3"/>
                </a:cxn>
                <a:cxn ang="0">
                  <a:pos x="csX4" y="csY4"/>
                </a:cxn>
              </a:cxnLst>
              <a:rect l="l" t="t" r="r" b="b"/>
              <a:pathLst>
                <a:path w="128518" h="128518">
                  <a:moveTo>
                    <a:pt x="123296" y="64639"/>
                  </a:moveTo>
                  <a:cubicBezTo>
                    <a:pt x="123296" y="100129"/>
                    <a:pt x="94527" y="128899"/>
                    <a:pt x="59037" y="128899"/>
                  </a:cubicBezTo>
                  <a:cubicBezTo>
                    <a:pt x="23547" y="128899"/>
                    <a:pt x="-5222" y="100129"/>
                    <a:pt x="-5222" y="64639"/>
                  </a:cubicBezTo>
                  <a:cubicBezTo>
                    <a:pt x="-5222" y="29150"/>
                    <a:pt x="23547" y="380"/>
                    <a:pt x="59037" y="380"/>
                  </a:cubicBezTo>
                  <a:cubicBezTo>
                    <a:pt x="94527" y="380"/>
                    <a:pt x="123296" y="29150"/>
                    <a:pt x="123296" y="64639"/>
                  </a:cubicBez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16" name="フリーフォーム: 図形 215">
              <a:extLst>
                <a:ext uri="{FF2B5EF4-FFF2-40B4-BE49-F238E27FC236}">
                  <a16:creationId xmlns:a16="http://schemas.microsoft.com/office/drawing/2014/main" id="{5DF4AD59-90B4-4B4F-F925-227B6AC7486E}"/>
                </a:ext>
              </a:extLst>
            </p:cNvPr>
            <p:cNvSpPr/>
            <p:nvPr/>
          </p:nvSpPr>
          <p:spPr>
            <a:xfrm>
              <a:off x="5235400" y="4552315"/>
              <a:ext cx="128518" cy="128518"/>
            </a:xfrm>
            <a:custGeom>
              <a:avLst/>
              <a:gdLst>
                <a:gd name="csX0" fmla="*/ 123296 w 128518"/>
                <a:gd name="csY0" fmla="*/ 64639 h 128518"/>
                <a:gd name="csX1" fmla="*/ 59037 w 128518"/>
                <a:gd name="csY1" fmla="*/ 128899 h 128518"/>
                <a:gd name="csX2" fmla="*/ -5222 w 128518"/>
                <a:gd name="csY2" fmla="*/ 64639 h 128518"/>
                <a:gd name="csX3" fmla="*/ 59037 w 128518"/>
                <a:gd name="csY3" fmla="*/ 380 h 128518"/>
                <a:gd name="csX4" fmla="*/ 123296 w 128518"/>
                <a:gd name="csY4" fmla="*/ 64639 h 128518"/>
              </a:gdLst>
              <a:ahLst/>
              <a:cxnLst>
                <a:cxn ang="0">
                  <a:pos x="csX0" y="csY0"/>
                </a:cxn>
                <a:cxn ang="0">
                  <a:pos x="csX1" y="csY1"/>
                </a:cxn>
                <a:cxn ang="0">
                  <a:pos x="csX2" y="csY2"/>
                </a:cxn>
                <a:cxn ang="0">
                  <a:pos x="csX3" y="csY3"/>
                </a:cxn>
                <a:cxn ang="0">
                  <a:pos x="csX4" y="csY4"/>
                </a:cxn>
              </a:cxnLst>
              <a:rect l="l" t="t" r="r" b="b"/>
              <a:pathLst>
                <a:path w="128518" h="128518">
                  <a:moveTo>
                    <a:pt x="123296" y="64639"/>
                  </a:moveTo>
                  <a:cubicBezTo>
                    <a:pt x="123296" y="100129"/>
                    <a:pt x="94527" y="128899"/>
                    <a:pt x="59037" y="128899"/>
                  </a:cubicBezTo>
                  <a:cubicBezTo>
                    <a:pt x="23547" y="128899"/>
                    <a:pt x="-5222" y="100129"/>
                    <a:pt x="-5222" y="64639"/>
                  </a:cubicBezTo>
                  <a:cubicBezTo>
                    <a:pt x="-5222" y="29150"/>
                    <a:pt x="23547" y="380"/>
                    <a:pt x="59037" y="380"/>
                  </a:cubicBezTo>
                  <a:cubicBezTo>
                    <a:pt x="94527" y="380"/>
                    <a:pt x="123296" y="29150"/>
                    <a:pt x="123296" y="64639"/>
                  </a:cubicBezTo>
                  <a:close/>
                </a:path>
              </a:pathLst>
            </a:custGeom>
            <a:solidFill>
              <a:srgbClr val="F8DFD3"/>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17" name="テキスト ボックス 216">
              <a:extLst>
                <a:ext uri="{FF2B5EF4-FFF2-40B4-BE49-F238E27FC236}">
                  <a16:creationId xmlns:a16="http://schemas.microsoft.com/office/drawing/2014/main" id="{05C88DB4-BDD4-4153-77CE-DA21CF46A8E4}"/>
                </a:ext>
              </a:extLst>
            </p:cNvPr>
            <p:cNvSpPr txBox="1"/>
            <p:nvPr/>
          </p:nvSpPr>
          <p:spPr>
            <a:xfrm>
              <a:off x="5144995" y="4539076"/>
              <a:ext cx="30168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NIA2</a:t>
              </a:r>
            </a:p>
          </p:txBody>
        </p:sp>
        <p:sp>
          <p:nvSpPr>
            <p:cNvPr id="218" name="フリーフォーム: 図形 217">
              <a:extLst>
                <a:ext uri="{FF2B5EF4-FFF2-40B4-BE49-F238E27FC236}">
                  <a16:creationId xmlns:a16="http://schemas.microsoft.com/office/drawing/2014/main" id="{98D709D4-7837-8556-3E9E-F9E4A99062CE}"/>
                </a:ext>
              </a:extLst>
            </p:cNvPr>
            <p:cNvSpPr/>
            <p:nvPr/>
          </p:nvSpPr>
          <p:spPr>
            <a:xfrm>
              <a:off x="5985747" y="4820019"/>
              <a:ext cx="128518" cy="128518"/>
            </a:xfrm>
            <a:custGeom>
              <a:avLst/>
              <a:gdLst>
                <a:gd name="csX0" fmla="*/ 123120 w 128518"/>
                <a:gd name="csY0" fmla="*/ 64576 h 128518"/>
                <a:gd name="csX1" fmla="*/ 58861 w 128518"/>
                <a:gd name="csY1" fmla="*/ 128836 h 128518"/>
                <a:gd name="csX2" fmla="*/ -5399 w 128518"/>
                <a:gd name="csY2" fmla="*/ 64576 h 128518"/>
                <a:gd name="csX3" fmla="*/ 58861 w 128518"/>
                <a:gd name="csY3" fmla="*/ 317 h 128518"/>
                <a:gd name="csX4" fmla="*/ 123120 w 128518"/>
                <a:gd name="csY4" fmla="*/ 64576 h 128518"/>
              </a:gdLst>
              <a:ahLst/>
              <a:cxnLst>
                <a:cxn ang="0">
                  <a:pos x="csX0" y="csY0"/>
                </a:cxn>
                <a:cxn ang="0">
                  <a:pos x="csX1" y="csY1"/>
                </a:cxn>
                <a:cxn ang="0">
                  <a:pos x="csX2" y="csY2"/>
                </a:cxn>
                <a:cxn ang="0">
                  <a:pos x="csX3" y="csY3"/>
                </a:cxn>
                <a:cxn ang="0">
                  <a:pos x="csX4" y="csY4"/>
                </a:cxn>
              </a:cxnLst>
              <a:rect l="l" t="t" r="r" b="b"/>
              <a:pathLst>
                <a:path w="128518" h="128518">
                  <a:moveTo>
                    <a:pt x="123120" y="64576"/>
                  </a:moveTo>
                  <a:cubicBezTo>
                    <a:pt x="123120" y="100066"/>
                    <a:pt x="94350" y="128836"/>
                    <a:pt x="58861" y="128836"/>
                  </a:cubicBezTo>
                  <a:cubicBezTo>
                    <a:pt x="23371" y="128836"/>
                    <a:pt x="-5399" y="100066"/>
                    <a:pt x="-5399" y="64576"/>
                  </a:cubicBezTo>
                  <a:cubicBezTo>
                    <a:pt x="-5399" y="29087"/>
                    <a:pt x="23371" y="317"/>
                    <a:pt x="58861" y="317"/>
                  </a:cubicBezTo>
                  <a:cubicBezTo>
                    <a:pt x="94350" y="317"/>
                    <a:pt x="123120" y="29087"/>
                    <a:pt x="123120" y="64576"/>
                  </a:cubicBez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19" name="フリーフォーム: 図形 218">
              <a:extLst>
                <a:ext uri="{FF2B5EF4-FFF2-40B4-BE49-F238E27FC236}">
                  <a16:creationId xmlns:a16="http://schemas.microsoft.com/office/drawing/2014/main" id="{31764C72-8B4F-D020-AE07-28D82B33B2E1}"/>
                </a:ext>
              </a:extLst>
            </p:cNvPr>
            <p:cNvSpPr/>
            <p:nvPr/>
          </p:nvSpPr>
          <p:spPr>
            <a:xfrm>
              <a:off x="5985747" y="4820019"/>
              <a:ext cx="128518" cy="128518"/>
            </a:xfrm>
            <a:custGeom>
              <a:avLst/>
              <a:gdLst>
                <a:gd name="csX0" fmla="*/ 123120 w 128518"/>
                <a:gd name="csY0" fmla="*/ 64576 h 128518"/>
                <a:gd name="csX1" fmla="*/ 58861 w 128518"/>
                <a:gd name="csY1" fmla="*/ 128836 h 128518"/>
                <a:gd name="csX2" fmla="*/ -5399 w 128518"/>
                <a:gd name="csY2" fmla="*/ 64576 h 128518"/>
                <a:gd name="csX3" fmla="*/ 58861 w 128518"/>
                <a:gd name="csY3" fmla="*/ 317 h 128518"/>
                <a:gd name="csX4" fmla="*/ 123120 w 128518"/>
                <a:gd name="csY4" fmla="*/ 64576 h 128518"/>
              </a:gdLst>
              <a:ahLst/>
              <a:cxnLst>
                <a:cxn ang="0">
                  <a:pos x="csX0" y="csY0"/>
                </a:cxn>
                <a:cxn ang="0">
                  <a:pos x="csX1" y="csY1"/>
                </a:cxn>
                <a:cxn ang="0">
                  <a:pos x="csX2" y="csY2"/>
                </a:cxn>
                <a:cxn ang="0">
                  <a:pos x="csX3" y="csY3"/>
                </a:cxn>
                <a:cxn ang="0">
                  <a:pos x="csX4" y="csY4"/>
                </a:cxn>
              </a:cxnLst>
              <a:rect l="l" t="t" r="r" b="b"/>
              <a:pathLst>
                <a:path w="128518" h="128518">
                  <a:moveTo>
                    <a:pt x="123120" y="64576"/>
                  </a:moveTo>
                  <a:cubicBezTo>
                    <a:pt x="123120" y="100066"/>
                    <a:pt x="94350" y="128836"/>
                    <a:pt x="58861" y="128836"/>
                  </a:cubicBezTo>
                  <a:cubicBezTo>
                    <a:pt x="23371" y="128836"/>
                    <a:pt x="-5399" y="100066"/>
                    <a:pt x="-5399" y="64576"/>
                  </a:cubicBezTo>
                  <a:cubicBezTo>
                    <a:pt x="-5399" y="29087"/>
                    <a:pt x="23371" y="317"/>
                    <a:pt x="58861" y="317"/>
                  </a:cubicBezTo>
                  <a:cubicBezTo>
                    <a:pt x="94350" y="317"/>
                    <a:pt x="123120" y="29087"/>
                    <a:pt x="123120" y="64576"/>
                  </a:cubicBezTo>
                  <a:close/>
                </a:path>
              </a:pathLst>
            </a:custGeom>
            <a:solidFill>
              <a:srgbClr val="F8DBCC"/>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20" name="テキスト ボックス 219">
              <a:extLst>
                <a:ext uri="{FF2B5EF4-FFF2-40B4-BE49-F238E27FC236}">
                  <a16:creationId xmlns:a16="http://schemas.microsoft.com/office/drawing/2014/main" id="{2FEDBFBC-C1D6-29E9-AC25-ED21461BB201}"/>
                </a:ext>
              </a:extLst>
            </p:cNvPr>
            <p:cNvSpPr txBox="1"/>
            <p:nvPr/>
          </p:nvSpPr>
          <p:spPr>
            <a:xfrm>
              <a:off x="5881427" y="4806838"/>
              <a:ext cx="32893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CKA</a:t>
              </a:r>
            </a:p>
          </p:txBody>
        </p:sp>
        <p:sp>
          <p:nvSpPr>
            <p:cNvPr id="221" name="フリーフォーム: 図形 220">
              <a:extLst>
                <a:ext uri="{FF2B5EF4-FFF2-40B4-BE49-F238E27FC236}">
                  <a16:creationId xmlns:a16="http://schemas.microsoft.com/office/drawing/2014/main" id="{A6FEA34F-0374-7EFD-3B2F-6A84909A9AC2}"/>
                </a:ext>
              </a:extLst>
            </p:cNvPr>
            <p:cNvSpPr/>
            <p:nvPr/>
          </p:nvSpPr>
          <p:spPr>
            <a:xfrm>
              <a:off x="5367303" y="5001492"/>
              <a:ext cx="128518" cy="128518"/>
            </a:xfrm>
            <a:custGeom>
              <a:avLst/>
              <a:gdLst>
                <a:gd name="csX0" fmla="*/ 123265 w 128518"/>
                <a:gd name="csY0" fmla="*/ 64534 h 128518"/>
                <a:gd name="csX1" fmla="*/ 59006 w 128518"/>
                <a:gd name="csY1" fmla="*/ 128793 h 128518"/>
                <a:gd name="csX2" fmla="*/ -5253 w 128518"/>
                <a:gd name="csY2" fmla="*/ 64534 h 128518"/>
                <a:gd name="csX3" fmla="*/ 59006 w 128518"/>
                <a:gd name="csY3" fmla="*/ 275 h 128518"/>
                <a:gd name="csX4" fmla="*/ 123265 w 128518"/>
                <a:gd name="csY4" fmla="*/ 64534 h 128518"/>
              </a:gdLst>
              <a:ahLst/>
              <a:cxnLst>
                <a:cxn ang="0">
                  <a:pos x="csX0" y="csY0"/>
                </a:cxn>
                <a:cxn ang="0">
                  <a:pos x="csX1" y="csY1"/>
                </a:cxn>
                <a:cxn ang="0">
                  <a:pos x="csX2" y="csY2"/>
                </a:cxn>
                <a:cxn ang="0">
                  <a:pos x="csX3" y="csY3"/>
                </a:cxn>
                <a:cxn ang="0">
                  <a:pos x="csX4" y="csY4"/>
                </a:cxn>
              </a:cxnLst>
              <a:rect l="l" t="t" r="r" b="b"/>
              <a:pathLst>
                <a:path w="128518" h="128518">
                  <a:moveTo>
                    <a:pt x="123265" y="64534"/>
                  </a:moveTo>
                  <a:cubicBezTo>
                    <a:pt x="123265" y="100023"/>
                    <a:pt x="94496" y="128793"/>
                    <a:pt x="59006" y="128793"/>
                  </a:cubicBezTo>
                  <a:cubicBezTo>
                    <a:pt x="23516" y="128793"/>
                    <a:pt x="-5253" y="100023"/>
                    <a:pt x="-5253" y="64534"/>
                  </a:cubicBezTo>
                  <a:cubicBezTo>
                    <a:pt x="-5253" y="29044"/>
                    <a:pt x="23516" y="275"/>
                    <a:pt x="59006" y="275"/>
                  </a:cubicBezTo>
                  <a:cubicBezTo>
                    <a:pt x="94496" y="275"/>
                    <a:pt x="123265" y="29044"/>
                    <a:pt x="123265" y="64534"/>
                  </a:cubicBezTo>
                  <a:close/>
                </a:path>
              </a:pathLst>
            </a:custGeom>
            <a:noFill/>
            <a:ln w="11669"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22" name="フリーフォーム: 図形 221">
              <a:extLst>
                <a:ext uri="{FF2B5EF4-FFF2-40B4-BE49-F238E27FC236}">
                  <a16:creationId xmlns:a16="http://schemas.microsoft.com/office/drawing/2014/main" id="{5762EF35-A2A1-A483-5E23-61DF66B9F638}"/>
                </a:ext>
              </a:extLst>
            </p:cNvPr>
            <p:cNvSpPr/>
            <p:nvPr/>
          </p:nvSpPr>
          <p:spPr>
            <a:xfrm>
              <a:off x="5367303" y="5001492"/>
              <a:ext cx="128518" cy="128518"/>
            </a:xfrm>
            <a:custGeom>
              <a:avLst/>
              <a:gdLst>
                <a:gd name="csX0" fmla="*/ 123265 w 128518"/>
                <a:gd name="csY0" fmla="*/ 64534 h 128518"/>
                <a:gd name="csX1" fmla="*/ 59006 w 128518"/>
                <a:gd name="csY1" fmla="*/ 128793 h 128518"/>
                <a:gd name="csX2" fmla="*/ -5253 w 128518"/>
                <a:gd name="csY2" fmla="*/ 64534 h 128518"/>
                <a:gd name="csX3" fmla="*/ 59006 w 128518"/>
                <a:gd name="csY3" fmla="*/ 275 h 128518"/>
                <a:gd name="csX4" fmla="*/ 123265 w 128518"/>
                <a:gd name="csY4" fmla="*/ 64534 h 128518"/>
              </a:gdLst>
              <a:ahLst/>
              <a:cxnLst>
                <a:cxn ang="0">
                  <a:pos x="csX0" y="csY0"/>
                </a:cxn>
                <a:cxn ang="0">
                  <a:pos x="csX1" y="csY1"/>
                </a:cxn>
                <a:cxn ang="0">
                  <a:pos x="csX2" y="csY2"/>
                </a:cxn>
                <a:cxn ang="0">
                  <a:pos x="csX3" y="csY3"/>
                </a:cxn>
                <a:cxn ang="0">
                  <a:pos x="csX4" y="csY4"/>
                </a:cxn>
              </a:cxnLst>
              <a:rect l="l" t="t" r="r" b="b"/>
              <a:pathLst>
                <a:path w="128518" h="128518">
                  <a:moveTo>
                    <a:pt x="123265" y="64534"/>
                  </a:moveTo>
                  <a:cubicBezTo>
                    <a:pt x="123265" y="100023"/>
                    <a:pt x="94496" y="128793"/>
                    <a:pt x="59006" y="128793"/>
                  </a:cubicBezTo>
                  <a:cubicBezTo>
                    <a:pt x="23516" y="128793"/>
                    <a:pt x="-5253" y="100023"/>
                    <a:pt x="-5253" y="64534"/>
                  </a:cubicBezTo>
                  <a:cubicBezTo>
                    <a:pt x="-5253" y="29044"/>
                    <a:pt x="23516" y="275"/>
                    <a:pt x="59006" y="275"/>
                  </a:cubicBezTo>
                  <a:cubicBezTo>
                    <a:pt x="94496" y="275"/>
                    <a:pt x="123265" y="29044"/>
                    <a:pt x="123265" y="64534"/>
                  </a:cubicBezTo>
                  <a:close/>
                </a:path>
              </a:pathLst>
            </a:custGeom>
            <a:solidFill>
              <a:srgbClr val="EFF3F5"/>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23" name="テキスト ボックス 222">
              <a:extLst>
                <a:ext uri="{FF2B5EF4-FFF2-40B4-BE49-F238E27FC236}">
                  <a16:creationId xmlns:a16="http://schemas.microsoft.com/office/drawing/2014/main" id="{27E4A5D4-009B-DA55-E4B1-1FD953CF7AAD}"/>
                </a:ext>
              </a:extLst>
            </p:cNvPr>
            <p:cNvSpPr txBox="1"/>
            <p:nvPr/>
          </p:nvSpPr>
          <p:spPr>
            <a:xfrm>
              <a:off x="5282501" y="4989346"/>
              <a:ext cx="288861"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VCS</a:t>
              </a:r>
            </a:p>
          </p:txBody>
        </p:sp>
        <p:sp>
          <p:nvSpPr>
            <p:cNvPr id="224" name="フリーフォーム: 図形 223">
              <a:extLst>
                <a:ext uri="{FF2B5EF4-FFF2-40B4-BE49-F238E27FC236}">
                  <a16:creationId xmlns:a16="http://schemas.microsoft.com/office/drawing/2014/main" id="{66E6D367-8C00-18EB-9657-E662B793C672}"/>
                </a:ext>
              </a:extLst>
            </p:cNvPr>
            <p:cNvSpPr/>
            <p:nvPr/>
          </p:nvSpPr>
          <p:spPr>
            <a:xfrm>
              <a:off x="5119146" y="5142561"/>
              <a:ext cx="140201" cy="140201"/>
            </a:xfrm>
            <a:custGeom>
              <a:avLst/>
              <a:gdLst>
                <a:gd name="csX0" fmla="*/ 64905 w 140201"/>
                <a:gd name="csY0" fmla="*/ 240 h 140201"/>
                <a:gd name="csX1" fmla="*/ 135006 w 140201"/>
                <a:gd name="csY1" fmla="*/ 70341 h 140201"/>
                <a:gd name="csX2" fmla="*/ 64905 w 140201"/>
                <a:gd name="csY2" fmla="*/ 140442 h 140201"/>
                <a:gd name="csX3" fmla="*/ -5196 w 140201"/>
                <a:gd name="csY3" fmla="*/ 70341 h 140201"/>
              </a:gdLst>
              <a:ahLst/>
              <a:cxnLst>
                <a:cxn ang="0">
                  <a:pos x="csX0" y="csY0"/>
                </a:cxn>
                <a:cxn ang="0">
                  <a:pos x="csX1" y="csY1"/>
                </a:cxn>
                <a:cxn ang="0">
                  <a:pos x="csX2" y="csY2"/>
                </a:cxn>
                <a:cxn ang="0">
                  <a:pos x="csX3" y="csY3"/>
                </a:cxn>
              </a:cxnLst>
              <a:rect l="l" t="t" r="r" b="b"/>
              <a:pathLst>
                <a:path w="140201" h="140201">
                  <a:moveTo>
                    <a:pt x="64905" y="240"/>
                  </a:moveTo>
                  <a:lnTo>
                    <a:pt x="135006" y="70341"/>
                  </a:lnTo>
                  <a:lnTo>
                    <a:pt x="64905" y="140442"/>
                  </a:lnTo>
                  <a:lnTo>
                    <a:pt x="-5196" y="70341"/>
                  </a:ln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25" name="フリーフォーム: 図形 224">
              <a:extLst>
                <a:ext uri="{FF2B5EF4-FFF2-40B4-BE49-F238E27FC236}">
                  <a16:creationId xmlns:a16="http://schemas.microsoft.com/office/drawing/2014/main" id="{02089BDF-02BD-66BA-6C49-54C64462875A}"/>
                </a:ext>
              </a:extLst>
            </p:cNvPr>
            <p:cNvSpPr/>
            <p:nvPr/>
          </p:nvSpPr>
          <p:spPr>
            <a:xfrm>
              <a:off x="5119146" y="5142561"/>
              <a:ext cx="140201" cy="140201"/>
            </a:xfrm>
            <a:custGeom>
              <a:avLst/>
              <a:gdLst>
                <a:gd name="csX0" fmla="*/ 64905 w 140201"/>
                <a:gd name="csY0" fmla="*/ 240 h 140201"/>
                <a:gd name="csX1" fmla="*/ 135006 w 140201"/>
                <a:gd name="csY1" fmla="*/ 70341 h 140201"/>
                <a:gd name="csX2" fmla="*/ 64905 w 140201"/>
                <a:gd name="csY2" fmla="*/ 140442 h 140201"/>
                <a:gd name="csX3" fmla="*/ -5196 w 140201"/>
                <a:gd name="csY3" fmla="*/ 70341 h 140201"/>
              </a:gdLst>
              <a:ahLst/>
              <a:cxnLst>
                <a:cxn ang="0">
                  <a:pos x="csX0" y="csY0"/>
                </a:cxn>
                <a:cxn ang="0">
                  <a:pos x="csX1" y="csY1"/>
                </a:cxn>
                <a:cxn ang="0">
                  <a:pos x="csX2" y="csY2"/>
                </a:cxn>
                <a:cxn ang="0">
                  <a:pos x="csX3" y="csY3"/>
                </a:cxn>
              </a:cxnLst>
              <a:rect l="l" t="t" r="r" b="b"/>
              <a:pathLst>
                <a:path w="140201" h="140201">
                  <a:moveTo>
                    <a:pt x="64905" y="240"/>
                  </a:moveTo>
                  <a:lnTo>
                    <a:pt x="135006" y="70341"/>
                  </a:lnTo>
                  <a:lnTo>
                    <a:pt x="64905" y="140442"/>
                  </a:lnTo>
                  <a:lnTo>
                    <a:pt x="-5196" y="70341"/>
                  </a:lnTo>
                  <a:close/>
                </a:path>
              </a:pathLst>
            </a:custGeom>
            <a:solidFill>
              <a:srgbClr val="F99E70"/>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26" name="テキスト ボックス 225">
              <a:extLst>
                <a:ext uri="{FF2B5EF4-FFF2-40B4-BE49-F238E27FC236}">
                  <a16:creationId xmlns:a16="http://schemas.microsoft.com/office/drawing/2014/main" id="{B36BB6B2-3F37-E90A-31C5-C6811C5767CD}"/>
                </a:ext>
              </a:extLst>
            </p:cNvPr>
            <p:cNvSpPr txBox="1"/>
            <p:nvPr/>
          </p:nvSpPr>
          <p:spPr>
            <a:xfrm>
              <a:off x="5005835" y="5136325"/>
              <a:ext cx="35779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RK2B</a:t>
              </a:r>
            </a:p>
          </p:txBody>
        </p:sp>
        <p:sp>
          <p:nvSpPr>
            <p:cNvPr id="227" name="フリーフォーム: 図形 226">
              <a:extLst>
                <a:ext uri="{FF2B5EF4-FFF2-40B4-BE49-F238E27FC236}">
                  <a16:creationId xmlns:a16="http://schemas.microsoft.com/office/drawing/2014/main" id="{DC64A198-7960-36AC-B5BD-774425761383}"/>
                </a:ext>
              </a:extLst>
            </p:cNvPr>
            <p:cNvSpPr/>
            <p:nvPr/>
          </p:nvSpPr>
          <p:spPr>
            <a:xfrm>
              <a:off x="5707716" y="5157777"/>
              <a:ext cx="140201" cy="140201"/>
            </a:xfrm>
            <a:custGeom>
              <a:avLst/>
              <a:gdLst>
                <a:gd name="csX0" fmla="*/ 64766 w 140201"/>
                <a:gd name="csY0" fmla="*/ 237 h 140201"/>
                <a:gd name="csX1" fmla="*/ 134867 w 140201"/>
                <a:gd name="csY1" fmla="*/ 70337 h 140201"/>
                <a:gd name="csX2" fmla="*/ 64766 w 140201"/>
                <a:gd name="csY2" fmla="*/ 140438 h 140201"/>
                <a:gd name="csX3" fmla="*/ -5335 w 140201"/>
                <a:gd name="csY3" fmla="*/ 70337 h 140201"/>
              </a:gdLst>
              <a:ahLst/>
              <a:cxnLst>
                <a:cxn ang="0">
                  <a:pos x="csX0" y="csY0"/>
                </a:cxn>
                <a:cxn ang="0">
                  <a:pos x="csX1" y="csY1"/>
                </a:cxn>
                <a:cxn ang="0">
                  <a:pos x="csX2" y="csY2"/>
                </a:cxn>
                <a:cxn ang="0">
                  <a:pos x="csX3" y="csY3"/>
                </a:cxn>
              </a:cxnLst>
              <a:rect l="l" t="t" r="r" b="b"/>
              <a:pathLst>
                <a:path w="140201" h="140201">
                  <a:moveTo>
                    <a:pt x="64766" y="237"/>
                  </a:moveTo>
                  <a:lnTo>
                    <a:pt x="134867" y="70337"/>
                  </a:lnTo>
                  <a:lnTo>
                    <a:pt x="64766" y="140438"/>
                  </a:lnTo>
                  <a:lnTo>
                    <a:pt x="-5335" y="70337"/>
                  </a:ln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28" name="フリーフォーム: 図形 227">
              <a:extLst>
                <a:ext uri="{FF2B5EF4-FFF2-40B4-BE49-F238E27FC236}">
                  <a16:creationId xmlns:a16="http://schemas.microsoft.com/office/drawing/2014/main" id="{C9F5C401-383E-3176-70A4-C8087076AFC4}"/>
                </a:ext>
              </a:extLst>
            </p:cNvPr>
            <p:cNvSpPr/>
            <p:nvPr/>
          </p:nvSpPr>
          <p:spPr>
            <a:xfrm>
              <a:off x="5707716" y="5157777"/>
              <a:ext cx="140201" cy="140201"/>
            </a:xfrm>
            <a:custGeom>
              <a:avLst/>
              <a:gdLst>
                <a:gd name="csX0" fmla="*/ 64766 w 140201"/>
                <a:gd name="csY0" fmla="*/ 237 h 140201"/>
                <a:gd name="csX1" fmla="*/ 134867 w 140201"/>
                <a:gd name="csY1" fmla="*/ 70337 h 140201"/>
                <a:gd name="csX2" fmla="*/ 64766 w 140201"/>
                <a:gd name="csY2" fmla="*/ 140438 h 140201"/>
                <a:gd name="csX3" fmla="*/ -5335 w 140201"/>
                <a:gd name="csY3" fmla="*/ 70337 h 140201"/>
              </a:gdLst>
              <a:ahLst/>
              <a:cxnLst>
                <a:cxn ang="0">
                  <a:pos x="csX0" y="csY0"/>
                </a:cxn>
                <a:cxn ang="0">
                  <a:pos x="csX1" y="csY1"/>
                </a:cxn>
                <a:cxn ang="0">
                  <a:pos x="csX2" y="csY2"/>
                </a:cxn>
                <a:cxn ang="0">
                  <a:pos x="csX3" y="csY3"/>
                </a:cxn>
              </a:cxnLst>
              <a:rect l="l" t="t" r="r" b="b"/>
              <a:pathLst>
                <a:path w="140201" h="140201">
                  <a:moveTo>
                    <a:pt x="64766" y="237"/>
                  </a:moveTo>
                  <a:lnTo>
                    <a:pt x="134867" y="70337"/>
                  </a:lnTo>
                  <a:lnTo>
                    <a:pt x="64766" y="140438"/>
                  </a:lnTo>
                  <a:lnTo>
                    <a:pt x="-5335" y="70337"/>
                  </a:lnTo>
                  <a:close/>
                </a:path>
              </a:pathLst>
            </a:custGeom>
            <a:solidFill>
              <a:srgbClr val="F8CDB7"/>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29" name="テキスト ボックス 228">
              <a:extLst>
                <a:ext uri="{FF2B5EF4-FFF2-40B4-BE49-F238E27FC236}">
                  <a16:creationId xmlns:a16="http://schemas.microsoft.com/office/drawing/2014/main" id="{CCCB7123-AC01-AE13-DBBB-534F51767325}"/>
                </a:ext>
              </a:extLst>
            </p:cNvPr>
            <p:cNvSpPr txBox="1"/>
            <p:nvPr/>
          </p:nvSpPr>
          <p:spPr>
            <a:xfrm>
              <a:off x="5614501" y="5147004"/>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PK2</a:t>
              </a:r>
            </a:p>
          </p:txBody>
        </p:sp>
        <p:sp>
          <p:nvSpPr>
            <p:cNvPr id="230" name="フリーフォーム: 図形 229">
              <a:extLst>
                <a:ext uri="{FF2B5EF4-FFF2-40B4-BE49-F238E27FC236}">
                  <a16:creationId xmlns:a16="http://schemas.microsoft.com/office/drawing/2014/main" id="{D15A5BDE-0D1C-0C67-A7AF-8DD14EF54E7F}"/>
                </a:ext>
              </a:extLst>
            </p:cNvPr>
            <p:cNvSpPr/>
            <p:nvPr/>
          </p:nvSpPr>
          <p:spPr>
            <a:xfrm>
              <a:off x="5579866" y="4729081"/>
              <a:ext cx="144000" cy="144000"/>
            </a:xfrm>
            <a:custGeom>
              <a:avLst/>
              <a:gdLst>
                <a:gd name="csX0" fmla="*/ 64796 w 140201"/>
                <a:gd name="csY0" fmla="*/ 337 h 140201"/>
                <a:gd name="csX1" fmla="*/ 134897 w 140201"/>
                <a:gd name="csY1" fmla="*/ 70438 h 140201"/>
                <a:gd name="csX2" fmla="*/ 64796 w 140201"/>
                <a:gd name="csY2" fmla="*/ 140539 h 140201"/>
                <a:gd name="csX3" fmla="*/ -5305 w 140201"/>
                <a:gd name="csY3" fmla="*/ 70438 h 140201"/>
              </a:gdLst>
              <a:ahLst/>
              <a:cxnLst>
                <a:cxn ang="0">
                  <a:pos x="csX0" y="csY0"/>
                </a:cxn>
                <a:cxn ang="0">
                  <a:pos x="csX1" y="csY1"/>
                </a:cxn>
                <a:cxn ang="0">
                  <a:pos x="csX2" y="csY2"/>
                </a:cxn>
                <a:cxn ang="0">
                  <a:pos x="csX3" y="csY3"/>
                </a:cxn>
              </a:cxnLst>
              <a:rect l="l" t="t" r="r" b="b"/>
              <a:pathLst>
                <a:path w="140201" h="140201">
                  <a:moveTo>
                    <a:pt x="64796" y="337"/>
                  </a:moveTo>
                  <a:lnTo>
                    <a:pt x="134897" y="70438"/>
                  </a:lnTo>
                  <a:lnTo>
                    <a:pt x="64796" y="140539"/>
                  </a:lnTo>
                  <a:lnTo>
                    <a:pt x="-5305" y="70438"/>
                  </a:lnTo>
                  <a:close/>
                </a:path>
              </a:pathLst>
            </a:custGeom>
            <a:solidFill>
              <a:srgbClr val="D8E6EF"/>
            </a:solidFill>
            <a:ln w="6350" cap="sq">
              <a:solidFill>
                <a:srgbClr val="0070C0"/>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31" name="テキスト ボックス 230">
              <a:extLst>
                <a:ext uri="{FF2B5EF4-FFF2-40B4-BE49-F238E27FC236}">
                  <a16:creationId xmlns:a16="http://schemas.microsoft.com/office/drawing/2014/main" id="{440D6D05-1680-3DD3-F5B1-C17332F9FB12}"/>
                </a:ext>
              </a:extLst>
            </p:cNvPr>
            <p:cNvSpPr txBox="1"/>
            <p:nvPr/>
          </p:nvSpPr>
          <p:spPr>
            <a:xfrm>
              <a:off x="5488199" y="4724137"/>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PK6</a:t>
              </a:r>
            </a:p>
          </p:txBody>
        </p:sp>
        <p:sp>
          <p:nvSpPr>
            <p:cNvPr id="232" name="フリーフォーム: 図形 231">
              <a:extLst>
                <a:ext uri="{FF2B5EF4-FFF2-40B4-BE49-F238E27FC236}">
                  <a16:creationId xmlns:a16="http://schemas.microsoft.com/office/drawing/2014/main" id="{C5B2CAB2-EF95-3C58-8EEB-AAA58B13E172}"/>
                </a:ext>
              </a:extLst>
            </p:cNvPr>
            <p:cNvSpPr/>
            <p:nvPr/>
          </p:nvSpPr>
          <p:spPr>
            <a:xfrm>
              <a:off x="6085103" y="4984406"/>
              <a:ext cx="140201" cy="140201"/>
            </a:xfrm>
            <a:custGeom>
              <a:avLst/>
              <a:gdLst>
                <a:gd name="csX0" fmla="*/ 64678 w 140201"/>
                <a:gd name="csY0" fmla="*/ 277 h 140201"/>
                <a:gd name="csX1" fmla="*/ 134779 w 140201"/>
                <a:gd name="csY1" fmla="*/ 70378 h 140201"/>
                <a:gd name="csX2" fmla="*/ 64678 w 140201"/>
                <a:gd name="csY2" fmla="*/ 140479 h 140201"/>
                <a:gd name="csX3" fmla="*/ -5423 w 140201"/>
                <a:gd name="csY3" fmla="*/ 70378 h 140201"/>
              </a:gdLst>
              <a:ahLst/>
              <a:cxnLst>
                <a:cxn ang="0">
                  <a:pos x="csX0" y="csY0"/>
                </a:cxn>
                <a:cxn ang="0">
                  <a:pos x="csX1" y="csY1"/>
                </a:cxn>
                <a:cxn ang="0">
                  <a:pos x="csX2" y="csY2"/>
                </a:cxn>
                <a:cxn ang="0">
                  <a:pos x="csX3" y="csY3"/>
                </a:cxn>
              </a:cxnLst>
              <a:rect l="l" t="t" r="r" b="b"/>
              <a:pathLst>
                <a:path w="140201" h="140201">
                  <a:moveTo>
                    <a:pt x="64678" y="277"/>
                  </a:moveTo>
                  <a:lnTo>
                    <a:pt x="134779" y="70378"/>
                  </a:lnTo>
                  <a:lnTo>
                    <a:pt x="64678" y="140479"/>
                  </a:lnTo>
                  <a:lnTo>
                    <a:pt x="-5423" y="70378"/>
                  </a:lnTo>
                  <a:close/>
                </a:path>
              </a:pathLst>
            </a:custGeom>
            <a:noFill/>
            <a:ln w="11669"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33" name="フリーフォーム: 図形 232">
              <a:extLst>
                <a:ext uri="{FF2B5EF4-FFF2-40B4-BE49-F238E27FC236}">
                  <a16:creationId xmlns:a16="http://schemas.microsoft.com/office/drawing/2014/main" id="{C6FD5D07-E0D5-86B8-059A-6C2B1CD00C04}"/>
                </a:ext>
              </a:extLst>
            </p:cNvPr>
            <p:cNvSpPr/>
            <p:nvPr/>
          </p:nvSpPr>
          <p:spPr>
            <a:xfrm>
              <a:off x="6085103" y="4984406"/>
              <a:ext cx="140201" cy="140201"/>
            </a:xfrm>
            <a:custGeom>
              <a:avLst/>
              <a:gdLst>
                <a:gd name="csX0" fmla="*/ 64678 w 140201"/>
                <a:gd name="csY0" fmla="*/ 277 h 140201"/>
                <a:gd name="csX1" fmla="*/ 134779 w 140201"/>
                <a:gd name="csY1" fmla="*/ 70378 h 140201"/>
                <a:gd name="csX2" fmla="*/ 64678 w 140201"/>
                <a:gd name="csY2" fmla="*/ 140479 h 140201"/>
                <a:gd name="csX3" fmla="*/ -5423 w 140201"/>
                <a:gd name="csY3" fmla="*/ 70378 h 140201"/>
              </a:gdLst>
              <a:ahLst/>
              <a:cxnLst>
                <a:cxn ang="0">
                  <a:pos x="csX0" y="csY0"/>
                </a:cxn>
                <a:cxn ang="0">
                  <a:pos x="csX1" y="csY1"/>
                </a:cxn>
                <a:cxn ang="0">
                  <a:pos x="csX2" y="csY2"/>
                </a:cxn>
                <a:cxn ang="0">
                  <a:pos x="csX3" y="csY3"/>
                </a:cxn>
              </a:cxnLst>
              <a:rect l="l" t="t" r="r" b="b"/>
              <a:pathLst>
                <a:path w="140201" h="140201">
                  <a:moveTo>
                    <a:pt x="64678" y="277"/>
                  </a:moveTo>
                  <a:lnTo>
                    <a:pt x="134779" y="70378"/>
                  </a:lnTo>
                  <a:lnTo>
                    <a:pt x="64678" y="140479"/>
                  </a:lnTo>
                  <a:lnTo>
                    <a:pt x="-5423" y="70378"/>
                  </a:lnTo>
                  <a:close/>
                </a:path>
              </a:pathLst>
            </a:custGeom>
            <a:solidFill>
              <a:srgbClr val="FA7837"/>
            </a:solidFill>
            <a:ln w="2334"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34" name="テキスト ボックス 233">
              <a:extLst>
                <a:ext uri="{FF2B5EF4-FFF2-40B4-BE49-F238E27FC236}">
                  <a16:creationId xmlns:a16="http://schemas.microsoft.com/office/drawing/2014/main" id="{22C277E4-1DBF-1404-BF70-96BC7CF501B0}"/>
                </a:ext>
              </a:extLst>
            </p:cNvPr>
            <p:cNvSpPr txBox="1"/>
            <p:nvPr/>
          </p:nvSpPr>
          <p:spPr>
            <a:xfrm>
              <a:off x="6000115" y="4979756"/>
              <a:ext cx="33054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KK3</a:t>
              </a:r>
            </a:p>
          </p:txBody>
        </p:sp>
        <p:grpSp>
          <p:nvGrpSpPr>
            <p:cNvPr id="235" name="グループ化 234">
              <a:extLst>
                <a:ext uri="{FF2B5EF4-FFF2-40B4-BE49-F238E27FC236}">
                  <a16:creationId xmlns:a16="http://schemas.microsoft.com/office/drawing/2014/main" id="{A56B944E-D20F-DBAD-10BB-E94B39098EF2}"/>
                </a:ext>
              </a:extLst>
            </p:cNvPr>
            <p:cNvGrpSpPr/>
            <p:nvPr/>
          </p:nvGrpSpPr>
          <p:grpSpPr>
            <a:xfrm>
              <a:off x="5211529" y="4376396"/>
              <a:ext cx="327334" cy="153888"/>
              <a:chOff x="5175334" y="4338296"/>
              <a:chExt cx="327334" cy="153888"/>
            </a:xfrm>
          </p:grpSpPr>
          <p:sp>
            <p:nvSpPr>
              <p:cNvPr id="236" name="フリーフォーム: 図形 235">
                <a:extLst>
                  <a:ext uri="{FF2B5EF4-FFF2-40B4-BE49-F238E27FC236}">
                    <a16:creationId xmlns:a16="http://schemas.microsoft.com/office/drawing/2014/main" id="{CE3299CC-EE34-71E9-76E0-65699CF226CA}"/>
                  </a:ext>
                </a:extLst>
              </p:cNvPr>
              <p:cNvSpPr/>
              <p:nvPr/>
            </p:nvSpPr>
            <p:spPr>
              <a:xfrm>
                <a:off x="5270811" y="4343240"/>
                <a:ext cx="144000" cy="144000"/>
              </a:xfrm>
              <a:custGeom>
                <a:avLst/>
                <a:gdLst>
                  <a:gd name="csX0" fmla="*/ 123265 w 128518"/>
                  <a:gd name="csY0" fmla="*/ 64661 h 128518"/>
                  <a:gd name="csX1" fmla="*/ 59006 w 128518"/>
                  <a:gd name="csY1" fmla="*/ 128920 h 128518"/>
                  <a:gd name="csX2" fmla="*/ -5254 w 128518"/>
                  <a:gd name="csY2" fmla="*/ 64661 h 128518"/>
                  <a:gd name="csX3" fmla="*/ 59006 w 128518"/>
                  <a:gd name="csY3" fmla="*/ 402 h 128518"/>
                  <a:gd name="csX4" fmla="*/ 123265 w 128518"/>
                  <a:gd name="csY4" fmla="*/ 64661 h 128518"/>
                </a:gdLst>
                <a:ahLst/>
                <a:cxnLst>
                  <a:cxn ang="0">
                    <a:pos x="csX0" y="csY0"/>
                  </a:cxn>
                  <a:cxn ang="0">
                    <a:pos x="csX1" y="csY1"/>
                  </a:cxn>
                  <a:cxn ang="0">
                    <a:pos x="csX2" y="csY2"/>
                  </a:cxn>
                  <a:cxn ang="0">
                    <a:pos x="csX3" y="csY3"/>
                  </a:cxn>
                  <a:cxn ang="0">
                    <a:pos x="csX4" y="csY4"/>
                  </a:cxn>
                </a:cxnLst>
                <a:rect l="l" t="t" r="r" b="b"/>
                <a:pathLst>
                  <a:path w="128518" h="128518">
                    <a:moveTo>
                      <a:pt x="123265" y="64661"/>
                    </a:moveTo>
                    <a:cubicBezTo>
                      <a:pt x="123265" y="100150"/>
                      <a:pt x="94495" y="128920"/>
                      <a:pt x="59006" y="128920"/>
                    </a:cubicBezTo>
                    <a:cubicBezTo>
                      <a:pt x="23516" y="128920"/>
                      <a:pt x="-5254" y="100150"/>
                      <a:pt x="-5254" y="64661"/>
                    </a:cubicBezTo>
                    <a:cubicBezTo>
                      <a:pt x="-5254" y="29171"/>
                      <a:pt x="23516" y="402"/>
                      <a:pt x="59006" y="402"/>
                    </a:cubicBezTo>
                    <a:cubicBezTo>
                      <a:pt x="94495" y="402"/>
                      <a:pt x="123265" y="29171"/>
                      <a:pt x="123265" y="64661"/>
                    </a:cubicBezTo>
                    <a:close/>
                  </a:path>
                </a:pathLst>
              </a:custGeom>
              <a:solidFill>
                <a:srgbClr val="BCD6E7"/>
              </a:solidFill>
              <a:ln w="6350" cap="sq">
                <a:solidFill>
                  <a:srgbClr val="0070C0"/>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37" name="テキスト ボックス 236">
                <a:extLst>
                  <a:ext uri="{FF2B5EF4-FFF2-40B4-BE49-F238E27FC236}">
                    <a16:creationId xmlns:a16="http://schemas.microsoft.com/office/drawing/2014/main" id="{917C8FB8-3452-6F1C-BBFF-D8A7A88D3F23}"/>
                  </a:ext>
                </a:extLst>
              </p:cNvPr>
              <p:cNvSpPr txBox="1"/>
              <p:nvPr/>
            </p:nvSpPr>
            <p:spPr>
              <a:xfrm>
                <a:off x="5175334" y="4338296"/>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UGD2</a:t>
                </a:r>
              </a:p>
            </p:txBody>
          </p:sp>
        </p:grpSp>
      </p:grpSp>
      <p:grpSp>
        <p:nvGrpSpPr>
          <p:cNvPr id="244" name="グループ化 243">
            <a:extLst>
              <a:ext uri="{FF2B5EF4-FFF2-40B4-BE49-F238E27FC236}">
                <a16:creationId xmlns:a16="http://schemas.microsoft.com/office/drawing/2014/main" id="{3C4F1019-D6BB-7B0F-FE2D-81DE713AE7C6}"/>
              </a:ext>
            </a:extLst>
          </p:cNvPr>
          <p:cNvGrpSpPr/>
          <p:nvPr/>
        </p:nvGrpSpPr>
        <p:grpSpPr>
          <a:xfrm>
            <a:off x="2480480" y="1702752"/>
            <a:ext cx="2133997" cy="2439453"/>
            <a:chOff x="2485766" y="3963007"/>
            <a:chExt cx="2133997" cy="2439453"/>
          </a:xfrm>
        </p:grpSpPr>
        <p:sp>
          <p:nvSpPr>
            <p:cNvPr id="245" name="楕円 244">
              <a:extLst>
                <a:ext uri="{FF2B5EF4-FFF2-40B4-BE49-F238E27FC236}">
                  <a16:creationId xmlns:a16="http://schemas.microsoft.com/office/drawing/2014/main" id="{AA94BE87-850E-5912-BBEE-1002BE41D8DB}"/>
                </a:ext>
              </a:extLst>
            </p:cNvPr>
            <p:cNvSpPr/>
            <p:nvPr/>
          </p:nvSpPr>
          <p:spPr>
            <a:xfrm rot="19146084">
              <a:off x="2485766" y="4242460"/>
              <a:ext cx="1512000" cy="2160000"/>
            </a:xfrm>
            <a:prstGeom prst="ellipse">
              <a:avLst/>
            </a:prstGeom>
            <a:solidFill>
              <a:srgbClr val="FFFF99">
                <a:alpha val="49804"/>
              </a:srgb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b="1">
                <a:latin typeface="Arial" panose="020B0604020202020204" pitchFamily="34" charset="0"/>
                <a:cs typeface="Arial" panose="020B0604020202020204" pitchFamily="34" charset="0"/>
              </a:endParaRPr>
            </a:p>
          </p:txBody>
        </p:sp>
        <p:sp>
          <p:nvSpPr>
            <p:cNvPr id="246" name="楕円 245">
              <a:extLst>
                <a:ext uri="{FF2B5EF4-FFF2-40B4-BE49-F238E27FC236}">
                  <a16:creationId xmlns:a16="http://schemas.microsoft.com/office/drawing/2014/main" id="{BFB4F1E1-E81A-813E-8712-904F45201308}"/>
                </a:ext>
              </a:extLst>
            </p:cNvPr>
            <p:cNvSpPr/>
            <p:nvPr/>
          </p:nvSpPr>
          <p:spPr>
            <a:xfrm rot="19171770">
              <a:off x="3251763" y="3963007"/>
              <a:ext cx="1368000" cy="1800000"/>
            </a:xfrm>
            <a:prstGeom prst="ellipse">
              <a:avLst/>
            </a:prstGeom>
            <a:solidFill>
              <a:schemeClr val="accent6">
                <a:lumMod val="20000"/>
                <a:lumOff val="80000"/>
                <a:alpha val="50196"/>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b="1">
                <a:latin typeface="Arial" panose="020B0604020202020204" pitchFamily="34" charset="0"/>
                <a:cs typeface="Arial" panose="020B0604020202020204" pitchFamily="34" charset="0"/>
              </a:endParaRPr>
            </a:p>
          </p:txBody>
        </p:sp>
        <p:sp>
          <p:nvSpPr>
            <p:cNvPr id="247" name="フリーフォーム: 図形 246">
              <a:extLst>
                <a:ext uri="{FF2B5EF4-FFF2-40B4-BE49-F238E27FC236}">
                  <a16:creationId xmlns:a16="http://schemas.microsoft.com/office/drawing/2014/main" id="{B216BEC7-CCBE-5143-A5E9-FD7998D9321F}"/>
                </a:ext>
              </a:extLst>
            </p:cNvPr>
            <p:cNvSpPr/>
            <p:nvPr/>
          </p:nvSpPr>
          <p:spPr>
            <a:xfrm>
              <a:off x="3916193" y="4901569"/>
              <a:ext cx="177745" cy="447998"/>
            </a:xfrm>
            <a:custGeom>
              <a:avLst/>
              <a:gdLst>
                <a:gd name="csX0" fmla="*/ 174214 w 177745"/>
                <a:gd name="csY0" fmla="*/ 448311 h 447998"/>
                <a:gd name="csX1" fmla="*/ -3531 w 177745"/>
                <a:gd name="csY1" fmla="*/ 313 h 447998"/>
              </a:gdLst>
              <a:ahLst/>
              <a:cxnLst>
                <a:cxn ang="0">
                  <a:pos x="csX0" y="csY0"/>
                </a:cxn>
                <a:cxn ang="0">
                  <a:pos x="csX1" y="csY1"/>
                </a:cxn>
              </a:cxnLst>
              <a:rect l="l" t="t" r="r" b="b"/>
              <a:pathLst>
                <a:path w="177745" h="447998">
                  <a:moveTo>
                    <a:pt x="174214" y="448311"/>
                  </a:moveTo>
                  <a:lnTo>
                    <a:pt x="-3531" y="313"/>
                  </a:lnTo>
                </a:path>
              </a:pathLst>
            </a:custGeom>
            <a:noFill/>
            <a:ln w="11787" cap="flat">
              <a:solidFill>
                <a:srgbClr val="FEE08B"/>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48" name="フリーフォーム: 図形 247">
              <a:extLst>
                <a:ext uri="{FF2B5EF4-FFF2-40B4-BE49-F238E27FC236}">
                  <a16:creationId xmlns:a16="http://schemas.microsoft.com/office/drawing/2014/main" id="{E1D0D553-9075-0A5B-DFDF-9AE9AFAE3F8B}"/>
                </a:ext>
              </a:extLst>
            </p:cNvPr>
            <p:cNvSpPr/>
            <p:nvPr/>
          </p:nvSpPr>
          <p:spPr>
            <a:xfrm rot="4101547">
              <a:off x="4092076" y="5346409"/>
              <a:ext cx="5900" cy="11801"/>
            </a:xfrm>
            <a:custGeom>
              <a:avLst/>
              <a:gdLst>
                <a:gd name="csX0" fmla="*/ 335 w 5900"/>
                <a:gd name="csY0" fmla="*/ 12063 h 11801"/>
                <a:gd name="csX1" fmla="*/ 6235 w 5900"/>
                <a:gd name="csY1" fmla="*/ 6162 h 11801"/>
                <a:gd name="csX2" fmla="*/ 335 w 5900"/>
                <a:gd name="csY2" fmla="*/ 262 h 11801"/>
              </a:gdLst>
              <a:ahLst/>
              <a:cxnLst>
                <a:cxn ang="0">
                  <a:pos x="csX0" y="csY0"/>
                </a:cxn>
                <a:cxn ang="0">
                  <a:pos x="csX1" y="csY1"/>
                </a:cxn>
                <a:cxn ang="0">
                  <a:pos x="csX2" y="csY2"/>
                </a:cxn>
              </a:cxnLst>
              <a:rect l="l" t="t" r="r" b="b"/>
              <a:pathLst>
                <a:path w="5900" h="11801">
                  <a:moveTo>
                    <a:pt x="335" y="12063"/>
                  </a:moveTo>
                  <a:cubicBezTo>
                    <a:pt x="3594" y="12063"/>
                    <a:pt x="6235" y="9421"/>
                    <a:pt x="6235" y="6162"/>
                  </a:cubicBezTo>
                  <a:cubicBezTo>
                    <a:pt x="6235" y="2903"/>
                    <a:pt x="3594" y="262"/>
                    <a:pt x="335" y="262"/>
                  </a:cubicBezTo>
                  <a:close/>
                </a:path>
              </a:pathLst>
            </a:custGeom>
            <a:solidFill>
              <a:srgbClr val="FEE08B"/>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49" name="フリーフォーム: 図形 248">
              <a:extLst>
                <a:ext uri="{FF2B5EF4-FFF2-40B4-BE49-F238E27FC236}">
                  <a16:creationId xmlns:a16="http://schemas.microsoft.com/office/drawing/2014/main" id="{26692311-9D6B-5229-3E22-74D8B175A01E}"/>
                </a:ext>
              </a:extLst>
            </p:cNvPr>
            <p:cNvSpPr/>
            <p:nvPr/>
          </p:nvSpPr>
          <p:spPr>
            <a:xfrm rot="14901547">
              <a:off x="3907309" y="4882554"/>
              <a:ext cx="12981" cy="25963"/>
            </a:xfrm>
            <a:custGeom>
              <a:avLst/>
              <a:gdLst>
                <a:gd name="csX0" fmla="*/ 300 w 12981"/>
                <a:gd name="csY0" fmla="*/ 173 h 25963"/>
                <a:gd name="csX1" fmla="*/ 13282 w 12981"/>
                <a:gd name="csY1" fmla="*/ 13155 h 25963"/>
                <a:gd name="csX2" fmla="*/ 300 w 12981"/>
                <a:gd name="csY2" fmla="*/ 26137 h 25963"/>
              </a:gdLst>
              <a:ahLst/>
              <a:cxnLst>
                <a:cxn ang="0">
                  <a:pos x="csX0" y="csY0"/>
                </a:cxn>
                <a:cxn ang="0">
                  <a:pos x="csX1" y="csY1"/>
                </a:cxn>
                <a:cxn ang="0">
                  <a:pos x="csX2" y="csY2"/>
                </a:cxn>
              </a:cxnLst>
              <a:rect l="l" t="t" r="r" b="b"/>
              <a:pathLst>
                <a:path w="12981" h="25963">
                  <a:moveTo>
                    <a:pt x="300" y="173"/>
                  </a:moveTo>
                  <a:lnTo>
                    <a:pt x="13282" y="13155"/>
                  </a:lnTo>
                  <a:lnTo>
                    <a:pt x="300" y="26137"/>
                  </a:lnTo>
                  <a:close/>
                </a:path>
              </a:pathLst>
            </a:custGeom>
            <a:solidFill>
              <a:srgbClr val="FEE08B"/>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0" name="フリーフォーム: 図形 249">
              <a:extLst>
                <a:ext uri="{FF2B5EF4-FFF2-40B4-BE49-F238E27FC236}">
                  <a16:creationId xmlns:a16="http://schemas.microsoft.com/office/drawing/2014/main" id="{C9E261B8-1A48-DC16-EB27-00FFE0DE018E}"/>
                </a:ext>
              </a:extLst>
            </p:cNvPr>
            <p:cNvSpPr/>
            <p:nvPr/>
          </p:nvSpPr>
          <p:spPr>
            <a:xfrm>
              <a:off x="4084223" y="5473715"/>
              <a:ext cx="24023" cy="222297"/>
            </a:xfrm>
            <a:custGeom>
              <a:avLst/>
              <a:gdLst>
                <a:gd name="csX0" fmla="*/ 20472 w 24023"/>
                <a:gd name="csY0" fmla="*/ 207 h 222297"/>
                <a:gd name="csX1" fmla="*/ -3552 w 24023"/>
                <a:gd name="csY1" fmla="*/ 222504 h 222297"/>
              </a:gdLst>
              <a:ahLst/>
              <a:cxnLst>
                <a:cxn ang="0">
                  <a:pos x="csX0" y="csY0"/>
                </a:cxn>
                <a:cxn ang="0">
                  <a:pos x="csX1" y="csY1"/>
                </a:cxn>
              </a:cxnLst>
              <a:rect l="l" t="t" r="r" b="b"/>
              <a:pathLst>
                <a:path w="24023" h="222297">
                  <a:moveTo>
                    <a:pt x="20472" y="207"/>
                  </a:moveTo>
                  <a:lnTo>
                    <a:pt x="-3552" y="222504"/>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1" name="フリーフォーム: 図形 250">
              <a:extLst>
                <a:ext uri="{FF2B5EF4-FFF2-40B4-BE49-F238E27FC236}">
                  <a16:creationId xmlns:a16="http://schemas.microsoft.com/office/drawing/2014/main" id="{606D8FFF-A05C-572E-8009-62539DBFB4E9}"/>
                </a:ext>
              </a:extLst>
            </p:cNvPr>
            <p:cNvSpPr/>
            <p:nvPr/>
          </p:nvSpPr>
          <p:spPr>
            <a:xfrm>
              <a:off x="4153774" y="5443151"/>
              <a:ext cx="19199" cy="19510"/>
            </a:xfrm>
            <a:custGeom>
              <a:avLst/>
              <a:gdLst>
                <a:gd name="csX0" fmla="*/ -3568 w 19199"/>
                <a:gd name="csY0" fmla="*/ 237 h 19510"/>
                <a:gd name="csX1" fmla="*/ 15632 w 19199"/>
                <a:gd name="csY1" fmla="*/ 19748 h 19510"/>
              </a:gdLst>
              <a:ahLst/>
              <a:cxnLst>
                <a:cxn ang="0">
                  <a:pos x="csX0" y="csY0"/>
                </a:cxn>
                <a:cxn ang="0">
                  <a:pos x="csX1" y="csY1"/>
                </a:cxn>
              </a:cxnLst>
              <a:rect l="l" t="t" r="r" b="b"/>
              <a:pathLst>
                <a:path w="19199" h="19510">
                  <a:moveTo>
                    <a:pt x="-3568" y="237"/>
                  </a:moveTo>
                  <a:lnTo>
                    <a:pt x="15632" y="19748"/>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2" name="フリーフォーム: 図形 251">
              <a:extLst>
                <a:ext uri="{FF2B5EF4-FFF2-40B4-BE49-F238E27FC236}">
                  <a16:creationId xmlns:a16="http://schemas.microsoft.com/office/drawing/2014/main" id="{747A9910-1DF5-3D52-C0D7-0A7AA7B6632E}"/>
                </a:ext>
              </a:extLst>
            </p:cNvPr>
            <p:cNvSpPr/>
            <p:nvPr/>
          </p:nvSpPr>
          <p:spPr>
            <a:xfrm rot="13527639">
              <a:off x="4148754" y="5435147"/>
              <a:ext cx="5900" cy="11801"/>
            </a:xfrm>
            <a:custGeom>
              <a:avLst/>
              <a:gdLst>
                <a:gd name="csX0" fmla="*/ 346 w 5900"/>
                <a:gd name="csY0" fmla="*/ 12080 h 11801"/>
                <a:gd name="csX1" fmla="*/ 6246 w 5900"/>
                <a:gd name="csY1" fmla="*/ 6179 h 11801"/>
                <a:gd name="csX2" fmla="*/ 346 w 5900"/>
                <a:gd name="csY2" fmla="*/ 279 h 11801"/>
              </a:gdLst>
              <a:ahLst/>
              <a:cxnLst>
                <a:cxn ang="0">
                  <a:pos x="csX0" y="csY0"/>
                </a:cxn>
                <a:cxn ang="0">
                  <a:pos x="csX1" y="csY1"/>
                </a:cxn>
                <a:cxn ang="0">
                  <a:pos x="csX2" y="csY2"/>
                </a:cxn>
              </a:cxnLst>
              <a:rect l="l" t="t" r="r" b="b"/>
              <a:pathLst>
                <a:path w="5900" h="11801">
                  <a:moveTo>
                    <a:pt x="346" y="12080"/>
                  </a:moveTo>
                  <a:cubicBezTo>
                    <a:pt x="3604" y="12080"/>
                    <a:pt x="6246" y="9438"/>
                    <a:pt x="6246" y="6179"/>
                  </a:cubicBezTo>
                  <a:cubicBezTo>
                    <a:pt x="6246" y="2921"/>
                    <a:pt x="3604" y="279"/>
                    <a:pt x="346" y="279"/>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3" name="フリーフォーム: 図形 252">
              <a:extLst>
                <a:ext uri="{FF2B5EF4-FFF2-40B4-BE49-F238E27FC236}">
                  <a16:creationId xmlns:a16="http://schemas.microsoft.com/office/drawing/2014/main" id="{54FBB416-3C63-C3FF-1A2C-6BDF9F8EA670}"/>
                </a:ext>
              </a:extLst>
            </p:cNvPr>
            <p:cNvSpPr/>
            <p:nvPr/>
          </p:nvSpPr>
          <p:spPr>
            <a:xfrm rot="2727639">
              <a:off x="4165221" y="5468186"/>
              <a:ext cx="51926" cy="25963"/>
            </a:xfrm>
            <a:custGeom>
              <a:avLst/>
              <a:gdLst>
                <a:gd name="csX0" fmla="*/ 354 w 51926"/>
                <a:gd name="csY0" fmla="*/ 286 h 25963"/>
                <a:gd name="csX1" fmla="*/ 52281 w 51926"/>
                <a:gd name="csY1" fmla="*/ 13268 h 25963"/>
                <a:gd name="csX2" fmla="*/ 354 w 51926"/>
                <a:gd name="csY2" fmla="*/ 26250 h 25963"/>
              </a:gdLst>
              <a:ahLst/>
              <a:cxnLst>
                <a:cxn ang="0">
                  <a:pos x="csX0" y="csY0"/>
                </a:cxn>
                <a:cxn ang="0">
                  <a:pos x="csX1" y="csY1"/>
                </a:cxn>
                <a:cxn ang="0">
                  <a:pos x="csX2" y="csY2"/>
                </a:cxn>
              </a:cxnLst>
              <a:rect l="l" t="t" r="r" b="b"/>
              <a:pathLst>
                <a:path w="51926" h="25963">
                  <a:moveTo>
                    <a:pt x="354" y="286"/>
                  </a:moveTo>
                  <a:cubicBezTo>
                    <a:pt x="17663" y="8941"/>
                    <a:pt x="34972" y="13268"/>
                    <a:pt x="52281" y="13268"/>
                  </a:cubicBezTo>
                  <a:cubicBezTo>
                    <a:pt x="34972" y="13268"/>
                    <a:pt x="17663" y="17595"/>
                    <a:pt x="354" y="26250"/>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4" name="フリーフォーム: 図形 253">
              <a:extLst>
                <a:ext uri="{FF2B5EF4-FFF2-40B4-BE49-F238E27FC236}">
                  <a16:creationId xmlns:a16="http://schemas.microsoft.com/office/drawing/2014/main" id="{F7405186-41AE-3DF0-F218-AE2ADADB0F44}"/>
                </a:ext>
              </a:extLst>
            </p:cNvPr>
            <p:cNvSpPr/>
            <p:nvPr/>
          </p:nvSpPr>
          <p:spPr>
            <a:xfrm>
              <a:off x="4199022" y="5243053"/>
              <a:ext cx="119250" cy="95046"/>
            </a:xfrm>
            <a:custGeom>
              <a:avLst/>
              <a:gdLst>
                <a:gd name="csX0" fmla="*/ 115661 w 119250"/>
                <a:gd name="csY0" fmla="*/ 275 h 95046"/>
                <a:gd name="csX1" fmla="*/ -3590 w 119250"/>
                <a:gd name="csY1" fmla="*/ 95321 h 95046"/>
              </a:gdLst>
              <a:ahLst/>
              <a:cxnLst>
                <a:cxn ang="0">
                  <a:pos x="csX0" y="csY0"/>
                </a:cxn>
                <a:cxn ang="0">
                  <a:pos x="csX1" y="csY1"/>
                </a:cxn>
              </a:cxnLst>
              <a:rect l="l" t="t" r="r" b="b"/>
              <a:pathLst>
                <a:path w="119250" h="95046">
                  <a:moveTo>
                    <a:pt x="115661" y="275"/>
                  </a:moveTo>
                  <a:lnTo>
                    <a:pt x="-3590" y="95321"/>
                  </a:lnTo>
                </a:path>
              </a:pathLst>
            </a:custGeom>
            <a:noFill/>
            <a:ln w="11787" cap="flat">
              <a:solidFill>
                <a:srgbClr val="F46D43"/>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5" name="フリーフォーム: 図形 254">
              <a:extLst>
                <a:ext uri="{FF2B5EF4-FFF2-40B4-BE49-F238E27FC236}">
                  <a16:creationId xmlns:a16="http://schemas.microsoft.com/office/drawing/2014/main" id="{6FB33D86-59C8-ACE6-B815-7CCF510739CD}"/>
                </a:ext>
              </a:extLst>
            </p:cNvPr>
            <p:cNvSpPr/>
            <p:nvPr/>
          </p:nvSpPr>
          <p:spPr>
            <a:xfrm rot="19286637">
              <a:off x="4317629" y="5235313"/>
              <a:ext cx="5900" cy="11801"/>
            </a:xfrm>
            <a:custGeom>
              <a:avLst/>
              <a:gdLst>
                <a:gd name="csX0" fmla="*/ 378 w 5900"/>
                <a:gd name="csY0" fmla="*/ 12042 h 11801"/>
                <a:gd name="csX1" fmla="*/ 6279 w 5900"/>
                <a:gd name="csY1" fmla="*/ 6141 h 11801"/>
                <a:gd name="csX2" fmla="*/ 378 w 5900"/>
                <a:gd name="csY2" fmla="*/ 240 h 11801"/>
              </a:gdLst>
              <a:ahLst/>
              <a:cxnLst>
                <a:cxn ang="0">
                  <a:pos x="csX0" y="csY0"/>
                </a:cxn>
                <a:cxn ang="0">
                  <a:pos x="csX1" y="csY1"/>
                </a:cxn>
                <a:cxn ang="0">
                  <a:pos x="csX2" y="csY2"/>
                </a:cxn>
              </a:cxnLst>
              <a:rect l="l" t="t" r="r" b="b"/>
              <a:pathLst>
                <a:path w="5900" h="11801">
                  <a:moveTo>
                    <a:pt x="378" y="12042"/>
                  </a:moveTo>
                  <a:cubicBezTo>
                    <a:pt x="3637" y="12042"/>
                    <a:pt x="6279" y="9400"/>
                    <a:pt x="6279" y="6141"/>
                  </a:cubicBezTo>
                  <a:cubicBezTo>
                    <a:pt x="6279" y="2882"/>
                    <a:pt x="3637" y="240"/>
                    <a:pt x="378" y="240"/>
                  </a:cubicBezTo>
                  <a:close/>
                </a:path>
              </a:pathLst>
            </a:custGeom>
            <a:solidFill>
              <a:srgbClr val="F46D43"/>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6" name="フリーフォーム: 図形 255">
              <a:extLst>
                <a:ext uri="{FF2B5EF4-FFF2-40B4-BE49-F238E27FC236}">
                  <a16:creationId xmlns:a16="http://schemas.microsoft.com/office/drawing/2014/main" id="{F90A3AFB-E78C-6B0C-67F7-299CFFC848B7}"/>
                </a:ext>
              </a:extLst>
            </p:cNvPr>
            <p:cNvSpPr/>
            <p:nvPr/>
          </p:nvSpPr>
          <p:spPr>
            <a:xfrm rot="8486637">
              <a:off x="4152755" y="5341300"/>
              <a:ext cx="51926" cy="25963"/>
            </a:xfrm>
            <a:custGeom>
              <a:avLst/>
              <a:gdLst>
                <a:gd name="csX0" fmla="*/ 352 w 51926"/>
                <a:gd name="csY0" fmla="*/ 262 h 25963"/>
                <a:gd name="csX1" fmla="*/ 52279 w 51926"/>
                <a:gd name="csY1" fmla="*/ 13244 h 25963"/>
                <a:gd name="csX2" fmla="*/ 352 w 51926"/>
                <a:gd name="csY2" fmla="*/ 26225 h 25963"/>
              </a:gdLst>
              <a:ahLst/>
              <a:cxnLst>
                <a:cxn ang="0">
                  <a:pos x="csX0" y="csY0"/>
                </a:cxn>
                <a:cxn ang="0">
                  <a:pos x="csX1" y="csY1"/>
                </a:cxn>
                <a:cxn ang="0">
                  <a:pos x="csX2" y="csY2"/>
                </a:cxn>
              </a:cxnLst>
              <a:rect l="l" t="t" r="r" b="b"/>
              <a:pathLst>
                <a:path w="51926" h="25963">
                  <a:moveTo>
                    <a:pt x="352" y="262"/>
                  </a:moveTo>
                  <a:lnTo>
                    <a:pt x="52279" y="13244"/>
                  </a:lnTo>
                  <a:lnTo>
                    <a:pt x="352" y="26225"/>
                  </a:lnTo>
                  <a:close/>
                </a:path>
              </a:pathLst>
            </a:custGeom>
            <a:solidFill>
              <a:srgbClr val="F46D43"/>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7" name="フリーフォーム: 図形 256">
              <a:extLst>
                <a:ext uri="{FF2B5EF4-FFF2-40B4-BE49-F238E27FC236}">
                  <a16:creationId xmlns:a16="http://schemas.microsoft.com/office/drawing/2014/main" id="{CD67047D-EF61-F445-C8E7-AA5EBACBD17C}"/>
                </a:ext>
              </a:extLst>
            </p:cNvPr>
            <p:cNvSpPr/>
            <p:nvPr/>
          </p:nvSpPr>
          <p:spPr>
            <a:xfrm>
              <a:off x="3953030" y="4337737"/>
              <a:ext cx="52950" cy="90154"/>
            </a:xfrm>
            <a:custGeom>
              <a:avLst/>
              <a:gdLst>
                <a:gd name="csX0" fmla="*/ 49425 w 52950"/>
                <a:gd name="csY0" fmla="*/ 484 h 90154"/>
                <a:gd name="csX1" fmla="*/ -3525 w 52950"/>
                <a:gd name="csY1" fmla="*/ 90639 h 90154"/>
              </a:gdLst>
              <a:ahLst/>
              <a:cxnLst>
                <a:cxn ang="0">
                  <a:pos x="csX0" y="csY0"/>
                </a:cxn>
                <a:cxn ang="0">
                  <a:pos x="csX1" y="csY1"/>
                </a:cxn>
              </a:cxnLst>
              <a:rect l="l" t="t" r="r" b="b"/>
              <a:pathLst>
                <a:path w="52950" h="90154">
                  <a:moveTo>
                    <a:pt x="49425" y="484"/>
                  </a:moveTo>
                  <a:lnTo>
                    <a:pt x="-3525" y="90639"/>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8" name="フリーフォーム: 図形 257">
              <a:extLst>
                <a:ext uri="{FF2B5EF4-FFF2-40B4-BE49-F238E27FC236}">
                  <a16:creationId xmlns:a16="http://schemas.microsoft.com/office/drawing/2014/main" id="{485BC93F-97A6-6EBA-7FB3-2EDBFA0E2AFC}"/>
                </a:ext>
              </a:extLst>
            </p:cNvPr>
            <p:cNvSpPr/>
            <p:nvPr/>
          </p:nvSpPr>
          <p:spPr>
            <a:xfrm>
              <a:off x="2883945" y="4916300"/>
              <a:ext cx="74119" cy="37318"/>
            </a:xfrm>
            <a:custGeom>
              <a:avLst/>
              <a:gdLst>
                <a:gd name="csX0" fmla="*/ 70839 w 74119"/>
                <a:gd name="csY0" fmla="*/ 37675 h 37318"/>
                <a:gd name="csX1" fmla="*/ -3281 w 74119"/>
                <a:gd name="csY1" fmla="*/ 357 h 37318"/>
              </a:gdLst>
              <a:ahLst/>
              <a:cxnLst>
                <a:cxn ang="0">
                  <a:pos x="csX0" y="csY0"/>
                </a:cxn>
                <a:cxn ang="0">
                  <a:pos x="csX1" y="csY1"/>
                </a:cxn>
              </a:cxnLst>
              <a:rect l="l" t="t" r="r" b="b"/>
              <a:pathLst>
                <a:path w="74119" h="37318">
                  <a:moveTo>
                    <a:pt x="70839" y="37675"/>
                  </a:moveTo>
                  <a:lnTo>
                    <a:pt x="-3281" y="357"/>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59" name="フリーフォーム: 図形 258">
              <a:extLst>
                <a:ext uri="{FF2B5EF4-FFF2-40B4-BE49-F238E27FC236}">
                  <a16:creationId xmlns:a16="http://schemas.microsoft.com/office/drawing/2014/main" id="{AC1F06E9-2409-0DA9-DF3A-9E6D4AE7EF0D}"/>
                </a:ext>
              </a:extLst>
            </p:cNvPr>
            <p:cNvSpPr/>
            <p:nvPr/>
          </p:nvSpPr>
          <p:spPr>
            <a:xfrm>
              <a:off x="2756898" y="4756807"/>
              <a:ext cx="48232" cy="84888"/>
            </a:xfrm>
            <a:custGeom>
              <a:avLst/>
              <a:gdLst>
                <a:gd name="csX0" fmla="*/ 44984 w 48232"/>
                <a:gd name="csY0" fmla="*/ 85276 h 84888"/>
                <a:gd name="csX1" fmla="*/ -3249 w 48232"/>
                <a:gd name="csY1" fmla="*/ 388 h 84888"/>
              </a:gdLst>
              <a:ahLst/>
              <a:cxnLst>
                <a:cxn ang="0">
                  <a:pos x="csX0" y="csY0"/>
                </a:cxn>
                <a:cxn ang="0">
                  <a:pos x="csX1" y="csY1"/>
                </a:cxn>
              </a:cxnLst>
              <a:rect l="l" t="t" r="r" b="b"/>
              <a:pathLst>
                <a:path w="48232" h="84888">
                  <a:moveTo>
                    <a:pt x="44984" y="85276"/>
                  </a:moveTo>
                  <a:lnTo>
                    <a:pt x="-3249" y="388"/>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0" name="フリーフォーム: 図形 259">
              <a:extLst>
                <a:ext uri="{FF2B5EF4-FFF2-40B4-BE49-F238E27FC236}">
                  <a16:creationId xmlns:a16="http://schemas.microsoft.com/office/drawing/2014/main" id="{4934005D-250C-E1FA-DA50-9271FF7BD272}"/>
                </a:ext>
              </a:extLst>
            </p:cNvPr>
            <p:cNvSpPr/>
            <p:nvPr/>
          </p:nvSpPr>
          <p:spPr>
            <a:xfrm rot="3623703">
              <a:off x="2803638" y="4838360"/>
              <a:ext cx="5900" cy="11801"/>
            </a:xfrm>
            <a:custGeom>
              <a:avLst/>
              <a:gdLst>
                <a:gd name="csX0" fmla="*/ 86 w 5900"/>
                <a:gd name="csY0" fmla="*/ 11965 h 11801"/>
                <a:gd name="csX1" fmla="*/ 5987 w 5900"/>
                <a:gd name="csY1" fmla="*/ 6064 h 11801"/>
                <a:gd name="csX2" fmla="*/ 86 w 5900"/>
                <a:gd name="csY2" fmla="*/ 164 h 11801"/>
              </a:gdLst>
              <a:ahLst/>
              <a:cxnLst>
                <a:cxn ang="0">
                  <a:pos x="csX0" y="csY0"/>
                </a:cxn>
                <a:cxn ang="0">
                  <a:pos x="csX1" y="csY1"/>
                </a:cxn>
                <a:cxn ang="0">
                  <a:pos x="csX2" y="csY2"/>
                </a:cxn>
              </a:cxnLst>
              <a:rect l="l" t="t" r="r" b="b"/>
              <a:pathLst>
                <a:path w="5900" h="11801">
                  <a:moveTo>
                    <a:pt x="86" y="11965"/>
                  </a:moveTo>
                  <a:cubicBezTo>
                    <a:pt x="3345" y="11965"/>
                    <a:pt x="5987" y="9323"/>
                    <a:pt x="5987" y="6064"/>
                  </a:cubicBezTo>
                  <a:cubicBezTo>
                    <a:pt x="5987" y="2805"/>
                    <a:pt x="3345" y="164"/>
                    <a:pt x="86" y="164"/>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1" name="フリーフォーム: 図形 260">
              <a:extLst>
                <a:ext uri="{FF2B5EF4-FFF2-40B4-BE49-F238E27FC236}">
                  <a16:creationId xmlns:a16="http://schemas.microsoft.com/office/drawing/2014/main" id="{317DDEA5-42B1-3EED-0806-EEF72921A198}"/>
                </a:ext>
              </a:extLst>
            </p:cNvPr>
            <p:cNvSpPr/>
            <p:nvPr/>
          </p:nvSpPr>
          <p:spPr>
            <a:xfrm rot="14423703">
              <a:off x="2718108" y="4721251"/>
              <a:ext cx="51926" cy="25963"/>
            </a:xfrm>
            <a:custGeom>
              <a:avLst/>
              <a:gdLst>
                <a:gd name="csX0" fmla="*/ 75 w 51926"/>
                <a:gd name="csY0" fmla="*/ 142 h 25963"/>
                <a:gd name="csX1" fmla="*/ 52002 w 51926"/>
                <a:gd name="csY1" fmla="*/ 13124 h 25963"/>
                <a:gd name="csX2" fmla="*/ 75 w 51926"/>
                <a:gd name="csY2" fmla="*/ 26106 h 25963"/>
              </a:gdLst>
              <a:ahLst/>
              <a:cxnLst>
                <a:cxn ang="0">
                  <a:pos x="csX0" y="csY0"/>
                </a:cxn>
                <a:cxn ang="0">
                  <a:pos x="csX1" y="csY1"/>
                </a:cxn>
                <a:cxn ang="0">
                  <a:pos x="csX2" y="csY2"/>
                </a:cxn>
              </a:cxnLst>
              <a:rect l="l" t="t" r="r" b="b"/>
              <a:pathLst>
                <a:path w="51926" h="25963">
                  <a:moveTo>
                    <a:pt x="75" y="142"/>
                  </a:moveTo>
                  <a:cubicBezTo>
                    <a:pt x="17384" y="8797"/>
                    <a:pt x="34693" y="13124"/>
                    <a:pt x="52002" y="13124"/>
                  </a:cubicBezTo>
                  <a:cubicBezTo>
                    <a:pt x="34693" y="13124"/>
                    <a:pt x="17384" y="17451"/>
                    <a:pt x="75" y="26106"/>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2" name="フリーフォーム: 図形 261">
              <a:extLst>
                <a:ext uri="{FF2B5EF4-FFF2-40B4-BE49-F238E27FC236}">
                  <a16:creationId xmlns:a16="http://schemas.microsoft.com/office/drawing/2014/main" id="{B284069D-7CC1-F41C-6BEC-E17257135A4D}"/>
                </a:ext>
              </a:extLst>
            </p:cNvPr>
            <p:cNvSpPr/>
            <p:nvPr/>
          </p:nvSpPr>
          <p:spPr>
            <a:xfrm>
              <a:off x="2860480" y="4638765"/>
              <a:ext cx="113629" cy="202692"/>
            </a:xfrm>
            <a:custGeom>
              <a:avLst/>
              <a:gdLst>
                <a:gd name="csX0" fmla="*/ 110350 w 113629"/>
                <a:gd name="csY0" fmla="*/ 402 h 202692"/>
                <a:gd name="csX1" fmla="*/ -3280 w 113629"/>
                <a:gd name="csY1" fmla="*/ 203094 h 202692"/>
              </a:gdLst>
              <a:ahLst/>
              <a:cxnLst>
                <a:cxn ang="0">
                  <a:pos x="csX0" y="csY0"/>
                </a:cxn>
                <a:cxn ang="0">
                  <a:pos x="csX1" y="csY1"/>
                </a:cxn>
              </a:cxnLst>
              <a:rect l="l" t="t" r="r" b="b"/>
              <a:pathLst>
                <a:path w="113629" h="202692">
                  <a:moveTo>
                    <a:pt x="110350" y="402"/>
                  </a:moveTo>
                  <a:lnTo>
                    <a:pt x="-3280" y="203094"/>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3" name="フリーフォーム: 図形 262">
              <a:extLst>
                <a:ext uri="{FF2B5EF4-FFF2-40B4-BE49-F238E27FC236}">
                  <a16:creationId xmlns:a16="http://schemas.microsoft.com/office/drawing/2014/main" id="{A1407923-DE81-839F-4040-2F1F7FE39D7C}"/>
                </a:ext>
              </a:extLst>
            </p:cNvPr>
            <p:cNvSpPr/>
            <p:nvPr/>
          </p:nvSpPr>
          <p:spPr>
            <a:xfrm>
              <a:off x="2882927" y="4779585"/>
              <a:ext cx="157866" cy="84319"/>
            </a:xfrm>
            <a:custGeom>
              <a:avLst/>
              <a:gdLst>
                <a:gd name="csX0" fmla="*/ -3290 w 157866"/>
                <a:gd name="csY0" fmla="*/ 84702 h 84319"/>
                <a:gd name="csX1" fmla="*/ 154576 w 157866"/>
                <a:gd name="csY1" fmla="*/ 383 h 84319"/>
              </a:gdLst>
              <a:ahLst/>
              <a:cxnLst>
                <a:cxn ang="0">
                  <a:pos x="csX0" y="csY0"/>
                </a:cxn>
                <a:cxn ang="0">
                  <a:pos x="csX1" y="csY1"/>
                </a:cxn>
              </a:cxnLst>
              <a:rect l="l" t="t" r="r" b="b"/>
              <a:pathLst>
                <a:path w="157866" h="84319">
                  <a:moveTo>
                    <a:pt x="-3290" y="84702"/>
                  </a:moveTo>
                  <a:lnTo>
                    <a:pt x="154576" y="383"/>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4" name="フリーフォーム: 図形 263">
              <a:extLst>
                <a:ext uri="{FF2B5EF4-FFF2-40B4-BE49-F238E27FC236}">
                  <a16:creationId xmlns:a16="http://schemas.microsoft.com/office/drawing/2014/main" id="{4DC904CD-D2AC-87FD-DEDC-104C21B945B7}"/>
                </a:ext>
              </a:extLst>
            </p:cNvPr>
            <p:cNvSpPr/>
            <p:nvPr/>
          </p:nvSpPr>
          <p:spPr>
            <a:xfrm rot="9113548">
              <a:off x="2877374" y="4859393"/>
              <a:ext cx="5900" cy="11801"/>
            </a:xfrm>
            <a:custGeom>
              <a:avLst/>
              <a:gdLst>
                <a:gd name="csX0" fmla="*/ 100 w 5900"/>
                <a:gd name="csY0" fmla="*/ 11969 h 11801"/>
                <a:gd name="csX1" fmla="*/ 6001 w 5900"/>
                <a:gd name="csY1" fmla="*/ 6068 h 11801"/>
                <a:gd name="csX2" fmla="*/ 100 w 5900"/>
                <a:gd name="csY2" fmla="*/ 168 h 11801"/>
              </a:gdLst>
              <a:ahLst/>
              <a:cxnLst>
                <a:cxn ang="0">
                  <a:pos x="csX0" y="csY0"/>
                </a:cxn>
                <a:cxn ang="0">
                  <a:pos x="csX1" y="csY1"/>
                </a:cxn>
                <a:cxn ang="0">
                  <a:pos x="csX2" y="csY2"/>
                </a:cxn>
              </a:cxnLst>
              <a:rect l="l" t="t" r="r" b="b"/>
              <a:pathLst>
                <a:path w="5900" h="11801">
                  <a:moveTo>
                    <a:pt x="100" y="11969"/>
                  </a:moveTo>
                  <a:cubicBezTo>
                    <a:pt x="3359" y="11969"/>
                    <a:pt x="6001" y="9327"/>
                    <a:pt x="6001" y="6068"/>
                  </a:cubicBezTo>
                  <a:cubicBezTo>
                    <a:pt x="6001" y="2809"/>
                    <a:pt x="3359" y="168"/>
                    <a:pt x="100" y="168"/>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5" name="フリーフォーム: 図形 264">
              <a:extLst>
                <a:ext uri="{FF2B5EF4-FFF2-40B4-BE49-F238E27FC236}">
                  <a16:creationId xmlns:a16="http://schemas.microsoft.com/office/drawing/2014/main" id="{EF4B61B5-6450-D289-50CE-2EFB3FF2F925}"/>
                </a:ext>
              </a:extLst>
            </p:cNvPr>
            <p:cNvSpPr/>
            <p:nvPr/>
          </p:nvSpPr>
          <p:spPr>
            <a:xfrm rot="19913548">
              <a:off x="3037731" y="4754371"/>
              <a:ext cx="51926" cy="25963"/>
            </a:xfrm>
            <a:custGeom>
              <a:avLst/>
              <a:gdLst>
                <a:gd name="csX0" fmla="*/ 137 w 51926"/>
                <a:gd name="csY0" fmla="*/ 149 h 25963"/>
                <a:gd name="csX1" fmla="*/ 52064 w 51926"/>
                <a:gd name="csY1" fmla="*/ 13130 h 25963"/>
                <a:gd name="csX2" fmla="*/ 137 w 51926"/>
                <a:gd name="csY2" fmla="*/ 26112 h 25963"/>
              </a:gdLst>
              <a:ahLst/>
              <a:cxnLst>
                <a:cxn ang="0">
                  <a:pos x="csX0" y="csY0"/>
                </a:cxn>
                <a:cxn ang="0">
                  <a:pos x="csX1" y="csY1"/>
                </a:cxn>
                <a:cxn ang="0">
                  <a:pos x="csX2" y="csY2"/>
                </a:cxn>
              </a:cxnLst>
              <a:rect l="l" t="t" r="r" b="b"/>
              <a:pathLst>
                <a:path w="51926" h="25963">
                  <a:moveTo>
                    <a:pt x="137" y="149"/>
                  </a:moveTo>
                  <a:cubicBezTo>
                    <a:pt x="17446" y="8803"/>
                    <a:pt x="34755" y="13130"/>
                    <a:pt x="52064" y="13130"/>
                  </a:cubicBezTo>
                  <a:cubicBezTo>
                    <a:pt x="34755" y="13130"/>
                    <a:pt x="17446" y="17458"/>
                    <a:pt x="137" y="26112"/>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6" name="フリーフォーム: 図形 265">
              <a:extLst>
                <a:ext uri="{FF2B5EF4-FFF2-40B4-BE49-F238E27FC236}">
                  <a16:creationId xmlns:a16="http://schemas.microsoft.com/office/drawing/2014/main" id="{141EAFBE-7B3D-A70F-E157-740952D8ECA0}"/>
                </a:ext>
              </a:extLst>
            </p:cNvPr>
            <p:cNvSpPr/>
            <p:nvPr/>
          </p:nvSpPr>
          <p:spPr>
            <a:xfrm>
              <a:off x="2790389" y="5015963"/>
              <a:ext cx="167016" cy="79715"/>
            </a:xfrm>
            <a:custGeom>
              <a:avLst/>
              <a:gdLst>
                <a:gd name="csX0" fmla="*/ 163747 w 167016"/>
                <a:gd name="csY0" fmla="*/ 329 h 79715"/>
                <a:gd name="csX1" fmla="*/ -3270 w 167016"/>
                <a:gd name="csY1" fmla="*/ 80044 h 79715"/>
              </a:gdLst>
              <a:ahLst/>
              <a:cxnLst>
                <a:cxn ang="0">
                  <a:pos x="csX0" y="csY0"/>
                </a:cxn>
                <a:cxn ang="0">
                  <a:pos x="csX1" y="csY1"/>
                </a:cxn>
              </a:cxnLst>
              <a:rect l="l" t="t" r="r" b="b"/>
              <a:pathLst>
                <a:path w="167016" h="79715">
                  <a:moveTo>
                    <a:pt x="163747" y="329"/>
                  </a:moveTo>
                  <a:lnTo>
                    <a:pt x="-3270" y="80044"/>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7" name="フリーフォーム: 図形 266">
              <a:extLst>
                <a:ext uri="{FF2B5EF4-FFF2-40B4-BE49-F238E27FC236}">
                  <a16:creationId xmlns:a16="http://schemas.microsoft.com/office/drawing/2014/main" id="{D0526711-D80F-F641-BA8D-73E077A86CFE}"/>
                </a:ext>
              </a:extLst>
            </p:cNvPr>
            <p:cNvSpPr/>
            <p:nvPr/>
          </p:nvSpPr>
          <p:spPr>
            <a:xfrm>
              <a:off x="3485960" y="5499556"/>
              <a:ext cx="30658" cy="283650"/>
            </a:xfrm>
            <a:custGeom>
              <a:avLst/>
              <a:gdLst>
                <a:gd name="csX0" fmla="*/ -3415 w 30658"/>
                <a:gd name="csY0" fmla="*/ 194 h 283650"/>
                <a:gd name="csX1" fmla="*/ 27243 w 30658"/>
                <a:gd name="csY1" fmla="*/ 283844 h 283650"/>
              </a:gdLst>
              <a:ahLst/>
              <a:cxnLst>
                <a:cxn ang="0">
                  <a:pos x="csX0" y="csY0"/>
                </a:cxn>
                <a:cxn ang="0">
                  <a:pos x="csX1" y="csY1"/>
                </a:cxn>
              </a:cxnLst>
              <a:rect l="l" t="t" r="r" b="b"/>
              <a:pathLst>
                <a:path w="30658" h="283650">
                  <a:moveTo>
                    <a:pt x="-3415" y="194"/>
                  </a:moveTo>
                  <a:lnTo>
                    <a:pt x="27243" y="28384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8" name="フリーフォーム: 図形 267">
              <a:extLst>
                <a:ext uri="{FF2B5EF4-FFF2-40B4-BE49-F238E27FC236}">
                  <a16:creationId xmlns:a16="http://schemas.microsoft.com/office/drawing/2014/main" id="{4D4FDCA3-F898-4DB6-5B0C-AB8BF15A2A79}"/>
                </a:ext>
              </a:extLst>
            </p:cNvPr>
            <p:cNvSpPr/>
            <p:nvPr/>
          </p:nvSpPr>
          <p:spPr>
            <a:xfrm rot="15829874">
              <a:off x="3482693" y="5490722"/>
              <a:ext cx="5900" cy="11801"/>
            </a:xfrm>
            <a:custGeom>
              <a:avLst/>
              <a:gdLst>
                <a:gd name="csX0" fmla="*/ 217 w 5900"/>
                <a:gd name="csY0" fmla="*/ 12091 h 11801"/>
                <a:gd name="csX1" fmla="*/ 6118 w 5900"/>
                <a:gd name="csY1" fmla="*/ 6190 h 11801"/>
                <a:gd name="csX2" fmla="*/ 217 w 5900"/>
                <a:gd name="csY2" fmla="*/ 289 h 11801"/>
              </a:gdLst>
              <a:ahLst/>
              <a:cxnLst>
                <a:cxn ang="0">
                  <a:pos x="csX0" y="csY0"/>
                </a:cxn>
                <a:cxn ang="0">
                  <a:pos x="csX1" y="csY1"/>
                </a:cxn>
                <a:cxn ang="0">
                  <a:pos x="csX2" y="csY2"/>
                </a:cxn>
              </a:cxnLst>
              <a:rect l="l" t="t" r="r" b="b"/>
              <a:pathLst>
                <a:path w="5900" h="11801">
                  <a:moveTo>
                    <a:pt x="217" y="12091"/>
                  </a:moveTo>
                  <a:cubicBezTo>
                    <a:pt x="3476" y="12091"/>
                    <a:pt x="6118" y="9449"/>
                    <a:pt x="6118" y="6190"/>
                  </a:cubicBezTo>
                  <a:cubicBezTo>
                    <a:pt x="6118" y="2931"/>
                    <a:pt x="3476" y="289"/>
                    <a:pt x="217" y="289"/>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69" name="フリーフォーム: 図形 268">
              <a:extLst>
                <a:ext uri="{FF2B5EF4-FFF2-40B4-BE49-F238E27FC236}">
                  <a16:creationId xmlns:a16="http://schemas.microsoft.com/office/drawing/2014/main" id="{A61DF999-BBA4-D36A-7716-AD43C6B01148}"/>
                </a:ext>
              </a:extLst>
            </p:cNvPr>
            <p:cNvSpPr/>
            <p:nvPr/>
          </p:nvSpPr>
          <p:spPr>
            <a:xfrm rot="5029874">
              <a:off x="3493445" y="5796037"/>
              <a:ext cx="51926" cy="25963"/>
            </a:xfrm>
            <a:custGeom>
              <a:avLst/>
              <a:gdLst>
                <a:gd name="csX0" fmla="*/ 225 w 51926"/>
                <a:gd name="csY0" fmla="*/ 350 h 25963"/>
                <a:gd name="csX1" fmla="*/ 52152 w 51926"/>
                <a:gd name="csY1" fmla="*/ 13331 h 25963"/>
                <a:gd name="csX2" fmla="*/ 225 w 51926"/>
                <a:gd name="csY2" fmla="*/ 26313 h 25963"/>
              </a:gdLst>
              <a:ahLst/>
              <a:cxnLst>
                <a:cxn ang="0">
                  <a:pos x="csX0" y="csY0"/>
                </a:cxn>
                <a:cxn ang="0">
                  <a:pos x="csX1" y="csY1"/>
                </a:cxn>
                <a:cxn ang="0">
                  <a:pos x="csX2" y="csY2"/>
                </a:cxn>
              </a:cxnLst>
              <a:rect l="l" t="t" r="r" b="b"/>
              <a:pathLst>
                <a:path w="51926" h="25963">
                  <a:moveTo>
                    <a:pt x="225" y="350"/>
                  </a:moveTo>
                  <a:cubicBezTo>
                    <a:pt x="17534" y="9004"/>
                    <a:pt x="34843" y="13331"/>
                    <a:pt x="52152" y="13331"/>
                  </a:cubicBezTo>
                  <a:cubicBezTo>
                    <a:pt x="34843" y="13331"/>
                    <a:pt x="17534" y="17658"/>
                    <a:pt x="225" y="26313"/>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0" name="フリーフォーム: 図形 269">
              <a:extLst>
                <a:ext uri="{FF2B5EF4-FFF2-40B4-BE49-F238E27FC236}">
                  <a16:creationId xmlns:a16="http://schemas.microsoft.com/office/drawing/2014/main" id="{33F405D6-C0C1-3E6C-C284-13961F08A628}"/>
                </a:ext>
              </a:extLst>
            </p:cNvPr>
            <p:cNvSpPr/>
            <p:nvPr/>
          </p:nvSpPr>
          <p:spPr>
            <a:xfrm>
              <a:off x="3598560" y="5519290"/>
              <a:ext cx="192231" cy="284269"/>
            </a:xfrm>
            <a:custGeom>
              <a:avLst/>
              <a:gdLst>
                <a:gd name="csX0" fmla="*/ 188772 w 192231"/>
                <a:gd name="csY0" fmla="*/ 189 h 284269"/>
                <a:gd name="csX1" fmla="*/ -3459 w 192231"/>
                <a:gd name="csY1" fmla="*/ 284459 h 284269"/>
              </a:gdLst>
              <a:ahLst/>
              <a:cxnLst>
                <a:cxn ang="0">
                  <a:pos x="csX0" y="csY0"/>
                </a:cxn>
                <a:cxn ang="0">
                  <a:pos x="csX1" y="csY1"/>
                </a:cxn>
              </a:cxnLst>
              <a:rect l="l" t="t" r="r" b="b"/>
              <a:pathLst>
                <a:path w="192231" h="284269">
                  <a:moveTo>
                    <a:pt x="188772" y="189"/>
                  </a:moveTo>
                  <a:lnTo>
                    <a:pt x="-3459" y="284459"/>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1" name="フリーフォーム: 図形 270">
              <a:extLst>
                <a:ext uri="{FF2B5EF4-FFF2-40B4-BE49-F238E27FC236}">
                  <a16:creationId xmlns:a16="http://schemas.microsoft.com/office/drawing/2014/main" id="{2FB10579-EA28-4DFC-E179-824F3EDF1907}"/>
                </a:ext>
              </a:extLst>
            </p:cNvPr>
            <p:cNvSpPr/>
            <p:nvPr/>
          </p:nvSpPr>
          <p:spPr>
            <a:xfrm rot="18244060">
              <a:off x="3789494" y="5510945"/>
              <a:ext cx="5900" cy="11801"/>
            </a:xfrm>
            <a:custGeom>
              <a:avLst/>
              <a:gdLst>
                <a:gd name="csX0" fmla="*/ 276 w 5900"/>
                <a:gd name="csY0" fmla="*/ 12095 h 11801"/>
                <a:gd name="csX1" fmla="*/ 6177 w 5900"/>
                <a:gd name="csY1" fmla="*/ 6194 h 11801"/>
                <a:gd name="csX2" fmla="*/ 276 w 5900"/>
                <a:gd name="csY2" fmla="*/ 293 h 11801"/>
              </a:gdLst>
              <a:ahLst/>
              <a:cxnLst>
                <a:cxn ang="0">
                  <a:pos x="csX0" y="csY0"/>
                </a:cxn>
                <a:cxn ang="0">
                  <a:pos x="csX1" y="csY1"/>
                </a:cxn>
                <a:cxn ang="0">
                  <a:pos x="csX2" y="csY2"/>
                </a:cxn>
              </a:cxnLst>
              <a:rect l="l" t="t" r="r" b="b"/>
              <a:pathLst>
                <a:path w="5900" h="11801">
                  <a:moveTo>
                    <a:pt x="276" y="12095"/>
                  </a:moveTo>
                  <a:cubicBezTo>
                    <a:pt x="3535" y="12095"/>
                    <a:pt x="6177" y="9453"/>
                    <a:pt x="6177" y="6194"/>
                  </a:cubicBezTo>
                  <a:cubicBezTo>
                    <a:pt x="6177" y="2935"/>
                    <a:pt x="3535" y="293"/>
                    <a:pt x="276" y="293"/>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2" name="フリーフォーム: 図形 271">
              <a:extLst>
                <a:ext uri="{FF2B5EF4-FFF2-40B4-BE49-F238E27FC236}">
                  <a16:creationId xmlns:a16="http://schemas.microsoft.com/office/drawing/2014/main" id="{41B43FA4-04DA-764D-6A3C-DC0F8E14C9E3}"/>
                </a:ext>
              </a:extLst>
            </p:cNvPr>
            <p:cNvSpPr/>
            <p:nvPr/>
          </p:nvSpPr>
          <p:spPr>
            <a:xfrm rot="7444060">
              <a:off x="3558053" y="5812085"/>
              <a:ext cx="51926" cy="25963"/>
            </a:xfrm>
            <a:custGeom>
              <a:avLst/>
              <a:gdLst>
                <a:gd name="csX0" fmla="*/ 237 w 51926"/>
                <a:gd name="csY0" fmla="*/ 353 h 25963"/>
                <a:gd name="csX1" fmla="*/ 52164 w 51926"/>
                <a:gd name="csY1" fmla="*/ 13334 h 25963"/>
                <a:gd name="csX2" fmla="*/ 237 w 51926"/>
                <a:gd name="csY2" fmla="*/ 26316 h 25963"/>
              </a:gdLst>
              <a:ahLst/>
              <a:cxnLst>
                <a:cxn ang="0">
                  <a:pos x="csX0" y="csY0"/>
                </a:cxn>
                <a:cxn ang="0">
                  <a:pos x="csX1" y="csY1"/>
                </a:cxn>
                <a:cxn ang="0">
                  <a:pos x="csX2" y="csY2"/>
                </a:cxn>
              </a:cxnLst>
              <a:rect l="l" t="t" r="r" b="b"/>
              <a:pathLst>
                <a:path w="51926" h="25963">
                  <a:moveTo>
                    <a:pt x="237" y="353"/>
                  </a:moveTo>
                  <a:cubicBezTo>
                    <a:pt x="17546" y="9007"/>
                    <a:pt x="34855" y="13334"/>
                    <a:pt x="52164" y="13334"/>
                  </a:cubicBezTo>
                  <a:cubicBezTo>
                    <a:pt x="34855" y="13334"/>
                    <a:pt x="17546" y="17662"/>
                    <a:pt x="237" y="26316"/>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3" name="フリーフォーム: 図形 272">
              <a:extLst>
                <a:ext uri="{FF2B5EF4-FFF2-40B4-BE49-F238E27FC236}">
                  <a16:creationId xmlns:a16="http://schemas.microsoft.com/office/drawing/2014/main" id="{03BB7D1C-3FAF-C5C8-F1AB-99010ECA5784}"/>
                </a:ext>
              </a:extLst>
            </p:cNvPr>
            <p:cNvSpPr/>
            <p:nvPr/>
          </p:nvSpPr>
          <p:spPr>
            <a:xfrm>
              <a:off x="3216233" y="5672007"/>
              <a:ext cx="215091" cy="159976"/>
            </a:xfrm>
            <a:custGeom>
              <a:avLst/>
              <a:gdLst>
                <a:gd name="csX0" fmla="*/ -3374 w 215091"/>
                <a:gd name="csY0" fmla="*/ 168 h 159976"/>
                <a:gd name="csX1" fmla="*/ 211717 w 215091"/>
                <a:gd name="csY1" fmla="*/ 160144 h 159976"/>
              </a:gdLst>
              <a:ahLst/>
              <a:cxnLst>
                <a:cxn ang="0">
                  <a:pos x="csX0" y="csY0"/>
                </a:cxn>
                <a:cxn ang="0">
                  <a:pos x="csX1" y="csY1"/>
                </a:cxn>
              </a:cxnLst>
              <a:rect l="l" t="t" r="r" b="b"/>
              <a:pathLst>
                <a:path w="215091" h="159976">
                  <a:moveTo>
                    <a:pt x="-3374" y="168"/>
                  </a:moveTo>
                  <a:lnTo>
                    <a:pt x="211717" y="16014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4" name="フリーフォーム: 図形 273">
              <a:extLst>
                <a:ext uri="{FF2B5EF4-FFF2-40B4-BE49-F238E27FC236}">
                  <a16:creationId xmlns:a16="http://schemas.microsoft.com/office/drawing/2014/main" id="{67165FFD-859D-0E54-4D27-D00128DFE6C3}"/>
                </a:ext>
              </a:extLst>
            </p:cNvPr>
            <p:cNvSpPr/>
            <p:nvPr/>
          </p:nvSpPr>
          <p:spPr>
            <a:xfrm rot="12998424">
              <a:off x="3210916" y="5664346"/>
              <a:ext cx="5900" cy="11801"/>
            </a:xfrm>
            <a:custGeom>
              <a:avLst/>
              <a:gdLst>
                <a:gd name="csX0" fmla="*/ 165 w 5900"/>
                <a:gd name="csY0" fmla="*/ 12124 h 11801"/>
                <a:gd name="csX1" fmla="*/ 6065 w 5900"/>
                <a:gd name="csY1" fmla="*/ 6224 h 11801"/>
                <a:gd name="csX2" fmla="*/ 165 w 5900"/>
                <a:gd name="csY2" fmla="*/ 323 h 11801"/>
              </a:gdLst>
              <a:ahLst/>
              <a:cxnLst>
                <a:cxn ang="0">
                  <a:pos x="csX0" y="csY0"/>
                </a:cxn>
                <a:cxn ang="0">
                  <a:pos x="csX1" y="csY1"/>
                </a:cxn>
                <a:cxn ang="0">
                  <a:pos x="csX2" y="csY2"/>
                </a:cxn>
              </a:cxnLst>
              <a:rect l="l" t="t" r="r" b="b"/>
              <a:pathLst>
                <a:path w="5900" h="11801">
                  <a:moveTo>
                    <a:pt x="165" y="12124"/>
                  </a:moveTo>
                  <a:cubicBezTo>
                    <a:pt x="3424" y="12124"/>
                    <a:pt x="6065" y="9483"/>
                    <a:pt x="6065" y="6224"/>
                  </a:cubicBezTo>
                  <a:cubicBezTo>
                    <a:pt x="6065" y="2965"/>
                    <a:pt x="3424" y="323"/>
                    <a:pt x="165" y="323"/>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5" name="フリーフォーム: 図形 274">
              <a:extLst>
                <a:ext uri="{FF2B5EF4-FFF2-40B4-BE49-F238E27FC236}">
                  <a16:creationId xmlns:a16="http://schemas.microsoft.com/office/drawing/2014/main" id="{26E798CD-7495-31A3-9A91-724A9EE4724B}"/>
                </a:ext>
              </a:extLst>
            </p:cNvPr>
            <p:cNvSpPr/>
            <p:nvPr/>
          </p:nvSpPr>
          <p:spPr>
            <a:xfrm rot="2198424">
              <a:off x="3426194" y="5834496"/>
              <a:ext cx="51926" cy="25963"/>
            </a:xfrm>
            <a:custGeom>
              <a:avLst/>
              <a:gdLst>
                <a:gd name="csX0" fmla="*/ 212 w 51926"/>
                <a:gd name="csY0" fmla="*/ 357 h 25963"/>
                <a:gd name="csX1" fmla="*/ 52139 w 51926"/>
                <a:gd name="csY1" fmla="*/ 13339 h 25963"/>
                <a:gd name="csX2" fmla="*/ 212 w 51926"/>
                <a:gd name="csY2" fmla="*/ 26320 h 25963"/>
              </a:gdLst>
              <a:ahLst/>
              <a:cxnLst>
                <a:cxn ang="0">
                  <a:pos x="csX0" y="csY0"/>
                </a:cxn>
                <a:cxn ang="0">
                  <a:pos x="csX1" y="csY1"/>
                </a:cxn>
                <a:cxn ang="0">
                  <a:pos x="csX2" y="csY2"/>
                </a:cxn>
              </a:cxnLst>
              <a:rect l="l" t="t" r="r" b="b"/>
              <a:pathLst>
                <a:path w="51926" h="25963">
                  <a:moveTo>
                    <a:pt x="212" y="357"/>
                  </a:moveTo>
                  <a:cubicBezTo>
                    <a:pt x="17521" y="9011"/>
                    <a:pt x="34830" y="13339"/>
                    <a:pt x="52139" y="13339"/>
                  </a:cubicBezTo>
                  <a:cubicBezTo>
                    <a:pt x="34830" y="13339"/>
                    <a:pt x="17521" y="17666"/>
                    <a:pt x="212" y="26320"/>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6" name="フリーフォーム: 図形 275">
              <a:extLst>
                <a:ext uri="{FF2B5EF4-FFF2-40B4-BE49-F238E27FC236}">
                  <a16:creationId xmlns:a16="http://schemas.microsoft.com/office/drawing/2014/main" id="{FEDAAD8E-2960-A6D2-35EE-7647BC31F7D1}"/>
                </a:ext>
              </a:extLst>
            </p:cNvPr>
            <p:cNvSpPr/>
            <p:nvPr/>
          </p:nvSpPr>
          <p:spPr>
            <a:xfrm>
              <a:off x="3716739" y="4505261"/>
              <a:ext cx="146470" cy="279017"/>
            </a:xfrm>
            <a:custGeom>
              <a:avLst/>
              <a:gdLst>
                <a:gd name="csX0" fmla="*/ 142989 w 146470"/>
                <a:gd name="csY0" fmla="*/ 279441 h 279017"/>
                <a:gd name="csX1" fmla="*/ -3481 w 146470"/>
                <a:gd name="csY1" fmla="*/ 424 h 279017"/>
              </a:gdLst>
              <a:ahLst/>
              <a:cxnLst>
                <a:cxn ang="0">
                  <a:pos x="csX0" y="csY0"/>
                </a:cxn>
                <a:cxn ang="0">
                  <a:pos x="csX1" y="csY1"/>
                </a:cxn>
              </a:cxnLst>
              <a:rect l="l" t="t" r="r" b="b"/>
              <a:pathLst>
                <a:path w="146470" h="279017">
                  <a:moveTo>
                    <a:pt x="142989" y="279441"/>
                  </a:moveTo>
                  <a:lnTo>
                    <a:pt x="-3481" y="42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7" name="フリーフォーム: 図形 276">
              <a:extLst>
                <a:ext uri="{FF2B5EF4-FFF2-40B4-BE49-F238E27FC236}">
                  <a16:creationId xmlns:a16="http://schemas.microsoft.com/office/drawing/2014/main" id="{70D4D5E0-52EA-DCB5-E92D-D77033D3582F}"/>
                </a:ext>
              </a:extLst>
            </p:cNvPr>
            <p:cNvSpPr/>
            <p:nvPr/>
          </p:nvSpPr>
          <p:spPr>
            <a:xfrm rot="3738165">
              <a:off x="3861631" y="4780991"/>
              <a:ext cx="5900" cy="11801"/>
            </a:xfrm>
            <a:custGeom>
              <a:avLst/>
              <a:gdLst>
                <a:gd name="csX0" fmla="*/ 290 w 5900"/>
                <a:gd name="csY0" fmla="*/ 11954 h 11801"/>
                <a:gd name="csX1" fmla="*/ 6191 w 5900"/>
                <a:gd name="csY1" fmla="*/ 6053 h 11801"/>
                <a:gd name="csX2" fmla="*/ 290 w 5900"/>
                <a:gd name="csY2" fmla="*/ 153 h 11801"/>
              </a:gdLst>
              <a:ahLst/>
              <a:cxnLst>
                <a:cxn ang="0">
                  <a:pos x="csX0" y="csY0"/>
                </a:cxn>
                <a:cxn ang="0">
                  <a:pos x="csX1" y="csY1"/>
                </a:cxn>
                <a:cxn ang="0">
                  <a:pos x="csX2" y="csY2"/>
                </a:cxn>
              </a:cxnLst>
              <a:rect l="l" t="t" r="r" b="b"/>
              <a:pathLst>
                <a:path w="5900" h="11801">
                  <a:moveTo>
                    <a:pt x="290" y="11954"/>
                  </a:moveTo>
                  <a:cubicBezTo>
                    <a:pt x="3549" y="11954"/>
                    <a:pt x="6191" y="9312"/>
                    <a:pt x="6191" y="6053"/>
                  </a:cubicBezTo>
                  <a:cubicBezTo>
                    <a:pt x="6191" y="2794"/>
                    <a:pt x="3549" y="153"/>
                    <a:pt x="290" y="153"/>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8" name="フリーフォーム: 図形 277">
              <a:extLst>
                <a:ext uri="{FF2B5EF4-FFF2-40B4-BE49-F238E27FC236}">
                  <a16:creationId xmlns:a16="http://schemas.microsoft.com/office/drawing/2014/main" id="{2EDC2B1D-1A7F-A0DC-6EBF-0549CBFD8D0D}"/>
                </a:ext>
              </a:extLst>
            </p:cNvPr>
            <p:cNvSpPr/>
            <p:nvPr/>
          </p:nvSpPr>
          <p:spPr>
            <a:xfrm rot="14538165">
              <a:off x="3678708" y="4469291"/>
              <a:ext cx="51926" cy="25963"/>
            </a:xfrm>
            <a:custGeom>
              <a:avLst/>
              <a:gdLst>
                <a:gd name="csX0" fmla="*/ 261 w 51926"/>
                <a:gd name="csY0" fmla="*/ 94 h 25963"/>
                <a:gd name="csX1" fmla="*/ 52187 w 51926"/>
                <a:gd name="csY1" fmla="*/ 13075 h 25963"/>
                <a:gd name="csX2" fmla="*/ 261 w 51926"/>
                <a:gd name="csY2" fmla="*/ 26057 h 25963"/>
              </a:gdLst>
              <a:ahLst/>
              <a:cxnLst>
                <a:cxn ang="0">
                  <a:pos x="csX0" y="csY0"/>
                </a:cxn>
                <a:cxn ang="0">
                  <a:pos x="csX1" y="csY1"/>
                </a:cxn>
                <a:cxn ang="0">
                  <a:pos x="csX2" y="csY2"/>
                </a:cxn>
              </a:cxnLst>
              <a:rect l="l" t="t" r="r" b="b"/>
              <a:pathLst>
                <a:path w="51926" h="25963">
                  <a:moveTo>
                    <a:pt x="261" y="94"/>
                  </a:moveTo>
                  <a:cubicBezTo>
                    <a:pt x="17569" y="8748"/>
                    <a:pt x="34878" y="13075"/>
                    <a:pt x="52187" y="13075"/>
                  </a:cubicBezTo>
                  <a:cubicBezTo>
                    <a:pt x="34878" y="13075"/>
                    <a:pt x="17569" y="17403"/>
                    <a:pt x="261" y="26057"/>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79" name="フリーフォーム: 図形 278">
              <a:extLst>
                <a:ext uri="{FF2B5EF4-FFF2-40B4-BE49-F238E27FC236}">
                  <a16:creationId xmlns:a16="http://schemas.microsoft.com/office/drawing/2014/main" id="{E2D2EA21-25C0-5C7A-3E21-2E51883E5154}"/>
                </a:ext>
              </a:extLst>
            </p:cNvPr>
            <p:cNvSpPr/>
            <p:nvPr/>
          </p:nvSpPr>
          <p:spPr>
            <a:xfrm>
              <a:off x="3922676" y="4878232"/>
              <a:ext cx="161105" cy="212710"/>
            </a:xfrm>
            <a:custGeom>
              <a:avLst/>
              <a:gdLst>
                <a:gd name="csX0" fmla="*/ -3531 w 161105"/>
                <a:gd name="csY0" fmla="*/ 345 h 212710"/>
                <a:gd name="csX1" fmla="*/ 157574 w 161105"/>
                <a:gd name="csY1" fmla="*/ 213056 h 212710"/>
              </a:gdLst>
              <a:ahLst/>
              <a:cxnLst>
                <a:cxn ang="0">
                  <a:pos x="csX0" y="csY0"/>
                </a:cxn>
                <a:cxn ang="0">
                  <a:pos x="csX1" y="csY1"/>
                </a:cxn>
              </a:cxnLst>
              <a:rect l="l" t="t" r="r" b="b"/>
              <a:pathLst>
                <a:path w="161105" h="212710">
                  <a:moveTo>
                    <a:pt x="-3531" y="345"/>
                  </a:moveTo>
                  <a:lnTo>
                    <a:pt x="157574" y="213056"/>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0" name="フリーフォーム: 図形 279">
              <a:extLst>
                <a:ext uri="{FF2B5EF4-FFF2-40B4-BE49-F238E27FC236}">
                  <a16:creationId xmlns:a16="http://schemas.microsoft.com/office/drawing/2014/main" id="{E1C667F0-D799-E9E1-B268-83A4F300D8EA}"/>
                </a:ext>
              </a:extLst>
            </p:cNvPr>
            <p:cNvSpPr/>
            <p:nvPr/>
          </p:nvSpPr>
          <p:spPr>
            <a:xfrm rot="13971605">
              <a:off x="3917944" y="4869979"/>
              <a:ext cx="5900" cy="11801"/>
            </a:xfrm>
            <a:custGeom>
              <a:avLst/>
              <a:gdLst>
                <a:gd name="csX0" fmla="*/ 301 w 5900"/>
                <a:gd name="csY0" fmla="*/ 11971 h 11801"/>
                <a:gd name="csX1" fmla="*/ 6202 w 5900"/>
                <a:gd name="csY1" fmla="*/ 6070 h 11801"/>
                <a:gd name="csX2" fmla="*/ 301 w 5900"/>
                <a:gd name="csY2" fmla="*/ 170 h 11801"/>
              </a:gdLst>
              <a:ahLst/>
              <a:cxnLst>
                <a:cxn ang="0">
                  <a:pos x="csX0" y="csY0"/>
                </a:cxn>
                <a:cxn ang="0">
                  <a:pos x="csX1" y="csY1"/>
                </a:cxn>
                <a:cxn ang="0">
                  <a:pos x="csX2" y="csY2"/>
                </a:cxn>
              </a:cxnLst>
              <a:rect l="l" t="t" r="r" b="b"/>
              <a:pathLst>
                <a:path w="5900" h="11801">
                  <a:moveTo>
                    <a:pt x="301" y="11971"/>
                  </a:moveTo>
                  <a:cubicBezTo>
                    <a:pt x="3560" y="11971"/>
                    <a:pt x="6202" y="9329"/>
                    <a:pt x="6202" y="6070"/>
                  </a:cubicBezTo>
                  <a:cubicBezTo>
                    <a:pt x="6202" y="2812"/>
                    <a:pt x="3560" y="170"/>
                    <a:pt x="301" y="170"/>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1" name="フリーフォーム: 図形 280">
              <a:extLst>
                <a:ext uri="{FF2B5EF4-FFF2-40B4-BE49-F238E27FC236}">
                  <a16:creationId xmlns:a16="http://schemas.microsoft.com/office/drawing/2014/main" id="{4EDB26C2-4448-ABB3-CF6F-D6EC52693D73}"/>
                </a:ext>
              </a:extLst>
            </p:cNvPr>
            <p:cNvSpPr/>
            <p:nvPr/>
          </p:nvSpPr>
          <p:spPr>
            <a:xfrm rot="3171605">
              <a:off x="4073493" y="5098658"/>
              <a:ext cx="51926" cy="25963"/>
            </a:xfrm>
            <a:custGeom>
              <a:avLst/>
              <a:gdLst>
                <a:gd name="csX0" fmla="*/ 337 w 51926"/>
                <a:gd name="csY0" fmla="*/ 215 h 25963"/>
                <a:gd name="csX1" fmla="*/ 52263 w 51926"/>
                <a:gd name="csY1" fmla="*/ 13197 h 25963"/>
                <a:gd name="csX2" fmla="*/ 337 w 51926"/>
                <a:gd name="csY2" fmla="*/ 26178 h 25963"/>
              </a:gdLst>
              <a:ahLst/>
              <a:cxnLst>
                <a:cxn ang="0">
                  <a:pos x="csX0" y="csY0"/>
                </a:cxn>
                <a:cxn ang="0">
                  <a:pos x="csX1" y="csY1"/>
                </a:cxn>
                <a:cxn ang="0">
                  <a:pos x="csX2" y="csY2"/>
                </a:cxn>
              </a:cxnLst>
              <a:rect l="l" t="t" r="r" b="b"/>
              <a:pathLst>
                <a:path w="51926" h="25963">
                  <a:moveTo>
                    <a:pt x="337" y="215"/>
                  </a:moveTo>
                  <a:cubicBezTo>
                    <a:pt x="17646" y="8870"/>
                    <a:pt x="34955" y="13197"/>
                    <a:pt x="52263" y="13197"/>
                  </a:cubicBezTo>
                  <a:cubicBezTo>
                    <a:pt x="34955" y="13197"/>
                    <a:pt x="17646" y="17524"/>
                    <a:pt x="337" y="26178"/>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2" name="フリーフォーム: 図形 281">
              <a:extLst>
                <a:ext uri="{FF2B5EF4-FFF2-40B4-BE49-F238E27FC236}">
                  <a16:creationId xmlns:a16="http://schemas.microsoft.com/office/drawing/2014/main" id="{F28136EC-6D30-3C12-9029-C155D787A193}"/>
                </a:ext>
              </a:extLst>
            </p:cNvPr>
            <p:cNvSpPr/>
            <p:nvPr/>
          </p:nvSpPr>
          <p:spPr>
            <a:xfrm>
              <a:off x="3823501" y="4891512"/>
              <a:ext cx="46335" cy="133360"/>
            </a:xfrm>
            <a:custGeom>
              <a:avLst/>
              <a:gdLst>
                <a:gd name="csX0" fmla="*/ 42841 w 46335"/>
                <a:gd name="csY0" fmla="*/ 351 h 133360"/>
                <a:gd name="csX1" fmla="*/ -3495 w 46335"/>
                <a:gd name="csY1" fmla="*/ 133712 h 133360"/>
              </a:gdLst>
              <a:ahLst/>
              <a:cxnLst>
                <a:cxn ang="0">
                  <a:pos x="csX0" y="csY0"/>
                </a:cxn>
                <a:cxn ang="0">
                  <a:pos x="csX1" y="csY1"/>
                </a:cxn>
              </a:cxnLst>
              <a:rect l="l" t="t" r="r" b="b"/>
              <a:pathLst>
                <a:path w="46335" h="133360">
                  <a:moveTo>
                    <a:pt x="42841" y="351"/>
                  </a:moveTo>
                  <a:lnTo>
                    <a:pt x="-3495" y="133712"/>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3" name="フリーフォーム: 図形 282">
              <a:extLst>
                <a:ext uri="{FF2B5EF4-FFF2-40B4-BE49-F238E27FC236}">
                  <a16:creationId xmlns:a16="http://schemas.microsoft.com/office/drawing/2014/main" id="{FE3D92F7-FFEC-59F1-0A96-14AC6949D74A}"/>
                </a:ext>
              </a:extLst>
            </p:cNvPr>
            <p:cNvSpPr/>
            <p:nvPr/>
          </p:nvSpPr>
          <p:spPr>
            <a:xfrm rot="17349559">
              <a:off x="3867854" y="4882824"/>
              <a:ext cx="5900" cy="11801"/>
            </a:xfrm>
            <a:custGeom>
              <a:avLst/>
              <a:gdLst>
                <a:gd name="csX0" fmla="*/ 291 w 5900"/>
                <a:gd name="csY0" fmla="*/ 11974 h 11801"/>
                <a:gd name="csX1" fmla="*/ 6192 w 5900"/>
                <a:gd name="csY1" fmla="*/ 6073 h 11801"/>
                <a:gd name="csX2" fmla="*/ 291 w 5900"/>
                <a:gd name="csY2" fmla="*/ 172 h 11801"/>
              </a:gdLst>
              <a:ahLst/>
              <a:cxnLst>
                <a:cxn ang="0">
                  <a:pos x="csX0" y="csY0"/>
                </a:cxn>
                <a:cxn ang="0">
                  <a:pos x="csX1" y="csY1"/>
                </a:cxn>
                <a:cxn ang="0">
                  <a:pos x="csX2" y="csY2"/>
                </a:cxn>
              </a:cxnLst>
              <a:rect l="l" t="t" r="r" b="b"/>
              <a:pathLst>
                <a:path w="5900" h="11801">
                  <a:moveTo>
                    <a:pt x="291" y="11974"/>
                  </a:moveTo>
                  <a:cubicBezTo>
                    <a:pt x="3550" y="11974"/>
                    <a:pt x="6192" y="9332"/>
                    <a:pt x="6192" y="6073"/>
                  </a:cubicBezTo>
                  <a:cubicBezTo>
                    <a:pt x="6192" y="2814"/>
                    <a:pt x="3550" y="172"/>
                    <a:pt x="291" y="172"/>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4" name="フリーフォーム: 図形 283">
              <a:extLst>
                <a:ext uri="{FF2B5EF4-FFF2-40B4-BE49-F238E27FC236}">
                  <a16:creationId xmlns:a16="http://schemas.microsoft.com/office/drawing/2014/main" id="{FE8224F3-004F-2B39-8CD0-BE58C450F79B}"/>
                </a:ext>
              </a:extLst>
            </p:cNvPr>
            <p:cNvSpPr/>
            <p:nvPr/>
          </p:nvSpPr>
          <p:spPr>
            <a:xfrm rot="6549559">
              <a:off x="3789017" y="5036416"/>
              <a:ext cx="51926" cy="25963"/>
            </a:xfrm>
            <a:custGeom>
              <a:avLst/>
              <a:gdLst>
                <a:gd name="csX0" fmla="*/ 282 w 51926"/>
                <a:gd name="csY0" fmla="*/ 203 h 25963"/>
                <a:gd name="csX1" fmla="*/ 52209 w 51926"/>
                <a:gd name="csY1" fmla="*/ 13185 h 25963"/>
                <a:gd name="csX2" fmla="*/ 282 w 51926"/>
                <a:gd name="csY2" fmla="*/ 26166 h 25963"/>
              </a:gdLst>
              <a:ahLst/>
              <a:cxnLst>
                <a:cxn ang="0">
                  <a:pos x="csX0" y="csY0"/>
                </a:cxn>
                <a:cxn ang="0">
                  <a:pos x="csX1" y="csY1"/>
                </a:cxn>
                <a:cxn ang="0">
                  <a:pos x="csX2" y="csY2"/>
                </a:cxn>
              </a:cxnLst>
              <a:rect l="l" t="t" r="r" b="b"/>
              <a:pathLst>
                <a:path w="51926" h="25963">
                  <a:moveTo>
                    <a:pt x="282" y="203"/>
                  </a:moveTo>
                  <a:cubicBezTo>
                    <a:pt x="17591" y="8858"/>
                    <a:pt x="34900" y="13185"/>
                    <a:pt x="52209" y="13185"/>
                  </a:cubicBezTo>
                  <a:cubicBezTo>
                    <a:pt x="34900" y="13185"/>
                    <a:pt x="17591" y="17512"/>
                    <a:pt x="282" y="26166"/>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5" name="フリーフォーム: 図形 284">
              <a:extLst>
                <a:ext uri="{FF2B5EF4-FFF2-40B4-BE49-F238E27FC236}">
                  <a16:creationId xmlns:a16="http://schemas.microsoft.com/office/drawing/2014/main" id="{1CDD5866-7ABC-5067-BC42-1FF4768DAF1B}"/>
                </a:ext>
              </a:extLst>
            </p:cNvPr>
            <p:cNvSpPr/>
            <p:nvPr/>
          </p:nvSpPr>
          <p:spPr>
            <a:xfrm>
              <a:off x="3898486" y="4902422"/>
              <a:ext cx="31600" cy="241680"/>
            </a:xfrm>
            <a:custGeom>
              <a:avLst/>
              <a:gdLst>
                <a:gd name="csX0" fmla="*/ -3510 w 31600"/>
                <a:gd name="csY0" fmla="*/ 336 h 241680"/>
                <a:gd name="csX1" fmla="*/ 28090 w 31600"/>
                <a:gd name="csY1" fmla="*/ 242017 h 241680"/>
              </a:gdLst>
              <a:ahLst/>
              <a:cxnLst>
                <a:cxn ang="0">
                  <a:pos x="csX0" y="csY0"/>
                </a:cxn>
                <a:cxn ang="0">
                  <a:pos x="csX1" y="csY1"/>
                </a:cxn>
              </a:cxnLst>
              <a:rect l="l" t="t" r="r" b="b"/>
              <a:pathLst>
                <a:path w="31600" h="241680">
                  <a:moveTo>
                    <a:pt x="-3510" y="336"/>
                  </a:moveTo>
                  <a:lnTo>
                    <a:pt x="28090" y="242017"/>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6" name="フリーフォーム: 図形 285">
              <a:extLst>
                <a:ext uri="{FF2B5EF4-FFF2-40B4-BE49-F238E27FC236}">
                  <a16:creationId xmlns:a16="http://schemas.microsoft.com/office/drawing/2014/main" id="{8E888D27-3AEA-FD44-B803-71C27D678B79}"/>
                </a:ext>
              </a:extLst>
            </p:cNvPr>
            <p:cNvSpPr/>
            <p:nvPr/>
          </p:nvSpPr>
          <p:spPr>
            <a:xfrm rot="15753044">
              <a:off x="3895154" y="4893595"/>
              <a:ext cx="5900" cy="11801"/>
            </a:xfrm>
            <a:custGeom>
              <a:avLst/>
              <a:gdLst>
                <a:gd name="csX0" fmla="*/ 297 w 5900"/>
                <a:gd name="csY0" fmla="*/ 11976 h 11801"/>
                <a:gd name="csX1" fmla="*/ 6197 w 5900"/>
                <a:gd name="csY1" fmla="*/ 6075 h 11801"/>
                <a:gd name="csX2" fmla="*/ 297 w 5900"/>
                <a:gd name="csY2" fmla="*/ 174 h 11801"/>
              </a:gdLst>
              <a:ahLst/>
              <a:cxnLst>
                <a:cxn ang="0">
                  <a:pos x="csX0" y="csY0"/>
                </a:cxn>
                <a:cxn ang="0">
                  <a:pos x="csX1" y="csY1"/>
                </a:cxn>
                <a:cxn ang="0">
                  <a:pos x="csX2" y="csY2"/>
                </a:cxn>
              </a:cxnLst>
              <a:rect l="l" t="t" r="r" b="b"/>
              <a:pathLst>
                <a:path w="5900" h="11801">
                  <a:moveTo>
                    <a:pt x="297" y="11976"/>
                  </a:moveTo>
                  <a:cubicBezTo>
                    <a:pt x="3556" y="11976"/>
                    <a:pt x="6197" y="9334"/>
                    <a:pt x="6197" y="6075"/>
                  </a:cubicBezTo>
                  <a:cubicBezTo>
                    <a:pt x="6197" y="2816"/>
                    <a:pt x="3556" y="174"/>
                    <a:pt x="297" y="174"/>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7" name="フリーフォーム: 図形 286">
              <a:extLst>
                <a:ext uri="{FF2B5EF4-FFF2-40B4-BE49-F238E27FC236}">
                  <a16:creationId xmlns:a16="http://schemas.microsoft.com/office/drawing/2014/main" id="{C764DF1E-23D1-F870-9591-58B228FBDB35}"/>
                </a:ext>
              </a:extLst>
            </p:cNvPr>
            <p:cNvSpPr/>
            <p:nvPr/>
          </p:nvSpPr>
          <p:spPr>
            <a:xfrm rot="4953044">
              <a:off x="3907489" y="5156865"/>
              <a:ext cx="51926" cy="25963"/>
            </a:xfrm>
            <a:custGeom>
              <a:avLst/>
              <a:gdLst>
                <a:gd name="csX0" fmla="*/ 305 w 51926"/>
                <a:gd name="csY0" fmla="*/ 226 h 25963"/>
                <a:gd name="csX1" fmla="*/ 52231 w 51926"/>
                <a:gd name="csY1" fmla="*/ 13208 h 25963"/>
                <a:gd name="csX2" fmla="*/ 305 w 51926"/>
                <a:gd name="csY2" fmla="*/ 26190 h 25963"/>
              </a:gdLst>
              <a:ahLst/>
              <a:cxnLst>
                <a:cxn ang="0">
                  <a:pos x="csX0" y="csY0"/>
                </a:cxn>
                <a:cxn ang="0">
                  <a:pos x="csX1" y="csY1"/>
                </a:cxn>
                <a:cxn ang="0">
                  <a:pos x="csX2" y="csY2"/>
                </a:cxn>
              </a:cxnLst>
              <a:rect l="l" t="t" r="r" b="b"/>
              <a:pathLst>
                <a:path w="51926" h="25963">
                  <a:moveTo>
                    <a:pt x="305" y="226"/>
                  </a:moveTo>
                  <a:cubicBezTo>
                    <a:pt x="17614" y="8881"/>
                    <a:pt x="34923" y="13208"/>
                    <a:pt x="52231" y="13208"/>
                  </a:cubicBezTo>
                  <a:cubicBezTo>
                    <a:pt x="34923" y="13208"/>
                    <a:pt x="17614" y="17535"/>
                    <a:pt x="305" y="26190"/>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8" name="フリーフォーム: 図形 287">
              <a:extLst>
                <a:ext uri="{FF2B5EF4-FFF2-40B4-BE49-F238E27FC236}">
                  <a16:creationId xmlns:a16="http://schemas.microsoft.com/office/drawing/2014/main" id="{CCF00DB1-7EBC-36AF-AF1B-3E9F820FA27A}"/>
                </a:ext>
              </a:extLst>
            </p:cNvPr>
            <p:cNvSpPr/>
            <p:nvPr/>
          </p:nvSpPr>
          <p:spPr>
            <a:xfrm>
              <a:off x="3666159" y="4857869"/>
              <a:ext cx="170034" cy="74118"/>
            </a:xfrm>
            <a:custGeom>
              <a:avLst/>
              <a:gdLst>
                <a:gd name="csX0" fmla="*/ 166562 w 170034"/>
                <a:gd name="csY0" fmla="*/ 366 h 74118"/>
                <a:gd name="csX1" fmla="*/ -3472 w 170034"/>
                <a:gd name="csY1" fmla="*/ 74484 h 74118"/>
              </a:gdLst>
              <a:ahLst/>
              <a:cxnLst>
                <a:cxn ang="0">
                  <a:pos x="csX0" y="csY0"/>
                </a:cxn>
                <a:cxn ang="0">
                  <a:pos x="csX1" y="csY1"/>
                </a:cxn>
              </a:cxnLst>
              <a:rect l="l" t="t" r="r" b="b"/>
              <a:pathLst>
                <a:path w="170034" h="74118">
                  <a:moveTo>
                    <a:pt x="166562" y="366"/>
                  </a:moveTo>
                  <a:lnTo>
                    <a:pt x="-3472" y="7448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89" name="フリーフォーム: 図形 288">
              <a:extLst>
                <a:ext uri="{FF2B5EF4-FFF2-40B4-BE49-F238E27FC236}">
                  <a16:creationId xmlns:a16="http://schemas.microsoft.com/office/drawing/2014/main" id="{23FCDA44-198F-13B4-3F77-93FF6BD113AE}"/>
                </a:ext>
              </a:extLst>
            </p:cNvPr>
            <p:cNvSpPr/>
            <p:nvPr/>
          </p:nvSpPr>
          <p:spPr>
            <a:xfrm rot="20186854">
              <a:off x="3835948" y="4850790"/>
              <a:ext cx="5900" cy="11801"/>
            </a:xfrm>
            <a:custGeom>
              <a:avLst/>
              <a:gdLst>
                <a:gd name="csX0" fmla="*/ 285 w 5900"/>
                <a:gd name="csY0" fmla="*/ 11967 h 11801"/>
                <a:gd name="csX1" fmla="*/ 6186 w 5900"/>
                <a:gd name="csY1" fmla="*/ 6067 h 11801"/>
                <a:gd name="csX2" fmla="*/ 285 w 5900"/>
                <a:gd name="csY2" fmla="*/ 166 h 11801"/>
              </a:gdLst>
              <a:ahLst/>
              <a:cxnLst>
                <a:cxn ang="0">
                  <a:pos x="csX0" y="csY0"/>
                </a:cxn>
                <a:cxn ang="0">
                  <a:pos x="csX1" y="csY1"/>
                </a:cxn>
                <a:cxn ang="0">
                  <a:pos x="csX2" y="csY2"/>
                </a:cxn>
              </a:cxnLst>
              <a:rect l="l" t="t" r="r" b="b"/>
              <a:pathLst>
                <a:path w="5900" h="11801">
                  <a:moveTo>
                    <a:pt x="285" y="11967"/>
                  </a:moveTo>
                  <a:cubicBezTo>
                    <a:pt x="3544" y="11967"/>
                    <a:pt x="6186" y="9326"/>
                    <a:pt x="6186" y="6067"/>
                  </a:cubicBezTo>
                  <a:cubicBezTo>
                    <a:pt x="6186" y="2808"/>
                    <a:pt x="3544" y="166"/>
                    <a:pt x="285" y="166"/>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0" name="フリーフォーム: 図形 289">
              <a:extLst>
                <a:ext uri="{FF2B5EF4-FFF2-40B4-BE49-F238E27FC236}">
                  <a16:creationId xmlns:a16="http://schemas.microsoft.com/office/drawing/2014/main" id="{84329939-3B15-7606-30E5-06F3901E7084}"/>
                </a:ext>
              </a:extLst>
            </p:cNvPr>
            <p:cNvSpPr/>
            <p:nvPr/>
          </p:nvSpPr>
          <p:spPr>
            <a:xfrm rot="9386854">
              <a:off x="3616396" y="4929380"/>
              <a:ext cx="51926" cy="25963"/>
            </a:xfrm>
            <a:custGeom>
              <a:avLst/>
              <a:gdLst>
                <a:gd name="csX0" fmla="*/ 249 w 51926"/>
                <a:gd name="csY0" fmla="*/ 182 h 25963"/>
                <a:gd name="csX1" fmla="*/ 52175 w 51926"/>
                <a:gd name="csY1" fmla="*/ 13164 h 25963"/>
                <a:gd name="csX2" fmla="*/ 249 w 51926"/>
                <a:gd name="csY2" fmla="*/ 26146 h 25963"/>
              </a:gdLst>
              <a:ahLst/>
              <a:cxnLst>
                <a:cxn ang="0">
                  <a:pos x="csX0" y="csY0"/>
                </a:cxn>
                <a:cxn ang="0">
                  <a:pos x="csX1" y="csY1"/>
                </a:cxn>
                <a:cxn ang="0">
                  <a:pos x="csX2" y="csY2"/>
                </a:cxn>
              </a:cxnLst>
              <a:rect l="l" t="t" r="r" b="b"/>
              <a:pathLst>
                <a:path w="51926" h="25963">
                  <a:moveTo>
                    <a:pt x="249" y="182"/>
                  </a:moveTo>
                  <a:cubicBezTo>
                    <a:pt x="17557" y="8837"/>
                    <a:pt x="34866" y="13164"/>
                    <a:pt x="52175" y="13164"/>
                  </a:cubicBezTo>
                  <a:cubicBezTo>
                    <a:pt x="34866" y="13164"/>
                    <a:pt x="17557" y="17491"/>
                    <a:pt x="249" y="26146"/>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1" name="フリーフォーム: 図形 290">
              <a:extLst>
                <a:ext uri="{FF2B5EF4-FFF2-40B4-BE49-F238E27FC236}">
                  <a16:creationId xmlns:a16="http://schemas.microsoft.com/office/drawing/2014/main" id="{4F244BBB-A3BA-BD54-42DB-16C53EAA5D0D}"/>
                </a:ext>
              </a:extLst>
            </p:cNvPr>
            <p:cNvSpPr/>
            <p:nvPr/>
          </p:nvSpPr>
          <p:spPr>
            <a:xfrm>
              <a:off x="3956823" y="4805717"/>
              <a:ext cx="136921" cy="19361"/>
            </a:xfrm>
            <a:custGeom>
              <a:avLst/>
              <a:gdLst>
                <a:gd name="csX0" fmla="*/ -3536 w 136921"/>
                <a:gd name="csY0" fmla="*/ 19746 h 19361"/>
                <a:gd name="csX1" fmla="*/ 133386 w 136921"/>
                <a:gd name="csY1" fmla="*/ 384 h 19361"/>
              </a:gdLst>
              <a:ahLst/>
              <a:cxnLst>
                <a:cxn ang="0">
                  <a:pos x="csX0" y="csY0"/>
                </a:cxn>
                <a:cxn ang="0">
                  <a:pos x="csX1" y="csY1"/>
                </a:cxn>
              </a:cxnLst>
              <a:rect l="l" t="t" r="r" b="b"/>
              <a:pathLst>
                <a:path w="136921" h="19361">
                  <a:moveTo>
                    <a:pt x="-3536" y="19746"/>
                  </a:moveTo>
                  <a:lnTo>
                    <a:pt x="133386" y="38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2" name="フリーフォーム: 図形 291">
              <a:extLst>
                <a:ext uri="{FF2B5EF4-FFF2-40B4-BE49-F238E27FC236}">
                  <a16:creationId xmlns:a16="http://schemas.microsoft.com/office/drawing/2014/main" id="{A126EAE8-170C-8C38-0FF5-7C40D38F449C}"/>
                </a:ext>
              </a:extLst>
            </p:cNvPr>
            <p:cNvSpPr/>
            <p:nvPr/>
          </p:nvSpPr>
          <p:spPr>
            <a:xfrm rot="10317073">
              <a:off x="3950951" y="4819591"/>
              <a:ext cx="5900" cy="11801"/>
            </a:xfrm>
            <a:custGeom>
              <a:avLst/>
              <a:gdLst>
                <a:gd name="csX0" fmla="*/ 307 w 5900"/>
                <a:gd name="csY0" fmla="*/ 11961 h 11801"/>
                <a:gd name="csX1" fmla="*/ 6208 w 5900"/>
                <a:gd name="csY1" fmla="*/ 6061 h 11801"/>
                <a:gd name="csX2" fmla="*/ 307 w 5900"/>
                <a:gd name="csY2" fmla="*/ 160 h 11801"/>
              </a:gdLst>
              <a:ahLst/>
              <a:cxnLst>
                <a:cxn ang="0">
                  <a:pos x="csX0" y="csY0"/>
                </a:cxn>
                <a:cxn ang="0">
                  <a:pos x="csX1" y="csY1"/>
                </a:cxn>
                <a:cxn ang="0">
                  <a:pos x="csX2" y="csY2"/>
                </a:cxn>
              </a:cxnLst>
              <a:rect l="l" t="t" r="r" b="b"/>
              <a:pathLst>
                <a:path w="5900" h="11801">
                  <a:moveTo>
                    <a:pt x="307" y="11961"/>
                  </a:moveTo>
                  <a:cubicBezTo>
                    <a:pt x="3566" y="11961"/>
                    <a:pt x="6208" y="9320"/>
                    <a:pt x="6208" y="6061"/>
                  </a:cubicBezTo>
                  <a:cubicBezTo>
                    <a:pt x="6208" y="2802"/>
                    <a:pt x="3566" y="160"/>
                    <a:pt x="307" y="160"/>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3" name="フリーフォーム: 図形 292">
              <a:extLst>
                <a:ext uri="{FF2B5EF4-FFF2-40B4-BE49-F238E27FC236}">
                  <a16:creationId xmlns:a16="http://schemas.microsoft.com/office/drawing/2014/main" id="{EBC5A122-F53C-0C29-D91A-AA7CC5BB40BE}"/>
                </a:ext>
              </a:extLst>
            </p:cNvPr>
            <p:cNvSpPr/>
            <p:nvPr/>
          </p:nvSpPr>
          <p:spPr>
            <a:xfrm rot="21117073">
              <a:off x="4093488" y="4789100"/>
              <a:ext cx="51926" cy="25963"/>
            </a:xfrm>
            <a:custGeom>
              <a:avLst/>
              <a:gdLst>
                <a:gd name="csX0" fmla="*/ 341 w 51926"/>
                <a:gd name="csY0" fmla="*/ 155 h 25963"/>
                <a:gd name="csX1" fmla="*/ 52267 w 51926"/>
                <a:gd name="csY1" fmla="*/ 13137 h 25963"/>
                <a:gd name="csX2" fmla="*/ 341 w 51926"/>
                <a:gd name="csY2" fmla="*/ 26119 h 25963"/>
              </a:gdLst>
              <a:ahLst/>
              <a:cxnLst>
                <a:cxn ang="0">
                  <a:pos x="csX0" y="csY0"/>
                </a:cxn>
                <a:cxn ang="0">
                  <a:pos x="csX1" y="csY1"/>
                </a:cxn>
                <a:cxn ang="0">
                  <a:pos x="csX2" y="csY2"/>
                </a:cxn>
              </a:cxnLst>
              <a:rect l="l" t="t" r="r" b="b"/>
              <a:pathLst>
                <a:path w="51926" h="25963">
                  <a:moveTo>
                    <a:pt x="341" y="155"/>
                  </a:moveTo>
                  <a:cubicBezTo>
                    <a:pt x="17649" y="8810"/>
                    <a:pt x="34958" y="13137"/>
                    <a:pt x="52267" y="13137"/>
                  </a:cubicBezTo>
                  <a:cubicBezTo>
                    <a:pt x="34958" y="13137"/>
                    <a:pt x="17649" y="17464"/>
                    <a:pt x="341" y="26119"/>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4" name="フリーフォーム: 図形 293">
              <a:extLst>
                <a:ext uri="{FF2B5EF4-FFF2-40B4-BE49-F238E27FC236}">
                  <a16:creationId xmlns:a16="http://schemas.microsoft.com/office/drawing/2014/main" id="{D585802C-4008-1F77-A316-BB3CB7973235}"/>
                </a:ext>
              </a:extLst>
            </p:cNvPr>
            <p:cNvSpPr/>
            <p:nvPr/>
          </p:nvSpPr>
          <p:spPr>
            <a:xfrm>
              <a:off x="3897185" y="4611296"/>
              <a:ext cx="12136" cy="152240"/>
            </a:xfrm>
            <a:custGeom>
              <a:avLst/>
              <a:gdLst>
                <a:gd name="csX0" fmla="*/ -3507 w 12136"/>
                <a:gd name="csY0" fmla="*/ 152654 h 152240"/>
                <a:gd name="csX1" fmla="*/ 8629 w 12136"/>
                <a:gd name="csY1" fmla="*/ 414 h 152240"/>
              </a:gdLst>
              <a:ahLst/>
              <a:cxnLst>
                <a:cxn ang="0">
                  <a:pos x="csX0" y="csY0"/>
                </a:cxn>
                <a:cxn ang="0">
                  <a:pos x="csX1" y="csY1"/>
                </a:cxn>
              </a:cxnLst>
              <a:rect l="l" t="t" r="r" b="b"/>
              <a:pathLst>
                <a:path w="12136" h="152240">
                  <a:moveTo>
                    <a:pt x="-3507" y="152654"/>
                  </a:moveTo>
                  <a:lnTo>
                    <a:pt x="8629" y="41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5" name="フリーフォーム: 図形 294">
              <a:extLst>
                <a:ext uri="{FF2B5EF4-FFF2-40B4-BE49-F238E27FC236}">
                  <a16:creationId xmlns:a16="http://schemas.microsoft.com/office/drawing/2014/main" id="{AF6AD7A1-F8E1-8F18-E09D-3D2E46170602}"/>
                </a:ext>
              </a:extLst>
            </p:cNvPr>
            <p:cNvSpPr/>
            <p:nvPr/>
          </p:nvSpPr>
          <p:spPr>
            <a:xfrm rot="5673474">
              <a:off x="3892095" y="4760576"/>
              <a:ext cx="5900" cy="11801"/>
            </a:xfrm>
            <a:custGeom>
              <a:avLst/>
              <a:gdLst>
                <a:gd name="csX0" fmla="*/ 296 w 5900"/>
                <a:gd name="csY0" fmla="*/ 11950 h 11801"/>
                <a:gd name="csX1" fmla="*/ 6197 w 5900"/>
                <a:gd name="csY1" fmla="*/ 6049 h 11801"/>
                <a:gd name="csX2" fmla="*/ 296 w 5900"/>
                <a:gd name="csY2" fmla="*/ 149 h 11801"/>
              </a:gdLst>
              <a:ahLst/>
              <a:cxnLst>
                <a:cxn ang="0">
                  <a:pos x="csX0" y="csY0"/>
                </a:cxn>
                <a:cxn ang="0">
                  <a:pos x="csX1" y="csY1"/>
                </a:cxn>
                <a:cxn ang="0">
                  <a:pos x="csX2" y="csY2"/>
                </a:cxn>
              </a:cxnLst>
              <a:rect l="l" t="t" r="r" b="b"/>
              <a:pathLst>
                <a:path w="5900" h="11801">
                  <a:moveTo>
                    <a:pt x="296" y="11950"/>
                  </a:moveTo>
                  <a:cubicBezTo>
                    <a:pt x="3555" y="11950"/>
                    <a:pt x="6197" y="9308"/>
                    <a:pt x="6197" y="6049"/>
                  </a:cubicBezTo>
                  <a:cubicBezTo>
                    <a:pt x="6197" y="2790"/>
                    <a:pt x="3555" y="149"/>
                    <a:pt x="296" y="149"/>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6" name="フリーフォーム: 図形 295">
              <a:extLst>
                <a:ext uri="{FF2B5EF4-FFF2-40B4-BE49-F238E27FC236}">
                  <a16:creationId xmlns:a16="http://schemas.microsoft.com/office/drawing/2014/main" id="{2C15E489-2D03-A7C5-BD0F-02C92454E7C2}"/>
                </a:ext>
              </a:extLst>
            </p:cNvPr>
            <p:cNvSpPr/>
            <p:nvPr/>
          </p:nvSpPr>
          <p:spPr>
            <a:xfrm rot="16473474">
              <a:off x="3871659" y="4565428"/>
              <a:ext cx="72000" cy="36000"/>
            </a:xfrm>
            <a:custGeom>
              <a:avLst/>
              <a:gdLst>
                <a:gd name="csX0" fmla="*/ 300 w 51926"/>
                <a:gd name="csY0" fmla="*/ 114 h 25963"/>
                <a:gd name="csX1" fmla="*/ 52227 w 51926"/>
                <a:gd name="csY1" fmla="*/ 13095 h 25963"/>
                <a:gd name="csX2" fmla="*/ 300 w 51926"/>
                <a:gd name="csY2" fmla="*/ 26077 h 25963"/>
              </a:gdLst>
              <a:ahLst/>
              <a:cxnLst>
                <a:cxn ang="0">
                  <a:pos x="csX0" y="csY0"/>
                </a:cxn>
                <a:cxn ang="0">
                  <a:pos x="csX1" y="csY1"/>
                </a:cxn>
                <a:cxn ang="0">
                  <a:pos x="csX2" y="csY2"/>
                </a:cxn>
              </a:cxnLst>
              <a:rect l="l" t="t" r="r" b="b"/>
              <a:pathLst>
                <a:path w="51926" h="25963">
                  <a:moveTo>
                    <a:pt x="300" y="114"/>
                  </a:moveTo>
                  <a:cubicBezTo>
                    <a:pt x="17609" y="8768"/>
                    <a:pt x="34918" y="13095"/>
                    <a:pt x="52227" y="13095"/>
                  </a:cubicBezTo>
                  <a:cubicBezTo>
                    <a:pt x="34918" y="13095"/>
                    <a:pt x="17609" y="17423"/>
                    <a:pt x="300" y="26077"/>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7" name="フリーフォーム: 図形 296">
              <a:extLst>
                <a:ext uri="{FF2B5EF4-FFF2-40B4-BE49-F238E27FC236}">
                  <a16:creationId xmlns:a16="http://schemas.microsoft.com/office/drawing/2014/main" id="{1801D9A1-A9FB-BBDC-5C8F-1609EBD053AF}"/>
                </a:ext>
              </a:extLst>
            </p:cNvPr>
            <p:cNvSpPr/>
            <p:nvPr/>
          </p:nvSpPr>
          <p:spPr>
            <a:xfrm>
              <a:off x="3956350" y="4844559"/>
              <a:ext cx="308339" cy="46095"/>
            </a:xfrm>
            <a:custGeom>
              <a:avLst/>
              <a:gdLst>
                <a:gd name="csX0" fmla="*/ -3555 w 308339"/>
                <a:gd name="csY0" fmla="*/ 372 h 46095"/>
                <a:gd name="csX1" fmla="*/ 304784 w 308339"/>
                <a:gd name="csY1" fmla="*/ 46468 h 46095"/>
              </a:gdLst>
              <a:ahLst/>
              <a:cxnLst>
                <a:cxn ang="0">
                  <a:pos x="csX0" y="csY0"/>
                </a:cxn>
                <a:cxn ang="0">
                  <a:pos x="csX1" y="csY1"/>
                </a:cxn>
              </a:cxnLst>
              <a:rect l="l" t="t" r="r" b="b"/>
              <a:pathLst>
                <a:path w="308339" h="46095">
                  <a:moveTo>
                    <a:pt x="-3555" y="372"/>
                  </a:moveTo>
                  <a:lnTo>
                    <a:pt x="304784" y="46468"/>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8" name="フリーフォーム: 図形 297">
              <a:extLst>
                <a:ext uri="{FF2B5EF4-FFF2-40B4-BE49-F238E27FC236}">
                  <a16:creationId xmlns:a16="http://schemas.microsoft.com/office/drawing/2014/main" id="{2162F3D2-345D-CBDF-2B8C-A7951F46EB21}"/>
                </a:ext>
              </a:extLst>
            </p:cNvPr>
            <p:cNvSpPr/>
            <p:nvPr/>
          </p:nvSpPr>
          <p:spPr>
            <a:xfrm rot="11310155">
              <a:off x="3950481" y="4838222"/>
              <a:ext cx="5900" cy="11801"/>
            </a:xfrm>
            <a:custGeom>
              <a:avLst/>
              <a:gdLst>
                <a:gd name="csX0" fmla="*/ 307 w 5900"/>
                <a:gd name="csY0" fmla="*/ 11965 h 11801"/>
                <a:gd name="csX1" fmla="*/ 6208 w 5900"/>
                <a:gd name="csY1" fmla="*/ 6064 h 11801"/>
                <a:gd name="csX2" fmla="*/ 307 w 5900"/>
                <a:gd name="csY2" fmla="*/ 164 h 11801"/>
              </a:gdLst>
              <a:ahLst/>
              <a:cxnLst>
                <a:cxn ang="0">
                  <a:pos x="csX0" y="csY0"/>
                </a:cxn>
                <a:cxn ang="0">
                  <a:pos x="csX1" y="csY1"/>
                </a:cxn>
                <a:cxn ang="0">
                  <a:pos x="csX2" y="csY2"/>
                </a:cxn>
              </a:cxnLst>
              <a:rect l="l" t="t" r="r" b="b"/>
              <a:pathLst>
                <a:path w="5900" h="11801">
                  <a:moveTo>
                    <a:pt x="307" y="11965"/>
                  </a:moveTo>
                  <a:cubicBezTo>
                    <a:pt x="3566" y="11965"/>
                    <a:pt x="6208" y="9323"/>
                    <a:pt x="6208" y="6064"/>
                  </a:cubicBezTo>
                  <a:cubicBezTo>
                    <a:pt x="6208" y="2805"/>
                    <a:pt x="3566" y="164"/>
                    <a:pt x="307" y="164"/>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299" name="フリーフォーム: 図形 298">
              <a:extLst>
                <a:ext uri="{FF2B5EF4-FFF2-40B4-BE49-F238E27FC236}">
                  <a16:creationId xmlns:a16="http://schemas.microsoft.com/office/drawing/2014/main" id="{2830CC66-8EE6-00D1-B649-8AD896F6157C}"/>
                </a:ext>
              </a:extLst>
            </p:cNvPr>
            <p:cNvSpPr/>
            <p:nvPr/>
          </p:nvSpPr>
          <p:spPr>
            <a:xfrm rot="510155">
              <a:off x="4264404" y="4881512"/>
              <a:ext cx="51926" cy="25963"/>
            </a:xfrm>
            <a:custGeom>
              <a:avLst/>
              <a:gdLst>
                <a:gd name="csX0" fmla="*/ 374 w 51926"/>
                <a:gd name="csY0" fmla="*/ 173 h 25963"/>
                <a:gd name="csX1" fmla="*/ 52300 w 51926"/>
                <a:gd name="csY1" fmla="*/ 13155 h 25963"/>
                <a:gd name="csX2" fmla="*/ 374 w 51926"/>
                <a:gd name="csY2" fmla="*/ 26137 h 25963"/>
              </a:gdLst>
              <a:ahLst/>
              <a:cxnLst>
                <a:cxn ang="0">
                  <a:pos x="csX0" y="csY0"/>
                </a:cxn>
                <a:cxn ang="0">
                  <a:pos x="csX1" y="csY1"/>
                </a:cxn>
                <a:cxn ang="0">
                  <a:pos x="csX2" y="csY2"/>
                </a:cxn>
              </a:cxnLst>
              <a:rect l="l" t="t" r="r" b="b"/>
              <a:pathLst>
                <a:path w="51926" h="25963">
                  <a:moveTo>
                    <a:pt x="374" y="173"/>
                  </a:moveTo>
                  <a:cubicBezTo>
                    <a:pt x="17682" y="8828"/>
                    <a:pt x="34991" y="13155"/>
                    <a:pt x="52300" y="13155"/>
                  </a:cubicBezTo>
                  <a:cubicBezTo>
                    <a:pt x="34991" y="13155"/>
                    <a:pt x="17682" y="17482"/>
                    <a:pt x="374" y="26137"/>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0" name="フリーフォーム: 図形 299">
              <a:extLst>
                <a:ext uri="{FF2B5EF4-FFF2-40B4-BE49-F238E27FC236}">
                  <a16:creationId xmlns:a16="http://schemas.microsoft.com/office/drawing/2014/main" id="{5B58FE5B-4B3B-2D00-7F8C-CFDF67C721B6}"/>
                </a:ext>
              </a:extLst>
            </p:cNvPr>
            <p:cNvSpPr/>
            <p:nvPr/>
          </p:nvSpPr>
          <p:spPr>
            <a:xfrm>
              <a:off x="3936921" y="4671096"/>
              <a:ext cx="215706" cy="134081"/>
            </a:xfrm>
            <a:custGeom>
              <a:avLst/>
              <a:gdLst>
                <a:gd name="csX0" fmla="*/ -3540 w 215706"/>
                <a:gd name="csY0" fmla="*/ 134484 h 134081"/>
                <a:gd name="csX1" fmla="*/ 212166 w 215706"/>
                <a:gd name="csY1" fmla="*/ 402 h 134081"/>
              </a:gdLst>
              <a:ahLst/>
              <a:cxnLst>
                <a:cxn ang="0">
                  <a:pos x="csX0" y="csY0"/>
                </a:cxn>
                <a:cxn ang="0">
                  <a:pos x="csX1" y="csY1"/>
                </a:cxn>
              </a:cxnLst>
              <a:rect l="l" t="t" r="r" b="b"/>
              <a:pathLst>
                <a:path w="215706" h="134081">
                  <a:moveTo>
                    <a:pt x="-3540" y="134484"/>
                  </a:moveTo>
                  <a:lnTo>
                    <a:pt x="212166" y="402"/>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1" name="フリーフォーム: 図形 300">
              <a:extLst>
                <a:ext uri="{FF2B5EF4-FFF2-40B4-BE49-F238E27FC236}">
                  <a16:creationId xmlns:a16="http://schemas.microsoft.com/office/drawing/2014/main" id="{EE61986C-E1A8-40C4-5645-74EE229215B3}"/>
                </a:ext>
              </a:extLst>
            </p:cNvPr>
            <p:cNvSpPr/>
            <p:nvPr/>
          </p:nvSpPr>
          <p:spPr>
            <a:xfrm rot="8888110">
              <a:off x="3931465" y="4800834"/>
              <a:ext cx="5900" cy="11801"/>
            </a:xfrm>
            <a:custGeom>
              <a:avLst/>
              <a:gdLst>
                <a:gd name="csX0" fmla="*/ 304 w 5900"/>
                <a:gd name="csY0" fmla="*/ 11958 h 11801"/>
                <a:gd name="csX1" fmla="*/ 6204 w 5900"/>
                <a:gd name="csY1" fmla="*/ 6057 h 11801"/>
                <a:gd name="csX2" fmla="*/ 304 w 5900"/>
                <a:gd name="csY2" fmla="*/ 156 h 11801"/>
              </a:gdLst>
              <a:ahLst/>
              <a:cxnLst>
                <a:cxn ang="0">
                  <a:pos x="csX0" y="csY0"/>
                </a:cxn>
                <a:cxn ang="0">
                  <a:pos x="csX1" y="csY1"/>
                </a:cxn>
                <a:cxn ang="0">
                  <a:pos x="csX2" y="csY2"/>
                </a:cxn>
              </a:cxnLst>
              <a:rect l="l" t="t" r="r" b="b"/>
              <a:pathLst>
                <a:path w="5900" h="11801">
                  <a:moveTo>
                    <a:pt x="304" y="11958"/>
                  </a:moveTo>
                  <a:cubicBezTo>
                    <a:pt x="3563" y="11958"/>
                    <a:pt x="6204" y="9316"/>
                    <a:pt x="6204" y="6057"/>
                  </a:cubicBezTo>
                  <a:cubicBezTo>
                    <a:pt x="6204" y="2798"/>
                    <a:pt x="3563" y="156"/>
                    <a:pt x="304" y="156"/>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2" name="フリーフォーム: 図形 301">
              <a:extLst>
                <a:ext uri="{FF2B5EF4-FFF2-40B4-BE49-F238E27FC236}">
                  <a16:creationId xmlns:a16="http://schemas.microsoft.com/office/drawing/2014/main" id="{3F8865EC-260B-E975-B921-1C50621D0FC5}"/>
                </a:ext>
              </a:extLst>
            </p:cNvPr>
            <p:cNvSpPr/>
            <p:nvPr/>
          </p:nvSpPr>
          <p:spPr>
            <a:xfrm rot="19688110">
              <a:off x="4148715" y="4644408"/>
              <a:ext cx="51926" cy="25963"/>
            </a:xfrm>
            <a:custGeom>
              <a:avLst/>
              <a:gdLst>
                <a:gd name="csX0" fmla="*/ 351 w 51926"/>
                <a:gd name="csY0" fmla="*/ 128 h 25963"/>
                <a:gd name="csX1" fmla="*/ 52278 w 51926"/>
                <a:gd name="csY1" fmla="*/ 13109 h 25963"/>
                <a:gd name="csX2" fmla="*/ 351 w 51926"/>
                <a:gd name="csY2" fmla="*/ 26091 h 25963"/>
              </a:gdLst>
              <a:ahLst/>
              <a:cxnLst>
                <a:cxn ang="0">
                  <a:pos x="csX0" y="csY0"/>
                </a:cxn>
                <a:cxn ang="0">
                  <a:pos x="csX1" y="csY1"/>
                </a:cxn>
                <a:cxn ang="0">
                  <a:pos x="csX2" y="csY2"/>
                </a:cxn>
              </a:cxnLst>
              <a:rect l="l" t="t" r="r" b="b"/>
              <a:pathLst>
                <a:path w="51926" h="25963">
                  <a:moveTo>
                    <a:pt x="351" y="128"/>
                  </a:moveTo>
                  <a:cubicBezTo>
                    <a:pt x="17660" y="8782"/>
                    <a:pt x="34969" y="13109"/>
                    <a:pt x="52278" y="13109"/>
                  </a:cubicBezTo>
                  <a:cubicBezTo>
                    <a:pt x="34969" y="13109"/>
                    <a:pt x="17660" y="17436"/>
                    <a:pt x="351" y="26091"/>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3" name="フリーフォーム: 図形 302">
              <a:extLst>
                <a:ext uri="{FF2B5EF4-FFF2-40B4-BE49-F238E27FC236}">
                  <a16:creationId xmlns:a16="http://schemas.microsoft.com/office/drawing/2014/main" id="{61A7A328-689F-AC01-FB0B-110DC8388753}"/>
                </a:ext>
              </a:extLst>
            </p:cNvPr>
            <p:cNvSpPr/>
            <p:nvPr/>
          </p:nvSpPr>
          <p:spPr>
            <a:xfrm>
              <a:off x="3547949" y="4784592"/>
              <a:ext cx="274748" cy="40198"/>
            </a:xfrm>
            <a:custGeom>
              <a:avLst/>
              <a:gdLst>
                <a:gd name="csX0" fmla="*/ 271291 w 274748"/>
                <a:gd name="csY0" fmla="*/ 40586 h 40198"/>
                <a:gd name="csX1" fmla="*/ -3457 w 274748"/>
                <a:gd name="csY1" fmla="*/ 387 h 40198"/>
              </a:gdLst>
              <a:ahLst/>
              <a:cxnLst>
                <a:cxn ang="0">
                  <a:pos x="csX0" y="csY0"/>
                </a:cxn>
                <a:cxn ang="0">
                  <a:pos x="csX1" y="csY1"/>
                </a:cxn>
              </a:cxnLst>
              <a:rect l="l" t="t" r="r" b="b"/>
              <a:pathLst>
                <a:path w="274748" h="40198">
                  <a:moveTo>
                    <a:pt x="271291" y="40586"/>
                  </a:moveTo>
                  <a:lnTo>
                    <a:pt x="-3457" y="387"/>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4" name="フリーフォーム: 図形 303">
              <a:extLst>
                <a:ext uri="{FF2B5EF4-FFF2-40B4-BE49-F238E27FC236}">
                  <a16:creationId xmlns:a16="http://schemas.microsoft.com/office/drawing/2014/main" id="{A2B39F60-E544-7FCD-57B7-B1E779C59606}"/>
                </a:ext>
              </a:extLst>
            </p:cNvPr>
            <p:cNvSpPr/>
            <p:nvPr/>
          </p:nvSpPr>
          <p:spPr>
            <a:xfrm rot="499437">
              <a:off x="3822666" y="4819318"/>
              <a:ext cx="5900" cy="11801"/>
            </a:xfrm>
            <a:custGeom>
              <a:avLst/>
              <a:gdLst>
                <a:gd name="csX0" fmla="*/ 283 w 5900"/>
                <a:gd name="csY0" fmla="*/ 11961 h 11801"/>
                <a:gd name="csX1" fmla="*/ 6183 w 5900"/>
                <a:gd name="csY1" fmla="*/ 6061 h 11801"/>
                <a:gd name="csX2" fmla="*/ 283 w 5900"/>
                <a:gd name="csY2" fmla="*/ 160 h 11801"/>
              </a:gdLst>
              <a:ahLst/>
              <a:cxnLst>
                <a:cxn ang="0">
                  <a:pos x="csX0" y="csY0"/>
                </a:cxn>
                <a:cxn ang="0">
                  <a:pos x="csX1" y="csY1"/>
                </a:cxn>
                <a:cxn ang="0">
                  <a:pos x="csX2" y="csY2"/>
                </a:cxn>
              </a:cxnLst>
              <a:rect l="l" t="t" r="r" b="b"/>
              <a:pathLst>
                <a:path w="5900" h="11801">
                  <a:moveTo>
                    <a:pt x="283" y="11961"/>
                  </a:moveTo>
                  <a:cubicBezTo>
                    <a:pt x="3542" y="11961"/>
                    <a:pt x="6183" y="9320"/>
                    <a:pt x="6183" y="6061"/>
                  </a:cubicBezTo>
                  <a:cubicBezTo>
                    <a:pt x="6183" y="2802"/>
                    <a:pt x="3542" y="160"/>
                    <a:pt x="283" y="160"/>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5" name="フリーフォーム: 図形 304">
              <a:extLst>
                <a:ext uri="{FF2B5EF4-FFF2-40B4-BE49-F238E27FC236}">
                  <a16:creationId xmlns:a16="http://schemas.microsoft.com/office/drawing/2014/main" id="{FB3AC2C0-FF20-ABB4-A157-1AF1C60498BC}"/>
                </a:ext>
              </a:extLst>
            </p:cNvPr>
            <p:cNvSpPr/>
            <p:nvPr/>
          </p:nvSpPr>
          <p:spPr>
            <a:xfrm rot="11299437">
              <a:off x="3496295" y="4767852"/>
              <a:ext cx="51926" cy="25963"/>
            </a:xfrm>
            <a:custGeom>
              <a:avLst/>
              <a:gdLst>
                <a:gd name="csX0" fmla="*/ 225 w 51926"/>
                <a:gd name="csY0" fmla="*/ 151 h 25963"/>
                <a:gd name="csX1" fmla="*/ 52152 w 51926"/>
                <a:gd name="csY1" fmla="*/ 13133 h 25963"/>
                <a:gd name="csX2" fmla="*/ 225 w 51926"/>
                <a:gd name="csY2" fmla="*/ 26115 h 25963"/>
              </a:gdLst>
              <a:ahLst/>
              <a:cxnLst>
                <a:cxn ang="0">
                  <a:pos x="csX0" y="csY0"/>
                </a:cxn>
                <a:cxn ang="0">
                  <a:pos x="csX1" y="csY1"/>
                </a:cxn>
                <a:cxn ang="0">
                  <a:pos x="csX2" y="csY2"/>
                </a:cxn>
              </a:cxnLst>
              <a:rect l="l" t="t" r="r" b="b"/>
              <a:pathLst>
                <a:path w="51926" h="25963">
                  <a:moveTo>
                    <a:pt x="225" y="151"/>
                  </a:moveTo>
                  <a:cubicBezTo>
                    <a:pt x="17534" y="8806"/>
                    <a:pt x="34843" y="13133"/>
                    <a:pt x="52152" y="13133"/>
                  </a:cubicBezTo>
                  <a:cubicBezTo>
                    <a:pt x="34843" y="13133"/>
                    <a:pt x="17534" y="17460"/>
                    <a:pt x="225" y="26115"/>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6" name="フリーフォーム: 図形 305">
              <a:extLst>
                <a:ext uri="{FF2B5EF4-FFF2-40B4-BE49-F238E27FC236}">
                  <a16:creationId xmlns:a16="http://schemas.microsoft.com/office/drawing/2014/main" id="{6B7C90EB-2F3E-86F5-3087-A6F438E29ED3}"/>
                </a:ext>
              </a:extLst>
            </p:cNvPr>
            <p:cNvSpPr/>
            <p:nvPr/>
          </p:nvSpPr>
          <p:spPr>
            <a:xfrm>
              <a:off x="3919137" y="4578749"/>
              <a:ext cx="130525" cy="208644"/>
            </a:xfrm>
            <a:custGeom>
              <a:avLst/>
              <a:gdLst>
                <a:gd name="csX0" fmla="*/ -3526 w 130525"/>
                <a:gd name="csY0" fmla="*/ 209059 h 208644"/>
                <a:gd name="csX1" fmla="*/ 126999 w 130525"/>
                <a:gd name="csY1" fmla="*/ 415 h 208644"/>
              </a:gdLst>
              <a:ahLst/>
              <a:cxnLst>
                <a:cxn ang="0">
                  <a:pos x="csX0" y="csY0"/>
                </a:cxn>
                <a:cxn ang="0">
                  <a:pos x="csX1" y="csY1"/>
                </a:cxn>
              </a:cxnLst>
              <a:rect l="l" t="t" r="r" b="b"/>
              <a:pathLst>
                <a:path w="130525" h="208644">
                  <a:moveTo>
                    <a:pt x="-3526" y="209059"/>
                  </a:moveTo>
                  <a:lnTo>
                    <a:pt x="126999" y="415"/>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7" name="フリーフォーム: 図形 306">
              <a:extLst>
                <a:ext uri="{FF2B5EF4-FFF2-40B4-BE49-F238E27FC236}">
                  <a16:creationId xmlns:a16="http://schemas.microsoft.com/office/drawing/2014/main" id="{1525F5DE-D181-3C45-9A8D-2F6FA710E419}"/>
                </a:ext>
              </a:extLst>
            </p:cNvPr>
            <p:cNvSpPr/>
            <p:nvPr/>
          </p:nvSpPr>
          <p:spPr>
            <a:xfrm rot="7321778">
              <a:off x="3914622" y="4783994"/>
              <a:ext cx="5900" cy="11801"/>
            </a:xfrm>
            <a:custGeom>
              <a:avLst/>
              <a:gdLst>
                <a:gd name="csX0" fmla="*/ 300 w 5900"/>
                <a:gd name="csY0" fmla="*/ 11955 h 11801"/>
                <a:gd name="csX1" fmla="*/ 6201 w 5900"/>
                <a:gd name="csY1" fmla="*/ 6054 h 11801"/>
                <a:gd name="csX2" fmla="*/ 300 w 5900"/>
                <a:gd name="csY2" fmla="*/ 153 h 11801"/>
              </a:gdLst>
              <a:ahLst/>
              <a:cxnLst>
                <a:cxn ang="0">
                  <a:pos x="csX0" y="csY0"/>
                </a:cxn>
                <a:cxn ang="0">
                  <a:pos x="csX1" y="csY1"/>
                </a:cxn>
                <a:cxn ang="0">
                  <a:pos x="csX2" y="csY2"/>
                </a:cxn>
              </a:cxnLst>
              <a:rect l="l" t="t" r="r" b="b"/>
              <a:pathLst>
                <a:path w="5900" h="11801">
                  <a:moveTo>
                    <a:pt x="300" y="11955"/>
                  </a:moveTo>
                  <a:cubicBezTo>
                    <a:pt x="3559" y="11955"/>
                    <a:pt x="6201" y="9313"/>
                    <a:pt x="6201" y="6054"/>
                  </a:cubicBezTo>
                  <a:cubicBezTo>
                    <a:pt x="6201" y="2795"/>
                    <a:pt x="3559" y="153"/>
                    <a:pt x="300" y="153"/>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8" name="フリーフォーム: 図形 307">
              <a:extLst>
                <a:ext uri="{FF2B5EF4-FFF2-40B4-BE49-F238E27FC236}">
                  <a16:creationId xmlns:a16="http://schemas.microsoft.com/office/drawing/2014/main" id="{3C2476F1-D5EF-EFC6-D2CC-A35B3922BB45}"/>
                </a:ext>
              </a:extLst>
            </p:cNvPr>
            <p:cNvSpPr/>
            <p:nvPr/>
          </p:nvSpPr>
          <p:spPr>
            <a:xfrm rot="18121778">
              <a:off x="4037470" y="4543756"/>
              <a:ext cx="51926" cy="25963"/>
            </a:xfrm>
            <a:custGeom>
              <a:avLst/>
              <a:gdLst>
                <a:gd name="csX0" fmla="*/ 330 w 51926"/>
                <a:gd name="csY0" fmla="*/ 108 h 25963"/>
                <a:gd name="csX1" fmla="*/ 52256 w 51926"/>
                <a:gd name="csY1" fmla="*/ 13090 h 25963"/>
                <a:gd name="csX2" fmla="*/ 330 w 51926"/>
                <a:gd name="csY2" fmla="*/ 26071 h 25963"/>
              </a:gdLst>
              <a:ahLst/>
              <a:cxnLst>
                <a:cxn ang="0">
                  <a:pos x="csX0" y="csY0"/>
                </a:cxn>
                <a:cxn ang="0">
                  <a:pos x="csX1" y="csY1"/>
                </a:cxn>
                <a:cxn ang="0">
                  <a:pos x="csX2" y="csY2"/>
                </a:cxn>
              </a:cxnLst>
              <a:rect l="l" t="t" r="r" b="b"/>
              <a:pathLst>
                <a:path w="51926" h="25963">
                  <a:moveTo>
                    <a:pt x="330" y="108"/>
                  </a:moveTo>
                  <a:cubicBezTo>
                    <a:pt x="17639" y="8763"/>
                    <a:pt x="34948" y="13090"/>
                    <a:pt x="52256" y="13090"/>
                  </a:cubicBezTo>
                  <a:cubicBezTo>
                    <a:pt x="34948" y="13090"/>
                    <a:pt x="17639" y="17417"/>
                    <a:pt x="330" y="26071"/>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09" name="フリーフォーム: 図形 308">
              <a:extLst>
                <a:ext uri="{FF2B5EF4-FFF2-40B4-BE49-F238E27FC236}">
                  <a16:creationId xmlns:a16="http://schemas.microsoft.com/office/drawing/2014/main" id="{7FD138E3-D45B-8CD5-1789-AF21D73796F7}"/>
                </a:ext>
              </a:extLst>
            </p:cNvPr>
            <p:cNvSpPr/>
            <p:nvPr/>
          </p:nvSpPr>
          <p:spPr>
            <a:xfrm>
              <a:off x="3509800" y="4879969"/>
              <a:ext cx="348493" cy="504972"/>
            </a:xfrm>
            <a:custGeom>
              <a:avLst/>
              <a:gdLst>
                <a:gd name="csX0" fmla="*/ 345037 w 348493"/>
                <a:gd name="csY0" fmla="*/ 311 h 504972"/>
                <a:gd name="csX1" fmla="*/ -3457 w 348493"/>
                <a:gd name="csY1" fmla="*/ 505283 h 504972"/>
              </a:gdLst>
              <a:ahLst/>
              <a:cxnLst>
                <a:cxn ang="0">
                  <a:pos x="csX0" y="csY0"/>
                </a:cxn>
                <a:cxn ang="0">
                  <a:pos x="csX1" y="csY1"/>
                </a:cxn>
              </a:cxnLst>
              <a:rect l="l" t="t" r="r" b="b"/>
              <a:pathLst>
                <a:path w="348493" h="504972">
                  <a:moveTo>
                    <a:pt x="345037" y="311"/>
                  </a:moveTo>
                  <a:lnTo>
                    <a:pt x="-3457" y="505283"/>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0" name="フリーフォーム: 図形 309">
              <a:extLst>
                <a:ext uri="{FF2B5EF4-FFF2-40B4-BE49-F238E27FC236}">
                  <a16:creationId xmlns:a16="http://schemas.microsoft.com/office/drawing/2014/main" id="{B182B735-07E9-C1CD-A94A-3B3418884502}"/>
                </a:ext>
              </a:extLst>
            </p:cNvPr>
            <p:cNvSpPr/>
            <p:nvPr/>
          </p:nvSpPr>
          <p:spPr>
            <a:xfrm>
              <a:off x="3973023" y="4900843"/>
              <a:ext cx="345187" cy="274226"/>
            </a:xfrm>
            <a:custGeom>
              <a:avLst/>
              <a:gdLst>
                <a:gd name="csX0" fmla="*/ 341624 w 345187"/>
                <a:gd name="csY0" fmla="*/ 274559 h 274226"/>
                <a:gd name="csX1" fmla="*/ -3564 w 345187"/>
                <a:gd name="csY1" fmla="*/ 333 h 274226"/>
              </a:gdLst>
              <a:ahLst/>
              <a:cxnLst>
                <a:cxn ang="0">
                  <a:pos x="csX0" y="csY0"/>
                </a:cxn>
                <a:cxn ang="0">
                  <a:pos x="csX1" y="csY1"/>
                </a:cxn>
              </a:cxnLst>
              <a:rect l="l" t="t" r="r" b="b"/>
              <a:pathLst>
                <a:path w="345187" h="274226">
                  <a:moveTo>
                    <a:pt x="341624" y="274559"/>
                  </a:moveTo>
                  <a:lnTo>
                    <a:pt x="-3564" y="333"/>
                  </a:lnTo>
                </a:path>
              </a:pathLst>
            </a:custGeom>
            <a:noFill/>
            <a:ln w="11787" cap="flat">
              <a:solidFill>
                <a:srgbClr val="F46D43"/>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1" name="フリーフォーム: 図形 310">
              <a:extLst>
                <a:ext uri="{FF2B5EF4-FFF2-40B4-BE49-F238E27FC236}">
                  <a16:creationId xmlns:a16="http://schemas.microsoft.com/office/drawing/2014/main" id="{554DCC42-78CB-1E90-91A7-B0863838F410}"/>
                </a:ext>
              </a:extLst>
            </p:cNvPr>
            <p:cNvSpPr/>
            <p:nvPr/>
          </p:nvSpPr>
          <p:spPr>
            <a:xfrm rot="2307878">
              <a:off x="4317570" y="5171004"/>
              <a:ext cx="5900" cy="11801"/>
            </a:xfrm>
            <a:custGeom>
              <a:avLst/>
              <a:gdLst>
                <a:gd name="csX0" fmla="*/ 378 w 5900"/>
                <a:gd name="csY0" fmla="*/ 12029 h 11801"/>
                <a:gd name="csX1" fmla="*/ 6279 w 5900"/>
                <a:gd name="csY1" fmla="*/ 6128 h 11801"/>
                <a:gd name="csX2" fmla="*/ 378 w 5900"/>
                <a:gd name="csY2" fmla="*/ 228 h 11801"/>
              </a:gdLst>
              <a:ahLst/>
              <a:cxnLst>
                <a:cxn ang="0">
                  <a:pos x="csX0" y="csY0"/>
                </a:cxn>
                <a:cxn ang="0">
                  <a:pos x="csX1" y="csY1"/>
                </a:cxn>
                <a:cxn ang="0">
                  <a:pos x="csX2" y="csY2"/>
                </a:cxn>
              </a:cxnLst>
              <a:rect l="l" t="t" r="r" b="b"/>
              <a:pathLst>
                <a:path w="5900" h="11801">
                  <a:moveTo>
                    <a:pt x="378" y="12029"/>
                  </a:moveTo>
                  <a:cubicBezTo>
                    <a:pt x="3637" y="12029"/>
                    <a:pt x="6279" y="9387"/>
                    <a:pt x="6279" y="6128"/>
                  </a:cubicBezTo>
                  <a:cubicBezTo>
                    <a:pt x="6279" y="2870"/>
                    <a:pt x="3637" y="228"/>
                    <a:pt x="378" y="228"/>
                  </a:cubicBezTo>
                  <a:close/>
                </a:path>
              </a:pathLst>
            </a:custGeom>
            <a:solidFill>
              <a:srgbClr val="F46D43"/>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2" name="フリーフォーム: 図形 311">
              <a:extLst>
                <a:ext uri="{FF2B5EF4-FFF2-40B4-BE49-F238E27FC236}">
                  <a16:creationId xmlns:a16="http://schemas.microsoft.com/office/drawing/2014/main" id="{39B3D36D-41C6-2D07-AE61-CE7F9FFA5A9C}"/>
                </a:ext>
              </a:extLst>
            </p:cNvPr>
            <p:cNvSpPr/>
            <p:nvPr/>
          </p:nvSpPr>
          <p:spPr>
            <a:xfrm rot="13107878">
              <a:off x="3926731" y="4871711"/>
              <a:ext cx="51926" cy="25963"/>
            </a:xfrm>
            <a:custGeom>
              <a:avLst/>
              <a:gdLst>
                <a:gd name="csX0" fmla="*/ 308 w 51926"/>
                <a:gd name="csY0" fmla="*/ 171 h 25963"/>
                <a:gd name="csX1" fmla="*/ 52235 w 51926"/>
                <a:gd name="csY1" fmla="*/ 13153 h 25963"/>
                <a:gd name="csX2" fmla="*/ 308 w 51926"/>
                <a:gd name="csY2" fmla="*/ 26135 h 25963"/>
              </a:gdLst>
              <a:ahLst/>
              <a:cxnLst>
                <a:cxn ang="0">
                  <a:pos x="csX0" y="csY0"/>
                </a:cxn>
                <a:cxn ang="0">
                  <a:pos x="csX1" y="csY1"/>
                </a:cxn>
                <a:cxn ang="0">
                  <a:pos x="csX2" y="csY2"/>
                </a:cxn>
              </a:cxnLst>
              <a:rect l="l" t="t" r="r" b="b"/>
              <a:pathLst>
                <a:path w="51926" h="25963">
                  <a:moveTo>
                    <a:pt x="308" y="171"/>
                  </a:moveTo>
                  <a:lnTo>
                    <a:pt x="52235" y="13153"/>
                  </a:lnTo>
                  <a:lnTo>
                    <a:pt x="308" y="26135"/>
                  </a:lnTo>
                  <a:close/>
                </a:path>
              </a:pathLst>
            </a:custGeom>
            <a:solidFill>
              <a:srgbClr val="F46D43"/>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3" name="フリーフォーム: 図形 312">
              <a:extLst>
                <a:ext uri="{FF2B5EF4-FFF2-40B4-BE49-F238E27FC236}">
                  <a16:creationId xmlns:a16="http://schemas.microsoft.com/office/drawing/2014/main" id="{AE404564-A704-DA19-B6A8-5FA211975C18}"/>
                </a:ext>
              </a:extLst>
            </p:cNvPr>
            <p:cNvSpPr/>
            <p:nvPr/>
          </p:nvSpPr>
          <p:spPr>
            <a:xfrm>
              <a:off x="3705049" y="4698256"/>
              <a:ext cx="140446" cy="103737"/>
            </a:xfrm>
            <a:custGeom>
              <a:avLst/>
              <a:gdLst>
                <a:gd name="csX0" fmla="*/ 136969 w 140446"/>
                <a:gd name="csY0" fmla="*/ 104137 h 103737"/>
                <a:gd name="csX1" fmla="*/ -3478 w 140446"/>
                <a:gd name="csY1" fmla="*/ 399 h 103737"/>
              </a:gdLst>
              <a:ahLst/>
              <a:cxnLst>
                <a:cxn ang="0">
                  <a:pos x="csX0" y="csY0"/>
                </a:cxn>
                <a:cxn ang="0">
                  <a:pos x="csX1" y="csY1"/>
                </a:cxn>
              </a:cxnLst>
              <a:rect l="l" t="t" r="r" b="b"/>
              <a:pathLst>
                <a:path w="140446" h="103737">
                  <a:moveTo>
                    <a:pt x="136969" y="104137"/>
                  </a:moveTo>
                  <a:lnTo>
                    <a:pt x="-3478" y="399"/>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4" name="フリーフォーム: 図形 313">
              <a:extLst>
                <a:ext uri="{FF2B5EF4-FFF2-40B4-BE49-F238E27FC236}">
                  <a16:creationId xmlns:a16="http://schemas.microsoft.com/office/drawing/2014/main" id="{BA74C0E9-2151-E5CC-D497-E5706422463F}"/>
                </a:ext>
              </a:extLst>
            </p:cNvPr>
            <p:cNvSpPr/>
            <p:nvPr/>
          </p:nvSpPr>
          <p:spPr>
            <a:xfrm rot="2187033">
              <a:off x="3844918" y="4797845"/>
              <a:ext cx="5900" cy="11801"/>
            </a:xfrm>
            <a:custGeom>
              <a:avLst/>
              <a:gdLst>
                <a:gd name="csX0" fmla="*/ 287 w 5900"/>
                <a:gd name="csY0" fmla="*/ 11957 h 11801"/>
                <a:gd name="csX1" fmla="*/ 6188 w 5900"/>
                <a:gd name="csY1" fmla="*/ 6057 h 11801"/>
                <a:gd name="csX2" fmla="*/ 287 w 5900"/>
                <a:gd name="csY2" fmla="*/ 156 h 11801"/>
              </a:gdLst>
              <a:ahLst/>
              <a:cxnLst>
                <a:cxn ang="0">
                  <a:pos x="csX0" y="csY0"/>
                </a:cxn>
                <a:cxn ang="0">
                  <a:pos x="csX1" y="csY1"/>
                </a:cxn>
                <a:cxn ang="0">
                  <a:pos x="csX2" y="csY2"/>
                </a:cxn>
              </a:cxnLst>
              <a:rect l="l" t="t" r="r" b="b"/>
              <a:pathLst>
                <a:path w="5900" h="11801">
                  <a:moveTo>
                    <a:pt x="287" y="11957"/>
                  </a:moveTo>
                  <a:cubicBezTo>
                    <a:pt x="3546" y="11957"/>
                    <a:pt x="6188" y="9315"/>
                    <a:pt x="6188" y="6057"/>
                  </a:cubicBezTo>
                  <a:cubicBezTo>
                    <a:pt x="6188" y="2798"/>
                    <a:pt x="3546" y="156"/>
                    <a:pt x="287" y="156"/>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5" name="フリーフォーム: 図形 314">
              <a:extLst>
                <a:ext uri="{FF2B5EF4-FFF2-40B4-BE49-F238E27FC236}">
                  <a16:creationId xmlns:a16="http://schemas.microsoft.com/office/drawing/2014/main" id="{E30E4509-CF26-51A6-1EC8-FC3C689AC16F}"/>
                </a:ext>
              </a:extLst>
            </p:cNvPr>
            <p:cNvSpPr/>
            <p:nvPr/>
          </p:nvSpPr>
          <p:spPr>
            <a:xfrm rot="12987033">
              <a:off x="3658202" y="4669849"/>
              <a:ext cx="51926" cy="25963"/>
            </a:xfrm>
            <a:custGeom>
              <a:avLst/>
              <a:gdLst>
                <a:gd name="csX0" fmla="*/ 257 w 51926"/>
                <a:gd name="csY0" fmla="*/ 132 h 25963"/>
                <a:gd name="csX1" fmla="*/ 52183 w 51926"/>
                <a:gd name="csY1" fmla="*/ 13114 h 25963"/>
                <a:gd name="csX2" fmla="*/ 257 w 51926"/>
                <a:gd name="csY2" fmla="*/ 26096 h 25963"/>
              </a:gdLst>
              <a:ahLst/>
              <a:cxnLst>
                <a:cxn ang="0">
                  <a:pos x="csX0" y="csY0"/>
                </a:cxn>
                <a:cxn ang="0">
                  <a:pos x="csX1" y="csY1"/>
                </a:cxn>
                <a:cxn ang="0">
                  <a:pos x="csX2" y="csY2"/>
                </a:cxn>
              </a:cxnLst>
              <a:rect l="l" t="t" r="r" b="b"/>
              <a:pathLst>
                <a:path w="51926" h="25963">
                  <a:moveTo>
                    <a:pt x="257" y="132"/>
                  </a:moveTo>
                  <a:cubicBezTo>
                    <a:pt x="17566" y="8787"/>
                    <a:pt x="34874" y="13114"/>
                    <a:pt x="52183" y="13114"/>
                  </a:cubicBezTo>
                  <a:cubicBezTo>
                    <a:pt x="34874" y="13114"/>
                    <a:pt x="17566" y="17441"/>
                    <a:pt x="257" y="26096"/>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6" name="フリーフォーム: 図形 315">
              <a:extLst>
                <a:ext uri="{FF2B5EF4-FFF2-40B4-BE49-F238E27FC236}">
                  <a16:creationId xmlns:a16="http://schemas.microsoft.com/office/drawing/2014/main" id="{3BAC8C87-65B2-AE9C-0415-9A4405276AC8}"/>
                </a:ext>
              </a:extLst>
            </p:cNvPr>
            <p:cNvSpPr/>
            <p:nvPr/>
          </p:nvSpPr>
          <p:spPr>
            <a:xfrm>
              <a:off x="3356753" y="4843258"/>
              <a:ext cx="464828" cy="59274"/>
            </a:xfrm>
            <a:custGeom>
              <a:avLst/>
              <a:gdLst>
                <a:gd name="csX0" fmla="*/ 461394 w 464828"/>
                <a:gd name="csY0" fmla="*/ 371 h 59274"/>
                <a:gd name="csX1" fmla="*/ -3435 w 464828"/>
                <a:gd name="csY1" fmla="*/ 59645 h 59274"/>
              </a:gdLst>
              <a:ahLst/>
              <a:cxnLst>
                <a:cxn ang="0">
                  <a:pos x="csX0" y="csY0"/>
                </a:cxn>
                <a:cxn ang="0">
                  <a:pos x="csX1" y="csY1"/>
                </a:cxn>
              </a:cxnLst>
              <a:rect l="l" t="t" r="r" b="b"/>
              <a:pathLst>
                <a:path w="464828" h="59274">
                  <a:moveTo>
                    <a:pt x="461394" y="371"/>
                  </a:moveTo>
                  <a:lnTo>
                    <a:pt x="-3435" y="59645"/>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7" name="フリーフォーム: 図形 316">
              <a:extLst>
                <a:ext uri="{FF2B5EF4-FFF2-40B4-BE49-F238E27FC236}">
                  <a16:creationId xmlns:a16="http://schemas.microsoft.com/office/drawing/2014/main" id="{DD90AFE4-35A7-EC03-3EE1-BC93CCDC64B7}"/>
                </a:ext>
              </a:extLst>
            </p:cNvPr>
            <p:cNvSpPr/>
            <p:nvPr/>
          </p:nvSpPr>
          <p:spPr>
            <a:xfrm rot="21163977">
              <a:off x="3821558" y="4836984"/>
              <a:ext cx="5900" cy="11801"/>
            </a:xfrm>
            <a:custGeom>
              <a:avLst/>
              <a:gdLst>
                <a:gd name="csX0" fmla="*/ 282 w 5900"/>
                <a:gd name="csY0" fmla="*/ 11965 h 11801"/>
                <a:gd name="csX1" fmla="*/ 6183 w 5900"/>
                <a:gd name="csY1" fmla="*/ 6064 h 11801"/>
                <a:gd name="csX2" fmla="*/ 282 w 5900"/>
                <a:gd name="csY2" fmla="*/ 163 h 11801"/>
              </a:gdLst>
              <a:ahLst/>
              <a:cxnLst>
                <a:cxn ang="0">
                  <a:pos x="csX0" y="csY0"/>
                </a:cxn>
                <a:cxn ang="0">
                  <a:pos x="csX1" y="csY1"/>
                </a:cxn>
                <a:cxn ang="0">
                  <a:pos x="csX2" y="csY2"/>
                </a:cxn>
              </a:cxnLst>
              <a:rect l="l" t="t" r="r" b="b"/>
              <a:pathLst>
                <a:path w="5900" h="11801">
                  <a:moveTo>
                    <a:pt x="282" y="11965"/>
                  </a:moveTo>
                  <a:cubicBezTo>
                    <a:pt x="3541" y="11965"/>
                    <a:pt x="6183" y="9323"/>
                    <a:pt x="6183" y="6064"/>
                  </a:cubicBezTo>
                  <a:cubicBezTo>
                    <a:pt x="6183" y="2805"/>
                    <a:pt x="3541" y="163"/>
                    <a:pt x="282" y="163"/>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8" name="フリーフォーム: 図形 317">
              <a:extLst>
                <a:ext uri="{FF2B5EF4-FFF2-40B4-BE49-F238E27FC236}">
                  <a16:creationId xmlns:a16="http://schemas.microsoft.com/office/drawing/2014/main" id="{E9EC8147-8AD3-BB65-E96E-7E8D13E533A5}"/>
                </a:ext>
              </a:extLst>
            </p:cNvPr>
            <p:cNvSpPr/>
            <p:nvPr/>
          </p:nvSpPr>
          <p:spPr>
            <a:xfrm rot="10363977">
              <a:off x="3305035" y="4892834"/>
              <a:ext cx="51926" cy="25963"/>
            </a:xfrm>
            <a:custGeom>
              <a:avLst/>
              <a:gdLst>
                <a:gd name="csX0" fmla="*/ 189 w 51926"/>
                <a:gd name="csY0" fmla="*/ 175 h 25963"/>
                <a:gd name="csX1" fmla="*/ 52115 w 51926"/>
                <a:gd name="csY1" fmla="*/ 13157 h 25963"/>
                <a:gd name="csX2" fmla="*/ 189 w 51926"/>
                <a:gd name="csY2" fmla="*/ 26139 h 25963"/>
              </a:gdLst>
              <a:ahLst/>
              <a:cxnLst>
                <a:cxn ang="0">
                  <a:pos x="csX0" y="csY0"/>
                </a:cxn>
                <a:cxn ang="0">
                  <a:pos x="csX1" y="csY1"/>
                </a:cxn>
                <a:cxn ang="0">
                  <a:pos x="csX2" y="csY2"/>
                </a:cxn>
              </a:cxnLst>
              <a:rect l="l" t="t" r="r" b="b"/>
              <a:pathLst>
                <a:path w="51926" h="25963">
                  <a:moveTo>
                    <a:pt x="189" y="175"/>
                  </a:moveTo>
                  <a:cubicBezTo>
                    <a:pt x="17497" y="8830"/>
                    <a:pt x="34806" y="13157"/>
                    <a:pt x="52115" y="13157"/>
                  </a:cubicBezTo>
                  <a:cubicBezTo>
                    <a:pt x="34806" y="13157"/>
                    <a:pt x="17497" y="17484"/>
                    <a:pt x="189" y="26139"/>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19" name="フリーフォーム: 図形 318">
              <a:extLst>
                <a:ext uri="{FF2B5EF4-FFF2-40B4-BE49-F238E27FC236}">
                  <a16:creationId xmlns:a16="http://schemas.microsoft.com/office/drawing/2014/main" id="{9417401E-4077-4D5C-DE0E-19D5D3F1D4A0}"/>
                </a:ext>
              </a:extLst>
            </p:cNvPr>
            <p:cNvSpPr/>
            <p:nvPr/>
          </p:nvSpPr>
          <p:spPr>
            <a:xfrm>
              <a:off x="3940749" y="4860159"/>
              <a:ext cx="216000" cy="90000"/>
            </a:xfrm>
            <a:custGeom>
              <a:avLst/>
              <a:gdLst>
                <a:gd name="csX0" fmla="*/ -3536 w 174806"/>
                <a:gd name="csY0" fmla="*/ 364 h 87441"/>
                <a:gd name="csX1" fmla="*/ 171270 w 174806"/>
                <a:gd name="csY1" fmla="*/ 87805 h 87441"/>
              </a:gdLst>
              <a:ahLst/>
              <a:cxnLst>
                <a:cxn ang="0">
                  <a:pos x="csX0" y="csY0"/>
                </a:cxn>
                <a:cxn ang="0">
                  <a:pos x="csX1" y="csY1"/>
                </a:cxn>
              </a:cxnLst>
              <a:rect l="l" t="t" r="r" b="b"/>
              <a:pathLst>
                <a:path w="174806" h="87441">
                  <a:moveTo>
                    <a:pt x="-3536" y="364"/>
                  </a:moveTo>
                  <a:lnTo>
                    <a:pt x="171270" y="87805"/>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0" name="フリーフォーム: 図形 319">
              <a:extLst>
                <a:ext uri="{FF2B5EF4-FFF2-40B4-BE49-F238E27FC236}">
                  <a16:creationId xmlns:a16="http://schemas.microsoft.com/office/drawing/2014/main" id="{770BAA0A-51B2-929C-2A25-B585887BCB67}"/>
                </a:ext>
              </a:extLst>
            </p:cNvPr>
            <p:cNvSpPr/>
            <p:nvPr/>
          </p:nvSpPr>
          <p:spPr>
            <a:xfrm rot="12394506">
              <a:off x="3935160" y="4852939"/>
              <a:ext cx="5900" cy="11801"/>
            </a:xfrm>
            <a:custGeom>
              <a:avLst/>
              <a:gdLst>
                <a:gd name="csX0" fmla="*/ 304 w 5900"/>
                <a:gd name="csY0" fmla="*/ 11968 h 11801"/>
                <a:gd name="csX1" fmla="*/ 6205 w 5900"/>
                <a:gd name="csY1" fmla="*/ 6067 h 11801"/>
                <a:gd name="csX2" fmla="*/ 304 w 5900"/>
                <a:gd name="csY2" fmla="*/ 166 h 11801"/>
              </a:gdLst>
              <a:ahLst/>
              <a:cxnLst>
                <a:cxn ang="0">
                  <a:pos x="csX0" y="csY0"/>
                </a:cxn>
                <a:cxn ang="0">
                  <a:pos x="csX1" y="csY1"/>
                </a:cxn>
                <a:cxn ang="0">
                  <a:pos x="csX2" y="csY2"/>
                </a:cxn>
              </a:cxnLst>
              <a:rect l="l" t="t" r="r" b="b"/>
              <a:pathLst>
                <a:path w="5900" h="11801">
                  <a:moveTo>
                    <a:pt x="304" y="11968"/>
                  </a:moveTo>
                  <a:cubicBezTo>
                    <a:pt x="3563" y="11968"/>
                    <a:pt x="6205" y="9326"/>
                    <a:pt x="6205" y="6067"/>
                  </a:cubicBezTo>
                  <a:cubicBezTo>
                    <a:pt x="6205" y="2808"/>
                    <a:pt x="3563" y="166"/>
                    <a:pt x="304" y="166"/>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1" name="フリーフォーム: 図形 320">
              <a:extLst>
                <a:ext uri="{FF2B5EF4-FFF2-40B4-BE49-F238E27FC236}">
                  <a16:creationId xmlns:a16="http://schemas.microsoft.com/office/drawing/2014/main" id="{D465A14C-DEDC-5588-3751-6B9A547E60E2}"/>
                </a:ext>
              </a:extLst>
            </p:cNvPr>
            <p:cNvSpPr/>
            <p:nvPr/>
          </p:nvSpPr>
          <p:spPr>
            <a:xfrm rot="1594506">
              <a:off x="4137817" y="4942921"/>
              <a:ext cx="54000" cy="36000"/>
            </a:xfrm>
            <a:custGeom>
              <a:avLst/>
              <a:gdLst>
                <a:gd name="csX0" fmla="*/ 344 w 51926"/>
                <a:gd name="csY0" fmla="*/ 186 h 25963"/>
                <a:gd name="csX1" fmla="*/ 52271 w 51926"/>
                <a:gd name="csY1" fmla="*/ 13167 h 25963"/>
                <a:gd name="csX2" fmla="*/ 344 w 51926"/>
                <a:gd name="csY2" fmla="*/ 26149 h 25963"/>
              </a:gdLst>
              <a:ahLst/>
              <a:cxnLst>
                <a:cxn ang="0">
                  <a:pos x="csX0" y="csY0"/>
                </a:cxn>
                <a:cxn ang="0">
                  <a:pos x="csX1" y="csY1"/>
                </a:cxn>
                <a:cxn ang="0">
                  <a:pos x="csX2" y="csY2"/>
                </a:cxn>
              </a:cxnLst>
              <a:rect l="l" t="t" r="r" b="b"/>
              <a:pathLst>
                <a:path w="51926" h="25963">
                  <a:moveTo>
                    <a:pt x="344" y="186"/>
                  </a:moveTo>
                  <a:cubicBezTo>
                    <a:pt x="17653" y="8840"/>
                    <a:pt x="34962" y="13167"/>
                    <a:pt x="52271" y="13167"/>
                  </a:cubicBezTo>
                  <a:cubicBezTo>
                    <a:pt x="34962" y="13167"/>
                    <a:pt x="17653" y="17495"/>
                    <a:pt x="344" y="26149"/>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2" name="フリーフォーム: 図形 321">
              <a:extLst>
                <a:ext uri="{FF2B5EF4-FFF2-40B4-BE49-F238E27FC236}">
                  <a16:creationId xmlns:a16="http://schemas.microsoft.com/office/drawing/2014/main" id="{05D93EBA-B7EB-C5DB-ABED-BFCDA5263328}"/>
                </a:ext>
              </a:extLst>
            </p:cNvPr>
            <p:cNvSpPr/>
            <p:nvPr/>
          </p:nvSpPr>
          <p:spPr>
            <a:xfrm>
              <a:off x="3622412" y="4465546"/>
              <a:ext cx="21190" cy="90831"/>
            </a:xfrm>
            <a:custGeom>
              <a:avLst/>
              <a:gdLst>
                <a:gd name="csX0" fmla="*/ -3445 w 21190"/>
                <a:gd name="csY0" fmla="*/ 91286 h 90831"/>
                <a:gd name="csX1" fmla="*/ 17746 w 21190"/>
                <a:gd name="csY1" fmla="*/ 455 h 90831"/>
              </a:gdLst>
              <a:ahLst/>
              <a:cxnLst>
                <a:cxn ang="0">
                  <a:pos x="csX0" y="csY0"/>
                </a:cxn>
                <a:cxn ang="0">
                  <a:pos x="csX1" y="csY1"/>
                </a:cxn>
              </a:cxnLst>
              <a:rect l="l" t="t" r="r" b="b"/>
              <a:pathLst>
                <a:path w="21190" h="90831">
                  <a:moveTo>
                    <a:pt x="-3445" y="91286"/>
                  </a:moveTo>
                  <a:lnTo>
                    <a:pt x="17746" y="455"/>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3" name="フリーフォーム: 図形 322">
              <a:extLst>
                <a:ext uri="{FF2B5EF4-FFF2-40B4-BE49-F238E27FC236}">
                  <a16:creationId xmlns:a16="http://schemas.microsoft.com/office/drawing/2014/main" id="{532E51D4-8F88-84BE-4914-4D9EC051C05C}"/>
                </a:ext>
              </a:extLst>
            </p:cNvPr>
            <p:cNvSpPr/>
            <p:nvPr/>
          </p:nvSpPr>
          <p:spPr>
            <a:xfrm>
              <a:off x="3217839" y="5461441"/>
              <a:ext cx="215042" cy="146733"/>
            </a:xfrm>
            <a:custGeom>
              <a:avLst/>
              <a:gdLst>
                <a:gd name="csX0" fmla="*/ -3374 w 215042"/>
                <a:gd name="csY0" fmla="*/ 146952 h 146733"/>
                <a:gd name="csX1" fmla="*/ 211668 w 215042"/>
                <a:gd name="csY1" fmla="*/ 218 h 146733"/>
              </a:gdLst>
              <a:ahLst/>
              <a:cxnLst>
                <a:cxn ang="0">
                  <a:pos x="csX0" y="csY0"/>
                </a:cxn>
                <a:cxn ang="0">
                  <a:pos x="csX1" y="csY1"/>
                </a:cxn>
              </a:cxnLst>
              <a:rect l="l" t="t" r="r" b="b"/>
              <a:pathLst>
                <a:path w="215042" h="146733">
                  <a:moveTo>
                    <a:pt x="-3374" y="146952"/>
                  </a:moveTo>
                  <a:lnTo>
                    <a:pt x="211668" y="218"/>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4" name="フリーフォーム: 図形 323">
              <a:extLst>
                <a:ext uri="{FF2B5EF4-FFF2-40B4-BE49-F238E27FC236}">
                  <a16:creationId xmlns:a16="http://schemas.microsoft.com/office/drawing/2014/main" id="{42E927F2-E1C2-F33E-F869-5F67E29D7DCC}"/>
                </a:ext>
              </a:extLst>
            </p:cNvPr>
            <p:cNvSpPr/>
            <p:nvPr/>
          </p:nvSpPr>
          <p:spPr>
            <a:xfrm>
              <a:off x="3107174" y="5285385"/>
              <a:ext cx="316130" cy="123406"/>
            </a:xfrm>
            <a:custGeom>
              <a:avLst/>
              <a:gdLst>
                <a:gd name="csX0" fmla="*/ 312770 w 316130"/>
                <a:gd name="csY0" fmla="*/ 123668 h 123406"/>
                <a:gd name="csX1" fmla="*/ -3360 w 316130"/>
                <a:gd name="csY1" fmla="*/ 262 h 123406"/>
              </a:gdLst>
              <a:ahLst/>
              <a:cxnLst>
                <a:cxn ang="0">
                  <a:pos x="csX0" y="csY0"/>
                </a:cxn>
                <a:cxn ang="0">
                  <a:pos x="csX1" y="csY1"/>
                </a:cxn>
              </a:cxnLst>
              <a:rect l="l" t="t" r="r" b="b"/>
              <a:pathLst>
                <a:path w="316130" h="123406">
                  <a:moveTo>
                    <a:pt x="312770" y="123668"/>
                  </a:moveTo>
                  <a:lnTo>
                    <a:pt x="-3360" y="262"/>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5" name="フリーフォーム: 図形 324">
              <a:extLst>
                <a:ext uri="{FF2B5EF4-FFF2-40B4-BE49-F238E27FC236}">
                  <a16:creationId xmlns:a16="http://schemas.microsoft.com/office/drawing/2014/main" id="{A17E0D7D-1E1D-B7E4-2C86-7CD4B7676A0F}"/>
                </a:ext>
              </a:extLst>
            </p:cNvPr>
            <p:cNvSpPr/>
            <p:nvPr/>
          </p:nvSpPr>
          <p:spPr>
            <a:xfrm rot="1279435">
              <a:off x="3423103" y="5403963"/>
              <a:ext cx="5900" cy="11801"/>
            </a:xfrm>
            <a:custGeom>
              <a:avLst/>
              <a:gdLst>
                <a:gd name="csX0" fmla="*/ 206 w 5900"/>
                <a:gd name="csY0" fmla="*/ 12074 h 11801"/>
                <a:gd name="csX1" fmla="*/ 6106 w 5900"/>
                <a:gd name="csY1" fmla="*/ 6173 h 11801"/>
                <a:gd name="csX2" fmla="*/ 206 w 5900"/>
                <a:gd name="csY2" fmla="*/ 273 h 11801"/>
              </a:gdLst>
              <a:ahLst/>
              <a:cxnLst>
                <a:cxn ang="0">
                  <a:pos x="csX0" y="csY0"/>
                </a:cxn>
                <a:cxn ang="0">
                  <a:pos x="csX1" y="csY1"/>
                </a:cxn>
                <a:cxn ang="0">
                  <a:pos x="csX2" y="csY2"/>
                </a:cxn>
              </a:cxnLst>
              <a:rect l="l" t="t" r="r" b="b"/>
              <a:pathLst>
                <a:path w="5900" h="11801">
                  <a:moveTo>
                    <a:pt x="206" y="12074"/>
                  </a:moveTo>
                  <a:cubicBezTo>
                    <a:pt x="3465" y="12074"/>
                    <a:pt x="6106" y="9432"/>
                    <a:pt x="6106" y="6173"/>
                  </a:cubicBezTo>
                  <a:cubicBezTo>
                    <a:pt x="6106" y="2915"/>
                    <a:pt x="3465" y="273"/>
                    <a:pt x="206" y="273"/>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6" name="フリーフォーム: 図形 325">
              <a:extLst>
                <a:ext uri="{FF2B5EF4-FFF2-40B4-BE49-F238E27FC236}">
                  <a16:creationId xmlns:a16="http://schemas.microsoft.com/office/drawing/2014/main" id="{27484D7D-7BD9-FF03-A152-AE03C01557AC}"/>
                </a:ext>
              </a:extLst>
            </p:cNvPr>
            <p:cNvSpPr/>
            <p:nvPr/>
          </p:nvSpPr>
          <p:spPr>
            <a:xfrm rot="12079435">
              <a:off x="3057025" y="5262962"/>
              <a:ext cx="51926" cy="25963"/>
            </a:xfrm>
            <a:custGeom>
              <a:avLst/>
              <a:gdLst>
                <a:gd name="csX0" fmla="*/ 141 w 51926"/>
                <a:gd name="csY0" fmla="*/ 247 h 25963"/>
                <a:gd name="csX1" fmla="*/ 52067 w 51926"/>
                <a:gd name="csY1" fmla="*/ 13228 h 25963"/>
                <a:gd name="csX2" fmla="*/ 141 w 51926"/>
                <a:gd name="csY2" fmla="*/ 26210 h 25963"/>
              </a:gdLst>
              <a:ahLst/>
              <a:cxnLst>
                <a:cxn ang="0">
                  <a:pos x="csX0" y="csY0"/>
                </a:cxn>
                <a:cxn ang="0">
                  <a:pos x="csX1" y="csY1"/>
                </a:cxn>
                <a:cxn ang="0">
                  <a:pos x="csX2" y="csY2"/>
                </a:cxn>
              </a:cxnLst>
              <a:rect l="l" t="t" r="r" b="b"/>
              <a:pathLst>
                <a:path w="51926" h="25963">
                  <a:moveTo>
                    <a:pt x="141" y="247"/>
                  </a:moveTo>
                  <a:cubicBezTo>
                    <a:pt x="17450" y="8901"/>
                    <a:pt x="34758" y="13228"/>
                    <a:pt x="52067" y="13228"/>
                  </a:cubicBezTo>
                  <a:cubicBezTo>
                    <a:pt x="34758" y="13228"/>
                    <a:pt x="17450" y="17556"/>
                    <a:pt x="141" y="26210"/>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7" name="フリーフォーム: 図形 326">
              <a:extLst>
                <a:ext uri="{FF2B5EF4-FFF2-40B4-BE49-F238E27FC236}">
                  <a16:creationId xmlns:a16="http://schemas.microsoft.com/office/drawing/2014/main" id="{D5CC26C9-EC64-10D1-549B-E7ED25D0B4FC}"/>
                </a:ext>
              </a:extLst>
            </p:cNvPr>
            <p:cNvSpPr/>
            <p:nvPr/>
          </p:nvSpPr>
          <p:spPr>
            <a:xfrm>
              <a:off x="3267654" y="5213213"/>
              <a:ext cx="173033" cy="178196"/>
            </a:xfrm>
            <a:custGeom>
              <a:avLst/>
              <a:gdLst>
                <a:gd name="csX0" fmla="*/ 169652 w 173033"/>
                <a:gd name="csY0" fmla="*/ 178469 h 178196"/>
                <a:gd name="csX1" fmla="*/ -3381 w 173033"/>
                <a:gd name="csY1" fmla="*/ 272 h 178196"/>
              </a:gdLst>
              <a:ahLst/>
              <a:cxnLst>
                <a:cxn ang="0">
                  <a:pos x="csX0" y="csY0"/>
                </a:cxn>
                <a:cxn ang="0">
                  <a:pos x="csX1" y="csY1"/>
                </a:cxn>
              </a:cxnLst>
              <a:rect l="l" t="t" r="r" b="b"/>
              <a:pathLst>
                <a:path w="173033" h="178196">
                  <a:moveTo>
                    <a:pt x="169652" y="178469"/>
                  </a:moveTo>
                  <a:lnTo>
                    <a:pt x="-3381" y="272"/>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8" name="フリーフォーム: 図形 327">
              <a:extLst>
                <a:ext uri="{FF2B5EF4-FFF2-40B4-BE49-F238E27FC236}">
                  <a16:creationId xmlns:a16="http://schemas.microsoft.com/office/drawing/2014/main" id="{B0294B24-C2FB-DCA1-649F-A12ECF99C9C8}"/>
                </a:ext>
              </a:extLst>
            </p:cNvPr>
            <p:cNvSpPr/>
            <p:nvPr/>
          </p:nvSpPr>
          <p:spPr>
            <a:xfrm rot="2750537">
              <a:off x="3439792" y="5387625"/>
              <a:ext cx="5900" cy="11801"/>
            </a:xfrm>
            <a:custGeom>
              <a:avLst/>
              <a:gdLst>
                <a:gd name="csX0" fmla="*/ 209 w 5900"/>
                <a:gd name="csY0" fmla="*/ 12071 h 11801"/>
                <a:gd name="csX1" fmla="*/ 6110 w 5900"/>
                <a:gd name="csY1" fmla="*/ 6170 h 11801"/>
                <a:gd name="csX2" fmla="*/ 209 w 5900"/>
                <a:gd name="csY2" fmla="*/ 270 h 11801"/>
              </a:gdLst>
              <a:ahLst/>
              <a:cxnLst>
                <a:cxn ang="0">
                  <a:pos x="csX0" y="csY0"/>
                </a:cxn>
                <a:cxn ang="0">
                  <a:pos x="csX1" y="csY1"/>
                </a:cxn>
                <a:cxn ang="0">
                  <a:pos x="csX2" y="csY2"/>
                </a:cxn>
              </a:cxnLst>
              <a:rect l="l" t="t" r="r" b="b"/>
              <a:pathLst>
                <a:path w="5900" h="11801">
                  <a:moveTo>
                    <a:pt x="209" y="12071"/>
                  </a:moveTo>
                  <a:cubicBezTo>
                    <a:pt x="3468" y="12071"/>
                    <a:pt x="6110" y="9429"/>
                    <a:pt x="6110" y="6170"/>
                  </a:cubicBezTo>
                  <a:cubicBezTo>
                    <a:pt x="6110" y="2911"/>
                    <a:pt x="3468" y="270"/>
                    <a:pt x="209" y="270"/>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29" name="フリーフォーム: 図形 328">
              <a:extLst>
                <a:ext uri="{FF2B5EF4-FFF2-40B4-BE49-F238E27FC236}">
                  <a16:creationId xmlns:a16="http://schemas.microsoft.com/office/drawing/2014/main" id="{E056C8AF-19F7-6966-0C9A-5EBF12DF6290}"/>
                </a:ext>
              </a:extLst>
            </p:cNvPr>
            <p:cNvSpPr/>
            <p:nvPr/>
          </p:nvSpPr>
          <p:spPr>
            <a:xfrm rot="13550537">
              <a:off x="3223603" y="5181605"/>
              <a:ext cx="51926" cy="25963"/>
            </a:xfrm>
            <a:custGeom>
              <a:avLst/>
              <a:gdLst>
                <a:gd name="csX0" fmla="*/ 173 w 51926"/>
                <a:gd name="csY0" fmla="*/ 231 h 25963"/>
                <a:gd name="csX1" fmla="*/ 52100 w 51926"/>
                <a:gd name="csY1" fmla="*/ 13213 h 25963"/>
                <a:gd name="csX2" fmla="*/ 173 w 51926"/>
                <a:gd name="csY2" fmla="*/ 26194 h 25963"/>
              </a:gdLst>
              <a:ahLst/>
              <a:cxnLst>
                <a:cxn ang="0">
                  <a:pos x="csX0" y="csY0"/>
                </a:cxn>
                <a:cxn ang="0">
                  <a:pos x="csX1" y="csY1"/>
                </a:cxn>
                <a:cxn ang="0">
                  <a:pos x="csX2" y="csY2"/>
                </a:cxn>
              </a:cxnLst>
              <a:rect l="l" t="t" r="r" b="b"/>
              <a:pathLst>
                <a:path w="51926" h="25963">
                  <a:moveTo>
                    <a:pt x="173" y="231"/>
                  </a:moveTo>
                  <a:cubicBezTo>
                    <a:pt x="17482" y="8886"/>
                    <a:pt x="34791" y="13213"/>
                    <a:pt x="52100" y="13213"/>
                  </a:cubicBezTo>
                  <a:cubicBezTo>
                    <a:pt x="34791" y="13213"/>
                    <a:pt x="17482" y="17540"/>
                    <a:pt x="173" y="26194"/>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0" name="フリーフォーム: 図形 329">
              <a:extLst>
                <a:ext uri="{FF2B5EF4-FFF2-40B4-BE49-F238E27FC236}">
                  <a16:creationId xmlns:a16="http://schemas.microsoft.com/office/drawing/2014/main" id="{FEB78307-81AD-ABE8-90D5-AF5C85A59A5C}"/>
                </a:ext>
              </a:extLst>
            </p:cNvPr>
            <p:cNvSpPr/>
            <p:nvPr/>
          </p:nvSpPr>
          <p:spPr>
            <a:xfrm>
              <a:off x="3288636" y="5478650"/>
              <a:ext cx="161453" cy="274822"/>
            </a:xfrm>
            <a:custGeom>
              <a:avLst/>
              <a:gdLst>
                <a:gd name="csX0" fmla="*/ 158069 w 161453"/>
                <a:gd name="csY0" fmla="*/ 199 h 274822"/>
                <a:gd name="csX1" fmla="*/ -3384 w 161453"/>
                <a:gd name="csY1" fmla="*/ 275022 h 274822"/>
              </a:gdLst>
              <a:ahLst/>
              <a:cxnLst>
                <a:cxn ang="0">
                  <a:pos x="csX0" y="csY0"/>
                </a:cxn>
                <a:cxn ang="0">
                  <a:pos x="csX1" y="csY1"/>
                </a:cxn>
              </a:cxnLst>
              <a:rect l="l" t="t" r="r" b="b"/>
              <a:pathLst>
                <a:path w="161453" h="274822">
                  <a:moveTo>
                    <a:pt x="158069" y="199"/>
                  </a:moveTo>
                  <a:lnTo>
                    <a:pt x="-3384" y="275022"/>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1" name="フリーフォーム: 図形 330">
              <a:extLst>
                <a:ext uri="{FF2B5EF4-FFF2-40B4-BE49-F238E27FC236}">
                  <a16:creationId xmlns:a16="http://schemas.microsoft.com/office/drawing/2014/main" id="{A6821686-98CF-349D-E112-DAA6A2F15C5E}"/>
                </a:ext>
              </a:extLst>
            </p:cNvPr>
            <p:cNvSpPr/>
            <p:nvPr/>
          </p:nvSpPr>
          <p:spPr>
            <a:xfrm rot="18026007">
              <a:off x="3448634" y="5470205"/>
              <a:ext cx="5900" cy="11801"/>
            </a:xfrm>
            <a:custGeom>
              <a:avLst/>
              <a:gdLst>
                <a:gd name="csX0" fmla="*/ 211 w 5900"/>
                <a:gd name="csY0" fmla="*/ 12087 h 11801"/>
                <a:gd name="csX1" fmla="*/ 6111 w 5900"/>
                <a:gd name="csY1" fmla="*/ 6186 h 11801"/>
                <a:gd name="csX2" fmla="*/ 211 w 5900"/>
                <a:gd name="csY2" fmla="*/ 285 h 11801"/>
              </a:gdLst>
              <a:ahLst/>
              <a:cxnLst>
                <a:cxn ang="0">
                  <a:pos x="csX0" y="csY0"/>
                </a:cxn>
                <a:cxn ang="0">
                  <a:pos x="csX1" y="csY1"/>
                </a:cxn>
                <a:cxn ang="0">
                  <a:pos x="csX2" y="csY2"/>
                </a:cxn>
              </a:cxnLst>
              <a:rect l="l" t="t" r="r" b="b"/>
              <a:pathLst>
                <a:path w="5900" h="11801">
                  <a:moveTo>
                    <a:pt x="211" y="12087"/>
                  </a:moveTo>
                  <a:cubicBezTo>
                    <a:pt x="3469" y="12087"/>
                    <a:pt x="6111" y="9445"/>
                    <a:pt x="6111" y="6186"/>
                  </a:cubicBezTo>
                  <a:cubicBezTo>
                    <a:pt x="6111" y="2927"/>
                    <a:pt x="3469" y="285"/>
                    <a:pt x="211" y="285"/>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2" name="フリーフォーム: 図形 331">
              <a:extLst>
                <a:ext uri="{FF2B5EF4-FFF2-40B4-BE49-F238E27FC236}">
                  <a16:creationId xmlns:a16="http://schemas.microsoft.com/office/drawing/2014/main" id="{61E6A114-9654-8152-5804-3DFDAA617214}"/>
                </a:ext>
              </a:extLst>
            </p:cNvPr>
            <p:cNvSpPr/>
            <p:nvPr/>
          </p:nvSpPr>
          <p:spPr>
            <a:xfrm rot="7226007">
              <a:off x="3249521" y="5762877"/>
              <a:ext cx="51926" cy="25963"/>
            </a:xfrm>
            <a:custGeom>
              <a:avLst/>
              <a:gdLst>
                <a:gd name="csX0" fmla="*/ 178 w 51926"/>
                <a:gd name="csY0" fmla="*/ 343 h 25963"/>
                <a:gd name="csX1" fmla="*/ 52104 w 51926"/>
                <a:gd name="csY1" fmla="*/ 13325 h 25963"/>
                <a:gd name="csX2" fmla="*/ 178 w 51926"/>
                <a:gd name="csY2" fmla="*/ 26307 h 25963"/>
              </a:gdLst>
              <a:ahLst/>
              <a:cxnLst>
                <a:cxn ang="0">
                  <a:pos x="csX0" y="csY0"/>
                </a:cxn>
                <a:cxn ang="0">
                  <a:pos x="csX1" y="csY1"/>
                </a:cxn>
                <a:cxn ang="0">
                  <a:pos x="csX2" y="csY2"/>
                </a:cxn>
              </a:cxnLst>
              <a:rect l="l" t="t" r="r" b="b"/>
              <a:pathLst>
                <a:path w="51926" h="25963">
                  <a:moveTo>
                    <a:pt x="178" y="343"/>
                  </a:moveTo>
                  <a:cubicBezTo>
                    <a:pt x="17487" y="8998"/>
                    <a:pt x="34796" y="13325"/>
                    <a:pt x="52104" y="13325"/>
                  </a:cubicBezTo>
                  <a:cubicBezTo>
                    <a:pt x="34796" y="13325"/>
                    <a:pt x="17487" y="17652"/>
                    <a:pt x="178" y="26307"/>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3" name="フリーフォーム: 図形 332">
              <a:extLst>
                <a:ext uri="{FF2B5EF4-FFF2-40B4-BE49-F238E27FC236}">
                  <a16:creationId xmlns:a16="http://schemas.microsoft.com/office/drawing/2014/main" id="{D6C583EA-7AF9-42BA-6F0F-2CDF46927CCD}"/>
                </a:ext>
              </a:extLst>
            </p:cNvPr>
            <p:cNvSpPr/>
            <p:nvPr/>
          </p:nvSpPr>
          <p:spPr>
            <a:xfrm>
              <a:off x="3541708" y="5516399"/>
              <a:ext cx="211145" cy="287413"/>
            </a:xfrm>
            <a:custGeom>
              <a:avLst/>
              <a:gdLst>
                <a:gd name="csX0" fmla="*/ 207697 w 211145"/>
                <a:gd name="csY0" fmla="*/ 287603 h 287413"/>
                <a:gd name="csX1" fmla="*/ -3449 w 211145"/>
                <a:gd name="csY1" fmla="*/ 189 h 287413"/>
              </a:gdLst>
              <a:ahLst/>
              <a:cxnLst>
                <a:cxn ang="0">
                  <a:pos x="csX0" y="csY0"/>
                </a:cxn>
                <a:cxn ang="0">
                  <a:pos x="csX1" y="csY1"/>
                </a:cxn>
              </a:cxnLst>
              <a:rect l="l" t="t" r="r" b="b"/>
              <a:pathLst>
                <a:path w="211145" h="287413">
                  <a:moveTo>
                    <a:pt x="207697" y="287603"/>
                  </a:moveTo>
                  <a:lnTo>
                    <a:pt x="-3449" y="189"/>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4" name="フリーフォーム: 図形 333">
              <a:extLst>
                <a:ext uri="{FF2B5EF4-FFF2-40B4-BE49-F238E27FC236}">
                  <a16:creationId xmlns:a16="http://schemas.microsoft.com/office/drawing/2014/main" id="{DA8496B2-92B1-ABBA-A99A-FED21ABCBD8E}"/>
                </a:ext>
              </a:extLst>
            </p:cNvPr>
            <p:cNvSpPr/>
            <p:nvPr/>
          </p:nvSpPr>
          <p:spPr>
            <a:xfrm rot="3221860">
              <a:off x="3751649" y="5800289"/>
              <a:ext cx="5900" cy="11801"/>
            </a:xfrm>
            <a:custGeom>
              <a:avLst/>
              <a:gdLst>
                <a:gd name="csX0" fmla="*/ 269 w 5900"/>
                <a:gd name="csY0" fmla="*/ 12151 h 11801"/>
                <a:gd name="csX1" fmla="*/ 6170 w 5900"/>
                <a:gd name="csY1" fmla="*/ 6250 h 11801"/>
                <a:gd name="csX2" fmla="*/ 269 w 5900"/>
                <a:gd name="csY2" fmla="*/ 349 h 11801"/>
              </a:gdLst>
              <a:ahLst/>
              <a:cxnLst>
                <a:cxn ang="0">
                  <a:pos x="csX0" y="csY0"/>
                </a:cxn>
                <a:cxn ang="0">
                  <a:pos x="csX1" y="csY1"/>
                </a:cxn>
                <a:cxn ang="0">
                  <a:pos x="csX2" y="csY2"/>
                </a:cxn>
              </a:cxnLst>
              <a:rect l="l" t="t" r="r" b="b"/>
              <a:pathLst>
                <a:path w="5900" h="11801">
                  <a:moveTo>
                    <a:pt x="269" y="12151"/>
                  </a:moveTo>
                  <a:cubicBezTo>
                    <a:pt x="3528" y="12151"/>
                    <a:pt x="6170" y="9509"/>
                    <a:pt x="6170" y="6250"/>
                  </a:cubicBezTo>
                  <a:cubicBezTo>
                    <a:pt x="6170" y="2991"/>
                    <a:pt x="3528" y="349"/>
                    <a:pt x="269" y="349"/>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5" name="フリーフォーム: 図形 334">
              <a:extLst>
                <a:ext uri="{FF2B5EF4-FFF2-40B4-BE49-F238E27FC236}">
                  <a16:creationId xmlns:a16="http://schemas.microsoft.com/office/drawing/2014/main" id="{2BF2879F-F5FF-7709-3FCB-CC3A26AE5B15}"/>
                </a:ext>
              </a:extLst>
            </p:cNvPr>
            <p:cNvSpPr/>
            <p:nvPr/>
          </p:nvSpPr>
          <p:spPr>
            <a:xfrm rot="14021860">
              <a:off x="3500373" y="5482493"/>
              <a:ext cx="51926" cy="25963"/>
            </a:xfrm>
            <a:custGeom>
              <a:avLst/>
              <a:gdLst>
                <a:gd name="csX0" fmla="*/ 226 w 51926"/>
                <a:gd name="csY0" fmla="*/ 289 h 25963"/>
                <a:gd name="csX1" fmla="*/ 52153 w 51926"/>
                <a:gd name="csY1" fmla="*/ 13271 h 25963"/>
                <a:gd name="csX2" fmla="*/ 226 w 51926"/>
                <a:gd name="csY2" fmla="*/ 26252 h 25963"/>
              </a:gdLst>
              <a:ahLst/>
              <a:cxnLst>
                <a:cxn ang="0">
                  <a:pos x="csX0" y="csY0"/>
                </a:cxn>
                <a:cxn ang="0">
                  <a:pos x="csX1" y="csY1"/>
                </a:cxn>
                <a:cxn ang="0">
                  <a:pos x="csX2" y="csY2"/>
                </a:cxn>
              </a:cxnLst>
              <a:rect l="l" t="t" r="r" b="b"/>
              <a:pathLst>
                <a:path w="51926" h="25963">
                  <a:moveTo>
                    <a:pt x="226" y="289"/>
                  </a:moveTo>
                  <a:cubicBezTo>
                    <a:pt x="17535" y="8944"/>
                    <a:pt x="34844" y="13271"/>
                    <a:pt x="52153" y="13271"/>
                  </a:cubicBezTo>
                  <a:cubicBezTo>
                    <a:pt x="34844" y="13271"/>
                    <a:pt x="17535" y="17598"/>
                    <a:pt x="226" y="26252"/>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6" name="フリーフォーム: 図形 335">
              <a:extLst>
                <a:ext uri="{FF2B5EF4-FFF2-40B4-BE49-F238E27FC236}">
                  <a16:creationId xmlns:a16="http://schemas.microsoft.com/office/drawing/2014/main" id="{F2055CEF-0466-9162-94FC-82EB2333D45B}"/>
                </a:ext>
              </a:extLst>
            </p:cNvPr>
            <p:cNvSpPr/>
            <p:nvPr/>
          </p:nvSpPr>
          <p:spPr>
            <a:xfrm>
              <a:off x="3450567" y="5268634"/>
              <a:ext cx="16618" cy="96277"/>
            </a:xfrm>
            <a:custGeom>
              <a:avLst/>
              <a:gdLst>
                <a:gd name="csX0" fmla="*/ 13214 w 16618"/>
                <a:gd name="csY0" fmla="*/ 96546 h 96277"/>
                <a:gd name="csX1" fmla="*/ -3405 w 16618"/>
                <a:gd name="csY1" fmla="*/ 269 h 96277"/>
              </a:gdLst>
              <a:ahLst/>
              <a:cxnLst>
                <a:cxn ang="0">
                  <a:pos x="csX0" y="csY0"/>
                </a:cxn>
                <a:cxn ang="0">
                  <a:pos x="csX1" y="csY1"/>
                </a:cxn>
              </a:cxnLst>
              <a:rect l="l" t="t" r="r" b="b"/>
              <a:pathLst>
                <a:path w="16618" h="96277">
                  <a:moveTo>
                    <a:pt x="13214" y="96546"/>
                  </a:moveTo>
                  <a:lnTo>
                    <a:pt x="-3405" y="269"/>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7" name="フリーフォーム: 図形 336">
              <a:extLst>
                <a:ext uri="{FF2B5EF4-FFF2-40B4-BE49-F238E27FC236}">
                  <a16:creationId xmlns:a16="http://schemas.microsoft.com/office/drawing/2014/main" id="{C782854D-5683-FBA2-DE50-C2899FF0E1F1}"/>
                </a:ext>
              </a:extLst>
            </p:cNvPr>
            <p:cNvSpPr/>
            <p:nvPr/>
          </p:nvSpPr>
          <p:spPr>
            <a:xfrm rot="4812383">
              <a:off x="3464737" y="5361918"/>
              <a:ext cx="5900" cy="11801"/>
            </a:xfrm>
            <a:custGeom>
              <a:avLst/>
              <a:gdLst>
                <a:gd name="csX0" fmla="*/ 214 w 5900"/>
                <a:gd name="csY0" fmla="*/ 12066 h 11801"/>
                <a:gd name="csX1" fmla="*/ 6114 w 5900"/>
                <a:gd name="csY1" fmla="*/ 6165 h 11801"/>
                <a:gd name="csX2" fmla="*/ 214 w 5900"/>
                <a:gd name="csY2" fmla="*/ 265 h 11801"/>
              </a:gdLst>
              <a:ahLst/>
              <a:cxnLst>
                <a:cxn ang="0">
                  <a:pos x="csX0" y="csY0"/>
                </a:cxn>
                <a:cxn ang="0">
                  <a:pos x="csX1" y="csY1"/>
                </a:cxn>
                <a:cxn ang="0">
                  <a:pos x="csX2" y="csY2"/>
                </a:cxn>
              </a:cxnLst>
              <a:rect l="l" t="t" r="r" b="b"/>
              <a:pathLst>
                <a:path w="5900" h="11801">
                  <a:moveTo>
                    <a:pt x="214" y="12066"/>
                  </a:moveTo>
                  <a:cubicBezTo>
                    <a:pt x="3473" y="12066"/>
                    <a:pt x="6114" y="9424"/>
                    <a:pt x="6114" y="6165"/>
                  </a:cubicBezTo>
                  <a:cubicBezTo>
                    <a:pt x="6114" y="2906"/>
                    <a:pt x="3473" y="265"/>
                    <a:pt x="214" y="265"/>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8" name="フリーフォーム: 図形 337">
              <a:extLst>
                <a:ext uri="{FF2B5EF4-FFF2-40B4-BE49-F238E27FC236}">
                  <a16:creationId xmlns:a16="http://schemas.microsoft.com/office/drawing/2014/main" id="{A1C52168-B0E7-0A8E-2C61-8CA453073260}"/>
                </a:ext>
              </a:extLst>
            </p:cNvPr>
            <p:cNvSpPr/>
            <p:nvPr/>
          </p:nvSpPr>
          <p:spPr>
            <a:xfrm rot="15612383">
              <a:off x="3420187" y="5230067"/>
              <a:ext cx="51926" cy="25963"/>
            </a:xfrm>
            <a:custGeom>
              <a:avLst/>
              <a:gdLst>
                <a:gd name="csX0" fmla="*/ 211 w 51926"/>
                <a:gd name="csY0" fmla="*/ 240 h 25963"/>
                <a:gd name="csX1" fmla="*/ 52137 w 51926"/>
                <a:gd name="csY1" fmla="*/ 13222 h 25963"/>
                <a:gd name="csX2" fmla="*/ 211 w 51926"/>
                <a:gd name="csY2" fmla="*/ 26204 h 25963"/>
              </a:gdLst>
              <a:ahLst/>
              <a:cxnLst>
                <a:cxn ang="0">
                  <a:pos x="csX0" y="csY0"/>
                </a:cxn>
                <a:cxn ang="0">
                  <a:pos x="csX1" y="csY1"/>
                </a:cxn>
                <a:cxn ang="0">
                  <a:pos x="csX2" y="csY2"/>
                </a:cxn>
              </a:cxnLst>
              <a:rect l="l" t="t" r="r" b="b"/>
              <a:pathLst>
                <a:path w="51926" h="25963">
                  <a:moveTo>
                    <a:pt x="211" y="240"/>
                  </a:moveTo>
                  <a:cubicBezTo>
                    <a:pt x="17520" y="8895"/>
                    <a:pt x="34829" y="13222"/>
                    <a:pt x="52137" y="13222"/>
                  </a:cubicBezTo>
                  <a:cubicBezTo>
                    <a:pt x="34829" y="13222"/>
                    <a:pt x="17520" y="17549"/>
                    <a:pt x="211" y="26204"/>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39" name="フリーフォーム: 図形 338">
              <a:extLst>
                <a:ext uri="{FF2B5EF4-FFF2-40B4-BE49-F238E27FC236}">
                  <a16:creationId xmlns:a16="http://schemas.microsoft.com/office/drawing/2014/main" id="{006BEE9E-E2F7-37DC-ED3F-4C959A546671}"/>
                </a:ext>
              </a:extLst>
            </p:cNvPr>
            <p:cNvSpPr/>
            <p:nvPr/>
          </p:nvSpPr>
          <p:spPr>
            <a:xfrm>
              <a:off x="3527591" y="5457925"/>
              <a:ext cx="442021" cy="248364"/>
            </a:xfrm>
            <a:custGeom>
              <a:avLst/>
              <a:gdLst>
                <a:gd name="csX0" fmla="*/ -3472 w 442021"/>
                <a:gd name="csY0" fmla="*/ 207 h 248364"/>
                <a:gd name="csX1" fmla="*/ 438550 w 442021"/>
                <a:gd name="csY1" fmla="*/ 248572 h 248364"/>
              </a:gdLst>
              <a:ahLst/>
              <a:cxnLst>
                <a:cxn ang="0">
                  <a:pos x="csX0" y="csY0"/>
                </a:cxn>
                <a:cxn ang="0">
                  <a:pos x="csX1" y="csY1"/>
                </a:cxn>
              </a:cxnLst>
              <a:rect l="l" t="t" r="r" b="b"/>
              <a:pathLst>
                <a:path w="442021" h="248364">
                  <a:moveTo>
                    <a:pt x="-3472" y="207"/>
                  </a:moveTo>
                  <a:lnTo>
                    <a:pt x="438550" y="248572"/>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0" name="フリーフォーム: 図形 339">
              <a:extLst>
                <a:ext uri="{FF2B5EF4-FFF2-40B4-BE49-F238E27FC236}">
                  <a16:creationId xmlns:a16="http://schemas.microsoft.com/office/drawing/2014/main" id="{A99EA259-7777-8F52-4E61-C2A96FB4EB11}"/>
                </a:ext>
              </a:extLst>
            </p:cNvPr>
            <p:cNvSpPr/>
            <p:nvPr/>
          </p:nvSpPr>
          <p:spPr>
            <a:xfrm rot="12559853">
              <a:off x="3522069" y="5450579"/>
              <a:ext cx="5900" cy="11801"/>
            </a:xfrm>
            <a:custGeom>
              <a:avLst/>
              <a:gdLst>
                <a:gd name="csX0" fmla="*/ 225 w 5900"/>
                <a:gd name="csY0" fmla="*/ 12083 h 11801"/>
                <a:gd name="csX1" fmla="*/ 6125 w 5900"/>
                <a:gd name="csY1" fmla="*/ 6182 h 11801"/>
                <a:gd name="csX2" fmla="*/ 225 w 5900"/>
                <a:gd name="csY2" fmla="*/ 282 h 11801"/>
              </a:gdLst>
              <a:ahLst/>
              <a:cxnLst>
                <a:cxn ang="0">
                  <a:pos x="csX0" y="csY0"/>
                </a:cxn>
                <a:cxn ang="0">
                  <a:pos x="csX1" y="csY1"/>
                </a:cxn>
                <a:cxn ang="0">
                  <a:pos x="csX2" y="csY2"/>
                </a:cxn>
              </a:cxnLst>
              <a:rect l="l" t="t" r="r" b="b"/>
              <a:pathLst>
                <a:path w="5900" h="11801">
                  <a:moveTo>
                    <a:pt x="225" y="12083"/>
                  </a:moveTo>
                  <a:cubicBezTo>
                    <a:pt x="3484" y="12083"/>
                    <a:pt x="6125" y="9441"/>
                    <a:pt x="6125" y="6182"/>
                  </a:cubicBezTo>
                  <a:cubicBezTo>
                    <a:pt x="6125" y="2923"/>
                    <a:pt x="3484" y="282"/>
                    <a:pt x="225" y="282"/>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1" name="フリーフォーム: 図形 340">
              <a:extLst>
                <a:ext uri="{FF2B5EF4-FFF2-40B4-BE49-F238E27FC236}">
                  <a16:creationId xmlns:a16="http://schemas.microsoft.com/office/drawing/2014/main" id="{CDB06317-9C7D-DA94-6EC6-B707DA06DCCC}"/>
                </a:ext>
              </a:extLst>
            </p:cNvPr>
            <p:cNvSpPr/>
            <p:nvPr/>
          </p:nvSpPr>
          <p:spPr>
            <a:xfrm rot="1759853">
              <a:off x="3954298" y="5695138"/>
              <a:ext cx="54000" cy="36000"/>
            </a:xfrm>
            <a:custGeom>
              <a:avLst/>
              <a:gdLst>
                <a:gd name="csX0" fmla="*/ 316 w 51926"/>
                <a:gd name="csY0" fmla="*/ 332 h 25963"/>
                <a:gd name="csX1" fmla="*/ 52243 w 51926"/>
                <a:gd name="csY1" fmla="*/ 13314 h 25963"/>
                <a:gd name="csX2" fmla="*/ 316 w 51926"/>
                <a:gd name="csY2" fmla="*/ 26296 h 25963"/>
              </a:gdLst>
              <a:ahLst/>
              <a:cxnLst>
                <a:cxn ang="0">
                  <a:pos x="csX0" y="csY0"/>
                </a:cxn>
                <a:cxn ang="0">
                  <a:pos x="csX1" y="csY1"/>
                </a:cxn>
                <a:cxn ang="0">
                  <a:pos x="csX2" y="csY2"/>
                </a:cxn>
              </a:cxnLst>
              <a:rect l="l" t="t" r="r" b="b"/>
              <a:pathLst>
                <a:path w="51926" h="25963">
                  <a:moveTo>
                    <a:pt x="316" y="332"/>
                  </a:moveTo>
                  <a:cubicBezTo>
                    <a:pt x="17625" y="8987"/>
                    <a:pt x="34934" y="13314"/>
                    <a:pt x="52243" y="13314"/>
                  </a:cubicBezTo>
                  <a:cubicBezTo>
                    <a:pt x="34934" y="13314"/>
                    <a:pt x="17625" y="17641"/>
                    <a:pt x="316" y="26296"/>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2" name="フリーフォーム: 図形 341">
              <a:extLst>
                <a:ext uri="{FF2B5EF4-FFF2-40B4-BE49-F238E27FC236}">
                  <a16:creationId xmlns:a16="http://schemas.microsoft.com/office/drawing/2014/main" id="{01469DED-90E6-8157-E79B-95437032209E}"/>
                </a:ext>
              </a:extLst>
            </p:cNvPr>
            <p:cNvSpPr/>
            <p:nvPr/>
          </p:nvSpPr>
          <p:spPr>
            <a:xfrm>
              <a:off x="3546613" y="5438903"/>
              <a:ext cx="206990" cy="26049"/>
            </a:xfrm>
            <a:custGeom>
              <a:avLst/>
              <a:gdLst>
                <a:gd name="csX0" fmla="*/ -3449 w 206990"/>
                <a:gd name="csY0" fmla="*/ 237 h 26049"/>
                <a:gd name="csX1" fmla="*/ 203541 w 206990"/>
                <a:gd name="csY1" fmla="*/ 26286 h 26049"/>
              </a:gdLst>
              <a:ahLst/>
              <a:cxnLst>
                <a:cxn ang="0">
                  <a:pos x="csX0" y="csY0"/>
                </a:cxn>
                <a:cxn ang="0">
                  <a:pos x="csX1" y="csY1"/>
                </a:cxn>
              </a:cxnLst>
              <a:rect l="l" t="t" r="r" b="b"/>
              <a:pathLst>
                <a:path w="206990" h="26049">
                  <a:moveTo>
                    <a:pt x="-3449" y="237"/>
                  </a:moveTo>
                  <a:lnTo>
                    <a:pt x="203541" y="26286"/>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3" name="フリーフォーム: 図形 342">
              <a:extLst>
                <a:ext uri="{FF2B5EF4-FFF2-40B4-BE49-F238E27FC236}">
                  <a16:creationId xmlns:a16="http://schemas.microsoft.com/office/drawing/2014/main" id="{FA11EFC8-DBD8-1B9F-7767-DFAC7ED3ACA4}"/>
                </a:ext>
              </a:extLst>
            </p:cNvPr>
            <p:cNvSpPr/>
            <p:nvPr/>
          </p:nvSpPr>
          <p:spPr>
            <a:xfrm>
              <a:off x="3211139" y="5432817"/>
              <a:ext cx="140185" cy="2743"/>
            </a:xfrm>
            <a:custGeom>
              <a:avLst/>
              <a:gdLst>
                <a:gd name="csX0" fmla="*/ -3364 w 140185"/>
                <a:gd name="csY0" fmla="*/ 2985 h 2743"/>
                <a:gd name="csX1" fmla="*/ 136821 w 140185"/>
                <a:gd name="csY1" fmla="*/ 241 h 2743"/>
              </a:gdLst>
              <a:ahLst/>
              <a:cxnLst>
                <a:cxn ang="0">
                  <a:pos x="csX0" y="csY0"/>
                </a:cxn>
                <a:cxn ang="0">
                  <a:pos x="csX1" y="csY1"/>
                </a:cxn>
              </a:cxnLst>
              <a:rect l="l" t="t" r="r" b="b"/>
              <a:pathLst>
                <a:path w="140185" h="2743">
                  <a:moveTo>
                    <a:pt x="-3364" y="2985"/>
                  </a:moveTo>
                  <a:lnTo>
                    <a:pt x="136821" y="241"/>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4" name="フリーフォーム: 図形 343">
              <a:extLst>
                <a:ext uri="{FF2B5EF4-FFF2-40B4-BE49-F238E27FC236}">
                  <a16:creationId xmlns:a16="http://schemas.microsoft.com/office/drawing/2014/main" id="{31CE7F1F-F395-34C7-2DBB-4792A8FA0501}"/>
                </a:ext>
              </a:extLst>
            </p:cNvPr>
            <p:cNvSpPr/>
            <p:nvPr/>
          </p:nvSpPr>
          <p:spPr>
            <a:xfrm rot="10732725">
              <a:off x="3205239" y="5429718"/>
              <a:ext cx="5900" cy="11801"/>
            </a:xfrm>
            <a:custGeom>
              <a:avLst/>
              <a:gdLst>
                <a:gd name="csX0" fmla="*/ 164 w 5900"/>
                <a:gd name="csY0" fmla="*/ 12079 h 11801"/>
                <a:gd name="csX1" fmla="*/ 6064 w 5900"/>
                <a:gd name="csY1" fmla="*/ 6178 h 11801"/>
                <a:gd name="csX2" fmla="*/ 164 w 5900"/>
                <a:gd name="csY2" fmla="*/ 278 h 11801"/>
              </a:gdLst>
              <a:ahLst/>
              <a:cxnLst>
                <a:cxn ang="0">
                  <a:pos x="csX0" y="csY0"/>
                </a:cxn>
                <a:cxn ang="0">
                  <a:pos x="csX1" y="csY1"/>
                </a:cxn>
                <a:cxn ang="0">
                  <a:pos x="csX2" y="csY2"/>
                </a:cxn>
              </a:cxnLst>
              <a:rect l="l" t="t" r="r" b="b"/>
              <a:pathLst>
                <a:path w="5900" h="11801">
                  <a:moveTo>
                    <a:pt x="164" y="12079"/>
                  </a:moveTo>
                  <a:cubicBezTo>
                    <a:pt x="3423" y="12079"/>
                    <a:pt x="6064" y="9437"/>
                    <a:pt x="6064" y="6178"/>
                  </a:cubicBezTo>
                  <a:cubicBezTo>
                    <a:pt x="6064" y="2919"/>
                    <a:pt x="3423" y="278"/>
                    <a:pt x="164" y="278"/>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5" name="フリーフォーム: 図形 344">
              <a:extLst>
                <a:ext uri="{FF2B5EF4-FFF2-40B4-BE49-F238E27FC236}">
                  <a16:creationId xmlns:a16="http://schemas.microsoft.com/office/drawing/2014/main" id="{6891BB1D-5CF2-FE8E-73C7-4D79287D7465}"/>
                </a:ext>
              </a:extLst>
            </p:cNvPr>
            <p:cNvSpPr/>
            <p:nvPr/>
          </p:nvSpPr>
          <p:spPr>
            <a:xfrm rot="21532725">
              <a:off x="3351319" y="5419327"/>
              <a:ext cx="51926" cy="25963"/>
            </a:xfrm>
            <a:custGeom>
              <a:avLst/>
              <a:gdLst>
                <a:gd name="csX0" fmla="*/ 197 w 51926"/>
                <a:gd name="csY0" fmla="*/ 277 h 25963"/>
                <a:gd name="csX1" fmla="*/ 52124 w 51926"/>
                <a:gd name="csY1" fmla="*/ 13259 h 25963"/>
                <a:gd name="csX2" fmla="*/ 197 w 51926"/>
                <a:gd name="csY2" fmla="*/ 26240 h 25963"/>
              </a:gdLst>
              <a:ahLst/>
              <a:cxnLst>
                <a:cxn ang="0">
                  <a:pos x="csX0" y="csY0"/>
                </a:cxn>
                <a:cxn ang="0">
                  <a:pos x="csX1" y="csY1"/>
                </a:cxn>
                <a:cxn ang="0">
                  <a:pos x="csX2" y="csY2"/>
                </a:cxn>
              </a:cxnLst>
              <a:rect l="l" t="t" r="r" b="b"/>
              <a:pathLst>
                <a:path w="51926" h="25963">
                  <a:moveTo>
                    <a:pt x="197" y="277"/>
                  </a:moveTo>
                  <a:cubicBezTo>
                    <a:pt x="17506" y="8931"/>
                    <a:pt x="34815" y="13259"/>
                    <a:pt x="52124" y="13259"/>
                  </a:cubicBezTo>
                  <a:cubicBezTo>
                    <a:pt x="34815" y="13259"/>
                    <a:pt x="17506" y="17586"/>
                    <a:pt x="197" y="26240"/>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6" name="フリーフォーム: 図形 345">
              <a:extLst>
                <a:ext uri="{FF2B5EF4-FFF2-40B4-BE49-F238E27FC236}">
                  <a16:creationId xmlns:a16="http://schemas.microsoft.com/office/drawing/2014/main" id="{57DA6692-7D94-8750-1D5D-718F3D50C2FA}"/>
                </a:ext>
              </a:extLst>
            </p:cNvPr>
            <p:cNvSpPr/>
            <p:nvPr/>
          </p:nvSpPr>
          <p:spPr>
            <a:xfrm>
              <a:off x="3529613" y="5344620"/>
              <a:ext cx="120238" cy="60133"/>
            </a:xfrm>
            <a:custGeom>
              <a:avLst/>
              <a:gdLst>
                <a:gd name="csX0" fmla="*/ -3435 w 120238"/>
                <a:gd name="csY0" fmla="*/ 60389 h 60133"/>
                <a:gd name="csX1" fmla="*/ 116803 w 120238"/>
                <a:gd name="csY1" fmla="*/ 255 h 60133"/>
              </a:gdLst>
              <a:ahLst/>
              <a:cxnLst>
                <a:cxn ang="0">
                  <a:pos x="csX0" y="csY0"/>
                </a:cxn>
                <a:cxn ang="0">
                  <a:pos x="csX1" y="csY1"/>
                </a:cxn>
              </a:cxnLst>
              <a:rect l="l" t="t" r="r" b="b"/>
              <a:pathLst>
                <a:path w="120238" h="60133">
                  <a:moveTo>
                    <a:pt x="-3435" y="60389"/>
                  </a:moveTo>
                  <a:lnTo>
                    <a:pt x="116803" y="255"/>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7" name="フリーフォーム: 図形 346">
              <a:extLst>
                <a:ext uri="{FF2B5EF4-FFF2-40B4-BE49-F238E27FC236}">
                  <a16:creationId xmlns:a16="http://schemas.microsoft.com/office/drawing/2014/main" id="{06434998-BA81-3C81-E201-2B27AF143DE3}"/>
                </a:ext>
              </a:extLst>
            </p:cNvPr>
            <p:cNvSpPr/>
            <p:nvPr/>
          </p:nvSpPr>
          <p:spPr>
            <a:xfrm rot="9205761">
              <a:off x="3524024" y="5400173"/>
              <a:ext cx="5900" cy="11801"/>
            </a:xfrm>
            <a:custGeom>
              <a:avLst/>
              <a:gdLst>
                <a:gd name="csX0" fmla="*/ 225 w 5900"/>
                <a:gd name="csY0" fmla="*/ 12073 h 11801"/>
                <a:gd name="csX1" fmla="*/ 6126 w 5900"/>
                <a:gd name="csY1" fmla="*/ 6173 h 11801"/>
                <a:gd name="csX2" fmla="*/ 225 w 5900"/>
                <a:gd name="csY2" fmla="*/ 272 h 11801"/>
              </a:gdLst>
              <a:ahLst/>
              <a:cxnLst>
                <a:cxn ang="0">
                  <a:pos x="csX0" y="csY0"/>
                </a:cxn>
                <a:cxn ang="0">
                  <a:pos x="csX1" y="csY1"/>
                </a:cxn>
                <a:cxn ang="0">
                  <a:pos x="csX2" y="csY2"/>
                </a:cxn>
              </a:cxnLst>
              <a:rect l="l" t="t" r="r" b="b"/>
              <a:pathLst>
                <a:path w="5900" h="11801">
                  <a:moveTo>
                    <a:pt x="225" y="12073"/>
                  </a:moveTo>
                  <a:cubicBezTo>
                    <a:pt x="3484" y="12073"/>
                    <a:pt x="6126" y="9432"/>
                    <a:pt x="6126" y="6173"/>
                  </a:cubicBezTo>
                  <a:cubicBezTo>
                    <a:pt x="6126" y="2914"/>
                    <a:pt x="3484" y="272"/>
                    <a:pt x="225" y="272"/>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8" name="フリーフォーム: 図形 347">
              <a:extLst>
                <a:ext uri="{FF2B5EF4-FFF2-40B4-BE49-F238E27FC236}">
                  <a16:creationId xmlns:a16="http://schemas.microsoft.com/office/drawing/2014/main" id="{2DABA9F6-274B-2BF7-0DC9-22CBDB04AA30}"/>
                </a:ext>
              </a:extLst>
            </p:cNvPr>
            <p:cNvSpPr/>
            <p:nvPr/>
          </p:nvSpPr>
          <p:spPr>
            <a:xfrm rot="20005761">
              <a:off x="3647109" y="5320025"/>
              <a:ext cx="51926" cy="25963"/>
            </a:xfrm>
            <a:custGeom>
              <a:avLst/>
              <a:gdLst>
                <a:gd name="csX0" fmla="*/ 255 w 51926"/>
                <a:gd name="csY0" fmla="*/ 258 h 25963"/>
                <a:gd name="csX1" fmla="*/ 52181 w 51926"/>
                <a:gd name="csY1" fmla="*/ 13239 h 25963"/>
                <a:gd name="csX2" fmla="*/ 255 w 51926"/>
                <a:gd name="csY2" fmla="*/ 26221 h 25963"/>
              </a:gdLst>
              <a:ahLst/>
              <a:cxnLst>
                <a:cxn ang="0">
                  <a:pos x="csX0" y="csY0"/>
                </a:cxn>
                <a:cxn ang="0">
                  <a:pos x="csX1" y="csY1"/>
                </a:cxn>
                <a:cxn ang="0">
                  <a:pos x="csX2" y="csY2"/>
                </a:cxn>
              </a:cxnLst>
              <a:rect l="l" t="t" r="r" b="b"/>
              <a:pathLst>
                <a:path w="51926" h="25963">
                  <a:moveTo>
                    <a:pt x="255" y="258"/>
                  </a:moveTo>
                  <a:cubicBezTo>
                    <a:pt x="17563" y="8912"/>
                    <a:pt x="34872" y="13239"/>
                    <a:pt x="52181" y="13239"/>
                  </a:cubicBezTo>
                  <a:cubicBezTo>
                    <a:pt x="34872" y="13239"/>
                    <a:pt x="17563" y="17567"/>
                    <a:pt x="255" y="26221"/>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49" name="フリーフォーム: 図形 348">
              <a:extLst>
                <a:ext uri="{FF2B5EF4-FFF2-40B4-BE49-F238E27FC236}">
                  <a16:creationId xmlns:a16="http://schemas.microsoft.com/office/drawing/2014/main" id="{ACB160EA-640B-78B7-4D0E-E6CDAA09F0BA}"/>
                </a:ext>
              </a:extLst>
            </p:cNvPr>
            <p:cNvSpPr/>
            <p:nvPr/>
          </p:nvSpPr>
          <p:spPr>
            <a:xfrm>
              <a:off x="3248166" y="5006643"/>
              <a:ext cx="239467" cy="92905"/>
            </a:xfrm>
            <a:custGeom>
              <a:avLst/>
              <a:gdLst>
                <a:gd name="csX0" fmla="*/ 236084 w 239467"/>
                <a:gd name="csY0" fmla="*/ 329 h 92905"/>
                <a:gd name="csX1" fmla="*/ -3384 w 239467"/>
                <a:gd name="csY1" fmla="*/ 93235 h 92905"/>
              </a:gdLst>
              <a:ahLst/>
              <a:cxnLst>
                <a:cxn ang="0">
                  <a:pos x="csX0" y="csY0"/>
                </a:cxn>
                <a:cxn ang="0">
                  <a:pos x="csX1" y="csY1"/>
                </a:cxn>
              </a:cxnLst>
              <a:rect l="l" t="t" r="r" b="b"/>
              <a:pathLst>
                <a:path w="239467" h="92905">
                  <a:moveTo>
                    <a:pt x="236084" y="329"/>
                  </a:moveTo>
                  <a:lnTo>
                    <a:pt x="-3384" y="93235"/>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0" name="フリーフォーム: 図形 349">
              <a:extLst>
                <a:ext uri="{FF2B5EF4-FFF2-40B4-BE49-F238E27FC236}">
                  <a16:creationId xmlns:a16="http://schemas.microsoft.com/office/drawing/2014/main" id="{413ED65C-035B-C924-CB0E-AD074A656828}"/>
                </a:ext>
              </a:extLst>
            </p:cNvPr>
            <p:cNvSpPr/>
            <p:nvPr/>
          </p:nvSpPr>
          <p:spPr>
            <a:xfrm>
              <a:off x="3252936" y="5127002"/>
              <a:ext cx="459498" cy="11964"/>
            </a:xfrm>
            <a:custGeom>
              <a:avLst/>
              <a:gdLst>
                <a:gd name="csX0" fmla="*/ -3411 w 459498"/>
                <a:gd name="csY0" fmla="*/ 311 h 11964"/>
                <a:gd name="csX1" fmla="*/ 456088 w 459498"/>
                <a:gd name="csY1" fmla="*/ 12275 h 11964"/>
              </a:gdLst>
              <a:ahLst/>
              <a:cxnLst>
                <a:cxn ang="0">
                  <a:pos x="csX0" y="csY0"/>
                </a:cxn>
                <a:cxn ang="0">
                  <a:pos x="csX1" y="csY1"/>
                </a:cxn>
              </a:cxnLst>
              <a:rect l="l" t="t" r="r" b="b"/>
              <a:pathLst>
                <a:path w="459498" h="11964">
                  <a:moveTo>
                    <a:pt x="-3411" y="311"/>
                  </a:moveTo>
                  <a:lnTo>
                    <a:pt x="456088" y="12275"/>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1" name="フリーフォーム: 図形 350">
              <a:extLst>
                <a:ext uri="{FF2B5EF4-FFF2-40B4-BE49-F238E27FC236}">
                  <a16:creationId xmlns:a16="http://schemas.microsoft.com/office/drawing/2014/main" id="{F5EAB6A3-ACF0-32A7-AAA9-BA5A5C4CDC68}"/>
                </a:ext>
              </a:extLst>
            </p:cNvPr>
            <p:cNvSpPr/>
            <p:nvPr/>
          </p:nvSpPr>
          <p:spPr>
            <a:xfrm>
              <a:off x="3233355" y="5489124"/>
              <a:ext cx="527271" cy="134567"/>
            </a:xfrm>
            <a:custGeom>
              <a:avLst/>
              <a:gdLst>
                <a:gd name="csX0" fmla="*/ -3414 w 527271"/>
                <a:gd name="csY0" fmla="*/ 134781 h 134567"/>
                <a:gd name="csX1" fmla="*/ 523857 w 527271"/>
                <a:gd name="csY1" fmla="*/ 213 h 134567"/>
              </a:gdLst>
              <a:ahLst/>
              <a:cxnLst>
                <a:cxn ang="0">
                  <a:pos x="csX0" y="csY0"/>
                </a:cxn>
                <a:cxn ang="0">
                  <a:pos x="csX1" y="csY1"/>
                </a:cxn>
              </a:cxnLst>
              <a:rect l="l" t="t" r="r" b="b"/>
              <a:pathLst>
                <a:path w="527271" h="134567">
                  <a:moveTo>
                    <a:pt x="-3414" y="134781"/>
                  </a:moveTo>
                  <a:lnTo>
                    <a:pt x="523857" y="213"/>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2" name="フリーフォーム: 図形 351">
              <a:extLst>
                <a:ext uri="{FF2B5EF4-FFF2-40B4-BE49-F238E27FC236}">
                  <a16:creationId xmlns:a16="http://schemas.microsoft.com/office/drawing/2014/main" id="{1CCB761E-8E44-A228-CDB3-40AEBFA47436}"/>
                </a:ext>
              </a:extLst>
            </p:cNvPr>
            <p:cNvSpPr/>
            <p:nvPr/>
          </p:nvSpPr>
          <p:spPr>
            <a:xfrm>
              <a:off x="3239498" y="5648742"/>
              <a:ext cx="766996" cy="107812"/>
            </a:xfrm>
            <a:custGeom>
              <a:avLst/>
              <a:gdLst>
                <a:gd name="csX0" fmla="*/ 763553 w 766996"/>
                <a:gd name="csY0" fmla="*/ 107992 h 107812"/>
                <a:gd name="csX1" fmla="*/ -3443 w 766996"/>
                <a:gd name="csY1" fmla="*/ 179 h 107812"/>
              </a:gdLst>
              <a:ahLst/>
              <a:cxnLst>
                <a:cxn ang="0">
                  <a:pos x="csX0" y="csY0"/>
                </a:cxn>
                <a:cxn ang="0">
                  <a:pos x="csX1" y="csY1"/>
                </a:cxn>
              </a:cxnLst>
              <a:rect l="l" t="t" r="r" b="b"/>
              <a:pathLst>
                <a:path w="766996" h="107812">
                  <a:moveTo>
                    <a:pt x="763553" y="107992"/>
                  </a:moveTo>
                  <a:lnTo>
                    <a:pt x="-3443" y="179"/>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3" name="フリーフォーム: 図形 352">
              <a:extLst>
                <a:ext uri="{FF2B5EF4-FFF2-40B4-BE49-F238E27FC236}">
                  <a16:creationId xmlns:a16="http://schemas.microsoft.com/office/drawing/2014/main" id="{C36F3D1E-6C0E-4ADE-1E17-5A142BCCF832}"/>
                </a:ext>
              </a:extLst>
            </p:cNvPr>
            <p:cNvSpPr/>
            <p:nvPr/>
          </p:nvSpPr>
          <p:spPr>
            <a:xfrm>
              <a:off x="3198607" y="5256415"/>
              <a:ext cx="174142" cy="332528"/>
            </a:xfrm>
            <a:custGeom>
              <a:avLst/>
              <a:gdLst>
                <a:gd name="csX0" fmla="*/ -3365 w 174142"/>
                <a:gd name="csY0" fmla="*/ 332772 h 332528"/>
                <a:gd name="csX1" fmla="*/ 170777 w 174142"/>
                <a:gd name="csY1" fmla="*/ 244 h 332528"/>
              </a:gdLst>
              <a:ahLst/>
              <a:cxnLst>
                <a:cxn ang="0">
                  <a:pos x="csX0" y="csY0"/>
                </a:cxn>
                <a:cxn ang="0">
                  <a:pos x="csX1" y="csY1"/>
                </a:cxn>
              </a:cxnLst>
              <a:rect l="l" t="t" r="r" b="b"/>
              <a:pathLst>
                <a:path w="174142" h="332528">
                  <a:moveTo>
                    <a:pt x="-3365" y="332772"/>
                  </a:moveTo>
                  <a:lnTo>
                    <a:pt x="170777" y="24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4" name="フリーフォーム: 図形 353">
              <a:extLst>
                <a:ext uri="{FF2B5EF4-FFF2-40B4-BE49-F238E27FC236}">
                  <a16:creationId xmlns:a16="http://schemas.microsoft.com/office/drawing/2014/main" id="{FFE052AF-1342-0DFF-8E1E-6329073790D7}"/>
                </a:ext>
              </a:extLst>
            </p:cNvPr>
            <p:cNvSpPr/>
            <p:nvPr/>
          </p:nvSpPr>
          <p:spPr>
            <a:xfrm rot="7058436">
              <a:off x="3194288" y="5585657"/>
              <a:ext cx="5900" cy="11801"/>
            </a:xfrm>
            <a:custGeom>
              <a:avLst/>
              <a:gdLst>
                <a:gd name="csX0" fmla="*/ 162 w 5900"/>
                <a:gd name="csY0" fmla="*/ 12109 h 11801"/>
                <a:gd name="csX1" fmla="*/ 6062 w 5900"/>
                <a:gd name="csY1" fmla="*/ 6208 h 11801"/>
                <a:gd name="csX2" fmla="*/ 162 w 5900"/>
                <a:gd name="csY2" fmla="*/ 308 h 11801"/>
              </a:gdLst>
              <a:ahLst/>
              <a:cxnLst>
                <a:cxn ang="0">
                  <a:pos x="csX0" y="csY0"/>
                </a:cxn>
                <a:cxn ang="0">
                  <a:pos x="csX1" y="csY1"/>
                </a:cxn>
                <a:cxn ang="0">
                  <a:pos x="csX2" y="csY2"/>
                </a:cxn>
              </a:cxnLst>
              <a:rect l="l" t="t" r="r" b="b"/>
              <a:pathLst>
                <a:path w="5900" h="11801">
                  <a:moveTo>
                    <a:pt x="162" y="12109"/>
                  </a:moveTo>
                  <a:cubicBezTo>
                    <a:pt x="3420" y="12109"/>
                    <a:pt x="6062" y="9467"/>
                    <a:pt x="6062" y="6208"/>
                  </a:cubicBezTo>
                  <a:cubicBezTo>
                    <a:pt x="6062" y="2950"/>
                    <a:pt x="3420" y="308"/>
                    <a:pt x="162" y="308"/>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5" name="フリーフォーム: 図形 354">
              <a:extLst>
                <a:ext uri="{FF2B5EF4-FFF2-40B4-BE49-F238E27FC236}">
                  <a16:creationId xmlns:a16="http://schemas.microsoft.com/office/drawing/2014/main" id="{61B92E76-BBC4-8067-BCD5-46F23EE3584B}"/>
                </a:ext>
              </a:extLst>
            </p:cNvPr>
            <p:cNvSpPr/>
            <p:nvPr/>
          </p:nvSpPr>
          <p:spPr>
            <a:xfrm rot="17858436">
              <a:off x="3358831" y="5220434"/>
              <a:ext cx="51926" cy="25963"/>
            </a:xfrm>
            <a:custGeom>
              <a:avLst/>
              <a:gdLst>
                <a:gd name="csX0" fmla="*/ 199 w 51926"/>
                <a:gd name="csY0" fmla="*/ 239 h 25963"/>
                <a:gd name="csX1" fmla="*/ 52126 w 51926"/>
                <a:gd name="csY1" fmla="*/ 13220 h 25963"/>
                <a:gd name="csX2" fmla="*/ 199 w 51926"/>
                <a:gd name="csY2" fmla="*/ 26202 h 25963"/>
              </a:gdLst>
              <a:ahLst/>
              <a:cxnLst>
                <a:cxn ang="0">
                  <a:pos x="csX0" y="csY0"/>
                </a:cxn>
                <a:cxn ang="0">
                  <a:pos x="csX1" y="csY1"/>
                </a:cxn>
                <a:cxn ang="0">
                  <a:pos x="csX2" y="csY2"/>
                </a:cxn>
              </a:cxnLst>
              <a:rect l="l" t="t" r="r" b="b"/>
              <a:pathLst>
                <a:path w="51926" h="25963">
                  <a:moveTo>
                    <a:pt x="199" y="239"/>
                  </a:moveTo>
                  <a:cubicBezTo>
                    <a:pt x="17508" y="8893"/>
                    <a:pt x="34817" y="13220"/>
                    <a:pt x="52126" y="13220"/>
                  </a:cubicBezTo>
                  <a:cubicBezTo>
                    <a:pt x="34817" y="13220"/>
                    <a:pt x="17508" y="17547"/>
                    <a:pt x="199" y="26202"/>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6" name="フリーフォーム: 図形 355">
              <a:extLst>
                <a:ext uri="{FF2B5EF4-FFF2-40B4-BE49-F238E27FC236}">
                  <a16:creationId xmlns:a16="http://schemas.microsoft.com/office/drawing/2014/main" id="{2F6D9C4B-BD3A-EC6B-C9F0-4373085885F5}"/>
                </a:ext>
              </a:extLst>
            </p:cNvPr>
            <p:cNvSpPr/>
            <p:nvPr/>
          </p:nvSpPr>
          <p:spPr>
            <a:xfrm>
              <a:off x="3187410" y="5700830"/>
              <a:ext cx="9684" cy="39297"/>
            </a:xfrm>
            <a:custGeom>
              <a:avLst/>
              <a:gdLst>
                <a:gd name="csX0" fmla="*/ -3343 w 9684"/>
                <a:gd name="csY0" fmla="*/ 175 h 39297"/>
                <a:gd name="csX1" fmla="*/ 6341 w 9684"/>
                <a:gd name="csY1" fmla="*/ 39473 h 39297"/>
              </a:gdLst>
              <a:ahLst/>
              <a:cxnLst>
                <a:cxn ang="0">
                  <a:pos x="csX0" y="csY0"/>
                </a:cxn>
                <a:cxn ang="0">
                  <a:pos x="csX1" y="csY1"/>
                </a:cxn>
              </a:cxnLst>
              <a:rect l="l" t="t" r="r" b="b"/>
              <a:pathLst>
                <a:path w="9684" h="39297">
                  <a:moveTo>
                    <a:pt x="-3343" y="175"/>
                  </a:moveTo>
                  <a:lnTo>
                    <a:pt x="6341" y="39473"/>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7" name="フリーフォーム: 図形 356">
              <a:extLst>
                <a:ext uri="{FF2B5EF4-FFF2-40B4-BE49-F238E27FC236}">
                  <a16:creationId xmlns:a16="http://schemas.microsoft.com/office/drawing/2014/main" id="{2C62FD37-06B0-D1B5-9E7D-1D6B104D3875}"/>
                </a:ext>
              </a:extLst>
            </p:cNvPr>
            <p:cNvSpPr/>
            <p:nvPr/>
          </p:nvSpPr>
          <p:spPr>
            <a:xfrm rot="15369298">
              <a:off x="3183754" y="5692065"/>
              <a:ext cx="5900" cy="11801"/>
            </a:xfrm>
            <a:custGeom>
              <a:avLst/>
              <a:gdLst>
                <a:gd name="csX0" fmla="*/ 159 w 5900"/>
                <a:gd name="csY0" fmla="*/ 12130 h 11801"/>
                <a:gd name="csX1" fmla="*/ 6060 w 5900"/>
                <a:gd name="csY1" fmla="*/ 6229 h 11801"/>
                <a:gd name="csX2" fmla="*/ 159 w 5900"/>
                <a:gd name="csY2" fmla="*/ 328 h 11801"/>
              </a:gdLst>
              <a:ahLst/>
              <a:cxnLst>
                <a:cxn ang="0">
                  <a:pos x="csX0" y="csY0"/>
                </a:cxn>
                <a:cxn ang="0">
                  <a:pos x="csX1" y="csY1"/>
                </a:cxn>
                <a:cxn ang="0">
                  <a:pos x="csX2" y="csY2"/>
                </a:cxn>
              </a:cxnLst>
              <a:rect l="l" t="t" r="r" b="b"/>
              <a:pathLst>
                <a:path w="5900" h="11801">
                  <a:moveTo>
                    <a:pt x="159" y="12130"/>
                  </a:moveTo>
                  <a:cubicBezTo>
                    <a:pt x="3418" y="12130"/>
                    <a:pt x="6060" y="9488"/>
                    <a:pt x="6060" y="6229"/>
                  </a:cubicBezTo>
                  <a:cubicBezTo>
                    <a:pt x="6060" y="2970"/>
                    <a:pt x="3418" y="328"/>
                    <a:pt x="159" y="328"/>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8" name="フリーフォーム: 図形 357">
              <a:extLst>
                <a:ext uri="{FF2B5EF4-FFF2-40B4-BE49-F238E27FC236}">
                  <a16:creationId xmlns:a16="http://schemas.microsoft.com/office/drawing/2014/main" id="{F12AB3CE-18B9-6961-5BE0-B611CACC5E2A}"/>
                </a:ext>
              </a:extLst>
            </p:cNvPr>
            <p:cNvSpPr/>
            <p:nvPr/>
          </p:nvSpPr>
          <p:spPr>
            <a:xfrm rot="4569298">
              <a:off x="3177345" y="5752355"/>
              <a:ext cx="51926" cy="25963"/>
            </a:xfrm>
            <a:custGeom>
              <a:avLst/>
              <a:gdLst>
                <a:gd name="csX0" fmla="*/ 164 w 51926"/>
                <a:gd name="csY0" fmla="*/ 341 h 25963"/>
                <a:gd name="csX1" fmla="*/ 52091 w 51926"/>
                <a:gd name="csY1" fmla="*/ 13323 h 25963"/>
                <a:gd name="csX2" fmla="*/ 164 w 51926"/>
                <a:gd name="csY2" fmla="*/ 26305 h 25963"/>
              </a:gdLst>
              <a:ahLst/>
              <a:cxnLst>
                <a:cxn ang="0">
                  <a:pos x="csX0" y="csY0"/>
                </a:cxn>
                <a:cxn ang="0">
                  <a:pos x="csX1" y="csY1"/>
                </a:cxn>
                <a:cxn ang="0">
                  <a:pos x="csX2" y="csY2"/>
                </a:cxn>
              </a:cxnLst>
              <a:rect l="l" t="t" r="r" b="b"/>
              <a:pathLst>
                <a:path w="51926" h="25963">
                  <a:moveTo>
                    <a:pt x="164" y="341"/>
                  </a:moveTo>
                  <a:cubicBezTo>
                    <a:pt x="17473" y="8996"/>
                    <a:pt x="34782" y="13323"/>
                    <a:pt x="52091" y="13323"/>
                  </a:cubicBezTo>
                  <a:cubicBezTo>
                    <a:pt x="34782" y="13323"/>
                    <a:pt x="17473" y="17650"/>
                    <a:pt x="164" y="26305"/>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59" name="フリーフォーム: 図形 358">
              <a:extLst>
                <a:ext uri="{FF2B5EF4-FFF2-40B4-BE49-F238E27FC236}">
                  <a16:creationId xmlns:a16="http://schemas.microsoft.com/office/drawing/2014/main" id="{DA1AAF70-3B48-14BB-A922-5B52A6170606}"/>
                </a:ext>
              </a:extLst>
            </p:cNvPr>
            <p:cNvSpPr/>
            <p:nvPr/>
          </p:nvSpPr>
          <p:spPr>
            <a:xfrm>
              <a:off x="3611767" y="5021481"/>
              <a:ext cx="113334" cy="78879"/>
            </a:xfrm>
            <a:custGeom>
              <a:avLst/>
              <a:gdLst>
                <a:gd name="csX0" fmla="*/ -3453 w 113334"/>
                <a:gd name="csY0" fmla="*/ 328 h 78879"/>
                <a:gd name="csX1" fmla="*/ 109881 w 113334"/>
                <a:gd name="csY1" fmla="*/ 79207 h 78879"/>
              </a:gdLst>
              <a:ahLst/>
              <a:cxnLst>
                <a:cxn ang="0">
                  <a:pos x="csX0" y="csY0"/>
                </a:cxn>
                <a:cxn ang="0">
                  <a:pos x="csX1" y="csY1"/>
                </a:cxn>
              </a:cxnLst>
              <a:rect l="l" t="t" r="r" b="b"/>
              <a:pathLst>
                <a:path w="113334" h="78879">
                  <a:moveTo>
                    <a:pt x="-3453" y="328"/>
                  </a:moveTo>
                  <a:lnTo>
                    <a:pt x="109881" y="79207"/>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0" name="フリーフォーム: 図形 359">
              <a:extLst>
                <a:ext uri="{FF2B5EF4-FFF2-40B4-BE49-F238E27FC236}">
                  <a16:creationId xmlns:a16="http://schemas.microsoft.com/office/drawing/2014/main" id="{BD0C9C3A-FBE3-3065-103D-E0150973E455}"/>
                </a:ext>
              </a:extLst>
            </p:cNvPr>
            <p:cNvSpPr/>
            <p:nvPr/>
          </p:nvSpPr>
          <p:spPr>
            <a:xfrm>
              <a:off x="3858511" y="4332677"/>
              <a:ext cx="33774" cy="89978"/>
            </a:xfrm>
            <a:custGeom>
              <a:avLst/>
              <a:gdLst>
                <a:gd name="csX0" fmla="*/ -3501 w 33774"/>
                <a:gd name="csY0" fmla="*/ 485 h 89978"/>
                <a:gd name="csX1" fmla="*/ 30274 w 33774"/>
                <a:gd name="csY1" fmla="*/ 90464 h 89978"/>
              </a:gdLst>
              <a:ahLst/>
              <a:cxnLst>
                <a:cxn ang="0">
                  <a:pos x="csX0" y="csY0"/>
                </a:cxn>
                <a:cxn ang="0">
                  <a:pos x="csX1" y="csY1"/>
                </a:cxn>
              </a:cxnLst>
              <a:rect l="l" t="t" r="r" b="b"/>
              <a:pathLst>
                <a:path w="33774" h="89978">
                  <a:moveTo>
                    <a:pt x="-3501" y="485"/>
                  </a:moveTo>
                  <a:lnTo>
                    <a:pt x="30274" y="90464"/>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1" name="フリーフォーム: 図形 360">
              <a:extLst>
                <a:ext uri="{FF2B5EF4-FFF2-40B4-BE49-F238E27FC236}">
                  <a16:creationId xmlns:a16="http://schemas.microsoft.com/office/drawing/2014/main" id="{680B1DC1-FC4B-8D98-B8F5-3AD882F228C9}"/>
                </a:ext>
              </a:extLst>
            </p:cNvPr>
            <p:cNvSpPr/>
            <p:nvPr/>
          </p:nvSpPr>
          <p:spPr>
            <a:xfrm>
              <a:off x="3071537" y="4781371"/>
              <a:ext cx="41309" cy="92104"/>
            </a:xfrm>
            <a:custGeom>
              <a:avLst/>
              <a:gdLst>
                <a:gd name="csX0" fmla="*/ 37989 w 41309"/>
                <a:gd name="csY0" fmla="*/ 381 h 92104"/>
                <a:gd name="csX1" fmla="*/ -3320 w 41309"/>
                <a:gd name="csY1" fmla="*/ 92486 h 92104"/>
              </a:gdLst>
              <a:ahLst/>
              <a:cxnLst>
                <a:cxn ang="0">
                  <a:pos x="csX0" y="csY0"/>
                </a:cxn>
                <a:cxn ang="0">
                  <a:pos x="csX1" y="csY1"/>
                </a:cxn>
              </a:cxnLst>
              <a:rect l="l" t="t" r="r" b="b"/>
              <a:pathLst>
                <a:path w="41309" h="92104">
                  <a:moveTo>
                    <a:pt x="37989" y="381"/>
                  </a:moveTo>
                  <a:lnTo>
                    <a:pt x="-3320" y="92486"/>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2" name="フリーフォーム: 図形 361">
              <a:extLst>
                <a:ext uri="{FF2B5EF4-FFF2-40B4-BE49-F238E27FC236}">
                  <a16:creationId xmlns:a16="http://schemas.microsoft.com/office/drawing/2014/main" id="{3C1E9DC9-8D50-F5DD-CF25-347C2EF085AC}"/>
                </a:ext>
              </a:extLst>
            </p:cNvPr>
            <p:cNvSpPr/>
            <p:nvPr/>
          </p:nvSpPr>
          <p:spPr>
            <a:xfrm rot="17649398">
              <a:off x="3111103" y="4772778"/>
              <a:ext cx="5900" cy="11801"/>
            </a:xfrm>
            <a:custGeom>
              <a:avLst/>
              <a:gdLst>
                <a:gd name="csX0" fmla="*/ 145 w 5900"/>
                <a:gd name="csY0" fmla="*/ 11952 h 11801"/>
                <a:gd name="csX1" fmla="*/ 6046 w 5900"/>
                <a:gd name="csY1" fmla="*/ 6052 h 11801"/>
                <a:gd name="csX2" fmla="*/ 145 w 5900"/>
                <a:gd name="csY2" fmla="*/ 151 h 11801"/>
              </a:gdLst>
              <a:ahLst/>
              <a:cxnLst>
                <a:cxn ang="0">
                  <a:pos x="csX0" y="csY0"/>
                </a:cxn>
                <a:cxn ang="0">
                  <a:pos x="csX1" y="csY1"/>
                </a:cxn>
                <a:cxn ang="0">
                  <a:pos x="csX2" y="csY2"/>
                </a:cxn>
              </a:cxnLst>
              <a:rect l="l" t="t" r="r" b="b"/>
              <a:pathLst>
                <a:path w="5900" h="11801">
                  <a:moveTo>
                    <a:pt x="145" y="11952"/>
                  </a:moveTo>
                  <a:cubicBezTo>
                    <a:pt x="3404" y="11952"/>
                    <a:pt x="6046" y="9311"/>
                    <a:pt x="6046" y="6052"/>
                  </a:cubicBezTo>
                  <a:cubicBezTo>
                    <a:pt x="6046" y="2793"/>
                    <a:pt x="3404" y="151"/>
                    <a:pt x="145" y="151"/>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3" name="フリーフォーム: 図形 362">
              <a:extLst>
                <a:ext uri="{FF2B5EF4-FFF2-40B4-BE49-F238E27FC236}">
                  <a16:creationId xmlns:a16="http://schemas.microsoft.com/office/drawing/2014/main" id="{D516E599-D5DC-96C4-6D69-319E8C4C8EAE}"/>
                </a:ext>
              </a:extLst>
            </p:cNvPr>
            <p:cNvSpPr/>
            <p:nvPr/>
          </p:nvSpPr>
          <p:spPr>
            <a:xfrm rot="6849398">
              <a:off x="3034948" y="4884183"/>
              <a:ext cx="51926" cy="25963"/>
            </a:xfrm>
            <a:custGeom>
              <a:avLst/>
              <a:gdLst>
                <a:gd name="csX0" fmla="*/ 136 w 51926"/>
                <a:gd name="csY0" fmla="*/ 174 h 25963"/>
                <a:gd name="csX1" fmla="*/ 52063 w 51926"/>
                <a:gd name="csY1" fmla="*/ 13155 h 25963"/>
                <a:gd name="csX2" fmla="*/ 136 w 51926"/>
                <a:gd name="csY2" fmla="*/ 26137 h 25963"/>
              </a:gdLst>
              <a:ahLst/>
              <a:cxnLst>
                <a:cxn ang="0">
                  <a:pos x="csX0" y="csY0"/>
                </a:cxn>
                <a:cxn ang="0">
                  <a:pos x="csX1" y="csY1"/>
                </a:cxn>
                <a:cxn ang="0">
                  <a:pos x="csX2" y="csY2"/>
                </a:cxn>
              </a:cxnLst>
              <a:rect l="l" t="t" r="r" b="b"/>
              <a:pathLst>
                <a:path w="51926" h="25963">
                  <a:moveTo>
                    <a:pt x="136" y="174"/>
                  </a:moveTo>
                  <a:cubicBezTo>
                    <a:pt x="17445" y="8828"/>
                    <a:pt x="34754" y="13155"/>
                    <a:pt x="52063" y="13155"/>
                  </a:cubicBezTo>
                  <a:cubicBezTo>
                    <a:pt x="34754" y="13155"/>
                    <a:pt x="17445" y="17483"/>
                    <a:pt x="136" y="26137"/>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4" name="フリーフォーム: 図形 363">
              <a:extLst>
                <a:ext uri="{FF2B5EF4-FFF2-40B4-BE49-F238E27FC236}">
                  <a16:creationId xmlns:a16="http://schemas.microsoft.com/office/drawing/2014/main" id="{F450AF39-FBE0-2F75-8710-7C5E0D71C4D6}"/>
                </a:ext>
              </a:extLst>
            </p:cNvPr>
            <p:cNvSpPr/>
            <p:nvPr/>
          </p:nvSpPr>
          <p:spPr>
            <a:xfrm>
              <a:off x="3054420" y="4631099"/>
              <a:ext cx="47057" cy="55724"/>
            </a:xfrm>
            <a:custGeom>
              <a:avLst/>
              <a:gdLst>
                <a:gd name="csX0" fmla="*/ -3317 w 47057"/>
                <a:gd name="csY0" fmla="*/ 420 h 55724"/>
                <a:gd name="csX1" fmla="*/ 43741 w 47057"/>
                <a:gd name="csY1" fmla="*/ 56145 h 55724"/>
              </a:gdLst>
              <a:ahLst/>
              <a:cxnLst>
                <a:cxn ang="0">
                  <a:pos x="csX0" y="csY0"/>
                </a:cxn>
                <a:cxn ang="0">
                  <a:pos x="csX1" y="csY1"/>
                </a:cxn>
              </a:cxnLst>
              <a:rect l="l" t="t" r="r" b="b"/>
              <a:pathLst>
                <a:path w="47057" h="55724">
                  <a:moveTo>
                    <a:pt x="-3317" y="420"/>
                  </a:moveTo>
                  <a:lnTo>
                    <a:pt x="43741" y="56145"/>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5" name="フリーフォーム: 図形 364">
              <a:extLst>
                <a:ext uri="{FF2B5EF4-FFF2-40B4-BE49-F238E27FC236}">
                  <a16:creationId xmlns:a16="http://schemas.microsoft.com/office/drawing/2014/main" id="{19D7E2F1-D1FD-3CC2-9423-A8F8C87E24AC}"/>
                </a:ext>
              </a:extLst>
            </p:cNvPr>
            <p:cNvSpPr/>
            <p:nvPr/>
          </p:nvSpPr>
          <p:spPr>
            <a:xfrm>
              <a:off x="3162805" y="4778917"/>
              <a:ext cx="39585" cy="76288"/>
            </a:xfrm>
            <a:custGeom>
              <a:avLst/>
              <a:gdLst>
                <a:gd name="csX0" fmla="*/ -3341 w 39585"/>
                <a:gd name="csY0" fmla="*/ 384 h 76288"/>
                <a:gd name="csX1" fmla="*/ 36245 w 39585"/>
                <a:gd name="csY1" fmla="*/ 76673 h 76288"/>
              </a:gdLst>
              <a:ahLst/>
              <a:cxnLst>
                <a:cxn ang="0">
                  <a:pos x="csX0" y="csY0"/>
                </a:cxn>
                <a:cxn ang="0">
                  <a:pos x="csX1" y="csY1"/>
                </a:cxn>
              </a:cxnLst>
              <a:rect l="l" t="t" r="r" b="b"/>
              <a:pathLst>
                <a:path w="39585" h="76288">
                  <a:moveTo>
                    <a:pt x="-3341" y="384"/>
                  </a:moveTo>
                  <a:lnTo>
                    <a:pt x="36245" y="76673"/>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6" name="フリーフォーム: 図形 365">
              <a:extLst>
                <a:ext uri="{FF2B5EF4-FFF2-40B4-BE49-F238E27FC236}">
                  <a16:creationId xmlns:a16="http://schemas.microsoft.com/office/drawing/2014/main" id="{530EEE72-4590-671D-95E1-642D59A667B0}"/>
                </a:ext>
              </a:extLst>
            </p:cNvPr>
            <p:cNvSpPr/>
            <p:nvPr/>
          </p:nvSpPr>
          <p:spPr>
            <a:xfrm>
              <a:off x="2817104" y="4671587"/>
              <a:ext cx="254368" cy="45242"/>
            </a:xfrm>
            <a:custGeom>
              <a:avLst/>
              <a:gdLst>
                <a:gd name="csX0" fmla="*/ 251082 w 254368"/>
                <a:gd name="csY0" fmla="*/ 45655 h 45242"/>
                <a:gd name="csX1" fmla="*/ -3286 w 254368"/>
                <a:gd name="csY1" fmla="*/ 412 h 45242"/>
              </a:gdLst>
              <a:ahLst/>
              <a:cxnLst>
                <a:cxn ang="0">
                  <a:pos x="csX0" y="csY0"/>
                </a:cxn>
                <a:cxn ang="0">
                  <a:pos x="csX1" y="csY1"/>
                </a:cxn>
              </a:cxnLst>
              <a:rect l="l" t="t" r="r" b="b"/>
              <a:pathLst>
                <a:path w="254368" h="45242">
                  <a:moveTo>
                    <a:pt x="251082" y="45655"/>
                  </a:moveTo>
                  <a:lnTo>
                    <a:pt x="-3286" y="412"/>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7" name="フリーフォーム: 図形 366">
              <a:extLst>
                <a:ext uri="{FF2B5EF4-FFF2-40B4-BE49-F238E27FC236}">
                  <a16:creationId xmlns:a16="http://schemas.microsoft.com/office/drawing/2014/main" id="{2EBAAB2B-2FF4-DB0E-010A-CEF662ECB287}"/>
                </a:ext>
              </a:extLst>
            </p:cNvPr>
            <p:cNvSpPr/>
            <p:nvPr/>
          </p:nvSpPr>
          <p:spPr>
            <a:xfrm rot="605121">
              <a:off x="3071427" y="4711446"/>
              <a:ext cx="5900" cy="11801"/>
            </a:xfrm>
            <a:custGeom>
              <a:avLst/>
              <a:gdLst>
                <a:gd name="csX0" fmla="*/ 138 w 5900"/>
                <a:gd name="csY0" fmla="*/ 11941 h 11801"/>
                <a:gd name="csX1" fmla="*/ 6039 w 5900"/>
                <a:gd name="csY1" fmla="*/ 6040 h 11801"/>
                <a:gd name="csX2" fmla="*/ 138 w 5900"/>
                <a:gd name="csY2" fmla="*/ 139 h 11801"/>
              </a:gdLst>
              <a:ahLst/>
              <a:cxnLst>
                <a:cxn ang="0">
                  <a:pos x="csX0" y="csY0"/>
                </a:cxn>
                <a:cxn ang="0">
                  <a:pos x="csX1" y="csY1"/>
                </a:cxn>
                <a:cxn ang="0">
                  <a:pos x="csX2" y="csY2"/>
                </a:cxn>
              </a:cxnLst>
              <a:rect l="l" t="t" r="r" b="b"/>
              <a:pathLst>
                <a:path w="5900" h="11801">
                  <a:moveTo>
                    <a:pt x="138" y="11941"/>
                  </a:moveTo>
                  <a:cubicBezTo>
                    <a:pt x="3397" y="11941"/>
                    <a:pt x="6039" y="9299"/>
                    <a:pt x="6039" y="6040"/>
                  </a:cubicBezTo>
                  <a:cubicBezTo>
                    <a:pt x="6039" y="2781"/>
                    <a:pt x="3397" y="139"/>
                    <a:pt x="138" y="139"/>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8" name="フリーフォーム: 図形 367">
              <a:extLst>
                <a:ext uri="{FF2B5EF4-FFF2-40B4-BE49-F238E27FC236}">
                  <a16:creationId xmlns:a16="http://schemas.microsoft.com/office/drawing/2014/main" id="{80AB16E2-1810-F48D-2BD6-8EC12B1F4EFD}"/>
                </a:ext>
              </a:extLst>
            </p:cNvPr>
            <p:cNvSpPr/>
            <p:nvPr/>
          </p:nvSpPr>
          <p:spPr>
            <a:xfrm rot="11405121">
              <a:off x="2765578" y="4654059"/>
              <a:ext cx="51926" cy="25963"/>
            </a:xfrm>
            <a:custGeom>
              <a:avLst/>
              <a:gdLst>
                <a:gd name="csX0" fmla="*/ 85 w 51926"/>
                <a:gd name="csY0" fmla="*/ 129 h 25963"/>
                <a:gd name="csX1" fmla="*/ 52011 w 51926"/>
                <a:gd name="csY1" fmla="*/ 13111 h 25963"/>
                <a:gd name="csX2" fmla="*/ 85 w 51926"/>
                <a:gd name="csY2" fmla="*/ 26093 h 25963"/>
              </a:gdLst>
              <a:ahLst/>
              <a:cxnLst>
                <a:cxn ang="0">
                  <a:pos x="csX0" y="csY0"/>
                </a:cxn>
                <a:cxn ang="0">
                  <a:pos x="csX1" y="csY1"/>
                </a:cxn>
                <a:cxn ang="0">
                  <a:pos x="csX2" y="csY2"/>
                </a:cxn>
              </a:cxnLst>
              <a:rect l="l" t="t" r="r" b="b"/>
              <a:pathLst>
                <a:path w="51926" h="25963">
                  <a:moveTo>
                    <a:pt x="85" y="129"/>
                  </a:moveTo>
                  <a:cubicBezTo>
                    <a:pt x="17393" y="8784"/>
                    <a:pt x="34702" y="13111"/>
                    <a:pt x="52011" y="13111"/>
                  </a:cubicBezTo>
                  <a:cubicBezTo>
                    <a:pt x="34702" y="13111"/>
                    <a:pt x="17393" y="17438"/>
                    <a:pt x="85" y="26093"/>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69" name="フリーフォーム: 図形 368">
              <a:extLst>
                <a:ext uri="{FF2B5EF4-FFF2-40B4-BE49-F238E27FC236}">
                  <a16:creationId xmlns:a16="http://schemas.microsoft.com/office/drawing/2014/main" id="{0B834076-E358-3016-D51E-00E62D482008}"/>
                </a:ext>
              </a:extLst>
            </p:cNvPr>
            <p:cNvSpPr/>
            <p:nvPr/>
          </p:nvSpPr>
          <p:spPr>
            <a:xfrm>
              <a:off x="4166710" y="4522810"/>
              <a:ext cx="38203" cy="35379"/>
            </a:xfrm>
            <a:custGeom>
              <a:avLst/>
              <a:gdLst>
                <a:gd name="csX0" fmla="*/ 34631 w 38203"/>
                <a:gd name="csY0" fmla="*/ 35828 h 35379"/>
                <a:gd name="csX1" fmla="*/ -3573 w 38203"/>
                <a:gd name="csY1" fmla="*/ 448 h 35379"/>
              </a:gdLst>
              <a:ahLst/>
              <a:cxnLst>
                <a:cxn ang="0">
                  <a:pos x="csX0" y="csY0"/>
                </a:cxn>
                <a:cxn ang="0">
                  <a:pos x="csX1" y="csY1"/>
                </a:cxn>
              </a:cxnLst>
              <a:rect l="l" t="t" r="r" b="b"/>
              <a:pathLst>
                <a:path w="38203" h="35379">
                  <a:moveTo>
                    <a:pt x="34631" y="35828"/>
                  </a:moveTo>
                  <a:lnTo>
                    <a:pt x="-3573" y="448"/>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0" name="フリーフォーム: 図形 369">
              <a:extLst>
                <a:ext uri="{FF2B5EF4-FFF2-40B4-BE49-F238E27FC236}">
                  <a16:creationId xmlns:a16="http://schemas.microsoft.com/office/drawing/2014/main" id="{45790B99-C2FC-4753-898F-54DA9D75BA84}"/>
                </a:ext>
              </a:extLst>
            </p:cNvPr>
            <p:cNvSpPr/>
            <p:nvPr/>
          </p:nvSpPr>
          <p:spPr>
            <a:xfrm>
              <a:off x="3494728" y="5175685"/>
              <a:ext cx="199858" cy="86036"/>
            </a:xfrm>
            <a:custGeom>
              <a:avLst/>
              <a:gdLst>
                <a:gd name="csX0" fmla="*/ 196422 w 199858"/>
                <a:gd name="csY0" fmla="*/ 86328 h 86036"/>
                <a:gd name="csX1" fmla="*/ -3436 w 199858"/>
                <a:gd name="csY1" fmla="*/ 291 h 86036"/>
              </a:gdLst>
              <a:ahLst/>
              <a:cxnLst>
                <a:cxn ang="0">
                  <a:pos x="csX0" y="csY0"/>
                </a:cxn>
                <a:cxn ang="0">
                  <a:pos x="csX1" y="csY1"/>
                </a:cxn>
              </a:cxnLst>
              <a:rect l="l" t="t" r="r" b="b"/>
              <a:pathLst>
                <a:path w="199858" h="86036">
                  <a:moveTo>
                    <a:pt x="196422" y="86328"/>
                  </a:moveTo>
                  <a:lnTo>
                    <a:pt x="-3436" y="291"/>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1" name="フリーフォーム: 図形 370">
              <a:extLst>
                <a:ext uri="{FF2B5EF4-FFF2-40B4-BE49-F238E27FC236}">
                  <a16:creationId xmlns:a16="http://schemas.microsoft.com/office/drawing/2014/main" id="{A99A6487-6A65-9207-DCC5-C09000DBEF30}"/>
                </a:ext>
              </a:extLst>
            </p:cNvPr>
            <p:cNvSpPr/>
            <p:nvPr/>
          </p:nvSpPr>
          <p:spPr>
            <a:xfrm>
              <a:off x="3524080" y="5226137"/>
              <a:ext cx="255766" cy="212572"/>
            </a:xfrm>
            <a:custGeom>
              <a:avLst/>
              <a:gdLst>
                <a:gd name="csX0" fmla="*/ 252317 w 255766"/>
                <a:gd name="csY0" fmla="*/ 212837 h 212572"/>
                <a:gd name="csX1" fmla="*/ -3450 w 255766"/>
                <a:gd name="csY1" fmla="*/ 265 h 212572"/>
              </a:gdLst>
              <a:ahLst/>
              <a:cxnLst>
                <a:cxn ang="0">
                  <a:pos x="csX0" y="csY0"/>
                </a:cxn>
                <a:cxn ang="0">
                  <a:pos x="csX1" y="csY1"/>
                </a:cxn>
              </a:cxnLst>
              <a:rect l="l" t="t" r="r" b="b"/>
              <a:pathLst>
                <a:path w="255766" h="212572">
                  <a:moveTo>
                    <a:pt x="252317" y="212837"/>
                  </a:moveTo>
                  <a:lnTo>
                    <a:pt x="-3450" y="265"/>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2" name="フリーフォーム: 図形 371">
              <a:extLst>
                <a:ext uri="{FF2B5EF4-FFF2-40B4-BE49-F238E27FC236}">
                  <a16:creationId xmlns:a16="http://schemas.microsoft.com/office/drawing/2014/main" id="{E9F7C0C9-9A6D-FEFC-E9B1-993205C77E45}"/>
                </a:ext>
              </a:extLst>
            </p:cNvPr>
            <p:cNvSpPr/>
            <p:nvPr/>
          </p:nvSpPr>
          <p:spPr>
            <a:xfrm rot="2383840">
              <a:off x="3779165" y="5434694"/>
              <a:ext cx="5900" cy="11801"/>
            </a:xfrm>
            <a:custGeom>
              <a:avLst/>
              <a:gdLst>
                <a:gd name="csX0" fmla="*/ 274 w 5900"/>
                <a:gd name="csY0" fmla="*/ 12080 h 11801"/>
                <a:gd name="csX1" fmla="*/ 6175 w 5900"/>
                <a:gd name="csY1" fmla="*/ 6179 h 11801"/>
                <a:gd name="csX2" fmla="*/ 274 w 5900"/>
                <a:gd name="csY2" fmla="*/ 279 h 11801"/>
              </a:gdLst>
              <a:ahLst/>
              <a:cxnLst>
                <a:cxn ang="0">
                  <a:pos x="csX0" y="csY0"/>
                </a:cxn>
                <a:cxn ang="0">
                  <a:pos x="csX1" y="csY1"/>
                </a:cxn>
                <a:cxn ang="0">
                  <a:pos x="csX2" y="csY2"/>
                </a:cxn>
              </a:cxnLst>
              <a:rect l="l" t="t" r="r" b="b"/>
              <a:pathLst>
                <a:path w="5900" h="11801">
                  <a:moveTo>
                    <a:pt x="274" y="12080"/>
                  </a:moveTo>
                  <a:cubicBezTo>
                    <a:pt x="3533" y="12080"/>
                    <a:pt x="6175" y="9438"/>
                    <a:pt x="6175" y="6179"/>
                  </a:cubicBezTo>
                  <a:cubicBezTo>
                    <a:pt x="6175" y="2920"/>
                    <a:pt x="3533" y="279"/>
                    <a:pt x="274" y="279"/>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3" name="フリーフォーム: 図形 372">
              <a:extLst>
                <a:ext uri="{FF2B5EF4-FFF2-40B4-BE49-F238E27FC236}">
                  <a16:creationId xmlns:a16="http://schemas.microsoft.com/office/drawing/2014/main" id="{34E7BFF7-C46F-8ACE-3F56-FEC741737E9F}"/>
                </a:ext>
              </a:extLst>
            </p:cNvPr>
            <p:cNvSpPr/>
            <p:nvPr/>
          </p:nvSpPr>
          <p:spPr>
            <a:xfrm rot="13183840">
              <a:off x="3478150" y="5196560"/>
              <a:ext cx="51926" cy="25963"/>
            </a:xfrm>
            <a:custGeom>
              <a:avLst/>
              <a:gdLst>
                <a:gd name="csX0" fmla="*/ 222 w 51926"/>
                <a:gd name="csY0" fmla="*/ 234 h 25963"/>
                <a:gd name="csX1" fmla="*/ 52149 w 51926"/>
                <a:gd name="csY1" fmla="*/ 13216 h 25963"/>
                <a:gd name="csX2" fmla="*/ 222 w 51926"/>
                <a:gd name="csY2" fmla="*/ 26197 h 25963"/>
              </a:gdLst>
              <a:ahLst/>
              <a:cxnLst>
                <a:cxn ang="0">
                  <a:pos x="csX0" y="csY0"/>
                </a:cxn>
                <a:cxn ang="0">
                  <a:pos x="csX1" y="csY1"/>
                </a:cxn>
                <a:cxn ang="0">
                  <a:pos x="csX2" y="csY2"/>
                </a:cxn>
              </a:cxnLst>
              <a:rect l="l" t="t" r="r" b="b"/>
              <a:pathLst>
                <a:path w="51926" h="25963">
                  <a:moveTo>
                    <a:pt x="222" y="234"/>
                  </a:moveTo>
                  <a:cubicBezTo>
                    <a:pt x="17531" y="8888"/>
                    <a:pt x="34840" y="13216"/>
                    <a:pt x="52149" y="13216"/>
                  </a:cubicBezTo>
                  <a:cubicBezTo>
                    <a:pt x="34840" y="13216"/>
                    <a:pt x="17531" y="17543"/>
                    <a:pt x="222" y="26197"/>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4" name="フリーフォーム: 図形 373">
              <a:extLst>
                <a:ext uri="{FF2B5EF4-FFF2-40B4-BE49-F238E27FC236}">
                  <a16:creationId xmlns:a16="http://schemas.microsoft.com/office/drawing/2014/main" id="{931907CA-BCF8-1C2A-74E3-5C2717B720A6}"/>
                </a:ext>
              </a:extLst>
            </p:cNvPr>
            <p:cNvSpPr/>
            <p:nvPr/>
          </p:nvSpPr>
          <p:spPr>
            <a:xfrm>
              <a:off x="3427097" y="4837630"/>
              <a:ext cx="2000" cy="239250"/>
            </a:xfrm>
            <a:custGeom>
              <a:avLst/>
              <a:gdLst>
                <a:gd name="csX0" fmla="*/ -3398 w 2000"/>
                <a:gd name="csY0" fmla="*/ 352 h 239250"/>
                <a:gd name="csX1" fmla="*/ -1398 w 2000"/>
                <a:gd name="csY1" fmla="*/ 239602 h 239250"/>
              </a:gdLst>
              <a:ahLst/>
              <a:cxnLst>
                <a:cxn ang="0">
                  <a:pos x="csX0" y="csY0"/>
                </a:cxn>
                <a:cxn ang="0">
                  <a:pos x="csX1" y="csY1"/>
                </a:cxn>
              </a:cxnLst>
              <a:rect l="l" t="t" r="r" b="b"/>
              <a:pathLst>
                <a:path w="2000" h="239250">
                  <a:moveTo>
                    <a:pt x="-3398" y="352"/>
                  </a:moveTo>
                  <a:lnTo>
                    <a:pt x="-1398" y="239602"/>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5" name="フリーフォーム: 図形 374">
              <a:extLst>
                <a:ext uri="{FF2B5EF4-FFF2-40B4-BE49-F238E27FC236}">
                  <a16:creationId xmlns:a16="http://schemas.microsoft.com/office/drawing/2014/main" id="{357EB845-063B-4FD3-2E61-C31B88BF58D0}"/>
                </a:ext>
              </a:extLst>
            </p:cNvPr>
            <p:cNvSpPr/>
            <p:nvPr/>
          </p:nvSpPr>
          <p:spPr>
            <a:xfrm>
              <a:off x="3280795" y="4972067"/>
              <a:ext cx="103103" cy="121609"/>
            </a:xfrm>
            <a:custGeom>
              <a:avLst/>
              <a:gdLst>
                <a:gd name="csX0" fmla="*/ 99727 w 103103"/>
                <a:gd name="csY0" fmla="*/ 121944 h 121609"/>
                <a:gd name="csX1" fmla="*/ -3376 w 103103"/>
                <a:gd name="csY1" fmla="*/ 334 h 121609"/>
              </a:gdLst>
              <a:ahLst/>
              <a:cxnLst>
                <a:cxn ang="0">
                  <a:pos x="csX0" y="csY0"/>
                </a:cxn>
                <a:cxn ang="0">
                  <a:pos x="csX1" y="csY1"/>
                </a:cxn>
              </a:cxnLst>
              <a:rect l="l" t="t" r="r" b="b"/>
              <a:pathLst>
                <a:path w="103103" h="121609">
                  <a:moveTo>
                    <a:pt x="99727" y="121944"/>
                  </a:moveTo>
                  <a:lnTo>
                    <a:pt x="-3376" y="334"/>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6" name="フリーフォーム: 図形 375">
              <a:extLst>
                <a:ext uri="{FF2B5EF4-FFF2-40B4-BE49-F238E27FC236}">
                  <a16:creationId xmlns:a16="http://schemas.microsoft.com/office/drawing/2014/main" id="{5CEEBE90-CB31-58FC-77F6-96DC464C3BE5}"/>
                </a:ext>
              </a:extLst>
            </p:cNvPr>
            <p:cNvSpPr/>
            <p:nvPr/>
          </p:nvSpPr>
          <p:spPr>
            <a:xfrm>
              <a:off x="2847967" y="5465763"/>
              <a:ext cx="239953" cy="143677"/>
            </a:xfrm>
            <a:custGeom>
              <a:avLst/>
              <a:gdLst>
                <a:gd name="csX0" fmla="*/ 236662 w 239953"/>
                <a:gd name="csY0" fmla="*/ 218 h 143677"/>
                <a:gd name="csX1" fmla="*/ -3292 w 239953"/>
                <a:gd name="csY1" fmla="*/ 143895 h 143677"/>
              </a:gdLst>
              <a:ahLst/>
              <a:cxnLst>
                <a:cxn ang="0">
                  <a:pos x="csX0" y="csY0"/>
                </a:cxn>
                <a:cxn ang="0">
                  <a:pos x="csX1" y="csY1"/>
                </a:cxn>
              </a:cxnLst>
              <a:rect l="l" t="t" r="r" b="b"/>
              <a:pathLst>
                <a:path w="239953" h="143677">
                  <a:moveTo>
                    <a:pt x="236662" y="218"/>
                  </a:moveTo>
                  <a:lnTo>
                    <a:pt x="-3292" y="143895"/>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7" name="フリーフォーム: 図形 376">
              <a:extLst>
                <a:ext uri="{FF2B5EF4-FFF2-40B4-BE49-F238E27FC236}">
                  <a16:creationId xmlns:a16="http://schemas.microsoft.com/office/drawing/2014/main" id="{1A8101CD-8EB3-597E-014A-6115ADA141B1}"/>
                </a:ext>
              </a:extLst>
            </p:cNvPr>
            <p:cNvSpPr/>
            <p:nvPr/>
          </p:nvSpPr>
          <p:spPr>
            <a:xfrm>
              <a:off x="2892570" y="5418591"/>
              <a:ext cx="172026" cy="13038"/>
            </a:xfrm>
            <a:custGeom>
              <a:avLst/>
              <a:gdLst>
                <a:gd name="csX0" fmla="*/ 168732 w 172026"/>
                <a:gd name="csY0" fmla="*/ 13282 h 13038"/>
                <a:gd name="csX1" fmla="*/ -3294 w 172026"/>
                <a:gd name="csY1" fmla="*/ 244 h 13038"/>
              </a:gdLst>
              <a:ahLst/>
              <a:cxnLst>
                <a:cxn ang="0">
                  <a:pos x="csX0" y="csY0"/>
                </a:cxn>
                <a:cxn ang="0">
                  <a:pos x="csX1" y="csY1"/>
                </a:cxn>
              </a:cxnLst>
              <a:rect l="l" t="t" r="r" b="b"/>
              <a:pathLst>
                <a:path w="172026" h="13038">
                  <a:moveTo>
                    <a:pt x="168732" y="13282"/>
                  </a:moveTo>
                  <a:lnTo>
                    <a:pt x="-3294" y="244"/>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8" name="フリーフォーム: 図形 377">
              <a:extLst>
                <a:ext uri="{FF2B5EF4-FFF2-40B4-BE49-F238E27FC236}">
                  <a16:creationId xmlns:a16="http://schemas.microsoft.com/office/drawing/2014/main" id="{77BC815D-E48A-1929-7280-055AF05AC997}"/>
                </a:ext>
              </a:extLst>
            </p:cNvPr>
            <p:cNvSpPr/>
            <p:nvPr/>
          </p:nvSpPr>
          <p:spPr>
            <a:xfrm rot="260059">
              <a:off x="3064588" y="5425951"/>
              <a:ext cx="5900" cy="11801"/>
            </a:xfrm>
            <a:custGeom>
              <a:avLst/>
              <a:gdLst>
                <a:gd name="csX0" fmla="*/ 136 w 5900"/>
                <a:gd name="csY0" fmla="*/ 12078 h 11801"/>
                <a:gd name="csX1" fmla="*/ 6037 w 5900"/>
                <a:gd name="csY1" fmla="*/ 6178 h 11801"/>
                <a:gd name="csX2" fmla="*/ 136 w 5900"/>
                <a:gd name="csY2" fmla="*/ 277 h 11801"/>
              </a:gdLst>
              <a:ahLst/>
              <a:cxnLst>
                <a:cxn ang="0">
                  <a:pos x="csX0" y="csY0"/>
                </a:cxn>
                <a:cxn ang="0">
                  <a:pos x="csX1" y="csY1"/>
                </a:cxn>
                <a:cxn ang="0">
                  <a:pos x="csX2" y="csY2"/>
                </a:cxn>
              </a:cxnLst>
              <a:rect l="l" t="t" r="r" b="b"/>
              <a:pathLst>
                <a:path w="5900" h="11801">
                  <a:moveTo>
                    <a:pt x="136" y="12078"/>
                  </a:moveTo>
                  <a:cubicBezTo>
                    <a:pt x="3395" y="12078"/>
                    <a:pt x="6037" y="9437"/>
                    <a:pt x="6037" y="6178"/>
                  </a:cubicBezTo>
                  <a:cubicBezTo>
                    <a:pt x="6037" y="2919"/>
                    <a:pt x="3395" y="277"/>
                    <a:pt x="136" y="277"/>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79" name="フリーフォーム: 図形 378">
              <a:extLst>
                <a:ext uri="{FF2B5EF4-FFF2-40B4-BE49-F238E27FC236}">
                  <a16:creationId xmlns:a16="http://schemas.microsoft.com/office/drawing/2014/main" id="{47034169-2E58-6D07-BD62-B0FFB9A0FB32}"/>
                </a:ext>
              </a:extLst>
            </p:cNvPr>
            <p:cNvSpPr/>
            <p:nvPr/>
          </p:nvSpPr>
          <p:spPr>
            <a:xfrm rot="11060059">
              <a:off x="2840718" y="5403647"/>
              <a:ext cx="51926" cy="25963"/>
            </a:xfrm>
            <a:custGeom>
              <a:avLst/>
              <a:gdLst>
                <a:gd name="csX0" fmla="*/ 99 w 51926"/>
                <a:gd name="csY0" fmla="*/ 274 h 25963"/>
                <a:gd name="csX1" fmla="*/ 52026 w 51926"/>
                <a:gd name="csY1" fmla="*/ 13256 h 25963"/>
                <a:gd name="csX2" fmla="*/ 99 w 51926"/>
                <a:gd name="csY2" fmla="*/ 26237 h 25963"/>
              </a:gdLst>
              <a:ahLst/>
              <a:cxnLst>
                <a:cxn ang="0">
                  <a:pos x="csX0" y="csY0"/>
                </a:cxn>
                <a:cxn ang="0">
                  <a:pos x="csX1" y="csY1"/>
                </a:cxn>
                <a:cxn ang="0">
                  <a:pos x="csX2" y="csY2"/>
                </a:cxn>
              </a:cxnLst>
              <a:rect l="l" t="t" r="r" b="b"/>
              <a:pathLst>
                <a:path w="51926" h="25963">
                  <a:moveTo>
                    <a:pt x="99" y="274"/>
                  </a:moveTo>
                  <a:cubicBezTo>
                    <a:pt x="17408" y="8928"/>
                    <a:pt x="34717" y="13256"/>
                    <a:pt x="52026" y="13256"/>
                  </a:cubicBezTo>
                  <a:cubicBezTo>
                    <a:pt x="34717" y="13256"/>
                    <a:pt x="17408" y="17583"/>
                    <a:pt x="99" y="26237"/>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0" name="フリーフォーム: 図形 379">
              <a:extLst>
                <a:ext uri="{FF2B5EF4-FFF2-40B4-BE49-F238E27FC236}">
                  <a16:creationId xmlns:a16="http://schemas.microsoft.com/office/drawing/2014/main" id="{06B07A64-44D4-D93D-BDC8-315D5ECF32FE}"/>
                </a:ext>
              </a:extLst>
            </p:cNvPr>
            <p:cNvSpPr/>
            <p:nvPr/>
          </p:nvSpPr>
          <p:spPr>
            <a:xfrm>
              <a:off x="3008523" y="5107914"/>
              <a:ext cx="4444" cy="65233"/>
            </a:xfrm>
            <a:custGeom>
              <a:avLst/>
              <a:gdLst>
                <a:gd name="csX0" fmla="*/ -3302 w 4444"/>
                <a:gd name="csY0" fmla="*/ 65543 h 65233"/>
                <a:gd name="csX1" fmla="*/ 1142 w 4444"/>
                <a:gd name="csY1" fmla="*/ 309 h 65233"/>
              </a:gdLst>
              <a:ahLst/>
              <a:cxnLst>
                <a:cxn ang="0">
                  <a:pos x="csX0" y="csY0"/>
                </a:cxn>
                <a:cxn ang="0">
                  <a:pos x="csX1" y="csY1"/>
                </a:cxn>
              </a:cxnLst>
              <a:rect l="l" t="t" r="r" b="b"/>
              <a:pathLst>
                <a:path w="4444" h="65233">
                  <a:moveTo>
                    <a:pt x="-3302" y="65543"/>
                  </a:moveTo>
                  <a:lnTo>
                    <a:pt x="1142" y="309"/>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1" name="フリーフォーム: 図形 380">
              <a:extLst>
                <a:ext uri="{FF2B5EF4-FFF2-40B4-BE49-F238E27FC236}">
                  <a16:creationId xmlns:a16="http://schemas.microsoft.com/office/drawing/2014/main" id="{0E4DD3F1-95F2-EAB0-8923-BC2D4A2CAB57}"/>
                </a:ext>
              </a:extLst>
            </p:cNvPr>
            <p:cNvSpPr/>
            <p:nvPr/>
          </p:nvSpPr>
          <p:spPr>
            <a:xfrm rot="5633839">
              <a:off x="3005372" y="5170191"/>
              <a:ext cx="5900" cy="11801"/>
            </a:xfrm>
            <a:custGeom>
              <a:avLst/>
              <a:gdLst>
                <a:gd name="csX0" fmla="*/ 125 w 5900"/>
                <a:gd name="csY0" fmla="*/ 12029 h 11801"/>
                <a:gd name="csX1" fmla="*/ 6026 w 5900"/>
                <a:gd name="csY1" fmla="*/ 6128 h 11801"/>
                <a:gd name="csX2" fmla="*/ 125 w 5900"/>
                <a:gd name="csY2" fmla="*/ 228 h 11801"/>
              </a:gdLst>
              <a:ahLst/>
              <a:cxnLst>
                <a:cxn ang="0">
                  <a:pos x="csX0" y="csY0"/>
                </a:cxn>
                <a:cxn ang="0">
                  <a:pos x="csX1" y="csY1"/>
                </a:cxn>
                <a:cxn ang="0">
                  <a:pos x="csX2" y="csY2"/>
                </a:cxn>
              </a:cxnLst>
              <a:rect l="l" t="t" r="r" b="b"/>
              <a:pathLst>
                <a:path w="5900" h="11801">
                  <a:moveTo>
                    <a:pt x="125" y="12029"/>
                  </a:moveTo>
                  <a:cubicBezTo>
                    <a:pt x="3384" y="12029"/>
                    <a:pt x="6026" y="9387"/>
                    <a:pt x="6026" y="6128"/>
                  </a:cubicBezTo>
                  <a:cubicBezTo>
                    <a:pt x="6026" y="2869"/>
                    <a:pt x="3384" y="228"/>
                    <a:pt x="125" y="228"/>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2" name="フリーフォーム: 図形 381">
              <a:extLst>
                <a:ext uri="{FF2B5EF4-FFF2-40B4-BE49-F238E27FC236}">
                  <a16:creationId xmlns:a16="http://schemas.microsoft.com/office/drawing/2014/main" id="{06FD8318-0B88-1787-FF60-62DED9661CCF}"/>
                </a:ext>
              </a:extLst>
            </p:cNvPr>
            <p:cNvSpPr/>
            <p:nvPr/>
          </p:nvSpPr>
          <p:spPr>
            <a:xfrm rot="16433839">
              <a:off x="2988768" y="5069029"/>
              <a:ext cx="51926" cy="25963"/>
            </a:xfrm>
            <a:custGeom>
              <a:avLst/>
              <a:gdLst>
                <a:gd name="csX0" fmla="*/ 128 w 51926"/>
                <a:gd name="csY0" fmla="*/ 209 h 25963"/>
                <a:gd name="csX1" fmla="*/ 52054 w 51926"/>
                <a:gd name="csY1" fmla="*/ 13191 h 25963"/>
                <a:gd name="csX2" fmla="*/ 128 w 51926"/>
                <a:gd name="csY2" fmla="*/ 26173 h 25963"/>
              </a:gdLst>
              <a:ahLst/>
              <a:cxnLst>
                <a:cxn ang="0">
                  <a:pos x="csX0" y="csY0"/>
                </a:cxn>
                <a:cxn ang="0">
                  <a:pos x="csX1" y="csY1"/>
                </a:cxn>
                <a:cxn ang="0">
                  <a:pos x="csX2" y="csY2"/>
                </a:cxn>
              </a:cxnLst>
              <a:rect l="l" t="t" r="r" b="b"/>
              <a:pathLst>
                <a:path w="51926" h="25963">
                  <a:moveTo>
                    <a:pt x="128" y="209"/>
                  </a:moveTo>
                  <a:cubicBezTo>
                    <a:pt x="17436" y="8864"/>
                    <a:pt x="34745" y="13191"/>
                    <a:pt x="52054" y="13191"/>
                  </a:cubicBezTo>
                  <a:cubicBezTo>
                    <a:pt x="34745" y="13191"/>
                    <a:pt x="17436" y="17518"/>
                    <a:pt x="128" y="26173"/>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3" name="フリーフォーム: 図形 382">
              <a:extLst>
                <a:ext uri="{FF2B5EF4-FFF2-40B4-BE49-F238E27FC236}">
                  <a16:creationId xmlns:a16="http://schemas.microsoft.com/office/drawing/2014/main" id="{333BDE60-6909-C5DB-923F-F0304331424C}"/>
                </a:ext>
              </a:extLst>
            </p:cNvPr>
            <p:cNvSpPr/>
            <p:nvPr/>
          </p:nvSpPr>
          <p:spPr>
            <a:xfrm>
              <a:off x="2808136" y="5447323"/>
              <a:ext cx="367878" cy="362289"/>
            </a:xfrm>
            <a:custGeom>
              <a:avLst/>
              <a:gdLst>
                <a:gd name="csX0" fmla="*/ 364581 w 367878"/>
                <a:gd name="csY0" fmla="*/ 362487 h 362289"/>
                <a:gd name="csX1" fmla="*/ -3297 w 367878"/>
                <a:gd name="csY1" fmla="*/ 197 h 362289"/>
              </a:gdLst>
              <a:ahLst/>
              <a:cxnLst>
                <a:cxn ang="0">
                  <a:pos x="csX0" y="csY0"/>
                </a:cxn>
                <a:cxn ang="0">
                  <a:pos x="csX1" y="csY1"/>
                </a:cxn>
              </a:cxnLst>
              <a:rect l="l" t="t" r="r" b="b"/>
              <a:pathLst>
                <a:path w="367878" h="362289">
                  <a:moveTo>
                    <a:pt x="364581" y="362487"/>
                  </a:moveTo>
                  <a:lnTo>
                    <a:pt x="-3297" y="197"/>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4" name="フリーフォーム: 図形 383">
              <a:extLst>
                <a:ext uri="{FF2B5EF4-FFF2-40B4-BE49-F238E27FC236}">
                  <a16:creationId xmlns:a16="http://schemas.microsoft.com/office/drawing/2014/main" id="{937A9A34-734D-9C54-199C-A4207D5FB1C8}"/>
                </a:ext>
              </a:extLst>
            </p:cNvPr>
            <p:cNvSpPr/>
            <p:nvPr/>
          </p:nvSpPr>
          <p:spPr>
            <a:xfrm>
              <a:off x="3329464" y="5503691"/>
              <a:ext cx="445728" cy="288858"/>
            </a:xfrm>
            <a:custGeom>
              <a:avLst/>
              <a:gdLst>
                <a:gd name="csX0" fmla="*/ 442302 w 445728"/>
                <a:gd name="csY0" fmla="*/ 192 h 288858"/>
                <a:gd name="csX1" fmla="*/ -3427 w 445728"/>
                <a:gd name="csY1" fmla="*/ 289050 h 288858"/>
              </a:gdLst>
              <a:ahLst/>
              <a:cxnLst>
                <a:cxn ang="0">
                  <a:pos x="csX0" y="csY0"/>
                </a:cxn>
                <a:cxn ang="0">
                  <a:pos x="csX1" y="csY1"/>
                </a:cxn>
              </a:cxnLst>
              <a:rect l="l" t="t" r="r" b="b"/>
              <a:pathLst>
                <a:path w="445728" h="288858">
                  <a:moveTo>
                    <a:pt x="442302" y="192"/>
                  </a:moveTo>
                  <a:lnTo>
                    <a:pt x="-3427" y="289050"/>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5" name="フリーフォーム: 図形 384">
              <a:extLst>
                <a:ext uri="{FF2B5EF4-FFF2-40B4-BE49-F238E27FC236}">
                  <a16:creationId xmlns:a16="http://schemas.microsoft.com/office/drawing/2014/main" id="{01440521-C7DF-CAD6-9330-E3519BF9D5EE}"/>
                </a:ext>
              </a:extLst>
            </p:cNvPr>
            <p:cNvSpPr/>
            <p:nvPr/>
          </p:nvSpPr>
          <p:spPr>
            <a:xfrm rot="19623264">
              <a:off x="3774718" y="5496186"/>
              <a:ext cx="5900" cy="11801"/>
            </a:xfrm>
            <a:custGeom>
              <a:avLst/>
              <a:gdLst>
                <a:gd name="csX0" fmla="*/ 273 w 5900"/>
                <a:gd name="csY0" fmla="*/ 12092 h 11801"/>
                <a:gd name="csX1" fmla="*/ 6174 w 5900"/>
                <a:gd name="csY1" fmla="*/ 6191 h 11801"/>
                <a:gd name="csX2" fmla="*/ 273 w 5900"/>
                <a:gd name="csY2" fmla="*/ 290 h 11801"/>
              </a:gdLst>
              <a:ahLst/>
              <a:cxnLst>
                <a:cxn ang="0">
                  <a:pos x="csX0" y="csY0"/>
                </a:cxn>
                <a:cxn ang="0">
                  <a:pos x="csX1" y="csY1"/>
                </a:cxn>
                <a:cxn ang="0">
                  <a:pos x="csX2" y="csY2"/>
                </a:cxn>
              </a:cxnLst>
              <a:rect l="l" t="t" r="r" b="b"/>
              <a:pathLst>
                <a:path w="5900" h="11801">
                  <a:moveTo>
                    <a:pt x="273" y="12092"/>
                  </a:moveTo>
                  <a:cubicBezTo>
                    <a:pt x="3532" y="12092"/>
                    <a:pt x="6174" y="9450"/>
                    <a:pt x="6174" y="6191"/>
                  </a:cubicBezTo>
                  <a:cubicBezTo>
                    <a:pt x="6174" y="2932"/>
                    <a:pt x="3532" y="290"/>
                    <a:pt x="273" y="290"/>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6" name="フリーフォーム: 図形 385">
              <a:extLst>
                <a:ext uri="{FF2B5EF4-FFF2-40B4-BE49-F238E27FC236}">
                  <a16:creationId xmlns:a16="http://schemas.microsoft.com/office/drawing/2014/main" id="{5EBA29CB-6AB6-0FFF-0A57-1E2CACAA3BE9}"/>
                </a:ext>
              </a:extLst>
            </p:cNvPr>
            <p:cNvSpPr/>
            <p:nvPr/>
          </p:nvSpPr>
          <p:spPr>
            <a:xfrm rot="8823264">
              <a:off x="3281712" y="5793687"/>
              <a:ext cx="51926" cy="25963"/>
            </a:xfrm>
            <a:custGeom>
              <a:avLst/>
              <a:gdLst>
                <a:gd name="csX0" fmla="*/ 184 w 51926"/>
                <a:gd name="csY0" fmla="*/ 349 h 25963"/>
                <a:gd name="csX1" fmla="*/ 52111 w 51926"/>
                <a:gd name="csY1" fmla="*/ 13331 h 25963"/>
                <a:gd name="csX2" fmla="*/ 184 w 51926"/>
                <a:gd name="csY2" fmla="*/ 26312 h 25963"/>
              </a:gdLst>
              <a:ahLst/>
              <a:cxnLst>
                <a:cxn ang="0">
                  <a:pos x="csX0" y="csY0"/>
                </a:cxn>
                <a:cxn ang="0">
                  <a:pos x="csX1" y="csY1"/>
                </a:cxn>
                <a:cxn ang="0">
                  <a:pos x="csX2" y="csY2"/>
                </a:cxn>
              </a:cxnLst>
              <a:rect l="l" t="t" r="r" b="b"/>
              <a:pathLst>
                <a:path w="51926" h="25963">
                  <a:moveTo>
                    <a:pt x="184" y="349"/>
                  </a:moveTo>
                  <a:cubicBezTo>
                    <a:pt x="17493" y="9004"/>
                    <a:pt x="34802" y="13331"/>
                    <a:pt x="52111" y="13331"/>
                  </a:cubicBezTo>
                  <a:cubicBezTo>
                    <a:pt x="34802" y="13331"/>
                    <a:pt x="17493" y="17658"/>
                    <a:pt x="184" y="26312"/>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7" name="フリーフォーム: 図形 386">
              <a:extLst>
                <a:ext uri="{FF2B5EF4-FFF2-40B4-BE49-F238E27FC236}">
                  <a16:creationId xmlns:a16="http://schemas.microsoft.com/office/drawing/2014/main" id="{E7B04F5D-59C5-2548-F144-23A6519FE0EA}"/>
                </a:ext>
              </a:extLst>
            </p:cNvPr>
            <p:cNvSpPr/>
            <p:nvPr/>
          </p:nvSpPr>
          <p:spPr>
            <a:xfrm>
              <a:off x="3025844" y="5857974"/>
              <a:ext cx="129814" cy="856"/>
            </a:xfrm>
            <a:custGeom>
              <a:avLst/>
              <a:gdLst>
                <a:gd name="csX0" fmla="*/ 126494 w 129814"/>
                <a:gd name="csY0" fmla="*/ 1000 h 856"/>
                <a:gd name="csX1" fmla="*/ -3320 w 129814"/>
                <a:gd name="csY1" fmla="*/ 144 h 856"/>
              </a:gdLst>
              <a:ahLst/>
              <a:cxnLst>
                <a:cxn ang="0">
                  <a:pos x="csX0" y="csY0"/>
                </a:cxn>
                <a:cxn ang="0">
                  <a:pos x="csX1" y="csY1"/>
                </a:cxn>
              </a:cxnLst>
              <a:rect l="l" t="t" r="r" b="b"/>
              <a:pathLst>
                <a:path w="129814" h="856">
                  <a:moveTo>
                    <a:pt x="126494" y="1000"/>
                  </a:moveTo>
                  <a:lnTo>
                    <a:pt x="-3320" y="144"/>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8" name="フリーフォーム: 図形 387">
              <a:extLst>
                <a:ext uri="{FF2B5EF4-FFF2-40B4-BE49-F238E27FC236}">
                  <a16:creationId xmlns:a16="http://schemas.microsoft.com/office/drawing/2014/main" id="{A7614BE0-C0A0-DD8F-F5B9-C9548B83CF32}"/>
                </a:ext>
              </a:extLst>
            </p:cNvPr>
            <p:cNvSpPr/>
            <p:nvPr/>
          </p:nvSpPr>
          <p:spPr>
            <a:xfrm>
              <a:off x="2765212" y="4593128"/>
              <a:ext cx="174574" cy="40837"/>
            </a:xfrm>
            <a:custGeom>
              <a:avLst/>
              <a:gdLst>
                <a:gd name="csX0" fmla="*/ 171310 w 174574"/>
                <a:gd name="csY0" fmla="*/ 431 h 40837"/>
                <a:gd name="csX1" fmla="*/ -3265 w 174574"/>
                <a:gd name="csY1" fmla="*/ 41268 h 40837"/>
              </a:gdLst>
              <a:ahLst/>
              <a:cxnLst>
                <a:cxn ang="0">
                  <a:pos x="csX0" y="csY0"/>
                </a:cxn>
                <a:cxn ang="0">
                  <a:pos x="csX1" y="csY1"/>
                </a:cxn>
              </a:cxnLst>
              <a:rect l="l" t="t" r="r" b="b"/>
              <a:pathLst>
                <a:path w="174574" h="40837">
                  <a:moveTo>
                    <a:pt x="171310" y="431"/>
                  </a:moveTo>
                  <a:lnTo>
                    <a:pt x="-3265" y="41268"/>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89" name="フリーフォーム: 図形 388">
              <a:extLst>
                <a:ext uri="{FF2B5EF4-FFF2-40B4-BE49-F238E27FC236}">
                  <a16:creationId xmlns:a16="http://schemas.microsoft.com/office/drawing/2014/main" id="{4033BCB6-B314-0109-A681-D0B3BB4A6012}"/>
                </a:ext>
              </a:extLst>
            </p:cNvPr>
            <p:cNvSpPr/>
            <p:nvPr/>
          </p:nvSpPr>
          <p:spPr>
            <a:xfrm>
              <a:off x="3341377" y="4627051"/>
              <a:ext cx="48296" cy="79297"/>
            </a:xfrm>
            <a:custGeom>
              <a:avLst/>
              <a:gdLst>
                <a:gd name="csX0" fmla="*/ 44913 w 48296"/>
                <a:gd name="csY0" fmla="*/ 79716 h 79297"/>
                <a:gd name="csX1" fmla="*/ -3383 w 48296"/>
                <a:gd name="csY1" fmla="*/ 419 h 79297"/>
              </a:gdLst>
              <a:ahLst/>
              <a:cxnLst>
                <a:cxn ang="0">
                  <a:pos x="csX0" y="csY0"/>
                </a:cxn>
                <a:cxn ang="0">
                  <a:pos x="csX1" y="csY1"/>
                </a:cxn>
              </a:cxnLst>
              <a:rect l="l" t="t" r="r" b="b"/>
              <a:pathLst>
                <a:path w="48296" h="79297">
                  <a:moveTo>
                    <a:pt x="44913" y="79716"/>
                  </a:moveTo>
                  <a:lnTo>
                    <a:pt x="-3383" y="419"/>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0" name="フリーフォーム: 図形 389">
              <a:extLst>
                <a:ext uri="{FF2B5EF4-FFF2-40B4-BE49-F238E27FC236}">
                  <a16:creationId xmlns:a16="http://schemas.microsoft.com/office/drawing/2014/main" id="{7C303F3A-351E-1482-540B-66DA20E48F7A}"/>
                </a:ext>
              </a:extLst>
            </p:cNvPr>
            <p:cNvSpPr/>
            <p:nvPr/>
          </p:nvSpPr>
          <p:spPr>
            <a:xfrm>
              <a:off x="3813285" y="5204919"/>
              <a:ext cx="233263" cy="497383"/>
            </a:xfrm>
            <a:custGeom>
              <a:avLst/>
              <a:gdLst>
                <a:gd name="csX0" fmla="*/ 229750 w 233263"/>
                <a:gd name="csY0" fmla="*/ 497620 h 497383"/>
                <a:gd name="csX1" fmla="*/ -3514 w 233263"/>
                <a:gd name="csY1" fmla="*/ 237 h 497383"/>
              </a:gdLst>
              <a:ahLst/>
              <a:cxnLst>
                <a:cxn ang="0">
                  <a:pos x="csX0" y="csY0"/>
                </a:cxn>
                <a:cxn ang="0">
                  <a:pos x="csX1" y="csY1"/>
                </a:cxn>
              </a:cxnLst>
              <a:rect l="l" t="t" r="r" b="b"/>
              <a:pathLst>
                <a:path w="233263" h="497383">
                  <a:moveTo>
                    <a:pt x="229750" y="497620"/>
                  </a:moveTo>
                  <a:lnTo>
                    <a:pt x="-3514" y="237"/>
                  </a:lnTo>
                </a:path>
              </a:pathLst>
            </a:custGeom>
            <a:noFill/>
            <a:ln w="9429" cap="rnd">
              <a:solidFill>
                <a:srgbClr val="96969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1" name="フリーフォーム: 図形 390">
              <a:extLst>
                <a:ext uri="{FF2B5EF4-FFF2-40B4-BE49-F238E27FC236}">
                  <a16:creationId xmlns:a16="http://schemas.microsoft.com/office/drawing/2014/main" id="{F3EC86D7-0E3E-CEDA-66F6-801B94451B1C}"/>
                </a:ext>
              </a:extLst>
            </p:cNvPr>
            <p:cNvSpPr/>
            <p:nvPr/>
          </p:nvSpPr>
          <p:spPr>
            <a:xfrm>
              <a:off x="2830136" y="5172229"/>
              <a:ext cx="834437" cy="220971"/>
            </a:xfrm>
            <a:custGeom>
              <a:avLst/>
              <a:gdLst>
                <a:gd name="csX0" fmla="*/ -3356 w 834437"/>
                <a:gd name="csY0" fmla="*/ 221248 h 220971"/>
                <a:gd name="csX1" fmla="*/ 831081 w 834437"/>
                <a:gd name="csY1" fmla="*/ 276 h 220971"/>
              </a:gdLst>
              <a:ahLst/>
              <a:cxnLst>
                <a:cxn ang="0">
                  <a:pos x="csX0" y="csY0"/>
                </a:cxn>
                <a:cxn ang="0">
                  <a:pos x="csX1" y="csY1"/>
                </a:cxn>
              </a:cxnLst>
              <a:rect l="l" t="t" r="r" b="b"/>
              <a:pathLst>
                <a:path w="834437" h="220971">
                  <a:moveTo>
                    <a:pt x="-3356" y="221248"/>
                  </a:moveTo>
                  <a:lnTo>
                    <a:pt x="831081" y="276"/>
                  </a:lnTo>
                </a:path>
              </a:pathLst>
            </a:custGeom>
            <a:noFill/>
            <a:ln w="11787" cap="flat">
              <a:solidFill>
                <a:srgbClr val="FDAE61"/>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2" name="フリーフォーム: 図形 391">
              <a:extLst>
                <a:ext uri="{FF2B5EF4-FFF2-40B4-BE49-F238E27FC236}">
                  <a16:creationId xmlns:a16="http://schemas.microsoft.com/office/drawing/2014/main" id="{2677985C-210D-E455-9BC0-8BB7F20A914E}"/>
                </a:ext>
              </a:extLst>
            </p:cNvPr>
            <p:cNvSpPr/>
            <p:nvPr/>
          </p:nvSpPr>
          <p:spPr>
            <a:xfrm rot="9910059">
              <a:off x="2824334" y="5388056"/>
              <a:ext cx="5900" cy="11801"/>
            </a:xfrm>
            <a:custGeom>
              <a:avLst/>
              <a:gdLst>
                <a:gd name="csX0" fmla="*/ 90 w 5900"/>
                <a:gd name="csY0" fmla="*/ 12071 h 11801"/>
                <a:gd name="csX1" fmla="*/ 5991 w 5900"/>
                <a:gd name="csY1" fmla="*/ 6170 h 11801"/>
                <a:gd name="csX2" fmla="*/ 90 w 5900"/>
                <a:gd name="csY2" fmla="*/ 270 h 11801"/>
              </a:gdLst>
              <a:ahLst/>
              <a:cxnLst>
                <a:cxn ang="0">
                  <a:pos x="csX0" y="csY0"/>
                </a:cxn>
                <a:cxn ang="0">
                  <a:pos x="csX1" y="csY1"/>
                </a:cxn>
                <a:cxn ang="0">
                  <a:pos x="csX2" y="csY2"/>
                </a:cxn>
              </a:cxnLst>
              <a:rect l="l" t="t" r="r" b="b"/>
              <a:pathLst>
                <a:path w="5900" h="11801">
                  <a:moveTo>
                    <a:pt x="90" y="12071"/>
                  </a:moveTo>
                  <a:cubicBezTo>
                    <a:pt x="3349" y="12071"/>
                    <a:pt x="5991" y="9429"/>
                    <a:pt x="5991" y="6170"/>
                  </a:cubicBezTo>
                  <a:cubicBezTo>
                    <a:pt x="5991" y="2911"/>
                    <a:pt x="3349" y="270"/>
                    <a:pt x="90" y="270"/>
                  </a:cubicBezTo>
                  <a:close/>
                </a:path>
              </a:pathLst>
            </a:custGeom>
            <a:solidFill>
              <a:srgbClr val="FDAE61"/>
            </a:solidFill>
            <a:ln w="1178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3" name="フリーフォーム: 図形 392">
              <a:extLst>
                <a:ext uri="{FF2B5EF4-FFF2-40B4-BE49-F238E27FC236}">
                  <a16:creationId xmlns:a16="http://schemas.microsoft.com/office/drawing/2014/main" id="{4ACBF8FD-312C-E0CD-573B-5D01DAEA32E2}"/>
                </a:ext>
              </a:extLst>
            </p:cNvPr>
            <p:cNvSpPr/>
            <p:nvPr/>
          </p:nvSpPr>
          <p:spPr>
            <a:xfrm rot="20710059">
              <a:off x="3663708" y="5152601"/>
              <a:ext cx="51926" cy="25963"/>
            </a:xfrm>
            <a:custGeom>
              <a:avLst/>
              <a:gdLst>
                <a:gd name="csX0" fmla="*/ 258 w 51926"/>
                <a:gd name="csY0" fmla="*/ 226 h 25963"/>
                <a:gd name="csX1" fmla="*/ 52184 w 51926"/>
                <a:gd name="csY1" fmla="*/ 13207 h 25963"/>
                <a:gd name="csX2" fmla="*/ 258 w 51926"/>
                <a:gd name="csY2" fmla="*/ 26189 h 25963"/>
              </a:gdLst>
              <a:ahLst/>
              <a:cxnLst>
                <a:cxn ang="0">
                  <a:pos x="csX0" y="csY0"/>
                </a:cxn>
                <a:cxn ang="0">
                  <a:pos x="csX1" y="csY1"/>
                </a:cxn>
                <a:cxn ang="0">
                  <a:pos x="csX2" y="csY2"/>
                </a:cxn>
              </a:cxnLst>
              <a:rect l="l" t="t" r="r" b="b"/>
              <a:pathLst>
                <a:path w="51926" h="25963">
                  <a:moveTo>
                    <a:pt x="258" y="226"/>
                  </a:moveTo>
                  <a:cubicBezTo>
                    <a:pt x="17567" y="8880"/>
                    <a:pt x="34875" y="13207"/>
                    <a:pt x="52184" y="13207"/>
                  </a:cubicBezTo>
                  <a:cubicBezTo>
                    <a:pt x="34875" y="13207"/>
                    <a:pt x="17567" y="17534"/>
                    <a:pt x="258" y="26189"/>
                  </a:cubicBezTo>
                  <a:close/>
                </a:path>
              </a:pathLst>
            </a:custGeom>
            <a:solidFill>
              <a:srgbClr val="FDAE61"/>
            </a:solidFill>
            <a:ln w="25932"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4" name="フリーフォーム: 図形 393">
              <a:extLst>
                <a:ext uri="{FF2B5EF4-FFF2-40B4-BE49-F238E27FC236}">
                  <a16:creationId xmlns:a16="http://schemas.microsoft.com/office/drawing/2014/main" id="{6072AF65-0E5B-ADB1-31DF-48198966F70A}"/>
                </a:ext>
              </a:extLst>
            </p:cNvPr>
            <p:cNvSpPr/>
            <p:nvPr/>
          </p:nvSpPr>
          <p:spPr>
            <a:xfrm>
              <a:off x="4044919" y="5333678"/>
              <a:ext cx="141618" cy="141617"/>
            </a:xfrm>
            <a:custGeom>
              <a:avLst/>
              <a:gdLst>
                <a:gd name="csX0" fmla="*/ 67252 w 141618"/>
                <a:gd name="csY0" fmla="*/ 248 h 141617"/>
                <a:gd name="csX1" fmla="*/ 138062 w 141618"/>
                <a:gd name="csY1" fmla="*/ 71057 h 141617"/>
                <a:gd name="csX2" fmla="*/ 67252 w 141618"/>
                <a:gd name="csY2" fmla="*/ 141866 h 141617"/>
                <a:gd name="csX3" fmla="*/ -3557 w 141618"/>
                <a:gd name="csY3" fmla="*/ 71057 h 141617"/>
              </a:gdLst>
              <a:ahLst/>
              <a:cxnLst>
                <a:cxn ang="0">
                  <a:pos x="csX0" y="csY0"/>
                </a:cxn>
                <a:cxn ang="0">
                  <a:pos x="csX1" y="csY1"/>
                </a:cxn>
                <a:cxn ang="0">
                  <a:pos x="csX2" y="csY2"/>
                </a:cxn>
                <a:cxn ang="0">
                  <a:pos x="csX3" y="csY3"/>
                </a:cxn>
              </a:cxnLst>
              <a:rect l="l" t="t" r="r" b="b"/>
              <a:pathLst>
                <a:path w="141618" h="141617">
                  <a:moveTo>
                    <a:pt x="67252" y="248"/>
                  </a:moveTo>
                  <a:lnTo>
                    <a:pt x="138062" y="71057"/>
                  </a:lnTo>
                  <a:lnTo>
                    <a:pt x="67252" y="141866"/>
                  </a:lnTo>
                  <a:lnTo>
                    <a:pt x="-3557" y="71057"/>
                  </a:ln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5" name="フリーフォーム: 図形 394">
              <a:extLst>
                <a:ext uri="{FF2B5EF4-FFF2-40B4-BE49-F238E27FC236}">
                  <a16:creationId xmlns:a16="http://schemas.microsoft.com/office/drawing/2014/main" id="{55765EB3-4C29-926A-9C1B-2D1827623F0D}"/>
                </a:ext>
              </a:extLst>
            </p:cNvPr>
            <p:cNvSpPr/>
            <p:nvPr/>
          </p:nvSpPr>
          <p:spPr>
            <a:xfrm>
              <a:off x="4044919" y="5333678"/>
              <a:ext cx="141618" cy="141617"/>
            </a:xfrm>
            <a:custGeom>
              <a:avLst/>
              <a:gdLst>
                <a:gd name="csX0" fmla="*/ 67252 w 141618"/>
                <a:gd name="csY0" fmla="*/ 248 h 141617"/>
                <a:gd name="csX1" fmla="*/ 138062 w 141618"/>
                <a:gd name="csY1" fmla="*/ 71057 h 141617"/>
                <a:gd name="csX2" fmla="*/ 67252 w 141618"/>
                <a:gd name="csY2" fmla="*/ 141866 h 141617"/>
                <a:gd name="csX3" fmla="*/ -3557 w 141618"/>
                <a:gd name="csY3" fmla="*/ 71057 h 141617"/>
              </a:gdLst>
              <a:ahLst/>
              <a:cxnLst>
                <a:cxn ang="0">
                  <a:pos x="csX0" y="csY0"/>
                </a:cxn>
                <a:cxn ang="0">
                  <a:pos x="csX1" y="csY1"/>
                </a:cxn>
                <a:cxn ang="0">
                  <a:pos x="csX2" y="csY2"/>
                </a:cxn>
                <a:cxn ang="0">
                  <a:pos x="csX3" y="csY3"/>
                </a:cxn>
              </a:cxnLst>
              <a:rect l="l" t="t" r="r" b="b"/>
              <a:pathLst>
                <a:path w="141618" h="141617">
                  <a:moveTo>
                    <a:pt x="67252" y="248"/>
                  </a:moveTo>
                  <a:lnTo>
                    <a:pt x="138062" y="71057"/>
                  </a:lnTo>
                  <a:lnTo>
                    <a:pt x="67252" y="141866"/>
                  </a:lnTo>
                  <a:lnTo>
                    <a:pt x="-3557" y="71057"/>
                  </a:lnTo>
                  <a:close/>
                </a:path>
              </a:pathLst>
            </a:custGeom>
            <a:solidFill>
              <a:srgbClr val="F7F1EE"/>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6" name="テキスト ボックス 395">
              <a:extLst>
                <a:ext uri="{FF2B5EF4-FFF2-40B4-BE49-F238E27FC236}">
                  <a16:creationId xmlns:a16="http://schemas.microsoft.com/office/drawing/2014/main" id="{393CF988-0C5F-6E52-7D27-7F0930DCE1C3}"/>
                </a:ext>
              </a:extLst>
            </p:cNvPr>
            <p:cNvSpPr txBox="1"/>
            <p:nvPr/>
          </p:nvSpPr>
          <p:spPr>
            <a:xfrm>
              <a:off x="3946024" y="5327146"/>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PK2</a:t>
              </a:r>
            </a:p>
          </p:txBody>
        </p:sp>
        <p:sp>
          <p:nvSpPr>
            <p:cNvPr id="397" name="フリーフォーム: 図形 396">
              <a:extLst>
                <a:ext uri="{FF2B5EF4-FFF2-40B4-BE49-F238E27FC236}">
                  <a16:creationId xmlns:a16="http://schemas.microsoft.com/office/drawing/2014/main" id="{378E7B9E-B415-5BBA-1A41-995EA8E72EA6}"/>
                </a:ext>
              </a:extLst>
            </p:cNvPr>
            <p:cNvSpPr/>
            <p:nvPr/>
          </p:nvSpPr>
          <p:spPr>
            <a:xfrm>
              <a:off x="3976933" y="4211772"/>
              <a:ext cx="129816" cy="129816"/>
            </a:xfrm>
            <a:custGeom>
              <a:avLst/>
              <a:gdLst>
                <a:gd name="csX0" fmla="*/ 126277 w 129816"/>
                <a:gd name="csY0" fmla="*/ 65417 h 129816"/>
                <a:gd name="csX1" fmla="*/ 61369 w 129816"/>
                <a:gd name="csY1" fmla="*/ 130325 h 129816"/>
                <a:gd name="csX2" fmla="*/ -3540 w 129816"/>
                <a:gd name="csY2" fmla="*/ 65417 h 129816"/>
                <a:gd name="csX3" fmla="*/ 61369 w 129816"/>
                <a:gd name="csY3" fmla="*/ 509 h 129816"/>
                <a:gd name="csX4" fmla="*/ 126277 w 129816"/>
                <a:gd name="csY4" fmla="*/ 65417 h 129816"/>
              </a:gdLst>
              <a:ahLst/>
              <a:cxnLst>
                <a:cxn ang="0">
                  <a:pos x="csX0" y="csY0"/>
                </a:cxn>
                <a:cxn ang="0">
                  <a:pos x="csX1" y="csY1"/>
                </a:cxn>
                <a:cxn ang="0">
                  <a:pos x="csX2" y="csY2"/>
                </a:cxn>
                <a:cxn ang="0">
                  <a:pos x="csX3" y="csY3"/>
                </a:cxn>
                <a:cxn ang="0">
                  <a:pos x="csX4" y="csY4"/>
                </a:cxn>
              </a:cxnLst>
              <a:rect l="l" t="t" r="r" b="b"/>
              <a:pathLst>
                <a:path w="129816" h="129816">
                  <a:moveTo>
                    <a:pt x="126277" y="65417"/>
                  </a:moveTo>
                  <a:cubicBezTo>
                    <a:pt x="126277" y="101265"/>
                    <a:pt x="97216" y="130325"/>
                    <a:pt x="61369" y="130325"/>
                  </a:cubicBezTo>
                  <a:cubicBezTo>
                    <a:pt x="25521" y="130325"/>
                    <a:pt x="-3540" y="101265"/>
                    <a:pt x="-3540" y="65417"/>
                  </a:cubicBezTo>
                  <a:cubicBezTo>
                    <a:pt x="-3540" y="29569"/>
                    <a:pt x="25521" y="509"/>
                    <a:pt x="61369" y="509"/>
                  </a:cubicBezTo>
                  <a:cubicBezTo>
                    <a:pt x="97216" y="509"/>
                    <a:pt x="126277" y="29569"/>
                    <a:pt x="126277" y="65417"/>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8" name="フリーフォーム: 図形 397">
              <a:extLst>
                <a:ext uri="{FF2B5EF4-FFF2-40B4-BE49-F238E27FC236}">
                  <a16:creationId xmlns:a16="http://schemas.microsoft.com/office/drawing/2014/main" id="{A034AD01-3AF5-617D-9A30-44E7AFDB0680}"/>
                </a:ext>
              </a:extLst>
            </p:cNvPr>
            <p:cNvSpPr/>
            <p:nvPr/>
          </p:nvSpPr>
          <p:spPr>
            <a:xfrm>
              <a:off x="3976933" y="4211772"/>
              <a:ext cx="129816" cy="129816"/>
            </a:xfrm>
            <a:custGeom>
              <a:avLst/>
              <a:gdLst>
                <a:gd name="csX0" fmla="*/ 126277 w 129816"/>
                <a:gd name="csY0" fmla="*/ 65417 h 129816"/>
                <a:gd name="csX1" fmla="*/ 61369 w 129816"/>
                <a:gd name="csY1" fmla="*/ 130325 h 129816"/>
                <a:gd name="csX2" fmla="*/ -3540 w 129816"/>
                <a:gd name="csY2" fmla="*/ 65417 h 129816"/>
                <a:gd name="csX3" fmla="*/ 61369 w 129816"/>
                <a:gd name="csY3" fmla="*/ 509 h 129816"/>
                <a:gd name="csX4" fmla="*/ 126277 w 129816"/>
                <a:gd name="csY4" fmla="*/ 65417 h 129816"/>
              </a:gdLst>
              <a:ahLst/>
              <a:cxnLst>
                <a:cxn ang="0">
                  <a:pos x="csX0" y="csY0"/>
                </a:cxn>
                <a:cxn ang="0">
                  <a:pos x="csX1" y="csY1"/>
                </a:cxn>
                <a:cxn ang="0">
                  <a:pos x="csX2" y="csY2"/>
                </a:cxn>
                <a:cxn ang="0">
                  <a:pos x="csX3" y="csY3"/>
                </a:cxn>
                <a:cxn ang="0">
                  <a:pos x="csX4" y="csY4"/>
                </a:cxn>
              </a:cxnLst>
              <a:rect l="l" t="t" r="r" b="b"/>
              <a:pathLst>
                <a:path w="129816" h="129816">
                  <a:moveTo>
                    <a:pt x="126277" y="65417"/>
                  </a:moveTo>
                  <a:cubicBezTo>
                    <a:pt x="126277" y="101265"/>
                    <a:pt x="97216" y="130325"/>
                    <a:pt x="61369" y="130325"/>
                  </a:cubicBezTo>
                  <a:cubicBezTo>
                    <a:pt x="25521" y="130325"/>
                    <a:pt x="-3540" y="101265"/>
                    <a:pt x="-3540" y="65417"/>
                  </a:cubicBezTo>
                  <a:cubicBezTo>
                    <a:pt x="-3540" y="29569"/>
                    <a:pt x="25521" y="509"/>
                    <a:pt x="61369" y="509"/>
                  </a:cubicBezTo>
                  <a:cubicBezTo>
                    <a:pt x="97216" y="509"/>
                    <a:pt x="126277" y="29569"/>
                    <a:pt x="126277" y="65417"/>
                  </a:cubicBezTo>
                  <a:close/>
                </a:path>
              </a:pathLst>
            </a:custGeom>
            <a:solidFill>
              <a:srgbClr val="4292C6"/>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399" name="テキスト ボックス 398">
              <a:extLst>
                <a:ext uri="{FF2B5EF4-FFF2-40B4-BE49-F238E27FC236}">
                  <a16:creationId xmlns:a16="http://schemas.microsoft.com/office/drawing/2014/main" id="{02156C6D-B7D0-3A68-286D-5BE785391B59}"/>
                </a:ext>
              </a:extLst>
            </p:cNvPr>
            <p:cNvSpPr txBox="1"/>
            <p:nvPr/>
          </p:nvSpPr>
          <p:spPr>
            <a:xfrm>
              <a:off x="3865116" y="4198180"/>
              <a:ext cx="38183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RA1F3</a:t>
              </a:r>
            </a:p>
          </p:txBody>
        </p:sp>
        <p:sp>
          <p:nvSpPr>
            <p:cNvPr id="400" name="フリーフォーム: 図形 399">
              <a:extLst>
                <a:ext uri="{FF2B5EF4-FFF2-40B4-BE49-F238E27FC236}">
                  <a16:creationId xmlns:a16="http://schemas.microsoft.com/office/drawing/2014/main" id="{1ECD7BF1-2672-521B-D0A9-FCA151195F22}"/>
                </a:ext>
              </a:extLst>
            </p:cNvPr>
            <p:cNvSpPr/>
            <p:nvPr/>
          </p:nvSpPr>
          <p:spPr>
            <a:xfrm>
              <a:off x="2762115" y="4819802"/>
              <a:ext cx="141618" cy="141617"/>
            </a:xfrm>
            <a:custGeom>
              <a:avLst/>
              <a:gdLst>
                <a:gd name="csX0" fmla="*/ 67549 w 141618"/>
                <a:gd name="csY0" fmla="*/ 367 h 141617"/>
                <a:gd name="csX1" fmla="*/ 138358 w 141618"/>
                <a:gd name="csY1" fmla="*/ 71176 h 141617"/>
                <a:gd name="csX2" fmla="*/ 67549 w 141618"/>
                <a:gd name="csY2" fmla="*/ 141985 h 141617"/>
                <a:gd name="csX3" fmla="*/ -3261 w 141618"/>
                <a:gd name="csY3" fmla="*/ 71176 h 141617"/>
              </a:gdLst>
              <a:ahLst/>
              <a:cxnLst>
                <a:cxn ang="0">
                  <a:pos x="csX0" y="csY0"/>
                </a:cxn>
                <a:cxn ang="0">
                  <a:pos x="csX1" y="csY1"/>
                </a:cxn>
                <a:cxn ang="0">
                  <a:pos x="csX2" y="csY2"/>
                </a:cxn>
                <a:cxn ang="0">
                  <a:pos x="csX3" y="csY3"/>
                </a:cxn>
              </a:cxnLst>
              <a:rect l="l" t="t" r="r" b="b"/>
              <a:pathLst>
                <a:path w="141618" h="141617">
                  <a:moveTo>
                    <a:pt x="67549" y="367"/>
                  </a:moveTo>
                  <a:lnTo>
                    <a:pt x="138358" y="71176"/>
                  </a:lnTo>
                  <a:lnTo>
                    <a:pt x="67549" y="141985"/>
                  </a:lnTo>
                  <a:lnTo>
                    <a:pt x="-3261" y="71176"/>
                  </a:ln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01" name="フリーフォーム: 図形 400">
              <a:extLst>
                <a:ext uri="{FF2B5EF4-FFF2-40B4-BE49-F238E27FC236}">
                  <a16:creationId xmlns:a16="http://schemas.microsoft.com/office/drawing/2014/main" id="{3A1194A3-706D-82DD-5FFA-915CC5D07898}"/>
                </a:ext>
              </a:extLst>
            </p:cNvPr>
            <p:cNvSpPr/>
            <p:nvPr/>
          </p:nvSpPr>
          <p:spPr>
            <a:xfrm>
              <a:off x="2762115" y="4819802"/>
              <a:ext cx="141618" cy="141617"/>
            </a:xfrm>
            <a:custGeom>
              <a:avLst/>
              <a:gdLst>
                <a:gd name="csX0" fmla="*/ 67549 w 141618"/>
                <a:gd name="csY0" fmla="*/ 367 h 141617"/>
                <a:gd name="csX1" fmla="*/ 138358 w 141618"/>
                <a:gd name="csY1" fmla="*/ 71176 h 141617"/>
                <a:gd name="csX2" fmla="*/ 67549 w 141618"/>
                <a:gd name="csY2" fmla="*/ 141985 h 141617"/>
                <a:gd name="csX3" fmla="*/ -3261 w 141618"/>
                <a:gd name="csY3" fmla="*/ 71176 h 141617"/>
              </a:gdLst>
              <a:ahLst/>
              <a:cxnLst>
                <a:cxn ang="0">
                  <a:pos x="csX0" y="csY0"/>
                </a:cxn>
                <a:cxn ang="0">
                  <a:pos x="csX1" y="csY1"/>
                </a:cxn>
                <a:cxn ang="0">
                  <a:pos x="csX2" y="csY2"/>
                </a:cxn>
                <a:cxn ang="0">
                  <a:pos x="csX3" y="csY3"/>
                </a:cxn>
              </a:cxnLst>
              <a:rect l="l" t="t" r="r" b="b"/>
              <a:pathLst>
                <a:path w="141618" h="141617">
                  <a:moveTo>
                    <a:pt x="67549" y="367"/>
                  </a:moveTo>
                  <a:lnTo>
                    <a:pt x="138358" y="71176"/>
                  </a:lnTo>
                  <a:lnTo>
                    <a:pt x="67549" y="141985"/>
                  </a:lnTo>
                  <a:lnTo>
                    <a:pt x="-3261" y="71176"/>
                  </a:lnTo>
                  <a:close/>
                </a:path>
              </a:pathLst>
            </a:custGeom>
            <a:solidFill>
              <a:srgbClr val="EFF2F5"/>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02" name="テキスト ボックス 401">
              <a:extLst>
                <a:ext uri="{FF2B5EF4-FFF2-40B4-BE49-F238E27FC236}">
                  <a16:creationId xmlns:a16="http://schemas.microsoft.com/office/drawing/2014/main" id="{B67A4D5B-8CC1-2FF9-519C-79C006F2B870}"/>
                </a:ext>
              </a:extLst>
            </p:cNvPr>
            <p:cNvSpPr txBox="1"/>
            <p:nvPr/>
          </p:nvSpPr>
          <p:spPr>
            <a:xfrm>
              <a:off x="2646045" y="4813768"/>
              <a:ext cx="35618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HOT2</a:t>
              </a:r>
            </a:p>
          </p:txBody>
        </p:sp>
        <p:sp>
          <p:nvSpPr>
            <p:cNvPr id="403" name="フリーフォーム: 図形 402">
              <a:extLst>
                <a:ext uri="{FF2B5EF4-FFF2-40B4-BE49-F238E27FC236}">
                  <a16:creationId xmlns:a16="http://schemas.microsoft.com/office/drawing/2014/main" id="{075C7080-7B53-77DE-9E07-C4F2D2085300}"/>
                </a:ext>
              </a:extLst>
            </p:cNvPr>
            <p:cNvSpPr/>
            <p:nvPr/>
          </p:nvSpPr>
          <p:spPr>
            <a:xfrm>
              <a:off x="2661577" y="5061271"/>
              <a:ext cx="129816" cy="129816"/>
            </a:xfrm>
            <a:custGeom>
              <a:avLst/>
              <a:gdLst>
                <a:gd name="csX0" fmla="*/ 126581 w 129816"/>
                <a:gd name="csY0" fmla="*/ 65221 h 129816"/>
                <a:gd name="csX1" fmla="*/ 61672 w 129816"/>
                <a:gd name="csY1" fmla="*/ 130129 h 129816"/>
                <a:gd name="csX2" fmla="*/ -3236 w 129816"/>
                <a:gd name="csY2" fmla="*/ 65221 h 129816"/>
                <a:gd name="csX3" fmla="*/ 61672 w 129816"/>
                <a:gd name="csY3" fmla="*/ 313 h 129816"/>
                <a:gd name="csX4" fmla="*/ 126581 w 129816"/>
                <a:gd name="csY4" fmla="*/ 65221 h 129816"/>
              </a:gdLst>
              <a:ahLst/>
              <a:cxnLst>
                <a:cxn ang="0">
                  <a:pos x="csX0" y="csY0"/>
                </a:cxn>
                <a:cxn ang="0">
                  <a:pos x="csX1" y="csY1"/>
                </a:cxn>
                <a:cxn ang="0">
                  <a:pos x="csX2" y="csY2"/>
                </a:cxn>
                <a:cxn ang="0">
                  <a:pos x="csX3" y="csY3"/>
                </a:cxn>
                <a:cxn ang="0">
                  <a:pos x="csX4" y="csY4"/>
                </a:cxn>
              </a:cxnLst>
              <a:rect l="l" t="t" r="r" b="b"/>
              <a:pathLst>
                <a:path w="129816" h="129816">
                  <a:moveTo>
                    <a:pt x="126581" y="65221"/>
                  </a:moveTo>
                  <a:cubicBezTo>
                    <a:pt x="126581" y="101069"/>
                    <a:pt x="97520" y="130129"/>
                    <a:pt x="61672" y="130129"/>
                  </a:cubicBezTo>
                  <a:cubicBezTo>
                    <a:pt x="25825" y="130129"/>
                    <a:pt x="-3236" y="101069"/>
                    <a:pt x="-3236" y="65221"/>
                  </a:cubicBezTo>
                  <a:cubicBezTo>
                    <a:pt x="-3236" y="29373"/>
                    <a:pt x="25825" y="313"/>
                    <a:pt x="61672" y="313"/>
                  </a:cubicBezTo>
                  <a:cubicBezTo>
                    <a:pt x="97520" y="313"/>
                    <a:pt x="126581" y="29373"/>
                    <a:pt x="126581" y="65221"/>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04" name="フリーフォーム: 図形 403">
              <a:extLst>
                <a:ext uri="{FF2B5EF4-FFF2-40B4-BE49-F238E27FC236}">
                  <a16:creationId xmlns:a16="http://schemas.microsoft.com/office/drawing/2014/main" id="{28A59FEE-1620-0159-3EF5-9E5A0F5AA9A4}"/>
                </a:ext>
              </a:extLst>
            </p:cNvPr>
            <p:cNvSpPr/>
            <p:nvPr/>
          </p:nvSpPr>
          <p:spPr>
            <a:xfrm>
              <a:off x="2661577" y="5061271"/>
              <a:ext cx="129816" cy="129816"/>
            </a:xfrm>
            <a:custGeom>
              <a:avLst/>
              <a:gdLst>
                <a:gd name="csX0" fmla="*/ 126581 w 129816"/>
                <a:gd name="csY0" fmla="*/ 65221 h 129816"/>
                <a:gd name="csX1" fmla="*/ 61672 w 129816"/>
                <a:gd name="csY1" fmla="*/ 130129 h 129816"/>
                <a:gd name="csX2" fmla="*/ -3236 w 129816"/>
                <a:gd name="csY2" fmla="*/ 65221 h 129816"/>
                <a:gd name="csX3" fmla="*/ 61672 w 129816"/>
                <a:gd name="csY3" fmla="*/ 313 h 129816"/>
                <a:gd name="csX4" fmla="*/ 126581 w 129816"/>
                <a:gd name="csY4" fmla="*/ 65221 h 129816"/>
              </a:gdLst>
              <a:ahLst/>
              <a:cxnLst>
                <a:cxn ang="0">
                  <a:pos x="csX0" y="csY0"/>
                </a:cxn>
                <a:cxn ang="0">
                  <a:pos x="csX1" y="csY1"/>
                </a:cxn>
                <a:cxn ang="0">
                  <a:pos x="csX2" y="csY2"/>
                </a:cxn>
                <a:cxn ang="0">
                  <a:pos x="csX3" y="csY3"/>
                </a:cxn>
                <a:cxn ang="0">
                  <a:pos x="csX4" y="csY4"/>
                </a:cxn>
              </a:cxnLst>
              <a:rect l="l" t="t" r="r" b="b"/>
              <a:pathLst>
                <a:path w="129816" h="129816">
                  <a:moveTo>
                    <a:pt x="126581" y="65221"/>
                  </a:moveTo>
                  <a:cubicBezTo>
                    <a:pt x="126581" y="101069"/>
                    <a:pt x="97520" y="130129"/>
                    <a:pt x="61672" y="130129"/>
                  </a:cubicBezTo>
                  <a:cubicBezTo>
                    <a:pt x="25825" y="130129"/>
                    <a:pt x="-3236" y="101069"/>
                    <a:pt x="-3236" y="65221"/>
                  </a:cubicBezTo>
                  <a:cubicBezTo>
                    <a:pt x="-3236" y="29373"/>
                    <a:pt x="25825" y="313"/>
                    <a:pt x="61672" y="313"/>
                  </a:cubicBezTo>
                  <a:cubicBezTo>
                    <a:pt x="97520" y="313"/>
                    <a:pt x="126581" y="29373"/>
                    <a:pt x="126581" y="65221"/>
                  </a:cubicBezTo>
                  <a:close/>
                </a:path>
              </a:pathLst>
            </a:custGeom>
            <a:solidFill>
              <a:srgbClr val="D5E4EE"/>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05" name="テキスト ボックス 404">
              <a:extLst>
                <a:ext uri="{FF2B5EF4-FFF2-40B4-BE49-F238E27FC236}">
                  <a16:creationId xmlns:a16="http://schemas.microsoft.com/office/drawing/2014/main" id="{1F0B71A0-ECF8-7BA8-AC7E-B450C6E97F9E}"/>
                </a:ext>
              </a:extLst>
            </p:cNvPr>
            <p:cNvSpPr txBox="1"/>
            <p:nvPr/>
          </p:nvSpPr>
          <p:spPr>
            <a:xfrm>
              <a:off x="2560002" y="5055191"/>
              <a:ext cx="34176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IP2-6</a:t>
              </a:r>
            </a:p>
          </p:txBody>
        </p:sp>
        <p:sp>
          <p:nvSpPr>
            <p:cNvPr id="406" name="フリーフォーム: 図形 405">
              <a:extLst>
                <a:ext uri="{FF2B5EF4-FFF2-40B4-BE49-F238E27FC236}">
                  <a16:creationId xmlns:a16="http://schemas.microsoft.com/office/drawing/2014/main" id="{F374B941-7491-BE62-9AA9-D2D1FEE8C674}"/>
                </a:ext>
              </a:extLst>
            </p:cNvPr>
            <p:cNvSpPr/>
            <p:nvPr/>
          </p:nvSpPr>
          <p:spPr>
            <a:xfrm>
              <a:off x="3466223" y="5833247"/>
              <a:ext cx="144000" cy="144000"/>
            </a:xfrm>
            <a:custGeom>
              <a:avLst/>
              <a:gdLst>
                <a:gd name="csX0" fmla="*/ 126395 w 129816"/>
                <a:gd name="csY0" fmla="*/ 65041 h 129816"/>
                <a:gd name="csX1" fmla="*/ 61487 w 129816"/>
                <a:gd name="csY1" fmla="*/ 129949 h 129816"/>
                <a:gd name="csX2" fmla="*/ -3421 w 129816"/>
                <a:gd name="csY2" fmla="*/ 65041 h 129816"/>
                <a:gd name="csX3" fmla="*/ 61487 w 129816"/>
                <a:gd name="csY3" fmla="*/ 133 h 129816"/>
                <a:gd name="csX4" fmla="*/ 126395 w 129816"/>
                <a:gd name="csY4" fmla="*/ 65041 h 129816"/>
              </a:gdLst>
              <a:ahLst/>
              <a:cxnLst>
                <a:cxn ang="0">
                  <a:pos x="csX0" y="csY0"/>
                </a:cxn>
                <a:cxn ang="0">
                  <a:pos x="csX1" y="csY1"/>
                </a:cxn>
                <a:cxn ang="0">
                  <a:pos x="csX2" y="csY2"/>
                </a:cxn>
                <a:cxn ang="0">
                  <a:pos x="csX3" y="csY3"/>
                </a:cxn>
                <a:cxn ang="0">
                  <a:pos x="csX4" y="csY4"/>
                </a:cxn>
              </a:cxnLst>
              <a:rect l="l" t="t" r="r" b="b"/>
              <a:pathLst>
                <a:path w="129816" h="129816">
                  <a:moveTo>
                    <a:pt x="126395" y="65041"/>
                  </a:moveTo>
                  <a:cubicBezTo>
                    <a:pt x="126395" y="100889"/>
                    <a:pt x="97335" y="129949"/>
                    <a:pt x="61487" y="129949"/>
                  </a:cubicBezTo>
                  <a:cubicBezTo>
                    <a:pt x="25639" y="129949"/>
                    <a:pt x="-3421" y="100889"/>
                    <a:pt x="-3421" y="65041"/>
                  </a:cubicBezTo>
                  <a:cubicBezTo>
                    <a:pt x="-3421" y="29193"/>
                    <a:pt x="25639" y="133"/>
                    <a:pt x="61487" y="133"/>
                  </a:cubicBezTo>
                  <a:cubicBezTo>
                    <a:pt x="97335" y="133"/>
                    <a:pt x="126395" y="29193"/>
                    <a:pt x="126395" y="65041"/>
                  </a:cubicBezTo>
                  <a:close/>
                </a:path>
              </a:pathLst>
            </a:custGeom>
            <a:solidFill>
              <a:srgbClr val="F8D3C0"/>
            </a:solidFill>
            <a:ln w="6350" cap="sq">
              <a:solidFill>
                <a:schemeClr val="accent2"/>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07" name="テキスト ボックス 406">
              <a:extLst>
                <a:ext uri="{FF2B5EF4-FFF2-40B4-BE49-F238E27FC236}">
                  <a16:creationId xmlns:a16="http://schemas.microsoft.com/office/drawing/2014/main" id="{B654FC60-259D-8A6C-60D7-B4D186AB3D83}"/>
                </a:ext>
              </a:extLst>
            </p:cNvPr>
            <p:cNvSpPr txBox="1"/>
            <p:nvPr/>
          </p:nvSpPr>
          <p:spPr>
            <a:xfrm>
              <a:off x="3335857" y="5831342"/>
              <a:ext cx="41389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BHLH122</a:t>
              </a:r>
            </a:p>
          </p:txBody>
        </p:sp>
        <p:sp>
          <p:nvSpPr>
            <p:cNvPr id="408" name="フリーフォーム: 図形 407">
              <a:extLst>
                <a:ext uri="{FF2B5EF4-FFF2-40B4-BE49-F238E27FC236}">
                  <a16:creationId xmlns:a16="http://schemas.microsoft.com/office/drawing/2014/main" id="{FC49CB4A-6D2F-BC3F-F140-2ECD1A747F49}"/>
                </a:ext>
              </a:extLst>
            </p:cNvPr>
            <p:cNvSpPr/>
            <p:nvPr/>
          </p:nvSpPr>
          <p:spPr>
            <a:xfrm>
              <a:off x="3594783" y="4331681"/>
              <a:ext cx="129816" cy="129816"/>
            </a:xfrm>
            <a:custGeom>
              <a:avLst/>
              <a:gdLst>
                <a:gd name="csX0" fmla="*/ 126365 w 129816"/>
                <a:gd name="csY0" fmla="*/ 65389 h 129816"/>
                <a:gd name="csX1" fmla="*/ 61457 w 129816"/>
                <a:gd name="csY1" fmla="*/ 130297 h 129816"/>
                <a:gd name="csX2" fmla="*/ -3451 w 129816"/>
                <a:gd name="csY2" fmla="*/ 65389 h 129816"/>
                <a:gd name="csX3" fmla="*/ 61457 w 129816"/>
                <a:gd name="csY3" fmla="*/ 481 h 129816"/>
                <a:gd name="csX4" fmla="*/ 126365 w 129816"/>
                <a:gd name="csY4" fmla="*/ 65389 h 129816"/>
              </a:gdLst>
              <a:ahLst/>
              <a:cxnLst>
                <a:cxn ang="0">
                  <a:pos x="csX0" y="csY0"/>
                </a:cxn>
                <a:cxn ang="0">
                  <a:pos x="csX1" y="csY1"/>
                </a:cxn>
                <a:cxn ang="0">
                  <a:pos x="csX2" y="csY2"/>
                </a:cxn>
                <a:cxn ang="0">
                  <a:pos x="csX3" y="csY3"/>
                </a:cxn>
                <a:cxn ang="0">
                  <a:pos x="csX4" y="csY4"/>
                </a:cxn>
              </a:cxnLst>
              <a:rect l="l" t="t" r="r" b="b"/>
              <a:pathLst>
                <a:path w="129816" h="129816">
                  <a:moveTo>
                    <a:pt x="126365" y="65389"/>
                  </a:moveTo>
                  <a:cubicBezTo>
                    <a:pt x="126365" y="101237"/>
                    <a:pt x="97305" y="130297"/>
                    <a:pt x="61457" y="130297"/>
                  </a:cubicBezTo>
                  <a:cubicBezTo>
                    <a:pt x="25609" y="130297"/>
                    <a:pt x="-3451" y="101237"/>
                    <a:pt x="-3451" y="65389"/>
                  </a:cubicBezTo>
                  <a:cubicBezTo>
                    <a:pt x="-3451" y="29541"/>
                    <a:pt x="25609" y="481"/>
                    <a:pt x="61457" y="481"/>
                  </a:cubicBezTo>
                  <a:cubicBezTo>
                    <a:pt x="97305" y="481"/>
                    <a:pt x="126365" y="29541"/>
                    <a:pt x="126365" y="65389"/>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09" name="フリーフォーム: 図形 408">
              <a:extLst>
                <a:ext uri="{FF2B5EF4-FFF2-40B4-BE49-F238E27FC236}">
                  <a16:creationId xmlns:a16="http://schemas.microsoft.com/office/drawing/2014/main" id="{C59A29FF-DA6D-CBBA-8352-2E3ED4B8A5C6}"/>
                </a:ext>
              </a:extLst>
            </p:cNvPr>
            <p:cNvSpPr/>
            <p:nvPr/>
          </p:nvSpPr>
          <p:spPr>
            <a:xfrm>
              <a:off x="3594783" y="4331681"/>
              <a:ext cx="129816" cy="129816"/>
            </a:xfrm>
            <a:custGeom>
              <a:avLst/>
              <a:gdLst>
                <a:gd name="csX0" fmla="*/ 126365 w 129816"/>
                <a:gd name="csY0" fmla="*/ 65389 h 129816"/>
                <a:gd name="csX1" fmla="*/ 61457 w 129816"/>
                <a:gd name="csY1" fmla="*/ 130297 h 129816"/>
                <a:gd name="csX2" fmla="*/ -3451 w 129816"/>
                <a:gd name="csY2" fmla="*/ 65389 h 129816"/>
                <a:gd name="csX3" fmla="*/ 61457 w 129816"/>
                <a:gd name="csY3" fmla="*/ 481 h 129816"/>
                <a:gd name="csX4" fmla="*/ 126365 w 129816"/>
                <a:gd name="csY4" fmla="*/ 65389 h 129816"/>
              </a:gdLst>
              <a:ahLst/>
              <a:cxnLst>
                <a:cxn ang="0">
                  <a:pos x="csX0" y="csY0"/>
                </a:cxn>
                <a:cxn ang="0">
                  <a:pos x="csX1" y="csY1"/>
                </a:cxn>
                <a:cxn ang="0">
                  <a:pos x="csX2" y="csY2"/>
                </a:cxn>
                <a:cxn ang="0">
                  <a:pos x="csX3" y="csY3"/>
                </a:cxn>
                <a:cxn ang="0">
                  <a:pos x="csX4" y="csY4"/>
                </a:cxn>
              </a:cxnLst>
              <a:rect l="l" t="t" r="r" b="b"/>
              <a:pathLst>
                <a:path w="129816" h="129816">
                  <a:moveTo>
                    <a:pt x="126365" y="65389"/>
                  </a:moveTo>
                  <a:cubicBezTo>
                    <a:pt x="126365" y="101237"/>
                    <a:pt x="97305" y="130297"/>
                    <a:pt x="61457" y="130297"/>
                  </a:cubicBezTo>
                  <a:cubicBezTo>
                    <a:pt x="25609" y="130297"/>
                    <a:pt x="-3451" y="101237"/>
                    <a:pt x="-3451" y="65389"/>
                  </a:cubicBezTo>
                  <a:cubicBezTo>
                    <a:pt x="-3451" y="29541"/>
                    <a:pt x="25609" y="481"/>
                    <a:pt x="61457" y="481"/>
                  </a:cubicBezTo>
                  <a:cubicBezTo>
                    <a:pt x="97305" y="481"/>
                    <a:pt x="126365" y="29541"/>
                    <a:pt x="126365" y="65389"/>
                  </a:cubicBezTo>
                  <a:close/>
                </a:path>
              </a:pathLst>
            </a:custGeom>
            <a:solidFill>
              <a:srgbClr val="F8DBCD"/>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10" name="テキスト ボックス 409">
              <a:extLst>
                <a:ext uri="{FF2B5EF4-FFF2-40B4-BE49-F238E27FC236}">
                  <a16:creationId xmlns:a16="http://schemas.microsoft.com/office/drawing/2014/main" id="{2076170B-8D08-7522-0813-C7A9BDF656BC}"/>
                </a:ext>
              </a:extLst>
            </p:cNvPr>
            <p:cNvSpPr txBox="1"/>
            <p:nvPr/>
          </p:nvSpPr>
          <p:spPr>
            <a:xfrm>
              <a:off x="3493259" y="4319995"/>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UGD4</a:t>
              </a:r>
            </a:p>
          </p:txBody>
        </p:sp>
        <p:sp>
          <p:nvSpPr>
            <p:cNvPr id="411" name="フリーフォーム: 図形 410">
              <a:extLst>
                <a:ext uri="{FF2B5EF4-FFF2-40B4-BE49-F238E27FC236}">
                  <a16:creationId xmlns:a16="http://schemas.microsoft.com/office/drawing/2014/main" id="{FDD77B9C-3DCC-A1A4-52A1-CD3AA6EAB70A}"/>
                </a:ext>
              </a:extLst>
            </p:cNvPr>
            <p:cNvSpPr/>
            <p:nvPr/>
          </p:nvSpPr>
          <p:spPr>
            <a:xfrm>
              <a:off x="3407669" y="5359519"/>
              <a:ext cx="141618" cy="141617"/>
            </a:xfrm>
            <a:custGeom>
              <a:avLst/>
              <a:gdLst>
                <a:gd name="csX0" fmla="*/ 67400 w 141618"/>
                <a:gd name="csY0" fmla="*/ 242 h 141617"/>
                <a:gd name="csX1" fmla="*/ 138209 w 141618"/>
                <a:gd name="csY1" fmla="*/ 71051 h 141617"/>
                <a:gd name="csX2" fmla="*/ 67400 w 141618"/>
                <a:gd name="csY2" fmla="*/ 141860 h 141617"/>
                <a:gd name="csX3" fmla="*/ -3410 w 141618"/>
                <a:gd name="csY3" fmla="*/ 71051 h 141617"/>
              </a:gdLst>
              <a:ahLst/>
              <a:cxnLst>
                <a:cxn ang="0">
                  <a:pos x="csX0" y="csY0"/>
                </a:cxn>
                <a:cxn ang="0">
                  <a:pos x="csX1" y="csY1"/>
                </a:cxn>
                <a:cxn ang="0">
                  <a:pos x="csX2" y="csY2"/>
                </a:cxn>
                <a:cxn ang="0">
                  <a:pos x="csX3" y="csY3"/>
                </a:cxn>
              </a:cxnLst>
              <a:rect l="l" t="t" r="r" b="b"/>
              <a:pathLst>
                <a:path w="141618" h="141617">
                  <a:moveTo>
                    <a:pt x="67400" y="242"/>
                  </a:moveTo>
                  <a:lnTo>
                    <a:pt x="138209" y="71051"/>
                  </a:lnTo>
                  <a:lnTo>
                    <a:pt x="67400" y="141860"/>
                  </a:lnTo>
                  <a:lnTo>
                    <a:pt x="-3410" y="71051"/>
                  </a:ln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12" name="フリーフォーム: 図形 411">
              <a:extLst>
                <a:ext uri="{FF2B5EF4-FFF2-40B4-BE49-F238E27FC236}">
                  <a16:creationId xmlns:a16="http://schemas.microsoft.com/office/drawing/2014/main" id="{09978FFC-327E-C0F7-7011-A812B95DFE67}"/>
                </a:ext>
              </a:extLst>
            </p:cNvPr>
            <p:cNvSpPr/>
            <p:nvPr/>
          </p:nvSpPr>
          <p:spPr>
            <a:xfrm>
              <a:off x="3407669" y="5359519"/>
              <a:ext cx="141618" cy="141617"/>
            </a:xfrm>
            <a:custGeom>
              <a:avLst/>
              <a:gdLst>
                <a:gd name="csX0" fmla="*/ 67400 w 141618"/>
                <a:gd name="csY0" fmla="*/ 242 h 141617"/>
                <a:gd name="csX1" fmla="*/ 138209 w 141618"/>
                <a:gd name="csY1" fmla="*/ 71051 h 141617"/>
                <a:gd name="csX2" fmla="*/ 67400 w 141618"/>
                <a:gd name="csY2" fmla="*/ 141860 h 141617"/>
                <a:gd name="csX3" fmla="*/ -3410 w 141618"/>
                <a:gd name="csY3" fmla="*/ 71051 h 141617"/>
              </a:gdLst>
              <a:ahLst/>
              <a:cxnLst>
                <a:cxn ang="0">
                  <a:pos x="csX0" y="csY0"/>
                </a:cxn>
                <a:cxn ang="0">
                  <a:pos x="csX1" y="csY1"/>
                </a:cxn>
                <a:cxn ang="0">
                  <a:pos x="csX2" y="csY2"/>
                </a:cxn>
                <a:cxn ang="0">
                  <a:pos x="csX3" y="csY3"/>
                </a:cxn>
              </a:cxnLst>
              <a:rect l="l" t="t" r="r" b="b"/>
              <a:pathLst>
                <a:path w="141618" h="141617">
                  <a:moveTo>
                    <a:pt x="67400" y="242"/>
                  </a:moveTo>
                  <a:lnTo>
                    <a:pt x="138209" y="71051"/>
                  </a:lnTo>
                  <a:lnTo>
                    <a:pt x="67400" y="141860"/>
                  </a:lnTo>
                  <a:lnTo>
                    <a:pt x="-3410" y="71051"/>
                  </a:lnTo>
                  <a:close/>
                </a:path>
              </a:pathLst>
            </a:custGeom>
            <a:solidFill>
              <a:srgbClr val="F8DCCE"/>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13" name="テキスト ボックス 412">
              <a:extLst>
                <a:ext uri="{FF2B5EF4-FFF2-40B4-BE49-F238E27FC236}">
                  <a16:creationId xmlns:a16="http://schemas.microsoft.com/office/drawing/2014/main" id="{BBC83359-BDFF-063D-DD2D-665BC62D43F6}"/>
                </a:ext>
              </a:extLst>
            </p:cNvPr>
            <p:cNvSpPr txBox="1"/>
            <p:nvPr/>
          </p:nvSpPr>
          <p:spPr>
            <a:xfrm>
              <a:off x="3298175" y="5352782"/>
              <a:ext cx="35137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RK2E</a:t>
              </a:r>
            </a:p>
          </p:txBody>
        </p:sp>
        <p:sp>
          <p:nvSpPr>
            <p:cNvPr id="414" name="フリーフォーム: 図形 413">
              <a:extLst>
                <a:ext uri="{FF2B5EF4-FFF2-40B4-BE49-F238E27FC236}">
                  <a16:creationId xmlns:a16="http://schemas.microsoft.com/office/drawing/2014/main" id="{37C5C1A7-0103-11E4-2042-9036D128DED1}"/>
                </a:ext>
              </a:extLst>
            </p:cNvPr>
            <p:cNvSpPr/>
            <p:nvPr/>
          </p:nvSpPr>
          <p:spPr>
            <a:xfrm>
              <a:off x="3881091" y="5200894"/>
              <a:ext cx="129816" cy="129816"/>
            </a:xfrm>
            <a:custGeom>
              <a:avLst/>
              <a:gdLst>
                <a:gd name="csX0" fmla="*/ 126299 w 129816"/>
                <a:gd name="csY0" fmla="*/ 65189 h 129816"/>
                <a:gd name="csX1" fmla="*/ 61391 w 129816"/>
                <a:gd name="csY1" fmla="*/ 130097 h 129816"/>
                <a:gd name="csX2" fmla="*/ -3517 w 129816"/>
                <a:gd name="csY2" fmla="*/ 65189 h 129816"/>
                <a:gd name="csX3" fmla="*/ 61391 w 129816"/>
                <a:gd name="csY3" fmla="*/ 280 h 129816"/>
                <a:gd name="csX4" fmla="*/ 126299 w 129816"/>
                <a:gd name="csY4" fmla="*/ 65189 h 129816"/>
              </a:gdLst>
              <a:ahLst/>
              <a:cxnLst>
                <a:cxn ang="0">
                  <a:pos x="csX0" y="csY0"/>
                </a:cxn>
                <a:cxn ang="0">
                  <a:pos x="csX1" y="csY1"/>
                </a:cxn>
                <a:cxn ang="0">
                  <a:pos x="csX2" y="csY2"/>
                </a:cxn>
                <a:cxn ang="0">
                  <a:pos x="csX3" y="csY3"/>
                </a:cxn>
                <a:cxn ang="0">
                  <a:pos x="csX4" y="csY4"/>
                </a:cxn>
              </a:cxnLst>
              <a:rect l="l" t="t" r="r" b="b"/>
              <a:pathLst>
                <a:path w="129816" h="129816">
                  <a:moveTo>
                    <a:pt x="126299" y="65189"/>
                  </a:moveTo>
                  <a:cubicBezTo>
                    <a:pt x="126299" y="101036"/>
                    <a:pt x="97239" y="130097"/>
                    <a:pt x="61391" y="130097"/>
                  </a:cubicBezTo>
                  <a:cubicBezTo>
                    <a:pt x="25543" y="130097"/>
                    <a:pt x="-3517" y="101036"/>
                    <a:pt x="-3517" y="65189"/>
                  </a:cubicBezTo>
                  <a:cubicBezTo>
                    <a:pt x="-3517" y="29341"/>
                    <a:pt x="25543" y="280"/>
                    <a:pt x="61391" y="280"/>
                  </a:cubicBezTo>
                  <a:cubicBezTo>
                    <a:pt x="97239" y="280"/>
                    <a:pt x="126299" y="29341"/>
                    <a:pt x="126299" y="65189"/>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15" name="フリーフォーム: 図形 414">
              <a:extLst>
                <a:ext uri="{FF2B5EF4-FFF2-40B4-BE49-F238E27FC236}">
                  <a16:creationId xmlns:a16="http://schemas.microsoft.com/office/drawing/2014/main" id="{B82B83F4-C439-D825-574D-021491E8F808}"/>
                </a:ext>
              </a:extLst>
            </p:cNvPr>
            <p:cNvSpPr/>
            <p:nvPr/>
          </p:nvSpPr>
          <p:spPr>
            <a:xfrm>
              <a:off x="3881091" y="5200894"/>
              <a:ext cx="129816" cy="129816"/>
            </a:xfrm>
            <a:custGeom>
              <a:avLst/>
              <a:gdLst>
                <a:gd name="csX0" fmla="*/ 126299 w 129816"/>
                <a:gd name="csY0" fmla="*/ 65189 h 129816"/>
                <a:gd name="csX1" fmla="*/ 61391 w 129816"/>
                <a:gd name="csY1" fmla="*/ 130097 h 129816"/>
                <a:gd name="csX2" fmla="*/ -3517 w 129816"/>
                <a:gd name="csY2" fmla="*/ 65189 h 129816"/>
                <a:gd name="csX3" fmla="*/ 61391 w 129816"/>
                <a:gd name="csY3" fmla="*/ 280 h 129816"/>
                <a:gd name="csX4" fmla="*/ 126299 w 129816"/>
                <a:gd name="csY4" fmla="*/ 65189 h 129816"/>
              </a:gdLst>
              <a:ahLst/>
              <a:cxnLst>
                <a:cxn ang="0">
                  <a:pos x="csX0" y="csY0"/>
                </a:cxn>
                <a:cxn ang="0">
                  <a:pos x="csX1" y="csY1"/>
                </a:cxn>
                <a:cxn ang="0">
                  <a:pos x="csX2" y="csY2"/>
                </a:cxn>
                <a:cxn ang="0">
                  <a:pos x="csX3" y="csY3"/>
                </a:cxn>
                <a:cxn ang="0">
                  <a:pos x="csX4" y="csY4"/>
                </a:cxn>
              </a:cxnLst>
              <a:rect l="l" t="t" r="r" b="b"/>
              <a:pathLst>
                <a:path w="129816" h="129816">
                  <a:moveTo>
                    <a:pt x="126299" y="65189"/>
                  </a:moveTo>
                  <a:cubicBezTo>
                    <a:pt x="126299" y="101036"/>
                    <a:pt x="97239" y="130097"/>
                    <a:pt x="61391" y="130097"/>
                  </a:cubicBezTo>
                  <a:cubicBezTo>
                    <a:pt x="25543" y="130097"/>
                    <a:pt x="-3517" y="101036"/>
                    <a:pt x="-3517" y="65189"/>
                  </a:cubicBezTo>
                  <a:cubicBezTo>
                    <a:pt x="-3517" y="29341"/>
                    <a:pt x="25543" y="280"/>
                    <a:pt x="61391" y="280"/>
                  </a:cubicBezTo>
                  <a:cubicBezTo>
                    <a:pt x="97239" y="280"/>
                    <a:pt x="126299" y="29341"/>
                    <a:pt x="126299" y="65189"/>
                  </a:cubicBezTo>
                  <a:close/>
                </a:path>
              </a:pathLst>
            </a:custGeom>
            <a:solidFill>
              <a:srgbClr val="4292C6"/>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16" name="テキスト ボックス 415">
              <a:extLst>
                <a:ext uri="{FF2B5EF4-FFF2-40B4-BE49-F238E27FC236}">
                  <a16:creationId xmlns:a16="http://schemas.microsoft.com/office/drawing/2014/main" id="{F8B31792-A902-227B-36DC-D4666047D310}"/>
                </a:ext>
              </a:extLst>
            </p:cNvPr>
            <p:cNvSpPr txBox="1"/>
            <p:nvPr/>
          </p:nvSpPr>
          <p:spPr>
            <a:xfrm>
              <a:off x="3773218" y="5190449"/>
              <a:ext cx="35939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ATCTH</a:t>
              </a:r>
            </a:p>
          </p:txBody>
        </p:sp>
        <p:sp>
          <p:nvSpPr>
            <p:cNvPr id="417" name="フリーフォーム: 図形 416">
              <a:extLst>
                <a:ext uri="{FF2B5EF4-FFF2-40B4-BE49-F238E27FC236}">
                  <a16:creationId xmlns:a16="http://schemas.microsoft.com/office/drawing/2014/main" id="{BF71FBDA-DB38-4B28-BCB9-E975BE2D7396}"/>
                </a:ext>
              </a:extLst>
            </p:cNvPr>
            <p:cNvSpPr/>
            <p:nvPr/>
          </p:nvSpPr>
          <p:spPr>
            <a:xfrm>
              <a:off x="3117243" y="5060251"/>
              <a:ext cx="129816" cy="129816"/>
            </a:xfrm>
            <a:custGeom>
              <a:avLst/>
              <a:gdLst>
                <a:gd name="csX0" fmla="*/ 126475 w 129816"/>
                <a:gd name="csY0" fmla="*/ 65221 h 129816"/>
                <a:gd name="csX1" fmla="*/ 61567 w 129816"/>
                <a:gd name="csY1" fmla="*/ 130129 h 129816"/>
                <a:gd name="csX2" fmla="*/ -3341 w 129816"/>
                <a:gd name="csY2" fmla="*/ 65221 h 129816"/>
                <a:gd name="csX3" fmla="*/ 61567 w 129816"/>
                <a:gd name="csY3" fmla="*/ 313 h 129816"/>
                <a:gd name="csX4" fmla="*/ 126475 w 129816"/>
                <a:gd name="csY4" fmla="*/ 65221 h 129816"/>
              </a:gdLst>
              <a:ahLst/>
              <a:cxnLst>
                <a:cxn ang="0">
                  <a:pos x="csX0" y="csY0"/>
                </a:cxn>
                <a:cxn ang="0">
                  <a:pos x="csX1" y="csY1"/>
                </a:cxn>
                <a:cxn ang="0">
                  <a:pos x="csX2" y="csY2"/>
                </a:cxn>
                <a:cxn ang="0">
                  <a:pos x="csX3" y="csY3"/>
                </a:cxn>
                <a:cxn ang="0">
                  <a:pos x="csX4" y="csY4"/>
                </a:cxn>
              </a:cxnLst>
              <a:rect l="l" t="t" r="r" b="b"/>
              <a:pathLst>
                <a:path w="129816" h="129816">
                  <a:moveTo>
                    <a:pt x="126475" y="65221"/>
                  </a:moveTo>
                  <a:cubicBezTo>
                    <a:pt x="126475" y="101069"/>
                    <a:pt x="97415" y="130129"/>
                    <a:pt x="61567" y="130129"/>
                  </a:cubicBezTo>
                  <a:cubicBezTo>
                    <a:pt x="25720" y="130129"/>
                    <a:pt x="-3341" y="101069"/>
                    <a:pt x="-3341" y="65221"/>
                  </a:cubicBezTo>
                  <a:cubicBezTo>
                    <a:pt x="-3341" y="29373"/>
                    <a:pt x="25720" y="313"/>
                    <a:pt x="61567" y="313"/>
                  </a:cubicBezTo>
                  <a:cubicBezTo>
                    <a:pt x="97415" y="313"/>
                    <a:pt x="126475" y="29373"/>
                    <a:pt x="126475" y="65221"/>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18" name="フリーフォーム: 図形 417">
              <a:extLst>
                <a:ext uri="{FF2B5EF4-FFF2-40B4-BE49-F238E27FC236}">
                  <a16:creationId xmlns:a16="http://schemas.microsoft.com/office/drawing/2014/main" id="{50D78847-651D-0A6F-27F3-F8C8F07944A6}"/>
                </a:ext>
              </a:extLst>
            </p:cNvPr>
            <p:cNvSpPr/>
            <p:nvPr/>
          </p:nvSpPr>
          <p:spPr>
            <a:xfrm>
              <a:off x="3117243" y="5060251"/>
              <a:ext cx="129816" cy="129816"/>
            </a:xfrm>
            <a:custGeom>
              <a:avLst/>
              <a:gdLst>
                <a:gd name="csX0" fmla="*/ 126475 w 129816"/>
                <a:gd name="csY0" fmla="*/ 65221 h 129816"/>
                <a:gd name="csX1" fmla="*/ 61567 w 129816"/>
                <a:gd name="csY1" fmla="*/ 130129 h 129816"/>
                <a:gd name="csX2" fmla="*/ -3341 w 129816"/>
                <a:gd name="csY2" fmla="*/ 65221 h 129816"/>
                <a:gd name="csX3" fmla="*/ 61567 w 129816"/>
                <a:gd name="csY3" fmla="*/ 313 h 129816"/>
                <a:gd name="csX4" fmla="*/ 126475 w 129816"/>
                <a:gd name="csY4" fmla="*/ 65221 h 129816"/>
              </a:gdLst>
              <a:ahLst/>
              <a:cxnLst>
                <a:cxn ang="0">
                  <a:pos x="csX0" y="csY0"/>
                </a:cxn>
                <a:cxn ang="0">
                  <a:pos x="csX1" y="csY1"/>
                </a:cxn>
                <a:cxn ang="0">
                  <a:pos x="csX2" y="csY2"/>
                </a:cxn>
                <a:cxn ang="0">
                  <a:pos x="csX3" y="csY3"/>
                </a:cxn>
                <a:cxn ang="0">
                  <a:pos x="csX4" y="csY4"/>
                </a:cxn>
              </a:cxnLst>
              <a:rect l="l" t="t" r="r" b="b"/>
              <a:pathLst>
                <a:path w="129816" h="129816">
                  <a:moveTo>
                    <a:pt x="126475" y="65221"/>
                  </a:moveTo>
                  <a:cubicBezTo>
                    <a:pt x="126475" y="101069"/>
                    <a:pt x="97415" y="130129"/>
                    <a:pt x="61567" y="130129"/>
                  </a:cubicBezTo>
                  <a:cubicBezTo>
                    <a:pt x="25720" y="130129"/>
                    <a:pt x="-3341" y="101069"/>
                    <a:pt x="-3341" y="65221"/>
                  </a:cubicBezTo>
                  <a:cubicBezTo>
                    <a:pt x="-3341" y="29373"/>
                    <a:pt x="25720" y="313"/>
                    <a:pt x="61567" y="313"/>
                  </a:cubicBezTo>
                  <a:cubicBezTo>
                    <a:pt x="97415" y="313"/>
                    <a:pt x="126475" y="29373"/>
                    <a:pt x="126475" y="65221"/>
                  </a:cubicBezTo>
                  <a:close/>
                </a:path>
              </a:pathLst>
            </a:custGeom>
            <a:solidFill>
              <a:srgbClr val="DAE7EF"/>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19" name="テキスト ボックス 418">
              <a:extLst>
                <a:ext uri="{FF2B5EF4-FFF2-40B4-BE49-F238E27FC236}">
                  <a16:creationId xmlns:a16="http://schemas.microsoft.com/office/drawing/2014/main" id="{7E92C53F-1396-C902-6D46-B8B85C61360F}"/>
                </a:ext>
              </a:extLst>
            </p:cNvPr>
            <p:cNvSpPr txBox="1"/>
            <p:nvPr/>
          </p:nvSpPr>
          <p:spPr>
            <a:xfrm>
              <a:off x="3033596" y="5047391"/>
              <a:ext cx="292067"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VCR</a:t>
              </a:r>
            </a:p>
          </p:txBody>
        </p:sp>
        <p:sp>
          <p:nvSpPr>
            <p:cNvPr id="420" name="フリーフォーム: 図形 419">
              <a:extLst>
                <a:ext uri="{FF2B5EF4-FFF2-40B4-BE49-F238E27FC236}">
                  <a16:creationId xmlns:a16="http://schemas.microsoft.com/office/drawing/2014/main" id="{2DDF519E-516F-34AB-6D4C-B40BB31F881A}"/>
                </a:ext>
              </a:extLst>
            </p:cNvPr>
            <p:cNvSpPr/>
            <p:nvPr/>
          </p:nvSpPr>
          <p:spPr>
            <a:xfrm>
              <a:off x="3101433" y="5568479"/>
              <a:ext cx="141618" cy="141617"/>
            </a:xfrm>
            <a:custGeom>
              <a:avLst/>
              <a:gdLst>
                <a:gd name="csX0" fmla="*/ 67470 w 141618"/>
                <a:gd name="csY0" fmla="*/ 194 h 141617"/>
                <a:gd name="csX1" fmla="*/ 138279 w 141618"/>
                <a:gd name="csY1" fmla="*/ 71003 h 141617"/>
                <a:gd name="csX2" fmla="*/ 67470 w 141618"/>
                <a:gd name="csY2" fmla="*/ 141812 h 141617"/>
                <a:gd name="csX3" fmla="*/ -3339 w 141618"/>
                <a:gd name="csY3" fmla="*/ 71003 h 141617"/>
              </a:gdLst>
              <a:ahLst/>
              <a:cxnLst>
                <a:cxn ang="0">
                  <a:pos x="csX0" y="csY0"/>
                </a:cxn>
                <a:cxn ang="0">
                  <a:pos x="csX1" y="csY1"/>
                </a:cxn>
                <a:cxn ang="0">
                  <a:pos x="csX2" y="csY2"/>
                </a:cxn>
                <a:cxn ang="0">
                  <a:pos x="csX3" y="csY3"/>
                </a:cxn>
              </a:cxnLst>
              <a:rect l="l" t="t" r="r" b="b"/>
              <a:pathLst>
                <a:path w="141618" h="141617">
                  <a:moveTo>
                    <a:pt x="67470" y="194"/>
                  </a:moveTo>
                  <a:lnTo>
                    <a:pt x="138279" y="71003"/>
                  </a:lnTo>
                  <a:lnTo>
                    <a:pt x="67470" y="141812"/>
                  </a:lnTo>
                  <a:lnTo>
                    <a:pt x="-3339" y="71003"/>
                  </a:ln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21" name="フリーフォーム: 図形 420">
              <a:extLst>
                <a:ext uri="{FF2B5EF4-FFF2-40B4-BE49-F238E27FC236}">
                  <a16:creationId xmlns:a16="http://schemas.microsoft.com/office/drawing/2014/main" id="{110B6277-FC5A-96B8-5623-66A8450A6012}"/>
                </a:ext>
              </a:extLst>
            </p:cNvPr>
            <p:cNvSpPr/>
            <p:nvPr/>
          </p:nvSpPr>
          <p:spPr>
            <a:xfrm>
              <a:off x="3101433" y="5568479"/>
              <a:ext cx="141618" cy="141617"/>
            </a:xfrm>
            <a:custGeom>
              <a:avLst/>
              <a:gdLst>
                <a:gd name="csX0" fmla="*/ 67470 w 141618"/>
                <a:gd name="csY0" fmla="*/ 194 h 141617"/>
                <a:gd name="csX1" fmla="*/ 138279 w 141618"/>
                <a:gd name="csY1" fmla="*/ 71003 h 141617"/>
                <a:gd name="csX2" fmla="*/ 67470 w 141618"/>
                <a:gd name="csY2" fmla="*/ 141812 h 141617"/>
                <a:gd name="csX3" fmla="*/ -3339 w 141618"/>
                <a:gd name="csY3" fmla="*/ 71003 h 141617"/>
              </a:gdLst>
              <a:ahLst/>
              <a:cxnLst>
                <a:cxn ang="0">
                  <a:pos x="csX0" y="csY0"/>
                </a:cxn>
                <a:cxn ang="0">
                  <a:pos x="csX1" y="csY1"/>
                </a:cxn>
                <a:cxn ang="0">
                  <a:pos x="csX2" y="csY2"/>
                </a:cxn>
                <a:cxn ang="0">
                  <a:pos x="csX3" y="csY3"/>
                </a:cxn>
              </a:cxnLst>
              <a:rect l="l" t="t" r="r" b="b"/>
              <a:pathLst>
                <a:path w="141618" h="141617">
                  <a:moveTo>
                    <a:pt x="67470" y="194"/>
                  </a:moveTo>
                  <a:lnTo>
                    <a:pt x="138279" y="71003"/>
                  </a:lnTo>
                  <a:lnTo>
                    <a:pt x="67470" y="141812"/>
                  </a:lnTo>
                  <a:lnTo>
                    <a:pt x="-3339" y="71003"/>
                  </a:lnTo>
                  <a:close/>
                </a:path>
              </a:pathLst>
            </a:custGeom>
            <a:solidFill>
              <a:srgbClr val="F8DBCC"/>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22" name="テキスト ボックス 421">
              <a:extLst>
                <a:ext uri="{FF2B5EF4-FFF2-40B4-BE49-F238E27FC236}">
                  <a16:creationId xmlns:a16="http://schemas.microsoft.com/office/drawing/2014/main" id="{29AB2D08-34D2-502C-8E47-8DA61E3FA56D}"/>
                </a:ext>
              </a:extLst>
            </p:cNvPr>
            <p:cNvSpPr txBox="1"/>
            <p:nvPr/>
          </p:nvSpPr>
          <p:spPr>
            <a:xfrm>
              <a:off x="2989279" y="5565076"/>
              <a:ext cx="35779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RK2D</a:t>
              </a:r>
            </a:p>
          </p:txBody>
        </p:sp>
        <p:sp>
          <p:nvSpPr>
            <p:cNvPr id="423" name="フリーフォーム: 図形 422">
              <a:extLst>
                <a:ext uri="{FF2B5EF4-FFF2-40B4-BE49-F238E27FC236}">
                  <a16:creationId xmlns:a16="http://schemas.microsoft.com/office/drawing/2014/main" id="{0508FF95-8FA1-585D-9A70-27623061777A}"/>
                </a:ext>
              </a:extLst>
            </p:cNvPr>
            <p:cNvSpPr/>
            <p:nvPr/>
          </p:nvSpPr>
          <p:spPr>
            <a:xfrm>
              <a:off x="4098855" y="5107708"/>
              <a:ext cx="144000" cy="144000"/>
            </a:xfrm>
            <a:custGeom>
              <a:avLst/>
              <a:gdLst>
                <a:gd name="csX0" fmla="*/ 126250 w 129816"/>
                <a:gd name="csY0" fmla="*/ 65206 h 129816"/>
                <a:gd name="csX1" fmla="*/ 61342 w 129816"/>
                <a:gd name="csY1" fmla="*/ 130115 h 129816"/>
                <a:gd name="csX2" fmla="*/ -3566 w 129816"/>
                <a:gd name="csY2" fmla="*/ 65206 h 129816"/>
                <a:gd name="csX3" fmla="*/ 61342 w 129816"/>
                <a:gd name="csY3" fmla="*/ 298 h 129816"/>
                <a:gd name="csX4" fmla="*/ 126250 w 129816"/>
                <a:gd name="csY4" fmla="*/ 65206 h 129816"/>
              </a:gdLst>
              <a:ahLst/>
              <a:cxnLst>
                <a:cxn ang="0">
                  <a:pos x="csX0" y="csY0"/>
                </a:cxn>
                <a:cxn ang="0">
                  <a:pos x="csX1" y="csY1"/>
                </a:cxn>
                <a:cxn ang="0">
                  <a:pos x="csX2" y="csY2"/>
                </a:cxn>
                <a:cxn ang="0">
                  <a:pos x="csX3" y="csY3"/>
                </a:cxn>
                <a:cxn ang="0">
                  <a:pos x="csX4" y="csY4"/>
                </a:cxn>
              </a:cxnLst>
              <a:rect l="l" t="t" r="r" b="b"/>
              <a:pathLst>
                <a:path w="129816" h="129816">
                  <a:moveTo>
                    <a:pt x="126250" y="65206"/>
                  </a:moveTo>
                  <a:cubicBezTo>
                    <a:pt x="126250" y="101054"/>
                    <a:pt x="97190" y="130115"/>
                    <a:pt x="61342" y="130115"/>
                  </a:cubicBezTo>
                  <a:cubicBezTo>
                    <a:pt x="25494" y="130115"/>
                    <a:pt x="-3566" y="101054"/>
                    <a:pt x="-3566" y="65206"/>
                  </a:cubicBezTo>
                  <a:cubicBezTo>
                    <a:pt x="-3566" y="29359"/>
                    <a:pt x="25494" y="298"/>
                    <a:pt x="61342" y="298"/>
                  </a:cubicBezTo>
                  <a:cubicBezTo>
                    <a:pt x="97190" y="298"/>
                    <a:pt x="126250" y="29359"/>
                    <a:pt x="126250" y="65206"/>
                  </a:cubicBezTo>
                  <a:close/>
                </a:path>
              </a:pathLst>
            </a:custGeom>
            <a:solidFill>
              <a:srgbClr val="E3ECF1"/>
            </a:solidFill>
            <a:ln w="6350" cap="sq">
              <a:solidFill>
                <a:srgbClr val="0070C0"/>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24" name="テキスト ボックス 423">
              <a:extLst>
                <a:ext uri="{FF2B5EF4-FFF2-40B4-BE49-F238E27FC236}">
                  <a16:creationId xmlns:a16="http://schemas.microsoft.com/office/drawing/2014/main" id="{0B87B772-9F0F-AF34-0E21-5C187F27CA5C}"/>
                </a:ext>
              </a:extLst>
            </p:cNvPr>
            <p:cNvSpPr txBox="1"/>
            <p:nvPr/>
          </p:nvSpPr>
          <p:spPr>
            <a:xfrm>
              <a:off x="3980669" y="5105202"/>
              <a:ext cx="37221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TRM9-2</a:t>
              </a:r>
            </a:p>
          </p:txBody>
        </p:sp>
        <p:sp>
          <p:nvSpPr>
            <p:cNvPr id="425" name="フリーフォーム: 図形 424">
              <a:extLst>
                <a:ext uri="{FF2B5EF4-FFF2-40B4-BE49-F238E27FC236}">
                  <a16:creationId xmlns:a16="http://schemas.microsoft.com/office/drawing/2014/main" id="{E00DCDE8-BE0D-4CB2-3A75-3F72799BA247}"/>
                </a:ext>
              </a:extLst>
            </p:cNvPr>
            <p:cNvSpPr/>
            <p:nvPr/>
          </p:nvSpPr>
          <p:spPr>
            <a:xfrm>
              <a:off x="3488740" y="4916123"/>
              <a:ext cx="129816" cy="129816"/>
            </a:xfrm>
            <a:custGeom>
              <a:avLst/>
              <a:gdLst>
                <a:gd name="csX0" fmla="*/ 126390 w 129816"/>
                <a:gd name="csY0" fmla="*/ 65254 h 129816"/>
                <a:gd name="csX1" fmla="*/ 61481 w 129816"/>
                <a:gd name="csY1" fmla="*/ 130163 h 129816"/>
                <a:gd name="csX2" fmla="*/ -3427 w 129816"/>
                <a:gd name="csY2" fmla="*/ 65254 h 129816"/>
                <a:gd name="csX3" fmla="*/ 61481 w 129816"/>
                <a:gd name="csY3" fmla="*/ 346 h 129816"/>
                <a:gd name="csX4" fmla="*/ 126390 w 129816"/>
                <a:gd name="csY4" fmla="*/ 65254 h 129816"/>
              </a:gdLst>
              <a:ahLst/>
              <a:cxnLst>
                <a:cxn ang="0">
                  <a:pos x="csX0" y="csY0"/>
                </a:cxn>
                <a:cxn ang="0">
                  <a:pos x="csX1" y="csY1"/>
                </a:cxn>
                <a:cxn ang="0">
                  <a:pos x="csX2" y="csY2"/>
                </a:cxn>
                <a:cxn ang="0">
                  <a:pos x="csX3" y="csY3"/>
                </a:cxn>
                <a:cxn ang="0">
                  <a:pos x="csX4" y="csY4"/>
                </a:cxn>
              </a:cxnLst>
              <a:rect l="l" t="t" r="r" b="b"/>
              <a:pathLst>
                <a:path w="129816" h="129816">
                  <a:moveTo>
                    <a:pt x="126390" y="65254"/>
                  </a:moveTo>
                  <a:cubicBezTo>
                    <a:pt x="126390" y="101102"/>
                    <a:pt x="97329" y="130163"/>
                    <a:pt x="61481" y="130163"/>
                  </a:cubicBezTo>
                  <a:cubicBezTo>
                    <a:pt x="25634" y="130163"/>
                    <a:pt x="-3427" y="101102"/>
                    <a:pt x="-3427" y="65254"/>
                  </a:cubicBezTo>
                  <a:cubicBezTo>
                    <a:pt x="-3427" y="29406"/>
                    <a:pt x="25634" y="346"/>
                    <a:pt x="61481" y="346"/>
                  </a:cubicBezTo>
                  <a:cubicBezTo>
                    <a:pt x="97329" y="346"/>
                    <a:pt x="126390" y="29406"/>
                    <a:pt x="126390" y="65254"/>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26" name="フリーフォーム: 図形 425">
              <a:extLst>
                <a:ext uri="{FF2B5EF4-FFF2-40B4-BE49-F238E27FC236}">
                  <a16:creationId xmlns:a16="http://schemas.microsoft.com/office/drawing/2014/main" id="{BFB31EAE-D5EC-FC87-D0C2-DAC964A6ED16}"/>
                </a:ext>
              </a:extLst>
            </p:cNvPr>
            <p:cNvSpPr/>
            <p:nvPr/>
          </p:nvSpPr>
          <p:spPr>
            <a:xfrm>
              <a:off x="3488740" y="4916123"/>
              <a:ext cx="129816" cy="129816"/>
            </a:xfrm>
            <a:custGeom>
              <a:avLst/>
              <a:gdLst>
                <a:gd name="csX0" fmla="*/ 126390 w 129816"/>
                <a:gd name="csY0" fmla="*/ 65254 h 129816"/>
                <a:gd name="csX1" fmla="*/ 61481 w 129816"/>
                <a:gd name="csY1" fmla="*/ 130163 h 129816"/>
                <a:gd name="csX2" fmla="*/ -3427 w 129816"/>
                <a:gd name="csY2" fmla="*/ 65254 h 129816"/>
                <a:gd name="csX3" fmla="*/ 61481 w 129816"/>
                <a:gd name="csY3" fmla="*/ 346 h 129816"/>
                <a:gd name="csX4" fmla="*/ 126390 w 129816"/>
                <a:gd name="csY4" fmla="*/ 65254 h 129816"/>
              </a:gdLst>
              <a:ahLst/>
              <a:cxnLst>
                <a:cxn ang="0">
                  <a:pos x="csX0" y="csY0"/>
                </a:cxn>
                <a:cxn ang="0">
                  <a:pos x="csX1" y="csY1"/>
                </a:cxn>
                <a:cxn ang="0">
                  <a:pos x="csX2" y="csY2"/>
                </a:cxn>
                <a:cxn ang="0">
                  <a:pos x="csX3" y="csY3"/>
                </a:cxn>
                <a:cxn ang="0">
                  <a:pos x="csX4" y="csY4"/>
                </a:cxn>
              </a:cxnLst>
              <a:rect l="l" t="t" r="r" b="b"/>
              <a:pathLst>
                <a:path w="129816" h="129816">
                  <a:moveTo>
                    <a:pt x="126390" y="65254"/>
                  </a:moveTo>
                  <a:cubicBezTo>
                    <a:pt x="126390" y="101102"/>
                    <a:pt x="97329" y="130163"/>
                    <a:pt x="61481" y="130163"/>
                  </a:cubicBezTo>
                  <a:cubicBezTo>
                    <a:pt x="25634" y="130163"/>
                    <a:pt x="-3427" y="101102"/>
                    <a:pt x="-3427" y="65254"/>
                  </a:cubicBezTo>
                  <a:cubicBezTo>
                    <a:pt x="-3427" y="29406"/>
                    <a:pt x="25634" y="346"/>
                    <a:pt x="61481" y="346"/>
                  </a:cubicBezTo>
                  <a:cubicBezTo>
                    <a:pt x="97329" y="346"/>
                    <a:pt x="126390" y="29406"/>
                    <a:pt x="126390" y="65254"/>
                  </a:cubicBezTo>
                  <a:close/>
                </a:path>
              </a:pathLst>
            </a:custGeom>
            <a:solidFill>
              <a:srgbClr val="FA7837"/>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27" name="テキスト ボックス 426">
              <a:extLst>
                <a:ext uri="{FF2B5EF4-FFF2-40B4-BE49-F238E27FC236}">
                  <a16:creationId xmlns:a16="http://schemas.microsoft.com/office/drawing/2014/main" id="{C3254F8A-FB7E-6845-6A1E-90897778A47C}"/>
                </a:ext>
              </a:extLst>
            </p:cNvPr>
            <p:cNvSpPr txBox="1"/>
            <p:nvPr/>
          </p:nvSpPr>
          <p:spPr>
            <a:xfrm>
              <a:off x="3393142" y="4903129"/>
              <a:ext cx="31771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EXA1</a:t>
              </a:r>
            </a:p>
          </p:txBody>
        </p:sp>
        <p:sp>
          <p:nvSpPr>
            <p:cNvPr id="428" name="フリーフォーム: 図形 427">
              <a:extLst>
                <a:ext uri="{FF2B5EF4-FFF2-40B4-BE49-F238E27FC236}">
                  <a16:creationId xmlns:a16="http://schemas.microsoft.com/office/drawing/2014/main" id="{2C1BC89E-3C95-730D-CD9D-D06E3AD7F2BD}"/>
                </a:ext>
              </a:extLst>
            </p:cNvPr>
            <p:cNvSpPr/>
            <p:nvPr/>
          </p:nvSpPr>
          <p:spPr>
            <a:xfrm>
              <a:off x="4290266" y="5134135"/>
              <a:ext cx="144000" cy="144000"/>
            </a:xfrm>
            <a:custGeom>
              <a:avLst/>
              <a:gdLst>
                <a:gd name="csX0" fmla="*/ 67196 w 141618"/>
                <a:gd name="csY0" fmla="*/ 293 h 141617"/>
                <a:gd name="csX1" fmla="*/ 138005 w 141618"/>
                <a:gd name="csY1" fmla="*/ 71102 h 141617"/>
                <a:gd name="csX2" fmla="*/ 67196 w 141618"/>
                <a:gd name="csY2" fmla="*/ 141911 h 141617"/>
                <a:gd name="csX3" fmla="*/ -3613 w 141618"/>
                <a:gd name="csY3" fmla="*/ 71102 h 141617"/>
              </a:gdLst>
              <a:ahLst/>
              <a:cxnLst>
                <a:cxn ang="0">
                  <a:pos x="csX0" y="csY0"/>
                </a:cxn>
                <a:cxn ang="0">
                  <a:pos x="csX1" y="csY1"/>
                </a:cxn>
                <a:cxn ang="0">
                  <a:pos x="csX2" y="csY2"/>
                </a:cxn>
                <a:cxn ang="0">
                  <a:pos x="csX3" y="csY3"/>
                </a:cxn>
              </a:cxnLst>
              <a:rect l="l" t="t" r="r" b="b"/>
              <a:pathLst>
                <a:path w="141618" h="141617">
                  <a:moveTo>
                    <a:pt x="67196" y="293"/>
                  </a:moveTo>
                  <a:lnTo>
                    <a:pt x="138005" y="71102"/>
                  </a:lnTo>
                  <a:lnTo>
                    <a:pt x="67196" y="141911"/>
                  </a:lnTo>
                  <a:lnTo>
                    <a:pt x="-3613" y="71102"/>
                  </a:lnTo>
                  <a:close/>
                </a:path>
              </a:pathLst>
            </a:custGeom>
            <a:solidFill>
              <a:srgbClr val="FA7837"/>
            </a:solidFill>
            <a:ln w="6350" cap="sq">
              <a:solidFill>
                <a:schemeClr val="accent2"/>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29" name="テキスト ボックス 428">
              <a:extLst>
                <a:ext uri="{FF2B5EF4-FFF2-40B4-BE49-F238E27FC236}">
                  <a16:creationId xmlns:a16="http://schemas.microsoft.com/office/drawing/2014/main" id="{3A6B193C-352B-CE4D-1C2F-5502E6D64C16}"/>
                </a:ext>
              </a:extLst>
            </p:cNvPr>
            <p:cNvSpPr txBox="1"/>
            <p:nvPr/>
          </p:nvSpPr>
          <p:spPr>
            <a:xfrm>
              <a:off x="4198499" y="5129119"/>
              <a:ext cx="33054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KK3</a:t>
              </a:r>
            </a:p>
          </p:txBody>
        </p:sp>
        <p:sp>
          <p:nvSpPr>
            <p:cNvPr id="430" name="フリーフォーム: 図形 429">
              <a:extLst>
                <a:ext uri="{FF2B5EF4-FFF2-40B4-BE49-F238E27FC236}">
                  <a16:creationId xmlns:a16="http://schemas.microsoft.com/office/drawing/2014/main" id="{821809DC-D96C-248D-4568-EBD63754D9C1}"/>
                </a:ext>
              </a:extLst>
            </p:cNvPr>
            <p:cNvSpPr/>
            <p:nvPr/>
          </p:nvSpPr>
          <p:spPr>
            <a:xfrm>
              <a:off x="4321167" y="4843893"/>
              <a:ext cx="129816" cy="129816"/>
            </a:xfrm>
            <a:custGeom>
              <a:avLst/>
              <a:gdLst>
                <a:gd name="csX0" fmla="*/ 126198 w 129816"/>
                <a:gd name="csY0" fmla="*/ 65271 h 129816"/>
                <a:gd name="csX1" fmla="*/ 61289 w 129816"/>
                <a:gd name="csY1" fmla="*/ 130179 h 129816"/>
                <a:gd name="csX2" fmla="*/ -3619 w 129816"/>
                <a:gd name="csY2" fmla="*/ 65271 h 129816"/>
                <a:gd name="csX3" fmla="*/ 61289 w 129816"/>
                <a:gd name="csY3" fmla="*/ 363 h 129816"/>
                <a:gd name="csX4" fmla="*/ 126198 w 129816"/>
                <a:gd name="csY4" fmla="*/ 65271 h 129816"/>
              </a:gdLst>
              <a:ahLst/>
              <a:cxnLst>
                <a:cxn ang="0">
                  <a:pos x="csX0" y="csY0"/>
                </a:cxn>
                <a:cxn ang="0">
                  <a:pos x="csX1" y="csY1"/>
                </a:cxn>
                <a:cxn ang="0">
                  <a:pos x="csX2" y="csY2"/>
                </a:cxn>
                <a:cxn ang="0">
                  <a:pos x="csX3" y="csY3"/>
                </a:cxn>
                <a:cxn ang="0">
                  <a:pos x="csX4" y="csY4"/>
                </a:cxn>
              </a:cxnLst>
              <a:rect l="l" t="t" r="r" b="b"/>
              <a:pathLst>
                <a:path w="129816" h="129816">
                  <a:moveTo>
                    <a:pt x="126198" y="65271"/>
                  </a:moveTo>
                  <a:cubicBezTo>
                    <a:pt x="126198" y="101119"/>
                    <a:pt x="97137" y="130179"/>
                    <a:pt x="61289" y="130179"/>
                  </a:cubicBezTo>
                  <a:cubicBezTo>
                    <a:pt x="25442" y="130179"/>
                    <a:pt x="-3619" y="101119"/>
                    <a:pt x="-3619" y="65271"/>
                  </a:cubicBezTo>
                  <a:cubicBezTo>
                    <a:pt x="-3619" y="29423"/>
                    <a:pt x="25442" y="363"/>
                    <a:pt x="61289" y="363"/>
                  </a:cubicBezTo>
                  <a:cubicBezTo>
                    <a:pt x="97137" y="363"/>
                    <a:pt x="126198" y="29423"/>
                    <a:pt x="126198" y="65271"/>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31" name="フリーフォーム: 図形 430">
              <a:extLst>
                <a:ext uri="{FF2B5EF4-FFF2-40B4-BE49-F238E27FC236}">
                  <a16:creationId xmlns:a16="http://schemas.microsoft.com/office/drawing/2014/main" id="{3D5F80D6-BF5F-3C98-2C78-4561F79DCCB7}"/>
                </a:ext>
              </a:extLst>
            </p:cNvPr>
            <p:cNvSpPr/>
            <p:nvPr/>
          </p:nvSpPr>
          <p:spPr>
            <a:xfrm>
              <a:off x="4321167" y="4843893"/>
              <a:ext cx="129816" cy="129816"/>
            </a:xfrm>
            <a:custGeom>
              <a:avLst/>
              <a:gdLst>
                <a:gd name="csX0" fmla="*/ 126198 w 129816"/>
                <a:gd name="csY0" fmla="*/ 65271 h 129816"/>
                <a:gd name="csX1" fmla="*/ 61289 w 129816"/>
                <a:gd name="csY1" fmla="*/ 130179 h 129816"/>
                <a:gd name="csX2" fmla="*/ -3619 w 129816"/>
                <a:gd name="csY2" fmla="*/ 65271 h 129816"/>
                <a:gd name="csX3" fmla="*/ 61289 w 129816"/>
                <a:gd name="csY3" fmla="*/ 363 h 129816"/>
                <a:gd name="csX4" fmla="*/ 126198 w 129816"/>
                <a:gd name="csY4" fmla="*/ 65271 h 129816"/>
              </a:gdLst>
              <a:ahLst/>
              <a:cxnLst>
                <a:cxn ang="0">
                  <a:pos x="csX0" y="csY0"/>
                </a:cxn>
                <a:cxn ang="0">
                  <a:pos x="csX1" y="csY1"/>
                </a:cxn>
                <a:cxn ang="0">
                  <a:pos x="csX2" y="csY2"/>
                </a:cxn>
                <a:cxn ang="0">
                  <a:pos x="csX3" y="csY3"/>
                </a:cxn>
                <a:cxn ang="0">
                  <a:pos x="csX4" y="csY4"/>
                </a:cxn>
              </a:cxnLst>
              <a:rect l="l" t="t" r="r" b="b"/>
              <a:pathLst>
                <a:path w="129816" h="129816">
                  <a:moveTo>
                    <a:pt x="126198" y="65271"/>
                  </a:moveTo>
                  <a:cubicBezTo>
                    <a:pt x="126198" y="101119"/>
                    <a:pt x="97137" y="130179"/>
                    <a:pt x="61289" y="130179"/>
                  </a:cubicBezTo>
                  <a:cubicBezTo>
                    <a:pt x="25442" y="130179"/>
                    <a:pt x="-3619" y="101119"/>
                    <a:pt x="-3619" y="65271"/>
                  </a:cubicBezTo>
                  <a:cubicBezTo>
                    <a:pt x="-3619" y="29423"/>
                    <a:pt x="25442" y="363"/>
                    <a:pt x="61289" y="363"/>
                  </a:cubicBezTo>
                  <a:cubicBezTo>
                    <a:pt x="97137" y="363"/>
                    <a:pt x="126198" y="29423"/>
                    <a:pt x="126198" y="65271"/>
                  </a:cubicBezTo>
                  <a:close/>
                </a:path>
              </a:pathLst>
            </a:custGeom>
            <a:solidFill>
              <a:srgbClr val="DBE7EF"/>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32" name="テキスト ボックス 431">
              <a:extLst>
                <a:ext uri="{FF2B5EF4-FFF2-40B4-BE49-F238E27FC236}">
                  <a16:creationId xmlns:a16="http://schemas.microsoft.com/office/drawing/2014/main" id="{4E742C1F-6971-4419-B883-D096B0D52681}"/>
                </a:ext>
              </a:extLst>
            </p:cNvPr>
            <p:cNvSpPr txBox="1"/>
            <p:nvPr/>
          </p:nvSpPr>
          <p:spPr>
            <a:xfrm>
              <a:off x="4224110" y="4831913"/>
              <a:ext cx="33054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WDL5</a:t>
              </a:r>
            </a:p>
          </p:txBody>
        </p:sp>
        <p:sp>
          <p:nvSpPr>
            <p:cNvPr id="433" name="フリーフォーム: 図形 432">
              <a:extLst>
                <a:ext uri="{FF2B5EF4-FFF2-40B4-BE49-F238E27FC236}">
                  <a16:creationId xmlns:a16="http://schemas.microsoft.com/office/drawing/2014/main" id="{E6A2ABF0-DA65-14AC-9FDF-6110B2EFB1EF}"/>
                </a:ext>
              </a:extLst>
            </p:cNvPr>
            <p:cNvSpPr/>
            <p:nvPr/>
          </p:nvSpPr>
          <p:spPr>
            <a:xfrm>
              <a:off x="3541416" y="4560427"/>
              <a:ext cx="129816" cy="129816"/>
            </a:xfrm>
            <a:custGeom>
              <a:avLst/>
              <a:gdLst>
                <a:gd name="csX0" fmla="*/ 126378 w 129816"/>
                <a:gd name="csY0" fmla="*/ 65336 h 129816"/>
                <a:gd name="csX1" fmla="*/ 61469 w 129816"/>
                <a:gd name="csY1" fmla="*/ 130245 h 129816"/>
                <a:gd name="csX2" fmla="*/ -3439 w 129816"/>
                <a:gd name="csY2" fmla="*/ 65336 h 129816"/>
                <a:gd name="csX3" fmla="*/ 61469 w 129816"/>
                <a:gd name="csY3" fmla="*/ 428 h 129816"/>
                <a:gd name="csX4" fmla="*/ 126378 w 129816"/>
                <a:gd name="csY4" fmla="*/ 65336 h 129816"/>
              </a:gdLst>
              <a:ahLst/>
              <a:cxnLst>
                <a:cxn ang="0">
                  <a:pos x="csX0" y="csY0"/>
                </a:cxn>
                <a:cxn ang="0">
                  <a:pos x="csX1" y="csY1"/>
                </a:cxn>
                <a:cxn ang="0">
                  <a:pos x="csX2" y="csY2"/>
                </a:cxn>
                <a:cxn ang="0">
                  <a:pos x="csX3" y="csY3"/>
                </a:cxn>
                <a:cxn ang="0">
                  <a:pos x="csX4" y="csY4"/>
                </a:cxn>
              </a:cxnLst>
              <a:rect l="l" t="t" r="r" b="b"/>
              <a:pathLst>
                <a:path w="129816" h="129816">
                  <a:moveTo>
                    <a:pt x="126378" y="65336"/>
                  </a:moveTo>
                  <a:cubicBezTo>
                    <a:pt x="126378" y="101184"/>
                    <a:pt x="97317" y="130245"/>
                    <a:pt x="61469" y="130245"/>
                  </a:cubicBezTo>
                  <a:cubicBezTo>
                    <a:pt x="25622" y="130245"/>
                    <a:pt x="-3439" y="101184"/>
                    <a:pt x="-3439" y="65336"/>
                  </a:cubicBezTo>
                  <a:cubicBezTo>
                    <a:pt x="-3439" y="29489"/>
                    <a:pt x="25622" y="428"/>
                    <a:pt x="61469" y="428"/>
                  </a:cubicBezTo>
                  <a:cubicBezTo>
                    <a:pt x="97317" y="428"/>
                    <a:pt x="126378" y="29489"/>
                    <a:pt x="126378" y="65336"/>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34" name="フリーフォーム: 図形 433">
              <a:extLst>
                <a:ext uri="{FF2B5EF4-FFF2-40B4-BE49-F238E27FC236}">
                  <a16:creationId xmlns:a16="http://schemas.microsoft.com/office/drawing/2014/main" id="{E9DC879B-A600-67A7-11F4-3C88C05FEB42}"/>
                </a:ext>
              </a:extLst>
            </p:cNvPr>
            <p:cNvSpPr/>
            <p:nvPr/>
          </p:nvSpPr>
          <p:spPr>
            <a:xfrm>
              <a:off x="3541416" y="4560427"/>
              <a:ext cx="129816" cy="129816"/>
            </a:xfrm>
            <a:custGeom>
              <a:avLst/>
              <a:gdLst>
                <a:gd name="csX0" fmla="*/ 126378 w 129816"/>
                <a:gd name="csY0" fmla="*/ 65336 h 129816"/>
                <a:gd name="csX1" fmla="*/ 61469 w 129816"/>
                <a:gd name="csY1" fmla="*/ 130245 h 129816"/>
                <a:gd name="csX2" fmla="*/ -3439 w 129816"/>
                <a:gd name="csY2" fmla="*/ 65336 h 129816"/>
                <a:gd name="csX3" fmla="*/ 61469 w 129816"/>
                <a:gd name="csY3" fmla="*/ 428 h 129816"/>
                <a:gd name="csX4" fmla="*/ 126378 w 129816"/>
                <a:gd name="csY4" fmla="*/ 65336 h 129816"/>
              </a:gdLst>
              <a:ahLst/>
              <a:cxnLst>
                <a:cxn ang="0">
                  <a:pos x="csX0" y="csY0"/>
                </a:cxn>
                <a:cxn ang="0">
                  <a:pos x="csX1" y="csY1"/>
                </a:cxn>
                <a:cxn ang="0">
                  <a:pos x="csX2" y="csY2"/>
                </a:cxn>
                <a:cxn ang="0">
                  <a:pos x="csX3" y="csY3"/>
                </a:cxn>
                <a:cxn ang="0">
                  <a:pos x="csX4" y="csY4"/>
                </a:cxn>
              </a:cxnLst>
              <a:rect l="l" t="t" r="r" b="b"/>
              <a:pathLst>
                <a:path w="129816" h="129816">
                  <a:moveTo>
                    <a:pt x="126378" y="65336"/>
                  </a:moveTo>
                  <a:cubicBezTo>
                    <a:pt x="126378" y="101184"/>
                    <a:pt x="97317" y="130245"/>
                    <a:pt x="61469" y="130245"/>
                  </a:cubicBezTo>
                  <a:cubicBezTo>
                    <a:pt x="25622" y="130245"/>
                    <a:pt x="-3439" y="101184"/>
                    <a:pt x="-3439" y="65336"/>
                  </a:cubicBezTo>
                  <a:cubicBezTo>
                    <a:pt x="-3439" y="29489"/>
                    <a:pt x="25622" y="428"/>
                    <a:pt x="61469" y="428"/>
                  </a:cubicBezTo>
                  <a:cubicBezTo>
                    <a:pt x="97317" y="428"/>
                    <a:pt x="126378" y="29489"/>
                    <a:pt x="126378" y="65336"/>
                  </a:cubicBezTo>
                  <a:close/>
                </a:path>
              </a:pathLst>
            </a:custGeom>
            <a:solidFill>
              <a:srgbClr val="E4ECF2"/>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35" name="テキスト ボックス 434">
              <a:extLst>
                <a:ext uri="{FF2B5EF4-FFF2-40B4-BE49-F238E27FC236}">
                  <a16:creationId xmlns:a16="http://schemas.microsoft.com/office/drawing/2014/main" id="{34BD6E7E-3DC7-0F34-F9F0-296D572B2916}"/>
                </a:ext>
              </a:extLst>
            </p:cNvPr>
            <p:cNvSpPr txBox="1"/>
            <p:nvPr/>
          </p:nvSpPr>
          <p:spPr>
            <a:xfrm>
              <a:off x="3441782" y="4547435"/>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UGD2</a:t>
              </a:r>
            </a:p>
          </p:txBody>
        </p:sp>
        <p:sp>
          <p:nvSpPr>
            <p:cNvPr id="436" name="フリーフォーム: 図形 435">
              <a:extLst>
                <a:ext uri="{FF2B5EF4-FFF2-40B4-BE49-F238E27FC236}">
                  <a16:creationId xmlns:a16="http://schemas.microsoft.com/office/drawing/2014/main" id="{1575A2BC-7468-5F4E-F402-C0C274F1EBA5}"/>
                </a:ext>
              </a:extLst>
            </p:cNvPr>
            <p:cNvSpPr/>
            <p:nvPr/>
          </p:nvSpPr>
          <p:spPr>
            <a:xfrm>
              <a:off x="3852261" y="4424040"/>
              <a:ext cx="129816" cy="129816"/>
            </a:xfrm>
            <a:custGeom>
              <a:avLst/>
              <a:gdLst>
                <a:gd name="csX0" fmla="*/ 126306 w 129816"/>
                <a:gd name="csY0" fmla="*/ 65368 h 129816"/>
                <a:gd name="csX1" fmla="*/ 61398 w 129816"/>
                <a:gd name="csY1" fmla="*/ 130276 h 129816"/>
                <a:gd name="csX2" fmla="*/ -3511 w 129816"/>
                <a:gd name="csY2" fmla="*/ 65368 h 129816"/>
                <a:gd name="csX3" fmla="*/ 61398 w 129816"/>
                <a:gd name="csY3" fmla="*/ 460 h 129816"/>
                <a:gd name="csX4" fmla="*/ 126306 w 129816"/>
                <a:gd name="csY4" fmla="*/ 65368 h 129816"/>
              </a:gdLst>
              <a:ahLst/>
              <a:cxnLst>
                <a:cxn ang="0">
                  <a:pos x="csX0" y="csY0"/>
                </a:cxn>
                <a:cxn ang="0">
                  <a:pos x="csX1" y="csY1"/>
                </a:cxn>
                <a:cxn ang="0">
                  <a:pos x="csX2" y="csY2"/>
                </a:cxn>
                <a:cxn ang="0">
                  <a:pos x="csX3" y="csY3"/>
                </a:cxn>
                <a:cxn ang="0">
                  <a:pos x="csX4" y="csY4"/>
                </a:cxn>
              </a:cxnLst>
              <a:rect l="l" t="t" r="r" b="b"/>
              <a:pathLst>
                <a:path w="129816" h="129816">
                  <a:moveTo>
                    <a:pt x="126306" y="65368"/>
                  </a:moveTo>
                  <a:cubicBezTo>
                    <a:pt x="126306" y="101216"/>
                    <a:pt x="97245" y="130276"/>
                    <a:pt x="61398" y="130276"/>
                  </a:cubicBezTo>
                  <a:cubicBezTo>
                    <a:pt x="25550" y="130276"/>
                    <a:pt x="-3511" y="101216"/>
                    <a:pt x="-3511" y="65368"/>
                  </a:cubicBezTo>
                  <a:cubicBezTo>
                    <a:pt x="-3511" y="29520"/>
                    <a:pt x="25550" y="460"/>
                    <a:pt x="61398" y="460"/>
                  </a:cubicBezTo>
                  <a:cubicBezTo>
                    <a:pt x="97245" y="460"/>
                    <a:pt x="126306" y="29520"/>
                    <a:pt x="126306" y="65368"/>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37" name="フリーフォーム: 図形 436">
              <a:extLst>
                <a:ext uri="{FF2B5EF4-FFF2-40B4-BE49-F238E27FC236}">
                  <a16:creationId xmlns:a16="http://schemas.microsoft.com/office/drawing/2014/main" id="{727707FA-B074-65CF-91F5-77B6EEF2AA0F}"/>
                </a:ext>
              </a:extLst>
            </p:cNvPr>
            <p:cNvSpPr/>
            <p:nvPr/>
          </p:nvSpPr>
          <p:spPr>
            <a:xfrm>
              <a:off x="3852261" y="4424040"/>
              <a:ext cx="129816" cy="129816"/>
            </a:xfrm>
            <a:custGeom>
              <a:avLst/>
              <a:gdLst>
                <a:gd name="csX0" fmla="*/ 126306 w 129816"/>
                <a:gd name="csY0" fmla="*/ 65368 h 129816"/>
                <a:gd name="csX1" fmla="*/ 61398 w 129816"/>
                <a:gd name="csY1" fmla="*/ 130276 h 129816"/>
                <a:gd name="csX2" fmla="*/ -3511 w 129816"/>
                <a:gd name="csY2" fmla="*/ 65368 h 129816"/>
                <a:gd name="csX3" fmla="*/ 61398 w 129816"/>
                <a:gd name="csY3" fmla="*/ 460 h 129816"/>
                <a:gd name="csX4" fmla="*/ 126306 w 129816"/>
                <a:gd name="csY4" fmla="*/ 65368 h 129816"/>
              </a:gdLst>
              <a:ahLst/>
              <a:cxnLst>
                <a:cxn ang="0">
                  <a:pos x="csX0" y="csY0"/>
                </a:cxn>
                <a:cxn ang="0">
                  <a:pos x="csX1" y="csY1"/>
                </a:cxn>
                <a:cxn ang="0">
                  <a:pos x="csX2" y="csY2"/>
                </a:cxn>
                <a:cxn ang="0">
                  <a:pos x="csX3" y="csY3"/>
                </a:cxn>
                <a:cxn ang="0">
                  <a:pos x="csX4" y="csY4"/>
                </a:cxn>
              </a:cxnLst>
              <a:rect l="l" t="t" r="r" b="b"/>
              <a:pathLst>
                <a:path w="129816" h="129816">
                  <a:moveTo>
                    <a:pt x="126306" y="65368"/>
                  </a:moveTo>
                  <a:cubicBezTo>
                    <a:pt x="126306" y="101216"/>
                    <a:pt x="97245" y="130276"/>
                    <a:pt x="61398" y="130276"/>
                  </a:cubicBezTo>
                  <a:cubicBezTo>
                    <a:pt x="25550" y="130276"/>
                    <a:pt x="-3511" y="101216"/>
                    <a:pt x="-3511" y="65368"/>
                  </a:cubicBezTo>
                  <a:cubicBezTo>
                    <a:pt x="-3511" y="29520"/>
                    <a:pt x="25550" y="460"/>
                    <a:pt x="61398" y="460"/>
                  </a:cubicBezTo>
                  <a:cubicBezTo>
                    <a:pt x="97245" y="460"/>
                    <a:pt x="126306" y="29520"/>
                    <a:pt x="126306" y="65368"/>
                  </a:cubicBezTo>
                  <a:close/>
                </a:path>
              </a:pathLst>
            </a:custGeom>
            <a:solidFill>
              <a:srgbClr val="F7F1EE"/>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38" name="テキスト ボックス 437">
              <a:extLst>
                <a:ext uri="{FF2B5EF4-FFF2-40B4-BE49-F238E27FC236}">
                  <a16:creationId xmlns:a16="http://schemas.microsoft.com/office/drawing/2014/main" id="{4A2A402C-C251-0E6A-21FD-D3FFCFB8C9A7}"/>
                </a:ext>
              </a:extLst>
            </p:cNvPr>
            <p:cNvSpPr txBox="1"/>
            <p:nvPr/>
          </p:nvSpPr>
          <p:spPr>
            <a:xfrm>
              <a:off x="3755559" y="4412354"/>
              <a:ext cx="31771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TOL1</a:t>
              </a:r>
            </a:p>
          </p:txBody>
        </p:sp>
        <p:sp>
          <p:nvSpPr>
            <p:cNvPr id="439" name="フリーフォーム: 図形 438">
              <a:extLst>
                <a:ext uri="{FF2B5EF4-FFF2-40B4-BE49-F238E27FC236}">
                  <a16:creationId xmlns:a16="http://schemas.microsoft.com/office/drawing/2014/main" id="{0CC53284-2402-9358-50B6-272927C42B88}"/>
                </a:ext>
              </a:extLst>
            </p:cNvPr>
            <p:cNvSpPr/>
            <p:nvPr/>
          </p:nvSpPr>
          <p:spPr>
            <a:xfrm>
              <a:off x="3065790" y="4657604"/>
              <a:ext cx="141618" cy="141617"/>
            </a:xfrm>
            <a:custGeom>
              <a:avLst/>
              <a:gdLst>
                <a:gd name="csX0" fmla="*/ 67478 w 141618"/>
                <a:gd name="csY0" fmla="*/ 404 h 141617"/>
                <a:gd name="csX1" fmla="*/ 138288 w 141618"/>
                <a:gd name="csY1" fmla="*/ 71213 h 141617"/>
                <a:gd name="csX2" fmla="*/ 67478 w 141618"/>
                <a:gd name="csY2" fmla="*/ 142022 h 141617"/>
                <a:gd name="csX3" fmla="*/ -3331 w 141618"/>
                <a:gd name="csY3" fmla="*/ 71213 h 141617"/>
              </a:gdLst>
              <a:ahLst/>
              <a:cxnLst>
                <a:cxn ang="0">
                  <a:pos x="csX0" y="csY0"/>
                </a:cxn>
                <a:cxn ang="0">
                  <a:pos x="csX1" y="csY1"/>
                </a:cxn>
                <a:cxn ang="0">
                  <a:pos x="csX2" y="csY2"/>
                </a:cxn>
                <a:cxn ang="0">
                  <a:pos x="csX3" y="csY3"/>
                </a:cxn>
              </a:cxnLst>
              <a:rect l="l" t="t" r="r" b="b"/>
              <a:pathLst>
                <a:path w="141618" h="141617">
                  <a:moveTo>
                    <a:pt x="67478" y="404"/>
                  </a:moveTo>
                  <a:lnTo>
                    <a:pt x="138288" y="71213"/>
                  </a:lnTo>
                  <a:lnTo>
                    <a:pt x="67478" y="142022"/>
                  </a:lnTo>
                  <a:lnTo>
                    <a:pt x="-3331" y="71213"/>
                  </a:ln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40" name="フリーフォーム: 図形 439">
              <a:extLst>
                <a:ext uri="{FF2B5EF4-FFF2-40B4-BE49-F238E27FC236}">
                  <a16:creationId xmlns:a16="http://schemas.microsoft.com/office/drawing/2014/main" id="{C0910BE0-0021-9C51-2D6D-AF9660766326}"/>
                </a:ext>
              </a:extLst>
            </p:cNvPr>
            <p:cNvSpPr/>
            <p:nvPr/>
          </p:nvSpPr>
          <p:spPr>
            <a:xfrm>
              <a:off x="3065790" y="4657604"/>
              <a:ext cx="141618" cy="141617"/>
            </a:xfrm>
            <a:custGeom>
              <a:avLst/>
              <a:gdLst>
                <a:gd name="csX0" fmla="*/ 67478 w 141618"/>
                <a:gd name="csY0" fmla="*/ 404 h 141617"/>
                <a:gd name="csX1" fmla="*/ 138288 w 141618"/>
                <a:gd name="csY1" fmla="*/ 71213 h 141617"/>
                <a:gd name="csX2" fmla="*/ 67478 w 141618"/>
                <a:gd name="csY2" fmla="*/ 142022 h 141617"/>
                <a:gd name="csX3" fmla="*/ -3331 w 141618"/>
                <a:gd name="csY3" fmla="*/ 71213 h 141617"/>
              </a:gdLst>
              <a:ahLst/>
              <a:cxnLst>
                <a:cxn ang="0">
                  <a:pos x="csX0" y="csY0"/>
                </a:cxn>
                <a:cxn ang="0">
                  <a:pos x="csX1" y="csY1"/>
                </a:cxn>
                <a:cxn ang="0">
                  <a:pos x="csX2" y="csY2"/>
                </a:cxn>
                <a:cxn ang="0">
                  <a:pos x="csX3" y="csY3"/>
                </a:cxn>
              </a:cxnLst>
              <a:rect l="l" t="t" r="r" b="b"/>
              <a:pathLst>
                <a:path w="141618" h="141617">
                  <a:moveTo>
                    <a:pt x="67478" y="404"/>
                  </a:moveTo>
                  <a:lnTo>
                    <a:pt x="138288" y="71213"/>
                  </a:lnTo>
                  <a:lnTo>
                    <a:pt x="67478" y="142022"/>
                  </a:lnTo>
                  <a:lnTo>
                    <a:pt x="-3331" y="71213"/>
                  </a:lnTo>
                  <a:close/>
                </a:path>
              </a:pathLst>
            </a:custGeom>
            <a:solidFill>
              <a:srgbClr val="F7E6DE"/>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41" name="テキスト ボックス 440">
              <a:extLst>
                <a:ext uri="{FF2B5EF4-FFF2-40B4-BE49-F238E27FC236}">
                  <a16:creationId xmlns:a16="http://schemas.microsoft.com/office/drawing/2014/main" id="{0CFC3FA8-83E9-96F9-7ADB-9AB41447A619}"/>
                </a:ext>
              </a:extLst>
            </p:cNvPr>
            <p:cNvSpPr txBox="1"/>
            <p:nvPr/>
          </p:nvSpPr>
          <p:spPr>
            <a:xfrm>
              <a:off x="2955608" y="4651379"/>
              <a:ext cx="35618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HOT1</a:t>
              </a:r>
            </a:p>
          </p:txBody>
        </p:sp>
        <p:sp>
          <p:nvSpPr>
            <p:cNvPr id="442" name="フリーフォーム: 図形 441">
              <a:extLst>
                <a:ext uri="{FF2B5EF4-FFF2-40B4-BE49-F238E27FC236}">
                  <a16:creationId xmlns:a16="http://schemas.microsoft.com/office/drawing/2014/main" id="{197F490F-F9A2-2A0F-5879-6FD79D6AD3F5}"/>
                </a:ext>
              </a:extLst>
            </p:cNvPr>
            <p:cNvSpPr/>
            <p:nvPr/>
          </p:nvSpPr>
          <p:spPr>
            <a:xfrm>
              <a:off x="4195716" y="5472881"/>
              <a:ext cx="129816" cy="129816"/>
            </a:xfrm>
            <a:custGeom>
              <a:avLst/>
              <a:gdLst>
                <a:gd name="csX0" fmla="*/ 126227 w 129816"/>
                <a:gd name="csY0" fmla="*/ 65123 h 129816"/>
                <a:gd name="csX1" fmla="*/ 61319 w 129816"/>
                <a:gd name="csY1" fmla="*/ 130031 h 129816"/>
                <a:gd name="csX2" fmla="*/ -3590 w 129816"/>
                <a:gd name="csY2" fmla="*/ 65123 h 129816"/>
                <a:gd name="csX3" fmla="*/ 61319 w 129816"/>
                <a:gd name="csY3" fmla="*/ 215 h 129816"/>
                <a:gd name="csX4" fmla="*/ 126227 w 129816"/>
                <a:gd name="csY4" fmla="*/ 65123 h 129816"/>
              </a:gdLst>
              <a:ahLst/>
              <a:cxnLst>
                <a:cxn ang="0">
                  <a:pos x="csX0" y="csY0"/>
                </a:cxn>
                <a:cxn ang="0">
                  <a:pos x="csX1" y="csY1"/>
                </a:cxn>
                <a:cxn ang="0">
                  <a:pos x="csX2" y="csY2"/>
                </a:cxn>
                <a:cxn ang="0">
                  <a:pos x="csX3" y="csY3"/>
                </a:cxn>
                <a:cxn ang="0">
                  <a:pos x="csX4" y="csY4"/>
                </a:cxn>
              </a:cxnLst>
              <a:rect l="l" t="t" r="r" b="b"/>
              <a:pathLst>
                <a:path w="129816" h="129816">
                  <a:moveTo>
                    <a:pt x="126227" y="65123"/>
                  </a:moveTo>
                  <a:cubicBezTo>
                    <a:pt x="126227" y="100971"/>
                    <a:pt x="97166" y="130031"/>
                    <a:pt x="61319" y="130031"/>
                  </a:cubicBezTo>
                  <a:cubicBezTo>
                    <a:pt x="25471" y="130031"/>
                    <a:pt x="-3590" y="100971"/>
                    <a:pt x="-3590" y="65123"/>
                  </a:cubicBezTo>
                  <a:cubicBezTo>
                    <a:pt x="-3590" y="29275"/>
                    <a:pt x="25471" y="215"/>
                    <a:pt x="61319" y="215"/>
                  </a:cubicBezTo>
                  <a:cubicBezTo>
                    <a:pt x="97166" y="215"/>
                    <a:pt x="126227" y="29275"/>
                    <a:pt x="126227" y="65123"/>
                  </a:cubicBezTo>
                  <a:close/>
                </a:path>
              </a:pathLst>
            </a:custGeom>
            <a:solidFill>
              <a:srgbClr val="F8E0D4"/>
            </a:solidFill>
            <a:ln w="6350" cap="sq">
              <a:solidFill>
                <a:schemeClr val="accent2"/>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43" name="テキスト ボックス 442">
              <a:extLst>
                <a:ext uri="{FF2B5EF4-FFF2-40B4-BE49-F238E27FC236}">
                  <a16:creationId xmlns:a16="http://schemas.microsoft.com/office/drawing/2014/main" id="{E4AA4D3C-EEBB-B5FD-D4AA-17095FF56314}"/>
                </a:ext>
              </a:extLst>
            </p:cNvPr>
            <p:cNvSpPr txBox="1"/>
            <p:nvPr/>
          </p:nvSpPr>
          <p:spPr>
            <a:xfrm>
              <a:off x="4081734" y="5464137"/>
              <a:ext cx="35939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BD10</a:t>
              </a:r>
            </a:p>
          </p:txBody>
        </p:sp>
        <p:sp>
          <p:nvSpPr>
            <p:cNvPr id="444" name="フリーフォーム: 図形 443">
              <a:extLst>
                <a:ext uri="{FF2B5EF4-FFF2-40B4-BE49-F238E27FC236}">
                  <a16:creationId xmlns:a16="http://schemas.microsoft.com/office/drawing/2014/main" id="{3E58FAAD-9D4A-2515-47AD-C8E80A966B4F}"/>
                </a:ext>
              </a:extLst>
            </p:cNvPr>
            <p:cNvSpPr/>
            <p:nvPr/>
          </p:nvSpPr>
          <p:spPr>
            <a:xfrm>
              <a:off x="4049849" y="4409789"/>
              <a:ext cx="129816" cy="129816"/>
            </a:xfrm>
            <a:custGeom>
              <a:avLst/>
              <a:gdLst>
                <a:gd name="csX0" fmla="*/ 126260 w 129816"/>
                <a:gd name="csY0" fmla="*/ 65371 h 129816"/>
                <a:gd name="csX1" fmla="*/ 61352 w 129816"/>
                <a:gd name="csY1" fmla="*/ 130279 h 129816"/>
                <a:gd name="csX2" fmla="*/ -3556 w 129816"/>
                <a:gd name="csY2" fmla="*/ 65371 h 129816"/>
                <a:gd name="csX3" fmla="*/ 61352 w 129816"/>
                <a:gd name="csY3" fmla="*/ 463 h 129816"/>
                <a:gd name="csX4" fmla="*/ 126260 w 129816"/>
                <a:gd name="csY4" fmla="*/ 65371 h 129816"/>
              </a:gdLst>
              <a:ahLst/>
              <a:cxnLst>
                <a:cxn ang="0">
                  <a:pos x="csX0" y="csY0"/>
                </a:cxn>
                <a:cxn ang="0">
                  <a:pos x="csX1" y="csY1"/>
                </a:cxn>
                <a:cxn ang="0">
                  <a:pos x="csX2" y="csY2"/>
                </a:cxn>
                <a:cxn ang="0">
                  <a:pos x="csX3" y="csY3"/>
                </a:cxn>
                <a:cxn ang="0">
                  <a:pos x="csX4" y="csY4"/>
                </a:cxn>
              </a:cxnLst>
              <a:rect l="l" t="t" r="r" b="b"/>
              <a:pathLst>
                <a:path w="129816" h="129816">
                  <a:moveTo>
                    <a:pt x="126260" y="65371"/>
                  </a:moveTo>
                  <a:cubicBezTo>
                    <a:pt x="126260" y="101219"/>
                    <a:pt x="97200" y="130279"/>
                    <a:pt x="61352" y="130279"/>
                  </a:cubicBezTo>
                  <a:cubicBezTo>
                    <a:pt x="25504" y="130279"/>
                    <a:pt x="-3556" y="101219"/>
                    <a:pt x="-3556" y="65371"/>
                  </a:cubicBezTo>
                  <a:cubicBezTo>
                    <a:pt x="-3556" y="29523"/>
                    <a:pt x="25504" y="463"/>
                    <a:pt x="61352" y="463"/>
                  </a:cubicBezTo>
                  <a:cubicBezTo>
                    <a:pt x="97200" y="463"/>
                    <a:pt x="126260" y="29523"/>
                    <a:pt x="126260" y="65371"/>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45" name="フリーフォーム: 図形 444">
              <a:extLst>
                <a:ext uri="{FF2B5EF4-FFF2-40B4-BE49-F238E27FC236}">
                  <a16:creationId xmlns:a16="http://schemas.microsoft.com/office/drawing/2014/main" id="{6381827C-3EA5-0573-6892-F06B361EE2D4}"/>
                </a:ext>
              </a:extLst>
            </p:cNvPr>
            <p:cNvSpPr/>
            <p:nvPr/>
          </p:nvSpPr>
          <p:spPr>
            <a:xfrm>
              <a:off x="4049849" y="4409789"/>
              <a:ext cx="129816" cy="129816"/>
            </a:xfrm>
            <a:custGeom>
              <a:avLst/>
              <a:gdLst>
                <a:gd name="csX0" fmla="*/ 126260 w 129816"/>
                <a:gd name="csY0" fmla="*/ 65371 h 129816"/>
                <a:gd name="csX1" fmla="*/ 61352 w 129816"/>
                <a:gd name="csY1" fmla="*/ 130279 h 129816"/>
                <a:gd name="csX2" fmla="*/ -3556 w 129816"/>
                <a:gd name="csY2" fmla="*/ 65371 h 129816"/>
                <a:gd name="csX3" fmla="*/ 61352 w 129816"/>
                <a:gd name="csY3" fmla="*/ 463 h 129816"/>
                <a:gd name="csX4" fmla="*/ 126260 w 129816"/>
                <a:gd name="csY4" fmla="*/ 65371 h 129816"/>
              </a:gdLst>
              <a:ahLst/>
              <a:cxnLst>
                <a:cxn ang="0">
                  <a:pos x="csX0" y="csY0"/>
                </a:cxn>
                <a:cxn ang="0">
                  <a:pos x="csX1" y="csY1"/>
                </a:cxn>
                <a:cxn ang="0">
                  <a:pos x="csX2" y="csY2"/>
                </a:cxn>
                <a:cxn ang="0">
                  <a:pos x="csX3" y="csY3"/>
                </a:cxn>
                <a:cxn ang="0">
                  <a:pos x="csX4" y="csY4"/>
                </a:cxn>
              </a:cxnLst>
              <a:rect l="l" t="t" r="r" b="b"/>
              <a:pathLst>
                <a:path w="129816" h="129816">
                  <a:moveTo>
                    <a:pt x="126260" y="65371"/>
                  </a:moveTo>
                  <a:cubicBezTo>
                    <a:pt x="126260" y="101219"/>
                    <a:pt x="97200" y="130279"/>
                    <a:pt x="61352" y="130279"/>
                  </a:cubicBezTo>
                  <a:cubicBezTo>
                    <a:pt x="25504" y="130279"/>
                    <a:pt x="-3556" y="101219"/>
                    <a:pt x="-3556" y="65371"/>
                  </a:cubicBezTo>
                  <a:cubicBezTo>
                    <a:pt x="-3556" y="29523"/>
                    <a:pt x="25504" y="463"/>
                    <a:pt x="61352" y="463"/>
                  </a:cubicBezTo>
                  <a:cubicBezTo>
                    <a:pt x="97200" y="463"/>
                    <a:pt x="126260" y="29523"/>
                    <a:pt x="126260" y="65371"/>
                  </a:cubicBezTo>
                  <a:close/>
                </a:path>
              </a:pathLst>
            </a:custGeom>
            <a:solidFill>
              <a:srgbClr val="E6EEF2"/>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46" name="テキスト ボックス 445">
              <a:extLst>
                <a:ext uri="{FF2B5EF4-FFF2-40B4-BE49-F238E27FC236}">
                  <a16:creationId xmlns:a16="http://schemas.microsoft.com/office/drawing/2014/main" id="{AD820433-EDA7-CE38-FB8F-FF6CE1569A98}"/>
                </a:ext>
              </a:extLst>
            </p:cNvPr>
            <p:cNvSpPr txBox="1"/>
            <p:nvPr/>
          </p:nvSpPr>
          <p:spPr>
            <a:xfrm>
              <a:off x="3954482" y="4398103"/>
              <a:ext cx="31451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ZAT6</a:t>
              </a:r>
            </a:p>
          </p:txBody>
        </p:sp>
        <p:sp>
          <p:nvSpPr>
            <p:cNvPr id="447" name="フリーフォーム: 図形 446">
              <a:extLst>
                <a:ext uri="{FF2B5EF4-FFF2-40B4-BE49-F238E27FC236}">
                  <a16:creationId xmlns:a16="http://schemas.microsoft.com/office/drawing/2014/main" id="{3861EDAD-5B1E-8126-B154-3765A4A55050}"/>
                </a:ext>
              </a:extLst>
            </p:cNvPr>
            <p:cNvSpPr/>
            <p:nvPr/>
          </p:nvSpPr>
          <p:spPr>
            <a:xfrm>
              <a:off x="3694716" y="5224812"/>
              <a:ext cx="129816" cy="129816"/>
            </a:xfrm>
            <a:custGeom>
              <a:avLst/>
              <a:gdLst>
                <a:gd name="csX0" fmla="*/ 126342 w 129816"/>
                <a:gd name="csY0" fmla="*/ 65183 h 129816"/>
                <a:gd name="csX1" fmla="*/ 61434 w 129816"/>
                <a:gd name="csY1" fmla="*/ 130091 h 129816"/>
                <a:gd name="csX2" fmla="*/ -3474 w 129816"/>
                <a:gd name="csY2" fmla="*/ 65183 h 129816"/>
                <a:gd name="csX3" fmla="*/ 61434 w 129816"/>
                <a:gd name="csY3" fmla="*/ 275 h 129816"/>
                <a:gd name="csX4" fmla="*/ 126342 w 129816"/>
                <a:gd name="csY4" fmla="*/ 65183 h 129816"/>
              </a:gdLst>
              <a:ahLst/>
              <a:cxnLst>
                <a:cxn ang="0">
                  <a:pos x="csX0" y="csY0"/>
                </a:cxn>
                <a:cxn ang="0">
                  <a:pos x="csX1" y="csY1"/>
                </a:cxn>
                <a:cxn ang="0">
                  <a:pos x="csX2" y="csY2"/>
                </a:cxn>
                <a:cxn ang="0">
                  <a:pos x="csX3" y="csY3"/>
                </a:cxn>
                <a:cxn ang="0">
                  <a:pos x="csX4" y="csY4"/>
                </a:cxn>
              </a:cxnLst>
              <a:rect l="l" t="t" r="r" b="b"/>
              <a:pathLst>
                <a:path w="129816" h="129816">
                  <a:moveTo>
                    <a:pt x="126342" y="65183"/>
                  </a:moveTo>
                  <a:cubicBezTo>
                    <a:pt x="126342" y="101031"/>
                    <a:pt x="97282" y="130091"/>
                    <a:pt x="61434" y="130091"/>
                  </a:cubicBezTo>
                  <a:cubicBezTo>
                    <a:pt x="25586" y="130091"/>
                    <a:pt x="-3474" y="101031"/>
                    <a:pt x="-3474" y="65183"/>
                  </a:cubicBezTo>
                  <a:cubicBezTo>
                    <a:pt x="-3474" y="29335"/>
                    <a:pt x="25586" y="275"/>
                    <a:pt x="61434" y="275"/>
                  </a:cubicBezTo>
                  <a:cubicBezTo>
                    <a:pt x="97282" y="275"/>
                    <a:pt x="126342" y="29335"/>
                    <a:pt x="126342" y="65183"/>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48" name="フリーフォーム: 図形 447">
              <a:extLst>
                <a:ext uri="{FF2B5EF4-FFF2-40B4-BE49-F238E27FC236}">
                  <a16:creationId xmlns:a16="http://schemas.microsoft.com/office/drawing/2014/main" id="{C68098F7-EBC6-0CFE-8E9F-50BE3B80DB7B}"/>
                </a:ext>
              </a:extLst>
            </p:cNvPr>
            <p:cNvSpPr/>
            <p:nvPr/>
          </p:nvSpPr>
          <p:spPr>
            <a:xfrm>
              <a:off x="3694716" y="5224812"/>
              <a:ext cx="129816" cy="129816"/>
            </a:xfrm>
            <a:custGeom>
              <a:avLst/>
              <a:gdLst>
                <a:gd name="csX0" fmla="*/ 126342 w 129816"/>
                <a:gd name="csY0" fmla="*/ 65183 h 129816"/>
                <a:gd name="csX1" fmla="*/ 61434 w 129816"/>
                <a:gd name="csY1" fmla="*/ 130091 h 129816"/>
                <a:gd name="csX2" fmla="*/ -3474 w 129816"/>
                <a:gd name="csY2" fmla="*/ 65183 h 129816"/>
                <a:gd name="csX3" fmla="*/ 61434 w 129816"/>
                <a:gd name="csY3" fmla="*/ 275 h 129816"/>
                <a:gd name="csX4" fmla="*/ 126342 w 129816"/>
                <a:gd name="csY4" fmla="*/ 65183 h 129816"/>
              </a:gdLst>
              <a:ahLst/>
              <a:cxnLst>
                <a:cxn ang="0">
                  <a:pos x="csX0" y="csY0"/>
                </a:cxn>
                <a:cxn ang="0">
                  <a:pos x="csX1" y="csY1"/>
                </a:cxn>
                <a:cxn ang="0">
                  <a:pos x="csX2" y="csY2"/>
                </a:cxn>
                <a:cxn ang="0">
                  <a:pos x="csX3" y="csY3"/>
                </a:cxn>
                <a:cxn ang="0">
                  <a:pos x="csX4" y="csY4"/>
                </a:cxn>
              </a:cxnLst>
              <a:rect l="l" t="t" r="r" b="b"/>
              <a:pathLst>
                <a:path w="129816" h="129816">
                  <a:moveTo>
                    <a:pt x="126342" y="65183"/>
                  </a:moveTo>
                  <a:cubicBezTo>
                    <a:pt x="126342" y="101031"/>
                    <a:pt x="97282" y="130091"/>
                    <a:pt x="61434" y="130091"/>
                  </a:cubicBezTo>
                  <a:cubicBezTo>
                    <a:pt x="25586" y="130091"/>
                    <a:pt x="-3474" y="101031"/>
                    <a:pt x="-3474" y="65183"/>
                  </a:cubicBezTo>
                  <a:cubicBezTo>
                    <a:pt x="-3474" y="29335"/>
                    <a:pt x="25586" y="275"/>
                    <a:pt x="61434" y="275"/>
                  </a:cubicBezTo>
                  <a:cubicBezTo>
                    <a:pt x="97282" y="275"/>
                    <a:pt x="126342" y="29335"/>
                    <a:pt x="126342" y="65183"/>
                  </a:cubicBezTo>
                  <a:close/>
                </a:path>
              </a:pathLst>
            </a:custGeom>
            <a:solidFill>
              <a:srgbClr val="F8D9C9"/>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49" name="テキスト ボックス 448">
              <a:extLst>
                <a:ext uri="{FF2B5EF4-FFF2-40B4-BE49-F238E27FC236}">
                  <a16:creationId xmlns:a16="http://schemas.microsoft.com/office/drawing/2014/main" id="{22D6A556-1361-E785-7D04-BD53FC18136F}"/>
                </a:ext>
              </a:extLst>
            </p:cNvPr>
            <p:cNvSpPr txBox="1"/>
            <p:nvPr/>
          </p:nvSpPr>
          <p:spPr>
            <a:xfrm>
              <a:off x="3585235" y="5211782"/>
              <a:ext cx="34496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CLC-A</a:t>
              </a:r>
            </a:p>
          </p:txBody>
        </p:sp>
        <p:sp>
          <p:nvSpPr>
            <p:cNvPr id="450" name="フリーフォーム: 図形 449">
              <a:extLst>
                <a:ext uri="{FF2B5EF4-FFF2-40B4-BE49-F238E27FC236}">
                  <a16:creationId xmlns:a16="http://schemas.microsoft.com/office/drawing/2014/main" id="{9BCD924C-00C9-A321-BEEB-9ECED7D726E8}"/>
                </a:ext>
              </a:extLst>
            </p:cNvPr>
            <p:cNvSpPr/>
            <p:nvPr/>
          </p:nvSpPr>
          <p:spPr>
            <a:xfrm>
              <a:off x="3357000" y="5076631"/>
              <a:ext cx="144000" cy="144000"/>
            </a:xfrm>
            <a:custGeom>
              <a:avLst/>
              <a:gdLst>
                <a:gd name="csX0" fmla="*/ 126418 w 129816"/>
                <a:gd name="csY0" fmla="*/ 65216 h 129816"/>
                <a:gd name="csX1" fmla="*/ 61510 w 129816"/>
                <a:gd name="csY1" fmla="*/ 130124 h 129816"/>
                <a:gd name="csX2" fmla="*/ -3398 w 129816"/>
                <a:gd name="csY2" fmla="*/ 65216 h 129816"/>
                <a:gd name="csX3" fmla="*/ 61510 w 129816"/>
                <a:gd name="csY3" fmla="*/ 308 h 129816"/>
                <a:gd name="csX4" fmla="*/ 126418 w 129816"/>
                <a:gd name="csY4" fmla="*/ 65216 h 129816"/>
              </a:gdLst>
              <a:ahLst/>
              <a:cxnLst>
                <a:cxn ang="0">
                  <a:pos x="csX0" y="csY0"/>
                </a:cxn>
                <a:cxn ang="0">
                  <a:pos x="csX1" y="csY1"/>
                </a:cxn>
                <a:cxn ang="0">
                  <a:pos x="csX2" y="csY2"/>
                </a:cxn>
                <a:cxn ang="0">
                  <a:pos x="csX3" y="csY3"/>
                </a:cxn>
                <a:cxn ang="0">
                  <a:pos x="csX4" y="csY4"/>
                </a:cxn>
              </a:cxnLst>
              <a:rect l="l" t="t" r="r" b="b"/>
              <a:pathLst>
                <a:path w="129816" h="129816">
                  <a:moveTo>
                    <a:pt x="126418" y="65216"/>
                  </a:moveTo>
                  <a:cubicBezTo>
                    <a:pt x="126418" y="101064"/>
                    <a:pt x="97358" y="130124"/>
                    <a:pt x="61510" y="130124"/>
                  </a:cubicBezTo>
                  <a:cubicBezTo>
                    <a:pt x="25662" y="130124"/>
                    <a:pt x="-3398" y="101064"/>
                    <a:pt x="-3398" y="65216"/>
                  </a:cubicBezTo>
                  <a:cubicBezTo>
                    <a:pt x="-3398" y="29368"/>
                    <a:pt x="25662" y="308"/>
                    <a:pt x="61510" y="308"/>
                  </a:cubicBezTo>
                  <a:cubicBezTo>
                    <a:pt x="97358" y="308"/>
                    <a:pt x="126418" y="29368"/>
                    <a:pt x="126418" y="65216"/>
                  </a:cubicBezTo>
                  <a:close/>
                </a:path>
              </a:pathLst>
            </a:custGeom>
            <a:solidFill>
              <a:srgbClr val="F7F7F7"/>
            </a:solidFill>
            <a:ln w="6350" cap="sq">
              <a:solidFill>
                <a:schemeClr val="tx1">
                  <a:lumMod val="50000"/>
                  <a:lumOff val="50000"/>
                </a:schemeClr>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51" name="テキスト ボックス 450">
              <a:extLst>
                <a:ext uri="{FF2B5EF4-FFF2-40B4-BE49-F238E27FC236}">
                  <a16:creationId xmlns:a16="http://schemas.microsoft.com/office/drawing/2014/main" id="{620EFE39-1B40-D324-FF3B-B6B57ED710CE}"/>
                </a:ext>
              </a:extLst>
            </p:cNvPr>
            <p:cNvSpPr txBox="1"/>
            <p:nvPr/>
          </p:nvSpPr>
          <p:spPr>
            <a:xfrm>
              <a:off x="3248033" y="5073093"/>
              <a:ext cx="35939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NPF6.3</a:t>
              </a:r>
            </a:p>
          </p:txBody>
        </p:sp>
        <p:sp>
          <p:nvSpPr>
            <p:cNvPr id="452" name="フリーフォーム: 図形 451">
              <a:extLst>
                <a:ext uri="{FF2B5EF4-FFF2-40B4-BE49-F238E27FC236}">
                  <a16:creationId xmlns:a16="http://schemas.microsoft.com/office/drawing/2014/main" id="{554E77C5-01CE-AB9F-DEFB-E45140B9C044}"/>
                </a:ext>
              </a:extLst>
            </p:cNvPr>
            <p:cNvSpPr/>
            <p:nvPr/>
          </p:nvSpPr>
          <p:spPr>
            <a:xfrm>
              <a:off x="4150363" y="4723623"/>
              <a:ext cx="129816" cy="129816"/>
            </a:xfrm>
            <a:custGeom>
              <a:avLst/>
              <a:gdLst>
                <a:gd name="csX0" fmla="*/ 126237 w 129816"/>
                <a:gd name="csY0" fmla="*/ 65299 h 129816"/>
                <a:gd name="csX1" fmla="*/ 61329 w 129816"/>
                <a:gd name="csY1" fmla="*/ 130207 h 129816"/>
                <a:gd name="csX2" fmla="*/ -3580 w 129816"/>
                <a:gd name="csY2" fmla="*/ 65299 h 129816"/>
                <a:gd name="csX3" fmla="*/ 61329 w 129816"/>
                <a:gd name="csY3" fmla="*/ 390 h 129816"/>
                <a:gd name="csX4" fmla="*/ 126237 w 129816"/>
                <a:gd name="csY4" fmla="*/ 65299 h 129816"/>
              </a:gdLst>
              <a:ahLst/>
              <a:cxnLst>
                <a:cxn ang="0">
                  <a:pos x="csX0" y="csY0"/>
                </a:cxn>
                <a:cxn ang="0">
                  <a:pos x="csX1" y="csY1"/>
                </a:cxn>
                <a:cxn ang="0">
                  <a:pos x="csX2" y="csY2"/>
                </a:cxn>
                <a:cxn ang="0">
                  <a:pos x="csX3" y="csY3"/>
                </a:cxn>
                <a:cxn ang="0">
                  <a:pos x="csX4" y="csY4"/>
                </a:cxn>
              </a:cxnLst>
              <a:rect l="l" t="t" r="r" b="b"/>
              <a:pathLst>
                <a:path w="129816" h="129816">
                  <a:moveTo>
                    <a:pt x="126237" y="65299"/>
                  </a:moveTo>
                  <a:cubicBezTo>
                    <a:pt x="126237" y="101147"/>
                    <a:pt x="97176" y="130207"/>
                    <a:pt x="61329" y="130207"/>
                  </a:cubicBezTo>
                  <a:cubicBezTo>
                    <a:pt x="25481" y="130207"/>
                    <a:pt x="-3580" y="101147"/>
                    <a:pt x="-3580" y="65299"/>
                  </a:cubicBezTo>
                  <a:cubicBezTo>
                    <a:pt x="-3580" y="29451"/>
                    <a:pt x="25481" y="390"/>
                    <a:pt x="61329" y="390"/>
                  </a:cubicBezTo>
                  <a:cubicBezTo>
                    <a:pt x="97176" y="390"/>
                    <a:pt x="126237" y="29451"/>
                    <a:pt x="126237" y="65299"/>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53" name="フリーフォーム: 図形 452">
              <a:extLst>
                <a:ext uri="{FF2B5EF4-FFF2-40B4-BE49-F238E27FC236}">
                  <a16:creationId xmlns:a16="http://schemas.microsoft.com/office/drawing/2014/main" id="{85B84372-5775-D983-8A13-732623FFECC9}"/>
                </a:ext>
              </a:extLst>
            </p:cNvPr>
            <p:cNvSpPr/>
            <p:nvPr/>
          </p:nvSpPr>
          <p:spPr>
            <a:xfrm>
              <a:off x="4150363" y="4723623"/>
              <a:ext cx="129816" cy="129816"/>
            </a:xfrm>
            <a:custGeom>
              <a:avLst/>
              <a:gdLst>
                <a:gd name="csX0" fmla="*/ 126237 w 129816"/>
                <a:gd name="csY0" fmla="*/ 65299 h 129816"/>
                <a:gd name="csX1" fmla="*/ 61329 w 129816"/>
                <a:gd name="csY1" fmla="*/ 130207 h 129816"/>
                <a:gd name="csX2" fmla="*/ -3580 w 129816"/>
                <a:gd name="csY2" fmla="*/ 65299 h 129816"/>
                <a:gd name="csX3" fmla="*/ 61329 w 129816"/>
                <a:gd name="csY3" fmla="*/ 390 h 129816"/>
                <a:gd name="csX4" fmla="*/ 126237 w 129816"/>
                <a:gd name="csY4" fmla="*/ 65299 h 129816"/>
              </a:gdLst>
              <a:ahLst/>
              <a:cxnLst>
                <a:cxn ang="0">
                  <a:pos x="csX0" y="csY0"/>
                </a:cxn>
                <a:cxn ang="0">
                  <a:pos x="csX1" y="csY1"/>
                </a:cxn>
                <a:cxn ang="0">
                  <a:pos x="csX2" y="csY2"/>
                </a:cxn>
                <a:cxn ang="0">
                  <a:pos x="csX3" y="csY3"/>
                </a:cxn>
                <a:cxn ang="0">
                  <a:pos x="csX4" y="csY4"/>
                </a:cxn>
              </a:cxnLst>
              <a:rect l="l" t="t" r="r" b="b"/>
              <a:pathLst>
                <a:path w="129816" h="129816">
                  <a:moveTo>
                    <a:pt x="126237" y="65299"/>
                  </a:moveTo>
                  <a:cubicBezTo>
                    <a:pt x="126237" y="101147"/>
                    <a:pt x="97176" y="130207"/>
                    <a:pt x="61329" y="130207"/>
                  </a:cubicBezTo>
                  <a:cubicBezTo>
                    <a:pt x="25481" y="130207"/>
                    <a:pt x="-3580" y="101147"/>
                    <a:pt x="-3580" y="65299"/>
                  </a:cubicBezTo>
                  <a:cubicBezTo>
                    <a:pt x="-3580" y="29451"/>
                    <a:pt x="25481" y="390"/>
                    <a:pt x="61329" y="390"/>
                  </a:cubicBezTo>
                  <a:cubicBezTo>
                    <a:pt x="97176" y="390"/>
                    <a:pt x="126237" y="29451"/>
                    <a:pt x="126237" y="65299"/>
                  </a:cubicBezTo>
                  <a:close/>
                </a:path>
              </a:pathLst>
            </a:custGeom>
            <a:solidFill>
              <a:srgbClr val="B5D2E5"/>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54" name="テキスト ボックス 453">
              <a:extLst>
                <a:ext uri="{FF2B5EF4-FFF2-40B4-BE49-F238E27FC236}">
                  <a16:creationId xmlns:a16="http://schemas.microsoft.com/office/drawing/2014/main" id="{87208EAC-032E-6D06-CB71-AB7E75162E09}"/>
                </a:ext>
              </a:extLst>
            </p:cNvPr>
            <p:cNvSpPr txBox="1"/>
            <p:nvPr/>
          </p:nvSpPr>
          <p:spPr>
            <a:xfrm>
              <a:off x="4058318" y="4712556"/>
              <a:ext cx="32252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GRF4</a:t>
              </a:r>
            </a:p>
          </p:txBody>
        </p:sp>
        <p:sp>
          <p:nvSpPr>
            <p:cNvPr id="455" name="フリーフォーム: 図形 454">
              <a:extLst>
                <a:ext uri="{FF2B5EF4-FFF2-40B4-BE49-F238E27FC236}">
                  <a16:creationId xmlns:a16="http://schemas.microsoft.com/office/drawing/2014/main" id="{B598B27F-9E74-DF52-A2B6-7A8178B7D395}"/>
                </a:ext>
              </a:extLst>
            </p:cNvPr>
            <p:cNvSpPr/>
            <p:nvPr/>
          </p:nvSpPr>
          <p:spPr>
            <a:xfrm>
              <a:off x="3714532" y="5777226"/>
              <a:ext cx="141618" cy="141617"/>
            </a:xfrm>
            <a:custGeom>
              <a:avLst/>
              <a:gdLst>
                <a:gd name="csX0" fmla="*/ 67329 w 141618"/>
                <a:gd name="csY0" fmla="*/ 146 h 141617"/>
                <a:gd name="csX1" fmla="*/ 138138 w 141618"/>
                <a:gd name="csY1" fmla="*/ 70955 h 141617"/>
                <a:gd name="csX2" fmla="*/ 67329 w 141618"/>
                <a:gd name="csY2" fmla="*/ 141764 h 141617"/>
                <a:gd name="csX3" fmla="*/ -3480 w 141618"/>
                <a:gd name="csY3" fmla="*/ 70955 h 141617"/>
              </a:gdLst>
              <a:ahLst/>
              <a:cxnLst>
                <a:cxn ang="0">
                  <a:pos x="csX0" y="csY0"/>
                </a:cxn>
                <a:cxn ang="0">
                  <a:pos x="csX1" y="csY1"/>
                </a:cxn>
                <a:cxn ang="0">
                  <a:pos x="csX2" y="csY2"/>
                </a:cxn>
                <a:cxn ang="0">
                  <a:pos x="csX3" y="csY3"/>
                </a:cxn>
              </a:cxnLst>
              <a:rect l="l" t="t" r="r" b="b"/>
              <a:pathLst>
                <a:path w="141618" h="141617">
                  <a:moveTo>
                    <a:pt x="67329" y="146"/>
                  </a:moveTo>
                  <a:lnTo>
                    <a:pt x="138138" y="70955"/>
                  </a:lnTo>
                  <a:lnTo>
                    <a:pt x="67329" y="141764"/>
                  </a:lnTo>
                  <a:lnTo>
                    <a:pt x="-3480" y="70955"/>
                  </a:ln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56" name="フリーフォーム: 図形 455">
              <a:extLst>
                <a:ext uri="{FF2B5EF4-FFF2-40B4-BE49-F238E27FC236}">
                  <a16:creationId xmlns:a16="http://schemas.microsoft.com/office/drawing/2014/main" id="{ABE37ECB-C6DF-6A4C-835B-B57A438E7A17}"/>
                </a:ext>
              </a:extLst>
            </p:cNvPr>
            <p:cNvSpPr/>
            <p:nvPr/>
          </p:nvSpPr>
          <p:spPr>
            <a:xfrm>
              <a:off x="3714532" y="5777226"/>
              <a:ext cx="141618" cy="141617"/>
            </a:xfrm>
            <a:custGeom>
              <a:avLst/>
              <a:gdLst>
                <a:gd name="csX0" fmla="*/ 67329 w 141618"/>
                <a:gd name="csY0" fmla="*/ 146 h 141617"/>
                <a:gd name="csX1" fmla="*/ 138138 w 141618"/>
                <a:gd name="csY1" fmla="*/ 70955 h 141617"/>
                <a:gd name="csX2" fmla="*/ 67329 w 141618"/>
                <a:gd name="csY2" fmla="*/ 141764 h 141617"/>
                <a:gd name="csX3" fmla="*/ -3480 w 141618"/>
                <a:gd name="csY3" fmla="*/ 70955 h 141617"/>
              </a:gdLst>
              <a:ahLst/>
              <a:cxnLst>
                <a:cxn ang="0">
                  <a:pos x="csX0" y="csY0"/>
                </a:cxn>
                <a:cxn ang="0">
                  <a:pos x="csX1" y="csY1"/>
                </a:cxn>
                <a:cxn ang="0">
                  <a:pos x="csX2" y="csY2"/>
                </a:cxn>
                <a:cxn ang="0">
                  <a:pos x="csX3" y="csY3"/>
                </a:cxn>
              </a:cxnLst>
              <a:rect l="l" t="t" r="r" b="b"/>
              <a:pathLst>
                <a:path w="141618" h="141617">
                  <a:moveTo>
                    <a:pt x="67329" y="146"/>
                  </a:moveTo>
                  <a:lnTo>
                    <a:pt x="138138" y="70955"/>
                  </a:lnTo>
                  <a:lnTo>
                    <a:pt x="67329" y="141764"/>
                  </a:lnTo>
                  <a:lnTo>
                    <a:pt x="-3480" y="70955"/>
                  </a:lnTo>
                  <a:close/>
                </a:path>
              </a:pathLst>
            </a:custGeom>
            <a:solidFill>
              <a:srgbClr val="4292C6"/>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57" name="テキスト ボックス 456">
              <a:extLst>
                <a:ext uri="{FF2B5EF4-FFF2-40B4-BE49-F238E27FC236}">
                  <a16:creationId xmlns:a16="http://schemas.microsoft.com/office/drawing/2014/main" id="{62E68C1A-8630-DE8C-7220-B1E22256C31B}"/>
                </a:ext>
              </a:extLst>
            </p:cNvPr>
            <p:cNvSpPr txBox="1"/>
            <p:nvPr/>
          </p:nvSpPr>
          <p:spPr>
            <a:xfrm>
              <a:off x="3634451" y="5770919"/>
              <a:ext cx="29527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IS</a:t>
              </a:r>
              <a:r>
                <a:rPr lang="en-US" altLang="ja-JP" sz="400" b="1" baseline="0" dirty="0">
                  <a:ln w="0"/>
                  <a:latin typeface="Arial" panose="020B0604020202020204" pitchFamily="34" charset="0"/>
                  <a:cs typeface="Arial" panose="020B0604020202020204" pitchFamily="34" charset="0"/>
                  <a:sym typeface="Helvetica"/>
                  <a:rtl val="0"/>
                </a:rPr>
                <a:t>8</a:t>
              </a:r>
              <a:endParaRPr lang="ja-JP" altLang="en-US" sz="400" b="1" baseline="0" dirty="0">
                <a:ln w="0"/>
                <a:latin typeface="Arial" panose="020B0604020202020204" pitchFamily="34" charset="0"/>
                <a:cs typeface="Arial" panose="020B0604020202020204" pitchFamily="34" charset="0"/>
                <a:sym typeface="Helvetica"/>
                <a:rtl val="0"/>
              </a:endParaRPr>
            </a:p>
          </p:txBody>
        </p:sp>
        <p:sp>
          <p:nvSpPr>
            <p:cNvPr id="458" name="フリーフォーム: 図形 457">
              <a:extLst>
                <a:ext uri="{FF2B5EF4-FFF2-40B4-BE49-F238E27FC236}">
                  <a16:creationId xmlns:a16="http://schemas.microsoft.com/office/drawing/2014/main" id="{28DA5D9D-AB36-A94B-889B-1021796D961B}"/>
                </a:ext>
              </a:extLst>
            </p:cNvPr>
            <p:cNvSpPr/>
            <p:nvPr/>
          </p:nvSpPr>
          <p:spPr>
            <a:xfrm>
              <a:off x="3170095" y="4853149"/>
              <a:ext cx="129816" cy="129816"/>
            </a:xfrm>
            <a:custGeom>
              <a:avLst/>
              <a:gdLst>
                <a:gd name="csX0" fmla="*/ 126463 w 129816"/>
                <a:gd name="csY0" fmla="*/ 65269 h 129816"/>
                <a:gd name="csX1" fmla="*/ 61555 w 129816"/>
                <a:gd name="csY1" fmla="*/ 130177 h 129816"/>
                <a:gd name="csX2" fmla="*/ -3353 w 129816"/>
                <a:gd name="csY2" fmla="*/ 65269 h 129816"/>
                <a:gd name="csX3" fmla="*/ 61555 w 129816"/>
                <a:gd name="csY3" fmla="*/ 361 h 129816"/>
                <a:gd name="csX4" fmla="*/ 126463 w 129816"/>
                <a:gd name="csY4" fmla="*/ 65269 h 129816"/>
              </a:gdLst>
              <a:ahLst/>
              <a:cxnLst>
                <a:cxn ang="0">
                  <a:pos x="csX0" y="csY0"/>
                </a:cxn>
                <a:cxn ang="0">
                  <a:pos x="csX1" y="csY1"/>
                </a:cxn>
                <a:cxn ang="0">
                  <a:pos x="csX2" y="csY2"/>
                </a:cxn>
                <a:cxn ang="0">
                  <a:pos x="csX3" y="csY3"/>
                </a:cxn>
                <a:cxn ang="0">
                  <a:pos x="csX4" y="csY4"/>
                </a:cxn>
              </a:cxnLst>
              <a:rect l="l" t="t" r="r" b="b"/>
              <a:pathLst>
                <a:path w="129816" h="129816">
                  <a:moveTo>
                    <a:pt x="126463" y="65269"/>
                  </a:moveTo>
                  <a:cubicBezTo>
                    <a:pt x="126463" y="101117"/>
                    <a:pt x="97403" y="130177"/>
                    <a:pt x="61555" y="130177"/>
                  </a:cubicBezTo>
                  <a:cubicBezTo>
                    <a:pt x="25707" y="130177"/>
                    <a:pt x="-3353" y="101117"/>
                    <a:pt x="-3353" y="65269"/>
                  </a:cubicBezTo>
                  <a:cubicBezTo>
                    <a:pt x="-3353" y="29421"/>
                    <a:pt x="25707" y="361"/>
                    <a:pt x="61555" y="361"/>
                  </a:cubicBezTo>
                  <a:cubicBezTo>
                    <a:pt x="97403" y="361"/>
                    <a:pt x="126463" y="29421"/>
                    <a:pt x="126463" y="65269"/>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59" name="フリーフォーム: 図形 458">
              <a:extLst>
                <a:ext uri="{FF2B5EF4-FFF2-40B4-BE49-F238E27FC236}">
                  <a16:creationId xmlns:a16="http://schemas.microsoft.com/office/drawing/2014/main" id="{461D0D66-28B4-1B73-A120-AF5F6E5028B5}"/>
                </a:ext>
              </a:extLst>
            </p:cNvPr>
            <p:cNvSpPr/>
            <p:nvPr/>
          </p:nvSpPr>
          <p:spPr>
            <a:xfrm>
              <a:off x="3170095" y="4853149"/>
              <a:ext cx="129816" cy="129816"/>
            </a:xfrm>
            <a:custGeom>
              <a:avLst/>
              <a:gdLst>
                <a:gd name="csX0" fmla="*/ 126463 w 129816"/>
                <a:gd name="csY0" fmla="*/ 65269 h 129816"/>
                <a:gd name="csX1" fmla="*/ 61555 w 129816"/>
                <a:gd name="csY1" fmla="*/ 130177 h 129816"/>
                <a:gd name="csX2" fmla="*/ -3353 w 129816"/>
                <a:gd name="csY2" fmla="*/ 65269 h 129816"/>
                <a:gd name="csX3" fmla="*/ 61555 w 129816"/>
                <a:gd name="csY3" fmla="*/ 361 h 129816"/>
                <a:gd name="csX4" fmla="*/ 126463 w 129816"/>
                <a:gd name="csY4" fmla="*/ 65269 h 129816"/>
              </a:gdLst>
              <a:ahLst/>
              <a:cxnLst>
                <a:cxn ang="0">
                  <a:pos x="csX0" y="csY0"/>
                </a:cxn>
                <a:cxn ang="0">
                  <a:pos x="csX1" y="csY1"/>
                </a:cxn>
                <a:cxn ang="0">
                  <a:pos x="csX2" y="csY2"/>
                </a:cxn>
                <a:cxn ang="0">
                  <a:pos x="csX3" y="csY3"/>
                </a:cxn>
                <a:cxn ang="0">
                  <a:pos x="csX4" y="csY4"/>
                </a:cxn>
              </a:cxnLst>
              <a:rect l="l" t="t" r="r" b="b"/>
              <a:pathLst>
                <a:path w="129816" h="129816">
                  <a:moveTo>
                    <a:pt x="126463" y="65269"/>
                  </a:moveTo>
                  <a:cubicBezTo>
                    <a:pt x="126463" y="101117"/>
                    <a:pt x="97403" y="130177"/>
                    <a:pt x="61555" y="130177"/>
                  </a:cubicBezTo>
                  <a:cubicBezTo>
                    <a:pt x="25707" y="130177"/>
                    <a:pt x="-3353" y="101117"/>
                    <a:pt x="-3353" y="65269"/>
                  </a:cubicBezTo>
                  <a:cubicBezTo>
                    <a:pt x="-3353" y="29421"/>
                    <a:pt x="25707" y="361"/>
                    <a:pt x="61555" y="361"/>
                  </a:cubicBezTo>
                  <a:cubicBezTo>
                    <a:pt x="97403" y="361"/>
                    <a:pt x="126463" y="29421"/>
                    <a:pt x="126463" y="65269"/>
                  </a:cubicBezTo>
                  <a:close/>
                </a:path>
              </a:pathLst>
            </a:custGeom>
            <a:solidFill>
              <a:srgbClr val="FA7837"/>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60" name="テキスト ボックス 459">
              <a:extLst>
                <a:ext uri="{FF2B5EF4-FFF2-40B4-BE49-F238E27FC236}">
                  <a16:creationId xmlns:a16="http://schemas.microsoft.com/office/drawing/2014/main" id="{6FD2762E-6397-732B-62CC-4AD51C24C35A}"/>
                </a:ext>
              </a:extLst>
            </p:cNvPr>
            <p:cNvSpPr txBox="1"/>
            <p:nvPr/>
          </p:nvSpPr>
          <p:spPr>
            <a:xfrm>
              <a:off x="3083747" y="4845219"/>
              <a:ext cx="298479"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IN2</a:t>
              </a:r>
            </a:p>
          </p:txBody>
        </p:sp>
        <p:sp>
          <p:nvSpPr>
            <p:cNvPr id="461" name="フリーフォーム: 図形 460">
              <a:extLst>
                <a:ext uri="{FF2B5EF4-FFF2-40B4-BE49-F238E27FC236}">
                  <a16:creationId xmlns:a16="http://schemas.microsoft.com/office/drawing/2014/main" id="{D87155CB-FFC2-E483-4136-75285B3CFD93}"/>
                </a:ext>
              </a:extLst>
            </p:cNvPr>
            <p:cNvSpPr/>
            <p:nvPr/>
          </p:nvSpPr>
          <p:spPr>
            <a:xfrm>
              <a:off x="3065092" y="5366224"/>
              <a:ext cx="141618" cy="141617"/>
            </a:xfrm>
            <a:custGeom>
              <a:avLst/>
              <a:gdLst>
                <a:gd name="csX0" fmla="*/ 67479 w 141618"/>
                <a:gd name="csY0" fmla="*/ 241 h 141617"/>
                <a:gd name="csX1" fmla="*/ 138288 w 141618"/>
                <a:gd name="csY1" fmla="*/ 71050 h 141617"/>
                <a:gd name="csX2" fmla="*/ 67479 w 141618"/>
                <a:gd name="csY2" fmla="*/ 141859 h 141617"/>
                <a:gd name="csX3" fmla="*/ -3330 w 141618"/>
                <a:gd name="csY3" fmla="*/ 71050 h 141617"/>
              </a:gdLst>
              <a:ahLst/>
              <a:cxnLst>
                <a:cxn ang="0">
                  <a:pos x="csX0" y="csY0"/>
                </a:cxn>
                <a:cxn ang="0">
                  <a:pos x="csX1" y="csY1"/>
                </a:cxn>
                <a:cxn ang="0">
                  <a:pos x="csX2" y="csY2"/>
                </a:cxn>
                <a:cxn ang="0">
                  <a:pos x="csX3" y="csY3"/>
                </a:cxn>
              </a:cxnLst>
              <a:rect l="l" t="t" r="r" b="b"/>
              <a:pathLst>
                <a:path w="141618" h="141617">
                  <a:moveTo>
                    <a:pt x="67479" y="241"/>
                  </a:moveTo>
                  <a:lnTo>
                    <a:pt x="138288" y="71050"/>
                  </a:lnTo>
                  <a:lnTo>
                    <a:pt x="67479" y="141859"/>
                  </a:lnTo>
                  <a:lnTo>
                    <a:pt x="-3330" y="71050"/>
                  </a:ln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62" name="フリーフォーム: 図形 461">
              <a:extLst>
                <a:ext uri="{FF2B5EF4-FFF2-40B4-BE49-F238E27FC236}">
                  <a16:creationId xmlns:a16="http://schemas.microsoft.com/office/drawing/2014/main" id="{1C0BED32-497B-225D-7300-916D7CFA00E7}"/>
                </a:ext>
              </a:extLst>
            </p:cNvPr>
            <p:cNvSpPr/>
            <p:nvPr/>
          </p:nvSpPr>
          <p:spPr>
            <a:xfrm>
              <a:off x="3065092" y="5366224"/>
              <a:ext cx="141618" cy="141617"/>
            </a:xfrm>
            <a:custGeom>
              <a:avLst/>
              <a:gdLst>
                <a:gd name="csX0" fmla="*/ 67479 w 141618"/>
                <a:gd name="csY0" fmla="*/ 241 h 141617"/>
                <a:gd name="csX1" fmla="*/ 138288 w 141618"/>
                <a:gd name="csY1" fmla="*/ 71050 h 141617"/>
                <a:gd name="csX2" fmla="*/ 67479 w 141618"/>
                <a:gd name="csY2" fmla="*/ 141859 h 141617"/>
                <a:gd name="csX3" fmla="*/ -3330 w 141618"/>
                <a:gd name="csY3" fmla="*/ 71050 h 141617"/>
              </a:gdLst>
              <a:ahLst/>
              <a:cxnLst>
                <a:cxn ang="0">
                  <a:pos x="csX0" y="csY0"/>
                </a:cxn>
                <a:cxn ang="0">
                  <a:pos x="csX1" y="csY1"/>
                </a:cxn>
                <a:cxn ang="0">
                  <a:pos x="csX2" y="csY2"/>
                </a:cxn>
                <a:cxn ang="0">
                  <a:pos x="csX3" y="csY3"/>
                </a:cxn>
              </a:cxnLst>
              <a:rect l="l" t="t" r="r" b="b"/>
              <a:pathLst>
                <a:path w="141618" h="141617">
                  <a:moveTo>
                    <a:pt x="67479" y="241"/>
                  </a:moveTo>
                  <a:lnTo>
                    <a:pt x="138288" y="71050"/>
                  </a:lnTo>
                  <a:lnTo>
                    <a:pt x="67479" y="141859"/>
                  </a:lnTo>
                  <a:lnTo>
                    <a:pt x="-3330" y="71050"/>
                  </a:lnTo>
                  <a:close/>
                </a:path>
              </a:pathLst>
            </a:custGeom>
            <a:solidFill>
              <a:srgbClr val="E6EDF2"/>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63" name="テキスト ボックス 462">
              <a:extLst>
                <a:ext uri="{FF2B5EF4-FFF2-40B4-BE49-F238E27FC236}">
                  <a16:creationId xmlns:a16="http://schemas.microsoft.com/office/drawing/2014/main" id="{F1365C75-2F67-FE0E-25BF-C43F8139EA6C}"/>
                </a:ext>
              </a:extLst>
            </p:cNvPr>
            <p:cNvSpPr txBox="1"/>
            <p:nvPr/>
          </p:nvSpPr>
          <p:spPr>
            <a:xfrm>
              <a:off x="2961323" y="5356870"/>
              <a:ext cx="34496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RAF24</a:t>
              </a:r>
            </a:p>
          </p:txBody>
        </p:sp>
        <p:sp>
          <p:nvSpPr>
            <p:cNvPr id="464" name="フリーフォーム: 図形 463">
              <a:extLst>
                <a:ext uri="{FF2B5EF4-FFF2-40B4-BE49-F238E27FC236}">
                  <a16:creationId xmlns:a16="http://schemas.microsoft.com/office/drawing/2014/main" id="{CA816740-6092-27A2-BE5D-35866CA0DE06}"/>
                </a:ext>
              </a:extLst>
            </p:cNvPr>
            <p:cNvSpPr/>
            <p:nvPr/>
          </p:nvSpPr>
          <p:spPr>
            <a:xfrm>
              <a:off x="2932821" y="5174156"/>
              <a:ext cx="141618" cy="141617"/>
            </a:xfrm>
            <a:custGeom>
              <a:avLst/>
              <a:gdLst>
                <a:gd name="csX0" fmla="*/ 67509 w 141618"/>
                <a:gd name="csY0" fmla="*/ 285 h 141617"/>
                <a:gd name="csX1" fmla="*/ 138318 w 141618"/>
                <a:gd name="csY1" fmla="*/ 71094 h 141617"/>
                <a:gd name="csX2" fmla="*/ 67509 w 141618"/>
                <a:gd name="csY2" fmla="*/ 141903 h 141617"/>
                <a:gd name="csX3" fmla="*/ -3300 w 141618"/>
                <a:gd name="csY3" fmla="*/ 71094 h 141617"/>
              </a:gdLst>
              <a:ahLst/>
              <a:cxnLst>
                <a:cxn ang="0">
                  <a:pos x="csX0" y="csY0"/>
                </a:cxn>
                <a:cxn ang="0">
                  <a:pos x="csX1" y="csY1"/>
                </a:cxn>
                <a:cxn ang="0">
                  <a:pos x="csX2" y="csY2"/>
                </a:cxn>
                <a:cxn ang="0">
                  <a:pos x="csX3" y="csY3"/>
                </a:cxn>
              </a:cxnLst>
              <a:rect l="l" t="t" r="r" b="b"/>
              <a:pathLst>
                <a:path w="141618" h="141617">
                  <a:moveTo>
                    <a:pt x="67509" y="285"/>
                  </a:moveTo>
                  <a:lnTo>
                    <a:pt x="138318" y="71094"/>
                  </a:lnTo>
                  <a:lnTo>
                    <a:pt x="67509" y="141903"/>
                  </a:lnTo>
                  <a:lnTo>
                    <a:pt x="-3300" y="71094"/>
                  </a:ln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65" name="フリーフォーム: 図形 464">
              <a:extLst>
                <a:ext uri="{FF2B5EF4-FFF2-40B4-BE49-F238E27FC236}">
                  <a16:creationId xmlns:a16="http://schemas.microsoft.com/office/drawing/2014/main" id="{AE70F207-1124-CD28-C99D-FDC11A574F66}"/>
                </a:ext>
              </a:extLst>
            </p:cNvPr>
            <p:cNvSpPr/>
            <p:nvPr/>
          </p:nvSpPr>
          <p:spPr>
            <a:xfrm>
              <a:off x="2932821" y="5174156"/>
              <a:ext cx="141618" cy="141617"/>
            </a:xfrm>
            <a:custGeom>
              <a:avLst/>
              <a:gdLst>
                <a:gd name="csX0" fmla="*/ 67509 w 141618"/>
                <a:gd name="csY0" fmla="*/ 285 h 141617"/>
                <a:gd name="csX1" fmla="*/ 138318 w 141618"/>
                <a:gd name="csY1" fmla="*/ 71094 h 141617"/>
                <a:gd name="csX2" fmla="*/ 67509 w 141618"/>
                <a:gd name="csY2" fmla="*/ 141903 h 141617"/>
                <a:gd name="csX3" fmla="*/ -3300 w 141618"/>
                <a:gd name="csY3" fmla="*/ 71094 h 141617"/>
              </a:gdLst>
              <a:ahLst/>
              <a:cxnLst>
                <a:cxn ang="0">
                  <a:pos x="csX0" y="csY0"/>
                </a:cxn>
                <a:cxn ang="0">
                  <a:pos x="csX1" y="csY1"/>
                </a:cxn>
                <a:cxn ang="0">
                  <a:pos x="csX2" y="csY2"/>
                </a:cxn>
                <a:cxn ang="0">
                  <a:pos x="csX3" y="csY3"/>
                </a:cxn>
              </a:cxnLst>
              <a:rect l="l" t="t" r="r" b="b"/>
              <a:pathLst>
                <a:path w="141618" h="141617">
                  <a:moveTo>
                    <a:pt x="67509" y="285"/>
                  </a:moveTo>
                  <a:lnTo>
                    <a:pt x="138318" y="71094"/>
                  </a:lnTo>
                  <a:lnTo>
                    <a:pt x="67509" y="141903"/>
                  </a:lnTo>
                  <a:lnTo>
                    <a:pt x="-3300" y="71094"/>
                  </a:lnTo>
                  <a:close/>
                </a:path>
              </a:pathLst>
            </a:custGeom>
            <a:solidFill>
              <a:srgbClr val="D4E3ED"/>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66" name="テキスト ボックス 465">
              <a:extLst>
                <a:ext uri="{FF2B5EF4-FFF2-40B4-BE49-F238E27FC236}">
                  <a16:creationId xmlns:a16="http://schemas.microsoft.com/office/drawing/2014/main" id="{F9A6C92E-7358-48CF-DD69-F564BFD46BBC}"/>
                </a:ext>
              </a:extLst>
            </p:cNvPr>
            <p:cNvSpPr txBox="1"/>
            <p:nvPr/>
          </p:nvSpPr>
          <p:spPr>
            <a:xfrm>
              <a:off x="2845236" y="5168974"/>
              <a:ext cx="31771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TOT3</a:t>
              </a:r>
            </a:p>
          </p:txBody>
        </p:sp>
        <p:sp>
          <p:nvSpPr>
            <p:cNvPr id="467" name="フリーフォーム: 図形 466">
              <a:extLst>
                <a:ext uri="{FF2B5EF4-FFF2-40B4-BE49-F238E27FC236}">
                  <a16:creationId xmlns:a16="http://schemas.microsoft.com/office/drawing/2014/main" id="{EDE5299E-B0A9-C69B-C249-E54810AAE90E}"/>
                </a:ext>
              </a:extLst>
            </p:cNvPr>
            <p:cNvSpPr/>
            <p:nvPr/>
          </p:nvSpPr>
          <p:spPr>
            <a:xfrm>
              <a:off x="3161558" y="5794390"/>
              <a:ext cx="129816" cy="129816"/>
            </a:xfrm>
            <a:custGeom>
              <a:avLst/>
              <a:gdLst>
                <a:gd name="csX0" fmla="*/ 126465 w 129816"/>
                <a:gd name="csY0" fmla="*/ 65052 h 129816"/>
                <a:gd name="csX1" fmla="*/ 61557 w 129816"/>
                <a:gd name="csY1" fmla="*/ 129960 h 129816"/>
                <a:gd name="csX2" fmla="*/ -3351 w 129816"/>
                <a:gd name="csY2" fmla="*/ 65052 h 129816"/>
                <a:gd name="csX3" fmla="*/ 61557 w 129816"/>
                <a:gd name="csY3" fmla="*/ 143 h 129816"/>
                <a:gd name="csX4" fmla="*/ 126465 w 129816"/>
                <a:gd name="csY4" fmla="*/ 65052 h 129816"/>
              </a:gdLst>
              <a:ahLst/>
              <a:cxnLst>
                <a:cxn ang="0">
                  <a:pos x="csX0" y="csY0"/>
                </a:cxn>
                <a:cxn ang="0">
                  <a:pos x="csX1" y="csY1"/>
                </a:cxn>
                <a:cxn ang="0">
                  <a:pos x="csX2" y="csY2"/>
                </a:cxn>
                <a:cxn ang="0">
                  <a:pos x="csX3" y="csY3"/>
                </a:cxn>
                <a:cxn ang="0">
                  <a:pos x="csX4" y="csY4"/>
                </a:cxn>
              </a:cxnLst>
              <a:rect l="l" t="t" r="r" b="b"/>
              <a:pathLst>
                <a:path w="129816" h="129816">
                  <a:moveTo>
                    <a:pt x="126465" y="65052"/>
                  </a:moveTo>
                  <a:cubicBezTo>
                    <a:pt x="126465" y="100899"/>
                    <a:pt x="97405" y="129960"/>
                    <a:pt x="61557" y="129960"/>
                  </a:cubicBezTo>
                  <a:cubicBezTo>
                    <a:pt x="25709" y="129960"/>
                    <a:pt x="-3351" y="100899"/>
                    <a:pt x="-3351" y="65052"/>
                  </a:cubicBezTo>
                  <a:cubicBezTo>
                    <a:pt x="-3351" y="29204"/>
                    <a:pt x="25709" y="143"/>
                    <a:pt x="61557" y="143"/>
                  </a:cubicBezTo>
                  <a:cubicBezTo>
                    <a:pt x="97405" y="143"/>
                    <a:pt x="126465" y="29204"/>
                    <a:pt x="126465" y="65052"/>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68" name="フリーフォーム: 図形 467">
              <a:extLst>
                <a:ext uri="{FF2B5EF4-FFF2-40B4-BE49-F238E27FC236}">
                  <a16:creationId xmlns:a16="http://schemas.microsoft.com/office/drawing/2014/main" id="{4A450139-B83F-A97E-9595-C84A680C1D41}"/>
                </a:ext>
              </a:extLst>
            </p:cNvPr>
            <p:cNvSpPr/>
            <p:nvPr/>
          </p:nvSpPr>
          <p:spPr>
            <a:xfrm>
              <a:off x="3161558" y="5794390"/>
              <a:ext cx="129816" cy="129816"/>
            </a:xfrm>
            <a:custGeom>
              <a:avLst/>
              <a:gdLst>
                <a:gd name="csX0" fmla="*/ 126465 w 129816"/>
                <a:gd name="csY0" fmla="*/ 65052 h 129816"/>
                <a:gd name="csX1" fmla="*/ 61557 w 129816"/>
                <a:gd name="csY1" fmla="*/ 129960 h 129816"/>
                <a:gd name="csX2" fmla="*/ -3351 w 129816"/>
                <a:gd name="csY2" fmla="*/ 65052 h 129816"/>
                <a:gd name="csX3" fmla="*/ 61557 w 129816"/>
                <a:gd name="csY3" fmla="*/ 143 h 129816"/>
                <a:gd name="csX4" fmla="*/ 126465 w 129816"/>
                <a:gd name="csY4" fmla="*/ 65052 h 129816"/>
              </a:gdLst>
              <a:ahLst/>
              <a:cxnLst>
                <a:cxn ang="0">
                  <a:pos x="csX0" y="csY0"/>
                </a:cxn>
                <a:cxn ang="0">
                  <a:pos x="csX1" y="csY1"/>
                </a:cxn>
                <a:cxn ang="0">
                  <a:pos x="csX2" y="csY2"/>
                </a:cxn>
                <a:cxn ang="0">
                  <a:pos x="csX3" y="csY3"/>
                </a:cxn>
                <a:cxn ang="0">
                  <a:pos x="csX4" y="csY4"/>
                </a:cxn>
              </a:cxnLst>
              <a:rect l="l" t="t" r="r" b="b"/>
              <a:pathLst>
                <a:path w="129816" h="129816">
                  <a:moveTo>
                    <a:pt x="126465" y="65052"/>
                  </a:moveTo>
                  <a:cubicBezTo>
                    <a:pt x="126465" y="100899"/>
                    <a:pt x="97405" y="129960"/>
                    <a:pt x="61557" y="129960"/>
                  </a:cubicBezTo>
                  <a:cubicBezTo>
                    <a:pt x="25709" y="129960"/>
                    <a:pt x="-3351" y="100899"/>
                    <a:pt x="-3351" y="65052"/>
                  </a:cubicBezTo>
                  <a:cubicBezTo>
                    <a:pt x="-3351" y="29204"/>
                    <a:pt x="25709" y="143"/>
                    <a:pt x="61557" y="143"/>
                  </a:cubicBezTo>
                  <a:cubicBezTo>
                    <a:pt x="97405" y="143"/>
                    <a:pt x="126465" y="29204"/>
                    <a:pt x="126465" y="65052"/>
                  </a:cubicBezTo>
                  <a:close/>
                </a:path>
              </a:pathLst>
            </a:custGeom>
            <a:solidFill>
              <a:srgbClr val="FA7837"/>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69" name="テキスト ボックス 468">
              <a:extLst>
                <a:ext uri="{FF2B5EF4-FFF2-40B4-BE49-F238E27FC236}">
                  <a16:creationId xmlns:a16="http://schemas.microsoft.com/office/drawing/2014/main" id="{7EB5C2B4-0201-5243-8027-60D3CF07AA56}"/>
                </a:ext>
              </a:extLst>
            </p:cNvPr>
            <p:cNvSpPr txBox="1"/>
            <p:nvPr/>
          </p:nvSpPr>
          <p:spPr>
            <a:xfrm>
              <a:off x="3060183" y="5789898"/>
              <a:ext cx="31931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ABF3</a:t>
              </a:r>
            </a:p>
          </p:txBody>
        </p:sp>
        <p:sp>
          <p:nvSpPr>
            <p:cNvPr id="470" name="フリーフォーム: 図形 469">
              <a:extLst>
                <a:ext uri="{FF2B5EF4-FFF2-40B4-BE49-F238E27FC236}">
                  <a16:creationId xmlns:a16="http://schemas.microsoft.com/office/drawing/2014/main" id="{A4F25DEF-2349-CD3D-636C-4A4D34601FA7}"/>
                </a:ext>
              </a:extLst>
            </p:cNvPr>
            <p:cNvSpPr/>
            <p:nvPr/>
          </p:nvSpPr>
          <p:spPr>
            <a:xfrm>
              <a:off x="2722307" y="5580908"/>
              <a:ext cx="129816" cy="129816"/>
            </a:xfrm>
            <a:custGeom>
              <a:avLst/>
              <a:gdLst>
                <a:gd name="csX0" fmla="*/ 126567 w 129816"/>
                <a:gd name="csY0" fmla="*/ 65101 h 129816"/>
                <a:gd name="csX1" fmla="*/ 61658 w 129816"/>
                <a:gd name="csY1" fmla="*/ 130009 h 129816"/>
                <a:gd name="csX2" fmla="*/ -3250 w 129816"/>
                <a:gd name="csY2" fmla="*/ 65101 h 129816"/>
                <a:gd name="csX3" fmla="*/ 61658 w 129816"/>
                <a:gd name="csY3" fmla="*/ 193 h 129816"/>
                <a:gd name="csX4" fmla="*/ 126567 w 129816"/>
                <a:gd name="csY4" fmla="*/ 65101 h 129816"/>
              </a:gdLst>
              <a:ahLst/>
              <a:cxnLst>
                <a:cxn ang="0">
                  <a:pos x="csX0" y="csY0"/>
                </a:cxn>
                <a:cxn ang="0">
                  <a:pos x="csX1" y="csY1"/>
                </a:cxn>
                <a:cxn ang="0">
                  <a:pos x="csX2" y="csY2"/>
                </a:cxn>
                <a:cxn ang="0">
                  <a:pos x="csX3" y="csY3"/>
                </a:cxn>
                <a:cxn ang="0">
                  <a:pos x="csX4" y="csY4"/>
                </a:cxn>
              </a:cxnLst>
              <a:rect l="l" t="t" r="r" b="b"/>
              <a:pathLst>
                <a:path w="129816" h="129816">
                  <a:moveTo>
                    <a:pt x="126567" y="65101"/>
                  </a:moveTo>
                  <a:cubicBezTo>
                    <a:pt x="126567" y="100949"/>
                    <a:pt x="97506" y="130009"/>
                    <a:pt x="61658" y="130009"/>
                  </a:cubicBezTo>
                  <a:cubicBezTo>
                    <a:pt x="25811" y="130009"/>
                    <a:pt x="-3250" y="100949"/>
                    <a:pt x="-3250" y="65101"/>
                  </a:cubicBezTo>
                  <a:cubicBezTo>
                    <a:pt x="-3250" y="29253"/>
                    <a:pt x="25811" y="193"/>
                    <a:pt x="61658" y="193"/>
                  </a:cubicBezTo>
                  <a:cubicBezTo>
                    <a:pt x="97506" y="193"/>
                    <a:pt x="126567" y="29253"/>
                    <a:pt x="126567" y="65101"/>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71" name="フリーフォーム: 図形 470">
              <a:extLst>
                <a:ext uri="{FF2B5EF4-FFF2-40B4-BE49-F238E27FC236}">
                  <a16:creationId xmlns:a16="http://schemas.microsoft.com/office/drawing/2014/main" id="{4D028A22-C51E-B0B9-B8D0-8F23FED00158}"/>
                </a:ext>
              </a:extLst>
            </p:cNvPr>
            <p:cNvSpPr/>
            <p:nvPr/>
          </p:nvSpPr>
          <p:spPr>
            <a:xfrm>
              <a:off x="2722307" y="5580908"/>
              <a:ext cx="129816" cy="129816"/>
            </a:xfrm>
            <a:custGeom>
              <a:avLst/>
              <a:gdLst>
                <a:gd name="csX0" fmla="*/ 126567 w 129816"/>
                <a:gd name="csY0" fmla="*/ 65101 h 129816"/>
                <a:gd name="csX1" fmla="*/ 61658 w 129816"/>
                <a:gd name="csY1" fmla="*/ 130009 h 129816"/>
                <a:gd name="csX2" fmla="*/ -3250 w 129816"/>
                <a:gd name="csY2" fmla="*/ 65101 h 129816"/>
                <a:gd name="csX3" fmla="*/ 61658 w 129816"/>
                <a:gd name="csY3" fmla="*/ 193 h 129816"/>
                <a:gd name="csX4" fmla="*/ 126567 w 129816"/>
                <a:gd name="csY4" fmla="*/ 65101 h 129816"/>
              </a:gdLst>
              <a:ahLst/>
              <a:cxnLst>
                <a:cxn ang="0">
                  <a:pos x="csX0" y="csY0"/>
                </a:cxn>
                <a:cxn ang="0">
                  <a:pos x="csX1" y="csY1"/>
                </a:cxn>
                <a:cxn ang="0">
                  <a:pos x="csX2" y="csY2"/>
                </a:cxn>
                <a:cxn ang="0">
                  <a:pos x="csX3" y="csY3"/>
                </a:cxn>
                <a:cxn ang="0">
                  <a:pos x="csX4" y="csY4"/>
                </a:cxn>
              </a:cxnLst>
              <a:rect l="l" t="t" r="r" b="b"/>
              <a:pathLst>
                <a:path w="129816" h="129816">
                  <a:moveTo>
                    <a:pt x="126567" y="65101"/>
                  </a:moveTo>
                  <a:cubicBezTo>
                    <a:pt x="126567" y="100949"/>
                    <a:pt x="97506" y="130009"/>
                    <a:pt x="61658" y="130009"/>
                  </a:cubicBezTo>
                  <a:cubicBezTo>
                    <a:pt x="25811" y="130009"/>
                    <a:pt x="-3250" y="100949"/>
                    <a:pt x="-3250" y="65101"/>
                  </a:cubicBezTo>
                  <a:cubicBezTo>
                    <a:pt x="-3250" y="29253"/>
                    <a:pt x="25811" y="193"/>
                    <a:pt x="61658" y="193"/>
                  </a:cubicBezTo>
                  <a:cubicBezTo>
                    <a:pt x="97506" y="193"/>
                    <a:pt x="126567" y="29253"/>
                    <a:pt x="126567" y="65101"/>
                  </a:cubicBezTo>
                  <a:close/>
                </a:path>
              </a:pathLst>
            </a:custGeom>
            <a:solidFill>
              <a:srgbClr val="F8DCCE"/>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72" name="テキスト ボックス 471">
              <a:extLst>
                <a:ext uri="{FF2B5EF4-FFF2-40B4-BE49-F238E27FC236}">
                  <a16:creationId xmlns:a16="http://schemas.microsoft.com/office/drawing/2014/main" id="{71D3E393-8ADF-DC4C-99DD-09C04A22F053}"/>
                </a:ext>
              </a:extLst>
            </p:cNvPr>
            <p:cNvSpPr txBox="1"/>
            <p:nvPr/>
          </p:nvSpPr>
          <p:spPr>
            <a:xfrm>
              <a:off x="2589297" y="5574603"/>
              <a:ext cx="380232"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LP423</a:t>
              </a:r>
            </a:p>
          </p:txBody>
        </p:sp>
        <p:sp>
          <p:nvSpPr>
            <p:cNvPr id="473" name="フリーフォーム: 図形 472">
              <a:extLst>
                <a:ext uri="{FF2B5EF4-FFF2-40B4-BE49-F238E27FC236}">
                  <a16:creationId xmlns:a16="http://schemas.microsoft.com/office/drawing/2014/main" id="{C54F2AC6-C6D3-ADEA-1EE7-3B97097831F0}"/>
                </a:ext>
              </a:extLst>
            </p:cNvPr>
            <p:cNvSpPr/>
            <p:nvPr/>
          </p:nvSpPr>
          <p:spPr>
            <a:xfrm>
              <a:off x="2943827" y="4512091"/>
              <a:ext cx="129816" cy="129816"/>
            </a:xfrm>
            <a:custGeom>
              <a:avLst/>
              <a:gdLst>
                <a:gd name="csX0" fmla="*/ 126516 w 129816"/>
                <a:gd name="csY0" fmla="*/ 65348 h 129816"/>
                <a:gd name="csX1" fmla="*/ 61607 w 129816"/>
                <a:gd name="csY1" fmla="*/ 130256 h 129816"/>
                <a:gd name="csX2" fmla="*/ -3301 w 129816"/>
                <a:gd name="csY2" fmla="*/ 65348 h 129816"/>
                <a:gd name="csX3" fmla="*/ 61607 w 129816"/>
                <a:gd name="csY3" fmla="*/ 439 h 129816"/>
                <a:gd name="csX4" fmla="*/ 126516 w 129816"/>
                <a:gd name="csY4" fmla="*/ 65348 h 129816"/>
              </a:gdLst>
              <a:ahLst/>
              <a:cxnLst>
                <a:cxn ang="0">
                  <a:pos x="csX0" y="csY0"/>
                </a:cxn>
                <a:cxn ang="0">
                  <a:pos x="csX1" y="csY1"/>
                </a:cxn>
                <a:cxn ang="0">
                  <a:pos x="csX2" y="csY2"/>
                </a:cxn>
                <a:cxn ang="0">
                  <a:pos x="csX3" y="csY3"/>
                </a:cxn>
                <a:cxn ang="0">
                  <a:pos x="csX4" y="csY4"/>
                </a:cxn>
              </a:cxnLst>
              <a:rect l="l" t="t" r="r" b="b"/>
              <a:pathLst>
                <a:path w="129816" h="129816">
                  <a:moveTo>
                    <a:pt x="126516" y="65348"/>
                  </a:moveTo>
                  <a:cubicBezTo>
                    <a:pt x="126516" y="101195"/>
                    <a:pt x="97455" y="130256"/>
                    <a:pt x="61607" y="130256"/>
                  </a:cubicBezTo>
                  <a:cubicBezTo>
                    <a:pt x="25760" y="130256"/>
                    <a:pt x="-3301" y="101195"/>
                    <a:pt x="-3301" y="65348"/>
                  </a:cubicBezTo>
                  <a:cubicBezTo>
                    <a:pt x="-3301" y="29500"/>
                    <a:pt x="25760" y="439"/>
                    <a:pt x="61607" y="439"/>
                  </a:cubicBezTo>
                  <a:cubicBezTo>
                    <a:pt x="97455" y="439"/>
                    <a:pt x="126516" y="29500"/>
                    <a:pt x="126516" y="65348"/>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74" name="フリーフォーム: 図形 473">
              <a:extLst>
                <a:ext uri="{FF2B5EF4-FFF2-40B4-BE49-F238E27FC236}">
                  <a16:creationId xmlns:a16="http://schemas.microsoft.com/office/drawing/2014/main" id="{11870C2C-B84D-5EB0-2DDA-1FB0CD3705EE}"/>
                </a:ext>
              </a:extLst>
            </p:cNvPr>
            <p:cNvSpPr/>
            <p:nvPr/>
          </p:nvSpPr>
          <p:spPr>
            <a:xfrm>
              <a:off x="2943827" y="4512091"/>
              <a:ext cx="129816" cy="129816"/>
            </a:xfrm>
            <a:custGeom>
              <a:avLst/>
              <a:gdLst>
                <a:gd name="csX0" fmla="*/ 126516 w 129816"/>
                <a:gd name="csY0" fmla="*/ 65348 h 129816"/>
                <a:gd name="csX1" fmla="*/ 61607 w 129816"/>
                <a:gd name="csY1" fmla="*/ 130256 h 129816"/>
                <a:gd name="csX2" fmla="*/ -3301 w 129816"/>
                <a:gd name="csY2" fmla="*/ 65348 h 129816"/>
                <a:gd name="csX3" fmla="*/ 61607 w 129816"/>
                <a:gd name="csY3" fmla="*/ 439 h 129816"/>
                <a:gd name="csX4" fmla="*/ 126516 w 129816"/>
                <a:gd name="csY4" fmla="*/ 65348 h 129816"/>
              </a:gdLst>
              <a:ahLst/>
              <a:cxnLst>
                <a:cxn ang="0">
                  <a:pos x="csX0" y="csY0"/>
                </a:cxn>
                <a:cxn ang="0">
                  <a:pos x="csX1" y="csY1"/>
                </a:cxn>
                <a:cxn ang="0">
                  <a:pos x="csX2" y="csY2"/>
                </a:cxn>
                <a:cxn ang="0">
                  <a:pos x="csX3" y="csY3"/>
                </a:cxn>
                <a:cxn ang="0">
                  <a:pos x="csX4" y="csY4"/>
                </a:cxn>
              </a:cxnLst>
              <a:rect l="l" t="t" r="r" b="b"/>
              <a:pathLst>
                <a:path w="129816" h="129816">
                  <a:moveTo>
                    <a:pt x="126516" y="65348"/>
                  </a:moveTo>
                  <a:cubicBezTo>
                    <a:pt x="126516" y="101195"/>
                    <a:pt x="97455" y="130256"/>
                    <a:pt x="61607" y="130256"/>
                  </a:cubicBezTo>
                  <a:cubicBezTo>
                    <a:pt x="25760" y="130256"/>
                    <a:pt x="-3301" y="101195"/>
                    <a:pt x="-3301" y="65348"/>
                  </a:cubicBezTo>
                  <a:cubicBezTo>
                    <a:pt x="-3301" y="29500"/>
                    <a:pt x="25760" y="439"/>
                    <a:pt x="61607" y="439"/>
                  </a:cubicBezTo>
                  <a:cubicBezTo>
                    <a:pt x="97455" y="439"/>
                    <a:pt x="126516" y="29500"/>
                    <a:pt x="126516" y="65348"/>
                  </a:cubicBezTo>
                  <a:close/>
                </a:path>
              </a:pathLst>
            </a:custGeom>
            <a:solidFill>
              <a:srgbClr val="ADCEE3"/>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75" name="テキスト ボックス 474">
              <a:extLst>
                <a:ext uri="{FF2B5EF4-FFF2-40B4-BE49-F238E27FC236}">
                  <a16:creationId xmlns:a16="http://schemas.microsoft.com/office/drawing/2014/main" id="{8DD0D14D-5F5E-5FA6-F5AC-1E6287F4FFB6}"/>
                </a:ext>
              </a:extLst>
            </p:cNvPr>
            <p:cNvSpPr txBox="1"/>
            <p:nvPr/>
          </p:nvSpPr>
          <p:spPr>
            <a:xfrm>
              <a:off x="2847229" y="4496595"/>
              <a:ext cx="316112"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JAC1</a:t>
              </a:r>
            </a:p>
          </p:txBody>
        </p:sp>
        <p:sp>
          <p:nvSpPr>
            <p:cNvPr id="476" name="フリーフォーム: 図形 475">
              <a:extLst>
                <a:ext uri="{FF2B5EF4-FFF2-40B4-BE49-F238E27FC236}">
                  <a16:creationId xmlns:a16="http://schemas.microsoft.com/office/drawing/2014/main" id="{C1381190-C944-6FD2-0C25-BBC44EB7DBBD}"/>
                </a:ext>
              </a:extLst>
            </p:cNvPr>
            <p:cNvSpPr/>
            <p:nvPr/>
          </p:nvSpPr>
          <p:spPr>
            <a:xfrm>
              <a:off x="4191959" y="4541394"/>
              <a:ext cx="129816" cy="129816"/>
            </a:xfrm>
            <a:custGeom>
              <a:avLst/>
              <a:gdLst>
                <a:gd name="csX0" fmla="*/ 126227 w 129816"/>
                <a:gd name="csY0" fmla="*/ 65341 h 129816"/>
                <a:gd name="csX1" fmla="*/ 61319 w 129816"/>
                <a:gd name="csY1" fmla="*/ 130249 h 129816"/>
                <a:gd name="csX2" fmla="*/ -3589 w 129816"/>
                <a:gd name="csY2" fmla="*/ 65341 h 129816"/>
                <a:gd name="csX3" fmla="*/ 61319 w 129816"/>
                <a:gd name="csY3" fmla="*/ 433 h 129816"/>
                <a:gd name="csX4" fmla="*/ 126227 w 129816"/>
                <a:gd name="csY4" fmla="*/ 65341 h 129816"/>
              </a:gdLst>
              <a:ahLst/>
              <a:cxnLst>
                <a:cxn ang="0">
                  <a:pos x="csX0" y="csY0"/>
                </a:cxn>
                <a:cxn ang="0">
                  <a:pos x="csX1" y="csY1"/>
                </a:cxn>
                <a:cxn ang="0">
                  <a:pos x="csX2" y="csY2"/>
                </a:cxn>
                <a:cxn ang="0">
                  <a:pos x="csX3" y="csY3"/>
                </a:cxn>
                <a:cxn ang="0">
                  <a:pos x="csX4" y="csY4"/>
                </a:cxn>
              </a:cxnLst>
              <a:rect l="l" t="t" r="r" b="b"/>
              <a:pathLst>
                <a:path w="129816" h="129816">
                  <a:moveTo>
                    <a:pt x="126227" y="65341"/>
                  </a:moveTo>
                  <a:cubicBezTo>
                    <a:pt x="126227" y="101189"/>
                    <a:pt x="97167" y="130249"/>
                    <a:pt x="61319" y="130249"/>
                  </a:cubicBezTo>
                  <a:cubicBezTo>
                    <a:pt x="25471" y="130249"/>
                    <a:pt x="-3589" y="101189"/>
                    <a:pt x="-3589" y="65341"/>
                  </a:cubicBezTo>
                  <a:cubicBezTo>
                    <a:pt x="-3589" y="29493"/>
                    <a:pt x="25471" y="433"/>
                    <a:pt x="61319" y="433"/>
                  </a:cubicBezTo>
                  <a:cubicBezTo>
                    <a:pt x="97167" y="433"/>
                    <a:pt x="126227" y="29493"/>
                    <a:pt x="126227" y="65341"/>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77" name="フリーフォーム: 図形 476">
              <a:extLst>
                <a:ext uri="{FF2B5EF4-FFF2-40B4-BE49-F238E27FC236}">
                  <a16:creationId xmlns:a16="http://schemas.microsoft.com/office/drawing/2014/main" id="{C7BF2C7C-E2AC-CE66-6022-8E41D785AAAB}"/>
                </a:ext>
              </a:extLst>
            </p:cNvPr>
            <p:cNvSpPr/>
            <p:nvPr/>
          </p:nvSpPr>
          <p:spPr>
            <a:xfrm>
              <a:off x="4191959" y="4541394"/>
              <a:ext cx="129816" cy="129816"/>
            </a:xfrm>
            <a:custGeom>
              <a:avLst/>
              <a:gdLst>
                <a:gd name="csX0" fmla="*/ 126227 w 129816"/>
                <a:gd name="csY0" fmla="*/ 65341 h 129816"/>
                <a:gd name="csX1" fmla="*/ 61319 w 129816"/>
                <a:gd name="csY1" fmla="*/ 130249 h 129816"/>
                <a:gd name="csX2" fmla="*/ -3589 w 129816"/>
                <a:gd name="csY2" fmla="*/ 65341 h 129816"/>
                <a:gd name="csX3" fmla="*/ 61319 w 129816"/>
                <a:gd name="csY3" fmla="*/ 433 h 129816"/>
                <a:gd name="csX4" fmla="*/ 126227 w 129816"/>
                <a:gd name="csY4" fmla="*/ 65341 h 129816"/>
              </a:gdLst>
              <a:ahLst/>
              <a:cxnLst>
                <a:cxn ang="0">
                  <a:pos x="csX0" y="csY0"/>
                </a:cxn>
                <a:cxn ang="0">
                  <a:pos x="csX1" y="csY1"/>
                </a:cxn>
                <a:cxn ang="0">
                  <a:pos x="csX2" y="csY2"/>
                </a:cxn>
                <a:cxn ang="0">
                  <a:pos x="csX3" y="csY3"/>
                </a:cxn>
                <a:cxn ang="0">
                  <a:pos x="csX4" y="csY4"/>
                </a:cxn>
              </a:cxnLst>
              <a:rect l="l" t="t" r="r" b="b"/>
              <a:pathLst>
                <a:path w="129816" h="129816">
                  <a:moveTo>
                    <a:pt x="126227" y="65341"/>
                  </a:moveTo>
                  <a:cubicBezTo>
                    <a:pt x="126227" y="101189"/>
                    <a:pt x="97167" y="130249"/>
                    <a:pt x="61319" y="130249"/>
                  </a:cubicBezTo>
                  <a:cubicBezTo>
                    <a:pt x="25471" y="130249"/>
                    <a:pt x="-3589" y="101189"/>
                    <a:pt x="-3589" y="65341"/>
                  </a:cubicBezTo>
                  <a:cubicBezTo>
                    <a:pt x="-3589" y="29493"/>
                    <a:pt x="25471" y="433"/>
                    <a:pt x="61319" y="433"/>
                  </a:cubicBezTo>
                  <a:cubicBezTo>
                    <a:pt x="97167" y="433"/>
                    <a:pt x="126227" y="29493"/>
                    <a:pt x="126227" y="65341"/>
                  </a:cubicBezTo>
                  <a:close/>
                </a:path>
              </a:pathLst>
            </a:custGeom>
            <a:solidFill>
              <a:srgbClr val="D5E4EE"/>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78" name="テキスト ボックス 477">
              <a:extLst>
                <a:ext uri="{FF2B5EF4-FFF2-40B4-BE49-F238E27FC236}">
                  <a16:creationId xmlns:a16="http://schemas.microsoft.com/office/drawing/2014/main" id="{ED58BB76-6403-FEAA-0D55-C6969A4877C8}"/>
                </a:ext>
              </a:extLst>
            </p:cNvPr>
            <p:cNvSpPr txBox="1"/>
            <p:nvPr/>
          </p:nvSpPr>
          <p:spPr>
            <a:xfrm>
              <a:off x="4112677" y="4531169"/>
              <a:ext cx="282449"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TPL</a:t>
              </a:r>
            </a:p>
          </p:txBody>
        </p:sp>
        <p:sp>
          <p:nvSpPr>
            <p:cNvPr id="479" name="フリーフォーム: 図形 478">
              <a:extLst>
                <a:ext uri="{FF2B5EF4-FFF2-40B4-BE49-F238E27FC236}">
                  <a16:creationId xmlns:a16="http://schemas.microsoft.com/office/drawing/2014/main" id="{569D8B2D-538D-164F-D3B7-823F8EC8798D}"/>
                </a:ext>
              </a:extLst>
            </p:cNvPr>
            <p:cNvSpPr/>
            <p:nvPr/>
          </p:nvSpPr>
          <p:spPr>
            <a:xfrm>
              <a:off x="3361597" y="4701916"/>
              <a:ext cx="129816" cy="129816"/>
            </a:xfrm>
            <a:custGeom>
              <a:avLst/>
              <a:gdLst>
                <a:gd name="csX0" fmla="*/ 126419 w 129816"/>
                <a:gd name="csY0" fmla="*/ 65304 h 129816"/>
                <a:gd name="csX1" fmla="*/ 61511 w 129816"/>
                <a:gd name="csY1" fmla="*/ 130212 h 129816"/>
                <a:gd name="csX2" fmla="*/ -3398 w 129816"/>
                <a:gd name="csY2" fmla="*/ 65304 h 129816"/>
                <a:gd name="csX3" fmla="*/ 61511 w 129816"/>
                <a:gd name="csY3" fmla="*/ 395 h 129816"/>
                <a:gd name="csX4" fmla="*/ 126419 w 129816"/>
                <a:gd name="csY4" fmla="*/ 65304 h 129816"/>
              </a:gdLst>
              <a:ahLst/>
              <a:cxnLst>
                <a:cxn ang="0">
                  <a:pos x="csX0" y="csY0"/>
                </a:cxn>
                <a:cxn ang="0">
                  <a:pos x="csX1" y="csY1"/>
                </a:cxn>
                <a:cxn ang="0">
                  <a:pos x="csX2" y="csY2"/>
                </a:cxn>
                <a:cxn ang="0">
                  <a:pos x="csX3" y="csY3"/>
                </a:cxn>
                <a:cxn ang="0">
                  <a:pos x="csX4" y="csY4"/>
                </a:cxn>
              </a:cxnLst>
              <a:rect l="l" t="t" r="r" b="b"/>
              <a:pathLst>
                <a:path w="129816" h="129816">
                  <a:moveTo>
                    <a:pt x="126419" y="65304"/>
                  </a:moveTo>
                  <a:cubicBezTo>
                    <a:pt x="126419" y="101152"/>
                    <a:pt x="97358" y="130212"/>
                    <a:pt x="61511" y="130212"/>
                  </a:cubicBezTo>
                  <a:cubicBezTo>
                    <a:pt x="25663" y="130212"/>
                    <a:pt x="-3398" y="101152"/>
                    <a:pt x="-3398" y="65304"/>
                  </a:cubicBezTo>
                  <a:cubicBezTo>
                    <a:pt x="-3398" y="29456"/>
                    <a:pt x="25663" y="395"/>
                    <a:pt x="61511" y="395"/>
                  </a:cubicBezTo>
                  <a:cubicBezTo>
                    <a:pt x="97358" y="395"/>
                    <a:pt x="126419" y="29456"/>
                    <a:pt x="126419" y="65304"/>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80" name="フリーフォーム: 図形 479">
              <a:extLst>
                <a:ext uri="{FF2B5EF4-FFF2-40B4-BE49-F238E27FC236}">
                  <a16:creationId xmlns:a16="http://schemas.microsoft.com/office/drawing/2014/main" id="{4762BB9A-F391-3D69-7241-C22AFBD1FA93}"/>
                </a:ext>
              </a:extLst>
            </p:cNvPr>
            <p:cNvSpPr/>
            <p:nvPr/>
          </p:nvSpPr>
          <p:spPr>
            <a:xfrm>
              <a:off x="3361597" y="4701916"/>
              <a:ext cx="129816" cy="129816"/>
            </a:xfrm>
            <a:custGeom>
              <a:avLst/>
              <a:gdLst>
                <a:gd name="csX0" fmla="*/ 126419 w 129816"/>
                <a:gd name="csY0" fmla="*/ 65304 h 129816"/>
                <a:gd name="csX1" fmla="*/ 61511 w 129816"/>
                <a:gd name="csY1" fmla="*/ 130212 h 129816"/>
                <a:gd name="csX2" fmla="*/ -3398 w 129816"/>
                <a:gd name="csY2" fmla="*/ 65304 h 129816"/>
                <a:gd name="csX3" fmla="*/ 61511 w 129816"/>
                <a:gd name="csY3" fmla="*/ 395 h 129816"/>
                <a:gd name="csX4" fmla="*/ 126419 w 129816"/>
                <a:gd name="csY4" fmla="*/ 65304 h 129816"/>
              </a:gdLst>
              <a:ahLst/>
              <a:cxnLst>
                <a:cxn ang="0">
                  <a:pos x="csX0" y="csY0"/>
                </a:cxn>
                <a:cxn ang="0">
                  <a:pos x="csX1" y="csY1"/>
                </a:cxn>
                <a:cxn ang="0">
                  <a:pos x="csX2" y="csY2"/>
                </a:cxn>
                <a:cxn ang="0">
                  <a:pos x="csX3" y="csY3"/>
                </a:cxn>
                <a:cxn ang="0">
                  <a:pos x="csX4" y="csY4"/>
                </a:cxn>
              </a:cxnLst>
              <a:rect l="l" t="t" r="r" b="b"/>
              <a:pathLst>
                <a:path w="129816" h="129816">
                  <a:moveTo>
                    <a:pt x="126419" y="65304"/>
                  </a:moveTo>
                  <a:cubicBezTo>
                    <a:pt x="126419" y="101152"/>
                    <a:pt x="97358" y="130212"/>
                    <a:pt x="61511" y="130212"/>
                  </a:cubicBezTo>
                  <a:cubicBezTo>
                    <a:pt x="25663" y="130212"/>
                    <a:pt x="-3398" y="101152"/>
                    <a:pt x="-3398" y="65304"/>
                  </a:cubicBezTo>
                  <a:cubicBezTo>
                    <a:pt x="-3398" y="29456"/>
                    <a:pt x="25663" y="395"/>
                    <a:pt x="61511" y="395"/>
                  </a:cubicBezTo>
                  <a:cubicBezTo>
                    <a:pt x="97358" y="395"/>
                    <a:pt x="126419" y="29456"/>
                    <a:pt x="126419" y="65304"/>
                  </a:cubicBezTo>
                  <a:close/>
                </a:path>
              </a:pathLst>
            </a:custGeom>
            <a:solidFill>
              <a:srgbClr val="F8D8C9"/>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81" name="テキスト ボックス 480">
              <a:extLst>
                <a:ext uri="{FF2B5EF4-FFF2-40B4-BE49-F238E27FC236}">
                  <a16:creationId xmlns:a16="http://schemas.microsoft.com/office/drawing/2014/main" id="{5E3ACBF1-1EAE-E893-ECF6-F5AD24FD29CD}"/>
                </a:ext>
              </a:extLst>
            </p:cNvPr>
            <p:cNvSpPr txBox="1"/>
            <p:nvPr/>
          </p:nvSpPr>
          <p:spPr>
            <a:xfrm>
              <a:off x="3274832" y="4689780"/>
              <a:ext cx="30168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NIA2</a:t>
              </a:r>
            </a:p>
          </p:txBody>
        </p:sp>
        <p:sp>
          <p:nvSpPr>
            <p:cNvPr id="482" name="フリーフォーム: 図形 481">
              <a:extLst>
                <a:ext uri="{FF2B5EF4-FFF2-40B4-BE49-F238E27FC236}">
                  <a16:creationId xmlns:a16="http://schemas.microsoft.com/office/drawing/2014/main" id="{58E3A770-9E2B-414F-9CB4-5013A552D273}"/>
                </a:ext>
              </a:extLst>
            </p:cNvPr>
            <p:cNvSpPr/>
            <p:nvPr/>
          </p:nvSpPr>
          <p:spPr>
            <a:xfrm>
              <a:off x="4184154" y="4926950"/>
              <a:ext cx="144000" cy="144000"/>
            </a:xfrm>
            <a:custGeom>
              <a:avLst/>
              <a:gdLst>
                <a:gd name="csX0" fmla="*/ 126235 w 129816"/>
                <a:gd name="csY0" fmla="*/ 65249 h 129816"/>
                <a:gd name="csX1" fmla="*/ 61326 w 129816"/>
                <a:gd name="csY1" fmla="*/ 130158 h 129816"/>
                <a:gd name="csX2" fmla="*/ -3582 w 129816"/>
                <a:gd name="csY2" fmla="*/ 65249 h 129816"/>
                <a:gd name="csX3" fmla="*/ 61326 w 129816"/>
                <a:gd name="csY3" fmla="*/ 341 h 129816"/>
                <a:gd name="csX4" fmla="*/ 126235 w 129816"/>
                <a:gd name="csY4" fmla="*/ 65249 h 129816"/>
              </a:gdLst>
              <a:ahLst/>
              <a:cxnLst>
                <a:cxn ang="0">
                  <a:pos x="csX0" y="csY0"/>
                </a:cxn>
                <a:cxn ang="0">
                  <a:pos x="csX1" y="csY1"/>
                </a:cxn>
                <a:cxn ang="0">
                  <a:pos x="csX2" y="csY2"/>
                </a:cxn>
                <a:cxn ang="0">
                  <a:pos x="csX3" y="csY3"/>
                </a:cxn>
                <a:cxn ang="0">
                  <a:pos x="csX4" y="csY4"/>
                </a:cxn>
              </a:cxnLst>
              <a:rect l="l" t="t" r="r" b="b"/>
              <a:pathLst>
                <a:path w="129816" h="129816">
                  <a:moveTo>
                    <a:pt x="126235" y="65249"/>
                  </a:moveTo>
                  <a:cubicBezTo>
                    <a:pt x="126235" y="101097"/>
                    <a:pt x="97174" y="130158"/>
                    <a:pt x="61326" y="130158"/>
                  </a:cubicBezTo>
                  <a:cubicBezTo>
                    <a:pt x="25479" y="130158"/>
                    <a:pt x="-3582" y="101097"/>
                    <a:pt x="-3582" y="65249"/>
                  </a:cubicBezTo>
                  <a:cubicBezTo>
                    <a:pt x="-3582" y="29401"/>
                    <a:pt x="25479" y="341"/>
                    <a:pt x="61326" y="341"/>
                  </a:cubicBezTo>
                  <a:cubicBezTo>
                    <a:pt x="97174" y="341"/>
                    <a:pt x="126235" y="29401"/>
                    <a:pt x="126235" y="65249"/>
                  </a:cubicBezTo>
                  <a:close/>
                </a:path>
              </a:pathLst>
            </a:custGeom>
            <a:solidFill>
              <a:srgbClr val="F7E3D8"/>
            </a:solidFill>
            <a:ln w="6350" cap="sq">
              <a:solidFill>
                <a:schemeClr val="accent2"/>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83" name="テキスト ボックス 482">
              <a:extLst>
                <a:ext uri="{FF2B5EF4-FFF2-40B4-BE49-F238E27FC236}">
                  <a16:creationId xmlns:a16="http://schemas.microsoft.com/office/drawing/2014/main" id="{C774E554-A841-544D-08DC-A306F443C0DF}"/>
                </a:ext>
              </a:extLst>
            </p:cNvPr>
            <p:cNvSpPr txBox="1"/>
            <p:nvPr/>
          </p:nvSpPr>
          <p:spPr>
            <a:xfrm>
              <a:off x="4090956" y="4923199"/>
              <a:ext cx="32893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CKA</a:t>
              </a:r>
            </a:p>
          </p:txBody>
        </p:sp>
        <p:grpSp>
          <p:nvGrpSpPr>
            <p:cNvPr id="484" name="グループ化 483">
              <a:extLst>
                <a:ext uri="{FF2B5EF4-FFF2-40B4-BE49-F238E27FC236}">
                  <a16:creationId xmlns:a16="http://schemas.microsoft.com/office/drawing/2014/main" id="{94706DFF-2A5A-14EC-DBE6-0DA9E2519D99}"/>
                </a:ext>
              </a:extLst>
            </p:cNvPr>
            <p:cNvGrpSpPr/>
            <p:nvPr/>
          </p:nvGrpSpPr>
          <p:grpSpPr>
            <a:xfrm>
              <a:off x="3908890" y="5679014"/>
              <a:ext cx="317716" cy="153888"/>
              <a:chOff x="4489185" y="5941892"/>
              <a:chExt cx="317716" cy="153888"/>
            </a:xfrm>
          </p:grpSpPr>
          <p:sp>
            <p:nvSpPr>
              <p:cNvPr id="510" name="フリーフォーム: 図形 509">
                <a:extLst>
                  <a:ext uri="{FF2B5EF4-FFF2-40B4-BE49-F238E27FC236}">
                    <a16:creationId xmlns:a16="http://schemas.microsoft.com/office/drawing/2014/main" id="{B87F9BAB-EDEC-F404-3DAA-4CDD68B6F40F}"/>
                  </a:ext>
                </a:extLst>
              </p:cNvPr>
              <p:cNvSpPr/>
              <p:nvPr/>
            </p:nvSpPr>
            <p:spPr>
              <a:xfrm>
                <a:off x="4576043" y="5946836"/>
                <a:ext cx="144000" cy="144000"/>
              </a:xfrm>
              <a:custGeom>
                <a:avLst/>
                <a:gdLst>
                  <a:gd name="csX0" fmla="*/ 126269 w 129816"/>
                  <a:gd name="csY0" fmla="*/ 65073 h 129816"/>
                  <a:gd name="csX1" fmla="*/ 61361 w 129816"/>
                  <a:gd name="csY1" fmla="*/ 129981 h 129816"/>
                  <a:gd name="csX2" fmla="*/ -3548 w 129816"/>
                  <a:gd name="csY2" fmla="*/ 65073 h 129816"/>
                  <a:gd name="csX3" fmla="*/ 61361 w 129816"/>
                  <a:gd name="csY3" fmla="*/ 165 h 129816"/>
                  <a:gd name="csX4" fmla="*/ 126269 w 129816"/>
                  <a:gd name="csY4" fmla="*/ 65073 h 129816"/>
                </a:gdLst>
                <a:ahLst/>
                <a:cxnLst>
                  <a:cxn ang="0">
                    <a:pos x="csX0" y="csY0"/>
                  </a:cxn>
                  <a:cxn ang="0">
                    <a:pos x="csX1" y="csY1"/>
                  </a:cxn>
                  <a:cxn ang="0">
                    <a:pos x="csX2" y="csY2"/>
                  </a:cxn>
                  <a:cxn ang="0">
                    <a:pos x="csX3" y="csY3"/>
                  </a:cxn>
                  <a:cxn ang="0">
                    <a:pos x="csX4" y="csY4"/>
                  </a:cxn>
                </a:cxnLst>
                <a:rect l="l" t="t" r="r" b="b"/>
                <a:pathLst>
                  <a:path w="129816" h="129816">
                    <a:moveTo>
                      <a:pt x="126269" y="65073"/>
                    </a:moveTo>
                    <a:cubicBezTo>
                      <a:pt x="126269" y="100921"/>
                      <a:pt x="97208" y="129981"/>
                      <a:pt x="61361" y="129981"/>
                    </a:cubicBezTo>
                    <a:cubicBezTo>
                      <a:pt x="25513" y="129981"/>
                      <a:pt x="-3548" y="100921"/>
                      <a:pt x="-3548" y="65073"/>
                    </a:cubicBezTo>
                    <a:cubicBezTo>
                      <a:pt x="-3548" y="29225"/>
                      <a:pt x="25513" y="165"/>
                      <a:pt x="61361" y="165"/>
                    </a:cubicBezTo>
                    <a:cubicBezTo>
                      <a:pt x="97208" y="165"/>
                      <a:pt x="126269" y="29225"/>
                      <a:pt x="126269" y="65073"/>
                    </a:cubicBezTo>
                    <a:close/>
                  </a:path>
                </a:pathLst>
              </a:custGeom>
              <a:solidFill>
                <a:srgbClr val="F8DBCC"/>
              </a:solidFill>
              <a:ln w="6350" cap="sq">
                <a:solidFill>
                  <a:schemeClr val="accent2"/>
                </a:solidFill>
                <a:prstDash val="solid"/>
                <a:miter/>
              </a:ln>
            </p:spPr>
            <p:txBody>
              <a:bodyPr anchor="ctr"/>
              <a:lstStyle/>
              <a:p>
                <a:pPr algn="ctr"/>
                <a:endParaRPr lang="ja-JP" altLang="en-US" sz="400" b="1" dirty="0">
                  <a:ln w="0"/>
                  <a:latin typeface="Arial" panose="020B0604020202020204" pitchFamily="34" charset="0"/>
                  <a:cs typeface="Arial" panose="020B0604020202020204" pitchFamily="34" charset="0"/>
                </a:endParaRPr>
              </a:p>
            </p:txBody>
          </p:sp>
          <p:sp>
            <p:nvSpPr>
              <p:cNvPr id="511" name="テキスト ボックス 510">
                <a:extLst>
                  <a:ext uri="{FF2B5EF4-FFF2-40B4-BE49-F238E27FC236}">
                    <a16:creationId xmlns:a16="http://schemas.microsoft.com/office/drawing/2014/main" id="{D5185613-5585-201A-4ACB-BC11C1BF01A6}"/>
                  </a:ext>
                </a:extLst>
              </p:cNvPr>
              <p:cNvSpPr txBox="1"/>
              <p:nvPr/>
            </p:nvSpPr>
            <p:spPr>
              <a:xfrm>
                <a:off x="4489185" y="5941892"/>
                <a:ext cx="317716"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NS1</a:t>
                </a:r>
              </a:p>
            </p:txBody>
          </p:sp>
        </p:grpSp>
        <p:sp>
          <p:nvSpPr>
            <p:cNvPr id="485" name="フリーフォーム: 図形 484">
              <a:extLst>
                <a:ext uri="{FF2B5EF4-FFF2-40B4-BE49-F238E27FC236}">
                  <a16:creationId xmlns:a16="http://schemas.microsoft.com/office/drawing/2014/main" id="{4557C63F-5B61-AB83-579F-0E0D4A004083}"/>
                </a:ext>
              </a:extLst>
            </p:cNvPr>
            <p:cNvSpPr/>
            <p:nvPr/>
          </p:nvSpPr>
          <p:spPr>
            <a:xfrm>
              <a:off x="3750930" y="5402718"/>
              <a:ext cx="141618" cy="141617"/>
            </a:xfrm>
            <a:custGeom>
              <a:avLst/>
              <a:gdLst>
                <a:gd name="csX0" fmla="*/ 67320 w 141618"/>
                <a:gd name="csY0" fmla="*/ 232 h 141617"/>
                <a:gd name="csX1" fmla="*/ 138129 w 141618"/>
                <a:gd name="csY1" fmla="*/ 71041 h 141617"/>
                <a:gd name="csX2" fmla="*/ 67320 w 141618"/>
                <a:gd name="csY2" fmla="*/ 141850 h 141617"/>
                <a:gd name="csX3" fmla="*/ -3489 w 141618"/>
                <a:gd name="csY3" fmla="*/ 71041 h 141617"/>
              </a:gdLst>
              <a:ahLst/>
              <a:cxnLst>
                <a:cxn ang="0">
                  <a:pos x="csX0" y="csY0"/>
                </a:cxn>
                <a:cxn ang="0">
                  <a:pos x="csX1" y="csY1"/>
                </a:cxn>
                <a:cxn ang="0">
                  <a:pos x="csX2" y="csY2"/>
                </a:cxn>
                <a:cxn ang="0">
                  <a:pos x="csX3" y="csY3"/>
                </a:cxn>
              </a:cxnLst>
              <a:rect l="l" t="t" r="r" b="b"/>
              <a:pathLst>
                <a:path w="141618" h="141617">
                  <a:moveTo>
                    <a:pt x="67320" y="232"/>
                  </a:moveTo>
                  <a:lnTo>
                    <a:pt x="138129" y="71041"/>
                  </a:lnTo>
                  <a:lnTo>
                    <a:pt x="67320" y="141850"/>
                  </a:lnTo>
                  <a:lnTo>
                    <a:pt x="-3489" y="71041"/>
                  </a:ln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86" name="フリーフォーム: 図形 485">
              <a:extLst>
                <a:ext uri="{FF2B5EF4-FFF2-40B4-BE49-F238E27FC236}">
                  <a16:creationId xmlns:a16="http://schemas.microsoft.com/office/drawing/2014/main" id="{F3F1DF62-D586-C8DE-F99F-2F0DB4F78709}"/>
                </a:ext>
              </a:extLst>
            </p:cNvPr>
            <p:cNvSpPr/>
            <p:nvPr/>
          </p:nvSpPr>
          <p:spPr>
            <a:xfrm>
              <a:off x="3750930" y="5402718"/>
              <a:ext cx="141618" cy="141617"/>
            </a:xfrm>
            <a:custGeom>
              <a:avLst/>
              <a:gdLst>
                <a:gd name="csX0" fmla="*/ 67320 w 141618"/>
                <a:gd name="csY0" fmla="*/ 232 h 141617"/>
                <a:gd name="csX1" fmla="*/ 138129 w 141618"/>
                <a:gd name="csY1" fmla="*/ 71041 h 141617"/>
                <a:gd name="csX2" fmla="*/ 67320 w 141618"/>
                <a:gd name="csY2" fmla="*/ 141850 h 141617"/>
                <a:gd name="csX3" fmla="*/ -3489 w 141618"/>
                <a:gd name="csY3" fmla="*/ 71041 h 141617"/>
              </a:gdLst>
              <a:ahLst/>
              <a:cxnLst>
                <a:cxn ang="0">
                  <a:pos x="csX0" y="csY0"/>
                </a:cxn>
                <a:cxn ang="0">
                  <a:pos x="csX1" y="csY1"/>
                </a:cxn>
                <a:cxn ang="0">
                  <a:pos x="csX2" y="csY2"/>
                </a:cxn>
                <a:cxn ang="0">
                  <a:pos x="csX3" y="csY3"/>
                </a:cxn>
              </a:cxnLst>
              <a:rect l="l" t="t" r="r" b="b"/>
              <a:pathLst>
                <a:path w="141618" h="141617">
                  <a:moveTo>
                    <a:pt x="67320" y="232"/>
                  </a:moveTo>
                  <a:lnTo>
                    <a:pt x="138129" y="71041"/>
                  </a:lnTo>
                  <a:lnTo>
                    <a:pt x="67320" y="141850"/>
                  </a:lnTo>
                  <a:lnTo>
                    <a:pt x="-3489" y="71041"/>
                  </a:lnTo>
                  <a:close/>
                </a:path>
              </a:pathLst>
            </a:custGeom>
            <a:solidFill>
              <a:srgbClr val="F8DFD3"/>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87" name="テキスト ボックス 486">
              <a:extLst>
                <a:ext uri="{FF2B5EF4-FFF2-40B4-BE49-F238E27FC236}">
                  <a16:creationId xmlns:a16="http://schemas.microsoft.com/office/drawing/2014/main" id="{9044EC72-4332-3712-0B98-D4E072EA6DD8}"/>
                </a:ext>
              </a:extLst>
            </p:cNvPr>
            <p:cNvSpPr txBox="1"/>
            <p:nvPr/>
          </p:nvSpPr>
          <p:spPr>
            <a:xfrm>
              <a:off x="3644117" y="5397980"/>
              <a:ext cx="33534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RK2I</a:t>
              </a:r>
            </a:p>
          </p:txBody>
        </p:sp>
        <p:sp>
          <p:nvSpPr>
            <p:cNvPr id="488" name="フリーフォーム: 図形 487">
              <a:extLst>
                <a:ext uri="{FF2B5EF4-FFF2-40B4-BE49-F238E27FC236}">
                  <a16:creationId xmlns:a16="http://schemas.microsoft.com/office/drawing/2014/main" id="{CE689D7C-D13D-583F-E30C-C5BEBA70A0D1}"/>
                </a:ext>
              </a:extLst>
            </p:cNvPr>
            <p:cNvSpPr/>
            <p:nvPr/>
          </p:nvSpPr>
          <p:spPr>
            <a:xfrm>
              <a:off x="2631356" y="4585186"/>
              <a:ext cx="129816" cy="129816"/>
            </a:xfrm>
            <a:custGeom>
              <a:avLst/>
              <a:gdLst>
                <a:gd name="csX0" fmla="*/ 126588 w 129816"/>
                <a:gd name="csY0" fmla="*/ 65331 h 129816"/>
                <a:gd name="csX1" fmla="*/ 61679 w 129816"/>
                <a:gd name="csY1" fmla="*/ 130239 h 129816"/>
                <a:gd name="csX2" fmla="*/ -3229 w 129816"/>
                <a:gd name="csY2" fmla="*/ 65331 h 129816"/>
                <a:gd name="csX3" fmla="*/ 61679 w 129816"/>
                <a:gd name="csY3" fmla="*/ 422 h 129816"/>
                <a:gd name="csX4" fmla="*/ 126588 w 129816"/>
                <a:gd name="csY4" fmla="*/ 65331 h 129816"/>
              </a:gdLst>
              <a:ahLst/>
              <a:cxnLst>
                <a:cxn ang="0">
                  <a:pos x="csX0" y="csY0"/>
                </a:cxn>
                <a:cxn ang="0">
                  <a:pos x="csX1" y="csY1"/>
                </a:cxn>
                <a:cxn ang="0">
                  <a:pos x="csX2" y="csY2"/>
                </a:cxn>
                <a:cxn ang="0">
                  <a:pos x="csX3" y="csY3"/>
                </a:cxn>
                <a:cxn ang="0">
                  <a:pos x="csX4" y="csY4"/>
                </a:cxn>
              </a:cxnLst>
              <a:rect l="l" t="t" r="r" b="b"/>
              <a:pathLst>
                <a:path w="129816" h="129816">
                  <a:moveTo>
                    <a:pt x="126588" y="65331"/>
                  </a:moveTo>
                  <a:cubicBezTo>
                    <a:pt x="126588" y="101179"/>
                    <a:pt x="97527" y="130239"/>
                    <a:pt x="61679" y="130239"/>
                  </a:cubicBezTo>
                  <a:cubicBezTo>
                    <a:pt x="25832" y="130239"/>
                    <a:pt x="-3229" y="101179"/>
                    <a:pt x="-3229" y="65331"/>
                  </a:cubicBezTo>
                  <a:cubicBezTo>
                    <a:pt x="-3229" y="29483"/>
                    <a:pt x="25832" y="422"/>
                    <a:pt x="61679" y="422"/>
                  </a:cubicBezTo>
                  <a:cubicBezTo>
                    <a:pt x="97527" y="422"/>
                    <a:pt x="126588" y="29483"/>
                    <a:pt x="126588" y="65331"/>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89" name="フリーフォーム: 図形 488">
              <a:extLst>
                <a:ext uri="{FF2B5EF4-FFF2-40B4-BE49-F238E27FC236}">
                  <a16:creationId xmlns:a16="http://schemas.microsoft.com/office/drawing/2014/main" id="{4983EDFE-871A-150D-627A-E98302E62B4C}"/>
                </a:ext>
              </a:extLst>
            </p:cNvPr>
            <p:cNvSpPr/>
            <p:nvPr/>
          </p:nvSpPr>
          <p:spPr>
            <a:xfrm>
              <a:off x="2631356" y="4585186"/>
              <a:ext cx="129816" cy="129816"/>
            </a:xfrm>
            <a:custGeom>
              <a:avLst/>
              <a:gdLst>
                <a:gd name="csX0" fmla="*/ 126588 w 129816"/>
                <a:gd name="csY0" fmla="*/ 65331 h 129816"/>
                <a:gd name="csX1" fmla="*/ 61679 w 129816"/>
                <a:gd name="csY1" fmla="*/ 130239 h 129816"/>
                <a:gd name="csX2" fmla="*/ -3229 w 129816"/>
                <a:gd name="csY2" fmla="*/ 65331 h 129816"/>
                <a:gd name="csX3" fmla="*/ 61679 w 129816"/>
                <a:gd name="csY3" fmla="*/ 422 h 129816"/>
                <a:gd name="csX4" fmla="*/ 126588 w 129816"/>
                <a:gd name="csY4" fmla="*/ 65331 h 129816"/>
              </a:gdLst>
              <a:ahLst/>
              <a:cxnLst>
                <a:cxn ang="0">
                  <a:pos x="csX0" y="csY0"/>
                </a:cxn>
                <a:cxn ang="0">
                  <a:pos x="csX1" y="csY1"/>
                </a:cxn>
                <a:cxn ang="0">
                  <a:pos x="csX2" y="csY2"/>
                </a:cxn>
                <a:cxn ang="0">
                  <a:pos x="csX3" y="csY3"/>
                </a:cxn>
                <a:cxn ang="0">
                  <a:pos x="csX4" y="csY4"/>
                </a:cxn>
              </a:cxnLst>
              <a:rect l="l" t="t" r="r" b="b"/>
              <a:pathLst>
                <a:path w="129816" h="129816">
                  <a:moveTo>
                    <a:pt x="126588" y="65331"/>
                  </a:moveTo>
                  <a:cubicBezTo>
                    <a:pt x="126588" y="101179"/>
                    <a:pt x="97527" y="130239"/>
                    <a:pt x="61679" y="130239"/>
                  </a:cubicBezTo>
                  <a:cubicBezTo>
                    <a:pt x="25832" y="130239"/>
                    <a:pt x="-3229" y="101179"/>
                    <a:pt x="-3229" y="65331"/>
                  </a:cubicBezTo>
                  <a:cubicBezTo>
                    <a:pt x="-3229" y="29483"/>
                    <a:pt x="25832" y="422"/>
                    <a:pt x="61679" y="422"/>
                  </a:cubicBezTo>
                  <a:cubicBezTo>
                    <a:pt x="97527" y="422"/>
                    <a:pt x="126588" y="29483"/>
                    <a:pt x="126588" y="65331"/>
                  </a:cubicBezTo>
                  <a:close/>
                </a:path>
              </a:pathLst>
            </a:custGeom>
            <a:solidFill>
              <a:srgbClr val="FA7837"/>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90" name="テキスト ボックス 489">
              <a:extLst>
                <a:ext uri="{FF2B5EF4-FFF2-40B4-BE49-F238E27FC236}">
                  <a16:creationId xmlns:a16="http://schemas.microsoft.com/office/drawing/2014/main" id="{BDF3B53F-3396-624B-63A9-FC49D3F65618}"/>
                </a:ext>
              </a:extLst>
            </p:cNvPr>
            <p:cNvSpPr txBox="1"/>
            <p:nvPr/>
          </p:nvSpPr>
          <p:spPr>
            <a:xfrm>
              <a:off x="2536470" y="4581392"/>
              <a:ext cx="316112"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RPT2</a:t>
              </a:r>
            </a:p>
          </p:txBody>
        </p:sp>
        <p:sp>
          <p:nvSpPr>
            <p:cNvPr id="491" name="フリーフォーム: 図形 490">
              <a:extLst>
                <a:ext uri="{FF2B5EF4-FFF2-40B4-BE49-F238E27FC236}">
                  <a16:creationId xmlns:a16="http://schemas.microsoft.com/office/drawing/2014/main" id="{9899E51C-8AC9-E0A6-6FEB-0FAE304ED0EE}"/>
                </a:ext>
              </a:extLst>
            </p:cNvPr>
            <p:cNvSpPr/>
            <p:nvPr/>
          </p:nvSpPr>
          <p:spPr>
            <a:xfrm>
              <a:off x="2890129" y="5792598"/>
              <a:ext cx="129816" cy="129816"/>
            </a:xfrm>
            <a:custGeom>
              <a:avLst/>
              <a:gdLst>
                <a:gd name="csX0" fmla="*/ 126528 w 129816"/>
                <a:gd name="csY0" fmla="*/ 65052 h 129816"/>
                <a:gd name="csX1" fmla="*/ 61620 w 129816"/>
                <a:gd name="csY1" fmla="*/ 129960 h 129816"/>
                <a:gd name="csX2" fmla="*/ -3289 w 129816"/>
                <a:gd name="csY2" fmla="*/ 65052 h 129816"/>
                <a:gd name="csX3" fmla="*/ 61620 w 129816"/>
                <a:gd name="csY3" fmla="*/ 144 h 129816"/>
                <a:gd name="csX4" fmla="*/ 126528 w 129816"/>
                <a:gd name="csY4" fmla="*/ 65052 h 129816"/>
              </a:gdLst>
              <a:ahLst/>
              <a:cxnLst>
                <a:cxn ang="0">
                  <a:pos x="csX0" y="csY0"/>
                </a:cxn>
                <a:cxn ang="0">
                  <a:pos x="csX1" y="csY1"/>
                </a:cxn>
                <a:cxn ang="0">
                  <a:pos x="csX2" y="csY2"/>
                </a:cxn>
                <a:cxn ang="0">
                  <a:pos x="csX3" y="csY3"/>
                </a:cxn>
                <a:cxn ang="0">
                  <a:pos x="csX4" y="csY4"/>
                </a:cxn>
              </a:cxnLst>
              <a:rect l="l" t="t" r="r" b="b"/>
              <a:pathLst>
                <a:path w="129816" h="129816">
                  <a:moveTo>
                    <a:pt x="126528" y="65052"/>
                  </a:moveTo>
                  <a:cubicBezTo>
                    <a:pt x="126528" y="100900"/>
                    <a:pt x="97467" y="129960"/>
                    <a:pt x="61620" y="129960"/>
                  </a:cubicBezTo>
                  <a:cubicBezTo>
                    <a:pt x="25772" y="129960"/>
                    <a:pt x="-3289" y="100900"/>
                    <a:pt x="-3289" y="65052"/>
                  </a:cubicBezTo>
                  <a:cubicBezTo>
                    <a:pt x="-3289" y="29204"/>
                    <a:pt x="25772" y="144"/>
                    <a:pt x="61620" y="144"/>
                  </a:cubicBezTo>
                  <a:cubicBezTo>
                    <a:pt x="97467" y="144"/>
                    <a:pt x="126528" y="29204"/>
                    <a:pt x="126528" y="65052"/>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92" name="フリーフォーム: 図形 491">
              <a:extLst>
                <a:ext uri="{FF2B5EF4-FFF2-40B4-BE49-F238E27FC236}">
                  <a16:creationId xmlns:a16="http://schemas.microsoft.com/office/drawing/2014/main" id="{94DDCB34-AEFD-1F93-2741-F250B95913B0}"/>
                </a:ext>
              </a:extLst>
            </p:cNvPr>
            <p:cNvSpPr/>
            <p:nvPr/>
          </p:nvSpPr>
          <p:spPr>
            <a:xfrm>
              <a:off x="2890129" y="5792598"/>
              <a:ext cx="129816" cy="129816"/>
            </a:xfrm>
            <a:custGeom>
              <a:avLst/>
              <a:gdLst>
                <a:gd name="csX0" fmla="*/ 126528 w 129816"/>
                <a:gd name="csY0" fmla="*/ 65052 h 129816"/>
                <a:gd name="csX1" fmla="*/ 61620 w 129816"/>
                <a:gd name="csY1" fmla="*/ 129960 h 129816"/>
                <a:gd name="csX2" fmla="*/ -3289 w 129816"/>
                <a:gd name="csY2" fmla="*/ 65052 h 129816"/>
                <a:gd name="csX3" fmla="*/ 61620 w 129816"/>
                <a:gd name="csY3" fmla="*/ 144 h 129816"/>
                <a:gd name="csX4" fmla="*/ 126528 w 129816"/>
                <a:gd name="csY4" fmla="*/ 65052 h 129816"/>
              </a:gdLst>
              <a:ahLst/>
              <a:cxnLst>
                <a:cxn ang="0">
                  <a:pos x="csX0" y="csY0"/>
                </a:cxn>
                <a:cxn ang="0">
                  <a:pos x="csX1" y="csY1"/>
                </a:cxn>
                <a:cxn ang="0">
                  <a:pos x="csX2" y="csY2"/>
                </a:cxn>
                <a:cxn ang="0">
                  <a:pos x="csX3" y="csY3"/>
                </a:cxn>
                <a:cxn ang="0">
                  <a:pos x="csX4" y="csY4"/>
                </a:cxn>
              </a:cxnLst>
              <a:rect l="l" t="t" r="r" b="b"/>
              <a:pathLst>
                <a:path w="129816" h="129816">
                  <a:moveTo>
                    <a:pt x="126528" y="65052"/>
                  </a:moveTo>
                  <a:cubicBezTo>
                    <a:pt x="126528" y="100900"/>
                    <a:pt x="97467" y="129960"/>
                    <a:pt x="61620" y="129960"/>
                  </a:cubicBezTo>
                  <a:cubicBezTo>
                    <a:pt x="25772" y="129960"/>
                    <a:pt x="-3289" y="100900"/>
                    <a:pt x="-3289" y="65052"/>
                  </a:cubicBezTo>
                  <a:cubicBezTo>
                    <a:pt x="-3289" y="29204"/>
                    <a:pt x="25772" y="144"/>
                    <a:pt x="61620" y="144"/>
                  </a:cubicBezTo>
                  <a:cubicBezTo>
                    <a:pt x="97467" y="144"/>
                    <a:pt x="126528" y="29204"/>
                    <a:pt x="126528" y="65052"/>
                  </a:cubicBezTo>
                  <a:close/>
                </a:path>
              </a:pathLst>
            </a:custGeom>
            <a:solidFill>
              <a:srgbClr val="FA7837"/>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93" name="テキスト ボックス 492">
              <a:extLst>
                <a:ext uri="{FF2B5EF4-FFF2-40B4-BE49-F238E27FC236}">
                  <a16:creationId xmlns:a16="http://schemas.microsoft.com/office/drawing/2014/main" id="{90C9BC32-07C4-92AB-199C-7F389F73FE33}"/>
                </a:ext>
              </a:extLst>
            </p:cNvPr>
            <p:cNvSpPr txBox="1"/>
            <p:nvPr/>
          </p:nvSpPr>
          <p:spPr>
            <a:xfrm>
              <a:off x="2759087" y="5789898"/>
              <a:ext cx="37382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ATHB-6</a:t>
              </a:r>
            </a:p>
          </p:txBody>
        </p:sp>
        <p:sp>
          <p:nvSpPr>
            <p:cNvPr id="494" name="フリーフォーム: 図形 493">
              <a:extLst>
                <a:ext uri="{FF2B5EF4-FFF2-40B4-BE49-F238E27FC236}">
                  <a16:creationId xmlns:a16="http://schemas.microsoft.com/office/drawing/2014/main" id="{C9C8B57D-CF00-3173-F632-9A456AC00733}"/>
                </a:ext>
              </a:extLst>
            </p:cNvPr>
            <p:cNvSpPr/>
            <p:nvPr/>
          </p:nvSpPr>
          <p:spPr>
            <a:xfrm>
              <a:off x="3718311" y="5075902"/>
              <a:ext cx="129816" cy="129816"/>
            </a:xfrm>
            <a:custGeom>
              <a:avLst/>
              <a:gdLst>
                <a:gd name="csX0" fmla="*/ 126337 w 129816"/>
                <a:gd name="csY0" fmla="*/ 65217 h 129816"/>
                <a:gd name="csX1" fmla="*/ 61428 w 129816"/>
                <a:gd name="csY1" fmla="*/ 130126 h 129816"/>
                <a:gd name="csX2" fmla="*/ -3480 w 129816"/>
                <a:gd name="csY2" fmla="*/ 65217 h 129816"/>
                <a:gd name="csX3" fmla="*/ 61428 w 129816"/>
                <a:gd name="csY3" fmla="*/ 309 h 129816"/>
                <a:gd name="csX4" fmla="*/ 126337 w 129816"/>
                <a:gd name="csY4" fmla="*/ 65217 h 129816"/>
              </a:gdLst>
              <a:ahLst/>
              <a:cxnLst>
                <a:cxn ang="0">
                  <a:pos x="csX0" y="csY0"/>
                </a:cxn>
                <a:cxn ang="0">
                  <a:pos x="csX1" y="csY1"/>
                </a:cxn>
                <a:cxn ang="0">
                  <a:pos x="csX2" y="csY2"/>
                </a:cxn>
                <a:cxn ang="0">
                  <a:pos x="csX3" y="csY3"/>
                </a:cxn>
                <a:cxn ang="0">
                  <a:pos x="csX4" y="csY4"/>
                </a:cxn>
              </a:cxnLst>
              <a:rect l="l" t="t" r="r" b="b"/>
              <a:pathLst>
                <a:path w="129816" h="129816">
                  <a:moveTo>
                    <a:pt x="126337" y="65217"/>
                  </a:moveTo>
                  <a:cubicBezTo>
                    <a:pt x="126337" y="101065"/>
                    <a:pt x="97276" y="130126"/>
                    <a:pt x="61428" y="130126"/>
                  </a:cubicBezTo>
                  <a:cubicBezTo>
                    <a:pt x="25581" y="130126"/>
                    <a:pt x="-3480" y="101065"/>
                    <a:pt x="-3480" y="65217"/>
                  </a:cubicBezTo>
                  <a:cubicBezTo>
                    <a:pt x="-3480" y="29370"/>
                    <a:pt x="25581" y="309"/>
                    <a:pt x="61428" y="309"/>
                  </a:cubicBezTo>
                  <a:cubicBezTo>
                    <a:pt x="97276" y="309"/>
                    <a:pt x="126337" y="29370"/>
                    <a:pt x="126337" y="65217"/>
                  </a:cubicBez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95" name="フリーフォーム: 図形 494">
              <a:extLst>
                <a:ext uri="{FF2B5EF4-FFF2-40B4-BE49-F238E27FC236}">
                  <a16:creationId xmlns:a16="http://schemas.microsoft.com/office/drawing/2014/main" id="{D3B23791-FCCF-30D0-1E6A-95F4EFC25889}"/>
                </a:ext>
              </a:extLst>
            </p:cNvPr>
            <p:cNvSpPr/>
            <p:nvPr/>
          </p:nvSpPr>
          <p:spPr>
            <a:xfrm>
              <a:off x="3718311" y="5075902"/>
              <a:ext cx="129816" cy="129816"/>
            </a:xfrm>
            <a:custGeom>
              <a:avLst/>
              <a:gdLst>
                <a:gd name="csX0" fmla="*/ 126337 w 129816"/>
                <a:gd name="csY0" fmla="*/ 65217 h 129816"/>
                <a:gd name="csX1" fmla="*/ 61428 w 129816"/>
                <a:gd name="csY1" fmla="*/ 130126 h 129816"/>
                <a:gd name="csX2" fmla="*/ -3480 w 129816"/>
                <a:gd name="csY2" fmla="*/ 65217 h 129816"/>
                <a:gd name="csX3" fmla="*/ 61428 w 129816"/>
                <a:gd name="csY3" fmla="*/ 309 h 129816"/>
                <a:gd name="csX4" fmla="*/ 126337 w 129816"/>
                <a:gd name="csY4" fmla="*/ 65217 h 129816"/>
              </a:gdLst>
              <a:ahLst/>
              <a:cxnLst>
                <a:cxn ang="0">
                  <a:pos x="csX0" y="csY0"/>
                </a:cxn>
                <a:cxn ang="0">
                  <a:pos x="csX1" y="csY1"/>
                </a:cxn>
                <a:cxn ang="0">
                  <a:pos x="csX2" y="csY2"/>
                </a:cxn>
                <a:cxn ang="0">
                  <a:pos x="csX3" y="csY3"/>
                </a:cxn>
                <a:cxn ang="0">
                  <a:pos x="csX4" y="csY4"/>
                </a:cxn>
              </a:cxnLst>
              <a:rect l="l" t="t" r="r" b="b"/>
              <a:pathLst>
                <a:path w="129816" h="129816">
                  <a:moveTo>
                    <a:pt x="126337" y="65217"/>
                  </a:moveTo>
                  <a:cubicBezTo>
                    <a:pt x="126337" y="101065"/>
                    <a:pt x="97276" y="130126"/>
                    <a:pt x="61428" y="130126"/>
                  </a:cubicBezTo>
                  <a:cubicBezTo>
                    <a:pt x="25581" y="130126"/>
                    <a:pt x="-3480" y="101065"/>
                    <a:pt x="-3480" y="65217"/>
                  </a:cubicBezTo>
                  <a:cubicBezTo>
                    <a:pt x="-3480" y="29370"/>
                    <a:pt x="25581" y="309"/>
                    <a:pt x="61428" y="309"/>
                  </a:cubicBezTo>
                  <a:cubicBezTo>
                    <a:pt x="97276" y="309"/>
                    <a:pt x="126337" y="29370"/>
                    <a:pt x="126337" y="65217"/>
                  </a:cubicBezTo>
                  <a:close/>
                </a:path>
              </a:pathLst>
            </a:custGeom>
            <a:solidFill>
              <a:srgbClr val="F8DDD0"/>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96" name="テキスト ボックス 495">
              <a:extLst>
                <a:ext uri="{FF2B5EF4-FFF2-40B4-BE49-F238E27FC236}">
                  <a16:creationId xmlns:a16="http://schemas.microsoft.com/office/drawing/2014/main" id="{B1891E91-7949-58F0-80E2-29636F3D2323}"/>
                </a:ext>
              </a:extLst>
            </p:cNvPr>
            <p:cNvSpPr txBox="1"/>
            <p:nvPr/>
          </p:nvSpPr>
          <p:spPr>
            <a:xfrm>
              <a:off x="3636173" y="5064137"/>
              <a:ext cx="288861"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VCS</a:t>
              </a:r>
            </a:p>
          </p:txBody>
        </p:sp>
        <p:sp>
          <p:nvSpPr>
            <p:cNvPr id="497" name="フリーフォーム: 図形 496">
              <a:extLst>
                <a:ext uri="{FF2B5EF4-FFF2-40B4-BE49-F238E27FC236}">
                  <a16:creationId xmlns:a16="http://schemas.microsoft.com/office/drawing/2014/main" id="{44A3A945-CC52-A2E5-D3A6-7D2481AE0281}"/>
                </a:ext>
              </a:extLst>
            </p:cNvPr>
            <p:cNvSpPr/>
            <p:nvPr/>
          </p:nvSpPr>
          <p:spPr>
            <a:xfrm>
              <a:off x="3766766" y="4206094"/>
              <a:ext cx="141618" cy="141617"/>
            </a:xfrm>
            <a:custGeom>
              <a:avLst/>
              <a:gdLst>
                <a:gd name="csX0" fmla="*/ 67317 w 141618"/>
                <a:gd name="csY0" fmla="*/ 509 h 141617"/>
                <a:gd name="csX1" fmla="*/ 138126 w 141618"/>
                <a:gd name="csY1" fmla="*/ 71318 h 141617"/>
                <a:gd name="csX2" fmla="*/ 67317 w 141618"/>
                <a:gd name="csY2" fmla="*/ 142127 h 141617"/>
                <a:gd name="csX3" fmla="*/ -3492 w 141618"/>
                <a:gd name="csY3" fmla="*/ 71318 h 141617"/>
              </a:gdLst>
              <a:ahLst/>
              <a:cxnLst>
                <a:cxn ang="0">
                  <a:pos x="csX0" y="csY0"/>
                </a:cxn>
                <a:cxn ang="0">
                  <a:pos x="csX1" y="csY1"/>
                </a:cxn>
                <a:cxn ang="0">
                  <a:pos x="csX2" y="csY2"/>
                </a:cxn>
                <a:cxn ang="0">
                  <a:pos x="csX3" y="csY3"/>
                </a:cxn>
              </a:cxnLst>
              <a:rect l="l" t="t" r="r" b="b"/>
              <a:pathLst>
                <a:path w="141618" h="141617">
                  <a:moveTo>
                    <a:pt x="67317" y="509"/>
                  </a:moveTo>
                  <a:lnTo>
                    <a:pt x="138126" y="71318"/>
                  </a:lnTo>
                  <a:lnTo>
                    <a:pt x="67317" y="142127"/>
                  </a:lnTo>
                  <a:lnTo>
                    <a:pt x="-3492" y="71318"/>
                  </a:ln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98" name="フリーフォーム: 図形 497">
              <a:extLst>
                <a:ext uri="{FF2B5EF4-FFF2-40B4-BE49-F238E27FC236}">
                  <a16:creationId xmlns:a16="http://schemas.microsoft.com/office/drawing/2014/main" id="{01304F2F-066F-895B-42E7-A00FF60E028E}"/>
                </a:ext>
              </a:extLst>
            </p:cNvPr>
            <p:cNvSpPr/>
            <p:nvPr/>
          </p:nvSpPr>
          <p:spPr>
            <a:xfrm>
              <a:off x="3766766" y="4206094"/>
              <a:ext cx="141618" cy="141617"/>
            </a:xfrm>
            <a:custGeom>
              <a:avLst/>
              <a:gdLst>
                <a:gd name="csX0" fmla="*/ 67317 w 141618"/>
                <a:gd name="csY0" fmla="*/ 509 h 141617"/>
                <a:gd name="csX1" fmla="*/ 138126 w 141618"/>
                <a:gd name="csY1" fmla="*/ 71318 h 141617"/>
                <a:gd name="csX2" fmla="*/ 67317 w 141618"/>
                <a:gd name="csY2" fmla="*/ 142127 h 141617"/>
                <a:gd name="csX3" fmla="*/ -3492 w 141618"/>
                <a:gd name="csY3" fmla="*/ 71318 h 141617"/>
              </a:gdLst>
              <a:ahLst/>
              <a:cxnLst>
                <a:cxn ang="0">
                  <a:pos x="csX0" y="csY0"/>
                </a:cxn>
                <a:cxn ang="0">
                  <a:pos x="csX1" y="csY1"/>
                </a:cxn>
                <a:cxn ang="0">
                  <a:pos x="csX2" y="csY2"/>
                </a:cxn>
                <a:cxn ang="0">
                  <a:pos x="csX3" y="csY3"/>
                </a:cxn>
              </a:cxnLst>
              <a:rect l="l" t="t" r="r" b="b"/>
              <a:pathLst>
                <a:path w="141618" h="141617">
                  <a:moveTo>
                    <a:pt x="67317" y="509"/>
                  </a:moveTo>
                  <a:lnTo>
                    <a:pt x="138126" y="71318"/>
                  </a:lnTo>
                  <a:lnTo>
                    <a:pt x="67317" y="142127"/>
                  </a:lnTo>
                  <a:lnTo>
                    <a:pt x="-3492" y="71318"/>
                  </a:lnTo>
                  <a:close/>
                </a:path>
              </a:pathLst>
            </a:custGeom>
            <a:solidFill>
              <a:srgbClr val="4292C6"/>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499" name="テキスト ボックス 498">
              <a:extLst>
                <a:ext uri="{FF2B5EF4-FFF2-40B4-BE49-F238E27FC236}">
                  <a16:creationId xmlns:a16="http://schemas.microsoft.com/office/drawing/2014/main" id="{6A70A280-55B9-D05B-CDAF-36B84330B4B4}"/>
                </a:ext>
              </a:extLst>
            </p:cNvPr>
            <p:cNvSpPr txBox="1"/>
            <p:nvPr/>
          </p:nvSpPr>
          <p:spPr>
            <a:xfrm>
              <a:off x="3672121" y="4200308"/>
              <a:ext cx="316112"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RF3</a:t>
              </a:r>
            </a:p>
          </p:txBody>
        </p:sp>
        <p:sp>
          <p:nvSpPr>
            <p:cNvPr id="500" name="フリーフォーム: 図形 499">
              <a:extLst>
                <a:ext uri="{FF2B5EF4-FFF2-40B4-BE49-F238E27FC236}">
                  <a16:creationId xmlns:a16="http://schemas.microsoft.com/office/drawing/2014/main" id="{5F37DAD0-3E6B-D697-43E2-3663BCFF8F78}"/>
                </a:ext>
              </a:extLst>
            </p:cNvPr>
            <p:cNvSpPr/>
            <p:nvPr/>
          </p:nvSpPr>
          <p:spPr>
            <a:xfrm>
              <a:off x="2698678" y="5338453"/>
              <a:ext cx="141618" cy="141617"/>
            </a:xfrm>
            <a:custGeom>
              <a:avLst/>
              <a:gdLst>
                <a:gd name="csX0" fmla="*/ 67563 w 141618"/>
                <a:gd name="csY0" fmla="*/ 247 h 141617"/>
                <a:gd name="csX1" fmla="*/ 138372 w 141618"/>
                <a:gd name="csY1" fmla="*/ 71056 h 141617"/>
                <a:gd name="csX2" fmla="*/ 67563 w 141618"/>
                <a:gd name="csY2" fmla="*/ 141865 h 141617"/>
                <a:gd name="csX3" fmla="*/ -3246 w 141618"/>
                <a:gd name="csY3" fmla="*/ 71056 h 141617"/>
              </a:gdLst>
              <a:ahLst/>
              <a:cxnLst>
                <a:cxn ang="0">
                  <a:pos x="csX0" y="csY0"/>
                </a:cxn>
                <a:cxn ang="0">
                  <a:pos x="csX1" y="csY1"/>
                </a:cxn>
                <a:cxn ang="0">
                  <a:pos x="csX2" y="csY2"/>
                </a:cxn>
                <a:cxn ang="0">
                  <a:pos x="csX3" y="csY3"/>
                </a:cxn>
              </a:cxnLst>
              <a:rect l="l" t="t" r="r" b="b"/>
              <a:pathLst>
                <a:path w="141618" h="141617">
                  <a:moveTo>
                    <a:pt x="67563" y="247"/>
                  </a:moveTo>
                  <a:lnTo>
                    <a:pt x="138372" y="71056"/>
                  </a:lnTo>
                  <a:lnTo>
                    <a:pt x="67563" y="141865"/>
                  </a:lnTo>
                  <a:lnTo>
                    <a:pt x="-3246" y="71056"/>
                  </a:lnTo>
                  <a:close/>
                </a:path>
              </a:pathLst>
            </a:custGeom>
            <a:noFill/>
            <a:ln w="11787" cap="rnd">
              <a:solidFill>
                <a:srgbClr val="FA7837"/>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501" name="フリーフォーム: 図形 500">
              <a:extLst>
                <a:ext uri="{FF2B5EF4-FFF2-40B4-BE49-F238E27FC236}">
                  <a16:creationId xmlns:a16="http://schemas.microsoft.com/office/drawing/2014/main" id="{E840CCEF-9BF8-175B-C1B8-610063732FF3}"/>
                </a:ext>
              </a:extLst>
            </p:cNvPr>
            <p:cNvSpPr/>
            <p:nvPr/>
          </p:nvSpPr>
          <p:spPr>
            <a:xfrm>
              <a:off x="2698678" y="5338453"/>
              <a:ext cx="141618" cy="141617"/>
            </a:xfrm>
            <a:custGeom>
              <a:avLst/>
              <a:gdLst>
                <a:gd name="csX0" fmla="*/ 67563 w 141618"/>
                <a:gd name="csY0" fmla="*/ 247 h 141617"/>
                <a:gd name="csX1" fmla="*/ 138372 w 141618"/>
                <a:gd name="csY1" fmla="*/ 71056 h 141617"/>
                <a:gd name="csX2" fmla="*/ 67563 w 141618"/>
                <a:gd name="csY2" fmla="*/ 141865 h 141617"/>
                <a:gd name="csX3" fmla="*/ -3246 w 141618"/>
                <a:gd name="csY3" fmla="*/ 71056 h 141617"/>
              </a:gdLst>
              <a:ahLst/>
              <a:cxnLst>
                <a:cxn ang="0">
                  <a:pos x="csX0" y="csY0"/>
                </a:cxn>
                <a:cxn ang="0">
                  <a:pos x="csX1" y="csY1"/>
                </a:cxn>
                <a:cxn ang="0">
                  <a:pos x="csX2" y="csY2"/>
                </a:cxn>
                <a:cxn ang="0">
                  <a:pos x="csX3" y="csY3"/>
                </a:cxn>
              </a:cxnLst>
              <a:rect l="l" t="t" r="r" b="b"/>
              <a:pathLst>
                <a:path w="141618" h="141617">
                  <a:moveTo>
                    <a:pt x="67563" y="247"/>
                  </a:moveTo>
                  <a:lnTo>
                    <a:pt x="138372" y="71056"/>
                  </a:lnTo>
                  <a:lnTo>
                    <a:pt x="67563" y="141865"/>
                  </a:lnTo>
                  <a:lnTo>
                    <a:pt x="-3246" y="71056"/>
                  </a:lnTo>
                  <a:close/>
                </a:path>
              </a:pathLst>
            </a:custGeom>
            <a:solidFill>
              <a:srgbClr val="F99868"/>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502" name="テキスト ボックス 501">
              <a:extLst>
                <a:ext uri="{FF2B5EF4-FFF2-40B4-BE49-F238E27FC236}">
                  <a16:creationId xmlns:a16="http://schemas.microsoft.com/office/drawing/2014/main" id="{AB081E21-DADE-8E6A-7E86-BF40256EE1A5}"/>
                </a:ext>
              </a:extLst>
            </p:cNvPr>
            <p:cNvSpPr txBox="1"/>
            <p:nvPr/>
          </p:nvSpPr>
          <p:spPr>
            <a:xfrm>
              <a:off x="2590840" y="5334244"/>
              <a:ext cx="357790"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SRK2B</a:t>
              </a:r>
            </a:p>
          </p:txBody>
        </p:sp>
        <p:sp>
          <p:nvSpPr>
            <p:cNvPr id="503" name="フリーフォーム: 図形 502">
              <a:extLst>
                <a:ext uri="{FF2B5EF4-FFF2-40B4-BE49-F238E27FC236}">
                  <a16:creationId xmlns:a16="http://schemas.microsoft.com/office/drawing/2014/main" id="{5011BD32-1AA8-4528-2D77-0B7B63F299DD}"/>
                </a:ext>
              </a:extLst>
            </p:cNvPr>
            <p:cNvSpPr/>
            <p:nvPr/>
          </p:nvSpPr>
          <p:spPr>
            <a:xfrm>
              <a:off x="2956401" y="4920554"/>
              <a:ext cx="129816" cy="129816"/>
            </a:xfrm>
            <a:custGeom>
              <a:avLst/>
              <a:gdLst>
                <a:gd name="csX0" fmla="*/ 126513 w 129816"/>
                <a:gd name="csY0" fmla="*/ 65253 h 129816"/>
                <a:gd name="csX1" fmla="*/ 61604 w 129816"/>
                <a:gd name="csY1" fmla="*/ 130161 h 129816"/>
                <a:gd name="csX2" fmla="*/ -3304 w 129816"/>
                <a:gd name="csY2" fmla="*/ 65253 h 129816"/>
                <a:gd name="csX3" fmla="*/ 61604 w 129816"/>
                <a:gd name="csY3" fmla="*/ 345 h 129816"/>
                <a:gd name="csX4" fmla="*/ 126513 w 129816"/>
                <a:gd name="csY4" fmla="*/ 65253 h 129816"/>
              </a:gdLst>
              <a:ahLst/>
              <a:cxnLst>
                <a:cxn ang="0">
                  <a:pos x="csX0" y="csY0"/>
                </a:cxn>
                <a:cxn ang="0">
                  <a:pos x="csX1" y="csY1"/>
                </a:cxn>
                <a:cxn ang="0">
                  <a:pos x="csX2" y="csY2"/>
                </a:cxn>
                <a:cxn ang="0">
                  <a:pos x="csX3" y="csY3"/>
                </a:cxn>
                <a:cxn ang="0">
                  <a:pos x="csX4" y="csY4"/>
                </a:cxn>
              </a:cxnLst>
              <a:rect l="l" t="t" r="r" b="b"/>
              <a:pathLst>
                <a:path w="129816" h="129816">
                  <a:moveTo>
                    <a:pt x="126513" y="65253"/>
                  </a:moveTo>
                  <a:cubicBezTo>
                    <a:pt x="126513" y="101101"/>
                    <a:pt x="97452" y="130161"/>
                    <a:pt x="61604" y="130161"/>
                  </a:cubicBezTo>
                  <a:cubicBezTo>
                    <a:pt x="25757" y="130161"/>
                    <a:pt x="-3304" y="101101"/>
                    <a:pt x="-3304" y="65253"/>
                  </a:cubicBezTo>
                  <a:cubicBezTo>
                    <a:pt x="-3304" y="29405"/>
                    <a:pt x="25757" y="345"/>
                    <a:pt x="61604" y="345"/>
                  </a:cubicBezTo>
                  <a:cubicBezTo>
                    <a:pt x="97452" y="345"/>
                    <a:pt x="126513" y="29405"/>
                    <a:pt x="126513" y="65253"/>
                  </a:cubicBezTo>
                  <a:close/>
                </a:path>
              </a:pathLst>
            </a:custGeom>
            <a:noFill/>
            <a:ln w="11787" cap="rnd">
              <a:solidFill>
                <a:srgbClr val="4292C6"/>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504" name="フリーフォーム: 図形 503">
              <a:extLst>
                <a:ext uri="{FF2B5EF4-FFF2-40B4-BE49-F238E27FC236}">
                  <a16:creationId xmlns:a16="http://schemas.microsoft.com/office/drawing/2014/main" id="{0A52217D-4A8E-40BC-550F-848850201E6F}"/>
                </a:ext>
              </a:extLst>
            </p:cNvPr>
            <p:cNvSpPr/>
            <p:nvPr/>
          </p:nvSpPr>
          <p:spPr>
            <a:xfrm>
              <a:off x="2956401" y="4920554"/>
              <a:ext cx="129816" cy="129816"/>
            </a:xfrm>
            <a:custGeom>
              <a:avLst/>
              <a:gdLst>
                <a:gd name="csX0" fmla="*/ 126513 w 129816"/>
                <a:gd name="csY0" fmla="*/ 65253 h 129816"/>
                <a:gd name="csX1" fmla="*/ 61604 w 129816"/>
                <a:gd name="csY1" fmla="*/ 130161 h 129816"/>
                <a:gd name="csX2" fmla="*/ -3304 w 129816"/>
                <a:gd name="csY2" fmla="*/ 65253 h 129816"/>
                <a:gd name="csX3" fmla="*/ 61604 w 129816"/>
                <a:gd name="csY3" fmla="*/ 345 h 129816"/>
                <a:gd name="csX4" fmla="*/ 126513 w 129816"/>
                <a:gd name="csY4" fmla="*/ 65253 h 129816"/>
              </a:gdLst>
              <a:ahLst/>
              <a:cxnLst>
                <a:cxn ang="0">
                  <a:pos x="csX0" y="csY0"/>
                </a:cxn>
                <a:cxn ang="0">
                  <a:pos x="csX1" y="csY1"/>
                </a:cxn>
                <a:cxn ang="0">
                  <a:pos x="csX2" y="csY2"/>
                </a:cxn>
                <a:cxn ang="0">
                  <a:pos x="csX3" y="csY3"/>
                </a:cxn>
                <a:cxn ang="0">
                  <a:pos x="csX4" y="csY4"/>
                </a:cxn>
              </a:cxnLst>
              <a:rect l="l" t="t" r="r" b="b"/>
              <a:pathLst>
                <a:path w="129816" h="129816">
                  <a:moveTo>
                    <a:pt x="126513" y="65253"/>
                  </a:moveTo>
                  <a:cubicBezTo>
                    <a:pt x="126513" y="101101"/>
                    <a:pt x="97452" y="130161"/>
                    <a:pt x="61604" y="130161"/>
                  </a:cubicBezTo>
                  <a:cubicBezTo>
                    <a:pt x="25757" y="130161"/>
                    <a:pt x="-3304" y="101101"/>
                    <a:pt x="-3304" y="65253"/>
                  </a:cubicBezTo>
                  <a:cubicBezTo>
                    <a:pt x="-3304" y="29405"/>
                    <a:pt x="25757" y="345"/>
                    <a:pt x="61604" y="345"/>
                  </a:cubicBezTo>
                  <a:cubicBezTo>
                    <a:pt x="97452" y="345"/>
                    <a:pt x="126513" y="29405"/>
                    <a:pt x="126513" y="65253"/>
                  </a:cubicBezTo>
                  <a:close/>
                </a:path>
              </a:pathLst>
            </a:custGeom>
            <a:solidFill>
              <a:srgbClr val="DBE8F0"/>
            </a:solidFill>
            <a:ln w="2357" cap="sq">
              <a:no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505" name="テキスト ボックス 504">
              <a:extLst>
                <a:ext uri="{FF2B5EF4-FFF2-40B4-BE49-F238E27FC236}">
                  <a16:creationId xmlns:a16="http://schemas.microsoft.com/office/drawing/2014/main" id="{B2F0912F-12F1-BF29-607E-1CF2ED3B880E}"/>
                </a:ext>
              </a:extLst>
            </p:cNvPr>
            <p:cNvSpPr txBox="1"/>
            <p:nvPr/>
          </p:nvSpPr>
          <p:spPr>
            <a:xfrm>
              <a:off x="2856285" y="4906625"/>
              <a:ext cx="324128"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AHA1</a:t>
              </a:r>
            </a:p>
          </p:txBody>
        </p:sp>
        <p:sp>
          <p:nvSpPr>
            <p:cNvPr id="506" name="フリーフォーム: 図形 505">
              <a:extLst>
                <a:ext uri="{FF2B5EF4-FFF2-40B4-BE49-F238E27FC236}">
                  <a16:creationId xmlns:a16="http://schemas.microsoft.com/office/drawing/2014/main" id="{96E6002A-4D15-80EC-9397-D222D002692D}"/>
                </a:ext>
              </a:extLst>
            </p:cNvPr>
            <p:cNvSpPr/>
            <p:nvPr/>
          </p:nvSpPr>
          <p:spPr>
            <a:xfrm>
              <a:off x="3240546" y="4482618"/>
              <a:ext cx="144000" cy="144000"/>
            </a:xfrm>
            <a:custGeom>
              <a:avLst/>
              <a:gdLst>
                <a:gd name="csX0" fmla="*/ 126447 w 129816"/>
                <a:gd name="csY0" fmla="*/ 65350 h 129816"/>
                <a:gd name="csX1" fmla="*/ 61539 w 129816"/>
                <a:gd name="csY1" fmla="*/ 130258 h 129816"/>
                <a:gd name="csX2" fmla="*/ -3369 w 129816"/>
                <a:gd name="csY2" fmla="*/ 65350 h 129816"/>
                <a:gd name="csX3" fmla="*/ 61539 w 129816"/>
                <a:gd name="csY3" fmla="*/ 442 h 129816"/>
                <a:gd name="csX4" fmla="*/ 126447 w 129816"/>
                <a:gd name="csY4" fmla="*/ 65350 h 129816"/>
              </a:gdLst>
              <a:ahLst/>
              <a:cxnLst>
                <a:cxn ang="0">
                  <a:pos x="csX0" y="csY0"/>
                </a:cxn>
                <a:cxn ang="0">
                  <a:pos x="csX1" y="csY1"/>
                </a:cxn>
                <a:cxn ang="0">
                  <a:pos x="csX2" y="csY2"/>
                </a:cxn>
                <a:cxn ang="0">
                  <a:pos x="csX3" y="csY3"/>
                </a:cxn>
                <a:cxn ang="0">
                  <a:pos x="csX4" y="csY4"/>
                </a:cxn>
              </a:cxnLst>
              <a:rect l="l" t="t" r="r" b="b"/>
              <a:pathLst>
                <a:path w="129816" h="129816">
                  <a:moveTo>
                    <a:pt x="126447" y="65350"/>
                  </a:moveTo>
                  <a:cubicBezTo>
                    <a:pt x="126447" y="101198"/>
                    <a:pt x="97387" y="130258"/>
                    <a:pt x="61539" y="130258"/>
                  </a:cubicBezTo>
                  <a:cubicBezTo>
                    <a:pt x="25691" y="130258"/>
                    <a:pt x="-3369" y="101198"/>
                    <a:pt x="-3369" y="65350"/>
                  </a:cubicBezTo>
                  <a:cubicBezTo>
                    <a:pt x="-3369" y="29502"/>
                    <a:pt x="25691" y="442"/>
                    <a:pt x="61539" y="442"/>
                  </a:cubicBezTo>
                  <a:cubicBezTo>
                    <a:pt x="97387" y="442"/>
                    <a:pt x="126447" y="29502"/>
                    <a:pt x="126447" y="65350"/>
                  </a:cubicBezTo>
                  <a:close/>
                </a:path>
              </a:pathLst>
            </a:custGeom>
            <a:solidFill>
              <a:srgbClr val="4292C6"/>
            </a:solidFill>
            <a:ln w="6350" cap="sq">
              <a:solidFill>
                <a:srgbClr val="0070C0"/>
              </a:solidFill>
              <a:prstDash val="solid"/>
              <a:miter/>
            </a:ln>
          </p:spPr>
          <p:txBody>
            <a:bodyPr anchor="ctr"/>
            <a:lstStyle/>
            <a:p>
              <a:pPr algn="ctr"/>
              <a:endParaRPr lang="ja-JP" altLang="en-US" sz="400" b="1">
                <a:ln w="0"/>
                <a:latin typeface="Arial" panose="020B0604020202020204" pitchFamily="34" charset="0"/>
                <a:cs typeface="Arial" panose="020B0604020202020204" pitchFamily="34" charset="0"/>
              </a:endParaRPr>
            </a:p>
          </p:txBody>
        </p:sp>
        <p:sp>
          <p:nvSpPr>
            <p:cNvPr id="507" name="テキスト ボックス 506">
              <a:extLst>
                <a:ext uri="{FF2B5EF4-FFF2-40B4-BE49-F238E27FC236}">
                  <a16:creationId xmlns:a16="http://schemas.microsoft.com/office/drawing/2014/main" id="{8B1FE41D-9125-39E0-A94B-90FB16BCEB26}"/>
                </a:ext>
              </a:extLst>
            </p:cNvPr>
            <p:cNvSpPr txBox="1"/>
            <p:nvPr/>
          </p:nvSpPr>
          <p:spPr>
            <a:xfrm>
              <a:off x="3161246" y="4476646"/>
              <a:ext cx="298479"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PMK</a:t>
              </a:r>
            </a:p>
          </p:txBody>
        </p:sp>
        <p:sp>
          <p:nvSpPr>
            <p:cNvPr id="508" name="フリーフォーム: 図形 507">
              <a:extLst>
                <a:ext uri="{FF2B5EF4-FFF2-40B4-BE49-F238E27FC236}">
                  <a16:creationId xmlns:a16="http://schemas.microsoft.com/office/drawing/2014/main" id="{B9935CC5-2060-2210-E01C-9FEC800A8794}"/>
                </a:ext>
              </a:extLst>
            </p:cNvPr>
            <p:cNvSpPr/>
            <p:nvPr/>
          </p:nvSpPr>
          <p:spPr>
            <a:xfrm>
              <a:off x="3812853" y="4761272"/>
              <a:ext cx="144000" cy="144000"/>
            </a:xfrm>
            <a:custGeom>
              <a:avLst/>
              <a:gdLst>
                <a:gd name="csX0" fmla="*/ 67305 w 141618"/>
                <a:gd name="csY0" fmla="*/ 380 h 141617"/>
                <a:gd name="csX1" fmla="*/ 138114 w 141618"/>
                <a:gd name="csY1" fmla="*/ 71189 h 141617"/>
                <a:gd name="csX2" fmla="*/ 67305 w 141618"/>
                <a:gd name="csY2" fmla="*/ 141998 h 141617"/>
                <a:gd name="csX3" fmla="*/ -3504 w 141618"/>
                <a:gd name="csY3" fmla="*/ 71189 h 141617"/>
              </a:gdLst>
              <a:ahLst/>
              <a:cxnLst>
                <a:cxn ang="0">
                  <a:pos x="csX0" y="csY0"/>
                </a:cxn>
                <a:cxn ang="0">
                  <a:pos x="csX1" y="csY1"/>
                </a:cxn>
                <a:cxn ang="0">
                  <a:pos x="csX2" y="csY2"/>
                </a:cxn>
                <a:cxn ang="0">
                  <a:pos x="csX3" y="csY3"/>
                </a:cxn>
              </a:cxnLst>
              <a:rect l="l" t="t" r="r" b="b"/>
              <a:pathLst>
                <a:path w="141618" h="141617">
                  <a:moveTo>
                    <a:pt x="67305" y="380"/>
                  </a:moveTo>
                  <a:lnTo>
                    <a:pt x="138114" y="71189"/>
                  </a:lnTo>
                  <a:lnTo>
                    <a:pt x="67305" y="141998"/>
                  </a:lnTo>
                  <a:lnTo>
                    <a:pt x="-3504" y="71189"/>
                  </a:lnTo>
                  <a:close/>
                </a:path>
              </a:pathLst>
            </a:custGeom>
            <a:solidFill>
              <a:srgbClr val="D9E6EF"/>
            </a:solidFill>
            <a:ln w="6350" cap="sq">
              <a:solidFill>
                <a:srgbClr val="0070C0"/>
              </a:solidFill>
              <a:prstDash val="solid"/>
              <a:miter/>
            </a:ln>
          </p:spPr>
          <p:txBody>
            <a:bodyPr anchor="ctr"/>
            <a:lstStyle/>
            <a:p>
              <a:pPr algn="ctr"/>
              <a:endParaRPr lang="ja-JP" altLang="en-US" sz="400" b="1" dirty="0">
                <a:ln w="0"/>
                <a:latin typeface="Arial" panose="020B0604020202020204" pitchFamily="34" charset="0"/>
                <a:cs typeface="Arial" panose="020B0604020202020204" pitchFamily="34" charset="0"/>
              </a:endParaRPr>
            </a:p>
          </p:txBody>
        </p:sp>
        <p:sp>
          <p:nvSpPr>
            <p:cNvPr id="509" name="テキスト ボックス 508">
              <a:extLst>
                <a:ext uri="{FF2B5EF4-FFF2-40B4-BE49-F238E27FC236}">
                  <a16:creationId xmlns:a16="http://schemas.microsoft.com/office/drawing/2014/main" id="{C6DE429A-AA72-49EF-DE83-B02B224307A4}"/>
                </a:ext>
              </a:extLst>
            </p:cNvPr>
            <p:cNvSpPr txBox="1"/>
            <p:nvPr/>
          </p:nvSpPr>
          <p:spPr>
            <a:xfrm>
              <a:off x="3720861" y="4755660"/>
              <a:ext cx="327334" cy="153888"/>
            </a:xfrm>
            <a:prstGeom prst="rect">
              <a:avLst/>
            </a:prstGeom>
            <a:noFill/>
          </p:spPr>
          <p:txBody>
            <a:bodyPr rot="0" spcFirstLastPara="0" vertOverflow="overflow" horzOverflow="overflow" vert="horz" wrap="none" lIns="91440" tIns="45720" rIns="91440" bIns="45720" numCol="1" spcCol="0" rtlCol="0" fromWordArt="0" anchor="ctr" anchorCtr="0" forceAA="0" compatLnSpc="1">
              <a:prstTxWarp prst="textNoShape">
                <a:avLst/>
              </a:prstTxWarp>
              <a:spAutoFit/>
            </a:bodyPr>
            <a:lstStyle/>
            <a:p>
              <a:pPr algn="ctr"/>
              <a:r>
                <a:rPr lang="ja-JP" altLang="en-US" sz="400" b="1" baseline="0" dirty="0">
                  <a:ln w="0"/>
                  <a:latin typeface="Arial" panose="020B0604020202020204" pitchFamily="34" charset="0"/>
                  <a:cs typeface="Arial" panose="020B0604020202020204" pitchFamily="34" charset="0"/>
                  <a:sym typeface="Helvetica"/>
                  <a:rtl val="0"/>
                </a:rPr>
                <a:t>MPK6</a:t>
              </a:r>
            </a:p>
          </p:txBody>
        </p:sp>
      </p:grpSp>
      <p:sp>
        <p:nvSpPr>
          <p:cNvPr id="512" name="テキスト ボックス 511">
            <a:extLst>
              <a:ext uri="{FF2B5EF4-FFF2-40B4-BE49-F238E27FC236}">
                <a16:creationId xmlns:a16="http://schemas.microsoft.com/office/drawing/2014/main" id="{CE0A37FA-1CF6-2899-6AD1-4B4C259B82AD}"/>
              </a:ext>
            </a:extLst>
          </p:cNvPr>
          <p:cNvSpPr txBox="1"/>
          <p:nvPr/>
        </p:nvSpPr>
        <p:spPr>
          <a:xfrm>
            <a:off x="872999" y="2240266"/>
            <a:ext cx="604653" cy="200055"/>
          </a:xfrm>
          <a:prstGeom prst="rect">
            <a:avLst/>
          </a:prstGeom>
          <a:noFill/>
        </p:spPr>
        <p:txBody>
          <a:bodyPr wrap="none" rtlCol="0">
            <a:spAutoFit/>
          </a:bodyPr>
          <a:lstStyle/>
          <a:p>
            <a:pPr algn="ctr"/>
            <a:r>
              <a:rPr kumimoji="1" lang="en-US" altLang="ja-JP" sz="700" b="1" dirty="0">
                <a:latin typeface="Arial" panose="020B0604020202020204" pitchFamily="34" charset="0"/>
                <a:cs typeface="Arial" panose="020B0604020202020204" pitchFamily="34" charset="0"/>
              </a:rPr>
              <a:t>t = 15 min</a:t>
            </a:r>
            <a:endParaRPr kumimoji="1" lang="ja-JP" altLang="en-US" sz="700" b="1" dirty="0">
              <a:latin typeface="Arial" panose="020B0604020202020204" pitchFamily="34" charset="0"/>
              <a:cs typeface="Arial" panose="020B0604020202020204" pitchFamily="34" charset="0"/>
            </a:endParaRPr>
          </a:p>
        </p:txBody>
      </p:sp>
      <p:sp>
        <p:nvSpPr>
          <p:cNvPr id="513" name="テキスト ボックス 512">
            <a:extLst>
              <a:ext uri="{FF2B5EF4-FFF2-40B4-BE49-F238E27FC236}">
                <a16:creationId xmlns:a16="http://schemas.microsoft.com/office/drawing/2014/main" id="{38B5A244-3B59-71EA-0443-18F78B4EB59B}"/>
              </a:ext>
            </a:extLst>
          </p:cNvPr>
          <p:cNvSpPr txBox="1"/>
          <p:nvPr/>
        </p:nvSpPr>
        <p:spPr>
          <a:xfrm>
            <a:off x="2515640" y="1841002"/>
            <a:ext cx="604653" cy="200055"/>
          </a:xfrm>
          <a:prstGeom prst="rect">
            <a:avLst/>
          </a:prstGeom>
          <a:noFill/>
        </p:spPr>
        <p:txBody>
          <a:bodyPr wrap="none" rtlCol="0">
            <a:spAutoFit/>
          </a:bodyPr>
          <a:lstStyle/>
          <a:p>
            <a:pPr algn="ctr"/>
            <a:r>
              <a:rPr kumimoji="1" lang="en-US" altLang="ja-JP" sz="700" b="1" dirty="0">
                <a:latin typeface="Arial" panose="020B0604020202020204" pitchFamily="34" charset="0"/>
                <a:cs typeface="Arial" panose="020B0604020202020204" pitchFamily="34" charset="0"/>
              </a:rPr>
              <a:t>t = 30 min</a:t>
            </a:r>
            <a:endParaRPr kumimoji="1" lang="ja-JP" altLang="en-US" sz="700" b="1" dirty="0">
              <a:latin typeface="Arial" panose="020B0604020202020204" pitchFamily="34" charset="0"/>
              <a:cs typeface="Arial" panose="020B0604020202020204" pitchFamily="34" charset="0"/>
            </a:endParaRPr>
          </a:p>
        </p:txBody>
      </p:sp>
      <p:sp>
        <p:nvSpPr>
          <p:cNvPr id="514" name="テキスト ボックス 513">
            <a:extLst>
              <a:ext uri="{FF2B5EF4-FFF2-40B4-BE49-F238E27FC236}">
                <a16:creationId xmlns:a16="http://schemas.microsoft.com/office/drawing/2014/main" id="{8DAC84B3-ACBB-44C1-5211-028BB0B01ADE}"/>
              </a:ext>
            </a:extLst>
          </p:cNvPr>
          <p:cNvSpPr txBox="1"/>
          <p:nvPr/>
        </p:nvSpPr>
        <p:spPr>
          <a:xfrm>
            <a:off x="4158280" y="1441737"/>
            <a:ext cx="604653" cy="200055"/>
          </a:xfrm>
          <a:prstGeom prst="rect">
            <a:avLst/>
          </a:prstGeom>
          <a:noFill/>
        </p:spPr>
        <p:txBody>
          <a:bodyPr wrap="none" rtlCol="0">
            <a:spAutoFit/>
          </a:bodyPr>
          <a:lstStyle/>
          <a:p>
            <a:pPr algn="ctr"/>
            <a:r>
              <a:rPr kumimoji="1" lang="en-US" altLang="ja-JP" sz="700" b="1" dirty="0">
                <a:latin typeface="Arial" panose="020B0604020202020204" pitchFamily="34" charset="0"/>
                <a:cs typeface="Arial" panose="020B0604020202020204" pitchFamily="34" charset="0"/>
              </a:rPr>
              <a:t>t = 90 min</a:t>
            </a:r>
            <a:endParaRPr kumimoji="1" lang="ja-JP" altLang="en-US" sz="700" b="1" dirty="0">
              <a:latin typeface="Arial" panose="020B0604020202020204" pitchFamily="34" charset="0"/>
              <a:cs typeface="Arial" panose="020B0604020202020204" pitchFamily="34" charset="0"/>
            </a:endParaRPr>
          </a:p>
        </p:txBody>
      </p:sp>
      <p:cxnSp>
        <p:nvCxnSpPr>
          <p:cNvPr id="515" name="直線矢印コネクタ 514">
            <a:extLst>
              <a:ext uri="{FF2B5EF4-FFF2-40B4-BE49-F238E27FC236}">
                <a16:creationId xmlns:a16="http://schemas.microsoft.com/office/drawing/2014/main" id="{DF9519DC-2837-D30A-8AC2-C584A52D8B56}"/>
              </a:ext>
            </a:extLst>
          </p:cNvPr>
          <p:cNvCxnSpPr>
            <a:cxnSpLocks/>
          </p:cNvCxnSpPr>
          <p:nvPr/>
        </p:nvCxnSpPr>
        <p:spPr>
          <a:xfrm flipV="1">
            <a:off x="1492646" y="2022769"/>
            <a:ext cx="1008000" cy="324000"/>
          </a:xfrm>
          <a:prstGeom prst="straightConnector1">
            <a:avLst/>
          </a:prstGeom>
          <a:ln>
            <a:solidFill>
              <a:schemeClr val="tx1">
                <a:lumMod val="50000"/>
                <a:lumOff val="50000"/>
              </a:schemeClr>
            </a:solidFill>
            <a:prstDash val="sysDot"/>
            <a:tailEnd type="triangle"/>
          </a:ln>
          <a:effectLst/>
        </p:spPr>
        <p:style>
          <a:lnRef idx="2">
            <a:schemeClr val="dk1"/>
          </a:lnRef>
          <a:fillRef idx="0">
            <a:schemeClr val="dk1"/>
          </a:fillRef>
          <a:effectRef idx="1">
            <a:schemeClr val="dk1"/>
          </a:effectRef>
          <a:fontRef idx="minor">
            <a:schemeClr val="tx1"/>
          </a:fontRef>
        </p:style>
      </p:cxnSp>
      <p:cxnSp>
        <p:nvCxnSpPr>
          <p:cNvPr id="516" name="直線矢印コネクタ 515">
            <a:extLst>
              <a:ext uri="{FF2B5EF4-FFF2-40B4-BE49-F238E27FC236}">
                <a16:creationId xmlns:a16="http://schemas.microsoft.com/office/drawing/2014/main" id="{93CA3BB9-C8D2-3A27-BD81-66CD5EBF52D4}"/>
              </a:ext>
            </a:extLst>
          </p:cNvPr>
          <p:cNvCxnSpPr>
            <a:cxnSpLocks/>
          </p:cNvCxnSpPr>
          <p:nvPr/>
        </p:nvCxnSpPr>
        <p:spPr>
          <a:xfrm flipV="1">
            <a:off x="3135287" y="1534714"/>
            <a:ext cx="1008000" cy="324000"/>
          </a:xfrm>
          <a:prstGeom prst="straightConnector1">
            <a:avLst/>
          </a:prstGeom>
          <a:ln>
            <a:solidFill>
              <a:schemeClr val="tx1">
                <a:lumMod val="50000"/>
                <a:lumOff val="50000"/>
              </a:schemeClr>
            </a:solidFill>
            <a:prstDash val="sysDot"/>
            <a:tailEnd type="triangle"/>
          </a:ln>
          <a:effectLst/>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37786838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4A7ADE6-E503-CF67-85A4-DD0BE1841C59}"/>
            </a:ext>
          </a:extLst>
        </p:cNvPr>
        <p:cNvGrpSpPr/>
        <p:nvPr/>
      </p:nvGrpSpPr>
      <p:grpSpPr>
        <a:xfrm>
          <a:off x="0" y="0"/>
          <a:ext cx="0" cy="0"/>
          <a:chOff x="0" y="0"/>
          <a:chExt cx="0" cy="0"/>
        </a:xfrm>
      </p:grpSpPr>
      <p:sp>
        <p:nvSpPr>
          <p:cNvPr id="16" name="テキスト ボックス 15">
            <a:extLst>
              <a:ext uri="{FF2B5EF4-FFF2-40B4-BE49-F238E27FC236}">
                <a16:creationId xmlns:a16="http://schemas.microsoft.com/office/drawing/2014/main" id="{E6DC2C6D-574A-F14A-649E-89DEDD8D44F5}"/>
              </a:ext>
            </a:extLst>
          </p:cNvPr>
          <p:cNvSpPr txBox="1"/>
          <p:nvPr/>
        </p:nvSpPr>
        <p:spPr>
          <a:xfrm>
            <a:off x="853816" y="3642224"/>
            <a:ext cx="5400000" cy="707886"/>
          </a:xfrm>
          <a:prstGeom prst="rect">
            <a:avLst/>
          </a:prstGeom>
          <a:noFill/>
        </p:spPr>
        <p:txBody>
          <a:bodyPr wrap="square">
            <a:spAutoFit/>
          </a:bodyPr>
          <a:lstStyle/>
          <a:p>
            <a:pPr algn="just"/>
            <a:r>
              <a:rPr lang="en-US" altLang="ja-JP" sz="1000" b="1" dirty="0">
                <a:latin typeface="Arial" panose="020B0604020202020204" pitchFamily="34" charset="0"/>
                <a:cs typeface="Arial" panose="020B0604020202020204" pitchFamily="34" charset="0"/>
              </a:rPr>
              <a:t>Supplementary Figure S5. Heat map showing the intensity of </a:t>
            </a:r>
            <a:r>
              <a:rPr lang="en-US" altLang="ja-JP" sz="1000" b="1" dirty="0" err="1">
                <a:latin typeface="Arial" panose="020B0604020202020204" pitchFamily="34" charset="0"/>
                <a:cs typeface="Arial" panose="020B0604020202020204" pitchFamily="34" charset="0"/>
              </a:rPr>
              <a:t>phosphopeptides</a:t>
            </a:r>
            <a:r>
              <a:rPr lang="en-US" altLang="ja-JP" sz="1000" b="1" dirty="0">
                <a:latin typeface="Arial" panose="020B0604020202020204" pitchFamily="34" charset="0"/>
                <a:cs typeface="Arial" panose="020B0604020202020204" pitchFamily="34" charset="0"/>
              </a:rPr>
              <a:t> from known SnRK2 substrates. </a:t>
            </a:r>
            <a:r>
              <a:rPr lang="en-US" altLang="ja-JP" sz="1000" dirty="0">
                <a:latin typeface="Arial" panose="020B0604020202020204" pitchFamily="34" charset="0"/>
                <a:cs typeface="Arial" panose="020B0604020202020204" pitchFamily="34" charset="0"/>
              </a:rPr>
              <a:t>To compare the peptide abundance between samples under different conditions, the mean intensities were scaled to the same range for each </a:t>
            </a:r>
            <a:r>
              <a:rPr lang="en-US" altLang="ja-JP" sz="1000" dirty="0" err="1">
                <a:latin typeface="Arial" panose="020B0604020202020204" pitchFamily="34" charset="0"/>
                <a:cs typeface="Arial" panose="020B0604020202020204" pitchFamily="34" charset="0"/>
              </a:rPr>
              <a:t>phosphopeptide</a:t>
            </a:r>
            <a:r>
              <a:rPr lang="en-US" altLang="ja-JP" sz="1000" dirty="0">
                <a:latin typeface="Arial" panose="020B0604020202020204" pitchFamily="34" charset="0"/>
                <a:cs typeface="Arial" panose="020B0604020202020204" pitchFamily="34" charset="0"/>
              </a:rPr>
              <a:t>.</a:t>
            </a:r>
            <a:endParaRPr lang="en" altLang="ja-JP" sz="1000" dirty="0">
              <a:latin typeface="Arial" panose="020B0604020202020204" pitchFamily="34" charset="0"/>
              <a:cs typeface="Arial" panose="020B0604020202020204" pitchFamily="34" charset="0"/>
            </a:endParaRPr>
          </a:p>
        </p:txBody>
      </p:sp>
      <p:grpSp>
        <p:nvGrpSpPr>
          <p:cNvPr id="472" name="グループ化 471">
            <a:extLst>
              <a:ext uri="{FF2B5EF4-FFF2-40B4-BE49-F238E27FC236}">
                <a16:creationId xmlns:a16="http://schemas.microsoft.com/office/drawing/2014/main" id="{DFF9196F-E031-8B30-9524-78CA1F2AC7E9}"/>
              </a:ext>
            </a:extLst>
          </p:cNvPr>
          <p:cNvGrpSpPr/>
          <p:nvPr/>
        </p:nvGrpSpPr>
        <p:grpSpPr>
          <a:xfrm>
            <a:off x="1186628" y="1884519"/>
            <a:ext cx="4496683" cy="1410851"/>
            <a:chOff x="1186628" y="1884519"/>
            <a:chExt cx="4496683" cy="1410851"/>
          </a:xfrm>
        </p:grpSpPr>
        <p:grpSp>
          <p:nvGrpSpPr>
            <p:cNvPr id="6" name="グループ化 5">
              <a:extLst>
                <a:ext uri="{FF2B5EF4-FFF2-40B4-BE49-F238E27FC236}">
                  <a16:creationId xmlns:a16="http://schemas.microsoft.com/office/drawing/2014/main" id="{2F8D4D92-EC6F-5600-5072-8FD01A8AD285}"/>
                </a:ext>
              </a:extLst>
            </p:cNvPr>
            <p:cNvGrpSpPr/>
            <p:nvPr/>
          </p:nvGrpSpPr>
          <p:grpSpPr>
            <a:xfrm>
              <a:off x="3124818" y="3024484"/>
              <a:ext cx="2351303" cy="270886"/>
              <a:chOff x="3128221" y="4163577"/>
              <a:chExt cx="2351303" cy="270886"/>
            </a:xfrm>
          </p:grpSpPr>
          <p:sp>
            <p:nvSpPr>
              <p:cNvPr id="7" name="テキスト ボックス 6">
                <a:extLst>
                  <a:ext uri="{FF2B5EF4-FFF2-40B4-BE49-F238E27FC236}">
                    <a16:creationId xmlns:a16="http://schemas.microsoft.com/office/drawing/2014/main" id="{24A4D69F-0BCC-3881-0C1F-F27B19565975}"/>
                  </a:ext>
                </a:extLst>
              </p:cNvPr>
              <p:cNvSpPr txBox="1"/>
              <p:nvPr/>
            </p:nvSpPr>
            <p:spPr>
              <a:xfrm>
                <a:off x="3128221" y="4249797"/>
                <a:ext cx="1729930" cy="184666"/>
              </a:xfrm>
              <a:prstGeom prst="rect">
                <a:avLst/>
              </a:prstGeom>
              <a:noFill/>
            </p:spPr>
            <p:txBody>
              <a:bodyPr wrap="square" rtlCol="0">
                <a:spAutoFit/>
              </a:bodyPr>
              <a:lstStyle/>
              <a:p>
                <a:pPr algn="ctr"/>
                <a:r>
                  <a:rPr lang="en-US" altLang="ja-JP" sz="600" dirty="0">
                    <a:latin typeface="Arial" panose="020B0604020202020204" pitchFamily="34" charset="0"/>
                    <a:cs typeface="Arial" panose="020B0604020202020204" pitchFamily="34" charset="0"/>
                  </a:rPr>
                  <a:t>P</a:t>
                </a:r>
                <a:r>
                  <a:rPr kumimoji="1" lang="en-US" altLang="ja-JP" sz="600" dirty="0">
                    <a:latin typeface="Arial" panose="020B0604020202020204" pitchFamily="34" charset="0"/>
                    <a:cs typeface="Arial" panose="020B0604020202020204" pitchFamily="34" charset="0"/>
                  </a:rPr>
                  <a:t>hosphopeptide intensity (scaled)</a:t>
                </a:r>
                <a:endParaRPr kumimoji="1" lang="ja-JP" altLang="en-US" sz="600" dirty="0">
                  <a:latin typeface="Arial" panose="020B0604020202020204" pitchFamily="34" charset="0"/>
                  <a:cs typeface="Arial" panose="020B0604020202020204" pitchFamily="34" charset="0"/>
                </a:endParaRPr>
              </a:p>
            </p:txBody>
          </p:sp>
          <p:cxnSp>
            <p:nvCxnSpPr>
              <p:cNvPr id="8" name="直線コネクタ 7">
                <a:extLst>
                  <a:ext uri="{FF2B5EF4-FFF2-40B4-BE49-F238E27FC236}">
                    <a16:creationId xmlns:a16="http://schemas.microsoft.com/office/drawing/2014/main" id="{0D6A989B-A768-26F4-445F-37ED4613F2D7}"/>
                  </a:ext>
                </a:extLst>
              </p:cNvPr>
              <p:cNvCxnSpPr>
                <a:cxnSpLocks/>
              </p:cNvCxnSpPr>
              <p:nvPr/>
            </p:nvCxnSpPr>
            <p:spPr>
              <a:xfrm>
                <a:off x="5338188" y="4296461"/>
                <a:ext cx="0" cy="3069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直線コネクタ 8">
                <a:extLst>
                  <a:ext uri="{FF2B5EF4-FFF2-40B4-BE49-F238E27FC236}">
                    <a16:creationId xmlns:a16="http://schemas.microsoft.com/office/drawing/2014/main" id="{AB0E386A-77F7-20AC-9758-25475937BDAE}"/>
                  </a:ext>
                </a:extLst>
              </p:cNvPr>
              <p:cNvCxnSpPr>
                <a:cxnSpLocks/>
              </p:cNvCxnSpPr>
              <p:nvPr/>
            </p:nvCxnSpPr>
            <p:spPr>
              <a:xfrm>
                <a:off x="4619833" y="4296461"/>
                <a:ext cx="0" cy="3069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1FE01106-B25F-8B3C-15B7-28897A89D251}"/>
                  </a:ext>
                </a:extLst>
              </p:cNvPr>
              <p:cNvCxnSpPr>
                <a:cxnSpLocks/>
              </p:cNvCxnSpPr>
              <p:nvPr/>
            </p:nvCxnSpPr>
            <p:spPr>
              <a:xfrm>
                <a:off x="4859285" y="4296461"/>
                <a:ext cx="0" cy="3069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線コネクタ 10">
                <a:extLst>
                  <a:ext uri="{FF2B5EF4-FFF2-40B4-BE49-F238E27FC236}">
                    <a16:creationId xmlns:a16="http://schemas.microsoft.com/office/drawing/2014/main" id="{1EB20DE5-6DA3-668E-4C5F-534698CA30CC}"/>
                  </a:ext>
                </a:extLst>
              </p:cNvPr>
              <p:cNvCxnSpPr>
                <a:cxnSpLocks/>
              </p:cNvCxnSpPr>
              <p:nvPr/>
            </p:nvCxnSpPr>
            <p:spPr>
              <a:xfrm>
                <a:off x="5098737" y="4296461"/>
                <a:ext cx="0" cy="3069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a:extLst>
                  <a:ext uri="{FF2B5EF4-FFF2-40B4-BE49-F238E27FC236}">
                    <a16:creationId xmlns:a16="http://schemas.microsoft.com/office/drawing/2014/main" id="{138A4472-B7BA-A881-AC3E-AF6D65DB6FA3}"/>
                  </a:ext>
                </a:extLst>
              </p:cNvPr>
              <p:cNvSpPr txBox="1"/>
              <p:nvPr/>
            </p:nvSpPr>
            <p:spPr>
              <a:xfrm>
                <a:off x="5152191" y="4163577"/>
                <a:ext cx="327333" cy="169277"/>
              </a:xfrm>
              <a:prstGeom prst="rect">
                <a:avLst/>
              </a:prstGeom>
              <a:noFill/>
            </p:spPr>
            <p:txBody>
              <a:bodyPr wrap="none" rtlCol="0">
                <a:spAutoFit/>
              </a:bodyPr>
              <a:lstStyle/>
              <a:p>
                <a:pPr algn="ctr"/>
                <a:r>
                  <a:rPr kumimoji="1" lang="en-US" altLang="ja-JP" sz="500" dirty="0">
                    <a:latin typeface="Arial" panose="020B0604020202020204" pitchFamily="34" charset="0"/>
                    <a:cs typeface="Arial" panose="020B0604020202020204" pitchFamily="34" charset="0"/>
                  </a:rPr>
                  <a:t>&gt;300</a:t>
                </a:r>
                <a:endParaRPr kumimoji="1" lang="ja-JP" altLang="en-US" sz="5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3CA1203F-814F-76C5-E0DF-AF1072887940}"/>
                  </a:ext>
                </a:extLst>
              </p:cNvPr>
              <p:cNvSpPr txBox="1"/>
              <p:nvPr/>
            </p:nvSpPr>
            <p:spPr>
              <a:xfrm>
                <a:off x="4510557" y="4163577"/>
                <a:ext cx="219932" cy="169277"/>
              </a:xfrm>
              <a:prstGeom prst="rect">
                <a:avLst/>
              </a:prstGeom>
              <a:noFill/>
            </p:spPr>
            <p:txBody>
              <a:bodyPr wrap="none" rtlCol="0">
                <a:spAutoFit/>
              </a:bodyPr>
              <a:lstStyle/>
              <a:p>
                <a:pPr algn="ctr"/>
                <a:r>
                  <a:rPr lang="en-US" altLang="ja-JP" sz="500" dirty="0">
                    <a:latin typeface="Arial" panose="020B0604020202020204" pitchFamily="34" charset="0"/>
                    <a:cs typeface="Arial" panose="020B0604020202020204" pitchFamily="34" charset="0"/>
                  </a:rPr>
                  <a:t>0</a:t>
                </a:r>
                <a:endParaRPr kumimoji="1" lang="ja-JP" altLang="en-US" sz="5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0E2923FF-3F20-D7D6-5932-CF982BF9783F}"/>
                  </a:ext>
                </a:extLst>
              </p:cNvPr>
              <p:cNvSpPr txBox="1"/>
              <p:nvPr/>
            </p:nvSpPr>
            <p:spPr>
              <a:xfrm>
                <a:off x="4715508" y="4163577"/>
                <a:ext cx="290464" cy="169277"/>
              </a:xfrm>
              <a:prstGeom prst="rect">
                <a:avLst/>
              </a:prstGeom>
              <a:noFill/>
            </p:spPr>
            <p:txBody>
              <a:bodyPr wrap="none" rtlCol="0">
                <a:spAutoFit/>
              </a:bodyPr>
              <a:lstStyle/>
              <a:p>
                <a:pPr algn="ctr"/>
                <a:r>
                  <a:rPr kumimoji="1" lang="en-US" altLang="ja-JP" sz="500" dirty="0">
                    <a:latin typeface="Arial" panose="020B0604020202020204" pitchFamily="34" charset="0"/>
                    <a:cs typeface="Arial" panose="020B0604020202020204" pitchFamily="34" charset="0"/>
                  </a:rPr>
                  <a:t>100</a:t>
                </a:r>
                <a:endParaRPr kumimoji="1" lang="ja-JP" altLang="en-US" sz="5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FA2E4E23-C08F-1794-8F98-5EF0D26F9C04}"/>
                  </a:ext>
                </a:extLst>
              </p:cNvPr>
              <p:cNvSpPr txBox="1"/>
              <p:nvPr/>
            </p:nvSpPr>
            <p:spPr>
              <a:xfrm>
                <a:off x="4952900" y="4163577"/>
                <a:ext cx="290464" cy="169277"/>
              </a:xfrm>
              <a:prstGeom prst="rect">
                <a:avLst/>
              </a:prstGeom>
              <a:noFill/>
            </p:spPr>
            <p:txBody>
              <a:bodyPr wrap="none" rtlCol="0">
                <a:spAutoFit/>
              </a:bodyPr>
              <a:lstStyle/>
              <a:p>
                <a:pPr algn="ctr"/>
                <a:r>
                  <a:rPr lang="en-US" altLang="ja-JP" sz="500" dirty="0">
                    <a:latin typeface="Arial" panose="020B0604020202020204" pitchFamily="34" charset="0"/>
                    <a:cs typeface="Arial" panose="020B0604020202020204" pitchFamily="34" charset="0"/>
                  </a:rPr>
                  <a:t>200</a:t>
                </a:r>
                <a:endParaRPr kumimoji="1" lang="ja-JP" altLang="en-US" sz="500" dirty="0">
                  <a:latin typeface="Arial" panose="020B0604020202020204" pitchFamily="34" charset="0"/>
                  <a:cs typeface="Arial" panose="020B0604020202020204" pitchFamily="34" charset="0"/>
                </a:endParaRPr>
              </a:p>
            </p:txBody>
          </p:sp>
          <p:grpSp>
            <p:nvGrpSpPr>
              <p:cNvPr id="17" name="グループ化 16">
                <a:extLst>
                  <a:ext uri="{FF2B5EF4-FFF2-40B4-BE49-F238E27FC236}">
                    <a16:creationId xmlns:a16="http://schemas.microsoft.com/office/drawing/2014/main" id="{634EE47D-7CBB-9EBC-D520-C744FDC8C926}"/>
                  </a:ext>
                </a:extLst>
              </p:cNvPr>
              <p:cNvGrpSpPr/>
              <p:nvPr/>
            </p:nvGrpSpPr>
            <p:grpSpPr>
              <a:xfrm>
                <a:off x="4619833" y="4322689"/>
                <a:ext cx="722162" cy="55592"/>
                <a:chOff x="4608726" y="4364328"/>
                <a:chExt cx="722162" cy="55592"/>
              </a:xfrm>
            </p:grpSpPr>
            <p:pic>
              <p:nvPicPr>
                <p:cNvPr id="18" name="図 17">
                  <a:extLst>
                    <a:ext uri="{FF2B5EF4-FFF2-40B4-BE49-F238E27FC236}">
                      <a16:creationId xmlns:a16="http://schemas.microsoft.com/office/drawing/2014/main" id="{F23C10FA-FFE9-B9F2-ABD5-501B450FB385}"/>
                    </a:ext>
                  </a:extLst>
                </p:cNvPr>
                <p:cNvPicPr>
                  <a:picLocks noChangeAspect="1"/>
                </p:cNvPicPr>
                <p:nvPr/>
              </p:nvPicPr>
              <p:blipFill>
                <a:blip r:embed="rId3"/>
                <a:stretch>
                  <a:fillRect/>
                </a:stretch>
              </p:blipFill>
              <p:spPr>
                <a:xfrm>
                  <a:off x="4610888" y="4366016"/>
                  <a:ext cx="720000" cy="53904"/>
                </a:xfrm>
                <a:prstGeom prst="rect">
                  <a:avLst/>
                </a:prstGeom>
              </p:spPr>
            </p:pic>
            <p:sp>
              <p:nvSpPr>
                <p:cNvPr id="19" name="正方形/長方形 18">
                  <a:extLst>
                    <a:ext uri="{FF2B5EF4-FFF2-40B4-BE49-F238E27FC236}">
                      <a16:creationId xmlns:a16="http://schemas.microsoft.com/office/drawing/2014/main" id="{5D1B80E5-0789-5ECD-5A69-CD79DC202DE1}"/>
                    </a:ext>
                  </a:extLst>
                </p:cNvPr>
                <p:cNvSpPr/>
                <p:nvPr/>
              </p:nvSpPr>
              <p:spPr>
                <a:xfrm>
                  <a:off x="4608726" y="4364328"/>
                  <a:ext cx="720000" cy="48359"/>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grpSp>
          <p:nvGrpSpPr>
            <p:cNvPr id="20" name="グループ化 19">
              <a:extLst>
                <a:ext uri="{FF2B5EF4-FFF2-40B4-BE49-F238E27FC236}">
                  <a16:creationId xmlns:a16="http://schemas.microsoft.com/office/drawing/2014/main" id="{9CDEA6CB-2269-AE4E-4650-0D5D98C1F29D}"/>
                </a:ext>
              </a:extLst>
            </p:cNvPr>
            <p:cNvGrpSpPr/>
            <p:nvPr/>
          </p:nvGrpSpPr>
          <p:grpSpPr>
            <a:xfrm>
              <a:off x="1811956" y="2001357"/>
              <a:ext cx="3871355" cy="275566"/>
              <a:chOff x="1710275" y="2234009"/>
              <a:chExt cx="3871355" cy="275566"/>
            </a:xfrm>
          </p:grpSpPr>
          <p:sp>
            <p:nvSpPr>
              <p:cNvPr id="21" name="テキスト ボックス 20">
                <a:extLst>
                  <a:ext uri="{FF2B5EF4-FFF2-40B4-BE49-F238E27FC236}">
                    <a16:creationId xmlns:a16="http://schemas.microsoft.com/office/drawing/2014/main" id="{12FC0A85-CFC0-BFC6-C773-83676C09F327}"/>
                  </a:ext>
                </a:extLst>
              </p:cNvPr>
              <p:cNvSpPr txBox="1"/>
              <p:nvPr/>
            </p:nvSpPr>
            <p:spPr>
              <a:xfrm>
                <a:off x="5186923" y="2234009"/>
                <a:ext cx="394707" cy="268535"/>
              </a:xfrm>
              <a:prstGeom prst="rect">
                <a:avLst/>
              </a:prstGeom>
              <a:noFill/>
            </p:spPr>
            <p:txBody>
              <a:bodyPr wrap="square" rtlCol="0" anchor="ctr">
                <a:spAutoFit/>
              </a:bodyPr>
              <a:lstStyle/>
              <a:p>
                <a:pPr algn="ctr">
                  <a:lnSpc>
                    <a:spcPct val="120000"/>
                  </a:lnSpc>
                </a:pPr>
                <a:r>
                  <a:rPr kumimoji="1" lang="en-US" altLang="ja-JP" sz="500" dirty="0">
                    <a:latin typeface="Arial" panose="020B0604020202020204" pitchFamily="34" charset="0"/>
                    <a:cs typeface="Arial" panose="020B0604020202020204" pitchFamily="34" charset="0"/>
                  </a:rPr>
                  <a:t>ABA</a:t>
                </a:r>
                <a:br>
                  <a:rPr lang="en-US" altLang="ja-JP" sz="500" dirty="0">
                    <a:latin typeface="Arial" panose="020B0604020202020204" pitchFamily="34" charset="0"/>
                    <a:cs typeface="Arial" panose="020B0604020202020204" pitchFamily="34" charset="0"/>
                  </a:rPr>
                </a:br>
                <a:r>
                  <a:rPr kumimoji="1" lang="en-US" altLang="ja-JP" sz="500" dirty="0">
                    <a:latin typeface="Arial" panose="020B0604020202020204" pitchFamily="34" charset="0"/>
                    <a:cs typeface="Arial" panose="020B0604020202020204" pitchFamily="34" charset="0"/>
                  </a:rPr>
                  <a:t>(min)</a:t>
                </a:r>
                <a:endParaRPr kumimoji="1" lang="ja-JP" altLang="en-US" sz="500" dirty="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2D42CCE5-5751-34B7-FD07-72AD314D80A5}"/>
                  </a:ext>
                </a:extLst>
              </p:cNvPr>
              <p:cNvSpPr txBox="1"/>
              <p:nvPr/>
            </p:nvSpPr>
            <p:spPr>
              <a:xfrm>
                <a:off x="1710275" y="2324909"/>
                <a:ext cx="227948" cy="184666"/>
              </a:xfrm>
              <a:prstGeom prst="rect">
                <a:avLst/>
              </a:prstGeom>
              <a:noFill/>
            </p:spPr>
            <p:txBody>
              <a:bodyPr wrap="none" rtlCol="0">
                <a:spAutoFit/>
              </a:bodyPr>
              <a:lstStyle/>
              <a:p>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BF10AD4A-A8D5-C0F9-BB44-D06FD9229364}"/>
                  </a:ext>
                </a:extLst>
              </p:cNvPr>
              <p:cNvSpPr txBox="1"/>
              <p:nvPr/>
            </p:nvSpPr>
            <p:spPr>
              <a:xfrm>
                <a:off x="1987995"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15</a:t>
                </a:r>
                <a:endParaRPr kumimoji="1" lang="ja-JP" altLang="en-US" sz="600"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8EDAFDCD-2208-DF0E-EF89-AF861F4D7D03}"/>
                  </a:ext>
                </a:extLst>
              </p:cNvPr>
              <p:cNvSpPr txBox="1"/>
              <p:nvPr/>
            </p:nvSpPr>
            <p:spPr>
              <a:xfrm>
                <a:off x="2285091"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30</a:t>
                </a:r>
                <a:endParaRPr kumimoji="1" lang="ja-JP" altLang="en-US" sz="600"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34762FB2-5DF6-C52B-718E-E4454BE8BB13}"/>
                  </a:ext>
                </a:extLst>
              </p:cNvPr>
              <p:cNvSpPr txBox="1"/>
              <p:nvPr/>
            </p:nvSpPr>
            <p:spPr>
              <a:xfrm>
                <a:off x="2582187"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90</a:t>
                </a:r>
              </a:p>
            </p:txBody>
          </p:sp>
          <p:sp>
            <p:nvSpPr>
              <p:cNvPr id="26" name="テキスト ボックス 25">
                <a:extLst>
                  <a:ext uri="{FF2B5EF4-FFF2-40B4-BE49-F238E27FC236}">
                    <a16:creationId xmlns:a16="http://schemas.microsoft.com/office/drawing/2014/main" id="{CF5B29F3-D92D-24DA-A576-6B3A619C1EC1}"/>
                  </a:ext>
                </a:extLst>
              </p:cNvPr>
              <p:cNvSpPr txBox="1"/>
              <p:nvPr/>
            </p:nvSpPr>
            <p:spPr>
              <a:xfrm>
                <a:off x="2909163" y="2324909"/>
                <a:ext cx="227948" cy="184666"/>
              </a:xfrm>
              <a:prstGeom prst="rect">
                <a:avLst/>
              </a:prstGeom>
              <a:noFill/>
            </p:spPr>
            <p:txBody>
              <a:bodyPr wrap="none" rtlCol="0">
                <a:spAutoFit/>
              </a:bodyPr>
              <a:lstStyle/>
              <a:p>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4E20AC2A-9C0E-892D-FD26-62FE4DFC3C91}"/>
                  </a:ext>
                </a:extLst>
              </p:cNvPr>
              <p:cNvSpPr txBox="1"/>
              <p:nvPr/>
            </p:nvSpPr>
            <p:spPr>
              <a:xfrm>
                <a:off x="3180907"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15</a:t>
                </a:r>
                <a:endParaRPr kumimoji="1" lang="ja-JP" altLang="en-US" sz="600"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3B44C25E-7E6D-68B9-A54D-4B05776E08AE}"/>
                  </a:ext>
                </a:extLst>
              </p:cNvPr>
              <p:cNvSpPr txBox="1"/>
              <p:nvPr/>
            </p:nvSpPr>
            <p:spPr>
              <a:xfrm>
                <a:off x="3489955"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30</a:t>
                </a:r>
                <a:endParaRPr kumimoji="1" lang="ja-JP" altLang="en-US" sz="600"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E4A83139-F444-C7E8-BE32-AB36187DA1D4}"/>
                  </a:ext>
                </a:extLst>
              </p:cNvPr>
              <p:cNvSpPr txBox="1"/>
              <p:nvPr/>
            </p:nvSpPr>
            <p:spPr>
              <a:xfrm>
                <a:off x="3787051"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90</a:t>
                </a:r>
              </a:p>
            </p:txBody>
          </p:sp>
          <p:sp>
            <p:nvSpPr>
              <p:cNvPr id="30" name="テキスト ボックス 29">
                <a:extLst>
                  <a:ext uri="{FF2B5EF4-FFF2-40B4-BE49-F238E27FC236}">
                    <a16:creationId xmlns:a16="http://schemas.microsoft.com/office/drawing/2014/main" id="{76B0680F-66D6-AC41-ACBA-E7FE5D2C38EE}"/>
                  </a:ext>
                </a:extLst>
              </p:cNvPr>
              <p:cNvSpPr txBox="1"/>
              <p:nvPr/>
            </p:nvSpPr>
            <p:spPr>
              <a:xfrm>
                <a:off x="4096099" y="2324909"/>
                <a:ext cx="227948" cy="184666"/>
              </a:xfrm>
              <a:prstGeom prst="rect">
                <a:avLst/>
              </a:prstGeom>
              <a:noFill/>
            </p:spPr>
            <p:txBody>
              <a:bodyPr wrap="none" rtlCol="0">
                <a:spAutoFit/>
              </a:bodyPr>
              <a:lstStyle/>
              <a:p>
                <a:r>
                  <a:rPr kumimoji="1" lang="en-US" altLang="ja-JP" sz="600" dirty="0">
                    <a:latin typeface="Arial" panose="020B0604020202020204" pitchFamily="34" charset="0"/>
                    <a:cs typeface="Arial" panose="020B0604020202020204" pitchFamily="34" charset="0"/>
                  </a:rPr>
                  <a:t>0</a:t>
                </a:r>
                <a:endParaRPr kumimoji="1" lang="ja-JP" altLang="en-US" sz="600" dirty="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A50E0076-6A8C-DA57-3E67-4EB00F6189B2}"/>
                  </a:ext>
                </a:extLst>
              </p:cNvPr>
              <p:cNvSpPr txBox="1"/>
              <p:nvPr/>
            </p:nvSpPr>
            <p:spPr>
              <a:xfrm>
                <a:off x="4373819"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15</a:t>
                </a:r>
                <a:endParaRPr kumimoji="1" lang="ja-JP" altLang="en-US" sz="600"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322AE361-932C-3025-6F92-7235D02367D6}"/>
                  </a:ext>
                </a:extLst>
              </p:cNvPr>
              <p:cNvSpPr txBox="1"/>
              <p:nvPr/>
            </p:nvSpPr>
            <p:spPr>
              <a:xfrm>
                <a:off x="4682867"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30</a:t>
                </a:r>
                <a:endParaRPr kumimoji="1" lang="ja-JP" altLang="en-US" sz="600"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341BF7C0-214F-3050-1AB9-BAAE7086F660}"/>
                  </a:ext>
                </a:extLst>
              </p:cNvPr>
              <p:cNvSpPr txBox="1"/>
              <p:nvPr/>
            </p:nvSpPr>
            <p:spPr>
              <a:xfrm>
                <a:off x="4979963" y="2324909"/>
                <a:ext cx="271228" cy="184666"/>
              </a:xfrm>
              <a:prstGeom prst="rect">
                <a:avLst/>
              </a:prstGeom>
              <a:noFill/>
            </p:spPr>
            <p:txBody>
              <a:bodyPr wrap="none" rtlCol="0">
                <a:spAutoFit/>
              </a:bodyPr>
              <a:lstStyle/>
              <a:p>
                <a:r>
                  <a:rPr lang="en-US" altLang="ja-JP" sz="600" dirty="0">
                    <a:latin typeface="Arial" panose="020B0604020202020204" pitchFamily="34" charset="0"/>
                    <a:cs typeface="Arial" panose="020B0604020202020204" pitchFamily="34" charset="0"/>
                  </a:rPr>
                  <a:t>90</a:t>
                </a:r>
              </a:p>
            </p:txBody>
          </p:sp>
        </p:grpSp>
        <p:grpSp>
          <p:nvGrpSpPr>
            <p:cNvPr id="38" name="グループ化 37">
              <a:extLst>
                <a:ext uri="{FF2B5EF4-FFF2-40B4-BE49-F238E27FC236}">
                  <a16:creationId xmlns:a16="http://schemas.microsoft.com/office/drawing/2014/main" id="{517D90B3-66DE-5CFA-76D0-364167F6E03E}"/>
                </a:ext>
              </a:extLst>
            </p:cNvPr>
            <p:cNvGrpSpPr/>
            <p:nvPr/>
          </p:nvGrpSpPr>
          <p:grpSpPr>
            <a:xfrm>
              <a:off x="1885228" y="1884519"/>
              <a:ext cx="975255" cy="184666"/>
              <a:chOff x="1771595" y="2117171"/>
              <a:chExt cx="975255" cy="184666"/>
            </a:xfrm>
          </p:grpSpPr>
          <p:sp>
            <p:nvSpPr>
              <p:cNvPr id="39" name="テキスト ボックス 38">
                <a:extLst>
                  <a:ext uri="{FF2B5EF4-FFF2-40B4-BE49-F238E27FC236}">
                    <a16:creationId xmlns:a16="http://schemas.microsoft.com/office/drawing/2014/main" id="{75BDF092-A2FB-DA79-85C3-ACD372365888}"/>
                  </a:ext>
                </a:extLst>
              </p:cNvPr>
              <p:cNvSpPr txBox="1"/>
              <p:nvPr/>
            </p:nvSpPr>
            <p:spPr>
              <a:xfrm>
                <a:off x="1966562" y="2117171"/>
                <a:ext cx="585321" cy="184666"/>
              </a:xfrm>
              <a:prstGeom prst="rect">
                <a:avLst/>
              </a:prstGeom>
              <a:noFill/>
            </p:spPr>
            <p:txBody>
              <a:bodyPr wrap="square" rtlCol="0" anchor="ctr">
                <a:spAutoFit/>
              </a:bodyPr>
              <a:lstStyle/>
              <a:p>
                <a:pPr algn="ctr"/>
                <a:r>
                  <a:rPr kumimoji="1" lang="en-US" altLang="ja-JP" sz="600" dirty="0">
                    <a:latin typeface="Arial" panose="020B0604020202020204" pitchFamily="34" charset="0"/>
                    <a:cs typeface="Arial" panose="020B0604020202020204" pitchFamily="34" charset="0"/>
                  </a:rPr>
                  <a:t>Col-0</a:t>
                </a:r>
                <a:endParaRPr kumimoji="1" lang="ja-JP" altLang="en-US" sz="600" dirty="0">
                  <a:latin typeface="Arial" panose="020B0604020202020204" pitchFamily="34" charset="0"/>
                  <a:cs typeface="Arial" panose="020B0604020202020204" pitchFamily="34" charset="0"/>
                </a:endParaRPr>
              </a:p>
            </p:txBody>
          </p:sp>
          <p:cxnSp>
            <p:nvCxnSpPr>
              <p:cNvPr id="40" name="直線コネクタ 39">
                <a:extLst>
                  <a:ext uri="{FF2B5EF4-FFF2-40B4-BE49-F238E27FC236}">
                    <a16:creationId xmlns:a16="http://schemas.microsoft.com/office/drawing/2014/main" id="{9C95B6CB-4C98-BD1C-DF03-1D4034CB1DD6}"/>
                  </a:ext>
                </a:extLst>
              </p:cNvPr>
              <p:cNvCxnSpPr>
                <a:cxnSpLocks/>
              </p:cNvCxnSpPr>
              <p:nvPr/>
            </p:nvCxnSpPr>
            <p:spPr>
              <a:xfrm>
                <a:off x="1771595" y="2296653"/>
                <a:ext cx="975255"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41" name="グループ化 40">
              <a:extLst>
                <a:ext uri="{FF2B5EF4-FFF2-40B4-BE49-F238E27FC236}">
                  <a16:creationId xmlns:a16="http://schemas.microsoft.com/office/drawing/2014/main" id="{6D72A340-1693-CD05-2CA4-1FF9E47CE0DF}"/>
                </a:ext>
              </a:extLst>
            </p:cNvPr>
            <p:cNvGrpSpPr/>
            <p:nvPr/>
          </p:nvGrpSpPr>
          <p:grpSpPr>
            <a:xfrm>
              <a:off x="3081128" y="1884519"/>
              <a:ext cx="975255" cy="184666"/>
              <a:chOff x="2979428" y="2117171"/>
              <a:chExt cx="975255" cy="184666"/>
            </a:xfrm>
          </p:grpSpPr>
          <p:sp>
            <p:nvSpPr>
              <p:cNvPr id="42" name="テキスト ボックス 41">
                <a:extLst>
                  <a:ext uri="{FF2B5EF4-FFF2-40B4-BE49-F238E27FC236}">
                    <a16:creationId xmlns:a16="http://schemas.microsoft.com/office/drawing/2014/main" id="{27DC08D8-4918-6523-1F99-DC4854CC39C8}"/>
                  </a:ext>
                </a:extLst>
              </p:cNvPr>
              <p:cNvSpPr txBox="1"/>
              <p:nvPr/>
            </p:nvSpPr>
            <p:spPr>
              <a:xfrm>
                <a:off x="3156234" y="2117171"/>
                <a:ext cx="621642" cy="184666"/>
              </a:xfrm>
              <a:prstGeom prst="rect">
                <a:avLst/>
              </a:prstGeom>
              <a:noFill/>
            </p:spPr>
            <p:txBody>
              <a:bodyPr wrap="square" rtlCol="0" anchor="ctr">
                <a:spAutoFit/>
              </a:bodyPr>
              <a:lstStyle/>
              <a:p>
                <a:pPr algn="ctr"/>
                <a:r>
                  <a:rPr kumimoji="1" lang="en-US" altLang="ja-JP" sz="600" i="1" dirty="0">
                    <a:latin typeface="Arial" panose="020B0604020202020204" pitchFamily="34" charset="0"/>
                    <a:cs typeface="Arial" panose="020B0604020202020204" pitchFamily="34" charset="0"/>
                  </a:rPr>
                  <a:t>srk2dei</a:t>
                </a:r>
                <a:endParaRPr kumimoji="1" lang="ja-JP" altLang="en-US" sz="600" dirty="0">
                  <a:latin typeface="Arial" panose="020B0604020202020204" pitchFamily="34" charset="0"/>
                  <a:cs typeface="Arial" panose="020B0604020202020204" pitchFamily="34" charset="0"/>
                </a:endParaRPr>
              </a:p>
            </p:txBody>
          </p:sp>
          <p:cxnSp>
            <p:nvCxnSpPr>
              <p:cNvPr id="43" name="直線コネクタ 42">
                <a:extLst>
                  <a:ext uri="{FF2B5EF4-FFF2-40B4-BE49-F238E27FC236}">
                    <a16:creationId xmlns:a16="http://schemas.microsoft.com/office/drawing/2014/main" id="{78A998B9-40D1-FEBF-3A0F-B539522BC65F}"/>
                  </a:ext>
                </a:extLst>
              </p:cNvPr>
              <p:cNvCxnSpPr>
                <a:cxnSpLocks/>
              </p:cNvCxnSpPr>
              <p:nvPr/>
            </p:nvCxnSpPr>
            <p:spPr>
              <a:xfrm>
                <a:off x="2979428" y="2296653"/>
                <a:ext cx="975255"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44" name="グループ化 43">
              <a:extLst>
                <a:ext uri="{FF2B5EF4-FFF2-40B4-BE49-F238E27FC236}">
                  <a16:creationId xmlns:a16="http://schemas.microsoft.com/office/drawing/2014/main" id="{9802F568-3A86-7C8E-7B0E-552C11A020A8}"/>
                </a:ext>
              </a:extLst>
            </p:cNvPr>
            <p:cNvGrpSpPr/>
            <p:nvPr/>
          </p:nvGrpSpPr>
          <p:grpSpPr>
            <a:xfrm>
              <a:off x="4277028" y="1884519"/>
              <a:ext cx="975255" cy="184666"/>
              <a:chOff x="4157419" y="2117171"/>
              <a:chExt cx="975255" cy="184666"/>
            </a:xfrm>
          </p:grpSpPr>
          <p:sp>
            <p:nvSpPr>
              <p:cNvPr id="45" name="テキスト ボックス 44">
                <a:extLst>
                  <a:ext uri="{FF2B5EF4-FFF2-40B4-BE49-F238E27FC236}">
                    <a16:creationId xmlns:a16="http://schemas.microsoft.com/office/drawing/2014/main" id="{B26C600C-72B0-6EEE-CDEE-E105D8C98FB5}"/>
                  </a:ext>
                </a:extLst>
              </p:cNvPr>
              <p:cNvSpPr txBox="1"/>
              <p:nvPr/>
            </p:nvSpPr>
            <p:spPr>
              <a:xfrm>
                <a:off x="4337132" y="2117171"/>
                <a:ext cx="615828" cy="184666"/>
              </a:xfrm>
              <a:prstGeom prst="rect">
                <a:avLst/>
              </a:prstGeom>
              <a:noFill/>
            </p:spPr>
            <p:txBody>
              <a:bodyPr wrap="square" rtlCol="0" anchor="ctr">
                <a:spAutoFit/>
              </a:bodyPr>
              <a:lstStyle/>
              <a:p>
                <a:pPr algn="ctr"/>
                <a:r>
                  <a:rPr kumimoji="1" lang="en-US" altLang="ja-JP" sz="600" i="1" dirty="0">
                    <a:latin typeface="Arial" panose="020B0604020202020204" pitchFamily="34" charset="0"/>
                    <a:cs typeface="Arial" panose="020B0604020202020204" pitchFamily="34" charset="0"/>
                  </a:rPr>
                  <a:t>abi1-1C</a:t>
                </a:r>
                <a:endParaRPr kumimoji="1" lang="ja-JP" altLang="en-US" sz="600" dirty="0">
                  <a:latin typeface="Arial" panose="020B0604020202020204" pitchFamily="34" charset="0"/>
                  <a:cs typeface="Arial" panose="020B0604020202020204" pitchFamily="34" charset="0"/>
                </a:endParaRPr>
              </a:p>
            </p:txBody>
          </p:sp>
          <p:cxnSp>
            <p:nvCxnSpPr>
              <p:cNvPr id="46" name="直線コネクタ 45">
                <a:extLst>
                  <a:ext uri="{FF2B5EF4-FFF2-40B4-BE49-F238E27FC236}">
                    <a16:creationId xmlns:a16="http://schemas.microsoft.com/office/drawing/2014/main" id="{F6FAD5EF-1D9E-42AB-CAB2-FCB58BA4F236}"/>
                  </a:ext>
                </a:extLst>
              </p:cNvPr>
              <p:cNvCxnSpPr>
                <a:cxnSpLocks/>
              </p:cNvCxnSpPr>
              <p:nvPr/>
            </p:nvCxnSpPr>
            <p:spPr>
              <a:xfrm>
                <a:off x="4157419" y="2296653"/>
                <a:ext cx="975255" cy="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sp>
          <p:nvSpPr>
            <p:cNvPr id="60" name="テキスト ボックス 59">
              <a:extLst>
                <a:ext uri="{FF2B5EF4-FFF2-40B4-BE49-F238E27FC236}">
                  <a16:creationId xmlns:a16="http://schemas.microsoft.com/office/drawing/2014/main" id="{39519996-CF4C-9175-D13E-96CB48176FC8}"/>
                </a:ext>
              </a:extLst>
            </p:cNvPr>
            <p:cNvSpPr txBox="1"/>
            <p:nvPr/>
          </p:nvSpPr>
          <p:spPr>
            <a:xfrm>
              <a:off x="1276396" y="2536011"/>
              <a:ext cx="551754" cy="184666"/>
            </a:xfrm>
            <a:prstGeom prst="rect">
              <a:avLst/>
            </a:prstGeom>
            <a:noFill/>
          </p:spPr>
          <p:txBody>
            <a:bodyPr wrap="none" rtlCol="0" anchor="ctr">
              <a:spAutoFit/>
            </a:bodyPr>
            <a:lstStyle/>
            <a:p>
              <a:pPr algn="r"/>
              <a:r>
                <a:rPr lang="en-US" altLang="ja-JP" sz="600" dirty="0">
                  <a:latin typeface="Arial" panose="020B0604020202020204" pitchFamily="34" charset="0"/>
                  <a:cs typeface="Arial" panose="020B0604020202020204" pitchFamily="34" charset="0"/>
                </a:rPr>
                <a:t>VCS</a:t>
              </a:r>
              <a:r>
                <a:rPr kumimoji="1" lang="en-US" altLang="ja-JP" sz="500" dirty="0">
                  <a:latin typeface="Arial" panose="020B0604020202020204" pitchFamily="34" charset="0"/>
                  <a:cs typeface="Arial" panose="020B0604020202020204" pitchFamily="34" charset="0"/>
                </a:rPr>
                <a:t> (</a:t>
              </a:r>
              <a:r>
                <a:rPr lang="en-US" altLang="ja-JP" sz="500" dirty="0">
                  <a:latin typeface="Arial" panose="020B0604020202020204" pitchFamily="34" charset="0"/>
                  <a:cs typeface="Arial" panose="020B0604020202020204" pitchFamily="34" charset="0"/>
                </a:rPr>
                <a:t>S736</a:t>
              </a:r>
              <a:r>
                <a:rPr kumimoji="1" lang="en-US" altLang="ja-JP" sz="500" dirty="0">
                  <a:latin typeface="Arial" panose="020B0604020202020204" pitchFamily="34" charset="0"/>
                  <a:cs typeface="Arial" panose="020B0604020202020204" pitchFamily="34" charset="0"/>
                </a:rPr>
                <a:t>)</a:t>
              </a:r>
              <a:endParaRPr kumimoji="1" lang="ja-JP" altLang="en-US" sz="500" dirty="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83BB759C-7360-7E22-0B42-831E90A6E548}"/>
                </a:ext>
              </a:extLst>
            </p:cNvPr>
            <p:cNvSpPr txBox="1"/>
            <p:nvPr/>
          </p:nvSpPr>
          <p:spPr>
            <a:xfrm>
              <a:off x="1186628" y="2232203"/>
              <a:ext cx="641522" cy="184666"/>
            </a:xfrm>
            <a:prstGeom prst="rect">
              <a:avLst/>
            </a:prstGeom>
            <a:noFill/>
          </p:spPr>
          <p:txBody>
            <a:bodyPr wrap="none" rtlCol="0" anchor="ctr">
              <a:spAutoFit/>
            </a:bodyPr>
            <a:lstStyle/>
            <a:p>
              <a:pPr algn="r"/>
              <a:r>
                <a:rPr kumimoji="1" lang="en-US" altLang="ja-JP" sz="600" dirty="0">
                  <a:latin typeface="Arial" panose="020B0604020202020204" pitchFamily="34" charset="0"/>
                  <a:cs typeface="Arial" panose="020B0604020202020204" pitchFamily="34" charset="0"/>
                </a:rPr>
                <a:t>AREB3</a:t>
              </a:r>
              <a:r>
                <a:rPr kumimoji="1" lang="en-US" altLang="ja-JP" sz="500" dirty="0">
                  <a:latin typeface="Arial" panose="020B0604020202020204" pitchFamily="34" charset="0"/>
                  <a:cs typeface="Arial" panose="020B0604020202020204" pitchFamily="34" charset="0"/>
                </a:rPr>
                <a:t> (T118)</a:t>
              </a:r>
              <a:endParaRPr kumimoji="1" lang="ja-JP" altLang="en-US" sz="500" dirty="0">
                <a:latin typeface="Arial" panose="020B0604020202020204" pitchFamily="34" charset="0"/>
                <a:cs typeface="Arial" panose="020B0604020202020204" pitchFamily="34" charset="0"/>
              </a:endParaRPr>
            </a:p>
          </p:txBody>
        </p:sp>
        <p:sp>
          <p:nvSpPr>
            <p:cNvPr id="62" name="テキスト ボックス 61">
              <a:extLst>
                <a:ext uri="{FF2B5EF4-FFF2-40B4-BE49-F238E27FC236}">
                  <a16:creationId xmlns:a16="http://schemas.microsoft.com/office/drawing/2014/main" id="{A6CF330D-D875-6C7A-9DC2-2FA04142F175}"/>
                </a:ext>
              </a:extLst>
            </p:cNvPr>
            <p:cNvSpPr txBox="1"/>
            <p:nvPr/>
          </p:nvSpPr>
          <p:spPr>
            <a:xfrm>
              <a:off x="1433490" y="2384107"/>
              <a:ext cx="394660" cy="184666"/>
            </a:xfrm>
            <a:prstGeom prst="rect">
              <a:avLst/>
            </a:prstGeom>
            <a:noFill/>
          </p:spPr>
          <p:txBody>
            <a:bodyPr wrap="none" rtlCol="0" anchor="ctr">
              <a:spAutoFit/>
            </a:bodyPr>
            <a:lstStyle/>
            <a:p>
              <a:pPr algn="r"/>
              <a:r>
                <a:rPr lang="en-US" altLang="ja-JP" sz="600" dirty="0">
                  <a:latin typeface="Arial" panose="020B0604020202020204" pitchFamily="34" charset="0"/>
                  <a:cs typeface="Arial" panose="020B0604020202020204" pitchFamily="34" charset="0"/>
                </a:rPr>
                <a:t>MPK2</a:t>
              </a:r>
              <a:endParaRPr kumimoji="1" lang="ja-JP" altLang="en-US" sz="500" dirty="0">
                <a:latin typeface="Arial" panose="020B0604020202020204" pitchFamily="34" charset="0"/>
                <a:cs typeface="Arial" panose="020B0604020202020204" pitchFamily="34" charset="0"/>
              </a:endParaRPr>
            </a:p>
          </p:txBody>
        </p:sp>
        <p:sp>
          <p:nvSpPr>
            <p:cNvPr id="63" name="テキスト ボックス 62">
              <a:extLst>
                <a:ext uri="{FF2B5EF4-FFF2-40B4-BE49-F238E27FC236}">
                  <a16:creationId xmlns:a16="http://schemas.microsoft.com/office/drawing/2014/main" id="{77473A1C-D9DA-703D-F20A-832889B217C2}"/>
                </a:ext>
              </a:extLst>
            </p:cNvPr>
            <p:cNvSpPr txBox="1"/>
            <p:nvPr/>
          </p:nvSpPr>
          <p:spPr>
            <a:xfrm>
              <a:off x="1268380" y="2687915"/>
              <a:ext cx="559770" cy="184666"/>
            </a:xfrm>
            <a:prstGeom prst="rect">
              <a:avLst/>
            </a:prstGeom>
            <a:noFill/>
          </p:spPr>
          <p:txBody>
            <a:bodyPr wrap="none" rtlCol="0" anchor="ctr">
              <a:spAutoFit/>
            </a:bodyPr>
            <a:lstStyle/>
            <a:p>
              <a:pPr algn="r"/>
              <a:r>
                <a:rPr kumimoji="1" lang="en-US" altLang="ja-JP" sz="600" dirty="0">
                  <a:latin typeface="Arial" panose="020B0604020202020204" pitchFamily="34" charset="0"/>
                  <a:cs typeface="Arial" panose="020B0604020202020204" pitchFamily="34" charset="0"/>
                </a:rPr>
                <a:t>SNS1</a:t>
              </a:r>
              <a:r>
                <a:rPr kumimoji="1" lang="en-US" altLang="ja-JP" sz="500" dirty="0">
                  <a:latin typeface="Arial" panose="020B0604020202020204" pitchFamily="34" charset="0"/>
                  <a:cs typeface="Arial" panose="020B0604020202020204" pitchFamily="34" charset="0"/>
                </a:rPr>
                <a:t> (S43)</a:t>
              </a:r>
              <a:endParaRPr kumimoji="1" lang="ja-JP" altLang="en-US" sz="500" dirty="0">
                <a:latin typeface="Arial" panose="020B0604020202020204" pitchFamily="34" charset="0"/>
                <a:cs typeface="Arial" panose="020B0604020202020204" pitchFamily="34" charset="0"/>
              </a:endParaRPr>
            </a:p>
          </p:txBody>
        </p:sp>
        <p:sp>
          <p:nvSpPr>
            <p:cNvPr id="448" name="テキスト ボックス 447">
              <a:extLst>
                <a:ext uri="{FF2B5EF4-FFF2-40B4-BE49-F238E27FC236}">
                  <a16:creationId xmlns:a16="http://schemas.microsoft.com/office/drawing/2014/main" id="{B00CD456-DEF6-B4B5-F78C-DF1A5CC05561}"/>
                </a:ext>
              </a:extLst>
            </p:cNvPr>
            <p:cNvSpPr txBox="1"/>
            <p:nvPr/>
          </p:nvSpPr>
          <p:spPr>
            <a:xfrm>
              <a:off x="1217084" y="2839818"/>
              <a:ext cx="611066" cy="184666"/>
            </a:xfrm>
            <a:prstGeom prst="rect">
              <a:avLst/>
            </a:prstGeom>
            <a:noFill/>
          </p:spPr>
          <p:txBody>
            <a:bodyPr wrap="none" rtlCol="0" anchor="ctr">
              <a:spAutoFit/>
            </a:bodyPr>
            <a:lstStyle/>
            <a:p>
              <a:pPr algn="r"/>
              <a:r>
                <a:rPr lang="en-US" altLang="ja-JP" sz="600" dirty="0">
                  <a:latin typeface="Arial" panose="020B0604020202020204" pitchFamily="34" charset="0"/>
                  <a:cs typeface="Arial" panose="020B0604020202020204" pitchFamily="34" charset="0"/>
                </a:rPr>
                <a:t>MBD10</a:t>
              </a:r>
              <a:r>
                <a:rPr kumimoji="1" lang="en-US" altLang="ja-JP" sz="500" dirty="0">
                  <a:latin typeface="Arial" panose="020B0604020202020204" pitchFamily="34" charset="0"/>
                  <a:cs typeface="Arial" panose="020B0604020202020204" pitchFamily="34" charset="0"/>
                </a:rPr>
                <a:t> (</a:t>
              </a:r>
              <a:r>
                <a:rPr lang="en-US" altLang="ja-JP" sz="500" dirty="0">
                  <a:latin typeface="Arial" panose="020B0604020202020204" pitchFamily="34" charset="0"/>
                  <a:cs typeface="Arial" panose="020B0604020202020204" pitchFamily="34" charset="0"/>
                </a:rPr>
                <a:t>T89</a:t>
              </a:r>
              <a:r>
                <a:rPr kumimoji="1" lang="en-US" altLang="ja-JP" sz="500" dirty="0">
                  <a:latin typeface="Arial" panose="020B0604020202020204" pitchFamily="34" charset="0"/>
                  <a:cs typeface="Arial" panose="020B0604020202020204" pitchFamily="34" charset="0"/>
                </a:rPr>
                <a:t>)</a:t>
              </a:r>
              <a:endParaRPr kumimoji="1" lang="ja-JP" altLang="en-US" sz="500" dirty="0">
                <a:latin typeface="Arial" panose="020B0604020202020204" pitchFamily="34" charset="0"/>
                <a:cs typeface="Arial" panose="020B0604020202020204" pitchFamily="34" charset="0"/>
              </a:endParaRPr>
            </a:p>
          </p:txBody>
        </p:sp>
        <p:pic>
          <p:nvPicPr>
            <p:cNvPr id="451" name="図 450">
              <a:extLst>
                <a:ext uri="{FF2B5EF4-FFF2-40B4-BE49-F238E27FC236}">
                  <a16:creationId xmlns:a16="http://schemas.microsoft.com/office/drawing/2014/main" id="{3EFBB1DA-BFC6-E5BE-4F6D-C3996756D74B}"/>
                </a:ext>
              </a:extLst>
            </p:cNvPr>
            <p:cNvPicPr>
              <a:picLocks noChangeAspect="1"/>
            </p:cNvPicPr>
            <p:nvPr/>
          </p:nvPicPr>
          <p:blipFill>
            <a:blip r:embed="rId4"/>
            <a:stretch>
              <a:fillRect/>
            </a:stretch>
          </p:blipFill>
          <p:spPr>
            <a:xfrm>
              <a:off x="1768737" y="2882918"/>
              <a:ext cx="3600000" cy="130909"/>
            </a:xfrm>
            <a:prstGeom prst="rect">
              <a:avLst/>
            </a:prstGeom>
          </p:spPr>
        </p:pic>
        <p:pic>
          <p:nvPicPr>
            <p:cNvPr id="452" name="図 451">
              <a:extLst>
                <a:ext uri="{FF2B5EF4-FFF2-40B4-BE49-F238E27FC236}">
                  <a16:creationId xmlns:a16="http://schemas.microsoft.com/office/drawing/2014/main" id="{83AED780-D4EF-B87D-EFB8-4945CFF6790D}"/>
                </a:ext>
              </a:extLst>
            </p:cNvPr>
            <p:cNvPicPr>
              <a:picLocks noChangeAspect="1"/>
            </p:cNvPicPr>
            <p:nvPr/>
          </p:nvPicPr>
          <p:blipFill>
            <a:blip r:embed="rId5"/>
            <a:stretch>
              <a:fillRect/>
            </a:stretch>
          </p:blipFill>
          <p:spPr>
            <a:xfrm>
              <a:off x="1768737" y="2731145"/>
              <a:ext cx="3600000" cy="130909"/>
            </a:xfrm>
            <a:prstGeom prst="rect">
              <a:avLst/>
            </a:prstGeom>
          </p:spPr>
        </p:pic>
        <p:pic>
          <p:nvPicPr>
            <p:cNvPr id="466" name="図 465">
              <a:extLst>
                <a:ext uri="{FF2B5EF4-FFF2-40B4-BE49-F238E27FC236}">
                  <a16:creationId xmlns:a16="http://schemas.microsoft.com/office/drawing/2014/main" id="{0D14E540-A416-4E03-7538-D391F95E42C4}"/>
                </a:ext>
              </a:extLst>
            </p:cNvPr>
            <p:cNvPicPr>
              <a:picLocks noChangeAspect="1"/>
            </p:cNvPicPr>
            <p:nvPr/>
          </p:nvPicPr>
          <p:blipFill>
            <a:blip r:embed="rId6"/>
            <a:stretch>
              <a:fillRect/>
            </a:stretch>
          </p:blipFill>
          <p:spPr>
            <a:xfrm>
              <a:off x="1768737" y="2275835"/>
              <a:ext cx="3600000" cy="130909"/>
            </a:xfrm>
            <a:prstGeom prst="rect">
              <a:avLst/>
            </a:prstGeom>
          </p:spPr>
        </p:pic>
        <p:pic>
          <p:nvPicPr>
            <p:cNvPr id="469" name="図 468">
              <a:extLst>
                <a:ext uri="{FF2B5EF4-FFF2-40B4-BE49-F238E27FC236}">
                  <a16:creationId xmlns:a16="http://schemas.microsoft.com/office/drawing/2014/main" id="{C6508C6C-531E-1D69-444F-689B2ACA60C8}"/>
                </a:ext>
              </a:extLst>
            </p:cNvPr>
            <p:cNvPicPr>
              <a:picLocks noChangeAspect="1"/>
            </p:cNvPicPr>
            <p:nvPr/>
          </p:nvPicPr>
          <p:blipFill>
            <a:blip r:embed="rId7"/>
            <a:stretch>
              <a:fillRect/>
            </a:stretch>
          </p:blipFill>
          <p:spPr>
            <a:xfrm>
              <a:off x="1768737" y="2427605"/>
              <a:ext cx="3600000" cy="130909"/>
            </a:xfrm>
            <a:prstGeom prst="rect">
              <a:avLst/>
            </a:prstGeom>
          </p:spPr>
        </p:pic>
        <p:pic>
          <p:nvPicPr>
            <p:cNvPr id="471" name="図 470">
              <a:extLst>
                <a:ext uri="{FF2B5EF4-FFF2-40B4-BE49-F238E27FC236}">
                  <a16:creationId xmlns:a16="http://schemas.microsoft.com/office/drawing/2014/main" id="{3CC63106-16B7-1938-DE94-C2877ADB45DF}"/>
                </a:ext>
              </a:extLst>
            </p:cNvPr>
            <p:cNvPicPr>
              <a:picLocks noChangeAspect="1"/>
            </p:cNvPicPr>
            <p:nvPr/>
          </p:nvPicPr>
          <p:blipFill>
            <a:blip r:embed="rId8"/>
            <a:stretch>
              <a:fillRect/>
            </a:stretch>
          </p:blipFill>
          <p:spPr>
            <a:xfrm>
              <a:off x="1768737" y="2579375"/>
              <a:ext cx="3600000" cy="130909"/>
            </a:xfrm>
            <a:prstGeom prst="rect">
              <a:avLst/>
            </a:prstGeom>
          </p:spPr>
        </p:pic>
      </p:grpSp>
    </p:spTree>
    <p:extLst>
      <p:ext uri="{BB962C8B-B14F-4D97-AF65-F5344CB8AC3E}">
        <p14:creationId xmlns:p14="http://schemas.microsoft.com/office/powerpoint/2010/main" val="2550414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592669E-0824-9915-B6FA-88DDDAE644ED}"/>
            </a:ext>
          </a:extLst>
        </p:cNvPr>
        <p:cNvGrpSpPr/>
        <p:nvPr/>
      </p:nvGrpSpPr>
      <p:grpSpPr>
        <a:xfrm>
          <a:off x="0" y="0"/>
          <a:ext cx="0" cy="0"/>
          <a:chOff x="0" y="0"/>
          <a:chExt cx="0" cy="0"/>
        </a:xfrm>
      </p:grpSpPr>
      <p:sp>
        <p:nvSpPr>
          <p:cNvPr id="16" name="テキスト ボックス 15">
            <a:extLst>
              <a:ext uri="{FF2B5EF4-FFF2-40B4-BE49-F238E27FC236}">
                <a16:creationId xmlns:a16="http://schemas.microsoft.com/office/drawing/2014/main" id="{95F59B55-C7A5-3019-48AC-120360F5FF1C}"/>
              </a:ext>
            </a:extLst>
          </p:cNvPr>
          <p:cNvSpPr txBox="1"/>
          <p:nvPr/>
        </p:nvSpPr>
        <p:spPr>
          <a:xfrm>
            <a:off x="891635" y="7278053"/>
            <a:ext cx="5400000" cy="1015663"/>
          </a:xfrm>
          <a:prstGeom prst="rect">
            <a:avLst/>
          </a:prstGeom>
          <a:noFill/>
        </p:spPr>
        <p:txBody>
          <a:bodyPr wrap="square">
            <a:spAutoFit/>
          </a:bodyPr>
          <a:lstStyle/>
          <a:p>
            <a:pPr algn="just"/>
            <a:r>
              <a:rPr lang="en-US" altLang="ja-JP" sz="1000" b="1" dirty="0">
                <a:latin typeface="Arial" panose="020B0604020202020204" pitchFamily="34" charset="0"/>
                <a:cs typeface="Arial" panose="020B0604020202020204" pitchFamily="34" charset="0"/>
              </a:rPr>
              <a:t>Supplementary Figure S6. Candidate ABI1 substrates. </a:t>
            </a:r>
            <a:r>
              <a:rPr lang="en-US" altLang="ja-JP" sz="1000" dirty="0">
                <a:latin typeface="Arial" panose="020B0604020202020204" pitchFamily="34" charset="0"/>
                <a:cs typeface="Arial" panose="020B0604020202020204" pitchFamily="34" charset="0"/>
              </a:rPr>
              <a:t>(</a:t>
            </a:r>
            <a:r>
              <a:rPr lang="en-US" altLang="ja-JP" sz="1000" b="1" dirty="0">
                <a:latin typeface="Arial" panose="020B0604020202020204" pitchFamily="34" charset="0"/>
                <a:cs typeface="Arial" panose="020B0604020202020204" pitchFamily="34" charset="0"/>
              </a:rPr>
              <a:t>A</a:t>
            </a:r>
            <a:r>
              <a:rPr lang="en-US" altLang="ja-JP" sz="1000" dirty="0">
                <a:latin typeface="Arial" panose="020B0604020202020204" pitchFamily="34" charset="0"/>
                <a:cs typeface="Arial" panose="020B0604020202020204" pitchFamily="34" charset="0"/>
              </a:rPr>
              <a:t>) Venn diagram showing the overlap between phosphoproteins identified in this study and proteins previously reported as candidate ABI1 interactors. ABA‑induced phosphoproteins significantly down‑regulated (</a:t>
            </a:r>
            <a:r>
              <a:rPr lang="en-US" altLang="ja-JP" sz="1000" i="1" dirty="0">
                <a:latin typeface="Arial" panose="020B0604020202020204" pitchFamily="34" charset="0"/>
                <a:cs typeface="Arial" panose="020B0604020202020204" pitchFamily="34" charset="0"/>
              </a:rPr>
              <a:t>P</a:t>
            </a:r>
            <a:r>
              <a:rPr lang="en-US" altLang="ja-JP" sz="1000" dirty="0">
                <a:latin typeface="Arial" panose="020B0604020202020204" pitchFamily="34" charset="0"/>
                <a:cs typeface="Arial" panose="020B0604020202020204" pitchFamily="34" charset="0"/>
              </a:rPr>
              <a:t> &lt; 0.05) less than half of the Col-0 ratio in </a:t>
            </a:r>
            <a:r>
              <a:rPr lang="en-US" altLang="ja-JP" sz="1000" i="1" dirty="0">
                <a:latin typeface="Arial" panose="020B0604020202020204" pitchFamily="34" charset="0"/>
                <a:cs typeface="Arial" panose="020B0604020202020204" pitchFamily="34" charset="0"/>
              </a:rPr>
              <a:t>abi1‑1C</a:t>
            </a:r>
            <a:r>
              <a:rPr lang="en-US" altLang="ja-JP" sz="1000" dirty="0">
                <a:latin typeface="Arial" panose="020B0604020202020204" pitchFamily="34" charset="0"/>
                <a:cs typeface="Arial" panose="020B0604020202020204" pitchFamily="34" charset="0"/>
              </a:rPr>
              <a:t>, but not in </a:t>
            </a:r>
            <a:r>
              <a:rPr lang="en-US" altLang="ja-JP" sz="1000" i="1" dirty="0">
                <a:latin typeface="Arial" panose="020B0604020202020204" pitchFamily="34" charset="0"/>
                <a:cs typeface="Arial" panose="020B0604020202020204" pitchFamily="34" charset="0"/>
              </a:rPr>
              <a:t>srk2dei</a:t>
            </a:r>
            <a:r>
              <a:rPr lang="en-US" altLang="ja-JP" sz="1000" dirty="0">
                <a:latin typeface="Arial" panose="020B0604020202020204" pitchFamily="34" charset="0"/>
                <a:cs typeface="Arial" panose="020B0604020202020204" pitchFamily="34" charset="0"/>
              </a:rPr>
              <a:t>, are indicated. (</a:t>
            </a:r>
            <a:r>
              <a:rPr lang="en-US" altLang="ja-JP" sz="1000" b="1" dirty="0">
                <a:latin typeface="Arial" panose="020B0604020202020204" pitchFamily="34" charset="0"/>
                <a:cs typeface="Arial" panose="020B0604020202020204" pitchFamily="34" charset="0"/>
              </a:rPr>
              <a:t>B</a:t>
            </a:r>
            <a:r>
              <a:rPr lang="en-US" altLang="ja-JP" sz="1000" dirty="0">
                <a:latin typeface="Arial" panose="020B0604020202020204" pitchFamily="34" charset="0"/>
                <a:cs typeface="Arial" panose="020B0604020202020204" pitchFamily="34" charset="0"/>
              </a:rPr>
              <a:t>) List of proteins included in (A) that were identified both in the </a:t>
            </a:r>
            <a:r>
              <a:rPr lang="en-US" altLang="ja-JP" sz="1000" dirty="0" err="1">
                <a:latin typeface="Arial" panose="020B0604020202020204" pitchFamily="34" charset="0"/>
                <a:cs typeface="Arial" panose="020B0604020202020204" pitchFamily="34" charset="0"/>
              </a:rPr>
              <a:t>phosphoproteomic</a:t>
            </a:r>
            <a:r>
              <a:rPr lang="en-US" altLang="ja-JP" sz="1000" dirty="0">
                <a:latin typeface="Arial" panose="020B0604020202020204" pitchFamily="34" charset="0"/>
                <a:cs typeface="Arial" panose="020B0604020202020204" pitchFamily="34" charset="0"/>
              </a:rPr>
              <a:t> analysis of this study and in the previous interactome study.</a:t>
            </a:r>
          </a:p>
        </p:txBody>
      </p:sp>
      <p:sp>
        <p:nvSpPr>
          <p:cNvPr id="3" name="楕円 2">
            <a:extLst>
              <a:ext uri="{FF2B5EF4-FFF2-40B4-BE49-F238E27FC236}">
                <a16:creationId xmlns:a16="http://schemas.microsoft.com/office/drawing/2014/main" id="{AB63F091-DF1D-DFFE-65EA-E0DC4D929F1B}"/>
              </a:ext>
            </a:extLst>
          </p:cNvPr>
          <p:cNvSpPr/>
          <p:nvPr/>
        </p:nvSpPr>
        <p:spPr>
          <a:xfrm>
            <a:off x="2378512" y="1086718"/>
            <a:ext cx="900000" cy="900000"/>
          </a:xfrm>
          <a:prstGeom prst="ellipse">
            <a:avLst/>
          </a:prstGeom>
          <a:noFill/>
          <a:ln w="190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4" name="楕円 3">
            <a:extLst>
              <a:ext uri="{FF2B5EF4-FFF2-40B4-BE49-F238E27FC236}">
                <a16:creationId xmlns:a16="http://schemas.microsoft.com/office/drawing/2014/main" id="{7FCA1741-0C2D-6759-AFDD-6429057F7256}"/>
              </a:ext>
            </a:extLst>
          </p:cNvPr>
          <p:cNvSpPr/>
          <p:nvPr/>
        </p:nvSpPr>
        <p:spPr>
          <a:xfrm>
            <a:off x="2871635" y="815011"/>
            <a:ext cx="1440000" cy="1440000"/>
          </a:xfrm>
          <a:prstGeom prst="ellipse">
            <a:avLst/>
          </a:prstGeom>
          <a:noFill/>
          <a:ln w="19050" cmpd="sng">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5" name="テキスト ボックス 4">
            <a:extLst>
              <a:ext uri="{FF2B5EF4-FFF2-40B4-BE49-F238E27FC236}">
                <a16:creationId xmlns:a16="http://schemas.microsoft.com/office/drawing/2014/main" id="{22183061-C2EA-BEDD-45D3-26D3DC6B3941}"/>
              </a:ext>
            </a:extLst>
          </p:cNvPr>
          <p:cNvSpPr txBox="1"/>
          <p:nvPr/>
        </p:nvSpPr>
        <p:spPr>
          <a:xfrm>
            <a:off x="1810001" y="855884"/>
            <a:ext cx="722486" cy="461665"/>
          </a:xfrm>
          <a:prstGeom prst="rect">
            <a:avLst/>
          </a:prstGeom>
          <a:noFill/>
        </p:spPr>
        <p:txBody>
          <a:bodyPr wrap="square" rtlCol="0" anchor="ctr">
            <a:spAutoFit/>
          </a:bodyPr>
          <a:lstStyle/>
          <a:p>
            <a:pPr algn="ctr"/>
            <a:r>
              <a:rPr lang="en-US" altLang="ja-JP" sz="600" dirty="0">
                <a:latin typeface="Arial" panose="020B0604020202020204" pitchFamily="34" charset="0"/>
                <a:cs typeface="Arial" panose="020B0604020202020204" pitchFamily="34" charset="0"/>
              </a:rPr>
              <a:t>Candidate ABI1 substrates.in this study</a:t>
            </a:r>
            <a:br>
              <a:rPr lang="en-US" altLang="ja-JP" sz="600" dirty="0">
                <a:latin typeface="Arial" panose="020B0604020202020204" pitchFamily="34" charset="0"/>
                <a:cs typeface="Arial" panose="020B0604020202020204" pitchFamily="34" charset="0"/>
              </a:rPr>
            </a:br>
            <a:r>
              <a:rPr lang="en-US" altLang="ja-JP" sz="600" dirty="0">
                <a:latin typeface="Arial" panose="020B0604020202020204" pitchFamily="34" charset="0"/>
                <a:cs typeface="Arial" panose="020B0604020202020204" pitchFamily="34" charset="0"/>
              </a:rPr>
              <a:t>(140)</a:t>
            </a:r>
            <a:endParaRPr lang="ja-JP" altLang="en-US" sz="600" dirty="0">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D92B7133-9B44-249F-AACB-499AE3799A8A}"/>
              </a:ext>
            </a:extLst>
          </p:cNvPr>
          <p:cNvSpPr txBox="1"/>
          <p:nvPr/>
        </p:nvSpPr>
        <p:spPr>
          <a:xfrm>
            <a:off x="4146828" y="855884"/>
            <a:ext cx="722486" cy="461665"/>
          </a:xfrm>
          <a:prstGeom prst="rect">
            <a:avLst/>
          </a:prstGeom>
          <a:noFill/>
        </p:spPr>
        <p:txBody>
          <a:bodyPr wrap="square" rtlCol="0" anchor="ctr">
            <a:spAutoFit/>
          </a:bodyPr>
          <a:lstStyle/>
          <a:p>
            <a:pPr algn="ctr"/>
            <a:r>
              <a:rPr lang="en-US" altLang="ja-JP" sz="600" dirty="0">
                <a:solidFill>
                  <a:schemeClr val="accent1"/>
                </a:solidFill>
                <a:latin typeface="Arial" panose="020B0604020202020204" pitchFamily="34" charset="0"/>
                <a:cs typeface="Arial" panose="020B0604020202020204" pitchFamily="34" charset="0"/>
              </a:rPr>
              <a:t>Candidate ABI1 interactors.in previous study</a:t>
            </a:r>
            <a:br>
              <a:rPr lang="en-US" altLang="ja-JP" sz="600" dirty="0">
                <a:solidFill>
                  <a:schemeClr val="accent1"/>
                </a:solidFill>
                <a:latin typeface="Arial"/>
                <a:cs typeface="Arial"/>
              </a:rPr>
            </a:br>
            <a:r>
              <a:rPr lang="en-US" altLang="ja-JP" sz="600" dirty="0">
                <a:solidFill>
                  <a:schemeClr val="accent1"/>
                </a:solidFill>
                <a:latin typeface="Arial"/>
                <a:cs typeface="Arial"/>
              </a:rPr>
              <a:t>(1542)</a:t>
            </a:r>
            <a:endParaRPr lang="ja-JP" altLang="en-US" sz="600" dirty="0">
              <a:solidFill>
                <a:schemeClr val="accent1"/>
              </a:solidFill>
              <a:latin typeface="Arial"/>
              <a:cs typeface="Arial"/>
            </a:endParaRPr>
          </a:p>
        </p:txBody>
      </p:sp>
      <p:sp>
        <p:nvSpPr>
          <p:cNvPr id="35" name="テキスト ボックス 34">
            <a:extLst>
              <a:ext uri="{FF2B5EF4-FFF2-40B4-BE49-F238E27FC236}">
                <a16:creationId xmlns:a16="http://schemas.microsoft.com/office/drawing/2014/main" id="{8B02EC54-0582-E292-10A1-10D0B120FF5F}"/>
              </a:ext>
            </a:extLst>
          </p:cNvPr>
          <p:cNvSpPr txBox="1"/>
          <p:nvPr/>
        </p:nvSpPr>
        <p:spPr>
          <a:xfrm>
            <a:off x="2702893" y="1442678"/>
            <a:ext cx="722486" cy="184666"/>
          </a:xfrm>
          <a:prstGeom prst="rect">
            <a:avLst/>
          </a:prstGeom>
          <a:noFill/>
        </p:spPr>
        <p:txBody>
          <a:bodyPr wrap="square" rtlCol="0" anchor="ctr">
            <a:spAutoFit/>
          </a:bodyPr>
          <a:lstStyle/>
          <a:p>
            <a:pPr algn="ctr"/>
            <a:r>
              <a:rPr lang="en-US" altLang="ja-JP" sz="600" dirty="0">
                <a:latin typeface="Arial"/>
                <a:cs typeface="Arial"/>
              </a:rPr>
              <a:t>42</a:t>
            </a:r>
            <a:endParaRPr lang="ja-JP" altLang="en-US" sz="600" dirty="0">
              <a:latin typeface="Arial"/>
              <a:cs typeface="Arial"/>
            </a:endParaRPr>
          </a:p>
        </p:txBody>
      </p:sp>
      <p:sp>
        <p:nvSpPr>
          <p:cNvPr id="36" name="テキスト ボックス 35">
            <a:extLst>
              <a:ext uri="{FF2B5EF4-FFF2-40B4-BE49-F238E27FC236}">
                <a16:creationId xmlns:a16="http://schemas.microsoft.com/office/drawing/2014/main" id="{943073D4-79FE-BCAD-78ED-614C3EBB0F2E}"/>
              </a:ext>
            </a:extLst>
          </p:cNvPr>
          <p:cNvSpPr txBox="1"/>
          <p:nvPr/>
        </p:nvSpPr>
        <p:spPr>
          <a:xfrm>
            <a:off x="2286019" y="1442678"/>
            <a:ext cx="722486" cy="184666"/>
          </a:xfrm>
          <a:prstGeom prst="rect">
            <a:avLst/>
          </a:prstGeom>
          <a:noFill/>
        </p:spPr>
        <p:txBody>
          <a:bodyPr wrap="square" rtlCol="0" anchor="ctr">
            <a:spAutoFit/>
          </a:bodyPr>
          <a:lstStyle/>
          <a:p>
            <a:pPr algn="ctr"/>
            <a:r>
              <a:rPr lang="en-US" altLang="ja-JP" sz="600" dirty="0">
                <a:latin typeface="Arial"/>
                <a:cs typeface="Arial"/>
              </a:rPr>
              <a:t>98</a:t>
            </a:r>
            <a:endParaRPr lang="ja-JP" altLang="en-US" sz="600" dirty="0">
              <a:latin typeface="Arial"/>
              <a:cs typeface="Arial"/>
            </a:endParaRPr>
          </a:p>
        </p:txBody>
      </p:sp>
      <p:sp>
        <p:nvSpPr>
          <p:cNvPr id="37" name="テキスト ボックス 36">
            <a:extLst>
              <a:ext uri="{FF2B5EF4-FFF2-40B4-BE49-F238E27FC236}">
                <a16:creationId xmlns:a16="http://schemas.microsoft.com/office/drawing/2014/main" id="{E2DAE1D1-F3B1-954A-7EE9-E776BEAD5935}"/>
              </a:ext>
            </a:extLst>
          </p:cNvPr>
          <p:cNvSpPr txBox="1"/>
          <p:nvPr/>
        </p:nvSpPr>
        <p:spPr>
          <a:xfrm>
            <a:off x="3244923" y="1442678"/>
            <a:ext cx="722486" cy="184666"/>
          </a:xfrm>
          <a:prstGeom prst="rect">
            <a:avLst/>
          </a:prstGeom>
          <a:noFill/>
        </p:spPr>
        <p:txBody>
          <a:bodyPr wrap="square" rtlCol="0" anchor="ctr">
            <a:spAutoFit/>
          </a:bodyPr>
          <a:lstStyle/>
          <a:p>
            <a:pPr algn="ctr"/>
            <a:r>
              <a:rPr lang="en-US" altLang="ja-JP" sz="600" dirty="0">
                <a:latin typeface="Arial"/>
                <a:cs typeface="Arial"/>
              </a:rPr>
              <a:t>1500</a:t>
            </a:r>
            <a:endParaRPr lang="ja-JP" altLang="en-US" sz="600" dirty="0">
              <a:latin typeface="Arial"/>
              <a:cs typeface="Arial"/>
            </a:endParaRPr>
          </a:p>
        </p:txBody>
      </p:sp>
      <p:graphicFrame>
        <p:nvGraphicFramePr>
          <p:cNvPr id="49" name="表 48">
            <a:extLst>
              <a:ext uri="{FF2B5EF4-FFF2-40B4-BE49-F238E27FC236}">
                <a16:creationId xmlns:a16="http://schemas.microsoft.com/office/drawing/2014/main" id="{CDFEF6A3-FD5F-6403-520D-3A3C22DAA23E}"/>
              </a:ext>
            </a:extLst>
          </p:cNvPr>
          <p:cNvGraphicFramePr>
            <a:graphicFrameLocks noGrp="1"/>
          </p:cNvGraphicFramePr>
          <p:nvPr>
            <p:extLst>
              <p:ext uri="{D42A27DB-BD31-4B8C-83A1-F6EECF244321}">
                <p14:modId xmlns:p14="http://schemas.microsoft.com/office/powerpoint/2010/main" val="949911899"/>
              </p:ext>
            </p:extLst>
          </p:nvPr>
        </p:nvGraphicFramePr>
        <p:xfrm>
          <a:off x="1150195" y="2522711"/>
          <a:ext cx="4550368" cy="4361406"/>
        </p:xfrm>
        <a:graphic>
          <a:graphicData uri="http://schemas.openxmlformats.org/drawingml/2006/table">
            <a:tbl>
              <a:tblPr>
                <a:tableStyleId>{5C22544A-7EE6-4342-B048-85BDC9FD1C3A}</a:tableStyleId>
              </a:tblPr>
              <a:tblGrid>
                <a:gridCol w="569210">
                  <a:extLst>
                    <a:ext uri="{9D8B030D-6E8A-4147-A177-3AD203B41FA5}">
                      <a16:colId xmlns:a16="http://schemas.microsoft.com/office/drawing/2014/main" val="4050934806"/>
                    </a:ext>
                  </a:extLst>
                </a:gridCol>
                <a:gridCol w="1007751">
                  <a:extLst>
                    <a:ext uri="{9D8B030D-6E8A-4147-A177-3AD203B41FA5}">
                      <a16:colId xmlns:a16="http://schemas.microsoft.com/office/drawing/2014/main" val="1021638759"/>
                    </a:ext>
                  </a:extLst>
                </a:gridCol>
                <a:gridCol w="2973407">
                  <a:extLst>
                    <a:ext uri="{9D8B030D-6E8A-4147-A177-3AD203B41FA5}">
                      <a16:colId xmlns:a16="http://schemas.microsoft.com/office/drawing/2014/main" val="367950149"/>
                    </a:ext>
                  </a:extLst>
                </a:gridCol>
              </a:tblGrid>
              <a:tr h="0">
                <a:tc>
                  <a:txBody>
                    <a:bodyPr/>
                    <a:lstStyle/>
                    <a:p>
                      <a:pPr algn="l" fontAlgn="b">
                        <a:buNone/>
                      </a:pPr>
                      <a:r>
                        <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rPr>
                        <a:t>Accession No.</a:t>
                      </a: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a:txBody>
                    <a:bodyPr/>
                    <a:lstStyle/>
                    <a:p>
                      <a:pPr algn="l" fontAlgn="b">
                        <a:buNone/>
                      </a:pPr>
                      <a:r>
                        <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rPr>
                        <a:t>Gene symbol</a:t>
                      </a: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a:txBody>
                    <a:bodyPr/>
                    <a:lstStyle/>
                    <a:p>
                      <a:pPr algn="l" fontAlgn="b">
                        <a:buNone/>
                      </a:pPr>
                      <a:r>
                        <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rPr>
                        <a:t>Descriptions</a:t>
                      </a: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extLst>
                  <a:ext uri="{0D108BD9-81ED-4DB2-BD59-A6C34878D82A}">
                    <a16:rowId xmlns:a16="http://schemas.microsoft.com/office/drawing/2014/main" val="1003196965"/>
                  </a:ext>
                </a:extLst>
              </a:tr>
              <a:tr h="0">
                <a:tc>
                  <a:txBody>
                    <a:bodyPr/>
                    <a:lstStyle/>
                    <a:p>
                      <a:pPr algn="ctr" fontAlgn="b">
                        <a:buNone/>
                      </a:pPr>
                      <a:r>
                        <a:rPr lang="en-US" sz="600" u="none" strike="noStrike" dirty="0">
                          <a:effectLst/>
                          <a:latin typeface="Arial" panose="020B0604020202020204" pitchFamily="34" charset="0"/>
                          <a:cs typeface="Arial" panose="020B0604020202020204" pitchFamily="34" charset="0"/>
                        </a:rPr>
                        <a:t>AT1G21630</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Calcium-binding EF hand 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42498439"/>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2507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RIN4</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RPM1 interacting protein 4</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10025509"/>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2731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altLang="ja-JP"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rPr>
                        <a:t>PUX1</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lant UBX domain-containing protein 1</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94035595"/>
                  </a:ext>
                </a:extLst>
              </a:tr>
              <a:tr h="0">
                <a:tc>
                  <a:txBody>
                    <a:bodyPr/>
                    <a:lstStyle/>
                    <a:p>
                      <a:pPr algn="ctr" fontAlgn="b">
                        <a:buNone/>
                      </a:pPr>
                      <a:r>
                        <a:rPr lang="en-US" sz="600" u="none" strike="noStrike" dirty="0">
                          <a:effectLst/>
                          <a:latin typeface="Arial" panose="020B0604020202020204" pitchFamily="34" charset="0"/>
                          <a:cs typeface="Arial" panose="020B0604020202020204" pitchFamily="34" charset="0"/>
                        </a:rPr>
                        <a:t>AT4G39680</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SAP domain-containing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00434484"/>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2G0315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RSA1, emb1579</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ATP/GTP-binding protein family</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86114922"/>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5527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b" latinLnBrk="0" hangingPunct="1">
                        <a:lnSpc>
                          <a:spcPct val="100000"/>
                        </a:lnSpc>
                        <a:spcBef>
                          <a:spcPts val="0"/>
                        </a:spcBef>
                        <a:spcAft>
                          <a:spcPts val="0"/>
                        </a:spcAft>
                        <a:buClrTx/>
                        <a:buSzTx/>
                        <a:buFontTx/>
                        <a:buNone/>
                        <a:tabLst/>
                        <a:defRPr/>
                      </a:pPr>
                      <a:r>
                        <a:rPr lang="en-US" altLang="ja-JP" sz="600" u="none" strike="noStrike">
                          <a:effectLst/>
                          <a:latin typeface="Arial" panose="020B0604020202020204" pitchFamily="34" charset="0"/>
                          <a:cs typeface="Arial" panose="020B0604020202020204" pitchFamily="34" charset="0"/>
                        </a:rPr>
                        <a:t>MKP1,ATMKP1</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mitogen-activated protein kinase phosphatase 1</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5876555"/>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CG0048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b" latinLnBrk="0" hangingPunct="1">
                        <a:lnSpc>
                          <a:spcPct val="100000"/>
                        </a:lnSpc>
                        <a:spcBef>
                          <a:spcPts val="0"/>
                        </a:spcBef>
                        <a:spcAft>
                          <a:spcPts val="0"/>
                        </a:spcAft>
                        <a:buClrTx/>
                        <a:buSzTx/>
                        <a:buFontTx/>
                        <a:buNone/>
                        <a:tabLst/>
                        <a:defRPr/>
                      </a:pPr>
                      <a:r>
                        <a:rPr lang="en-US" sz="600" u="none" strike="noStrike">
                          <a:effectLst/>
                          <a:latin typeface="Arial" panose="020B0604020202020204" pitchFamily="34" charset="0"/>
                          <a:cs typeface="Arial" panose="020B0604020202020204" pitchFamily="34" charset="0"/>
                        </a:rPr>
                        <a:t>atpB, </a:t>
                      </a:r>
                      <a:r>
                        <a:rPr lang="en-US" altLang="ja-JP" sz="600" u="none" strike="noStrike">
                          <a:effectLst/>
                          <a:latin typeface="Arial" panose="020B0604020202020204" pitchFamily="34" charset="0"/>
                          <a:cs typeface="Arial" panose="020B0604020202020204" pitchFamily="34" charset="0"/>
                        </a:rPr>
                        <a:t>ATPB,PB</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ATP synthase subunit beta</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99953156"/>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5092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altLang="ja-JP" sz="600" u="none" strike="noStrike" dirty="0">
                          <a:effectLst/>
                          <a:latin typeface="Arial" panose="020B0604020202020204" pitchFamily="34" charset="0"/>
                          <a:cs typeface="Arial" panose="020B0604020202020204" pitchFamily="34" charset="0"/>
                        </a:rPr>
                        <a:t>CLPC,ATHSP93-V,HSP93-V,DCA1,CLPC1</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fr-FR" sz="600" u="none" strike="noStrike" dirty="0">
                          <a:effectLst/>
                          <a:latin typeface="Arial" panose="020B0604020202020204" pitchFamily="34" charset="0"/>
                          <a:cs typeface="Arial" panose="020B0604020202020204" pitchFamily="34" charset="0"/>
                        </a:rPr>
                        <a:t>CLPC homologue 1, Clp ATPase</a:t>
                      </a:r>
                      <a:endParaRPr lang="fr-FR"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34861546"/>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0357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da-DK" sz="600" u="none" strike="noStrike">
                          <a:effectLst/>
                          <a:latin typeface="Arial" panose="020B0604020202020204" pitchFamily="34" charset="0"/>
                          <a:cs typeface="Arial" panose="020B0604020202020204" pitchFamily="34" charset="0"/>
                        </a:rPr>
                        <a:t>signal transducer%2C putative (DUF3550/UPF0682)</a:t>
                      </a:r>
                      <a:endParaRPr lang="da-DK"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33420309"/>
                  </a:ext>
                </a:extLst>
              </a:tr>
              <a:tr h="0">
                <a:tc>
                  <a:txBody>
                    <a:bodyPr/>
                    <a:lstStyle/>
                    <a:p>
                      <a:pPr algn="ctr" fontAlgn="b">
                        <a:buNone/>
                      </a:pPr>
                      <a:r>
                        <a:rPr lang="en-US" sz="600" u="none" strike="noStrike" dirty="0">
                          <a:effectLst/>
                          <a:latin typeface="Arial" panose="020B0604020202020204" pitchFamily="34" charset="0"/>
                          <a:cs typeface="Arial" panose="020B0604020202020204" pitchFamily="34" charset="0"/>
                        </a:rPr>
                        <a:t>AT1G73450</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dirty="0">
                          <a:effectLst/>
                          <a:latin typeface="Arial" panose="020B0604020202020204" pitchFamily="34" charset="0"/>
                          <a:cs typeface="Arial" panose="020B0604020202020204" pitchFamily="34" charset="0"/>
                        </a:rPr>
                        <a:t>Protein kinase superfamily protein </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61341901"/>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6121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altLang="ja-JP" sz="600" u="none" strike="noStrike" dirty="0">
                          <a:effectLst/>
                          <a:latin typeface="Arial" panose="020B0604020202020204" pitchFamily="34" charset="0"/>
                          <a:cs typeface="Arial" panose="020B0604020202020204" pitchFamily="34" charset="0"/>
                        </a:rPr>
                        <a:t>SNAP33,ATSNAP33,SNP33,ATSNAP33B</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pt-BR" sz="600" u="none" strike="noStrike">
                          <a:effectLst/>
                          <a:latin typeface="Arial" panose="020B0604020202020204" pitchFamily="34" charset="0"/>
                          <a:cs typeface="Arial" panose="020B0604020202020204" pitchFamily="34" charset="0"/>
                        </a:rPr>
                        <a:t>soluble N-ethylmaleimide-sensitive factor adaptor protein 33</a:t>
                      </a:r>
                      <a:endParaRPr lang="pt-BR"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8214020"/>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CG0049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rPr>
                        <a:t>RBCL</a:t>
                      </a: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ribulose-bisphosphate carboxylase</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61700368"/>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2G1586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dirty="0">
                          <a:effectLst/>
                          <a:latin typeface="Arial" panose="020B0604020202020204" pitchFamily="34" charset="0"/>
                          <a:cs typeface="Arial" panose="020B0604020202020204" pitchFamily="34" charset="0"/>
                        </a:rPr>
                        <a:t>BAT2 domain protein</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61326433"/>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4678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TAC16</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lastid transcriptionally active 16</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82688073"/>
                  </a:ext>
                </a:extLst>
              </a:tr>
              <a:tr h="0">
                <a:tc>
                  <a:txBody>
                    <a:bodyPr/>
                    <a:lstStyle/>
                    <a:p>
                      <a:pPr algn="ctr" fontAlgn="b">
                        <a:buNone/>
                      </a:pPr>
                      <a:r>
                        <a:rPr lang="en-US" sz="600" u="none" strike="noStrike" dirty="0">
                          <a:effectLst/>
                          <a:latin typeface="Arial" panose="020B0604020202020204" pitchFamily="34" charset="0"/>
                          <a:cs typeface="Arial" panose="020B0604020202020204" pitchFamily="34" charset="0"/>
                        </a:rPr>
                        <a:t>AT1G79570</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kinase superfamily with octicosapeptide/Phox/Bem1p domain-containing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64427511"/>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6316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F16M2_1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outer envelope membrane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67222810"/>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5180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b" latinLnBrk="0" hangingPunct="1">
                        <a:lnSpc>
                          <a:spcPct val="100000"/>
                        </a:lnSpc>
                        <a:spcBef>
                          <a:spcPts val="0"/>
                        </a:spcBef>
                        <a:spcAft>
                          <a:spcPts val="0"/>
                        </a:spcAft>
                        <a:buClrTx/>
                        <a:buSzTx/>
                        <a:buFontTx/>
                        <a:buNone/>
                        <a:tabLst/>
                        <a:defRPr/>
                      </a:pPr>
                      <a:r>
                        <a:rPr lang="en-US" altLang="ja-JP" sz="600" u="none" strike="noStrike" dirty="0">
                          <a:effectLst/>
                          <a:latin typeface="Arial" panose="020B0604020202020204" pitchFamily="34" charset="0"/>
                          <a:cs typeface="Arial" panose="020B0604020202020204" pitchFamily="34" charset="0"/>
                        </a:rPr>
                        <a:t>ATG2,EBP1,ATEBP1</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metallopeptidase M24 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60113473"/>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CG0027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sbD</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hotosystem II reaction center protein D</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20437155"/>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4195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HLB1</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Tetratricopeptide repeat (TPR)-like super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88768992"/>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4G3712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re-mRNA splicing Prp18-interacting factor</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66361509"/>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5553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Calcium-dependent lipid-binding (CaLB domain) 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7498964"/>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4G2808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REC2</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Tetratricopeptide repeat (TPR)-like super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29724652"/>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2306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CAS</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calcium sensing receptor</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44192807"/>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1G1148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eukaryotic translation initiation factor-like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99016157"/>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1G5531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SCL33</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SC35-like splicing factor 33</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64285178"/>
                  </a:ext>
                </a:extLst>
              </a:tr>
              <a:tr h="0">
                <a:tc>
                  <a:txBody>
                    <a:bodyPr/>
                    <a:lstStyle/>
                    <a:p>
                      <a:pPr algn="ctr" fontAlgn="b">
                        <a:buNone/>
                      </a:pPr>
                      <a:r>
                        <a:rPr lang="en-US" sz="600" u="none" strike="noStrike" dirty="0">
                          <a:effectLst/>
                          <a:latin typeface="Arial" panose="020B0604020202020204" pitchFamily="34" charset="0"/>
                          <a:cs typeface="Arial" panose="020B0604020202020204" pitchFamily="34" charset="0"/>
                        </a:rPr>
                        <a:t>AT2G20190</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b" latinLnBrk="0" hangingPunct="1">
                        <a:lnSpc>
                          <a:spcPct val="100000"/>
                        </a:lnSpc>
                        <a:spcBef>
                          <a:spcPts val="0"/>
                        </a:spcBef>
                        <a:spcAft>
                          <a:spcPts val="0"/>
                        </a:spcAft>
                        <a:buClrTx/>
                        <a:buSzTx/>
                        <a:buFontTx/>
                        <a:buNone/>
                        <a:tabLst/>
                        <a:defRPr/>
                      </a:pPr>
                      <a:r>
                        <a:rPr lang="en-US" altLang="ja-JP" sz="600" u="none" strike="noStrike" dirty="0">
                          <a:effectLst/>
                          <a:latin typeface="Arial" panose="020B0604020202020204" pitchFamily="34" charset="0"/>
                          <a:cs typeface="Arial" panose="020B0604020202020204" pitchFamily="34" charset="0"/>
                        </a:rPr>
                        <a:t>ATCLASP,CLASP</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CLIP-associated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05656755"/>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4076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G6PD6</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glucose-6-phosphate dehydrogenase 6</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32892628"/>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4G3855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hospholipase-like protein (PEARLI 4) 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66239195"/>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2116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dirty="0">
                          <a:effectLst/>
                          <a:latin typeface="Arial" panose="020B0604020202020204" pitchFamily="34" charset="0"/>
                          <a:cs typeface="Arial" panose="020B0604020202020204" pitchFamily="34" charset="0"/>
                        </a:rPr>
                        <a:t>LARP1a</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LA RNA-binding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837827412"/>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5454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ABCF4</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general control non-repressible 4</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3246802"/>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4045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MPO12.16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A-kinase anchor-like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30511258"/>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4G2750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PI1</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roton pump interactor 1</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89169935"/>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6178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dirty="0">
                          <a:effectLst/>
                          <a:latin typeface="Arial" panose="020B0604020202020204" pitchFamily="34" charset="0"/>
                          <a:cs typeface="Arial" panose="020B0604020202020204" pitchFamily="34" charset="0"/>
                        </a:rPr>
                        <a:t>TSN2</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TUDOR-SN protein 2</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47793707"/>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0414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b" latinLnBrk="0" hangingPunct="1">
                        <a:lnSpc>
                          <a:spcPct val="100000"/>
                        </a:lnSpc>
                        <a:spcBef>
                          <a:spcPts val="0"/>
                        </a:spcBef>
                        <a:spcAft>
                          <a:spcPts val="0"/>
                        </a:spcAft>
                        <a:buClrTx/>
                        <a:buSzTx/>
                        <a:buFontTx/>
                        <a:buNone/>
                        <a:tabLst/>
                        <a:defRPr/>
                      </a:pPr>
                      <a:r>
                        <a:rPr lang="en-US" altLang="ja-JP" sz="600" u="none" strike="noStrike" dirty="0">
                          <a:effectLst/>
                          <a:latin typeface="Arial" panose="020B0604020202020204" pitchFamily="34" charset="0"/>
                          <a:cs typeface="Arial" panose="020B0604020202020204" pitchFamily="34" charset="0"/>
                        </a:rPr>
                        <a:t>GLU1,GLS1,GLUS,FD-GOGAT</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glutamate synthase 1</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98809969"/>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4G1335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NIG</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NSP (nuclear shuttle protein)-interacting GTPase</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8212937"/>
                  </a:ext>
                </a:extLst>
              </a:tr>
              <a:tr h="0">
                <a:tc>
                  <a:txBody>
                    <a:bodyPr/>
                    <a:lstStyle/>
                    <a:p>
                      <a:pPr algn="ctr" fontAlgn="b">
                        <a:buNone/>
                      </a:pPr>
                      <a:r>
                        <a:rPr lang="en-US" sz="600" u="none" strike="noStrike" dirty="0">
                          <a:effectLst/>
                          <a:latin typeface="Arial" panose="020B0604020202020204" pitchFamily="34" charset="0"/>
                          <a:cs typeface="Arial" panose="020B0604020202020204" pitchFamily="34" charset="0"/>
                        </a:rPr>
                        <a:t>AT4G18480</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dirty="0">
                          <a:effectLst/>
                          <a:latin typeface="Arial" panose="020B0604020202020204" pitchFamily="34" charset="0"/>
                          <a:cs typeface="Arial" panose="020B0604020202020204" pitchFamily="34" charset="0"/>
                        </a:rPr>
                        <a:t>P-loop containing nucleoside triphosphate hydrolases superfamily protein</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22898039"/>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5G4383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MQD19.19</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aluminum induced protein with YGL and LRDR motifs</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11833489"/>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2285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aluminum induced protein with YGL and LRDR motifs</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83705955"/>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4G2745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aluminum induced protein with YGL and LRDR motifs</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27627012"/>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3G6326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b" latinLnBrk="0" hangingPunct="1">
                        <a:lnSpc>
                          <a:spcPct val="100000"/>
                        </a:lnSpc>
                        <a:spcBef>
                          <a:spcPts val="0"/>
                        </a:spcBef>
                        <a:spcAft>
                          <a:spcPts val="0"/>
                        </a:spcAft>
                        <a:buClrTx/>
                        <a:buSzTx/>
                        <a:buFontTx/>
                        <a:buNone/>
                        <a:tabLst/>
                        <a:defRPr/>
                      </a:pPr>
                      <a:r>
                        <a:rPr lang="en-US" sz="600" u="none" strike="noStrike" dirty="0">
                          <a:effectLst/>
                          <a:latin typeface="Arial" panose="020B0604020202020204" pitchFamily="34" charset="0"/>
                          <a:cs typeface="Arial" panose="020B0604020202020204" pitchFamily="34" charset="0"/>
                        </a:rPr>
                        <a:t>F16M2_110, </a:t>
                      </a:r>
                      <a:r>
                        <a:rPr lang="en-US" altLang="ja-JP" sz="600" u="none" strike="noStrike" dirty="0">
                          <a:effectLst/>
                          <a:latin typeface="Arial" panose="020B0604020202020204" pitchFamily="34" charset="0"/>
                          <a:cs typeface="Arial" panose="020B0604020202020204" pitchFamily="34" charset="0"/>
                        </a:rPr>
                        <a:t>ATMRK1</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Protein kinase super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05910371"/>
                  </a:ext>
                </a:extLst>
              </a:tr>
              <a:tr h="0">
                <a:tc>
                  <a:txBody>
                    <a:bodyPr/>
                    <a:lstStyle/>
                    <a:p>
                      <a:pPr algn="ctr" fontAlgn="b">
                        <a:buNone/>
                      </a:pPr>
                      <a:r>
                        <a:rPr lang="en-US" sz="600" u="none" strike="noStrike">
                          <a:effectLst/>
                          <a:latin typeface="Arial" panose="020B0604020202020204" pitchFamily="34" charset="0"/>
                          <a:cs typeface="Arial" panose="020B0604020202020204" pitchFamily="34" charset="0"/>
                        </a:rPr>
                        <a:t>AT4G17720</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a:effectLst/>
                          <a:latin typeface="Arial" panose="020B0604020202020204" pitchFamily="34" charset="0"/>
                          <a:cs typeface="Arial" panose="020B0604020202020204" pitchFamily="34" charset="0"/>
                        </a:rPr>
                        <a:t>RNA-binding (RRM/RBD/RNP motifs) family protein</a:t>
                      </a:r>
                      <a:endParaRPr lang="en-US" sz="600" b="0" i="0" u="none" strike="noStrike">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77722364"/>
                  </a:ext>
                </a:extLst>
              </a:tr>
              <a:tr h="0">
                <a:tc>
                  <a:txBody>
                    <a:bodyPr/>
                    <a:lstStyle/>
                    <a:p>
                      <a:pPr algn="ctr" fontAlgn="b">
                        <a:buNone/>
                      </a:pPr>
                      <a:r>
                        <a:rPr lang="en-US" sz="600" u="none" strike="noStrike" dirty="0">
                          <a:effectLst/>
                          <a:latin typeface="Arial" panose="020B0604020202020204" pitchFamily="34" charset="0"/>
                          <a:cs typeface="Arial" panose="020B0604020202020204" pitchFamily="34" charset="0"/>
                        </a:rPr>
                        <a:t>AT1G13440</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635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457200" rtl="0" eaLnBrk="1" fontAlgn="b" latinLnBrk="0" hangingPunct="1">
                        <a:lnSpc>
                          <a:spcPct val="100000"/>
                        </a:lnSpc>
                        <a:spcBef>
                          <a:spcPts val="0"/>
                        </a:spcBef>
                        <a:spcAft>
                          <a:spcPts val="0"/>
                        </a:spcAft>
                        <a:buClrTx/>
                        <a:buSzTx/>
                        <a:buFontTx/>
                        <a:buNone/>
                        <a:tabLst/>
                        <a:defRPr/>
                      </a:pPr>
                      <a:r>
                        <a:rPr lang="en-US" altLang="ja-JP" sz="600" u="none" strike="noStrike" dirty="0">
                          <a:effectLst/>
                          <a:latin typeface="Arial" panose="020B0604020202020204" pitchFamily="34" charset="0"/>
                          <a:cs typeface="Arial" panose="020B0604020202020204" pitchFamily="34" charset="0"/>
                        </a:rPr>
                        <a:t>GAPC-2,GAPC2</a:t>
                      </a:r>
                      <a:endParaRPr lang="en-US" altLang="ja-JP"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buNone/>
                      </a:pPr>
                      <a:r>
                        <a:rPr lang="en-US" sz="600" u="none" strike="noStrike" dirty="0">
                          <a:effectLst/>
                          <a:latin typeface="Arial" panose="020B0604020202020204" pitchFamily="34" charset="0"/>
                          <a:cs typeface="Arial" panose="020B0604020202020204" pitchFamily="34" charset="0"/>
                        </a:rPr>
                        <a:t>glyceraldehyde-3-phosphate dehydrogenase C2, glyceraldehyde-3-phosphate dehydrogenase C subunit 1</a:t>
                      </a:r>
                      <a:endParaRPr lang="en-US" sz="600" b="0" i="0" u="none" strike="noStrike" dirty="0">
                        <a:solidFill>
                          <a:srgbClr val="000000"/>
                        </a:solidFill>
                        <a:effectLst/>
                        <a:latin typeface="Arial" panose="020B0604020202020204" pitchFamily="34" charset="0"/>
                        <a:ea typeface="Yu Gothic" panose="020B0400000000000000" pitchFamily="50" charset="-128"/>
                        <a:cs typeface="Arial" panose="020B0604020202020204" pitchFamily="34" charset="0"/>
                      </a:endParaRPr>
                    </a:p>
                  </a:txBody>
                  <a:tcPr marL="1482" marR="1482" marT="1482" marB="0" anchor="ctr">
                    <a:lnL w="3175"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17800502"/>
                  </a:ext>
                </a:extLst>
              </a:tr>
            </a:tbl>
          </a:graphicData>
        </a:graphic>
      </p:graphicFrame>
      <p:sp>
        <p:nvSpPr>
          <p:cNvPr id="50" name="テキスト ボックス 49">
            <a:extLst>
              <a:ext uri="{FF2B5EF4-FFF2-40B4-BE49-F238E27FC236}">
                <a16:creationId xmlns:a16="http://schemas.microsoft.com/office/drawing/2014/main" id="{B9376B40-D659-EA8B-3A26-553AEE417B75}"/>
              </a:ext>
            </a:extLst>
          </p:cNvPr>
          <p:cNvSpPr txBox="1"/>
          <p:nvPr/>
        </p:nvSpPr>
        <p:spPr>
          <a:xfrm>
            <a:off x="1650605" y="695143"/>
            <a:ext cx="269626" cy="246221"/>
          </a:xfrm>
          <a:prstGeom prst="rect">
            <a:avLst/>
          </a:prstGeom>
          <a:noFill/>
        </p:spPr>
        <p:txBody>
          <a:bodyPr wrap="none" rtlCol="0">
            <a:spAutoFit/>
          </a:bodyPr>
          <a:lstStyle/>
          <a:p>
            <a:r>
              <a:rPr kumimoji="1" lang="en-US" altLang="ja-JP" sz="1000" dirty="0">
                <a:latin typeface="Arial"/>
                <a:cs typeface="Arial"/>
              </a:rPr>
              <a:t>A</a:t>
            </a:r>
            <a:endParaRPr kumimoji="1" lang="ja-JP" altLang="en-US" sz="1000" dirty="0">
              <a:latin typeface="Arial"/>
              <a:cs typeface="Arial"/>
            </a:endParaRPr>
          </a:p>
        </p:txBody>
      </p:sp>
      <p:sp>
        <p:nvSpPr>
          <p:cNvPr id="51" name="テキスト ボックス 50">
            <a:extLst>
              <a:ext uri="{FF2B5EF4-FFF2-40B4-BE49-F238E27FC236}">
                <a16:creationId xmlns:a16="http://schemas.microsoft.com/office/drawing/2014/main" id="{95F3B9BD-10E4-19F5-7E36-492BC6D62A83}"/>
              </a:ext>
            </a:extLst>
          </p:cNvPr>
          <p:cNvSpPr txBox="1"/>
          <p:nvPr/>
        </p:nvSpPr>
        <p:spPr>
          <a:xfrm>
            <a:off x="1103953" y="2236374"/>
            <a:ext cx="269626" cy="246221"/>
          </a:xfrm>
          <a:prstGeom prst="rect">
            <a:avLst/>
          </a:prstGeom>
          <a:noFill/>
        </p:spPr>
        <p:txBody>
          <a:bodyPr wrap="none" rtlCol="0">
            <a:spAutoFit/>
          </a:bodyPr>
          <a:lstStyle/>
          <a:p>
            <a:r>
              <a:rPr lang="en-US" altLang="ja-JP" sz="1000" dirty="0">
                <a:latin typeface="Arial"/>
                <a:cs typeface="Arial"/>
              </a:rPr>
              <a:t>B</a:t>
            </a:r>
            <a:endParaRPr kumimoji="1" lang="ja-JP" altLang="en-US" sz="1000" dirty="0">
              <a:latin typeface="Arial"/>
              <a:cs typeface="Arial"/>
            </a:endParaRPr>
          </a:p>
        </p:txBody>
      </p:sp>
    </p:spTree>
    <p:extLst>
      <p:ext uri="{BB962C8B-B14F-4D97-AF65-F5344CB8AC3E}">
        <p14:creationId xmlns:p14="http://schemas.microsoft.com/office/powerpoint/2010/main" val="3620670821"/>
      </p:ext>
    </p:extLst>
  </p:cSld>
  <p:clrMapOvr>
    <a:masterClrMapping/>
  </p:clrMapOvr>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noFill/>
        <a:ln w="12700" cmpd="sng">
          <a:solidFill>
            <a:schemeClr val="tx1"/>
          </a:solidFill>
        </a:ln>
        <a:effectLst/>
      </a:spPr>
      <a:bodyPr rtlCol="0" anchor="ctr"/>
      <a:lstStyle>
        <a:defPPr algn="ctr">
          <a:defRPr kumimoji="1"/>
        </a:defPPr>
      </a:lstStyle>
      <a:style>
        <a:lnRef idx="1">
          <a:schemeClr val="accent1"/>
        </a:lnRef>
        <a:fillRef idx="3">
          <a:schemeClr val="accent1"/>
        </a:fillRef>
        <a:effectRef idx="2">
          <a:schemeClr val="accent1"/>
        </a:effectRef>
        <a:fontRef idx="minor">
          <a:schemeClr val="lt1"/>
        </a:fontRef>
      </a:style>
    </a:spDef>
    <a:lnDef>
      <a:spPr>
        <a:ln w="12700" cmpd="sng">
          <a:solidFill>
            <a:schemeClr val="tx1"/>
          </a:solidFill>
        </a:ln>
        <a:effectLst/>
      </a:spPr>
      <a:bodyPr/>
      <a:lstStyle/>
      <a:style>
        <a:lnRef idx="2">
          <a:schemeClr val="accent1"/>
        </a:lnRef>
        <a:fillRef idx="0">
          <a:schemeClr val="accent1"/>
        </a:fillRef>
        <a:effectRef idx="1">
          <a:schemeClr val="accent1"/>
        </a:effectRef>
        <a:fontRef idx="minor">
          <a:schemeClr val="tx1"/>
        </a:fontRef>
      </a:style>
    </a:lnDef>
    <a:txDef>
      <a:spPr>
        <a:noFill/>
      </a:spPr>
      <a:bodyPr wrap="none" rtlCol="0">
        <a:spAutoFit/>
      </a:bodyPr>
      <a:lstStyle>
        <a:defPPr>
          <a:defRPr kumimoji="1" dirty="0" smtClean="0">
            <a:latin typeface="Arial"/>
            <a:cs typeface="Arial"/>
          </a:defRPr>
        </a:defPPr>
      </a:lstStyle>
    </a:txDef>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5329</TotalTime>
  <Words>3636</Words>
  <Application>Microsoft Office PowerPoint</Application>
  <PresentationFormat>On-screen Show (4:3)</PresentationFormat>
  <Paragraphs>361</Paragraphs>
  <Slides>6</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游ゴシック</vt:lpstr>
      <vt:lpstr>Arial</vt:lpstr>
      <vt:lpstr>Calibri</vt:lpstr>
      <vt:lpstr>ホワイト</vt:lpstr>
      <vt:lpstr>PowerPoint Presentation</vt:lpstr>
      <vt:lpstr>PowerPoint Presentation</vt:lpstr>
      <vt:lpstr>PowerPoint Presentation</vt:lpstr>
      <vt:lpstr>PowerPoint Presentation</vt:lpstr>
      <vt:lpstr>PowerPoint Presentation</vt:lpstr>
      <vt:lpstr>PowerPoint Presentation</vt:lpstr>
    </vt:vector>
  </TitlesOfParts>
  <Company>理化学研究所</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梅澤 泰史</dc:creator>
  <cp:lastModifiedBy>MDPI</cp:lastModifiedBy>
  <cp:revision>521</cp:revision>
  <cp:lastPrinted>2025-10-26T07:32:21Z</cp:lastPrinted>
  <dcterms:created xsi:type="dcterms:W3CDTF">2016-04-07T07:23:01Z</dcterms:created>
  <dcterms:modified xsi:type="dcterms:W3CDTF">2026-04-15T13:17:02Z</dcterms:modified>
</cp:coreProperties>
</file>